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notesSlides/notesSlide3.xml" ContentType="application/vnd.openxmlformats-officedocument.presentationml.notesSlid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notesSlides/notesSlide4.xml" ContentType="application/vnd.openxmlformats-officedocument.presentationml.notesSlide+xml"/>
  <Override PartName="/ppt/charts/chart8.xml" ContentType="application/vnd.openxmlformats-officedocument.drawingml.chart+xml"/>
  <Override PartName="/ppt/charts/style8.xml" ContentType="application/vnd.ms-office.chartstyle+xml"/>
  <Override PartName="/ppt/charts/colors8.xml" ContentType="application/vnd.ms-office.chartcolorstyle+xml"/>
  <Override PartName="/ppt/charts/chart9.xml" ContentType="application/vnd.openxmlformats-officedocument.drawingml.chart+xml"/>
  <Override PartName="/ppt/charts/style9.xml" ContentType="application/vnd.ms-office.chartstyle+xml"/>
  <Override PartName="/ppt/charts/colors9.xml" ContentType="application/vnd.ms-office.chartcolorstyle+xml"/>
  <Override PartName="/ppt/charts/chart10.xml" ContentType="application/vnd.openxmlformats-officedocument.drawingml.chart+xml"/>
  <Override PartName="/ppt/charts/style10.xml" ContentType="application/vnd.ms-office.chartstyle+xml"/>
  <Override PartName="/ppt/charts/colors10.xml" ContentType="application/vnd.ms-office.chartcolorstyl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authors.xml" ContentType="application/vnd.ms-powerpoint.authors+xml"/>
  <Override PartName="/ppt/changesInfos/changesInfo1.xml" ContentType="application/vnd.ms-powerpoint.changesinfo+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notesMasterIdLst>
    <p:notesMasterId r:id="rId8"/>
  </p:notesMasterIdLst>
  <p:sldIdLst>
    <p:sldId id="257" r:id="rId2"/>
    <p:sldId id="275" r:id="rId3"/>
    <p:sldId id="265" r:id="rId4"/>
    <p:sldId id="276" r:id="rId5"/>
    <p:sldId id="271" r:id="rId6"/>
    <p:sldId id="268" r:id="rId7"/>
  </p:sldIdLst>
  <p:sldSz cx="6858000" cy="9144000" type="letter"/>
  <p:notesSz cx="6805613" cy="99393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49" userDrawn="1">
          <p15:clr>
            <a:srgbClr val="A4A3A4"/>
          </p15:clr>
        </p15:guide>
        <p15:guide id="3" pos="2160" userDrawn="1">
          <p15:clr>
            <a:srgbClr val="A4A3A4"/>
          </p15:clr>
        </p15:guide>
        <p15:guide id="4" pos="119" userDrawn="1">
          <p15:clr>
            <a:srgbClr val="A4A3A4"/>
          </p15:clr>
        </p15:guide>
        <p15:guide id="5" pos="4201" userDrawn="1">
          <p15:clr>
            <a:srgbClr val="A4A3A4"/>
          </p15:clr>
        </p15:guide>
        <p15:guide id="6" orient="horz" pos="3923" userDrawn="1">
          <p15:clr>
            <a:srgbClr val="A4A3A4"/>
          </p15:clr>
        </p15:guide>
        <p15:guide id="7" orient="horz" pos="317" userDrawn="1">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E94806F5-F1DD-79F5-3D8D-85F6927CF9C2}" name="Author" initials="A" userId="Author" providerId="None"/>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0000"/>
    <a:srgbClr val="339933"/>
    <a:srgbClr val="00CC00"/>
    <a:srgbClr val="33CC33"/>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E9639D4-E3E2-4D34-9284-5A2195B3D0D7}" styleName="밝은 스타일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525" autoAdjust="0"/>
    <p:restoredTop sz="94335" autoAdjust="0"/>
  </p:normalViewPr>
  <p:slideViewPr>
    <p:cSldViewPr snapToGrid="0">
      <p:cViewPr varScale="1">
        <p:scale>
          <a:sx n="53" d="100"/>
          <a:sy n="53" d="100"/>
        </p:scale>
        <p:origin x="2310" y="78"/>
      </p:cViewPr>
      <p:guideLst>
        <p:guide orient="horz" pos="249"/>
        <p:guide pos="2160"/>
        <p:guide pos="119"/>
        <p:guide pos="4201"/>
        <p:guide orient="horz" pos="3923"/>
        <p:guide orient="horz" pos="317"/>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20" Type="http://schemas.microsoft.com/office/2018/10/relationships/authors" Target="author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19" Type="http://schemas.microsoft.com/office/2016/11/relationships/changesInfo" Target="changesInfos/changesInfo1.xml"/><Relationship Id="rId4" Type="http://schemas.openxmlformats.org/officeDocument/2006/relationships/slide" Target="slides/slide3.xml"/><Relationship Id="rId9"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Pooja Vaswani" userId="22baf0d2-7753-4a6a-8c2b-f698ff262cb1" providerId="ADAL" clId="{BD4EAB91-9883-43EB-9A5E-652120A83152}"/>
    <pc:docChg chg="">
      <pc:chgData name="Pooja Vaswani" userId="22baf0d2-7753-4a6a-8c2b-f698ff262cb1" providerId="ADAL" clId="{BD4EAB91-9883-43EB-9A5E-652120A83152}" dt="2023-10-31T05:08:44.979" v="3"/>
      <pc:docMkLst>
        <pc:docMk/>
      </pc:docMkLst>
      <pc:sldChg chg="delCm">
        <pc:chgData name="Pooja Vaswani" userId="22baf0d2-7753-4a6a-8c2b-f698ff262cb1" providerId="ADAL" clId="{BD4EAB91-9883-43EB-9A5E-652120A83152}" dt="2023-10-31T05:06:43.506" v="0"/>
        <pc:sldMkLst>
          <pc:docMk/>
          <pc:sldMk cId="3619803851" sldId="256"/>
        </pc:sldMkLst>
        <pc:extLst>
          <p:ext xmlns:p="http://schemas.openxmlformats.org/presentationml/2006/main" uri="{D6D511B9-2390-475A-947B-AFAB55BFBCF1}">
            <pc226:cmChg xmlns:pc226="http://schemas.microsoft.com/office/powerpoint/2022/06/main/command" chg="del">
              <pc226:chgData name="Pooja Vaswani" userId="22baf0d2-7753-4a6a-8c2b-f698ff262cb1" providerId="ADAL" clId="{BD4EAB91-9883-43EB-9A5E-652120A83152}" dt="2023-10-31T05:06:43.506" v="0"/>
              <pc2:cmMkLst xmlns:pc2="http://schemas.microsoft.com/office/powerpoint/2019/9/main/command">
                <pc:docMk/>
                <pc:sldMk cId="3619803851" sldId="256"/>
                <pc2:cmMk id="{0D79F496-E7C0-469C-9106-CE09C7A49049}"/>
              </pc2:cmMkLst>
            </pc226:cmChg>
          </p:ext>
        </pc:extLst>
      </pc:sldChg>
      <pc:sldChg chg="delCm">
        <pc:chgData name="Pooja Vaswani" userId="22baf0d2-7753-4a6a-8c2b-f698ff262cb1" providerId="ADAL" clId="{BD4EAB91-9883-43EB-9A5E-652120A83152}" dt="2023-10-31T05:07:27.113" v="2"/>
        <pc:sldMkLst>
          <pc:docMk/>
          <pc:sldMk cId="3309978689" sldId="262"/>
        </pc:sldMkLst>
        <pc:extLst>
          <p:ext xmlns:p="http://schemas.openxmlformats.org/presentationml/2006/main" uri="{D6D511B9-2390-475A-947B-AFAB55BFBCF1}">
            <pc226:cmChg xmlns:pc226="http://schemas.microsoft.com/office/powerpoint/2022/06/main/command" chg="del">
              <pc226:chgData name="Pooja Vaswani" userId="22baf0d2-7753-4a6a-8c2b-f698ff262cb1" providerId="ADAL" clId="{BD4EAB91-9883-43EB-9A5E-652120A83152}" dt="2023-10-31T05:07:27.113" v="2"/>
              <pc2:cmMkLst xmlns:pc2="http://schemas.microsoft.com/office/powerpoint/2019/9/main/command">
                <pc:docMk/>
                <pc:sldMk cId="3309978689" sldId="262"/>
                <pc2:cmMk id="{CAE0E7A8-6B2A-4DEA-A2FE-C97B4D92E6AD}"/>
              </pc2:cmMkLst>
            </pc226:cmChg>
          </p:ext>
        </pc:extLst>
      </pc:sldChg>
      <pc:sldChg chg="delCm">
        <pc:chgData name="Pooja Vaswani" userId="22baf0d2-7753-4a6a-8c2b-f698ff262cb1" providerId="ADAL" clId="{BD4EAB91-9883-43EB-9A5E-652120A83152}" dt="2023-10-31T05:08:44.979" v="3"/>
        <pc:sldMkLst>
          <pc:docMk/>
          <pc:sldMk cId="1815120767" sldId="265"/>
        </pc:sldMkLst>
        <pc:extLst>
          <p:ext xmlns:p="http://schemas.openxmlformats.org/presentationml/2006/main" uri="{D6D511B9-2390-475A-947B-AFAB55BFBCF1}">
            <pc226:cmChg xmlns:pc226="http://schemas.microsoft.com/office/powerpoint/2022/06/main/command" chg="del">
              <pc226:chgData name="Pooja Vaswani" userId="22baf0d2-7753-4a6a-8c2b-f698ff262cb1" providerId="ADAL" clId="{BD4EAB91-9883-43EB-9A5E-652120A83152}" dt="2023-10-31T05:08:44.979" v="3"/>
              <pc2:cmMkLst xmlns:pc2="http://schemas.microsoft.com/office/powerpoint/2019/9/main/command">
                <pc:docMk/>
                <pc:sldMk cId="1815120767" sldId="265"/>
                <pc2:cmMk id="{761CC44E-2D17-4C4B-91A7-15402239A223}"/>
              </pc2:cmMkLst>
            </pc226:cmChg>
          </p:ext>
        </pc:extLst>
      </pc:sldChg>
      <pc:sldChg chg="delCm">
        <pc:chgData name="Pooja Vaswani" userId="22baf0d2-7753-4a6a-8c2b-f698ff262cb1" providerId="ADAL" clId="{BD4EAB91-9883-43EB-9A5E-652120A83152}" dt="2023-10-31T05:07:14.474" v="1"/>
        <pc:sldMkLst>
          <pc:docMk/>
          <pc:sldMk cId="4211855561" sldId="270"/>
        </pc:sldMkLst>
        <pc:extLst>
          <p:ext xmlns:p="http://schemas.openxmlformats.org/presentationml/2006/main" uri="{D6D511B9-2390-475A-947B-AFAB55BFBCF1}">
            <pc226:cmChg xmlns:pc226="http://schemas.microsoft.com/office/powerpoint/2022/06/main/command" chg="del">
              <pc226:chgData name="Pooja Vaswani" userId="22baf0d2-7753-4a6a-8c2b-f698ff262cb1" providerId="ADAL" clId="{BD4EAB91-9883-43EB-9A5E-652120A83152}" dt="2023-10-31T05:07:14.474" v="1"/>
              <pc2:cmMkLst xmlns:pc2="http://schemas.microsoft.com/office/powerpoint/2019/9/main/command">
                <pc:docMk/>
                <pc:sldMk cId="4211855561" sldId="270"/>
                <pc2:cmMk id="{B2E19A77-81B7-4594-9550-6C50297F2BDB}"/>
              </pc2:cmMkLst>
            </pc226:cmChg>
          </p:ext>
        </pc:extLst>
      </pc:sldChg>
    </pc:docChg>
  </pc:docChgLst>
</pc:chgInfo>
</file>

<file path=ppt/charts/_rels/chart1.xml.rels><?xml version="1.0" encoding="UTF-8" standalone="yes"?>
<Relationships xmlns="http://schemas.openxmlformats.org/package/2006/relationships"><Relationship Id="rId3" Type="http://schemas.openxmlformats.org/officeDocument/2006/relationships/oleObject" Target="file:///D:\backup\Project\2020%20&#44284;&#51228;\&#48709;&#45936;&#51060;&#53552;\GTEx%20&#50672;&#44396;\202007_WGCNA_&#54588;&#54616;&#48373;&#48512;\20200714_WGCNA_ver.2.R_cutoff1%23\WGCNA_total_sample\%235%20sined_SoftThreshold9_MinModSize30\black%20module%207%20gene_Age_BMI%20correlation.xlsx" TargetMode="External"/><Relationship Id="rId2" Type="http://schemas.microsoft.com/office/2011/relationships/chartColorStyle" Target="colors1.xml"/><Relationship Id="rId1" Type="http://schemas.microsoft.com/office/2011/relationships/chartStyle" Target="style1.xml"/></Relationships>
</file>

<file path=ppt/charts/_rels/chart10.xml.rels><?xml version="1.0" encoding="UTF-8" standalone="yes"?>
<Relationships xmlns="http://schemas.openxmlformats.org/package/2006/relationships"><Relationship Id="rId3" Type="http://schemas.openxmlformats.org/officeDocument/2006/relationships/oleObject" Target="file:///D:\backup\Project\2020%20&#44284;&#51228;\&#48709;&#45936;&#51060;&#53552;\GTEx%20&#50672;&#44396;\202007_WGCNA_&#54588;&#54616;&#48373;&#48512;\20200714_WGCNA_ver.2.R_cutoff1%23\2023.03.20.%20SenMayo_genelist_adipose%20tissue%20tpm_agecor.xlsx" TargetMode="External"/><Relationship Id="rId2" Type="http://schemas.microsoft.com/office/2011/relationships/chartColorStyle" Target="colors10.xml"/><Relationship Id="rId1" Type="http://schemas.microsoft.com/office/2011/relationships/chartStyle" Target="style10.xml"/></Relationships>
</file>

<file path=ppt/charts/_rels/chart2.xml.rels><?xml version="1.0" encoding="UTF-8" standalone="yes"?>
<Relationships xmlns="http://schemas.openxmlformats.org/package/2006/relationships"><Relationship Id="rId3" Type="http://schemas.openxmlformats.org/officeDocument/2006/relationships/oleObject" Target="file:///C:\backup\Project\2020%20&#44284;&#51228;\&#48709;&#45936;&#51060;&#53552;\GTEx%20&#50672;&#44396;\202007_WGCNA_&#54588;&#54616;&#48373;&#48512;\GYG2\&#48373;&#49324;&#48376;%20GYG2%20expression_&#44608;&#44508;&#54620;&#45784;%20%23.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D:\backup\Project\2020%20&#44284;&#51228;\&#48709;&#45936;&#51060;&#53552;\GTEx%20&#50672;&#44396;\202007_WGCNA_&#54588;&#54616;&#48373;&#48512;\20200714_WGCNA_ver.2.R_cutoff1%23\WGCNA_total_sample\%235%20sined_SoftThreshold9_MinModSize30\black%20module%207%20gene_Age_BMI%20correlation.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file:///D:\backup\Project\2022%20&#44284;&#51228;\GYG2%20&#45436;&#47928;%20&#51456;&#48708;\Revision\Experiment\2023.10.20.%20gene_cor_adipose.xlsx"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file:///D:\backup\Project\2022%20&#44284;&#51228;\GYG2%20&#45436;&#47928;%20&#51456;&#48708;\Revision\Experiment\2023.10.20.%20gene_cor_adipose.xlsx" TargetMode="External"/><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oleObject" Target="file:///D:\backup\Project\2022%20&#44284;&#51228;\GYG2%20&#45436;&#47928;%20&#51456;&#48708;\Revision\Experiment\2023.10.20.%20gene_cor_adipose.xlsx" TargetMode="External"/><Relationship Id="rId2" Type="http://schemas.microsoft.com/office/2011/relationships/chartColorStyle" Target="colors6.xml"/><Relationship Id="rId1" Type="http://schemas.microsoft.com/office/2011/relationships/chartStyle" Target="style6.xml"/></Relationships>
</file>

<file path=ppt/charts/_rels/chart7.xml.rels><?xml version="1.0" encoding="UTF-8" standalone="yes"?>
<Relationships xmlns="http://schemas.openxmlformats.org/package/2006/relationships"><Relationship Id="rId3" Type="http://schemas.openxmlformats.org/officeDocument/2006/relationships/oleObject" Target="file:///D:\backup\Project\2022%20&#44284;&#51228;\GYG2%20&#45436;&#47928;%20&#51456;&#48708;\Revision\Experiment\38295_Summary_&#51221;&#47532;.xlsx" TargetMode="External"/><Relationship Id="rId2" Type="http://schemas.microsoft.com/office/2011/relationships/chartColorStyle" Target="colors7.xml"/><Relationship Id="rId1" Type="http://schemas.microsoft.com/office/2011/relationships/chartStyle" Target="style7.xml"/></Relationships>
</file>

<file path=ppt/charts/_rels/chart8.xml.rels><?xml version="1.0" encoding="UTF-8" standalone="yes"?>
<Relationships xmlns="http://schemas.openxmlformats.org/package/2006/relationships"><Relationship Id="rId3" Type="http://schemas.openxmlformats.org/officeDocument/2006/relationships/oleObject" Target="file:///D:\backup\Project\2020%20&#44284;&#51228;\&#48709;&#45936;&#51060;&#53552;\GTEx%20&#50672;&#44396;\202007_WGCNA_&#54588;&#54616;&#48373;&#48512;\20200714_WGCNA_ver.2.R_cutoff1%23\2023.03.20.%20SenMayo_genelist_adipose%20tissue%20tpm_agecor.xlsx" TargetMode="External"/><Relationship Id="rId2" Type="http://schemas.microsoft.com/office/2011/relationships/chartColorStyle" Target="colors8.xml"/><Relationship Id="rId1" Type="http://schemas.microsoft.com/office/2011/relationships/chartStyle" Target="style8.xml"/></Relationships>
</file>

<file path=ppt/charts/_rels/chart9.xml.rels><?xml version="1.0" encoding="UTF-8" standalone="yes"?>
<Relationships xmlns="http://schemas.openxmlformats.org/package/2006/relationships"><Relationship Id="rId3" Type="http://schemas.openxmlformats.org/officeDocument/2006/relationships/oleObject" Target="file:///D:\backup\Project\2020%20&#44284;&#51228;\&#48709;&#45936;&#51060;&#53552;\GTEx%20&#50672;&#44396;\202007_WGCNA_&#54588;&#54616;&#48373;&#48512;\20200714_WGCNA_ver.2.R_cutoff1%23\2023.03.20.%20SenMayo_genelist_adipose%20tissue%20tpm_agecor.xlsx" TargetMode="External"/><Relationship Id="rId2" Type="http://schemas.microsoft.com/office/2011/relationships/chartColorStyle" Target="colors9.xml"/><Relationship Id="rId1" Type="http://schemas.microsoft.com/office/2011/relationships/chartStyle" Target="style9.xm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9453333333333334"/>
          <c:y val="5.1880555555555569E-2"/>
          <c:w val="0.74634722222222238"/>
          <c:h val="0.75989722222222222"/>
        </c:manualLayout>
      </c:layout>
      <c:scatterChart>
        <c:scatterStyle val="lineMarker"/>
        <c:varyColors val="0"/>
        <c:ser>
          <c:idx val="0"/>
          <c:order val="0"/>
          <c:tx>
            <c:strRef>
              <c:f>'suq BMI cor'!$A$1</c:f>
              <c:strCache>
                <c:ptCount val="1"/>
                <c:pt idx="0">
                  <c:v>MALE</c:v>
                </c:pt>
              </c:strCache>
            </c:strRef>
          </c:tx>
          <c:spPr>
            <a:ln w="25400" cap="rnd">
              <a:noFill/>
              <a:round/>
            </a:ln>
            <a:effectLst/>
          </c:spPr>
          <c:marker>
            <c:symbol val="circle"/>
            <c:size val="3"/>
            <c:spPr>
              <a:solidFill>
                <a:schemeClr val="accent1"/>
              </a:solidFill>
              <a:ln w="9525">
                <a:solidFill>
                  <a:schemeClr val="accent1"/>
                </a:solidFill>
              </a:ln>
              <a:effectLst/>
            </c:spPr>
          </c:marker>
          <c:trendline>
            <c:spPr>
              <a:ln w="19050" cap="rnd">
                <a:solidFill>
                  <a:schemeClr val="accent1"/>
                </a:solidFill>
                <a:prstDash val="solid"/>
              </a:ln>
              <a:effectLst/>
            </c:spPr>
            <c:trendlineType val="linear"/>
            <c:dispRSqr val="0"/>
            <c:dispEq val="0"/>
          </c:trendline>
          <c:xVal>
            <c:numRef>
              <c:f>'suq BMI cor'!$G$9:$KE$9</c:f>
              <c:numCache>
                <c:formatCode>General</c:formatCode>
                <c:ptCount val="285"/>
                <c:pt idx="0">
                  <c:v>23.96</c:v>
                </c:pt>
                <c:pt idx="1">
                  <c:v>28.06</c:v>
                </c:pt>
                <c:pt idx="2">
                  <c:v>21.97</c:v>
                </c:pt>
                <c:pt idx="3">
                  <c:v>26.52</c:v>
                </c:pt>
                <c:pt idx="4">
                  <c:v>23.31</c:v>
                </c:pt>
                <c:pt idx="5">
                  <c:v>24.78</c:v>
                </c:pt>
                <c:pt idx="6">
                  <c:v>28.4</c:v>
                </c:pt>
                <c:pt idx="7">
                  <c:v>22.24</c:v>
                </c:pt>
                <c:pt idx="8">
                  <c:v>24.41</c:v>
                </c:pt>
                <c:pt idx="9">
                  <c:v>20.62</c:v>
                </c:pt>
                <c:pt idx="10">
                  <c:v>20.67</c:v>
                </c:pt>
                <c:pt idx="11">
                  <c:v>22.65</c:v>
                </c:pt>
                <c:pt idx="12">
                  <c:v>26.29</c:v>
                </c:pt>
                <c:pt idx="13">
                  <c:v>22.09</c:v>
                </c:pt>
                <c:pt idx="14">
                  <c:v>21.18</c:v>
                </c:pt>
                <c:pt idx="15">
                  <c:v>27.11</c:v>
                </c:pt>
                <c:pt idx="16">
                  <c:v>25.97</c:v>
                </c:pt>
                <c:pt idx="17">
                  <c:v>22.81</c:v>
                </c:pt>
                <c:pt idx="18">
                  <c:v>29.95</c:v>
                </c:pt>
                <c:pt idx="19">
                  <c:v>30.51</c:v>
                </c:pt>
                <c:pt idx="20">
                  <c:v>32.99</c:v>
                </c:pt>
                <c:pt idx="21">
                  <c:v>26.38</c:v>
                </c:pt>
                <c:pt idx="22">
                  <c:v>32.200000000000003</c:v>
                </c:pt>
                <c:pt idx="23">
                  <c:v>28.66</c:v>
                </c:pt>
                <c:pt idx="24">
                  <c:v>23.36</c:v>
                </c:pt>
                <c:pt idx="25">
                  <c:v>30.38</c:v>
                </c:pt>
                <c:pt idx="26">
                  <c:v>25.24</c:v>
                </c:pt>
                <c:pt idx="27">
                  <c:v>21.26</c:v>
                </c:pt>
                <c:pt idx="28">
                  <c:v>24.12</c:v>
                </c:pt>
                <c:pt idx="29">
                  <c:v>34.28</c:v>
                </c:pt>
                <c:pt idx="30">
                  <c:v>25.24</c:v>
                </c:pt>
                <c:pt idx="31">
                  <c:v>25.62</c:v>
                </c:pt>
                <c:pt idx="32">
                  <c:v>27.37</c:v>
                </c:pt>
                <c:pt idx="33">
                  <c:v>22.08</c:v>
                </c:pt>
                <c:pt idx="34">
                  <c:v>33.11</c:v>
                </c:pt>
                <c:pt idx="35">
                  <c:v>20.98</c:v>
                </c:pt>
                <c:pt idx="36">
                  <c:v>27.32</c:v>
                </c:pt>
                <c:pt idx="37">
                  <c:v>32.18</c:v>
                </c:pt>
                <c:pt idx="38">
                  <c:v>34.78</c:v>
                </c:pt>
                <c:pt idx="39">
                  <c:v>33.33</c:v>
                </c:pt>
                <c:pt idx="40">
                  <c:v>32.020000000000003</c:v>
                </c:pt>
                <c:pt idx="41">
                  <c:v>29.37</c:v>
                </c:pt>
                <c:pt idx="42">
                  <c:v>27.61</c:v>
                </c:pt>
                <c:pt idx="43">
                  <c:v>25.36</c:v>
                </c:pt>
                <c:pt idx="44">
                  <c:v>24.27</c:v>
                </c:pt>
                <c:pt idx="45">
                  <c:v>27.12</c:v>
                </c:pt>
                <c:pt idx="46">
                  <c:v>29.41</c:v>
                </c:pt>
                <c:pt idx="47">
                  <c:v>27.89</c:v>
                </c:pt>
                <c:pt idx="48">
                  <c:v>32.92</c:v>
                </c:pt>
                <c:pt idx="49">
                  <c:v>29.7</c:v>
                </c:pt>
                <c:pt idx="50">
                  <c:v>28.45</c:v>
                </c:pt>
                <c:pt idx="51">
                  <c:v>33.47</c:v>
                </c:pt>
                <c:pt idx="52">
                  <c:v>24.41</c:v>
                </c:pt>
                <c:pt idx="53">
                  <c:v>20.34</c:v>
                </c:pt>
                <c:pt idx="54">
                  <c:v>23.77</c:v>
                </c:pt>
                <c:pt idx="55">
                  <c:v>35.44</c:v>
                </c:pt>
                <c:pt idx="56">
                  <c:v>30.17</c:v>
                </c:pt>
                <c:pt idx="57">
                  <c:v>19.8</c:v>
                </c:pt>
                <c:pt idx="58">
                  <c:v>26.04</c:v>
                </c:pt>
                <c:pt idx="59">
                  <c:v>29.29</c:v>
                </c:pt>
                <c:pt idx="60">
                  <c:v>33.89</c:v>
                </c:pt>
                <c:pt idx="61">
                  <c:v>28.74</c:v>
                </c:pt>
                <c:pt idx="62">
                  <c:v>26.31</c:v>
                </c:pt>
                <c:pt idx="63">
                  <c:v>22.88</c:v>
                </c:pt>
                <c:pt idx="64">
                  <c:v>30.55</c:v>
                </c:pt>
                <c:pt idx="65">
                  <c:v>25.36</c:v>
                </c:pt>
                <c:pt idx="66">
                  <c:v>22.31</c:v>
                </c:pt>
                <c:pt idx="67">
                  <c:v>29.24</c:v>
                </c:pt>
                <c:pt idx="68">
                  <c:v>27.61</c:v>
                </c:pt>
                <c:pt idx="69">
                  <c:v>32.549999999999997</c:v>
                </c:pt>
                <c:pt idx="70">
                  <c:v>20.88</c:v>
                </c:pt>
                <c:pt idx="71">
                  <c:v>31.4</c:v>
                </c:pt>
                <c:pt idx="72">
                  <c:v>23.57</c:v>
                </c:pt>
                <c:pt idx="73">
                  <c:v>29.94</c:v>
                </c:pt>
                <c:pt idx="74">
                  <c:v>30.11</c:v>
                </c:pt>
                <c:pt idx="75">
                  <c:v>32.26</c:v>
                </c:pt>
                <c:pt idx="76">
                  <c:v>29.83</c:v>
                </c:pt>
                <c:pt idx="77">
                  <c:v>29.29</c:v>
                </c:pt>
                <c:pt idx="78">
                  <c:v>28.97</c:v>
                </c:pt>
                <c:pt idx="79">
                  <c:v>21.7</c:v>
                </c:pt>
                <c:pt idx="80">
                  <c:v>28.61</c:v>
                </c:pt>
                <c:pt idx="81">
                  <c:v>31.26</c:v>
                </c:pt>
                <c:pt idx="82">
                  <c:v>27.4</c:v>
                </c:pt>
                <c:pt idx="83">
                  <c:v>27.12</c:v>
                </c:pt>
                <c:pt idx="84">
                  <c:v>31.77</c:v>
                </c:pt>
                <c:pt idx="85">
                  <c:v>24.75</c:v>
                </c:pt>
                <c:pt idx="86">
                  <c:v>34.4</c:v>
                </c:pt>
                <c:pt idx="87">
                  <c:v>21.41</c:v>
                </c:pt>
                <c:pt idx="88">
                  <c:v>34.979999999999997</c:v>
                </c:pt>
                <c:pt idx="89">
                  <c:v>19.760000000000002</c:v>
                </c:pt>
                <c:pt idx="90">
                  <c:v>34.69</c:v>
                </c:pt>
                <c:pt idx="91">
                  <c:v>33.01</c:v>
                </c:pt>
                <c:pt idx="92">
                  <c:v>27.7</c:v>
                </c:pt>
                <c:pt idx="93">
                  <c:v>19.760000000000002</c:v>
                </c:pt>
                <c:pt idx="94">
                  <c:v>30.57</c:v>
                </c:pt>
                <c:pt idx="95">
                  <c:v>32.71</c:v>
                </c:pt>
                <c:pt idx="96">
                  <c:v>31.58</c:v>
                </c:pt>
                <c:pt idx="97">
                  <c:v>30.56</c:v>
                </c:pt>
                <c:pt idx="98">
                  <c:v>25.1</c:v>
                </c:pt>
                <c:pt idx="99">
                  <c:v>26.58</c:v>
                </c:pt>
                <c:pt idx="100">
                  <c:v>26.85</c:v>
                </c:pt>
                <c:pt idx="101">
                  <c:v>29.21</c:v>
                </c:pt>
                <c:pt idx="102">
                  <c:v>23.63</c:v>
                </c:pt>
                <c:pt idx="103">
                  <c:v>31.98</c:v>
                </c:pt>
                <c:pt idx="104">
                  <c:v>26.71</c:v>
                </c:pt>
                <c:pt idx="105">
                  <c:v>30.27</c:v>
                </c:pt>
                <c:pt idx="106">
                  <c:v>29.24</c:v>
                </c:pt>
                <c:pt idx="107">
                  <c:v>18.75</c:v>
                </c:pt>
                <c:pt idx="108">
                  <c:v>22.38</c:v>
                </c:pt>
                <c:pt idx="109">
                  <c:v>24.41</c:v>
                </c:pt>
                <c:pt idx="110">
                  <c:v>28.12</c:v>
                </c:pt>
                <c:pt idx="111">
                  <c:v>32</c:v>
                </c:pt>
                <c:pt idx="112">
                  <c:v>26.16</c:v>
                </c:pt>
                <c:pt idx="113">
                  <c:v>33.119999999999997</c:v>
                </c:pt>
                <c:pt idx="114">
                  <c:v>22.31</c:v>
                </c:pt>
                <c:pt idx="115">
                  <c:v>25.68</c:v>
                </c:pt>
                <c:pt idx="116">
                  <c:v>19.77</c:v>
                </c:pt>
                <c:pt idx="117">
                  <c:v>34.86</c:v>
                </c:pt>
                <c:pt idx="118">
                  <c:v>27.26</c:v>
                </c:pt>
                <c:pt idx="119">
                  <c:v>27.46</c:v>
                </c:pt>
                <c:pt idx="120">
                  <c:v>30.85</c:v>
                </c:pt>
                <c:pt idx="121">
                  <c:v>22.34</c:v>
                </c:pt>
                <c:pt idx="122">
                  <c:v>28.59</c:v>
                </c:pt>
                <c:pt idx="123">
                  <c:v>22.16</c:v>
                </c:pt>
                <c:pt idx="124">
                  <c:v>29.02</c:v>
                </c:pt>
                <c:pt idx="125">
                  <c:v>23.93</c:v>
                </c:pt>
                <c:pt idx="126">
                  <c:v>34.43</c:v>
                </c:pt>
                <c:pt idx="127">
                  <c:v>22.43</c:v>
                </c:pt>
                <c:pt idx="128">
                  <c:v>31.56</c:v>
                </c:pt>
                <c:pt idx="129">
                  <c:v>31.51</c:v>
                </c:pt>
                <c:pt idx="130">
                  <c:v>33.81</c:v>
                </c:pt>
                <c:pt idx="131">
                  <c:v>27.31</c:v>
                </c:pt>
                <c:pt idx="132">
                  <c:v>25.31</c:v>
                </c:pt>
                <c:pt idx="133">
                  <c:v>25.09</c:v>
                </c:pt>
                <c:pt idx="134">
                  <c:v>30.32</c:v>
                </c:pt>
                <c:pt idx="135">
                  <c:v>31.56</c:v>
                </c:pt>
                <c:pt idx="136">
                  <c:v>22.92</c:v>
                </c:pt>
                <c:pt idx="137">
                  <c:v>27.12</c:v>
                </c:pt>
                <c:pt idx="138">
                  <c:v>20.07</c:v>
                </c:pt>
                <c:pt idx="139">
                  <c:v>25.42</c:v>
                </c:pt>
                <c:pt idx="140">
                  <c:v>32.479999999999997</c:v>
                </c:pt>
                <c:pt idx="141">
                  <c:v>26.58</c:v>
                </c:pt>
                <c:pt idx="142">
                  <c:v>20.29</c:v>
                </c:pt>
                <c:pt idx="143">
                  <c:v>32.979999999999997</c:v>
                </c:pt>
                <c:pt idx="144">
                  <c:v>29.91</c:v>
                </c:pt>
                <c:pt idx="145">
                  <c:v>32.909999999999997</c:v>
                </c:pt>
                <c:pt idx="146">
                  <c:v>23.8</c:v>
                </c:pt>
                <c:pt idx="147">
                  <c:v>25.1</c:v>
                </c:pt>
                <c:pt idx="148">
                  <c:v>25.85</c:v>
                </c:pt>
                <c:pt idx="149">
                  <c:v>24.62</c:v>
                </c:pt>
                <c:pt idx="150">
                  <c:v>26.44</c:v>
                </c:pt>
                <c:pt idx="151">
                  <c:v>31.58</c:v>
                </c:pt>
                <c:pt idx="152">
                  <c:v>33.57</c:v>
                </c:pt>
                <c:pt idx="153">
                  <c:v>32.28</c:v>
                </c:pt>
                <c:pt idx="154">
                  <c:v>30.94</c:v>
                </c:pt>
                <c:pt idx="155">
                  <c:v>27.25</c:v>
                </c:pt>
                <c:pt idx="156">
                  <c:v>30.51</c:v>
                </c:pt>
                <c:pt idx="157">
                  <c:v>27.12</c:v>
                </c:pt>
                <c:pt idx="158">
                  <c:v>27.5</c:v>
                </c:pt>
                <c:pt idx="159">
                  <c:v>31.32</c:v>
                </c:pt>
                <c:pt idx="160">
                  <c:v>27.02</c:v>
                </c:pt>
                <c:pt idx="161">
                  <c:v>25.82</c:v>
                </c:pt>
                <c:pt idx="162">
                  <c:v>22.1</c:v>
                </c:pt>
                <c:pt idx="163">
                  <c:v>23.49</c:v>
                </c:pt>
                <c:pt idx="164">
                  <c:v>34.54</c:v>
                </c:pt>
                <c:pt idx="165">
                  <c:v>23.71</c:v>
                </c:pt>
                <c:pt idx="166">
                  <c:v>25.68</c:v>
                </c:pt>
                <c:pt idx="167">
                  <c:v>20.94</c:v>
                </c:pt>
                <c:pt idx="168">
                  <c:v>26.5</c:v>
                </c:pt>
                <c:pt idx="169">
                  <c:v>27.12</c:v>
                </c:pt>
                <c:pt idx="170">
                  <c:v>29.81</c:v>
                </c:pt>
                <c:pt idx="171">
                  <c:v>27.86</c:v>
                </c:pt>
                <c:pt idx="172">
                  <c:v>33.97</c:v>
                </c:pt>
                <c:pt idx="173">
                  <c:v>28.21</c:v>
                </c:pt>
                <c:pt idx="174">
                  <c:v>22.8</c:v>
                </c:pt>
                <c:pt idx="175">
                  <c:v>26.61</c:v>
                </c:pt>
                <c:pt idx="176">
                  <c:v>23.36</c:v>
                </c:pt>
                <c:pt idx="177">
                  <c:v>27.12</c:v>
                </c:pt>
                <c:pt idx="178">
                  <c:v>32.28</c:v>
                </c:pt>
                <c:pt idx="179">
                  <c:v>33.19</c:v>
                </c:pt>
                <c:pt idx="180">
                  <c:v>33.47</c:v>
                </c:pt>
                <c:pt idx="181">
                  <c:v>28.69</c:v>
                </c:pt>
                <c:pt idx="182">
                  <c:v>35.049999999999997</c:v>
                </c:pt>
                <c:pt idx="183">
                  <c:v>20.8</c:v>
                </c:pt>
                <c:pt idx="184">
                  <c:v>23.45</c:v>
                </c:pt>
                <c:pt idx="185">
                  <c:v>22.23</c:v>
                </c:pt>
                <c:pt idx="186">
                  <c:v>34.119999999999997</c:v>
                </c:pt>
                <c:pt idx="187">
                  <c:v>31.06</c:v>
                </c:pt>
                <c:pt idx="188">
                  <c:v>27.89</c:v>
                </c:pt>
                <c:pt idx="189">
                  <c:v>31.66</c:v>
                </c:pt>
                <c:pt idx="190">
                  <c:v>27.44</c:v>
                </c:pt>
                <c:pt idx="191">
                  <c:v>26.55</c:v>
                </c:pt>
                <c:pt idx="192">
                  <c:v>18.64</c:v>
                </c:pt>
                <c:pt idx="193">
                  <c:v>24.33</c:v>
                </c:pt>
                <c:pt idx="194">
                  <c:v>25.39</c:v>
                </c:pt>
                <c:pt idx="195">
                  <c:v>26.81</c:v>
                </c:pt>
                <c:pt idx="196">
                  <c:v>19</c:v>
                </c:pt>
                <c:pt idx="197">
                  <c:v>22.04</c:v>
                </c:pt>
                <c:pt idx="198">
                  <c:v>25.06</c:v>
                </c:pt>
                <c:pt idx="199">
                  <c:v>32.06</c:v>
                </c:pt>
                <c:pt idx="200">
                  <c:v>32.979999999999997</c:v>
                </c:pt>
                <c:pt idx="201">
                  <c:v>24.41</c:v>
                </c:pt>
                <c:pt idx="202">
                  <c:v>34.72</c:v>
                </c:pt>
                <c:pt idx="203">
                  <c:v>27.89</c:v>
                </c:pt>
                <c:pt idx="204">
                  <c:v>29.16</c:v>
                </c:pt>
                <c:pt idx="205">
                  <c:v>33.28</c:v>
                </c:pt>
                <c:pt idx="206">
                  <c:v>26.28</c:v>
                </c:pt>
                <c:pt idx="207">
                  <c:v>31.75</c:v>
                </c:pt>
                <c:pt idx="208">
                  <c:v>28.21</c:v>
                </c:pt>
                <c:pt idx="209">
                  <c:v>23.33</c:v>
                </c:pt>
                <c:pt idx="210">
                  <c:v>30.78</c:v>
                </c:pt>
                <c:pt idx="211">
                  <c:v>29.54</c:v>
                </c:pt>
                <c:pt idx="212">
                  <c:v>29.98</c:v>
                </c:pt>
                <c:pt idx="213">
                  <c:v>31.32</c:v>
                </c:pt>
                <c:pt idx="214">
                  <c:v>28.06</c:v>
                </c:pt>
                <c:pt idx="215">
                  <c:v>21.93</c:v>
                </c:pt>
                <c:pt idx="216">
                  <c:v>28.49</c:v>
                </c:pt>
                <c:pt idx="217">
                  <c:v>27.73</c:v>
                </c:pt>
                <c:pt idx="218">
                  <c:v>28.59</c:v>
                </c:pt>
                <c:pt idx="219">
                  <c:v>29.53</c:v>
                </c:pt>
                <c:pt idx="220">
                  <c:v>24.68</c:v>
                </c:pt>
                <c:pt idx="221">
                  <c:v>27.12</c:v>
                </c:pt>
                <c:pt idx="222">
                  <c:v>22.15</c:v>
                </c:pt>
                <c:pt idx="223">
                  <c:v>32.840000000000003</c:v>
                </c:pt>
                <c:pt idx="224">
                  <c:v>32.549999999999997</c:v>
                </c:pt>
                <c:pt idx="225">
                  <c:v>28.51</c:v>
                </c:pt>
                <c:pt idx="226">
                  <c:v>30.11</c:v>
                </c:pt>
                <c:pt idx="227">
                  <c:v>26.25</c:v>
                </c:pt>
                <c:pt idx="228">
                  <c:v>25.93</c:v>
                </c:pt>
                <c:pt idx="229">
                  <c:v>29.02</c:v>
                </c:pt>
                <c:pt idx="230">
                  <c:v>27.12</c:v>
                </c:pt>
                <c:pt idx="231">
                  <c:v>27.12</c:v>
                </c:pt>
                <c:pt idx="232">
                  <c:v>28.69</c:v>
                </c:pt>
                <c:pt idx="233">
                  <c:v>33.9</c:v>
                </c:pt>
                <c:pt idx="234">
                  <c:v>33.9</c:v>
                </c:pt>
                <c:pt idx="235">
                  <c:v>29.01</c:v>
                </c:pt>
                <c:pt idx="236">
                  <c:v>27.12</c:v>
                </c:pt>
                <c:pt idx="237">
                  <c:v>24.89</c:v>
                </c:pt>
                <c:pt idx="238">
                  <c:v>34.43</c:v>
                </c:pt>
                <c:pt idx="239">
                  <c:v>23.08</c:v>
                </c:pt>
                <c:pt idx="240">
                  <c:v>27.72</c:v>
                </c:pt>
                <c:pt idx="241">
                  <c:v>33.36</c:v>
                </c:pt>
                <c:pt idx="242">
                  <c:v>30.41</c:v>
                </c:pt>
                <c:pt idx="243">
                  <c:v>32.630000000000003</c:v>
                </c:pt>
                <c:pt idx="244">
                  <c:v>34.659999999999997</c:v>
                </c:pt>
                <c:pt idx="245">
                  <c:v>28.94</c:v>
                </c:pt>
                <c:pt idx="246">
                  <c:v>29.66</c:v>
                </c:pt>
                <c:pt idx="247">
                  <c:v>26.96</c:v>
                </c:pt>
                <c:pt idx="248">
                  <c:v>33.369999999999997</c:v>
                </c:pt>
                <c:pt idx="249">
                  <c:v>23.92</c:v>
                </c:pt>
                <c:pt idx="250">
                  <c:v>27.12</c:v>
                </c:pt>
                <c:pt idx="251">
                  <c:v>23.43</c:v>
                </c:pt>
                <c:pt idx="252">
                  <c:v>28.99</c:v>
                </c:pt>
                <c:pt idx="253">
                  <c:v>27.76</c:v>
                </c:pt>
                <c:pt idx="254">
                  <c:v>23.18</c:v>
                </c:pt>
                <c:pt idx="255">
                  <c:v>30.17</c:v>
                </c:pt>
                <c:pt idx="256">
                  <c:v>28.26</c:v>
                </c:pt>
                <c:pt idx="257">
                  <c:v>21.3</c:v>
                </c:pt>
                <c:pt idx="258">
                  <c:v>24.58</c:v>
                </c:pt>
                <c:pt idx="259">
                  <c:v>27.89</c:v>
                </c:pt>
                <c:pt idx="260">
                  <c:v>31.53</c:v>
                </c:pt>
                <c:pt idx="261">
                  <c:v>28.57</c:v>
                </c:pt>
                <c:pt idx="262">
                  <c:v>18.989999999999998</c:v>
                </c:pt>
                <c:pt idx="263">
                  <c:v>32.89</c:v>
                </c:pt>
                <c:pt idx="264">
                  <c:v>31.6</c:v>
                </c:pt>
                <c:pt idx="265">
                  <c:v>22.67</c:v>
                </c:pt>
                <c:pt idx="266">
                  <c:v>29.83</c:v>
                </c:pt>
                <c:pt idx="267">
                  <c:v>29.55</c:v>
                </c:pt>
                <c:pt idx="268">
                  <c:v>18.8</c:v>
                </c:pt>
                <c:pt idx="269">
                  <c:v>33.71</c:v>
                </c:pt>
                <c:pt idx="270">
                  <c:v>24.36</c:v>
                </c:pt>
                <c:pt idx="271">
                  <c:v>25.1</c:v>
                </c:pt>
                <c:pt idx="272">
                  <c:v>27.12</c:v>
                </c:pt>
                <c:pt idx="273">
                  <c:v>28.89</c:v>
                </c:pt>
                <c:pt idx="274">
                  <c:v>27.89</c:v>
                </c:pt>
                <c:pt idx="275">
                  <c:v>33.75</c:v>
                </c:pt>
                <c:pt idx="276">
                  <c:v>26.54</c:v>
                </c:pt>
                <c:pt idx="277">
                  <c:v>28.69</c:v>
                </c:pt>
                <c:pt idx="278">
                  <c:v>27.77</c:v>
                </c:pt>
                <c:pt idx="279">
                  <c:v>26.65</c:v>
                </c:pt>
                <c:pt idx="280">
                  <c:v>32.08</c:v>
                </c:pt>
                <c:pt idx="281">
                  <c:v>28.89</c:v>
                </c:pt>
                <c:pt idx="282">
                  <c:v>22.74</c:v>
                </c:pt>
                <c:pt idx="283">
                  <c:v>21.41</c:v>
                </c:pt>
                <c:pt idx="284">
                  <c:v>19.79</c:v>
                </c:pt>
              </c:numCache>
            </c:numRef>
          </c:xVal>
          <c:yVal>
            <c:numRef>
              <c:f>'suq BMI cor'!$G$15:$KE$15</c:f>
              <c:numCache>
                <c:formatCode>General</c:formatCode>
                <c:ptCount val="285"/>
                <c:pt idx="0">
                  <c:v>169.6</c:v>
                </c:pt>
                <c:pt idx="1">
                  <c:v>207</c:v>
                </c:pt>
                <c:pt idx="2">
                  <c:v>162.5</c:v>
                </c:pt>
                <c:pt idx="3">
                  <c:v>191.9</c:v>
                </c:pt>
                <c:pt idx="4">
                  <c:v>14.71</c:v>
                </c:pt>
                <c:pt idx="5">
                  <c:v>159.1</c:v>
                </c:pt>
                <c:pt idx="6">
                  <c:v>100.4</c:v>
                </c:pt>
                <c:pt idx="7">
                  <c:v>145.19999999999999</c:v>
                </c:pt>
                <c:pt idx="8">
                  <c:v>95.45</c:v>
                </c:pt>
                <c:pt idx="9">
                  <c:v>61.36</c:v>
                </c:pt>
                <c:pt idx="10">
                  <c:v>125.6</c:v>
                </c:pt>
                <c:pt idx="11">
                  <c:v>29.29</c:v>
                </c:pt>
                <c:pt idx="12">
                  <c:v>132.80000000000001</c:v>
                </c:pt>
                <c:pt idx="13">
                  <c:v>140.80000000000001</c:v>
                </c:pt>
                <c:pt idx="14">
                  <c:v>59.53</c:v>
                </c:pt>
                <c:pt idx="15">
                  <c:v>24.76</c:v>
                </c:pt>
                <c:pt idx="16">
                  <c:v>40.299999999999997</c:v>
                </c:pt>
                <c:pt idx="17">
                  <c:v>84.54</c:v>
                </c:pt>
                <c:pt idx="18">
                  <c:v>185.2</c:v>
                </c:pt>
                <c:pt idx="19">
                  <c:v>124.2</c:v>
                </c:pt>
                <c:pt idx="20">
                  <c:v>59.14</c:v>
                </c:pt>
                <c:pt idx="21">
                  <c:v>78.819999999999993</c:v>
                </c:pt>
                <c:pt idx="22">
                  <c:v>40</c:v>
                </c:pt>
                <c:pt idx="23">
                  <c:v>89.49</c:v>
                </c:pt>
                <c:pt idx="24">
                  <c:v>123.2</c:v>
                </c:pt>
                <c:pt idx="25">
                  <c:v>121.5</c:v>
                </c:pt>
                <c:pt idx="26">
                  <c:v>129.69999999999999</c:v>
                </c:pt>
                <c:pt idx="27">
                  <c:v>110.5</c:v>
                </c:pt>
                <c:pt idx="28">
                  <c:v>115</c:v>
                </c:pt>
                <c:pt idx="29">
                  <c:v>168.6</c:v>
                </c:pt>
                <c:pt idx="30">
                  <c:v>82.08</c:v>
                </c:pt>
                <c:pt idx="31">
                  <c:v>5.5439999999999996</c:v>
                </c:pt>
                <c:pt idx="32">
                  <c:v>138.9</c:v>
                </c:pt>
                <c:pt idx="33">
                  <c:v>154.1</c:v>
                </c:pt>
                <c:pt idx="34">
                  <c:v>88.47</c:v>
                </c:pt>
                <c:pt idx="35">
                  <c:v>126</c:v>
                </c:pt>
                <c:pt idx="36">
                  <c:v>32.15</c:v>
                </c:pt>
                <c:pt idx="37">
                  <c:v>49.91</c:v>
                </c:pt>
                <c:pt idx="38">
                  <c:v>84.29</c:v>
                </c:pt>
                <c:pt idx="39">
                  <c:v>60.57</c:v>
                </c:pt>
                <c:pt idx="40">
                  <c:v>46.08</c:v>
                </c:pt>
                <c:pt idx="41">
                  <c:v>134.69999999999999</c:v>
                </c:pt>
                <c:pt idx="42">
                  <c:v>217.6</c:v>
                </c:pt>
                <c:pt idx="43">
                  <c:v>88.16</c:v>
                </c:pt>
                <c:pt idx="44">
                  <c:v>59.94</c:v>
                </c:pt>
                <c:pt idx="45">
                  <c:v>113.3</c:v>
                </c:pt>
                <c:pt idx="46">
                  <c:v>179.9</c:v>
                </c:pt>
                <c:pt idx="47">
                  <c:v>53.3</c:v>
                </c:pt>
                <c:pt idx="48">
                  <c:v>75.010000000000005</c:v>
                </c:pt>
                <c:pt idx="49">
                  <c:v>71.87</c:v>
                </c:pt>
                <c:pt idx="50">
                  <c:v>33.71</c:v>
                </c:pt>
                <c:pt idx="51">
                  <c:v>41.84</c:v>
                </c:pt>
                <c:pt idx="52">
                  <c:v>96.47</c:v>
                </c:pt>
                <c:pt idx="53">
                  <c:v>36.57</c:v>
                </c:pt>
                <c:pt idx="54">
                  <c:v>47.95</c:v>
                </c:pt>
                <c:pt idx="55">
                  <c:v>125.8</c:v>
                </c:pt>
                <c:pt idx="56">
                  <c:v>64.239999999999995</c:v>
                </c:pt>
                <c:pt idx="57">
                  <c:v>229.2</c:v>
                </c:pt>
                <c:pt idx="58">
                  <c:v>83.71</c:v>
                </c:pt>
                <c:pt idx="59">
                  <c:v>100.5</c:v>
                </c:pt>
                <c:pt idx="60">
                  <c:v>50.39</c:v>
                </c:pt>
                <c:pt idx="61">
                  <c:v>97.55</c:v>
                </c:pt>
                <c:pt idx="62">
                  <c:v>164.9</c:v>
                </c:pt>
                <c:pt idx="63">
                  <c:v>57.66</c:v>
                </c:pt>
                <c:pt idx="64">
                  <c:v>110.3</c:v>
                </c:pt>
                <c:pt idx="65">
                  <c:v>11.53</c:v>
                </c:pt>
                <c:pt idx="66">
                  <c:v>38.840000000000003</c:v>
                </c:pt>
                <c:pt idx="67">
                  <c:v>83.95</c:v>
                </c:pt>
                <c:pt idx="68">
                  <c:v>73.13</c:v>
                </c:pt>
                <c:pt idx="69">
                  <c:v>48.1</c:v>
                </c:pt>
                <c:pt idx="70">
                  <c:v>125</c:v>
                </c:pt>
                <c:pt idx="71">
                  <c:v>102.3</c:v>
                </c:pt>
                <c:pt idx="72">
                  <c:v>186.7</c:v>
                </c:pt>
                <c:pt idx="73">
                  <c:v>102.1</c:v>
                </c:pt>
                <c:pt idx="74">
                  <c:v>39.090000000000003</c:v>
                </c:pt>
                <c:pt idx="75">
                  <c:v>129.30000000000001</c:v>
                </c:pt>
                <c:pt idx="76">
                  <c:v>18.100000000000001</c:v>
                </c:pt>
                <c:pt idx="77">
                  <c:v>42.16</c:v>
                </c:pt>
                <c:pt idx="78">
                  <c:v>26.07</c:v>
                </c:pt>
                <c:pt idx="79">
                  <c:v>16.64</c:v>
                </c:pt>
                <c:pt idx="80">
                  <c:v>76.48</c:v>
                </c:pt>
                <c:pt idx="81">
                  <c:v>145.69999999999999</c:v>
                </c:pt>
                <c:pt idx="82">
                  <c:v>108.7</c:v>
                </c:pt>
                <c:pt idx="83">
                  <c:v>56.56</c:v>
                </c:pt>
                <c:pt idx="84">
                  <c:v>151.5</c:v>
                </c:pt>
                <c:pt idx="85">
                  <c:v>148.6</c:v>
                </c:pt>
                <c:pt idx="86">
                  <c:v>71.790000000000006</c:v>
                </c:pt>
                <c:pt idx="87">
                  <c:v>277.8</c:v>
                </c:pt>
                <c:pt idx="88">
                  <c:v>38.61</c:v>
                </c:pt>
                <c:pt idx="89">
                  <c:v>71.75</c:v>
                </c:pt>
                <c:pt idx="90">
                  <c:v>169.9</c:v>
                </c:pt>
                <c:pt idx="91">
                  <c:v>140.30000000000001</c:v>
                </c:pt>
                <c:pt idx="92">
                  <c:v>8.218</c:v>
                </c:pt>
                <c:pt idx="93">
                  <c:v>13.75</c:v>
                </c:pt>
                <c:pt idx="94">
                  <c:v>124.9</c:v>
                </c:pt>
                <c:pt idx="95">
                  <c:v>221.7</c:v>
                </c:pt>
                <c:pt idx="96">
                  <c:v>88.01</c:v>
                </c:pt>
                <c:pt idx="97">
                  <c:v>67.52</c:v>
                </c:pt>
                <c:pt idx="98">
                  <c:v>91.08</c:v>
                </c:pt>
                <c:pt idx="99">
                  <c:v>40.9</c:v>
                </c:pt>
                <c:pt idx="100">
                  <c:v>138</c:v>
                </c:pt>
                <c:pt idx="101">
                  <c:v>151.80000000000001</c:v>
                </c:pt>
                <c:pt idx="102">
                  <c:v>13.65</c:v>
                </c:pt>
                <c:pt idx="103">
                  <c:v>9.3780000000000001</c:v>
                </c:pt>
                <c:pt idx="104">
                  <c:v>13.97</c:v>
                </c:pt>
                <c:pt idx="105">
                  <c:v>60.96</c:v>
                </c:pt>
                <c:pt idx="106">
                  <c:v>58.08</c:v>
                </c:pt>
                <c:pt idx="107">
                  <c:v>175.3</c:v>
                </c:pt>
                <c:pt idx="108">
                  <c:v>269.60000000000002</c:v>
                </c:pt>
                <c:pt idx="109">
                  <c:v>20.04</c:v>
                </c:pt>
                <c:pt idx="110">
                  <c:v>109.4</c:v>
                </c:pt>
                <c:pt idx="111">
                  <c:v>73.11</c:v>
                </c:pt>
                <c:pt idx="112">
                  <c:v>29.61</c:v>
                </c:pt>
                <c:pt idx="113">
                  <c:v>45.84</c:v>
                </c:pt>
                <c:pt idx="114">
                  <c:v>71.03</c:v>
                </c:pt>
                <c:pt idx="115">
                  <c:v>70.98</c:v>
                </c:pt>
                <c:pt idx="116">
                  <c:v>80.64</c:v>
                </c:pt>
                <c:pt idx="117">
                  <c:v>68.849999999999994</c:v>
                </c:pt>
                <c:pt idx="118">
                  <c:v>37.61</c:v>
                </c:pt>
                <c:pt idx="119">
                  <c:v>101.8</c:v>
                </c:pt>
                <c:pt idx="120">
                  <c:v>14.72</c:v>
                </c:pt>
                <c:pt idx="121">
                  <c:v>256</c:v>
                </c:pt>
                <c:pt idx="122">
                  <c:v>41.65</c:v>
                </c:pt>
                <c:pt idx="123">
                  <c:v>73.28</c:v>
                </c:pt>
                <c:pt idx="124">
                  <c:v>112.4</c:v>
                </c:pt>
                <c:pt idx="125">
                  <c:v>92.12</c:v>
                </c:pt>
                <c:pt idx="126">
                  <c:v>25.82</c:v>
                </c:pt>
                <c:pt idx="127">
                  <c:v>6.819</c:v>
                </c:pt>
                <c:pt idx="128">
                  <c:v>89.64</c:v>
                </c:pt>
                <c:pt idx="129">
                  <c:v>9.9260000000000002</c:v>
                </c:pt>
                <c:pt idx="130">
                  <c:v>38.65</c:v>
                </c:pt>
                <c:pt idx="131">
                  <c:v>115.3</c:v>
                </c:pt>
                <c:pt idx="132">
                  <c:v>138.19999999999999</c:v>
                </c:pt>
                <c:pt idx="133">
                  <c:v>4.9400000000000004</c:v>
                </c:pt>
                <c:pt idx="134">
                  <c:v>78.5</c:v>
                </c:pt>
                <c:pt idx="135">
                  <c:v>61.59</c:v>
                </c:pt>
                <c:pt idx="136">
                  <c:v>156</c:v>
                </c:pt>
                <c:pt idx="137">
                  <c:v>17.68</c:v>
                </c:pt>
                <c:pt idx="138">
                  <c:v>43.98</c:v>
                </c:pt>
                <c:pt idx="139">
                  <c:v>33.89</c:v>
                </c:pt>
                <c:pt idx="140">
                  <c:v>86.87</c:v>
                </c:pt>
                <c:pt idx="141">
                  <c:v>36</c:v>
                </c:pt>
                <c:pt idx="142">
                  <c:v>16.739999999999998</c:v>
                </c:pt>
                <c:pt idx="143">
                  <c:v>56.62</c:v>
                </c:pt>
                <c:pt idx="144">
                  <c:v>102.8</c:v>
                </c:pt>
                <c:pt idx="145">
                  <c:v>84.64</c:v>
                </c:pt>
                <c:pt idx="146">
                  <c:v>88.07</c:v>
                </c:pt>
                <c:pt idx="147">
                  <c:v>56.65</c:v>
                </c:pt>
                <c:pt idx="148">
                  <c:v>150</c:v>
                </c:pt>
                <c:pt idx="149">
                  <c:v>76.98</c:v>
                </c:pt>
                <c:pt idx="150">
                  <c:v>6.5990000000000002</c:v>
                </c:pt>
                <c:pt idx="151">
                  <c:v>56.59</c:v>
                </c:pt>
                <c:pt idx="152">
                  <c:v>125.8</c:v>
                </c:pt>
                <c:pt idx="153">
                  <c:v>40.22</c:v>
                </c:pt>
                <c:pt idx="154">
                  <c:v>102.1</c:v>
                </c:pt>
                <c:pt idx="155">
                  <c:v>18.059999999999999</c:v>
                </c:pt>
                <c:pt idx="156">
                  <c:v>118.1</c:v>
                </c:pt>
                <c:pt idx="157">
                  <c:v>53.5</c:v>
                </c:pt>
                <c:pt idx="158">
                  <c:v>39.65</c:v>
                </c:pt>
                <c:pt idx="159">
                  <c:v>64.39</c:v>
                </c:pt>
                <c:pt idx="160">
                  <c:v>48.17</c:v>
                </c:pt>
                <c:pt idx="161">
                  <c:v>22.64</c:v>
                </c:pt>
                <c:pt idx="162">
                  <c:v>161.4</c:v>
                </c:pt>
                <c:pt idx="163">
                  <c:v>119.1</c:v>
                </c:pt>
                <c:pt idx="164">
                  <c:v>119.5</c:v>
                </c:pt>
                <c:pt idx="165">
                  <c:v>136</c:v>
                </c:pt>
                <c:pt idx="166">
                  <c:v>37.85</c:v>
                </c:pt>
                <c:pt idx="167">
                  <c:v>52.28</c:v>
                </c:pt>
                <c:pt idx="168">
                  <c:v>69.48</c:v>
                </c:pt>
                <c:pt idx="169">
                  <c:v>56.36</c:v>
                </c:pt>
                <c:pt idx="170">
                  <c:v>82.52</c:v>
                </c:pt>
                <c:pt idx="171">
                  <c:v>27.77</c:v>
                </c:pt>
                <c:pt idx="172">
                  <c:v>104.3</c:v>
                </c:pt>
                <c:pt idx="173">
                  <c:v>90.99</c:v>
                </c:pt>
                <c:pt idx="174">
                  <c:v>27.23</c:v>
                </c:pt>
                <c:pt idx="175">
                  <c:v>110.5</c:v>
                </c:pt>
                <c:pt idx="176">
                  <c:v>40.33</c:v>
                </c:pt>
                <c:pt idx="177">
                  <c:v>14.17</c:v>
                </c:pt>
                <c:pt idx="178">
                  <c:v>52.57</c:v>
                </c:pt>
                <c:pt idx="179">
                  <c:v>53.06</c:v>
                </c:pt>
                <c:pt idx="180">
                  <c:v>75.709999999999994</c:v>
                </c:pt>
                <c:pt idx="181">
                  <c:v>39.22</c:v>
                </c:pt>
                <c:pt idx="182">
                  <c:v>36.369999999999997</c:v>
                </c:pt>
                <c:pt idx="183">
                  <c:v>148.4</c:v>
                </c:pt>
                <c:pt idx="184">
                  <c:v>6.1070000000000002</c:v>
                </c:pt>
                <c:pt idx="185">
                  <c:v>60.05</c:v>
                </c:pt>
                <c:pt idx="186">
                  <c:v>87.23</c:v>
                </c:pt>
                <c:pt idx="187">
                  <c:v>26.92</c:v>
                </c:pt>
                <c:pt idx="188">
                  <c:v>203.6</c:v>
                </c:pt>
                <c:pt idx="189">
                  <c:v>42.8</c:v>
                </c:pt>
                <c:pt idx="190">
                  <c:v>11.87</c:v>
                </c:pt>
                <c:pt idx="191">
                  <c:v>32.89</c:v>
                </c:pt>
                <c:pt idx="192">
                  <c:v>55.97</c:v>
                </c:pt>
                <c:pt idx="193">
                  <c:v>54.56</c:v>
                </c:pt>
                <c:pt idx="194">
                  <c:v>90.18</c:v>
                </c:pt>
                <c:pt idx="195">
                  <c:v>77.7</c:v>
                </c:pt>
                <c:pt idx="196">
                  <c:v>36.619999999999997</c:v>
                </c:pt>
                <c:pt idx="197">
                  <c:v>64.12</c:v>
                </c:pt>
                <c:pt idx="198">
                  <c:v>8.91</c:v>
                </c:pt>
                <c:pt idx="199">
                  <c:v>33.33</c:v>
                </c:pt>
                <c:pt idx="200">
                  <c:v>75.28</c:v>
                </c:pt>
                <c:pt idx="201">
                  <c:v>185.8</c:v>
                </c:pt>
                <c:pt idx="202">
                  <c:v>22.75</c:v>
                </c:pt>
                <c:pt idx="203">
                  <c:v>55.7</c:v>
                </c:pt>
                <c:pt idx="204">
                  <c:v>36.24</c:v>
                </c:pt>
                <c:pt idx="205">
                  <c:v>22.48</c:v>
                </c:pt>
                <c:pt idx="206">
                  <c:v>55.07</c:v>
                </c:pt>
                <c:pt idx="207">
                  <c:v>24.26</c:v>
                </c:pt>
                <c:pt idx="208">
                  <c:v>172.1</c:v>
                </c:pt>
                <c:pt idx="209">
                  <c:v>24.97</c:v>
                </c:pt>
                <c:pt idx="210">
                  <c:v>82.94</c:v>
                </c:pt>
                <c:pt idx="211">
                  <c:v>42.63</c:v>
                </c:pt>
                <c:pt idx="212">
                  <c:v>23.52</c:v>
                </c:pt>
                <c:pt idx="213">
                  <c:v>48.93</c:v>
                </c:pt>
                <c:pt idx="214">
                  <c:v>85.42</c:v>
                </c:pt>
                <c:pt idx="215">
                  <c:v>39.020000000000003</c:v>
                </c:pt>
                <c:pt idx="216">
                  <c:v>112.7</c:v>
                </c:pt>
                <c:pt idx="217">
                  <c:v>53</c:v>
                </c:pt>
                <c:pt idx="218">
                  <c:v>270.60000000000002</c:v>
                </c:pt>
                <c:pt idx="219">
                  <c:v>28.74</c:v>
                </c:pt>
                <c:pt idx="220">
                  <c:v>33.6</c:v>
                </c:pt>
                <c:pt idx="221">
                  <c:v>22.43</c:v>
                </c:pt>
                <c:pt idx="222">
                  <c:v>10.24</c:v>
                </c:pt>
                <c:pt idx="223">
                  <c:v>140.30000000000001</c:v>
                </c:pt>
                <c:pt idx="224">
                  <c:v>36.520000000000003</c:v>
                </c:pt>
                <c:pt idx="225">
                  <c:v>374.1</c:v>
                </c:pt>
                <c:pt idx="226">
                  <c:v>124.8</c:v>
                </c:pt>
                <c:pt idx="227">
                  <c:v>110.5</c:v>
                </c:pt>
                <c:pt idx="228">
                  <c:v>140.4</c:v>
                </c:pt>
                <c:pt idx="229">
                  <c:v>42.23</c:v>
                </c:pt>
                <c:pt idx="230">
                  <c:v>13.49</c:v>
                </c:pt>
                <c:pt idx="231">
                  <c:v>113.9</c:v>
                </c:pt>
                <c:pt idx="232">
                  <c:v>19.62</c:v>
                </c:pt>
                <c:pt idx="233">
                  <c:v>36.35</c:v>
                </c:pt>
                <c:pt idx="234">
                  <c:v>5.7649999999999997</c:v>
                </c:pt>
                <c:pt idx="235">
                  <c:v>144.6</c:v>
                </c:pt>
                <c:pt idx="236">
                  <c:v>123</c:v>
                </c:pt>
                <c:pt idx="237">
                  <c:v>74.09</c:v>
                </c:pt>
                <c:pt idx="238">
                  <c:v>32</c:v>
                </c:pt>
                <c:pt idx="239">
                  <c:v>147.19999999999999</c:v>
                </c:pt>
                <c:pt idx="240">
                  <c:v>32.43</c:v>
                </c:pt>
                <c:pt idx="241">
                  <c:v>39.869999999999997</c:v>
                </c:pt>
                <c:pt idx="242">
                  <c:v>10.86</c:v>
                </c:pt>
                <c:pt idx="243">
                  <c:v>8.0820000000000007</c:v>
                </c:pt>
                <c:pt idx="244">
                  <c:v>23.69</c:v>
                </c:pt>
                <c:pt idx="245">
                  <c:v>53.02</c:v>
                </c:pt>
                <c:pt idx="246">
                  <c:v>93.96</c:v>
                </c:pt>
                <c:pt idx="247">
                  <c:v>74.459999999999994</c:v>
                </c:pt>
                <c:pt idx="248">
                  <c:v>174.5</c:v>
                </c:pt>
                <c:pt idx="249">
                  <c:v>43.43</c:v>
                </c:pt>
                <c:pt idx="250">
                  <c:v>24.14</c:v>
                </c:pt>
                <c:pt idx="251">
                  <c:v>46.64</c:v>
                </c:pt>
                <c:pt idx="252">
                  <c:v>33.07</c:v>
                </c:pt>
                <c:pt idx="253">
                  <c:v>42.18</c:v>
                </c:pt>
                <c:pt idx="254">
                  <c:v>59.06</c:v>
                </c:pt>
                <c:pt idx="255">
                  <c:v>16.510000000000002</c:v>
                </c:pt>
                <c:pt idx="256">
                  <c:v>53.52</c:v>
                </c:pt>
                <c:pt idx="257">
                  <c:v>26.95</c:v>
                </c:pt>
                <c:pt idx="258">
                  <c:v>92.85</c:v>
                </c:pt>
                <c:pt idx="259">
                  <c:v>21.39</c:v>
                </c:pt>
                <c:pt idx="260">
                  <c:v>14.06</c:v>
                </c:pt>
                <c:pt idx="261">
                  <c:v>64.78</c:v>
                </c:pt>
                <c:pt idx="262">
                  <c:v>121.6</c:v>
                </c:pt>
                <c:pt idx="263">
                  <c:v>125.9</c:v>
                </c:pt>
                <c:pt idx="264">
                  <c:v>85.52</c:v>
                </c:pt>
                <c:pt idx="265">
                  <c:v>1.694</c:v>
                </c:pt>
                <c:pt idx="266">
                  <c:v>36.92</c:v>
                </c:pt>
                <c:pt idx="267">
                  <c:v>80.39</c:v>
                </c:pt>
                <c:pt idx="268">
                  <c:v>22.95</c:v>
                </c:pt>
                <c:pt idx="269">
                  <c:v>17.100000000000001</c:v>
                </c:pt>
                <c:pt idx="270">
                  <c:v>41.93</c:v>
                </c:pt>
                <c:pt idx="271">
                  <c:v>28.32</c:v>
                </c:pt>
                <c:pt idx="272">
                  <c:v>68.260000000000005</c:v>
                </c:pt>
                <c:pt idx="273">
                  <c:v>29.62</c:v>
                </c:pt>
                <c:pt idx="274">
                  <c:v>64.98</c:v>
                </c:pt>
                <c:pt idx="275">
                  <c:v>85.19</c:v>
                </c:pt>
                <c:pt idx="276">
                  <c:v>6.8970000000000002</c:v>
                </c:pt>
                <c:pt idx="277">
                  <c:v>6.5910000000000002</c:v>
                </c:pt>
                <c:pt idx="278">
                  <c:v>100.7</c:v>
                </c:pt>
                <c:pt idx="279">
                  <c:v>72.88</c:v>
                </c:pt>
                <c:pt idx="280">
                  <c:v>126</c:v>
                </c:pt>
                <c:pt idx="281">
                  <c:v>49.26</c:v>
                </c:pt>
                <c:pt idx="282">
                  <c:v>30.71</c:v>
                </c:pt>
                <c:pt idx="283">
                  <c:v>134.80000000000001</c:v>
                </c:pt>
                <c:pt idx="284">
                  <c:v>45.42</c:v>
                </c:pt>
              </c:numCache>
            </c:numRef>
          </c:yVal>
          <c:smooth val="0"/>
          <c:extLst xmlns:c16r2="http://schemas.microsoft.com/office/drawing/2015/06/chart">
            <c:ext xmlns:c16="http://schemas.microsoft.com/office/drawing/2014/chart" uri="{C3380CC4-5D6E-409C-BE32-E72D297353CC}">
              <c16:uniqueId val="{00000000-A142-4B47-9747-4034AA2E2B5F}"/>
            </c:ext>
          </c:extLst>
        </c:ser>
        <c:ser>
          <c:idx val="1"/>
          <c:order val="1"/>
          <c:tx>
            <c:strRef>
              <c:f>'suq BMI cor'!$A$22</c:f>
              <c:strCache>
                <c:ptCount val="1"/>
                <c:pt idx="0">
                  <c:v>FEMALE</c:v>
                </c:pt>
              </c:strCache>
            </c:strRef>
          </c:tx>
          <c:spPr>
            <a:ln w="25400" cap="rnd">
              <a:noFill/>
              <a:round/>
            </a:ln>
            <a:effectLst/>
          </c:spPr>
          <c:marker>
            <c:symbol val="circle"/>
            <c:size val="3"/>
            <c:spPr>
              <a:solidFill>
                <a:schemeClr val="accent2"/>
              </a:solidFill>
              <a:ln w="9525">
                <a:solidFill>
                  <a:schemeClr val="accent2"/>
                </a:solidFill>
              </a:ln>
              <a:effectLst/>
            </c:spPr>
          </c:marker>
          <c:trendline>
            <c:spPr>
              <a:ln w="19050" cap="rnd">
                <a:solidFill>
                  <a:schemeClr val="accent2"/>
                </a:solidFill>
                <a:prstDash val="solid"/>
              </a:ln>
              <a:effectLst/>
            </c:spPr>
            <c:trendlineType val="linear"/>
            <c:dispRSqr val="0"/>
            <c:dispEq val="0"/>
          </c:trendline>
          <c:xVal>
            <c:numRef>
              <c:f>'suq BMI cor'!$G$30:$FG$30</c:f>
              <c:numCache>
                <c:formatCode>General</c:formatCode>
                <c:ptCount val="157"/>
                <c:pt idx="0">
                  <c:v>22.21</c:v>
                </c:pt>
                <c:pt idx="1">
                  <c:v>27.52</c:v>
                </c:pt>
                <c:pt idx="2">
                  <c:v>26.43</c:v>
                </c:pt>
                <c:pt idx="3">
                  <c:v>25.69</c:v>
                </c:pt>
                <c:pt idx="4">
                  <c:v>24.13</c:v>
                </c:pt>
                <c:pt idx="5">
                  <c:v>26</c:v>
                </c:pt>
                <c:pt idx="6">
                  <c:v>33.28</c:v>
                </c:pt>
                <c:pt idx="7">
                  <c:v>24.97</c:v>
                </c:pt>
                <c:pt idx="8">
                  <c:v>26.31</c:v>
                </c:pt>
                <c:pt idx="9">
                  <c:v>23.72</c:v>
                </c:pt>
                <c:pt idx="10">
                  <c:v>24.39</c:v>
                </c:pt>
                <c:pt idx="11">
                  <c:v>23.97</c:v>
                </c:pt>
                <c:pt idx="12">
                  <c:v>23.9</c:v>
                </c:pt>
                <c:pt idx="13">
                  <c:v>21.03</c:v>
                </c:pt>
                <c:pt idx="14">
                  <c:v>30.87</c:v>
                </c:pt>
                <c:pt idx="15">
                  <c:v>30.18</c:v>
                </c:pt>
                <c:pt idx="16">
                  <c:v>30.63</c:v>
                </c:pt>
                <c:pt idx="17">
                  <c:v>20.99</c:v>
                </c:pt>
                <c:pt idx="18">
                  <c:v>19.57</c:v>
                </c:pt>
                <c:pt idx="19">
                  <c:v>27.79</c:v>
                </c:pt>
                <c:pt idx="20">
                  <c:v>28.11</c:v>
                </c:pt>
                <c:pt idx="21">
                  <c:v>32.44</c:v>
                </c:pt>
                <c:pt idx="22">
                  <c:v>28.48</c:v>
                </c:pt>
                <c:pt idx="23">
                  <c:v>21.96</c:v>
                </c:pt>
                <c:pt idx="24">
                  <c:v>29.75</c:v>
                </c:pt>
                <c:pt idx="25">
                  <c:v>26.64</c:v>
                </c:pt>
                <c:pt idx="26">
                  <c:v>30.7</c:v>
                </c:pt>
                <c:pt idx="27">
                  <c:v>25.98</c:v>
                </c:pt>
                <c:pt idx="28">
                  <c:v>24.14</c:v>
                </c:pt>
                <c:pt idx="29">
                  <c:v>18.89</c:v>
                </c:pt>
                <c:pt idx="30">
                  <c:v>32.28</c:v>
                </c:pt>
                <c:pt idx="31">
                  <c:v>26.09</c:v>
                </c:pt>
                <c:pt idx="32">
                  <c:v>29.05</c:v>
                </c:pt>
                <c:pt idx="33">
                  <c:v>26.92</c:v>
                </c:pt>
                <c:pt idx="34">
                  <c:v>19.8</c:v>
                </c:pt>
                <c:pt idx="35">
                  <c:v>21.16</c:v>
                </c:pt>
                <c:pt idx="36">
                  <c:v>28.52</c:v>
                </c:pt>
                <c:pt idx="37">
                  <c:v>27.44</c:v>
                </c:pt>
                <c:pt idx="38">
                  <c:v>22.09</c:v>
                </c:pt>
                <c:pt idx="39">
                  <c:v>26.88</c:v>
                </c:pt>
                <c:pt idx="40">
                  <c:v>31.32</c:v>
                </c:pt>
                <c:pt idx="41">
                  <c:v>29.3</c:v>
                </c:pt>
                <c:pt idx="42">
                  <c:v>22.14</c:v>
                </c:pt>
                <c:pt idx="43">
                  <c:v>23.6</c:v>
                </c:pt>
                <c:pt idx="44">
                  <c:v>26.78</c:v>
                </c:pt>
                <c:pt idx="45">
                  <c:v>24.14</c:v>
                </c:pt>
                <c:pt idx="46">
                  <c:v>27.88</c:v>
                </c:pt>
                <c:pt idx="47">
                  <c:v>29.69</c:v>
                </c:pt>
                <c:pt idx="48">
                  <c:v>24.96</c:v>
                </c:pt>
                <c:pt idx="49">
                  <c:v>25.01</c:v>
                </c:pt>
                <c:pt idx="50">
                  <c:v>29.45</c:v>
                </c:pt>
                <c:pt idx="51">
                  <c:v>25.82</c:v>
                </c:pt>
                <c:pt idx="52">
                  <c:v>30.29</c:v>
                </c:pt>
                <c:pt idx="53">
                  <c:v>31.32</c:v>
                </c:pt>
                <c:pt idx="54">
                  <c:v>25.21</c:v>
                </c:pt>
                <c:pt idx="55">
                  <c:v>22.48</c:v>
                </c:pt>
                <c:pt idx="56">
                  <c:v>29.86</c:v>
                </c:pt>
                <c:pt idx="57">
                  <c:v>31.77</c:v>
                </c:pt>
                <c:pt idx="58">
                  <c:v>24.42</c:v>
                </c:pt>
                <c:pt idx="59">
                  <c:v>31.61</c:v>
                </c:pt>
                <c:pt idx="60">
                  <c:v>29.35</c:v>
                </c:pt>
                <c:pt idx="61">
                  <c:v>26.78</c:v>
                </c:pt>
                <c:pt idx="62">
                  <c:v>25.96</c:v>
                </c:pt>
                <c:pt idx="63">
                  <c:v>29.57</c:v>
                </c:pt>
                <c:pt idx="64">
                  <c:v>30.11</c:v>
                </c:pt>
                <c:pt idx="65">
                  <c:v>35.42</c:v>
                </c:pt>
                <c:pt idx="66">
                  <c:v>33.28</c:v>
                </c:pt>
                <c:pt idx="67">
                  <c:v>33.47</c:v>
                </c:pt>
                <c:pt idx="68">
                  <c:v>24.17</c:v>
                </c:pt>
                <c:pt idx="69">
                  <c:v>20.85</c:v>
                </c:pt>
                <c:pt idx="70">
                  <c:v>21.48</c:v>
                </c:pt>
                <c:pt idx="71">
                  <c:v>33.89</c:v>
                </c:pt>
                <c:pt idx="72">
                  <c:v>22.46</c:v>
                </c:pt>
                <c:pt idx="73">
                  <c:v>26.89</c:v>
                </c:pt>
                <c:pt idx="74">
                  <c:v>33.08</c:v>
                </c:pt>
                <c:pt idx="75">
                  <c:v>27.24</c:v>
                </c:pt>
                <c:pt idx="76">
                  <c:v>30.21</c:v>
                </c:pt>
                <c:pt idx="77">
                  <c:v>27.62</c:v>
                </c:pt>
                <c:pt idx="78">
                  <c:v>23.46</c:v>
                </c:pt>
                <c:pt idx="79">
                  <c:v>27.98</c:v>
                </c:pt>
                <c:pt idx="80">
                  <c:v>27.82</c:v>
                </c:pt>
                <c:pt idx="81">
                  <c:v>31.32</c:v>
                </c:pt>
                <c:pt idx="82">
                  <c:v>20.98</c:v>
                </c:pt>
                <c:pt idx="83">
                  <c:v>23.02</c:v>
                </c:pt>
                <c:pt idx="84">
                  <c:v>26.62</c:v>
                </c:pt>
                <c:pt idx="85">
                  <c:v>25.73</c:v>
                </c:pt>
                <c:pt idx="86">
                  <c:v>27.72</c:v>
                </c:pt>
                <c:pt idx="87">
                  <c:v>24.8</c:v>
                </c:pt>
                <c:pt idx="88">
                  <c:v>31.95</c:v>
                </c:pt>
                <c:pt idx="89">
                  <c:v>33.270000000000003</c:v>
                </c:pt>
                <c:pt idx="90">
                  <c:v>25.74</c:v>
                </c:pt>
                <c:pt idx="91">
                  <c:v>24.29</c:v>
                </c:pt>
                <c:pt idx="92">
                  <c:v>32.58</c:v>
                </c:pt>
                <c:pt idx="93">
                  <c:v>29.75</c:v>
                </c:pt>
                <c:pt idx="94">
                  <c:v>21.03</c:v>
                </c:pt>
                <c:pt idx="95">
                  <c:v>29.02</c:v>
                </c:pt>
                <c:pt idx="96">
                  <c:v>24.46</c:v>
                </c:pt>
                <c:pt idx="97">
                  <c:v>24.54</c:v>
                </c:pt>
                <c:pt idx="98">
                  <c:v>24.37</c:v>
                </c:pt>
                <c:pt idx="99">
                  <c:v>24.13</c:v>
                </c:pt>
                <c:pt idx="100">
                  <c:v>23.86</c:v>
                </c:pt>
                <c:pt idx="101">
                  <c:v>32.28</c:v>
                </c:pt>
                <c:pt idx="102">
                  <c:v>21.97</c:v>
                </c:pt>
                <c:pt idx="103">
                  <c:v>24.06</c:v>
                </c:pt>
                <c:pt idx="104">
                  <c:v>24.33</c:v>
                </c:pt>
                <c:pt idx="105">
                  <c:v>28.32</c:v>
                </c:pt>
                <c:pt idx="106">
                  <c:v>28.81</c:v>
                </c:pt>
                <c:pt idx="107">
                  <c:v>22.31</c:v>
                </c:pt>
                <c:pt idx="108">
                  <c:v>23.83</c:v>
                </c:pt>
                <c:pt idx="109">
                  <c:v>28.4</c:v>
                </c:pt>
                <c:pt idx="110">
                  <c:v>25.18</c:v>
                </c:pt>
                <c:pt idx="111">
                  <c:v>29.29</c:v>
                </c:pt>
                <c:pt idx="112">
                  <c:v>27.07</c:v>
                </c:pt>
                <c:pt idx="113">
                  <c:v>30.78</c:v>
                </c:pt>
                <c:pt idx="114">
                  <c:v>29.05</c:v>
                </c:pt>
                <c:pt idx="115">
                  <c:v>25.77</c:v>
                </c:pt>
                <c:pt idx="116">
                  <c:v>22.14</c:v>
                </c:pt>
                <c:pt idx="117">
                  <c:v>21.92</c:v>
                </c:pt>
                <c:pt idx="118">
                  <c:v>32.19</c:v>
                </c:pt>
                <c:pt idx="119">
                  <c:v>22.85</c:v>
                </c:pt>
                <c:pt idx="120">
                  <c:v>19.13</c:v>
                </c:pt>
                <c:pt idx="121">
                  <c:v>32.76</c:v>
                </c:pt>
                <c:pt idx="122">
                  <c:v>31.24</c:v>
                </c:pt>
                <c:pt idx="123">
                  <c:v>23.89</c:v>
                </c:pt>
                <c:pt idx="124">
                  <c:v>24.97</c:v>
                </c:pt>
                <c:pt idx="125">
                  <c:v>28.34</c:v>
                </c:pt>
                <c:pt idx="126">
                  <c:v>23.15</c:v>
                </c:pt>
                <c:pt idx="127">
                  <c:v>26.63</c:v>
                </c:pt>
                <c:pt idx="128">
                  <c:v>32.119999999999997</c:v>
                </c:pt>
                <c:pt idx="129">
                  <c:v>25.82</c:v>
                </c:pt>
                <c:pt idx="130">
                  <c:v>21.63</c:v>
                </c:pt>
                <c:pt idx="131">
                  <c:v>20.12</c:v>
                </c:pt>
                <c:pt idx="132">
                  <c:v>20.98</c:v>
                </c:pt>
                <c:pt idx="133">
                  <c:v>28.89</c:v>
                </c:pt>
                <c:pt idx="134">
                  <c:v>19.95</c:v>
                </c:pt>
                <c:pt idx="135">
                  <c:v>23.24</c:v>
                </c:pt>
                <c:pt idx="136">
                  <c:v>25.88</c:v>
                </c:pt>
                <c:pt idx="137">
                  <c:v>31.93</c:v>
                </c:pt>
                <c:pt idx="138">
                  <c:v>25.63</c:v>
                </c:pt>
                <c:pt idx="139">
                  <c:v>21.41</c:v>
                </c:pt>
                <c:pt idx="140">
                  <c:v>40.35</c:v>
                </c:pt>
                <c:pt idx="141">
                  <c:v>25.57</c:v>
                </c:pt>
                <c:pt idx="142">
                  <c:v>20.6</c:v>
                </c:pt>
                <c:pt idx="143">
                  <c:v>21.12</c:v>
                </c:pt>
                <c:pt idx="144">
                  <c:v>29.08</c:v>
                </c:pt>
                <c:pt idx="145">
                  <c:v>25.97</c:v>
                </c:pt>
                <c:pt idx="146">
                  <c:v>27.98</c:v>
                </c:pt>
                <c:pt idx="147">
                  <c:v>28.95</c:v>
                </c:pt>
                <c:pt idx="148">
                  <c:v>25.74</c:v>
                </c:pt>
                <c:pt idx="149">
                  <c:v>29.08</c:v>
                </c:pt>
                <c:pt idx="150">
                  <c:v>30.89</c:v>
                </c:pt>
                <c:pt idx="151">
                  <c:v>29.53</c:v>
                </c:pt>
                <c:pt idx="152">
                  <c:v>31.32</c:v>
                </c:pt>
                <c:pt idx="153">
                  <c:v>27.6</c:v>
                </c:pt>
                <c:pt idx="154">
                  <c:v>24.71</c:v>
                </c:pt>
                <c:pt idx="155">
                  <c:v>31.45</c:v>
                </c:pt>
                <c:pt idx="156">
                  <c:v>27.61</c:v>
                </c:pt>
              </c:numCache>
            </c:numRef>
          </c:xVal>
          <c:yVal>
            <c:numRef>
              <c:f>'suq BMI cor'!$G$36:$FG$36</c:f>
              <c:numCache>
                <c:formatCode>General</c:formatCode>
                <c:ptCount val="157"/>
                <c:pt idx="0">
                  <c:v>375.1</c:v>
                </c:pt>
                <c:pt idx="1">
                  <c:v>261.60000000000002</c:v>
                </c:pt>
                <c:pt idx="2">
                  <c:v>450.3</c:v>
                </c:pt>
                <c:pt idx="3">
                  <c:v>74.84</c:v>
                </c:pt>
                <c:pt idx="4">
                  <c:v>138.9</c:v>
                </c:pt>
                <c:pt idx="5">
                  <c:v>232.8</c:v>
                </c:pt>
                <c:pt idx="6">
                  <c:v>190.5</c:v>
                </c:pt>
                <c:pt idx="7">
                  <c:v>443.6</c:v>
                </c:pt>
                <c:pt idx="8">
                  <c:v>335.7</c:v>
                </c:pt>
                <c:pt idx="9">
                  <c:v>240.4</c:v>
                </c:pt>
                <c:pt idx="10">
                  <c:v>198.2</c:v>
                </c:pt>
                <c:pt idx="11">
                  <c:v>449.6</c:v>
                </c:pt>
                <c:pt idx="12">
                  <c:v>252.4</c:v>
                </c:pt>
                <c:pt idx="13">
                  <c:v>133.69999999999999</c:v>
                </c:pt>
                <c:pt idx="14">
                  <c:v>164.8</c:v>
                </c:pt>
                <c:pt idx="15">
                  <c:v>352.2</c:v>
                </c:pt>
                <c:pt idx="16">
                  <c:v>387.5</c:v>
                </c:pt>
                <c:pt idx="17">
                  <c:v>282.60000000000002</c:v>
                </c:pt>
                <c:pt idx="18">
                  <c:v>271.8</c:v>
                </c:pt>
                <c:pt idx="19">
                  <c:v>24.36</c:v>
                </c:pt>
                <c:pt idx="20">
                  <c:v>310.7</c:v>
                </c:pt>
                <c:pt idx="21">
                  <c:v>258.5</c:v>
                </c:pt>
                <c:pt idx="22">
                  <c:v>69.680000000000007</c:v>
                </c:pt>
                <c:pt idx="23">
                  <c:v>461.9</c:v>
                </c:pt>
                <c:pt idx="24">
                  <c:v>419.8</c:v>
                </c:pt>
                <c:pt idx="25">
                  <c:v>406.9</c:v>
                </c:pt>
                <c:pt idx="26">
                  <c:v>179.6</c:v>
                </c:pt>
                <c:pt idx="27">
                  <c:v>182.3</c:v>
                </c:pt>
                <c:pt idx="28">
                  <c:v>268.8</c:v>
                </c:pt>
                <c:pt idx="29">
                  <c:v>140.69999999999999</c:v>
                </c:pt>
                <c:pt idx="30">
                  <c:v>224</c:v>
                </c:pt>
                <c:pt idx="31">
                  <c:v>484.7</c:v>
                </c:pt>
                <c:pt idx="32">
                  <c:v>27.98</c:v>
                </c:pt>
                <c:pt idx="33">
                  <c:v>2.2650000000000001</c:v>
                </c:pt>
                <c:pt idx="34">
                  <c:v>123.4</c:v>
                </c:pt>
                <c:pt idx="35">
                  <c:v>346</c:v>
                </c:pt>
                <c:pt idx="36">
                  <c:v>311.8</c:v>
                </c:pt>
                <c:pt idx="37">
                  <c:v>218</c:v>
                </c:pt>
                <c:pt idx="38">
                  <c:v>289.89999999999998</c:v>
                </c:pt>
                <c:pt idx="39">
                  <c:v>101.4</c:v>
                </c:pt>
                <c:pt idx="40">
                  <c:v>281.2</c:v>
                </c:pt>
                <c:pt idx="41">
                  <c:v>157.6</c:v>
                </c:pt>
                <c:pt idx="42">
                  <c:v>121.8</c:v>
                </c:pt>
                <c:pt idx="43">
                  <c:v>92.38</c:v>
                </c:pt>
                <c:pt idx="44">
                  <c:v>315.89999999999998</c:v>
                </c:pt>
                <c:pt idx="45">
                  <c:v>259.10000000000002</c:v>
                </c:pt>
                <c:pt idx="46">
                  <c:v>354.9</c:v>
                </c:pt>
                <c:pt idx="47">
                  <c:v>399.9</c:v>
                </c:pt>
                <c:pt idx="48">
                  <c:v>90.75</c:v>
                </c:pt>
                <c:pt idx="49">
                  <c:v>293.2</c:v>
                </c:pt>
                <c:pt idx="50">
                  <c:v>94.35</c:v>
                </c:pt>
                <c:pt idx="51">
                  <c:v>40.29</c:v>
                </c:pt>
                <c:pt idx="52">
                  <c:v>284.39999999999998</c:v>
                </c:pt>
                <c:pt idx="53">
                  <c:v>66.95</c:v>
                </c:pt>
                <c:pt idx="54">
                  <c:v>216.3</c:v>
                </c:pt>
                <c:pt idx="55">
                  <c:v>147.30000000000001</c:v>
                </c:pt>
                <c:pt idx="56">
                  <c:v>166.6</c:v>
                </c:pt>
                <c:pt idx="57">
                  <c:v>62.4</c:v>
                </c:pt>
                <c:pt idx="58">
                  <c:v>138</c:v>
                </c:pt>
                <c:pt idx="59">
                  <c:v>331.2</c:v>
                </c:pt>
                <c:pt idx="60">
                  <c:v>283.8</c:v>
                </c:pt>
                <c:pt idx="61">
                  <c:v>25.63</c:v>
                </c:pt>
                <c:pt idx="62">
                  <c:v>28.19</c:v>
                </c:pt>
                <c:pt idx="63">
                  <c:v>68.87</c:v>
                </c:pt>
                <c:pt idx="64">
                  <c:v>212.6</c:v>
                </c:pt>
                <c:pt idx="65">
                  <c:v>132</c:v>
                </c:pt>
                <c:pt idx="66">
                  <c:v>116.5</c:v>
                </c:pt>
                <c:pt idx="67">
                  <c:v>28.19</c:v>
                </c:pt>
                <c:pt idx="68">
                  <c:v>122.8</c:v>
                </c:pt>
                <c:pt idx="69">
                  <c:v>99.61</c:v>
                </c:pt>
                <c:pt idx="70">
                  <c:v>116.1</c:v>
                </c:pt>
                <c:pt idx="71">
                  <c:v>101.6</c:v>
                </c:pt>
                <c:pt idx="72">
                  <c:v>143.5</c:v>
                </c:pt>
                <c:pt idx="73">
                  <c:v>746.4</c:v>
                </c:pt>
                <c:pt idx="74">
                  <c:v>40.700000000000003</c:v>
                </c:pt>
                <c:pt idx="75">
                  <c:v>220.5</c:v>
                </c:pt>
                <c:pt idx="76">
                  <c:v>54.15</c:v>
                </c:pt>
                <c:pt idx="77">
                  <c:v>119.1</c:v>
                </c:pt>
                <c:pt idx="78">
                  <c:v>344.6</c:v>
                </c:pt>
                <c:pt idx="79">
                  <c:v>24.05</c:v>
                </c:pt>
                <c:pt idx="80">
                  <c:v>359.2</c:v>
                </c:pt>
                <c:pt idx="81">
                  <c:v>141.5</c:v>
                </c:pt>
                <c:pt idx="82">
                  <c:v>73.650000000000006</c:v>
                </c:pt>
                <c:pt idx="83">
                  <c:v>131.6</c:v>
                </c:pt>
                <c:pt idx="84">
                  <c:v>95.2</c:v>
                </c:pt>
                <c:pt idx="85">
                  <c:v>82.22</c:v>
                </c:pt>
                <c:pt idx="86">
                  <c:v>265.60000000000002</c:v>
                </c:pt>
                <c:pt idx="87">
                  <c:v>80.5</c:v>
                </c:pt>
                <c:pt idx="88">
                  <c:v>293.8</c:v>
                </c:pt>
                <c:pt idx="89">
                  <c:v>131.6</c:v>
                </c:pt>
                <c:pt idx="90">
                  <c:v>57.79</c:v>
                </c:pt>
                <c:pt idx="91">
                  <c:v>92.21</c:v>
                </c:pt>
                <c:pt idx="92">
                  <c:v>192.8</c:v>
                </c:pt>
                <c:pt idx="93">
                  <c:v>17.37</c:v>
                </c:pt>
                <c:pt idx="94">
                  <c:v>83.37</c:v>
                </c:pt>
                <c:pt idx="95">
                  <c:v>285</c:v>
                </c:pt>
                <c:pt idx="96">
                  <c:v>172.8</c:v>
                </c:pt>
                <c:pt idx="97">
                  <c:v>92.63</c:v>
                </c:pt>
                <c:pt idx="98">
                  <c:v>306.5</c:v>
                </c:pt>
                <c:pt idx="99">
                  <c:v>62.61</c:v>
                </c:pt>
                <c:pt idx="100">
                  <c:v>91.85</c:v>
                </c:pt>
                <c:pt idx="101">
                  <c:v>201</c:v>
                </c:pt>
                <c:pt idx="102">
                  <c:v>220.9</c:v>
                </c:pt>
                <c:pt idx="103">
                  <c:v>314.3</c:v>
                </c:pt>
                <c:pt idx="104">
                  <c:v>52.24</c:v>
                </c:pt>
                <c:pt idx="105">
                  <c:v>10.47</c:v>
                </c:pt>
                <c:pt idx="106">
                  <c:v>275.2</c:v>
                </c:pt>
                <c:pt idx="107">
                  <c:v>84.65</c:v>
                </c:pt>
                <c:pt idx="108">
                  <c:v>27.13</c:v>
                </c:pt>
                <c:pt idx="109">
                  <c:v>33.04</c:v>
                </c:pt>
                <c:pt idx="110">
                  <c:v>69.44</c:v>
                </c:pt>
                <c:pt idx="111">
                  <c:v>243</c:v>
                </c:pt>
                <c:pt idx="112">
                  <c:v>161.4</c:v>
                </c:pt>
                <c:pt idx="113">
                  <c:v>248.5</c:v>
                </c:pt>
                <c:pt idx="114">
                  <c:v>109</c:v>
                </c:pt>
                <c:pt idx="115">
                  <c:v>163.19999999999999</c:v>
                </c:pt>
                <c:pt idx="116">
                  <c:v>12.97</c:v>
                </c:pt>
                <c:pt idx="117">
                  <c:v>152.9</c:v>
                </c:pt>
                <c:pt idx="118">
                  <c:v>323.8</c:v>
                </c:pt>
                <c:pt idx="119">
                  <c:v>87.46</c:v>
                </c:pt>
                <c:pt idx="120">
                  <c:v>73.239999999999995</c:v>
                </c:pt>
                <c:pt idx="121">
                  <c:v>313.60000000000002</c:v>
                </c:pt>
                <c:pt idx="122">
                  <c:v>105.4</c:v>
                </c:pt>
                <c:pt idx="123">
                  <c:v>212.4</c:v>
                </c:pt>
                <c:pt idx="124">
                  <c:v>193.6</c:v>
                </c:pt>
                <c:pt idx="125">
                  <c:v>316.7</c:v>
                </c:pt>
                <c:pt idx="126">
                  <c:v>47.14</c:v>
                </c:pt>
                <c:pt idx="127">
                  <c:v>489</c:v>
                </c:pt>
                <c:pt idx="128">
                  <c:v>38.26</c:v>
                </c:pt>
                <c:pt idx="129">
                  <c:v>351.5</c:v>
                </c:pt>
                <c:pt idx="130">
                  <c:v>331.3</c:v>
                </c:pt>
                <c:pt idx="131">
                  <c:v>157.30000000000001</c:v>
                </c:pt>
                <c:pt idx="132">
                  <c:v>24.42</c:v>
                </c:pt>
                <c:pt idx="133">
                  <c:v>71.3</c:v>
                </c:pt>
                <c:pt idx="134">
                  <c:v>78.45</c:v>
                </c:pt>
                <c:pt idx="135">
                  <c:v>24.01</c:v>
                </c:pt>
                <c:pt idx="136">
                  <c:v>226.8</c:v>
                </c:pt>
                <c:pt idx="137">
                  <c:v>174.8</c:v>
                </c:pt>
                <c:pt idx="138">
                  <c:v>158.1</c:v>
                </c:pt>
                <c:pt idx="139">
                  <c:v>86.66</c:v>
                </c:pt>
                <c:pt idx="140">
                  <c:v>93.83</c:v>
                </c:pt>
                <c:pt idx="141">
                  <c:v>389.5</c:v>
                </c:pt>
                <c:pt idx="142">
                  <c:v>155.4</c:v>
                </c:pt>
                <c:pt idx="143">
                  <c:v>180.5</c:v>
                </c:pt>
                <c:pt idx="144">
                  <c:v>165.1</c:v>
                </c:pt>
                <c:pt idx="145">
                  <c:v>17.399999999999999</c:v>
                </c:pt>
                <c:pt idx="146">
                  <c:v>200.1</c:v>
                </c:pt>
                <c:pt idx="147">
                  <c:v>20.46</c:v>
                </c:pt>
                <c:pt idx="148">
                  <c:v>77.349999999999994</c:v>
                </c:pt>
                <c:pt idx="149">
                  <c:v>231.9</c:v>
                </c:pt>
                <c:pt idx="150">
                  <c:v>113.8</c:v>
                </c:pt>
                <c:pt idx="151">
                  <c:v>118.4</c:v>
                </c:pt>
                <c:pt idx="152">
                  <c:v>46.97</c:v>
                </c:pt>
                <c:pt idx="153">
                  <c:v>19.3</c:v>
                </c:pt>
                <c:pt idx="154">
                  <c:v>5.6639999999999997</c:v>
                </c:pt>
                <c:pt idx="155">
                  <c:v>179.7</c:v>
                </c:pt>
                <c:pt idx="156">
                  <c:v>82.98</c:v>
                </c:pt>
              </c:numCache>
            </c:numRef>
          </c:yVal>
          <c:smooth val="0"/>
          <c:extLst xmlns:c16r2="http://schemas.microsoft.com/office/drawing/2015/06/chart">
            <c:ext xmlns:c16="http://schemas.microsoft.com/office/drawing/2014/chart" uri="{C3380CC4-5D6E-409C-BE32-E72D297353CC}">
              <c16:uniqueId val="{00000001-A142-4B47-9747-4034AA2E2B5F}"/>
            </c:ext>
          </c:extLst>
        </c:ser>
        <c:dLbls>
          <c:showLegendKey val="0"/>
          <c:showVal val="0"/>
          <c:showCatName val="0"/>
          <c:showSerName val="0"/>
          <c:showPercent val="0"/>
          <c:showBubbleSize val="0"/>
        </c:dLbls>
        <c:axId val="-1517553392"/>
        <c:axId val="-1517552848"/>
      </c:scatterChart>
      <c:valAx>
        <c:axId val="-1517553392"/>
        <c:scaling>
          <c:orientation val="minMax"/>
          <c:max val="40"/>
          <c:min val="15"/>
        </c:scaling>
        <c:delete val="0"/>
        <c:axPos val="b"/>
        <c:title>
          <c:tx>
            <c:rich>
              <a:bodyPr rot="0" spcFirstLastPara="1" vertOverflow="ellipsis" vert="horz" wrap="square" anchor="ctr" anchorCtr="1"/>
              <a:lstStyle/>
              <a:p>
                <a:pPr>
                  <a:defRPr sz="800" b="0" i="0" u="none" strike="noStrike" kern="1200" baseline="0">
                    <a:solidFill>
                      <a:schemeClr val="tx1">
                        <a:lumMod val="65000"/>
                        <a:lumOff val="35000"/>
                      </a:schemeClr>
                    </a:solidFill>
                    <a:latin typeface="+mn-lt"/>
                    <a:ea typeface="+mn-ea"/>
                    <a:cs typeface="+mn-cs"/>
                  </a:defRPr>
                </a:pPr>
                <a:r>
                  <a:rPr lang="en-US" dirty="0"/>
                  <a:t>BMI</a:t>
                </a:r>
                <a:endParaRPr lang="ko-KR"/>
              </a:p>
            </c:rich>
          </c:tx>
          <c:layout>
            <c:manualLayout>
              <c:xMode val="edge"/>
              <c:yMode val="edge"/>
              <c:x val="0.546525462962963"/>
              <c:y val="0.88741944444444443"/>
            </c:manualLayout>
          </c:layout>
          <c:overlay val="0"/>
          <c:spPr>
            <a:noFill/>
            <a:ln>
              <a:noFill/>
            </a:ln>
            <a:effectLst/>
          </c:spPr>
          <c:txPr>
            <a:bodyPr rot="0" spcFirstLastPara="1" vertOverflow="ellipsis" vert="horz" wrap="square" anchor="ctr" anchorCtr="1"/>
            <a:lstStyle/>
            <a:p>
              <a:pPr>
                <a:defRPr sz="8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mn-lt"/>
                <a:ea typeface="+mn-ea"/>
                <a:cs typeface="+mn-cs"/>
              </a:defRPr>
            </a:pPr>
            <a:endParaRPr lang="en-US"/>
          </a:p>
        </c:txPr>
        <c:crossAx val="-1517552848"/>
        <c:crosses val="autoZero"/>
        <c:crossBetween val="midCat"/>
      </c:valAx>
      <c:valAx>
        <c:axId val="-1517552848"/>
        <c:scaling>
          <c:orientation val="minMax"/>
        </c:scaling>
        <c:delete val="0"/>
        <c:axPos val="l"/>
        <c:title>
          <c:tx>
            <c:rich>
              <a:bodyPr rot="-5400000" spcFirstLastPara="1" vertOverflow="ellipsis" vert="horz" wrap="square" anchor="ctr" anchorCtr="1"/>
              <a:lstStyle/>
              <a:p>
                <a:pPr>
                  <a:defRPr sz="800" b="0" i="0" u="none" strike="noStrike" kern="1200" baseline="0">
                    <a:solidFill>
                      <a:schemeClr val="tx1">
                        <a:lumMod val="65000"/>
                        <a:lumOff val="35000"/>
                      </a:schemeClr>
                    </a:solidFill>
                    <a:latin typeface="+mn-lt"/>
                    <a:ea typeface="+mn-ea"/>
                    <a:cs typeface="+mn-cs"/>
                  </a:defRPr>
                </a:pPr>
                <a:r>
                  <a:rPr lang="en-US" dirty="0"/>
                  <a:t>GYG2 mRNA </a:t>
                </a:r>
                <a:r>
                  <a:rPr lang="en-US" dirty="0" smtClean="0"/>
                  <a:t>(</a:t>
                </a:r>
                <a:r>
                  <a:rPr lang="en-US" altLang="ko-KR" dirty="0" smtClean="0"/>
                  <a:t>TPM</a:t>
                </a:r>
                <a:r>
                  <a:rPr lang="en-US" dirty="0" smtClean="0"/>
                  <a:t>)</a:t>
                </a:r>
                <a:endParaRPr lang="ko-KR" dirty="0"/>
              </a:p>
            </c:rich>
          </c:tx>
          <c:overlay val="0"/>
          <c:spPr>
            <a:noFill/>
            <a:ln>
              <a:noFill/>
            </a:ln>
            <a:effectLst/>
          </c:spPr>
          <c:txPr>
            <a:bodyPr rot="-5400000" spcFirstLastPara="1" vertOverflow="ellipsis" vert="horz" wrap="square" anchor="ctr" anchorCtr="1"/>
            <a:lstStyle/>
            <a:p>
              <a:pPr>
                <a:defRPr sz="8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mn-lt"/>
                <a:ea typeface="+mn-ea"/>
                <a:cs typeface="+mn-cs"/>
              </a:defRPr>
            </a:pPr>
            <a:endParaRPr lang="en-US"/>
          </a:p>
        </c:txPr>
        <c:crossAx val="-1517553392"/>
        <c:crosses val="autoZero"/>
        <c:crossBetween val="midCat"/>
      </c:valAx>
      <c:spPr>
        <a:noFill/>
        <a:ln>
          <a:noFill/>
        </a:ln>
        <a:effectLst/>
      </c:spPr>
    </c:plotArea>
    <c:plotVisOnly val="1"/>
    <c:dispBlanksAs val="gap"/>
    <c:showDLblsOverMax val="0"/>
  </c:chart>
  <c:spPr>
    <a:noFill/>
    <a:ln>
      <a:noFill/>
    </a:ln>
    <a:effectLst/>
  </c:spPr>
  <c:txPr>
    <a:bodyPr/>
    <a:lstStyle/>
    <a:p>
      <a:pPr>
        <a:defRPr sz="800">
          <a:latin typeface="+mn-lt"/>
        </a:defRPr>
      </a:pPr>
      <a:endParaRPr lang="en-US"/>
    </a:p>
  </c:txPr>
  <c:externalData r:id="rId3">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dPt>
            <c:idx val="0"/>
            <c:bubble3D val="0"/>
            <c:spPr>
              <a:solidFill>
                <a:schemeClr val="accent1"/>
              </a:solidFill>
              <a:ln>
                <a:noFill/>
              </a:ln>
              <a:effectLst>
                <a:outerShdw blurRad="63500" sx="102000" sy="102000" algn="ctr" rotWithShape="0">
                  <a:prstClr val="black">
                    <a:alpha val="20000"/>
                  </a:prstClr>
                </a:outerShdw>
              </a:effectLst>
            </c:spPr>
            <c:extLst xmlns:c16r2="http://schemas.microsoft.com/office/drawing/2015/06/chart">
              <c:ext xmlns:c16="http://schemas.microsoft.com/office/drawing/2014/chart" uri="{C3380CC4-5D6E-409C-BE32-E72D297353CC}">
                <c16:uniqueId val="{00000001-437E-4694-B595-DC8C99A90A63}"/>
              </c:ext>
            </c:extLst>
          </c:dPt>
          <c:dPt>
            <c:idx val="1"/>
            <c:bubble3D val="0"/>
            <c:spPr>
              <a:solidFill>
                <a:schemeClr val="accent2"/>
              </a:solidFill>
              <a:ln>
                <a:noFill/>
              </a:ln>
              <a:effectLst>
                <a:outerShdw blurRad="63500" sx="102000" sy="102000" algn="ctr" rotWithShape="0">
                  <a:prstClr val="black">
                    <a:alpha val="20000"/>
                  </a:prstClr>
                </a:outerShdw>
              </a:effectLst>
            </c:spPr>
            <c:extLst xmlns:c16r2="http://schemas.microsoft.com/office/drawing/2015/06/chart">
              <c:ext xmlns:c16="http://schemas.microsoft.com/office/drawing/2014/chart" uri="{C3380CC4-5D6E-409C-BE32-E72D297353CC}">
                <c16:uniqueId val="{00000003-437E-4694-B595-DC8C99A90A63}"/>
              </c:ext>
            </c:extLst>
          </c:dPt>
          <c:dPt>
            <c:idx val="2"/>
            <c:bubble3D val="0"/>
            <c:spPr>
              <a:solidFill>
                <a:schemeClr val="accent3"/>
              </a:solidFill>
              <a:ln>
                <a:noFill/>
              </a:ln>
              <a:effectLst>
                <a:outerShdw blurRad="63500" sx="102000" sy="102000" algn="ctr" rotWithShape="0">
                  <a:prstClr val="black">
                    <a:alpha val="20000"/>
                  </a:prstClr>
                </a:outerShdw>
              </a:effectLst>
            </c:spPr>
            <c:extLst xmlns:c16r2="http://schemas.microsoft.com/office/drawing/2015/06/chart">
              <c:ext xmlns:c16="http://schemas.microsoft.com/office/drawing/2014/chart" uri="{C3380CC4-5D6E-409C-BE32-E72D297353CC}">
                <c16:uniqueId val="{00000005-437E-4694-B595-DC8C99A90A63}"/>
              </c:ext>
            </c:extLst>
          </c:dPt>
          <c:dLbls>
            <c:dLbl>
              <c:idx val="0"/>
              <c:spPr>
                <a:noFill/>
                <a:ln>
                  <a:noFill/>
                </a:ln>
                <a:effectLst/>
              </c:spPr>
              <c:txPr>
                <a:bodyPr rot="0" spcFirstLastPara="1" vertOverflow="ellipsis" vert="horz" wrap="square" lIns="38100" tIns="19050" rIns="38100" bIns="19050" anchor="ctr" anchorCtr="1">
                  <a:spAutoFit/>
                </a:bodyPr>
                <a:lstStyle/>
                <a:p>
                  <a:pPr>
                    <a:defRPr sz="1000" b="1" i="0" u="none" strike="noStrike" kern="1200" spc="0" baseline="0">
                      <a:solidFill>
                        <a:schemeClr val="accent1"/>
                      </a:solidFill>
                      <a:latin typeface="+mn-lt"/>
                      <a:ea typeface="+mn-ea"/>
                      <a:cs typeface="+mn-cs"/>
                    </a:defRPr>
                  </a:pPr>
                  <a:endParaRPr lang="en-US"/>
                </a:p>
              </c:txPr>
              <c:dLblPos val="outEnd"/>
              <c:showLegendKey val="0"/>
              <c:showVal val="0"/>
              <c:showCatName val="1"/>
              <c:showSerName val="0"/>
              <c:showPercent val="0"/>
              <c:showBubbleSize val="0"/>
            </c:dLbl>
            <c:dLbl>
              <c:idx val="1"/>
              <c:spPr>
                <a:noFill/>
                <a:ln>
                  <a:noFill/>
                </a:ln>
                <a:effectLst/>
              </c:spPr>
              <c:txPr>
                <a:bodyPr rot="0" spcFirstLastPara="1" vertOverflow="ellipsis" vert="horz" wrap="square" lIns="38100" tIns="19050" rIns="38100" bIns="19050" anchor="ctr" anchorCtr="1">
                  <a:spAutoFit/>
                </a:bodyPr>
                <a:lstStyle/>
                <a:p>
                  <a:pPr>
                    <a:defRPr sz="1000" b="1" i="0" u="none" strike="noStrike" kern="1200" spc="0" baseline="0">
                      <a:solidFill>
                        <a:schemeClr val="accent2"/>
                      </a:solidFill>
                      <a:latin typeface="+mn-lt"/>
                      <a:ea typeface="+mn-ea"/>
                      <a:cs typeface="+mn-cs"/>
                    </a:defRPr>
                  </a:pPr>
                  <a:endParaRPr lang="en-US"/>
                </a:p>
              </c:txPr>
              <c:dLblPos val="outEnd"/>
              <c:showLegendKey val="0"/>
              <c:showVal val="0"/>
              <c:showCatName val="1"/>
              <c:showSerName val="0"/>
              <c:showPercent val="0"/>
              <c:showBubbleSize val="0"/>
            </c:dLbl>
            <c:dLbl>
              <c:idx val="2"/>
              <c:spPr>
                <a:noFill/>
                <a:ln>
                  <a:noFill/>
                </a:ln>
                <a:effectLst/>
              </c:spPr>
              <c:txPr>
                <a:bodyPr rot="0" spcFirstLastPara="1" vertOverflow="ellipsis" vert="horz" wrap="square" lIns="38100" tIns="19050" rIns="38100" bIns="19050" anchor="ctr" anchorCtr="1">
                  <a:spAutoFit/>
                </a:bodyPr>
                <a:lstStyle/>
                <a:p>
                  <a:pPr>
                    <a:defRPr sz="1000" b="1" i="0" u="none" strike="noStrike" kern="1200" spc="0" baseline="0">
                      <a:solidFill>
                        <a:schemeClr val="accent3"/>
                      </a:solidFill>
                      <a:latin typeface="+mn-lt"/>
                      <a:ea typeface="+mn-ea"/>
                      <a:cs typeface="+mn-cs"/>
                    </a:defRPr>
                  </a:pPr>
                  <a:endParaRPr lang="en-US"/>
                </a:p>
              </c:txPr>
              <c:dLblPos val="outEnd"/>
              <c:showLegendKey val="0"/>
              <c:showVal val="0"/>
              <c:showCatName val="1"/>
              <c:showSerName val="0"/>
              <c:showPercent val="0"/>
              <c:showBubbleSize val="0"/>
            </c:dLbl>
            <c:spPr>
              <a:noFill/>
              <a:ln>
                <a:noFill/>
              </a:ln>
              <a:effectLst/>
            </c:spPr>
            <c:dLblPos val="outEnd"/>
            <c:showLegendKey val="0"/>
            <c:showVal val="0"/>
            <c:showCatName val="1"/>
            <c:showSerName val="0"/>
            <c:showPercent val="0"/>
            <c:showBubbleSize val="0"/>
            <c:showLeaderLines val="1"/>
            <c:leaderLines>
              <c:spPr>
                <a:ln w="9525" cap="flat" cmpd="sng" algn="ctr">
                  <a:solidFill>
                    <a:schemeClr val="tx1">
                      <a:lumMod val="35000"/>
                      <a:lumOff val="65000"/>
                    </a:schemeClr>
                  </a:solidFill>
                  <a:round/>
                </a:ln>
                <a:effectLst/>
              </c:spPr>
            </c:leaderLines>
            <c:extLst xmlns:c16r2="http://schemas.microsoft.com/office/drawing/2015/06/chart">
              <c:ext xmlns:c15="http://schemas.microsoft.com/office/drawing/2012/chart" uri="{CE6537A1-D6FC-4f65-9D91-7224C49458BB}"/>
            </c:extLst>
          </c:dLbls>
          <c:cat>
            <c:strRef>
              <c:f>'Cellage_genelist_adipose tissue'!$E$4:$E$6</c:f>
              <c:strCache>
                <c:ptCount val="3"/>
                <c:pt idx="0">
                  <c:v>&lt;1</c:v>
                </c:pt>
                <c:pt idx="1">
                  <c:v>≥1 &amp; &lt;10</c:v>
                </c:pt>
                <c:pt idx="2">
                  <c:v>&gt;10</c:v>
                </c:pt>
              </c:strCache>
            </c:strRef>
          </c:cat>
          <c:val>
            <c:numRef>
              <c:f>'Cellage_genelist_adipose tissue'!$F$4:$F$6</c:f>
              <c:numCache>
                <c:formatCode>General</c:formatCode>
                <c:ptCount val="3"/>
                <c:pt idx="0">
                  <c:v>31</c:v>
                </c:pt>
                <c:pt idx="1">
                  <c:v>54</c:v>
                </c:pt>
                <c:pt idx="2">
                  <c:v>194</c:v>
                </c:pt>
              </c:numCache>
            </c:numRef>
          </c:val>
          <c:extLst xmlns:c16r2="http://schemas.microsoft.com/office/drawing/2015/06/chart">
            <c:ext xmlns:c16="http://schemas.microsoft.com/office/drawing/2014/chart" uri="{C3380CC4-5D6E-409C-BE32-E72D297353CC}">
              <c16:uniqueId val="{00000006-437E-4694-B595-DC8C99A90A63}"/>
            </c:ext>
          </c:extLst>
        </c:ser>
        <c:dLbls>
          <c:dLblPos val="outEnd"/>
          <c:showLegendKey val="0"/>
          <c:showVal val="0"/>
          <c:showCatName val="1"/>
          <c:showSerName val="0"/>
          <c:showPercent val="0"/>
          <c:showBubbleSize val="0"/>
          <c:showLeaderLines val="1"/>
        </c:dLbls>
        <c:firstSliceAng val="0"/>
      </c:pieChart>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24297453703703703"/>
          <c:y val="4.3061111111111113E-2"/>
          <c:w val="0.69790601851851852"/>
          <c:h val="0.75107777777777773"/>
        </c:manualLayout>
      </c:layout>
      <c:scatterChart>
        <c:scatterStyle val="lineMarker"/>
        <c:varyColors val="0"/>
        <c:ser>
          <c:idx val="0"/>
          <c:order val="0"/>
          <c:tx>
            <c:strRef>
              <c:f>'GYG2 graph'!$A$14</c:f>
              <c:strCache>
                <c:ptCount val="1"/>
                <c:pt idx="0">
                  <c:v>vis_female</c:v>
                </c:pt>
              </c:strCache>
            </c:strRef>
          </c:tx>
          <c:spPr>
            <a:ln w="25400" cap="rnd">
              <a:noFill/>
              <a:round/>
            </a:ln>
            <a:effectLst/>
          </c:spPr>
          <c:marker>
            <c:symbol val="circle"/>
            <c:size val="3"/>
            <c:spPr>
              <a:solidFill>
                <a:schemeClr val="accent2"/>
              </a:solidFill>
              <a:ln w="9525">
                <a:solidFill>
                  <a:schemeClr val="accent2"/>
                </a:solidFill>
              </a:ln>
              <a:effectLst/>
            </c:spPr>
          </c:marker>
          <c:trendline>
            <c:spPr>
              <a:ln w="19050" cap="rnd">
                <a:solidFill>
                  <a:schemeClr val="accent1"/>
                </a:solidFill>
                <a:prstDash val="sysDot"/>
              </a:ln>
              <a:effectLst/>
            </c:spPr>
            <c:trendlineType val="linear"/>
            <c:dispRSqr val="0"/>
            <c:dispEq val="0"/>
          </c:trendline>
          <c:trendline>
            <c:spPr>
              <a:ln w="19050" cap="rnd">
                <a:solidFill>
                  <a:schemeClr val="accent2"/>
                </a:solidFill>
                <a:prstDash val="solid"/>
              </a:ln>
              <a:effectLst/>
            </c:spPr>
            <c:trendlineType val="linear"/>
            <c:dispRSqr val="0"/>
            <c:dispEq val="0"/>
          </c:trendline>
          <c:xVal>
            <c:numRef>
              <c:f>'GYG2 graph'!$D$16:$DD$16</c:f>
              <c:numCache>
                <c:formatCode>General</c:formatCode>
                <c:ptCount val="105"/>
                <c:pt idx="0">
                  <c:v>21</c:v>
                </c:pt>
                <c:pt idx="1">
                  <c:v>21</c:v>
                </c:pt>
                <c:pt idx="2">
                  <c:v>21</c:v>
                </c:pt>
                <c:pt idx="3">
                  <c:v>24</c:v>
                </c:pt>
                <c:pt idx="4">
                  <c:v>26</c:v>
                </c:pt>
                <c:pt idx="5">
                  <c:v>27</c:v>
                </c:pt>
                <c:pt idx="6">
                  <c:v>28</c:v>
                </c:pt>
                <c:pt idx="7">
                  <c:v>28</c:v>
                </c:pt>
                <c:pt idx="8">
                  <c:v>28</c:v>
                </c:pt>
                <c:pt idx="9">
                  <c:v>29</c:v>
                </c:pt>
                <c:pt idx="10">
                  <c:v>29</c:v>
                </c:pt>
                <c:pt idx="11">
                  <c:v>30</c:v>
                </c:pt>
                <c:pt idx="12">
                  <c:v>31</c:v>
                </c:pt>
                <c:pt idx="13">
                  <c:v>31</c:v>
                </c:pt>
                <c:pt idx="14">
                  <c:v>33</c:v>
                </c:pt>
                <c:pt idx="15">
                  <c:v>33</c:v>
                </c:pt>
                <c:pt idx="16">
                  <c:v>34</c:v>
                </c:pt>
                <c:pt idx="17">
                  <c:v>35</c:v>
                </c:pt>
                <c:pt idx="18">
                  <c:v>37</c:v>
                </c:pt>
                <c:pt idx="19">
                  <c:v>38</c:v>
                </c:pt>
                <c:pt idx="20">
                  <c:v>39</c:v>
                </c:pt>
                <c:pt idx="21">
                  <c:v>40</c:v>
                </c:pt>
                <c:pt idx="22">
                  <c:v>41</c:v>
                </c:pt>
                <c:pt idx="23">
                  <c:v>41</c:v>
                </c:pt>
                <c:pt idx="24">
                  <c:v>41</c:v>
                </c:pt>
                <c:pt idx="25">
                  <c:v>42</c:v>
                </c:pt>
                <c:pt idx="26">
                  <c:v>43</c:v>
                </c:pt>
                <c:pt idx="27">
                  <c:v>44</c:v>
                </c:pt>
                <c:pt idx="28">
                  <c:v>44</c:v>
                </c:pt>
                <c:pt idx="29">
                  <c:v>44</c:v>
                </c:pt>
                <c:pt idx="30">
                  <c:v>46</c:v>
                </c:pt>
                <c:pt idx="31">
                  <c:v>46</c:v>
                </c:pt>
                <c:pt idx="32">
                  <c:v>46</c:v>
                </c:pt>
                <c:pt idx="33">
                  <c:v>47</c:v>
                </c:pt>
                <c:pt idx="34">
                  <c:v>47</c:v>
                </c:pt>
                <c:pt idx="35">
                  <c:v>48</c:v>
                </c:pt>
                <c:pt idx="36">
                  <c:v>48</c:v>
                </c:pt>
                <c:pt idx="37">
                  <c:v>48</c:v>
                </c:pt>
                <c:pt idx="38">
                  <c:v>48</c:v>
                </c:pt>
                <c:pt idx="39">
                  <c:v>49</c:v>
                </c:pt>
                <c:pt idx="40">
                  <c:v>49</c:v>
                </c:pt>
                <c:pt idx="41">
                  <c:v>49</c:v>
                </c:pt>
                <c:pt idx="42">
                  <c:v>50</c:v>
                </c:pt>
                <c:pt idx="43">
                  <c:v>50</c:v>
                </c:pt>
                <c:pt idx="44">
                  <c:v>50</c:v>
                </c:pt>
                <c:pt idx="45">
                  <c:v>51</c:v>
                </c:pt>
                <c:pt idx="46">
                  <c:v>51</c:v>
                </c:pt>
                <c:pt idx="47">
                  <c:v>51</c:v>
                </c:pt>
                <c:pt idx="48">
                  <c:v>53</c:v>
                </c:pt>
                <c:pt idx="49">
                  <c:v>53</c:v>
                </c:pt>
                <c:pt idx="50">
                  <c:v>53</c:v>
                </c:pt>
                <c:pt idx="51">
                  <c:v>53</c:v>
                </c:pt>
                <c:pt idx="52">
                  <c:v>53</c:v>
                </c:pt>
                <c:pt idx="53">
                  <c:v>54</c:v>
                </c:pt>
                <c:pt idx="54">
                  <c:v>54</c:v>
                </c:pt>
                <c:pt idx="55">
                  <c:v>55</c:v>
                </c:pt>
                <c:pt idx="56">
                  <c:v>55</c:v>
                </c:pt>
                <c:pt idx="57">
                  <c:v>55</c:v>
                </c:pt>
                <c:pt idx="58">
                  <c:v>55</c:v>
                </c:pt>
                <c:pt idx="59">
                  <c:v>55</c:v>
                </c:pt>
                <c:pt idx="60">
                  <c:v>55</c:v>
                </c:pt>
                <c:pt idx="61">
                  <c:v>55</c:v>
                </c:pt>
                <c:pt idx="62">
                  <c:v>56</c:v>
                </c:pt>
                <c:pt idx="63">
                  <c:v>56</c:v>
                </c:pt>
                <c:pt idx="64">
                  <c:v>58</c:v>
                </c:pt>
                <c:pt idx="65">
                  <c:v>58</c:v>
                </c:pt>
                <c:pt idx="66">
                  <c:v>58</c:v>
                </c:pt>
                <c:pt idx="67">
                  <c:v>59</c:v>
                </c:pt>
                <c:pt idx="68">
                  <c:v>59</c:v>
                </c:pt>
                <c:pt idx="69">
                  <c:v>59</c:v>
                </c:pt>
                <c:pt idx="70">
                  <c:v>59</c:v>
                </c:pt>
                <c:pt idx="71">
                  <c:v>60</c:v>
                </c:pt>
                <c:pt idx="72">
                  <c:v>61</c:v>
                </c:pt>
                <c:pt idx="73">
                  <c:v>61</c:v>
                </c:pt>
                <c:pt idx="74">
                  <c:v>61</c:v>
                </c:pt>
                <c:pt idx="75">
                  <c:v>62</c:v>
                </c:pt>
                <c:pt idx="76">
                  <c:v>62</c:v>
                </c:pt>
                <c:pt idx="77">
                  <c:v>62</c:v>
                </c:pt>
                <c:pt idx="78">
                  <c:v>62</c:v>
                </c:pt>
                <c:pt idx="79">
                  <c:v>63</c:v>
                </c:pt>
                <c:pt idx="80">
                  <c:v>63</c:v>
                </c:pt>
                <c:pt idx="81">
                  <c:v>63</c:v>
                </c:pt>
                <c:pt idx="82">
                  <c:v>64</c:v>
                </c:pt>
                <c:pt idx="83">
                  <c:v>64</c:v>
                </c:pt>
                <c:pt idx="84">
                  <c:v>65</c:v>
                </c:pt>
                <c:pt idx="85">
                  <c:v>65</c:v>
                </c:pt>
                <c:pt idx="86">
                  <c:v>65</c:v>
                </c:pt>
                <c:pt idx="87">
                  <c:v>65</c:v>
                </c:pt>
                <c:pt idx="88">
                  <c:v>66</c:v>
                </c:pt>
                <c:pt idx="89">
                  <c:v>66</c:v>
                </c:pt>
                <c:pt idx="90">
                  <c:v>66</c:v>
                </c:pt>
                <c:pt idx="91">
                  <c:v>66</c:v>
                </c:pt>
                <c:pt idx="92">
                  <c:v>66</c:v>
                </c:pt>
                <c:pt idx="93">
                  <c:v>67</c:v>
                </c:pt>
                <c:pt idx="94">
                  <c:v>67</c:v>
                </c:pt>
                <c:pt idx="95">
                  <c:v>67</c:v>
                </c:pt>
                <c:pt idx="96">
                  <c:v>67</c:v>
                </c:pt>
                <c:pt idx="97">
                  <c:v>67</c:v>
                </c:pt>
                <c:pt idx="98">
                  <c:v>68</c:v>
                </c:pt>
                <c:pt idx="99">
                  <c:v>68</c:v>
                </c:pt>
                <c:pt idx="100">
                  <c:v>68</c:v>
                </c:pt>
                <c:pt idx="101">
                  <c:v>68</c:v>
                </c:pt>
                <c:pt idx="102">
                  <c:v>70</c:v>
                </c:pt>
                <c:pt idx="103">
                  <c:v>70</c:v>
                </c:pt>
                <c:pt idx="104">
                  <c:v>70</c:v>
                </c:pt>
              </c:numCache>
            </c:numRef>
          </c:xVal>
          <c:yVal>
            <c:numRef>
              <c:f>'GYG2 graph'!$D$18:$DD$18</c:f>
              <c:numCache>
                <c:formatCode>General</c:formatCode>
                <c:ptCount val="105"/>
                <c:pt idx="0">
                  <c:v>37.700000000000003</c:v>
                </c:pt>
                <c:pt idx="1">
                  <c:v>186.5</c:v>
                </c:pt>
                <c:pt idx="2">
                  <c:v>157.4</c:v>
                </c:pt>
                <c:pt idx="3">
                  <c:v>112.2</c:v>
                </c:pt>
                <c:pt idx="4">
                  <c:v>130.6</c:v>
                </c:pt>
                <c:pt idx="5">
                  <c:v>295.7</c:v>
                </c:pt>
                <c:pt idx="6">
                  <c:v>216.3</c:v>
                </c:pt>
                <c:pt idx="7">
                  <c:v>52.77</c:v>
                </c:pt>
                <c:pt idx="8">
                  <c:v>153.19999999999999</c:v>
                </c:pt>
                <c:pt idx="9">
                  <c:v>44.24</c:v>
                </c:pt>
                <c:pt idx="10">
                  <c:v>405.6</c:v>
                </c:pt>
                <c:pt idx="11">
                  <c:v>12.85</c:v>
                </c:pt>
                <c:pt idx="12">
                  <c:v>269.10000000000002</c:v>
                </c:pt>
                <c:pt idx="13">
                  <c:v>70.099999999999994</c:v>
                </c:pt>
                <c:pt idx="14">
                  <c:v>120.8</c:v>
                </c:pt>
                <c:pt idx="15">
                  <c:v>67.11</c:v>
                </c:pt>
                <c:pt idx="16">
                  <c:v>149.30000000000001</c:v>
                </c:pt>
                <c:pt idx="17">
                  <c:v>465.7</c:v>
                </c:pt>
                <c:pt idx="18">
                  <c:v>135</c:v>
                </c:pt>
                <c:pt idx="19">
                  <c:v>147.4</c:v>
                </c:pt>
                <c:pt idx="20">
                  <c:v>137.4</c:v>
                </c:pt>
                <c:pt idx="21">
                  <c:v>170.4</c:v>
                </c:pt>
                <c:pt idx="22">
                  <c:v>39.58</c:v>
                </c:pt>
                <c:pt idx="23">
                  <c:v>172.3</c:v>
                </c:pt>
                <c:pt idx="24">
                  <c:v>48.73</c:v>
                </c:pt>
                <c:pt idx="25">
                  <c:v>230.2</c:v>
                </c:pt>
                <c:pt idx="26">
                  <c:v>40.1</c:v>
                </c:pt>
                <c:pt idx="27">
                  <c:v>13.65</c:v>
                </c:pt>
                <c:pt idx="28">
                  <c:v>158.6</c:v>
                </c:pt>
                <c:pt idx="29">
                  <c:v>202.2</c:v>
                </c:pt>
                <c:pt idx="30">
                  <c:v>32.92</c:v>
                </c:pt>
                <c:pt idx="31">
                  <c:v>16.37</c:v>
                </c:pt>
                <c:pt idx="32">
                  <c:v>32.72</c:v>
                </c:pt>
                <c:pt idx="33">
                  <c:v>79.349999999999994</c:v>
                </c:pt>
                <c:pt idx="34">
                  <c:v>60.98</c:v>
                </c:pt>
                <c:pt idx="35">
                  <c:v>134.4</c:v>
                </c:pt>
                <c:pt idx="36">
                  <c:v>308.2</c:v>
                </c:pt>
                <c:pt idx="37">
                  <c:v>373.6</c:v>
                </c:pt>
                <c:pt idx="38">
                  <c:v>139.6</c:v>
                </c:pt>
                <c:pt idx="39">
                  <c:v>238.3</c:v>
                </c:pt>
                <c:pt idx="40">
                  <c:v>326.8</c:v>
                </c:pt>
                <c:pt idx="41">
                  <c:v>270.7</c:v>
                </c:pt>
                <c:pt idx="42">
                  <c:v>233.1</c:v>
                </c:pt>
                <c:pt idx="43">
                  <c:v>63.15</c:v>
                </c:pt>
                <c:pt idx="44">
                  <c:v>82.89</c:v>
                </c:pt>
                <c:pt idx="45">
                  <c:v>324.8</c:v>
                </c:pt>
                <c:pt idx="46">
                  <c:v>260.39999999999998</c:v>
                </c:pt>
                <c:pt idx="47">
                  <c:v>171</c:v>
                </c:pt>
                <c:pt idx="48">
                  <c:v>11.84</c:v>
                </c:pt>
                <c:pt idx="49">
                  <c:v>32.19</c:v>
                </c:pt>
                <c:pt idx="50">
                  <c:v>30.75</c:v>
                </c:pt>
                <c:pt idx="51">
                  <c:v>247.3</c:v>
                </c:pt>
                <c:pt idx="52">
                  <c:v>624</c:v>
                </c:pt>
                <c:pt idx="53">
                  <c:v>230.4</c:v>
                </c:pt>
                <c:pt idx="54">
                  <c:v>174</c:v>
                </c:pt>
                <c:pt idx="55">
                  <c:v>67.47</c:v>
                </c:pt>
                <c:pt idx="56">
                  <c:v>332.7</c:v>
                </c:pt>
                <c:pt idx="57">
                  <c:v>212.7</c:v>
                </c:pt>
                <c:pt idx="58">
                  <c:v>112.8</c:v>
                </c:pt>
                <c:pt idx="59">
                  <c:v>57.54</c:v>
                </c:pt>
                <c:pt idx="60">
                  <c:v>286.2</c:v>
                </c:pt>
                <c:pt idx="61">
                  <c:v>27.09</c:v>
                </c:pt>
                <c:pt idx="62">
                  <c:v>105.9</c:v>
                </c:pt>
                <c:pt idx="63">
                  <c:v>48.21</c:v>
                </c:pt>
                <c:pt idx="64">
                  <c:v>281.8</c:v>
                </c:pt>
                <c:pt idx="65">
                  <c:v>37.450000000000003</c:v>
                </c:pt>
                <c:pt idx="66">
                  <c:v>18.100000000000001</c:v>
                </c:pt>
                <c:pt idx="67">
                  <c:v>86.89</c:v>
                </c:pt>
                <c:pt idx="68">
                  <c:v>221.3</c:v>
                </c:pt>
                <c:pt idx="69">
                  <c:v>276.60000000000002</c:v>
                </c:pt>
                <c:pt idx="70">
                  <c:v>213</c:v>
                </c:pt>
                <c:pt idx="71">
                  <c:v>271.8</c:v>
                </c:pt>
                <c:pt idx="72">
                  <c:v>139</c:v>
                </c:pt>
                <c:pt idx="73">
                  <c:v>389.4</c:v>
                </c:pt>
                <c:pt idx="74">
                  <c:v>183.9</c:v>
                </c:pt>
                <c:pt idx="75">
                  <c:v>62</c:v>
                </c:pt>
                <c:pt idx="76">
                  <c:v>156</c:v>
                </c:pt>
                <c:pt idx="77">
                  <c:v>22.4</c:v>
                </c:pt>
                <c:pt idx="78">
                  <c:v>353.1</c:v>
                </c:pt>
                <c:pt idx="79">
                  <c:v>284.7</c:v>
                </c:pt>
                <c:pt idx="80">
                  <c:v>86.93</c:v>
                </c:pt>
                <c:pt idx="81">
                  <c:v>29.66</c:v>
                </c:pt>
                <c:pt idx="82">
                  <c:v>347.1</c:v>
                </c:pt>
                <c:pt idx="83">
                  <c:v>194.9</c:v>
                </c:pt>
                <c:pt idx="84">
                  <c:v>5.1230000000000002</c:v>
                </c:pt>
                <c:pt idx="85">
                  <c:v>101.3</c:v>
                </c:pt>
                <c:pt idx="86">
                  <c:v>79.09</c:v>
                </c:pt>
                <c:pt idx="87">
                  <c:v>114.4</c:v>
                </c:pt>
                <c:pt idx="88">
                  <c:v>27.15</c:v>
                </c:pt>
                <c:pt idx="89">
                  <c:v>11.46</c:v>
                </c:pt>
                <c:pt idx="90">
                  <c:v>88.31</c:v>
                </c:pt>
                <c:pt idx="91">
                  <c:v>13.83</c:v>
                </c:pt>
                <c:pt idx="92">
                  <c:v>384.2</c:v>
                </c:pt>
                <c:pt idx="93">
                  <c:v>127.4</c:v>
                </c:pt>
                <c:pt idx="94">
                  <c:v>115.2</c:v>
                </c:pt>
                <c:pt idx="95">
                  <c:v>146.5</c:v>
                </c:pt>
                <c:pt idx="96">
                  <c:v>11.49</c:v>
                </c:pt>
                <c:pt idx="97">
                  <c:v>307.60000000000002</c:v>
                </c:pt>
                <c:pt idx="98">
                  <c:v>159.30000000000001</c:v>
                </c:pt>
                <c:pt idx="99">
                  <c:v>20.079999999999998</c:v>
                </c:pt>
                <c:pt idx="100">
                  <c:v>116.4</c:v>
                </c:pt>
                <c:pt idx="101">
                  <c:v>118.6</c:v>
                </c:pt>
                <c:pt idx="102">
                  <c:v>282.8</c:v>
                </c:pt>
                <c:pt idx="103">
                  <c:v>38.020000000000003</c:v>
                </c:pt>
                <c:pt idx="104">
                  <c:v>142.5</c:v>
                </c:pt>
              </c:numCache>
            </c:numRef>
          </c:yVal>
          <c:smooth val="0"/>
          <c:extLst xmlns:c16r2="http://schemas.microsoft.com/office/drawing/2015/06/chart">
            <c:ext xmlns:c16="http://schemas.microsoft.com/office/drawing/2014/chart" uri="{C3380CC4-5D6E-409C-BE32-E72D297353CC}">
              <c16:uniqueId val="{00000000-1934-4CDC-A442-5C756DE0C599}"/>
            </c:ext>
          </c:extLst>
        </c:ser>
        <c:ser>
          <c:idx val="1"/>
          <c:order val="1"/>
          <c:tx>
            <c:strRef>
              <c:f>'GYG2 graph'!$A$20</c:f>
              <c:strCache>
                <c:ptCount val="1"/>
                <c:pt idx="0">
                  <c:v>vis_male</c:v>
                </c:pt>
              </c:strCache>
            </c:strRef>
          </c:tx>
          <c:spPr>
            <a:ln w="25400" cap="rnd">
              <a:noFill/>
              <a:round/>
            </a:ln>
            <a:effectLst/>
          </c:spPr>
          <c:marker>
            <c:symbol val="circle"/>
            <c:size val="3"/>
            <c:spPr>
              <a:solidFill>
                <a:schemeClr val="accent1"/>
              </a:solidFill>
              <a:ln w="9525">
                <a:solidFill>
                  <a:schemeClr val="accent1"/>
                </a:solidFill>
              </a:ln>
              <a:effectLst/>
            </c:spPr>
          </c:marker>
          <c:trendline>
            <c:spPr>
              <a:ln w="25400" cap="rnd">
                <a:solidFill>
                  <a:schemeClr val="accent2"/>
                </a:solidFill>
                <a:prstDash val="solid"/>
              </a:ln>
              <a:effectLst/>
            </c:spPr>
            <c:trendlineType val="linear"/>
            <c:dispRSqr val="0"/>
            <c:dispEq val="0"/>
          </c:trendline>
          <c:xVal>
            <c:numRef>
              <c:f>'GYG2 graph'!$D$22:$HV$22</c:f>
              <c:numCache>
                <c:formatCode>General</c:formatCode>
                <c:ptCount val="227"/>
                <c:pt idx="0">
                  <c:v>21</c:v>
                </c:pt>
                <c:pt idx="1">
                  <c:v>21</c:v>
                </c:pt>
                <c:pt idx="2">
                  <c:v>22</c:v>
                </c:pt>
                <c:pt idx="3">
                  <c:v>22</c:v>
                </c:pt>
                <c:pt idx="4">
                  <c:v>23</c:v>
                </c:pt>
                <c:pt idx="5">
                  <c:v>23</c:v>
                </c:pt>
                <c:pt idx="6">
                  <c:v>24</c:v>
                </c:pt>
                <c:pt idx="7">
                  <c:v>24</c:v>
                </c:pt>
                <c:pt idx="8">
                  <c:v>24</c:v>
                </c:pt>
                <c:pt idx="9">
                  <c:v>26</c:v>
                </c:pt>
                <c:pt idx="10">
                  <c:v>26</c:v>
                </c:pt>
                <c:pt idx="11">
                  <c:v>27</c:v>
                </c:pt>
                <c:pt idx="12">
                  <c:v>29</c:v>
                </c:pt>
                <c:pt idx="13">
                  <c:v>29</c:v>
                </c:pt>
                <c:pt idx="14">
                  <c:v>30</c:v>
                </c:pt>
                <c:pt idx="15">
                  <c:v>31</c:v>
                </c:pt>
                <c:pt idx="16">
                  <c:v>31</c:v>
                </c:pt>
                <c:pt idx="17">
                  <c:v>32</c:v>
                </c:pt>
                <c:pt idx="18">
                  <c:v>32</c:v>
                </c:pt>
                <c:pt idx="19">
                  <c:v>32</c:v>
                </c:pt>
                <c:pt idx="20">
                  <c:v>33</c:v>
                </c:pt>
                <c:pt idx="21">
                  <c:v>34</c:v>
                </c:pt>
                <c:pt idx="22">
                  <c:v>35</c:v>
                </c:pt>
                <c:pt idx="23">
                  <c:v>35</c:v>
                </c:pt>
                <c:pt idx="24">
                  <c:v>36</c:v>
                </c:pt>
                <c:pt idx="25">
                  <c:v>36</c:v>
                </c:pt>
                <c:pt idx="26">
                  <c:v>37</c:v>
                </c:pt>
                <c:pt idx="27">
                  <c:v>37</c:v>
                </c:pt>
                <c:pt idx="28">
                  <c:v>37</c:v>
                </c:pt>
                <c:pt idx="29">
                  <c:v>38</c:v>
                </c:pt>
                <c:pt idx="30">
                  <c:v>38</c:v>
                </c:pt>
                <c:pt idx="31">
                  <c:v>38</c:v>
                </c:pt>
                <c:pt idx="32">
                  <c:v>40</c:v>
                </c:pt>
                <c:pt idx="33">
                  <c:v>40</c:v>
                </c:pt>
                <c:pt idx="34">
                  <c:v>41</c:v>
                </c:pt>
                <c:pt idx="35">
                  <c:v>42</c:v>
                </c:pt>
                <c:pt idx="36">
                  <c:v>42</c:v>
                </c:pt>
                <c:pt idx="37">
                  <c:v>43</c:v>
                </c:pt>
                <c:pt idx="38">
                  <c:v>43</c:v>
                </c:pt>
                <c:pt idx="39">
                  <c:v>43</c:v>
                </c:pt>
                <c:pt idx="40">
                  <c:v>44</c:v>
                </c:pt>
                <c:pt idx="41">
                  <c:v>44</c:v>
                </c:pt>
                <c:pt idx="42">
                  <c:v>44</c:v>
                </c:pt>
                <c:pt idx="43">
                  <c:v>44</c:v>
                </c:pt>
                <c:pt idx="44">
                  <c:v>44</c:v>
                </c:pt>
                <c:pt idx="45">
                  <c:v>44</c:v>
                </c:pt>
                <c:pt idx="46">
                  <c:v>45</c:v>
                </c:pt>
                <c:pt idx="47">
                  <c:v>46</c:v>
                </c:pt>
                <c:pt idx="48">
                  <c:v>46</c:v>
                </c:pt>
                <c:pt idx="49">
                  <c:v>46</c:v>
                </c:pt>
                <c:pt idx="50">
                  <c:v>47</c:v>
                </c:pt>
                <c:pt idx="51">
                  <c:v>47</c:v>
                </c:pt>
                <c:pt idx="52">
                  <c:v>47</c:v>
                </c:pt>
                <c:pt idx="53">
                  <c:v>47</c:v>
                </c:pt>
                <c:pt idx="54">
                  <c:v>47</c:v>
                </c:pt>
                <c:pt idx="55">
                  <c:v>47</c:v>
                </c:pt>
                <c:pt idx="56">
                  <c:v>47</c:v>
                </c:pt>
                <c:pt idx="57">
                  <c:v>48</c:v>
                </c:pt>
                <c:pt idx="58">
                  <c:v>48</c:v>
                </c:pt>
                <c:pt idx="59">
                  <c:v>48</c:v>
                </c:pt>
                <c:pt idx="60">
                  <c:v>49</c:v>
                </c:pt>
                <c:pt idx="61">
                  <c:v>49</c:v>
                </c:pt>
                <c:pt idx="62">
                  <c:v>49</c:v>
                </c:pt>
                <c:pt idx="63">
                  <c:v>50</c:v>
                </c:pt>
                <c:pt idx="64">
                  <c:v>50</c:v>
                </c:pt>
                <c:pt idx="65">
                  <c:v>50</c:v>
                </c:pt>
                <c:pt idx="66">
                  <c:v>50</c:v>
                </c:pt>
                <c:pt idx="67">
                  <c:v>50</c:v>
                </c:pt>
                <c:pt idx="68">
                  <c:v>50</c:v>
                </c:pt>
                <c:pt idx="69">
                  <c:v>50</c:v>
                </c:pt>
                <c:pt idx="70">
                  <c:v>50</c:v>
                </c:pt>
                <c:pt idx="71">
                  <c:v>50</c:v>
                </c:pt>
                <c:pt idx="72">
                  <c:v>50</c:v>
                </c:pt>
                <c:pt idx="73">
                  <c:v>50</c:v>
                </c:pt>
                <c:pt idx="74">
                  <c:v>51</c:v>
                </c:pt>
                <c:pt idx="75">
                  <c:v>51</c:v>
                </c:pt>
                <c:pt idx="76">
                  <c:v>51</c:v>
                </c:pt>
                <c:pt idx="77">
                  <c:v>51</c:v>
                </c:pt>
                <c:pt idx="78">
                  <c:v>52</c:v>
                </c:pt>
                <c:pt idx="79">
                  <c:v>52</c:v>
                </c:pt>
                <c:pt idx="80">
                  <c:v>52</c:v>
                </c:pt>
                <c:pt idx="81">
                  <c:v>52</c:v>
                </c:pt>
                <c:pt idx="82">
                  <c:v>52</c:v>
                </c:pt>
                <c:pt idx="83">
                  <c:v>52</c:v>
                </c:pt>
                <c:pt idx="84">
                  <c:v>53</c:v>
                </c:pt>
                <c:pt idx="85">
                  <c:v>53</c:v>
                </c:pt>
                <c:pt idx="86">
                  <c:v>53</c:v>
                </c:pt>
                <c:pt idx="87">
                  <c:v>53</c:v>
                </c:pt>
                <c:pt idx="88">
                  <c:v>53</c:v>
                </c:pt>
                <c:pt idx="89">
                  <c:v>53</c:v>
                </c:pt>
                <c:pt idx="90">
                  <c:v>53</c:v>
                </c:pt>
                <c:pt idx="91">
                  <c:v>53</c:v>
                </c:pt>
                <c:pt idx="92">
                  <c:v>53</c:v>
                </c:pt>
                <c:pt idx="93">
                  <c:v>53</c:v>
                </c:pt>
                <c:pt idx="94">
                  <c:v>53</c:v>
                </c:pt>
                <c:pt idx="95">
                  <c:v>54</c:v>
                </c:pt>
                <c:pt idx="96">
                  <c:v>54</c:v>
                </c:pt>
                <c:pt idx="97">
                  <c:v>54</c:v>
                </c:pt>
                <c:pt idx="98">
                  <c:v>54</c:v>
                </c:pt>
                <c:pt idx="99">
                  <c:v>54</c:v>
                </c:pt>
                <c:pt idx="100">
                  <c:v>54</c:v>
                </c:pt>
                <c:pt idx="101">
                  <c:v>54</c:v>
                </c:pt>
                <c:pt idx="102">
                  <c:v>54</c:v>
                </c:pt>
                <c:pt idx="103">
                  <c:v>54</c:v>
                </c:pt>
                <c:pt idx="104">
                  <c:v>54</c:v>
                </c:pt>
                <c:pt idx="105">
                  <c:v>54</c:v>
                </c:pt>
                <c:pt idx="106">
                  <c:v>55</c:v>
                </c:pt>
                <c:pt idx="107">
                  <c:v>55</c:v>
                </c:pt>
                <c:pt idx="108">
                  <c:v>55</c:v>
                </c:pt>
                <c:pt idx="109">
                  <c:v>55</c:v>
                </c:pt>
                <c:pt idx="110">
                  <c:v>55</c:v>
                </c:pt>
                <c:pt idx="111">
                  <c:v>56</c:v>
                </c:pt>
                <c:pt idx="112">
                  <c:v>56</c:v>
                </c:pt>
                <c:pt idx="113">
                  <c:v>56</c:v>
                </c:pt>
                <c:pt idx="114">
                  <c:v>56</c:v>
                </c:pt>
                <c:pt idx="115">
                  <c:v>56</c:v>
                </c:pt>
                <c:pt idx="116">
                  <c:v>56</c:v>
                </c:pt>
                <c:pt idx="117">
                  <c:v>56</c:v>
                </c:pt>
                <c:pt idx="118">
                  <c:v>56</c:v>
                </c:pt>
                <c:pt idx="119">
                  <c:v>56</c:v>
                </c:pt>
                <c:pt idx="120">
                  <c:v>57</c:v>
                </c:pt>
                <c:pt idx="121">
                  <c:v>57</c:v>
                </c:pt>
                <c:pt idx="122">
                  <c:v>57</c:v>
                </c:pt>
                <c:pt idx="123">
                  <c:v>57</c:v>
                </c:pt>
                <c:pt idx="124">
                  <c:v>57</c:v>
                </c:pt>
                <c:pt idx="125">
                  <c:v>57</c:v>
                </c:pt>
                <c:pt idx="126">
                  <c:v>57</c:v>
                </c:pt>
                <c:pt idx="127">
                  <c:v>57</c:v>
                </c:pt>
                <c:pt idx="128">
                  <c:v>57</c:v>
                </c:pt>
                <c:pt idx="129">
                  <c:v>57</c:v>
                </c:pt>
                <c:pt idx="130">
                  <c:v>58</c:v>
                </c:pt>
                <c:pt idx="131">
                  <c:v>58</c:v>
                </c:pt>
                <c:pt idx="132">
                  <c:v>58</c:v>
                </c:pt>
                <c:pt idx="133">
                  <c:v>58</c:v>
                </c:pt>
                <c:pt idx="134">
                  <c:v>58</c:v>
                </c:pt>
                <c:pt idx="135">
                  <c:v>58</c:v>
                </c:pt>
                <c:pt idx="136">
                  <c:v>58</c:v>
                </c:pt>
                <c:pt idx="137">
                  <c:v>59</c:v>
                </c:pt>
                <c:pt idx="138">
                  <c:v>59</c:v>
                </c:pt>
                <c:pt idx="139">
                  <c:v>59</c:v>
                </c:pt>
                <c:pt idx="140">
                  <c:v>59</c:v>
                </c:pt>
                <c:pt idx="141">
                  <c:v>59</c:v>
                </c:pt>
                <c:pt idx="142">
                  <c:v>59</c:v>
                </c:pt>
                <c:pt idx="143">
                  <c:v>59</c:v>
                </c:pt>
                <c:pt idx="144">
                  <c:v>59</c:v>
                </c:pt>
                <c:pt idx="145">
                  <c:v>59</c:v>
                </c:pt>
                <c:pt idx="146">
                  <c:v>59</c:v>
                </c:pt>
                <c:pt idx="147">
                  <c:v>59</c:v>
                </c:pt>
                <c:pt idx="148">
                  <c:v>60</c:v>
                </c:pt>
                <c:pt idx="149">
                  <c:v>60</c:v>
                </c:pt>
                <c:pt idx="150">
                  <c:v>60</c:v>
                </c:pt>
                <c:pt idx="151">
                  <c:v>60</c:v>
                </c:pt>
                <c:pt idx="152">
                  <c:v>60</c:v>
                </c:pt>
                <c:pt idx="153">
                  <c:v>60</c:v>
                </c:pt>
                <c:pt idx="154">
                  <c:v>60</c:v>
                </c:pt>
                <c:pt idx="155">
                  <c:v>61</c:v>
                </c:pt>
                <c:pt idx="156">
                  <c:v>61</c:v>
                </c:pt>
                <c:pt idx="157">
                  <c:v>61</c:v>
                </c:pt>
                <c:pt idx="158">
                  <c:v>61</c:v>
                </c:pt>
                <c:pt idx="159">
                  <c:v>61</c:v>
                </c:pt>
                <c:pt idx="160">
                  <c:v>61</c:v>
                </c:pt>
                <c:pt idx="161">
                  <c:v>62</c:v>
                </c:pt>
                <c:pt idx="162">
                  <c:v>62</c:v>
                </c:pt>
                <c:pt idx="163">
                  <c:v>62</c:v>
                </c:pt>
                <c:pt idx="164">
                  <c:v>62</c:v>
                </c:pt>
                <c:pt idx="165">
                  <c:v>62</c:v>
                </c:pt>
                <c:pt idx="166">
                  <c:v>62</c:v>
                </c:pt>
                <c:pt idx="167">
                  <c:v>63</c:v>
                </c:pt>
                <c:pt idx="168">
                  <c:v>63</c:v>
                </c:pt>
                <c:pt idx="169">
                  <c:v>63</c:v>
                </c:pt>
                <c:pt idx="170">
                  <c:v>63</c:v>
                </c:pt>
                <c:pt idx="171">
                  <c:v>63</c:v>
                </c:pt>
                <c:pt idx="172">
                  <c:v>63</c:v>
                </c:pt>
                <c:pt idx="173">
                  <c:v>63</c:v>
                </c:pt>
                <c:pt idx="174">
                  <c:v>63</c:v>
                </c:pt>
                <c:pt idx="175">
                  <c:v>63</c:v>
                </c:pt>
                <c:pt idx="176">
                  <c:v>64</c:v>
                </c:pt>
                <c:pt idx="177">
                  <c:v>64</c:v>
                </c:pt>
                <c:pt idx="178">
                  <c:v>64</c:v>
                </c:pt>
                <c:pt idx="179">
                  <c:v>64</c:v>
                </c:pt>
                <c:pt idx="180">
                  <c:v>64</c:v>
                </c:pt>
                <c:pt idx="181">
                  <c:v>64</c:v>
                </c:pt>
                <c:pt idx="182">
                  <c:v>64</c:v>
                </c:pt>
                <c:pt idx="183">
                  <c:v>65</c:v>
                </c:pt>
                <c:pt idx="184">
                  <c:v>65</c:v>
                </c:pt>
                <c:pt idx="185">
                  <c:v>65</c:v>
                </c:pt>
                <c:pt idx="186">
                  <c:v>65</c:v>
                </c:pt>
                <c:pt idx="187">
                  <c:v>65</c:v>
                </c:pt>
                <c:pt idx="188">
                  <c:v>65</c:v>
                </c:pt>
                <c:pt idx="189">
                  <c:v>66</c:v>
                </c:pt>
                <c:pt idx="190">
                  <c:v>66</c:v>
                </c:pt>
                <c:pt idx="191">
                  <c:v>66</c:v>
                </c:pt>
                <c:pt idx="192">
                  <c:v>66</c:v>
                </c:pt>
                <c:pt idx="193">
                  <c:v>66</c:v>
                </c:pt>
                <c:pt idx="194">
                  <c:v>66</c:v>
                </c:pt>
                <c:pt idx="195">
                  <c:v>66</c:v>
                </c:pt>
                <c:pt idx="196">
                  <c:v>66</c:v>
                </c:pt>
                <c:pt idx="197">
                  <c:v>66</c:v>
                </c:pt>
                <c:pt idx="198">
                  <c:v>67</c:v>
                </c:pt>
                <c:pt idx="199">
                  <c:v>67</c:v>
                </c:pt>
                <c:pt idx="200">
                  <c:v>67</c:v>
                </c:pt>
                <c:pt idx="201">
                  <c:v>67</c:v>
                </c:pt>
                <c:pt idx="202">
                  <c:v>68</c:v>
                </c:pt>
                <c:pt idx="203">
                  <c:v>68</c:v>
                </c:pt>
                <c:pt idx="204">
                  <c:v>68</c:v>
                </c:pt>
                <c:pt idx="205">
                  <c:v>68</c:v>
                </c:pt>
                <c:pt idx="206">
                  <c:v>68</c:v>
                </c:pt>
                <c:pt idx="207">
                  <c:v>68</c:v>
                </c:pt>
                <c:pt idx="208">
                  <c:v>68</c:v>
                </c:pt>
                <c:pt idx="209">
                  <c:v>68</c:v>
                </c:pt>
                <c:pt idx="210">
                  <c:v>69</c:v>
                </c:pt>
                <c:pt idx="211">
                  <c:v>69</c:v>
                </c:pt>
                <c:pt idx="212">
                  <c:v>69</c:v>
                </c:pt>
                <c:pt idx="213">
                  <c:v>69</c:v>
                </c:pt>
                <c:pt idx="214">
                  <c:v>69</c:v>
                </c:pt>
                <c:pt idx="215">
                  <c:v>69</c:v>
                </c:pt>
                <c:pt idx="216">
                  <c:v>69</c:v>
                </c:pt>
                <c:pt idx="217">
                  <c:v>69</c:v>
                </c:pt>
                <c:pt idx="218">
                  <c:v>69</c:v>
                </c:pt>
                <c:pt idx="219">
                  <c:v>70</c:v>
                </c:pt>
                <c:pt idx="220">
                  <c:v>70</c:v>
                </c:pt>
                <c:pt idx="221">
                  <c:v>70</c:v>
                </c:pt>
                <c:pt idx="222">
                  <c:v>70</c:v>
                </c:pt>
                <c:pt idx="223">
                  <c:v>70</c:v>
                </c:pt>
                <c:pt idx="224">
                  <c:v>70</c:v>
                </c:pt>
                <c:pt idx="225">
                  <c:v>70</c:v>
                </c:pt>
                <c:pt idx="226">
                  <c:v>70</c:v>
                </c:pt>
              </c:numCache>
            </c:numRef>
          </c:xVal>
          <c:yVal>
            <c:numRef>
              <c:f>'GYG2 graph'!$D$24:$HV$24</c:f>
              <c:numCache>
                <c:formatCode>General</c:formatCode>
                <c:ptCount val="227"/>
                <c:pt idx="0">
                  <c:v>121.2</c:v>
                </c:pt>
                <c:pt idx="1">
                  <c:v>16.149999999999999</c:v>
                </c:pt>
                <c:pt idx="2">
                  <c:v>27.4</c:v>
                </c:pt>
                <c:pt idx="3">
                  <c:v>78</c:v>
                </c:pt>
                <c:pt idx="4">
                  <c:v>77.25</c:v>
                </c:pt>
                <c:pt idx="5">
                  <c:v>13.25</c:v>
                </c:pt>
                <c:pt idx="6">
                  <c:v>12.28</c:v>
                </c:pt>
                <c:pt idx="7">
                  <c:v>8.7490000000000006</c:v>
                </c:pt>
                <c:pt idx="8">
                  <c:v>147.19999999999999</c:v>
                </c:pt>
                <c:pt idx="9">
                  <c:v>12.7</c:v>
                </c:pt>
                <c:pt idx="10">
                  <c:v>66.739999999999995</c:v>
                </c:pt>
                <c:pt idx="11">
                  <c:v>14.37</c:v>
                </c:pt>
                <c:pt idx="12">
                  <c:v>89.28</c:v>
                </c:pt>
                <c:pt idx="13">
                  <c:v>139.30000000000001</c:v>
                </c:pt>
                <c:pt idx="14">
                  <c:v>71.77</c:v>
                </c:pt>
                <c:pt idx="15">
                  <c:v>33.93</c:v>
                </c:pt>
                <c:pt idx="16">
                  <c:v>171.2</c:v>
                </c:pt>
                <c:pt idx="17">
                  <c:v>29.46</c:v>
                </c:pt>
                <c:pt idx="18">
                  <c:v>125.8</c:v>
                </c:pt>
                <c:pt idx="19">
                  <c:v>5.3860000000000001</c:v>
                </c:pt>
                <c:pt idx="20">
                  <c:v>222.7</c:v>
                </c:pt>
                <c:pt idx="21">
                  <c:v>72.150000000000006</c:v>
                </c:pt>
                <c:pt idx="22">
                  <c:v>87.43</c:v>
                </c:pt>
                <c:pt idx="23">
                  <c:v>3.0070000000000001</c:v>
                </c:pt>
                <c:pt idx="24">
                  <c:v>25.88</c:v>
                </c:pt>
                <c:pt idx="25">
                  <c:v>56.01</c:v>
                </c:pt>
                <c:pt idx="26">
                  <c:v>27.11</c:v>
                </c:pt>
                <c:pt idx="27">
                  <c:v>42.19</c:v>
                </c:pt>
                <c:pt idx="28">
                  <c:v>81.41</c:v>
                </c:pt>
                <c:pt idx="29">
                  <c:v>144.6</c:v>
                </c:pt>
                <c:pt idx="30">
                  <c:v>60.99</c:v>
                </c:pt>
                <c:pt idx="31">
                  <c:v>35.880000000000003</c:v>
                </c:pt>
                <c:pt idx="32">
                  <c:v>26.45</c:v>
                </c:pt>
                <c:pt idx="33">
                  <c:v>70.88</c:v>
                </c:pt>
                <c:pt idx="34">
                  <c:v>94.59</c:v>
                </c:pt>
                <c:pt idx="35">
                  <c:v>13.49</c:v>
                </c:pt>
                <c:pt idx="36">
                  <c:v>99.26</c:v>
                </c:pt>
                <c:pt idx="37">
                  <c:v>136</c:v>
                </c:pt>
                <c:pt idx="38">
                  <c:v>73.56</c:v>
                </c:pt>
                <c:pt idx="39">
                  <c:v>17.41</c:v>
                </c:pt>
                <c:pt idx="40">
                  <c:v>119.2</c:v>
                </c:pt>
                <c:pt idx="41">
                  <c:v>34.39</c:v>
                </c:pt>
                <c:pt idx="42">
                  <c:v>72.48</c:v>
                </c:pt>
                <c:pt idx="43">
                  <c:v>14.15</c:v>
                </c:pt>
                <c:pt idx="44">
                  <c:v>63.91</c:v>
                </c:pt>
                <c:pt idx="45">
                  <c:v>124.1</c:v>
                </c:pt>
                <c:pt idx="46">
                  <c:v>116.3</c:v>
                </c:pt>
                <c:pt idx="47">
                  <c:v>44.23</c:v>
                </c:pt>
                <c:pt idx="48">
                  <c:v>14.11</c:v>
                </c:pt>
                <c:pt idx="49">
                  <c:v>38.07</c:v>
                </c:pt>
                <c:pt idx="50">
                  <c:v>8.9290000000000003</c:v>
                </c:pt>
                <c:pt idx="51">
                  <c:v>117.2</c:v>
                </c:pt>
                <c:pt idx="52">
                  <c:v>133.69999999999999</c:v>
                </c:pt>
                <c:pt idx="53">
                  <c:v>53.61</c:v>
                </c:pt>
                <c:pt idx="54">
                  <c:v>76.66</c:v>
                </c:pt>
                <c:pt idx="55">
                  <c:v>94.88</c:v>
                </c:pt>
                <c:pt idx="56">
                  <c:v>129.5</c:v>
                </c:pt>
                <c:pt idx="57">
                  <c:v>15.53</c:v>
                </c:pt>
                <c:pt idx="58">
                  <c:v>33.770000000000003</c:v>
                </c:pt>
                <c:pt idx="59">
                  <c:v>192.9</c:v>
                </c:pt>
                <c:pt idx="60">
                  <c:v>4.0380000000000003</c:v>
                </c:pt>
                <c:pt idx="61">
                  <c:v>157.9</c:v>
                </c:pt>
                <c:pt idx="62">
                  <c:v>100.1</c:v>
                </c:pt>
                <c:pt idx="63">
                  <c:v>79.92</c:v>
                </c:pt>
                <c:pt idx="64">
                  <c:v>78.55</c:v>
                </c:pt>
                <c:pt idx="65">
                  <c:v>59.07</c:v>
                </c:pt>
                <c:pt idx="66">
                  <c:v>2.903</c:v>
                </c:pt>
                <c:pt idx="67">
                  <c:v>65.64</c:v>
                </c:pt>
                <c:pt idx="68">
                  <c:v>240.9</c:v>
                </c:pt>
                <c:pt idx="69">
                  <c:v>108.7</c:v>
                </c:pt>
                <c:pt idx="70">
                  <c:v>37.75</c:v>
                </c:pt>
                <c:pt idx="71">
                  <c:v>166.7</c:v>
                </c:pt>
                <c:pt idx="72">
                  <c:v>136.4</c:v>
                </c:pt>
                <c:pt idx="73">
                  <c:v>151</c:v>
                </c:pt>
                <c:pt idx="74">
                  <c:v>82.63</c:v>
                </c:pt>
                <c:pt idx="75">
                  <c:v>221.5</c:v>
                </c:pt>
                <c:pt idx="76">
                  <c:v>45.36</c:v>
                </c:pt>
                <c:pt idx="77">
                  <c:v>96.23</c:v>
                </c:pt>
                <c:pt idx="78">
                  <c:v>70.27</c:v>
                </c:pt>
                <c:pt idx="79">
                  <c:v>95.68</c:v>
                </c:pt>
                <c:pt idx="80">
                  <c:v>96.62</c:v>
                </c:pt>
                <c:pt idx="81">
                  <c:v>5.4329999999999998</c:v>
                </c:pt>
                <c:pt idx="82">
                  <c:v>27.48</c:v>
                </c:pt>
                <c:pt idx="83">
                  <c:v>82.15</c:v>
                </c:pt>
                <c:pt idx="84">
                  <c:v>7.7290000000000001</c:v>
                </c:pt>
                <c:pt idx="85">
                  <c:v>111.5</c:v>
                </c:pt>
                <c:pt idx="86">
                  <c:v>178.5</c:v>
                </c:pt>
                <c:pt idx="87">
                  <c:v>79.14</c:v>
                </c:pt>
                <c:pt idx="88">
                  <c:v>11.2</c:v>
                </c:pt>
                <c:pt idx="89">
                  <c:v>107.8</c:v>
                </c:pt>
                <c:pt idx="90">
                  <c:v>112.1</c:v>
                </c:pt>
                <c:pt idx="91">
                  <c:v>18.02</c:v>
                </c:pt>
                <c:pt idx="92">
                  <c:v>67.83</c:v>
                </c:pt>
                <c:pt idx="93">
                  <c:v>72.38</c:v>
                </c:pt>
                <c:pt idx="94">
                  <c:v>43.35</c:v>
                </c:pt>
                <c:pt idx="95">
                  <c:v>16.75</c:v>
                </c:pt>
                <c:pt idx="96">
                  <c:v>41.11</c:v>
                </c:pt>
                <c:pt idx="97">
                  <c:v>21.58</c:v>
                </c:pt>
                <c:pt idx="98">
                  <c:v>14</c:v>
                </c:pt>
                <c:pt idx="99">
                  <c:v>100.7</c:v>
                </c:pt>
                <c:pt idx="100">
                  <c:v>99.19</c:v>
                </c:pt>
                <c:pt idx="101">
                  <c:v>28.17</c:v>
                </c:pt>
                <c:pt idx="102">
                  <c:v>37.380000000000003</c:v>
                </c:pt>
                <c:pt idx="103">
                  <c:v>83.91</c:v>
                </c:pt>
                <c:pt idx="104">
                  <c:v>116.2</c:v>
                </c:pt>
                <c:pt idx="105">
                  <c:v>113.4</c:v>
                </c:pt>
                <c:pt idx="106">
                  <c:v>54.32</c:v>
                </c:pt>
                <c:pt idx="107">
                  <c:v>5.0640000000000001</c:v>
                </c:pt>
                <c:pt idx="108">
                  <c:v>6.609</c:v>
                </c:pt>
                <c:pt idx="109">
                  <c:v>110.2</c:v>
                </c:pt>
                <c:pt idx="110">
                  <c:v>6.3529999999999998</c:v>
                </c:pt>
                <c:pt idx="111">
                  <c:v>85.66</c:v>
                </c:pt>
                <c:pt idx="112">
                  <c:v>74.53</c:v>
                </c:pt>
                <c:pt idx="113">
                  <c:v>109</c:v>
                </c:pt>
                <c:pt idx="114">
                  <c:v>51.78</c:v>
                </c:pt>
                <c:pt idx="115">
                  <c:v>49.9</c:v>
                </c:pt>
                <c:pt idx="116">
                  <c:v>124.1</c:v>
                </c:pt>
                <c:pt idx="117">
                  <c:v>28.37</c:v>
                </c:pt>
                <c:pt idx="118">
                  <c:v>9.9510000000000005</c:v>
                </c:pt>
                <c:pt idx="119">
                  <c:v>58.68</c:v>
                </c:pt>
                <c:pt idx="120">
                  <c:v>171.4</c:v>
                </c:pt>
                <c:pt idx="121">
                  <c:v>19.47</c:v>
                </c:pt>
                <c:pt idx="122">
                  <c:v>24.03</c:v>
                </c:pt>
                <c:pt idx="123">
                  <c:v>158.5</c:v>
                </c:pt>
                <c:pt idx="124">
                  <c:v>12.24</c:v>
                </c:pt>
                <c:pt idx="125">
                  <c:v>189.5</c:v>
                </c:pt>
                <c:pt idx="126">
                  <c:v>13</c:v>
                </c:pt>
                <c:pt idx="127">
                  <c:v>53.32</c:v>
                </c:pt>
                <c:pt idx="128">
                  <c:v>19.77</c:v>
                </c:pt>
                <c:pt idx="129">
                  <c:v>95.2</c:v>
                </c:pt>
                <c:pt idx="130">
                  <c:v>26.85</c:v>
                </c:pt>
                <c:pt idx="131">
                  <c:v>25.18</c:v>
                </c:pt>
                <c:pt idx="132">
                  <c:v>89.68</c:v>
                </c:pt>
                <c:pt idx="133">
                  <c:v>42.56</c:v>
                </c:pt>
                <c:pt idx="134">
                  <c:v>107.3</c:v>
                </c:pt>
                <c:pt idx="135">
                  <c:v>35.520000000000003</c:v>
                </c:pt>
                <c:pt idx="136">
                  <c:v>29.16</c:v>
                </c:pt>
                <c:pt idx="137">
                  <c:v>26.06</c:v>
                </c:pt>
                <c:pt idx="138">
                  <c:v>139.6</c:v>
                </c:pt>
                <c:pt idx="139">
                  <c:v>11.58</c:v>
                </c:pt>
                <c:pt idx="140">
                  <c:v>30.66</c:v>
                </c:pt>
                <c:pt idx="141">
                  <c:v>31.84</c:v>
                </c:pt>
                <c:pt idx="142">
                  <c:v>46.96</c:v>
                </c:pt>
                <c:pt idx="143">
                  <c:v>89.41</c:v>
                </c:pt>
                <c:pt idx="144">
                  <c:v>136</c:v>
                </c:pt>
                <c:pt idx="145">
                  <c:v>79.540000000000006</c:v>
                </c:pt>
                <c:pt idx="146">
                  <c:v>45.32</c:v>
                </c:pt>
                <c:pt idx="147">
                  <c:v>69.06</c:v>
                </c:pt>
                <c:pt idx="148">
                  <c:v>116</c:v>
                </c:pt>
                <c:pt idx="149">
                  <c:v>113.4</c:v>
                </c:pt>
                <c:pt idx="150">
                  <c:v>58.82</c:v>
                </c:pt>
                <c:pt idx="151">
                  <c:v>2.9129999999999998</c:v>
                </c:pt>
                <c:pt idx="152">
                  <c:v>72.900000000000006</c:v>
                </c:pt>
                <c:pt idx="153">
                  <c:v>102.8</c:v>
                </c:pt>
                <c:pt idx="154">
                  <c:v>20.260000000000002</c:v>
                </c:pt>
                <c:pt idx="155">
                  <c:v>31.99</c:v>
                </c:pt>
                <c:pt idx="156">
                  <c:v>79.510000000000005</c:v>
                </c:pt>
                <c:pt idx="157">
                  <c:v>98.23</c:v>
                </c:pt>
                <c:pt idx="158">
                  <c:v>18.61</c:v>
                </c:pt>
                <c:pt idx="159">
                  <c:v>57.16</c:v>
                </c:pt>
                <c:pt idx="160">
                  <c:v>13.63</c:v>
                </c:pt>
                <c:pt idx="161">
                  <c:v>171</c:v>
                </c:pt>
                <c:pt idx="162">
                  <c:v>31.84</c:v>
                </c:pt>
                <c:pt idx="163">
                  <c:v>80.06</c:v>
                </c:pt>
                <c:pt idx="164">
                  <c:v>31.92</c:v>
                </c:pt>
                <c:pt idx="165">
                  <c:v>49.24</c:v>
                </c:pt>
                <c:pt idx="166">
                  <c:v>186.7</c:v>
                </c:pt>
                <c:pt idx="167">
                  <c:v>14.25</c:v>
                </c:pt>
                <c:pt idx="168">
                  <c:v>67.33</c:v>
                </c:pt>
                <c:pt idx="169">
                  <c:v>112.8</c:v>
                </c:pt>
                <c:pt idx="170">
                  <c:v>11.28</c:v>
                </c:pt>
                <c:pt idx="171">
                  <c:v>68.91</c:v>
                </c:pt>
                <c:pt idx="172">
                  <c:v>62.67</c:v>
                </c:pt>
                <c:pt idx="173">
                  <c:v>298.39999999999998</c:v>
                </c:pt>
                <c:pt idx="174">
                  <c:v>38.4</c:v>
                </c:pt>
                <c:pt idx="175">
                  <c:v>5.7050000000000001</c:v>
                </c:pt>
                <c:pt idx="176">
                  <c:v>23.7</c:v>
                </c:pt>
                <c:pt idx="177">
                  <c:v>29.16</c:v>
                </c:pt>
                <c:pt idx="178">
                  <c:v>30.9</c:v>
                </c:pt>
                <c:pt idx="179">
                  <c:v>17.75</c:v>
                </c:pt>
                <c:pt idx="180">
                  <c:v>2.246</c:v>
                </c:pt>
                <c:pt idx="181">
                  <c:v>94.8</c:v>
                </c:pt>
                <c:pt idx="182">
                  <c:v>29.53</c:v>
                </c:pt>
                <c:pt idx="183">
                  <c:v>36.11</c:v>
                </c:pt>
                <c:pt idx="184">
                  <c:v>22.85</c:v>
                </c:pt>
                <c:pt idx="185">
                  <c:v>153.19999999999999</c:v>
                </c:pt>
                <c:pt idx="186">
                  <c:v>2.2109999999999999</c:v>
                </c:pt>
                <c:pt idx="187">
                  <c:v>163.19999999999999</c:v>
                </c:pt>
                <c:pt idx="188">
                  <c:v>68.75</c:v>
                </c:pt>
                <c:pt idx="189">
                  <c:v>54.49</c:v>
                </c:pt>
                <c:pt idx="190">
                  <c:v>37.53</c:v>
                </c:pt>
                <c:pt idx="191">
                  <c:v>167.2</c:v>
                </c:pt>
                <c:pt idx="192">
                  <c:v>79.52</c:v>
                </c:pt>
                <c:pt idx="193">
                  <c:v>95.81</c:v>
                </c:pt>
                <c:pt idx="194">
                  <c:v>14.26</c:v>
                </c:pt>
                <c:pt idx="195">
                  <c:v>92.33</c:v>
                </c:pt>
                <c:pt idx="196">
                  <c:v>45.89</c:v>
                </c:pt>
                <c:pt idx="197">
                  <c:v>31.35</c:v>
                </c:pt>
                <c:pt idx="198">
                  <c:v>20.18</c:v>
                </c:pt>
                <c:pt idx="199">
                  <c:v>101.5</c:v>
                </c:pt>
                <c:pt idx="200">
                  <c:v>30.98</c:v>
                </c:pt>
                <c:pt idx="201">
                  <c:v>8.3840000000000003</c:v>
                </c:pt>
                <c:pt idx="202">
                  <c:v>19.39</c:v>
                </c:pt>
                <c:pt idx="203">
                  <c:v>86.6</c:v>
                </c:pt>
                <c:pt idx="204">
                  <c:v>68.58</c:v>
                </c:pt>
                <c:pt idx="205">
                  <c:v>8.0760000000000005</c:v>
                </c:pt>
                <c:pt idx="206">
                  <c:v>13.28</c:v>
                </c:pt>
                <c:pt idx="207">
                  <c:v>10.11</c:v>
                </c:pt>
                <c:pt idx="208">
                  <c:v>123.9</c:v>
                </c:pt>
                <c:pt idx="209">
                  <c:v>112.1</c:v>
                </c:pt>
                <c:pt idx="210">
                  <c:v>75.86</c:v>
                </c:pt>
                <c:pt idx="211">
                  <c:v>31.6</c:v>
                </c:pt>
                <c:pt idx="212">
                  <c:v>28.67</c:v>
                </c:pt>
                <c:pt idx="213">
                  <c:v>17.850000000000001</c:v>
                </c:pt>
                <c:pt idx="214">
                  <c:v>5.931</c:v>
                </c:pt>
                <c:pt idx="215">
                  <c:v>98.32</c:v>
                </c:pt>
                <c:pt idx="216">
                  <c:v>21.36</c:v>
                </c:pt>
                <c:pt idx="217">
                  <c:v>37.17</c:v>
                </c:pt>
                <c:pt idx="218">
                  <c:v>45.27</c:v>
                </c:pt>
                <c:pt idx="219">
                  <c:v>71.63</c:v>
                </c:pt>
                <c:pt idx="220">
                  <c:v>12.95</c:v>
                </c:pt>
                <c:pt idx="221">
                  <c:v>104</c:v>
                </c:pt>
                <c:pt idx="222">
                  <c:v>11.48</c:v>
                </c:pt>
                <c:pt idx="223">
                  <c:v>18.71</c:v>
                </c:pt>
                <c:pt idx="224">
                  <c:v>14.2</c:v>
                </c:pt>
                <c:pt idx="225">
                  <c:v>41.35</c:v>
                </c:pt>
                <c:pt idx="226">
                  <c:v>11.11</c:v>
                </c:pt>
              </c:numCache>
            </c:numRef>
          </c:yVal>
          <c:smooth val="0"/>
          <c:extLst xmlns:c16r2="http://schemas.microsoft.com/office/drawing/2015/06/chart">
            <c:ext xmlns:c16="http://schemas.microsoft.com/office/drawing/2014/chart" uri="{C3380CC4-5D6E-409C-BE32-E72D297353CC}">
              <c16:uniqueId val="{00000001-1934-4CDC-A442-5C756DE0C599}"/>
            </c:ext>
          </c:extLst>
        </c:ser>
        <c:dLbls>
          <c:showLegendKey val="0"/>
          <c:showVal val="0"/>
          <c:showCatName val="0"/>
          <c:showSerName val="0"/>
          <c:showPercent val="0"/>
          <c:showBubbleSize val="0"/>
        </c:dLbls>
        <c:axId val="-1517551760"/>
        <c:axId val="-1517551216"/>
      </c:scatterChart>
      <c:valAx>
        <c:axId val="-1517551760"/>
        <c:scaling>
          <c:orientation val="minMax"/>
          <c:max val="70"/>
          <c:min val="20"/>
        </c:scaling>
        <c:delete val="0"/>
        <c:axPos val="b"/>
        <c:title>
          <c:tx>
            <c:rich>
              <a:bodyPr rot="0" spcFirstLastPara="1" vertOverflow="ellipsis" vert="horz" wrap="square" anchor="ctr" anchorCtr="1"/>
              <a:lstStyle/>
              <a:p>
                <a:pPr>
                  <a:defRPr sz="800" b="0" i="0" u="none" strike="noStrike" kern="1200" baseline="0">
                    <a:solidFill>
                      <a:schemeClr val="tx1">
                        <a:lumMod val="65000"/>
                        <a:lumOff val="35000"/>
                      </a:schemeClr>
                    </a:solidFill>
                    <a:latin typeface="+mn-lt"/>
                    <a:ea typeface="+mn-ea"/>
                    <a:cs typeface="+mn-cs"/>
                  </a:defRPr>
                </a:pPr>
                <a:r>
                  <a:rPr lang="en-US"/>
                  <a:t>Age</a:t>
                </a:r>
                <a:endParaRPr lang="ko-KR"/>
              </a:p>
            </c:rich>
          </c:tx>
          <c:overlay val="0"/>
          <c:spPr>
            <a:noFill/>
            <a:ln>
              <a:noFill/>
            </a:ln>
            <a:effectLst/>
          </c:spPr>
          <c:txPr>
            <a:bodyPr rot="0" spcFirstLastPara="1" vertOverflow="ellipsis" vert="horz" wrap="square" anchor="ctr" anchorCtr="1"/>
            <a:lstStyle/>
            <a:p>
              <a:pPr>
                <a:defRPr sz="8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mn-lt"/>
                <a:ea typeface="+mn-ea"/>
                <a:cs typeface="+mn-cs"/>
              </a:defRPr>
            </a:pPr>
            <a:endParaRPr lang="en-US"/>
          </a:p>
        </c:txPr>
        <c:crossAx val="-1517551216"/>
        <c:crosses val="autoZero"/>
        <c:crossBetween val="midCat"/>
      </c:valAx>
      <c:valAx>
        <c:axId val="-1517551216"/>
        <c:scaling>
          <c:orientation val="minMax"/>
          <c:max val="800"/>
        </c:scaling>
        <c:delete val="0"/>
        <c:axPos val="l"/>
        <c:title>
          <c:tx>
            <c:rich>
              <a:bodyPr rot="-5400000" spcFirstLastPara="1" vertOverflow="ellipsis" vert="horz" wrap="square" anchor="ctr" anchorCtr="1"/>
              <a:lstStyle/>
              <a:p>
                <a:pPr>
                  <a:defRPr sz="800" b="0" i="0" u="none" strike="noStrike" kern="1200" baseline="0">
                    <a:solidFill>
                      <a:schemeClr val="tx1">
                        <a:lumMod val="65000"/>
                        <a:lumOff val="35000"/>
                      </a:schemeClr>
                    </a:solidFill>
                    <a:latin typeface="+mn-lt"/>
                    <a:ea typeface="+mn-ea"/>
                    <a:cs typeface="+mn-cs"/>
                  </a:defRPr>
                </a:pPr>
                <a:r>
                  <a:rPr lang="en-US" dirty="0"/>
                  <a:t>GYG2 mRNA </a:t>
                </a:r>
                <a:r>
                  <a:rPr lang="en-US" dirty="0" smtClean="0"/>
                  <a:t>(</a:t>
                </a:r>
                <a:r>
                  <a:rPr lang="en-US" altLang="ko-KR" dirty="0" smtClean="0"/>
                  <a:t>TPM</a:t>
                </a:r>
                <a:r>
                  <a:rPr lang="en-US" dirty="0" smtClean="0"/>
                  <a:t>)</a:t>
                </a:r>
                <a:endParaRPr lang="ko-KR" dirty="0"/>
              </a:p>
            </c:rich>
          </c:tx>
          <c:layout>
            <c:manualLayout>
              <c:xMode val="edge"/>
              <c:yMode val="edge"/>
              <c:x val="0"/>
              <c:y val="0.12142314814814817"/>
            </c:manualLayout>
          </c:layout>
          <c:overlay val="0"/>
          <c:spPr>
            <a:noFill/>
            <a:ln>
              <a:noFill/>
            </a:ln>
            <a:effectLst/>
          </c:spPr>
          <c:txPr>
            <a:bodyPr rot="-5400000" spcFirstLastPara="1" vertOverflow="ellipsis" vert="horz" wrap="square" anchor="ctr" anchorCtr="1"/>
            <a:lstStyle/>
            <a:p>
              <a:pPr>
                <a:defRPr sz="8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mn-lt"/>
                <a:ea typeface="+mn-ea"/>
                <a:cs typeface="+mn-cs"/>
              </a:defRPr>
            </a:pPr>
            <a:endParaRPr lang="en-US"/>
          </a:p>
        </c:txPr>
        <c:crossAx val="-1517551760"/>
        <c:crosses val="autoZero"/>
        <c:crossBetween val="midCat"/>
      </c:valAx>
      <c:spPr>
        <a:noFill/>
        <a:ln>
          <a:noFill/>
        </a:ln>
        <a:effectLst/>
      </c:spPr>
    </c:plotArea>
    <c:plotVisOnly val="1"/>
    <c:dispBlanksAs val="gap"/>
    <c:showDLblsOverMax val="0"/>
  </c:chart>
  <c:spPr>
    <a:noFill/>
    <a:ln>
      <a:noFill/>
    </a:ln>
    <a:effectLst/>
  </c:spPr>
  <c:txPr>
    <a:bodyPr/>
    <a:lstStyle/>
    <a:p>
      <a:pPr>
        <a:defRPr sz="800">
          <a:latin typeface="+mn-lt"/>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0041296296296296"/>
          <c:y val="4.3061111111111113E-2"/>
          <c:w val="0.74046759259259254"/>
          <c:h val="0.75989722222222222"/>
        </c:manualLayout>
      </c:layout>
      <c:scatterChart>
        <c:scatterStyle val="lineMarker"/>
        <c:varyColors val="0"/>
        <c:ser>
          <c:idx val="0"/>
          <c:order val="0"/>
          <c:tx>
            <c:strRef>
              <c:f>'vis BMI cor'!$A$1</c:f>
              <c:strCache>
                <c:ptCount val="1"/>
                <c:pt idx="0">
                  <c:v>MALE</c:v>
                </c:pt>
              </c:strCache>
            </c:strRef>
          </c:tx>
          <c:spPr>
            <a:ln w="25400" cap="rnd">
              <a:noFill/>
              <a:round/>
            </a:ln>
            <a:effectLst/>
          </c:spPr>
          <c:marker>
            <c:symbol val="circle"/>
            <c:size val="3"/>
            <c:spPr>
              <a:solidFill>
                <a:schemeClr val="accent1"/>
              </a:solidFill>
              <a:ln w="9525">
                <a:solidFill>
                  <a:schemeClr val="accent1"/>
                </a:solidFill>
              </a:ln>
              <a:effectLst/>
            </c:spPr>
          </c:marker>
          <c:trendline>
            <c:spPr>
              <a:ln w="19050" cap="rnd">
                <a:solidFill>
                  <a:schemeClr val="accent1"/>
                </a:solidFill>
                <a:prstDash val="solid"/>
              </a:ln>
              <a:effectLst/>
            </c:spPr>
            <c:trendlineType val="linear"/>
            <c:dispRSqr val="0"/>
            <c:dispEq val="0"/>
          </c:trendline>
          <c:xVal>
            <c:numRef>
              <c:f>'vis BMI cor'!$G$9:$KE$9</c:f>
              <c:numCache>
                <c:formatCode>General</c:formatCode>
                <c:ptCount val="285"/>
                <c:pt idx="0">
                  <c:v>33.57</c:v>
                </c:pt>
                <c:pt idx="1">
                  <c:v>30.78</c:v>
                </c:pt>
                <c:pt idx="2">
                  <c:v>29.83</c:v>
                </c:pt>
                <c:pt idx="3">
                  <c:v>22.92</c:v>
                </c:pt>
                <c:pt idx="4">
                  <c:v>24.49</c:v>
                </c:pt>
                <c:pt idx="5">
                  <c:v>20.67</c:v>
                </c:pt>
                <c:pt idx="6">
                  <c:v>21.95</c:v>
                </c:pt>
                <c:pt idx="7">
                  <c:v>31.32</c:v>
                </c:pt>
                <c:pt idx="8">
                  <c:v>25.24</c:v>
                </c:pt>
                <c:pt idx="9">
                  <c:v>32.06</c:v>
                </c:pt>
                <c:pt idx="10">
                  <c:v>32.979999999999997</c:v>
                </c:pt>
                <c:pt idx="11">
                  <c:v>33.33</c:v>
                </c:pt>
                <c:pt idx="12">
                  <c:v>23.01</c:v>
                </c:pt>
                <c:pt idx="13">
                  <c:v>28.69</c:v>
                </c:pt>
                <c:pt idx="14">
                  <c:v>24.68</c:v>
                </c:pt>
                <c:pt idx="15">
                  <c:v>20.98</c:v>
                </c:pt>
                <c:pt idx="16">
                  <c:v>23.96</c:v>
                </c:pt>
                <c:pt idx="17">
                  <c:v>34.43</c:v>
                </c:pt>
                <c:pt idx="18">
                  <c:v>23.31</c:v>
                </c:pt>
                <c:pt idx="19">
                  <c:v>23.72</c:v>
                </c:pt>
                <c:pt idx="20">
                  <c:v>27.32</c:v>
                </c:pt>
                <c:pt idx="21">
                  <c:v>23.92</c:v>
                </c:pt>
                <c:pt idx="22">
                  <c:v>33.47</c:v>
                </c:pt>
                <c:pt idx="23">
                  <c:v>18.989999999999998</c:v>
                </c:pt>
                <c:pt idx="24">
                  <c:v>24.35</c:v>
                </c:pt>
                <c:pt idx="25">
                  <c:v>20.62</c:v>
                </c:pt>
                <c:pt idx="26">
                  <c:v>27.37</c:v>
                </c:pt>
                <c:pt idx="27">
                  <c:v>21.3</c:v>
                </c:pt>
                <c:pt idx="28">
                  <c:v>32.979999999999997</c:v>
                </c:pt>
                <c:pt idx="29">
                  <c:v>26.58</c:v>
                </c:pt>
                <c:pt idx="30">
                  <c:v>24.39</c:v>
                </c:pt>
                <c:pt idx="31">
                  <c:v>31.98</c:v>
                </c:pt>
                <c:pt idx="32">
                  <c:v>27.12</c:v>
                </c:pt>
                <c:pt idx="33">
                  <c:v>22.04</c:v>
                </c:pt>
                <c:pt idx="34">
                  <c:v>26.71</c:v>
                </c:pt>
                <c:pt idx="35">
                  <c:v>24.41</c:v>
                </c:pt>
                <c:pt idx="36">
                  <c:v>34.69</c:v>
                </c:pt>
                <c:pt idx="37">
                  <c:v>31.66</c:v>
                </c:pt>
                <c:pt idx="38">
                  <c:v>25.33</c:v>
                </c:pt>
                <c:pt idx="39">
                  <c:v>20.98</c:v>
                </c:pt>
                <c:pt idx="40">
                  <c:v>25.49</c:v>
                </c:pt>
                <c:pt idx="41">
                  <c:v>24.58</c:v>
                </c:pt>
                <c:pt idx="42">
                  <c:v>28.82</c:v>
                </c:pt>
                <c:pt idx="43">
                  <c:v>27.89</c:v>
                </c:pt>
                <c:pt idx="44">
                  <c:v>33.01</c:v>
                </c:pt>
                <c:pt idx="45">
                  <c:v>33.9</c:v>
                </c:pt>
                <c:pt idx="46">
                  <c:v>19.77</c:v>
                </c:pt>
                <c:pt idx="47">
                  <c:v>34.72</c:v>
                </c:pt>
                <c:pt idx="48">
                  <c:v>26.04</c:v>
                </c:pt>
                <c:pt idx="49">
                  <c:v>22.15</c:v>
                </c:pt>
                <c:pt idx="50">
                  <c:v>25.1</c:v>
                </c:pt>
                <c:pt idx="51">
                  <c:v>26.65</c:v>
                </c:pt>
                <c:pt idx="52">
                  <c:v>32.08</c:v>
                </c:pt>
                <c:pt idx="53">
                  <c:v>26.55</c:v>
                </c:pt>
                <c:pt idx="54">
                  <c:v>22.15</c:v>
                </c:pt>
                <c:pt idx="55">
                  <c:v>22.43</c:v>
                </c:pt>
                <c:pt idx="56">
                  <c:v>25.24</c:v>
                </c:pt>
                <c:pt idx="57">
                  <c:v>33.97</c:v>
                </c:pt>
                <c:pt idx="58">
                  <c:v>28.21</c:v>
                </c:pt>
                <c:pt idx="59">
                  <c:v>34.86</c:v>
                </c:pt>
                <c:pt idx="60">
                  <c:v>31.6</c:v>
                </c:pt>
                <c:pt idx="61">
                  <c:v>29.98</c:v>
                </c:pt>
                <c:pt idx="62">
                  <c:v>25.66</c:v>
                </c:pt>
                <c:pt idx="63">
                  <c:v>29.41</c:v>
                </c:pt>
                <c:pt idx="64">
                  <c:v>27.7</c:v>
                </c:pt>
                <c:pt idx="65">
                  <c:v>22.8</c:v>
                </c:pt>
                <c:pt idx="66">
                  <c:v>27.26</c:v>
                </c:pt>
                <c:pt idx="67">
                  <c:v>27.12</c:v>
                </c:pt>
                <c:pt idx="68">
                  <c:v>31.32</c:v>
                </c:pt>
                <c:pt idx="69">
                  <c:v>26.61</c:v>
                </c:pt>
                <c:pt idx="70">
                  <c:v>23.32</c:v>
                </c:pt>
                <c:pt idx="71">
                  <c:v>30.5</c:v>
                </c:pt>
                <c:pt idx="72">
                  <c:v>25.82</c:v>
                </c:pt>
                <c:pt idx="73">
                  <c:v>34.770000000000003</c:v>
                </c:pt>
                <c:pt idx="74">
                  <c:v>21.95</c:v>
                </c:pt>
                <c:pt idx="75">
                  <c:v>32.909999999999997</c:v>
                </c:pt>
                <c:pt idx="76">
                  <c:v>27.12</c:v>
                </c:pt>
                <c:pt idx="77">
                  <c:v>27.26</c:v>
                </c:pt>
                <c:pt idx="78">
                  <c:v>24.78</c:v>
                </c:pt>
                <c:pt idx="79">
                  <c:v>26.2</c:v>
                </c:pt>
                <c:pt idx="80">
                  <c:v>29.29</c:v>
                </c:pt>
                <c:pt idx="81">
                  <c:v>27.12</c:v>
                </c:pt>
                <c:pt idx="82">
                  <c:v>19.79</c:v>
                </c:pt>
                <c:pt idx="83">
                  <c:v>19.760000000000002</c:v>
                </c:pt>
                <c:pt idx="84">
                  <c:v>31.53</c:v>
                </c:pt>
                <c:pt idx="85">
                  <c:v>27.12</c:v>
                </c:pt>
                <c:pt idx="86">
                  <c:v>30.55</c:v>
                </c:pt>
                <c:pt idx="87">
                  <c:v>27.12</c:v>
                </c:pt>
                <c:pt idx="88">
                  <c:v>27.12</c:v>
                </c:pt>
                <c:pt idx="89">
                  <c:v>31.56</c:v>
                </c:pt>
                <c:pt idx="90">
                  <c:v>27.46</c:v>
                </c:pt>
                <c:pt idx="91">
                  <c:v>33.86</c:v>
                </c:pt>
                <c:pt idx="92">
                  <c:v>30.55</c:v>
                </c:pt>
                <c:pt idx="93">
                  <c:v>32.630000000000003</c:v>
                </c:pt>
                <c:pt idx="94">
                  <c:v>30.57</c:v>
                </c:pt>
                <c:pt idx="95">
                  <c:v>20.07</c:v>
                </c:pt>
                <c:pt idx="96">
                  <c:v>29.29</c:v>
                </c:pt>
                <c:pt idx="97">
                  <c:v>30.85</c:v>
                </c:pt>
                <c:pt idx="98">
                  <c:v>32.200000000000003</c:v>
                </c:pt>
                <c:pt idx="99">
                  <c:v>30.1</c:v>
                </c:pt>
                <c:pt idx="100">
                  <c:v>23.77</c:v>
                </c:pt>
                <c:pt idx="101">
                  <c:v>25.62</c:v>
                </c:pt>
                <c:pt idx="102">
                  <c:v>32.549999999999997</c:v>
                </c:pt>
                <c:pt idx="103">
                  <c:v>22.1</c:v>
                </c:pt>
                <c:pt idx="104">
                  <c:v>30.94</c:v>
                </c:pt>
                <c:pt idx="105">
                  <c:v>23.49</c:v>
                </c:pt>
                <c:pt idx="106">
                  <c:v>28.94</c:v>
                </c:pt>
                <c:pt idx="107">
                  <c:v>30.34</c:v>
                </c:pt>
                <c:pt idx="108">
                  <c:v>19.3</c:v>
                </c:pt>
                <c:pt idx="109">
                  <c:v>23.75</c:v>
                </c:pt>
                <c:pt idx="110">
                  <c:v>27.89</c:v>
                </c:pt>
                <c:pt idx="111">
                  <c:v>32.49</c:v>
                </c:pt>
                <c:pt idx="112">
                  <c:v>34.44</c:v>
                </c:pt>
                <c:pt idx="113">
                  <c:v>29.83</c:v>
                </c:pt>
                <c:pt idx="114">
                  <c:v>27.89</c:v>
                </c:pt>
                <c:pt idx="115">
                  <c:v>21.38</c:v>
                </c:pt>
                <c:pt idx="116">
                  <c:v>30.51</c:v>
                </c:pt>
                <c:pt idx="117">
                  <c:v>27.11</c:v>
                </c:pt>
                <c:pt idx="118">
                  <c:v>28.24</c:v>
                </c:pt>
                <c:pt idx="119">
                  <c:v>32.28</c:v>
                </c:pt>
                <c:pt idx="120">
                  <c:v>33.75</c:v>
                </c:pt>
                <c:pt idx="121">
                  <c:v>28.12</c:v>
                </c:pt>
                <c:pt idx="122">
                  <c:v>25.42</c:v>
                </c:pt>
                <c:pt idx="123">
                  <c:v>22.92</c:v>
                </c:pt>
                <c:pt idx="124">
                  <c:v>31.77</c:v>
                </c:pt>
                <c:pt idx="125">
                  <c:v>33.89</c:v>
                </c:pt>
                <c:pt idx="126">
                  <c:v>25.11</c:v>
                </c:pt>
                <c:pt idx="127">
                  <c:v>21.41</c:v>
                </c:pt>
                <c:pt idx="128">
                  <c:v>27.25</c:v>
                </c:pt>
                <c:pt idx="129">
                  <c:v>27.21</c:v>
                </c:pt>
                <c:pt idx="130">
                  <c:v>23.05</c:v>
                </c:pt>
                <c:pt idx="131">
                  <c:v>33.19</c:v>
                </c:pt>
                <c:pt idx="132">
                  <c:v>32.71</c:v>
                </c:pt>
                <c:pt idx="133">
                  <c:v>33.47</c:v>
                </c:pt>
                <c:pt idx="134">
                  <c:v>30.51</c:v>
                </c:pt>
                <c:pt idx="135">
                  <c:v>28.69</c:v>
                </c:pt>
                <c:pt idx="136">
                  <c:v>21.7</c:v>
                </c:pt>
                <c:pt idx="137">
                  <c:v>30.51</c:v>
                </c:pt>
                <c:pt idx="138">
                  <c:v>28.06</c:v>
                </c:pt>
                <c:pt idx="139">
                  <c:v>25.1</c:v>
                </c:pt>
                <c:pt idx="140">
                  <c:v>28.51</c:v>
                </c:pt>
                <c:pt idx="141">
                  <c:v>25.85</c:v>
                </c:pt>
                <c:pt idx="142">
                  <c:v>28.06</c:v>
                </c:pt>
                <c:pt idx="143">
                  <c:v>25.77</c:v>
                </c:pt>
                <c:pt idx="144">
                  <c:v>30.51</c:v>
                </c:pt>
                <c:pt idx="145">
                  <c:v>28.45</c:v>
                </c:pt>
                <c:pt idx="146">
                  <c:v>27.91</c:v>
                </c:pt>
                <c:pt idx="147">
                  <c:v>28.66</c:v>
                </c:pt>
                <c:pt idx="148">
                  <c:v>23.43</c:v>
                </c:pt>
                <c:pt idx="149">
                  <c:v>28.3</c:v>
                </c:pt>
                <c:pt idx="150">
                  <c:v>26.54</c:v>
                </c:pt>
                <c:pt idx="151">
                  <c:v>23.24</c:v>
                </c:pt>
                <c:pt idx="152">
                  <c:v>27.26</c:v>
                </c:pt>
                <c:pt idx="153">
                  <c:v>28.99</c:v>
                </c:pt>
                <c:pt idx="154">
                  <c:v>32</c:v>
                </c:pt>
                <c:pt idx="155">
                  <c:v>28.26</c:v>
                </c:pt>
                <c:pt idx="156">
                  <c:v>34.54</c:v>
                </c:pt>
                <c:pt idx="157">
                  <c:v>31.58</c:v>
                </c:pt>
                <c:pt idx="158">
                  <c:v>26.16</c:v>
                </c:pt>
                <c:pt idx="159">
                  <c:v>29.16</c:v>
                </c:pt>
                <c:pt idx="160">
                  <c:v>30.56</c:v>
                </c:pt>
                <c:pt idx="161">
                  <c:v>32.549999999999997</c:v>
                </c:pt>
                <c:pt idx="162">
                  <c:v>28.4</c:v>
                </c:pt>
                <c:pt idx="163">
                  <c:v>19.79</c:v>
                </c:pt>
                <c:pt idx="164">
                  <c:v>23.71</c:v>
                </c:pt>
                <c:pt idx="165">
                  <c:v>30.11</c:v>
                </c:pt>
                <c:pt idx="166">
                  <c:v>26.66</c:v>
                </c:pt>
                <c:pt idx="167">
                  <c:v>24.13</c:v>
                </c:pt>
                <c:pt idx="168">
                  <c:v>34.43</c:v>
                </c:pt>
                <c:pt idx="169">
                  <c:v>21.79</c:v>
                </c:pt>
                <c:pt idx="170">
                  <c:v>23.99</c:v>
                </c:pt>
                <c:pt idx="171">
                  <c:v>27.2</c:v>
                </c:pt>
                <c:pt idx="172">
                  <c:v>27.89</c:v>
                </c:pt>
                <c:pt idx="173">
                  <c:v>24.19</c:v>
                </c:pt>
                <c:pt idx="174">
                  <c:v>31.73</c:v>
                </c:pt>
                <c:pt idx="175">
                  <c:v>23.63</c:v>
                </c:pt>
                <c:pt idx="176">
                  <c:v>25.36</c:v>
                </c:pt>
                <c:pt idx="177">
                  <c:v>29.15</c:v>
                </c:pt>
                <c:pt idx="178">
                  <c:v>18.8</c:v>
                </c:pt>
                <c:pt idx="179">
                  <c:v>20.8</c:v>
                </c:pt>
                <c:pt idx="180">
                  <c:v>34.78</c:v>
                </c:pt>
                <c:pt idx="181">
                  <c:v>30.17</c:v>
                </c:pt>
                <c:pt idx="182">
                  <c:v>24.75</c:v>
                </c:pt>
                <c:pt idx="183">
                  <c:v>26.85</c:v>
                </c:pt>
                <c:pt idx="184">
                  <c:v>22.71</c:v>
                </c:pt>
                <c:pt idx="185">
                  <c:v>27.19</c:v>
                </c:pt>
                <c:pt idx="186">
                  <c:v>28.59</c:v>
                </c:pt>
                <c:pt idx="187">
                  <c:v>25.29</c:v>
                </c:pt>
                <c:pt idx="188">
                  <c:v>31.62</c:v>
                </c:pt>
                <c:pt idx="189">
                  <c:v>25.31</c:v>
                </c:pt>
                <c:pt idx="190">
                  <c:v>33.69</c:v>
                </c:pt>
                <c:pt idx="191">
                  <c:v>31.57</c:v>
                </c:pt>
                <c:pt idx="192">
                  <c:v>20.37</c:v>
                </c:pt>
                <c:pt idx="193">
                  <c:v>22.88</c:v>
                </c:pt>
                <c:pt idx="194">
                  <c:v>27.5</c:v>
                </c:pt>
                <c:pt idx="195">
                  <c:v>26.81</c:v>
                </c:pt>
                <c:pt idx="196">
                  <c:v>29.94</c:v>
                </c:pt>
                <c:pt idx="197">
                  <c:v>29.21</c:v>
                </c:pt>
                <c:pt idx="198">
                  <c:v>33.36</c:v>
                </c:pt>
                <c:pt idx="199">
                  <c:v>26.31</c:v>
                </c:pt>
                <c:pt idx="200">
                  <c:v>21.18</c:v>
                </c:pt>
                <c:pt idx="201">
                  <c:v>30.32</c:v>
                </c:pt>
                <c:pt idx="202">
                  <c:v>22.16</c:v>
                </c:pt>
                <c:pt idx="203">
                  <c:v>23.63</c:v>
                </c:pt>
                <c:pt idx="204">
                  <c:v>31.06</c:v>
                </c:pt>
                <c:pt idx="205">
                  <c:v>29.66</c:v>
                </c:pt>
                <c:pt idx="206">
                  <c:v>22.31</c:v>
                </c:pt>
                <c:pt idx="207">
                  <c:v>30.38</c:v>
                </c:pt>
                <c:pt idx="208">
                  <c:v>31.58</c:v>
                </c:pt>
                <c:pt idx="209">
                  <c:v>29.7</c:v>
                </c:pt>
                <c:pt idx="210">
                  <c:v>27.76</c:v>
                </c:pt>
                <c:pt idx="211">
                  <c:v>34.979999999999997</c:v>
                </c:pt>
                <c:pt idx="212">
                  <c:v>19</c:v>
                </c:pt>
                <c:pt idx="213">
                  <c:v>30.11</c:v>
                </c:pt>
                <c:pt idx="214">
                  <c:v>23.6</c:v>
                </c:pt>
                <c:pt idx="215">
                  <c:v>23.57</c:v>
                </c:pt>
                <c:pt idx="216">
                  <c:v>33.25</c:v>
                </c:pt>
                <c:pt idx="217">
                  <c:v>23.18</c:v>
                </c:pt>
                <c:pt idx="218">
                  <c:v>28.59</c:v>
                </c:pt>
                <c:pt idx="219">
                  <c:v>22.04</c:v>
                </c:pt>
                <c:pt idx="220">
                  <c:v>23.93</c:v>
                </c:pt>
                <c:pt idx="221">
                  <c:v>28.69</c:v>
                </c:pt>
                <c:pt idx="222">
                  <c:v>31.56</c:v>
                </c:pt>
                <c:pt idx="223">
                  <c:v>27.77</c:v>
                </c:pt>
                <c:pt idx="224">
                  <c:v>25.99</c:v>
                </c:pt>
                <c:pt idx="225">
                  <c:v>27.4</c:v>
                </c:pt>
                <c:pt idx="226">
                  <c:v>28.66</c:v>
                </c:pt>
                <c:pt idx="227">
                  <c:v>26.12</c:v>
                </c:pt>
                <c:pt idx="228">
                  <c:v>19.8</c:v>
                </c:pt>
                <c:pt idx="229">
                  <c:v>32.26</c:v>
                </c:pt>
                <c:pt idx="230">
                  <c:v>22.65</c:v>
                </c:pt>
                <c:pt idx="231">
                  <c:v>29.24</c:v>
                </c:pt>
                <c:pt idx="232">
                  <c:v>29.95</c:v>
                </c:pt>
                <c:pt idx="233">
                  <c:v>27.89</c:v>
                </c:pt>
                <c:pt idx="234">
                  <c:v>25.68</c:v>
                </c:pt>
                <c:pt idx="235">
                  <c:v>29.81</c:v>
                </c:pt>
                <c:pt idx="236">
                  <c:v>30.17</c:v>
                </c:pt>
                <c:pt idx="237">
                  <c:v>31.32</c:v>
                </c:pt>
                <c:pt idx="238">
                  <c:v>26.38</c:v>
                </c:pt>
                <c:pt idx="239">
                  <c:v>28.26</c:v>
                </c:pt>
                <c:pt idx="240">
                  <c:v>26.29</c:v>
                </c:pt>
              </c:numCache>
            </c:numRef>
          </c:xVal>
          <c:yVal>
            <c:numRef>
              <c:f>'vis BMI cor'!$G$12:$KE$12</c:f>
              <c:numCache>
                <c:formatCode>General</c:formatCode>
                <c:ptCount val="285"/>
                <c:pt idx="0">
                  <c:v>171.4</c:v>
                </c:pt>
                <c:pt idx="1">
                  <c:v>171</c:v>
                </c:pt>
                <c:pt idx="2">
                  <c:v>26.85</c:v>
                </c:pt>
                <c:pt idx="3">
                  <c:v>54.32</c:v>
                </c:pt>
                <c:pt idx="4">
                  <c:v>5.0640000000000001</c:v>
                </c:pt>
                <c:pt idx="5">
                  <c:v>31.84</c:v>
                </c:pt>
                <c:pt idx="6">
                  <c:v>7.758</c:v>
                </c:pt>
                <c:pt idx="7">
                  <c:v>14.25</c:v>
                </c:pt>
                <c:pt idx="8">
                  <c:v>222.7</c:v>
                </c:pt>
                <c:pt idx="9">
                  <c:v>31.99</c:v>
                </c:pt>
                <c:pt idx="10">
                  <c:v>79.510000000000005</c:v>
                </c:pt>
                <c:pt idx="11">
                  <c:v>144.6</c:v>
                </c:pt>
                <c:pt idx="12">
                  <c:v>7.7290000000000001</c:v>
                </c:pt>
                <c:pt idx="13">
                  <c:v>23.7</c:v>
                </c:pt>
                <c:pt idx="14">
                  <c:v>67.33</c:v>
                </c:pt>
                <c:pt idx="15">
                  <c:v>27.11</c:v>
                </c:pt>
                <c:pt idx="16">
                  <c:v>121.2</c:v>
                </c:pt>
                <c:pt idx="17">
                  <c:v>16.75</c:v>
                </c:pt>
                <c:pt idx="18">
                  <c:v>27.4</c:v>
                </c:pt>
                <c:pt idx="19">
                  <c:v>6.609</c:v>
                </c:pt>
                <c:pt idx="20">
                  <c:v>42.19</c:v>
                </c:pt>
                <c:pt idx="21">
                  <c:v>54.49</c:v>
                </c:pt>
                <c:pt idx="22">
                  <c:v>13.49</c:v>
                </c:pt>
                <c:pt idx="23">
                  <c:v>87.07</c:v>
                </c:pt>
                <c:pt idx="24">
                  <c:v>98.23</c:v>
                </c:pt>
                <c:pt idx="25">
                  <c:v>77.25</c:v>
                </c:pt>
                <c:pt idx="26">
                  <c:v>25.88</c:v>
                </c:pt>
                <c:pt idx="27">
                  <c:v>20.18</c:v>
                </c:pt>
                <c:pt idx="28">
                  <c:v>85.66</c:v>
                </c:pt>
                <c:pt idx="29">
                  <c:v>71.63</c:v>
                </c:pt>
                <c:pt idx="30">
                  <c:v>41.11</c:v>
                </c:pt>
                <c:pt idx="31">
                  <c:v>82.63</c:v>
                </c:pt>
                <c:pt idx="32">
                  <c:v>112.8</c:v>
                </c:pt>
                <c:pt idx="33">
                  <c:v>19.47</c:v>
                </c:pt>
                <c:pt idx="34">
                  <c:v>221.5</c:v>
                </c:pt>
                <c:pt idx="35">
                  <c:v>70.27</c:v>
                </c:pt>
                <c:pt idx="36">
                  <c:v>79.92</c:v>
                </c:pt>
                <c:pt idx="37">
                  <c:v>116</c:v>
                </c:pt>
                <c:pt idx="38">
                  <c:v>111.5</c:v>
                </c:pt>
                <c:pt idx="39">
                  <c:v>113.4</c:v>
                </c:pt>
                <c:pt idx="40">
                  <c:v>19.39</c:v>
                </c:pt>
                <c:pt idx="41">
                  <c:v>101.5</c:v>
                </c:pt>
                <c:pt idx="42">
                  <c:v>99.26</c:v>
                </c:pt>
                <c:pt idx="43">
                  <c:v>30.98</c:v>
                </c:pt>
                <c:pt idx="44">
                  <c:v>19.23</c:v>
                </c:pt>
                <c:pt idx="45">
                  <c:v>29.16</c:v>
                </c:pt>
                <c:pt idx="46">
                  <c:v>178.5</c:v>
                </c:pt>
                <c:pt idx="47">
                  <c:v>18.61</c:v>
                </c:pt>
                <c:pt idx="48">
                  <c:v>119.2</c:v>
                </c:pt>
                <c:pt idx="49">
                  <c:v>26.06</c:v>
                </c:pt>
                <c:pt idx="50">
                  <c:v>75.86</c:v>
                </c:pt>
                <c:pt idx="51">
                  <c:v>12.95</c:v>
                </c:pt>
                <c:pt idx="52">
                  <c:v>104</c:v>
                </c:pt>
                <c:pt idx="53">
                  <c:v>58.82</c:v>
                </c:pt>
                <c:pt idx="54">
                  <c:v>11.28</c:v>
                </c:pt>
                <c:pt idx="55">
                  <c:v>21.58</c:v>
                </c:pt>
                <c:pt idx="56">
                  <c:v>87.43</c:v>
                </c:pt>
                <c:pt idx="57">
                  <c:v>139.6</c:v>
                </c:pt>
                <c:pt idx="58">
                  <c:v>11.58</c:v>
                </c:pt>
                <c:pt idx="59">
                  <c:v>79.14</c:v>
                </c:pt>
                <c:pt idx="60">
                  <c:v>86.6</c:v>
                </c:pt>
                <c:pt idx="61">
                  <c:v>80.06</c:v>
                </c:pt>
                <c:pt idx="62">
                  <c:v>11.48</c:v>
                </c:pt>
                <c:pt idx="63">
                  <c:v>26.45</c:v>
                </c:pt>
                <c:pt idx="64">
                  <c:v>78.55</c:v>
                </c:pt>
                <c:pt idx="65">
                  <c:v>30.66</c:v>
                </c:pt>
                <c:pt idx="66">
                  <c:v>11.2</c:v>
                </c:pt>
                <c:pt idx="67">
                  <c:v>37.53</c:v>
                </c:pt>
                <c:pt idx="68">
                  <c:v>31.92</c:v>
                </c:pt>
                <c:pt idx="69">
                  <c:v>31.84</c:v>
                </c:pt>
                <c:pt idx="70">
                  <c:v>89.28</c:v>
                </c:pt>
                <c:pt idx="71">
                  <c:v>34.39</c:v>
                </c:pt>
                <c:pt idx="72">
                  <c:v>25.18</c:v>
                </c:pt>
                <c:pt idx="73">
                  <c:v>24.03</c:v>
                </c:pt>
                <c:pt idx="74">
                  <c:v>36.11</c:v>
                </c:pt>
                <c:pt idx="75">
                  <c:v>74.53</c:v>
                </c:pt>
                <c:pt idx="76">
                  <c:v>30.9</c:v>
                </c:pt>
                <c:pt idx="77">
                  <c:v>17.75</c:v>
                </c:pt>
                <c:pt idx="78">
                  <c:v>78</c:v>
                </c:pt>
                <c:pt idx="79">
                  <c:v>45.36</c:v>
                </c:pt>
                <c:pt idx="80">
                  <c:v>72.48</c:v>
                </c:pt>
                <c:pt idx="81">
                  <c:v>59.07</c:v>
                </c:pt>
                <c:pt idx="82">
                  <c:v>107.8</c:v>
                </c:pt>
                <c:pt idx="83">
                  <c:v>89.52</c:v>
                </c:pt>
                <c:pt idx="84">
                  <c:v>8.3840000000000003</c:v>
                </c:pt>
                <c:pt idx="85">
                  <c:v>31.6</c:v>
                </c:pt>
                <c:pt idx="86">
                  <c:v>33.93</c:v>
                </c:pt>
                <c:pt idx="87">
                  <c:v>46.96</c:v>
                </c:pt>
                <c:pt idx="88">
                  <c:v>60.99</c:v>
                </c:pt>
                <c:pt idx="89">
                  <c:v>14</c:v>
                </c:pt>
                <c:pt idx="90">
                  <c:v>112.1</c:v>
                </c:pt>
                <c:pt idx="91">
                  <c:v>2.903</c:v>
                </c:pt>
                <c:pt idx="92">
                  <c:v>44.23</c:v>
                </c:pt>
                <c:pt idx="93">
                  <c:v>22.85</c:v>
                </c:pt>
                <c:pt idx="94">
                  <c:v>65.64</c:v>
                </c:pt>
                <c:pt idx="95">
                  <c:v>110.2</c:v>
                </c:pt>
                <c:pt idx="96">
                  <c:v>15.53</c:v>
                </c:pt>
                <c:pt idx="97">
                  <c:v>18.02</c:v>
                </c:pt>
                <c:pt idx="98">
                  <c:v>171.2</c:v>
                </c:pt>
                <c:pt idx="99">
                  <c:v>18.71</c:v>
                </c:pt>
                <c:pt idx="100">
                  <c:v>136</c:v>
                </c:pt>
                <c:pt idx="101">
                  <c:v>3.0070000000000001</c:v>
                </c:pt>
                <c:pt idx="102">
                  <c:v>68.91</c:v>
                </c:pt>
                <c:pt idx="103">
                  <c:v>89.68</c:v>
                </c:pt>
                <c:pt idx="104">
                  <c:v>158.5</c:v>
                </c:pt>
                <c:pt idx="105">
                  <c:v>42.56</c:v>
                </c:pt>
                <c:pt idx="106">
                  <c:v>153.19999999999999</c:v>
                </c:pt>
                <c:pt idx="107">
                  <c:v>56.01</c:v>
                </c:pt>
                <c:pt idx="108">
                  <c:v>68.58</c:v>
                </c:pt>
                <c:pt idx="109">
                  <c:v>109</c:v>
                </c:pt>
                <c:pt idx="110">
                  <c:v>28.67</c:v>
                </c:pt>
                <c:pt idx="111">
                  <c:v>8.9290000000000003</c:v>
                </c:pt>
                <c:pt idx="112">
                  <c:v>100.7</c:v>
                </c:pt>
                <c:pt idx="113">
                  <c:v>8.0760000000000005</c:v>
                </c:pt>
                <c:pt idx="114">
                  <c:v>57.16</c:v>
                </c:pt>
                <c:pt idx="115">
                  <c:v>4.8579999999999997</c:v>
                </c:pt>
                <c:pt idx="116">
                  <c:v>13.28</c:v>
                </c:pt>
                <c:pt idx="117">
                  <c:v>14.37</c:v>
                </c:pt>
                <c:pt idx="118">
                  <c:v>51.78</c:v>
                </c:pt>
                <c:pt idx="119">
                  <c:v>89.41</c:v>
                </c:pt>
                <c:pt idx="120">
                  <c:v>17.850000000000001</c:v>
                </c:pt>
                <c:pt idx="121">
                  <c:v>95.68</c:v>
                </c:pt>
                <c:pt idx="122">
                  <c:v>6.3529999999999998</c:v>
                </c:pt>
                <c:pt idx="123">
                  <c:v>62.67</c:v>
                </c:pt>
                <c:pt idx="124">
                  <c:v>117.2</c:v>
                </c:pt>
                <c:pt idx="125">
                  <c:v>14.15</c:v>
                </c:pt>
                <c:pt idx="126">
                  <c:v>14.2</c:v>
                </c:pt>
                <c:pt idx="127">
                  <c:v>41.35</c:v>
                </c:pt>
                <c:pt idx="128">
                  <c:v>12.24</c:v>
                </c:pt>
                <c:pt idx="129">
                  <c:v>189.5</c:v>
                </c:pt>
                <c:pt idx="130">
                  <c:v>167.2</c:v>
                </c:pt>
                <c:pt idx="131">
                  <c:v>136</c:v>
                </c:pt>
                <c:pt idx="132">
                  <c:v>240.9</c:v>
                </c:pt>
                <c:pt idx="133">
                  <c:v>79.540000000000006</c:v>
                </c:pt>
                <c:pt idx="134">
                  <c:v>13</c:v>
                </c:pt>
                <c:pt idx="135">
                  <c:v>15.48</c:v>
                </c:pt>
                <c:pt idx="136">
                  <c:v>33.770000000000003</c:v>
                </c:pt>
                <c:pt idx="137">
                  <c:v>139.30000000000001</c:v>
                </c:pt>
                <c:pt idx="138">
                  <c:v>16.149999999999999</c:v>
                </c:pt>
                <c:pt idx="139">
                  <c:v>49.9</c:v>
                </c:pt>
                <c:pt idx="140">
                  <c:v>298.39999999999998</c:v>
                </c:pt>
                <c:pt idx="141">
                  <c:v>124.1</c:v>
                </c:pt>
                <c:pt idx="142">
                  <c:v>49.24</c:v>
                </c:pt>
                <c:pt idx="143">
                  <c:v>11.11</c:v>
                </c:pt>
                <c:pt idx="144">
                  <c:v>38.4</c:v>
                </c:pt>
                <c:pt idx="145">
                  <c:v>94.59</c:v>
                </c:pt>
                <c:pt idx="146">
                  <c:v>29.46</c:v>
                </c:pt>
                <c:pt idx="147">
                  <c:v>125.8</c:v>
                </c:pt>
                <c:pt idx="148">
                  <c:v>79.52</c:v>
                </c:pt>
                <c:pt idx="149">
                  <c:v>2.2109999999999999</c:v>
                </c:pt>
                <c:pt idx="150">
                  <c:v>5.931</c:v>
                </c:pt>
                <c:pt idx="151">
                  <c:v>2.9129999999999998</c:v>
                </c:pt>
                <c:pt idx="152">
                  <c:v>10.11</c:v>
                </c:pt>
                <c:pt idx="153">
                  <c:v>95.81</c:v>
                </c:pt>
                <c:pt idx="154">
                  <c:v>96.62</c:v>
                </c:pt>
                <c:pt idx="155">
                  <c:v>53.32</c:v>
                </c:pt>
                <c:pt idx="156">
                  <c:v>25.32</c:v>
                </c:pt>
                <c:pt idx="157">
                  <c:v>108.7</c:v>
                </c:pt>
                <c:pt idx="158">
                  <c:v>5.4329999999999998</c:v>
                </c:pt>
                <c:pt idx="159">
                  <c:v>13.63</c:v>
                </c:pt>
                <c:pt idx="160">
                  <c:v>37.75</c:v>
                </c:pt>
                <c:pt idx="161">
                  <c:v>133.69999999999999</c:v>
                </c:pt>
                <c:pt idx="162">
                  <c:v>98.32</c:v>
                </c:pt>
                <c:pt idx="163">
                  <c:v>68.75</c:v>
                </c:pt>
                <c:pt idx="164">
                  <c:v>107.3</c:v>
                </c:pt>
                <c:pt idx="165">
                  <c:v>5.7050000000000001</c:v>
                </c:pt>
                <c:pt idx="166">
                  <c:v>35.520000000000003</c:v>
                </c:pt>
                <c:pt idx="167">
                  <c:v>163.19999999999999</c:v>
                </c:pt>
                <c:pt idx="168">
                  <c:v>2.246</c:v>
                </c:pt>
                <c:pt idx="169">
                  <c:v>13.25</c:v>
                </c:pt>
                <c:pt idx="170">
                  <c:v>94.8</c:v>
                </c:pt>
                <c:pt idx="171">
                  <c:v>155.5</c:v>
                </c:pt>
                <c:pt idx="172">
                  <c:v>72.900000000000006</c:v>
                </c:pt>
                <c:pt idx="173">
                  <c:v>21.36</c:v>
                </c:pt>
                <c:pt idx="174">
                  <c:v>53.61</c:v>
                </c:pt>
                <c:pt idx="175">
                  <c:v>123.9</c:v>
                </c:pt>
                <c:pt idx="176">
                  <c:v>35.880000000000003</c:v>
                </c:pt>
                <c:pt idx="177">
                  <c:v>4.0380000000000003</c:v>
                </c:pt>
                <c:pt idx="178">
                  <c:v>112.1</c:v>
                </c:pt>
                <c:pt idx="179">
                  <c:v>164.6</c:v>
                </c:pt>
                <c:pt idx="180">
                  <c:v>81.41</c:v>
                </c:pt>
                <c:pt idx="181">
                  <c:v>73.56</c:v>
                </c:pt>
                <c:pt idx="182">
                  <c:v>157.9</c:v>
                </c:pt>
                <c:pt idx="183">
                  <c:v>166.7</c:v>
                </c:pt>
                <c:pt idx="184">
                  <c:v>99.19</c:v>
                </c:pt>
                <c:pt idx="185">
                  <c:v>67.83</c:v>
                </c:pt>
                <c:pt idx="186">
                  <c:v>11.12</c:v>
                </c:pt>
                <c:pt idx="187">
                  <c:v>12.28</c:v>
                </c:pt>
                <c:pt idx="188">
                  <c:v>28.37</c:v>
                </c:pt>
                <c:pt idx="189">
                  <c:v>28.17</c:v>
                </c:pt>
                <c:pt idx="190">
                  <c:v>96.23</c:v>
                </c:pt>
                <c:pt idx="191">
                  <c:v>63.91</c:v>
                </c:pt>
                <c:pt idx="192">
                  <c:v>9.9510000000000005</c:v>
                </c:pt>
                <c:pt idx="193">
                  <c:v>116.3</c:v>
                </c:pt>
                <c:pt idx="194">
                  <c:v>19.77</c:v>
                </c:pt>
                <c:pt idx="195">
                  <c:v>102.8</c:v>
                </c:pt>
                <c:pt idx="196">
                  <c:v>76.66</c:v>
                </c:pt>
                <c:pt idx="197">
                  <c:v>136.4</c:v>
                </c:pt>
                <c:pt idx="198">
                  <c:v>29.53</c:v>
                </c:pt>
                <c:pt idx="199">
                  <c:v>124.1</c:v>
                </c:pt>
                <c:pt idx="200">
                  <c:v>12.7</c:v>
                </c:pt>
                <c:pt idx="201">
                  <c:v>37.380000000000003</c:v>
                </c:pt>
                <c:pt idx="202">
                  <c:v>72.38</c:v>
                </c:pt>
                <c:pt idx="203">
                  <c:v>151</c:v>
                </c:pt>
                <c:pt idx="204">
                  <c:v>45.32</c:v>
                </c:pt>
                <c:pt idx="205">
                  <c:v>68.75</c:v>
                </c:pt>
                <c:pt idx="206">
                  <c:v>14.11</c:v>
                </c:pt>
                <c:pt idx="207">
                  <c:v>5.3860000000000001</c:v>
                </c:pt>
                <c:pt idx="208">
                  <c:v>58.68</c:v>
                </c:pt>
                <c:pt idx="209">
                  <c:v>70.88</c:v>
                </c:pt>
                <c:pt idx="210">
                  <c:v>14.26</c:v>
                </c:pt>
                <c:pt idx="211">
                  <c:v>100.1</c:v>
                </c:pt>
                <c:pt idx="212">
                  <c:v>20.260000000000002</c:v>
                </c:pt>
                <c:pt idx="213">
                  <c:v>94.88</c:v>
                </c:pt>
                <c:pt idx="214">
                  <c:v>66.739999999999995</c:v>
                </c:pt>
                <c:pt idx="215">
                  <c:v>11.67</c:v>
                </c:pt>
                <c:pt idx="216">
                  <c:v>27.48</c:v>
                </c:pt>
                <c:pt idx="217">
                  <c:v>92.33</c:v>
                </c:pt>
                <c:pt idx="218">
                  <c:v>186.7</c:v>
                </c:pt>
                <c:pt idx="219">
                  <c:v>8.8710000000000004</c:v>
                </c:pt>
                <c:pt idx="220">
                  <c:v>43.35</c:v>
                </c:pt>
                <c:pt idx="221">
                  <c:v>37.17</c:v>
                </c:pt>
                <c:pt idx="222">
                  <c:v>83.91</c:v>
                </c:pt>
                <c:pt idx="223">
                  <c:v>45.27</c:v>
                </c:pt>
                <c:pt idx="224">
                  <c:v>29.16</c:v>
                </c:pt>
                <c:pt idx="225">
                  <c:v>192.9</c:v>
                </c:pt>
                <c:pt idx="226">
                  <c:v>72.150000000000006</c:v>
                </c:pt>
                <c:pt idx="227">
                  <c:v>116.2</c:v>
                </c:pt>
                <c:pt idx="228">
                  <c:v>17.41</c:v>
                </c:pt>
                <c:pt idx="229">
                  <c:v>129.5</c:v>
                </c:pt>
                <c:pt idx="230">
                  <c:v>8.7490000000000006</c:v>
                </c:pt>
                <c:pt idx="231">
                  <c:v>38.07</c:v>
                </c:pt>
                <c:pt idx="232">
                  <c:v>113.4</c:v>
                </c:pt>
                <c:pt idx="233">
                  <c:v>69.06</c:v>
                </c:pt>
                <c:pt idx="234">
                  <c:v>82.15</c:v>
                </c:pt>
                <c:pt idx="235">
                  <c:v>3.5329999999999999</c:v>
                </c:pt>
                <c:pt idx="236">
                  <c:v>45.89</c:v>
                </c:pt>
                <c:pt idx="237">
                  <c:v>95.2</c:v>
                </c:pt>
                <c:pt idx="238">
                  <c:v>71.77</c:v>
                </c:pt>
                <c:pt idx="239">
                  <c:v>31.35</c:v>
                </c:pt>
                <c:pt idx="240">
                  <c:v>147.19999999999999</c:v>
                </c:pt>
              </c:numCache>
            </c:numRef>
          </c:yVal>
          <c:smooth val="0"/>
          <c:extLst xmlns:c16r2="http://schemas.microsoft.com/office/drawing/2015/06/chart">
            <c:ext xmlns:c16="http://schemas.microsoft.com/office/drawing/2014/chart" uri="{C3380CC4-5D6E-409C-BE32-E72D297353CC}">
              <c16:uniqueId val="{00000000-BF9C-48F3-B7E9-32B7E9155911}"/>
            </c:ext>
          </c:extLst>
        </c:ser>
        <c:ser>
          <c:idx val="1"/>
          <c:order val="1"/>
          <c:tx>
            <c:strRef>
              <c:f>'vis BMI cor'!$A$16</c:f>
              <c:strCache>
                <c:ptCount val="1"/>
                <c:pt idx="0">
                  <c:v>FEMALE</c:v>
                </c:pt>
              </c:strCache>
            </c:strRef>
          </c:tx>
          <c:spPr>
            <a:ln w="25400" cap="rnd">
              <a:noFill/>
              <a:round/>
            </a:ln>
            <a:effectLst/>
          </c:spPr>
          <c:marker>
            <c:symbol val="circle"/>
            <c:size val="3"/>
            <c:spPr>
              <a:solidFill>
                <a:schemeClr val="accent2"/>
              </a:solidFill>
              <a:ln w="9525">
                <a:solidFill>
                  <a:schemeClr val="accent2"/>
                </a:solidFill>
              </a:ln>
              <a:effectLst/>
            </c:spPr>
          </c:marker>
          <c:trendline>
            <c:spPr>
              <a:ln w="19050" cap="rnd">
                <a:solidFill>
                  <a:schemeClr val="accent2"/>
                </a:solidFill>
                <a:prstDash val="solid"/>
              </a:ln>
              <a:effectLst/>
            </c:spPr>
            <c:trendlineType val="linear"/>
            <c:dispRSqr val="0"/>
            <c:dispEq val="0"/>
          </c:trendline>
          <c:xVal>
            <c:numRef>
              <c:f>'vis BMI cor'!$G$24:$FG$24</c:f>
              <c:numCache>
                <c:formatCode>General</c:formatCode>
                <c:ptCount val="157"/>
                <c:pt idx="0">
                  <c:v>32.119999999999997</c:v>
                </c:pt>
                <c:pt idx="1">
                  <c:v>32.76</c:v>
                </c:pt>
                <c:pt idx="2">
                  <c:v>25.82</c:v>
                </c:pt>
                <c:pt idx="3">
                  <c:v>27.99</c:v>
                </c:pt>
                <c:pt idx="4">
                  <c:v>21.63</c:v>
                </c:pt>
                <c:pt idx="5">
                  <c:v>22.21</c:v>
                </c:pt>
                <c:pt idx="6">
                  <c:v>29.35</c:v>
                </c:pt>
                <c:pt idx="7">
                  <c:v>30.87</c:v>
                </c:pt>
                <c:pt idx="8">
                  <c:v>32.28</c:v>
                </c:pt>
                <c:pt idx="9">
                  <c:v>23.6</c:v>
                </c:pt>
                <c:pt idx="10">
                  <c:v>31.93</c:v>
                </c:pt>
                <c:pt idx="11">
                  <c:v>22.85</c:v>
                </c:pt>
                <c:pt idx="12">
                  <c:v>32.89</c:v>
                </c:pt>
                <c:pt idx="13">
                  <c:v>26.12</c:v>
                </c:pt>
                <c:pt idx="14">
                  <c:v>29.45</c:v>
                </c:pt>
                <c:pt idx="15">
                  <c:v>28.81</c:v>
                </c:pt>
                <c:pt idx="16">
                  <c:v>33.89</c:v>
                </c:pt>
                <c:pt idx="17">
                  <c:v>24.97</c:v>
                </c:pt>
                <c:pt idx="18">
                  <c:v>21.41</c:v>
                </c:pt>
                <c:pt idx="19">
                  <c:v>23.02</c:v>
                </c:pt>
                <c:pt idx="20">
                  <c:v>33.28</c:v>
                </c:pt>
                <c:pt idx="21">
                  <c:v>19.52</c:v>
                </c:pt>
                <c:pt idx="22">
                  <c:v>27.79</c:v>
                </c:pt>
                <c:pt idx="23">
                  <c:v>25.77</c:v>
                </c:pt>
                <c:pt idx="24">
                  <c:v>29.02</c:v>
                </c:pt>
                <c:pt idx="25">
                  <c:v>27.24</c:v>
                </c:pt>
                <c:pt idx="26">
                  <c:v>34.99</c:v>
                </c:pt>
                <c:pt idx="27">
                  <c:v>26.88</c:v>
                </c:pt>
                <c:pt idx="28">
                  <c:v>29.86</c:v>
                </c:pt>
                <c:pt idx="29">
                  <c:v>30.21</c:v>
                </c:pt>
                <c:pt idx="30">
                  <c:v>21.21</c:v>
                </c:pt>
                <c:pt idx="31">
                  <c:v>29.43</c:v>
                </c:pt>
                <c:pt idx="32">
                  <c:v>29.08</c:v>
                </c:pt>
                <c:pt idx="33">
                  <c:v>29.75</c:v>
                </c:pt>
                <c:pt idx="34">
                  <c:v>28.89</c:v>
                </c:pt>
                <c:pt idx="35">
                  <c:v>29.3</c:v>
                </c:pt>
                <c:pt idx="36">
                  <c:v>24.13</c:v>
                </c:pt>
                <c:pt idx="37">
                  <c:v>23.89</c:v>
                </c:pt>
                <c:pt idx="38">
                  <c:v>31.12</c:v>
                </c:pt>
                <c:pt idx="39">
                  <c:v>22.31</c:v>
                </c:pt>
                <c:pt idx="40">
                  <c:v>31.32</c:v>
                </c:pt>
                <c:pt idx="41">
                  <c:v>25.97</c:v>
                </c:pt>
                <c:pt idx="42">
                  <c:v>27.62</c:v>
                </c:pt>
                <c:pt idx="43">
                  <c:v>27.98</c:v>
                </c:pt>
                <c:pt idx="44">
                  <c:v>26.78</c:v>
                </c:pt>
                <c:pt idx="45">
                  <c:v>25.34</c:v>
                </c:pt>
                <c:pt idx="46">
                  <c:v>26.62</c:v>
                </c:pt>
                <c:pt idx="47">
                  <c:v>24.97</c:v>
                </c:pt>
                <c:pt idx="48">
                  <c:v>19.13</c:v>
                </c:pt>
                <c:pt idx="49">
                  <c:v>28.11</c:v>
                </c:pt>
                <c:pt idx="50">
                  <c:v>22.14</c:v>
                </c:pt>
                <c:pt idx="51">
                  <c:v>26.57</c:v>
                </c:pt>
                <c:pt idx="52">
                  <c:v>20.7</c:v>
                </c:pt>
                <c:pt idx="53">
                  <c:v>24.37</c:v>
                </c:pt>
                <c:pt idx="54">
                  <c:v>29.53</c:v>
                </c:pt>
                <c:pt idx="55">
                  <c:v>26.92</c:v>
                </c:pt>
                <c:pt idx="56">
                  <c:v>24.97</c:v>
                </c:pt>
                <c:pt idx="57">
                  <c:v>34.96</c:v>
                </c:pt>
                <c:pt idx="58">
                  <c:v>24.1</c:v>
                </c:pt>
                <c:pt idx="59">
                  <c:v>27.39</c:v>
                </c:pt>
                <c:pt idx="60">
                  <c:v>25.42</c:v>
                </c:pt>
                <c:pt idx="61">
                  <c:v>30.82</c:v>
                </c:pt>
                <c:pt idx="62">
                  <c:v>24.39</c:v>
                </c:pt>
                <c:pt idx="63">
                  <c:v>20.97</c:v>
                </c:pt>
                <c:pt idx="64">
                  <c:v>32.44</c:v>
                </c:pt>
                <c:pt idx="65">
                  <c:v>25.98</c:v>
                </c:pt>
                <c:pt idx="66">
                  <c:v>26.61</c:v>
                </c:pt>
                <c:pt idx="67">
                  <c:v>24.14</c:v>
                </c:pt>
                <c:pt idx="68">
                  <c:v>27.6</c:v>
                </c:pt>
                <c:pt idx="69">
                  <c:v>31.79</c:v>
                </c:pt>
                <c:pt idx="70">
                  <c:v>22.46</c:v>
                </c:pt>
                <c:pt idx="71">
                  <c:v>23.9</c:v>
                </c:pt>
                <c:pt idx="72">
                  <c:v>27.98</c:v>
                </c:pt>
                <c:pt idx="73">
                  <c:v>30.63</c:v>
                </c:pt>
                <c:pt idx="74">
                  <c:v>29.57</c:v>
                </c:pt>
                <c:pt idx="75">
                  <c:v>23.81</c:v>
                </c:pt>
                <c:pt idx="76">
                  <c:v>24.13</c:v>
                </c:pt>
                <c:pt idx="77">
                  <c:v>31.75</c:v>
                </c:pt>
                <c:pt idx="78">
                  <c:v>31.45</c:v>
                </c:pt>
                <c:pt idx="79">
                  <c:v>24.96</c:v>
                </c:pt>
                <c:pt idx="80">
                  <c:v>21.16</c:v>
                </c:pt>
                <c:pt idx="81">
                  <c:v>23.34</c:v>
                </c:pt>
                <c:pt idx="82">
                  <c:v>25.7</c:v>
                </c:pt>
                <c:pt idx="83">
                  <c:v>31.24</c:v>
                </c:pt>
                <c:pt idx="84">
                  <c:v>33.42</c:v>
                </c:pt>
                <c:pt idx="85">
                  <c:v>20.85</c:v>
                </c:pt>
                <c:pt idx="86">
                  <c:v>32.22</c:v>
                </c:pt>
                <c:pt idx="87">
                  <c:v>30.18</c:v>
                </c:pt>
                <c:pt idx="88">
                  <c:v>25.21</c:v>
                </c:pt>
                <c:pt idx="89">
                  <c:v>23.15</c:v>
                </c:pt>
                <c:pt idx="90">
                  <c:v>24.42</c:v>
                </c:pt>
                <c:pt idx="91">
                  <c:v>22.72</c:v>
                </c:pt>
                <c:pt idx="92">
                  <c:v>27.07</c:v>
                </c:pt>
                <c:pt idx="93">
                  <c:v>21.48</c:v>
                </c:pt>
                <c:pt idx="94">
                  <c:v>24.54</c:v>
                </c:pt>
                <c:pt idx="95">
                  <c:v>24.14</c:v>
                </c:pt>
                <c:pt idx="96">
                  <c:v>29.75</c:v>
                </c:pt>
                <c:pt idx="97">
                  <c:v>25.88</c:v>
                </c:pt>
                <c:pt idx="98">
                  <c:v>29.53</c:v>
                </c:pt>
                <c:pt idx="99">
                  <c:v>33.28</c:v>
                </c:pt>
                <c:pt idx="100">
                  <c:v>33.51</c:v>
                </c:pt>
                <c:pt idx="101">
                  <c:v>30.78</c:v>
                </c:pt>
                <c:pt idx="102">
                  <c:v>21.97</c:v>
                </c:pt>
                <c:pt idx="103">
                  <c:v>23.97</c:v>
                </c:pt>
                <c:pt idx="104">
                  <c:v>32.19</c:v>
                </c:pt>
                <c:pt idx="105">
                  <c:v>25.01</c:v>
                </c:pt>
                <c:pt idx="106">
                  <c:v>26.63</c:v>
                </c:pt>
                <c:pt idx="107">
                  <c:v>27.52</c:v>
                </c:pt>
                <c:pt idx="108">
                  <c:v>27.8</c:v>
                </c:pt>
                <c:pt idx="109">
                  <c:v>24.06</c:v>
                </c:pt>
                <c:pt idx="110">
                  <c:v>21.96</c:v>
                </c:pt>
                <c:pt idx="111">
                  <c:v>30.96</c:v>
                </c:pt>
                <c:pt idx="112">
                  <c:v>33.08</c:v>
                </c:pt>
                <c:pt idx="113">
                  <c:v>31.61</c:v>
                </c:pt>
              </c:numCache>
            </c:numRef>
          </c:xVal>
          <c:yVal>
            <c:numRef>
              <c:f>'vis BMI cor'!$G$27:$FG$27</c:f>
              <c:numCache>
                <c:formatCode>General</c:formatCode>
                <c:ptCount val="157"/>
                <c:pt idx="0">
                  <c:v>27.15</c:v>
                </c:pt>
                <c:pt idx="1">
                  <c:v>347.1</c:v>
                </c:pt>
                <c:pt idx="2">
                  <c:v>11.46</c:v>
                </c:pt>
                <c:pt idx="3">
                  <c:v>11.84</c:v>
                </c:pt>
                <c:pt idx="4">
                  <c:v>88.31</c:v>
                </c:pt>
                <c:pt idx="5">
                  <c:v>37.700000000000003</c:v>
                </c:pt>
                <c:pt idx="6">
                  <c:v>324.8</c:v>
                </c:pt>
                <c:pt idx="7">
                  <c:v>269.10000000000002</c:v>
                </c:pt>
                <c:pt idx="8">
                  <c:v>29.52</c:v>
                </c:pt>
                <c:pt idx="9">
                  <c:v>134.4</c:v>
                </c:pt>
                <c:pt idx="10">
                  <c:v>127.4</c:v>
                </c:pt>
                <c:pt idx="11">
                  <c:v>284.7</c:v>
                </c:pt>
                <c:pt idx="12">
                  <c:v>67.47</c:v>
                </c:pt>
                <c:pt idx="13">
                  <c:v>39.58</c:v>
                </c:pt>
                <c:pt idx="14">
                  <c:v>344.1</c:v>
                </c:pt>
                <c:pt idx="15">
                  <c:v>139</c:v>
                </c:pt>
                <c:pt idx="16">
                  <c:v>230.4</c:v>
                </c:pt>
                <c:pt idx="17">
                  <c:v>332.7</c:v>
                </c:pt>
                <c:pt idx="18">
                  <c:v>134.4</c:v>
                </c:pt>
                <c:pt idx="19">
                  <c:v>105.9</c:v>
                </c:pt>
                <c:pt idx="20">
                  <c:v>130.6</c:v>
                </c:pt>
                <c:pt idx="21">
                  <c:v>120.8</c:v>
                </c:pt>
                <c:pt idx="22">
                  <c:v>149.30000000000001</c:v>
                </c:pt>
                <c:pt idx="23">
                  <c:v>62</c:v>
                </c:pt>
                <c:pt idx="24">
                  <c:v>281.8</c:v>
                </c:pt>
                <c:pt idx="25">
                  <c:v>212.7</c:v>
                </c:pt>
                <c:pt idx="26">
                  <c:v>216.3</c:v>
                </c:pt>
                <c:pt idx="27">
                  <c:v>32.92</c:v>
                </c:pt>
                <c:pt idx="28">
                  <c:v>233.1</c:v>
                </c:pt>
                <c:pt idx="29">
                  <c:v>112.8</c:v>
                </c:pt>
                <c:pt idx="30">
                  <c:v>13.65</c:v>
                </c:pt>
                <c:pt idx="31">
                  <c:v>156</c:v>
                </c:pt>
                <c:pt idx="32">
                  <c:v>159.30000000000001</c:v>
                </c:pt>
                <c:pt idx="33">
                  <c:v>170.4</c:v>
                </c:pt>
                <c:pt idx="34">
                  <c:v>13.83</c:v>
                </c:pt>
                <c:pt idx="35">
                  <c:v>79.349999999999994</c:v>
                </c:pt>
                <c:pt idx="36">
                  <c:v>112.2</c:v>
                </c:pt>
                <c:pt idx="37">
                  <c:v>5.1230000000000002</c:v>
                </c:pt>
                <c:pt idx="38">
                  <c:v>57.54</c:v>
                </c:pt>
                <c:pt idx="39">
                  <c:v>25.05</c:v>
                </c:pt>
                <c:pt idx="40">
                  <c:v>16.37</c:v>
                </c:pt>
                <c:pt idx="41">
                  <c:v>20.079999999999998</c:v>
                </c:pt>
                <c:pt idx="42">
                  <c:v>286.2</c:v>
                </c:pt>
                <c:pt idx="43">
                  <c:v>116.4</c:v>
                </c:pt>
                <c:pt idx="44">
                  <c:v>111.7</c:v>
                </c:pt>
                <c:pt idx="45">
                  <c:v>127.3</c:v>
                </c:pt>
                <c:pt idx="46">
                  <c:v>48.21</c:v>
                </c:pt>
                <c:pt idx="47">
                  <c:v>295.7</c:v>
                </c:pt>
                <c:pt idx="48">
                  <c:v>86.93</c:v>
                </c:pt>
                <c:pt idx="49">
                  <c:v>465.7</c:v>
                </c:pt>
                <c:pt idx="50">
                  <c:v>22.4</c:v>
                </c:pt>
                <c:pt idx="51">
                  <c:v>115.2</c:v>
                </c:pt>
                <c:pt idx="52">
                  <c:v>271.8</c:v>
                </c:pt>
                <c:pt idx="53">
                  <c:v>86.89</c:v>
                </c:pt>
                <c:pt idx="54">
                  <c:v>282.8</c:v>
                </c:pt>
                <c:pt idx="55">
                  <c:v>158.6</c:v>
                </c:pt>
                <c:pt idx="56">
                  <c:v>101.3</c:v>
                </c:pt>
                <c:pt idx="57">
                  <c:v>146.5</c:v>
                </c:pt>
                <c:pt idx="58">
                  <c:v>52.77</c:v>
                </c:pt>
                <c:pt idx="59">
                  <c:v>194.9</c:v>
                </c:pt>
                <c:pt idx="60">
                  <c:v>137.4</c:v>
                </c:pt>
                <c:pt idx="61">
                  <c:v>44.24</c:v>
                </c:pt>
                <c:pt idx="62">
                  <c:v>153.19999999999999</c:v>
                </c:pt>
                <c:pt idx="63">
                  <c:v>23.96</c:v>
                </c:pt>
                <c:pt idx="64">
                  <c:v>135</c:v>
                </c:pt>
                <c:pt idx="65">
                  <c:v>172.3</c:v>
                </c:pt>
                <c:pt idx="66">
                  <c:v>37.450000000000003</c:v>
                </c:pt>
                <c:pt idx="67">
                  <c:v>308.2</c:v>
                </c:pt>
                <c:pt idx="68">
                  <c:v>38.020000000000003</c:v>
                </c:pt>
                <c:pt idx="69">
                  <c:v>29.66</c:v>
                </c:pt>
                <c:pt idx="70">
                  <c:v>174</c:v>
                </c:pt>
                <c:pt idx="71">
                  <c:v>12.85</c:v>
                </c:pt>
                <c:pt idx="72">
                  <c:v>27.09</c:v>
                </c:pt>
                <c:pt idx="73">
                  <c:v>67.11</c:v>
                </c:pt>
                <c:pt idx="74">
                  <c:v>260.39999999999998</c:v>
                </c:pt>
                <c:pt idx="75">
                  <c:v>238.3</c:v>
                </c:pt>
                <c:pt idx="76">
                  <c:v>221.3</c:v>
                </c:pt>
                <c:pt idx="77">
                  <c:v>60.98</c:v>
                </c:pt>
                <c:pt idx="78">
                  <c:v>142.5</c:v>
                </c:pt>
                <c:pt idx="79">
                  <c:v>373.6</c:v>
                </c:pt>
                <c:pt idx="80">
                  <c:v>202.2</c:v>
                </c:pt>
                <c:pt idx="81">
                  <c:v>186.5</c:v>
                </c:pt>
                <c:pt idx="82">
                  <c:v>32.19</c:v>
                </c:pt>
                <c:pt idx="83">
                  <c:v>11.49</c:v>
                </c:pt>
                <c:pt idx="84">
                  <c:v>32.72</c:v>
                </c:pt>
                <c:pt idx="85">
                  <c:v>30.75</c:v>
                </c:pt>
                <c:pt idx="86">
                  <c:v>118.6</c:v>
                </c:pt>
                <c:pt idx="87">
                  <c:v>70.099999999999994</c:v>
                </c:pt>
                <c:pt idx="88">
                  <c:v>326.8</c:v>
                </c:pt>
                <c:pt idx="89">
                  <c:v>79.09</c:v>
                </c:pt>
                <c:pt idx="90">
                  <c:v>63.15</c:v>
                </c:pt>
                <c:pt idx="91">
                  <c:v>230.2</c:v>
                </c:pt>
                <c:pt idx="92">
                  <c:v>389.4</c:v>
                </c:pt>
                <c:pt idx="93">
                  <c:v>247.3</c:v>
                </c:pt>
                <c:pt idx="94">
                  <c:v>18.100000000000001</c:v>
                </c:pt>
                <c:pt idx="95">
                  <c:v>48.73</c:v>
                </c:pt>
                <c:pt idx="96">
                  <c:v>44.18</c:v>
                </c:pt>
                <c:pt idx="97">
                  <c:v>384.2</c:v>
                </c:pt>
                <c:pt idx="98">
                  <c:v>624</c:v>
                </c:pt>
                <c:pt idx="99">
                  <c:v>171</c:v>
                </c:pt>
                <c:pt idx="100">
                  <c:v>40.1</c:v>
                </c:pt>
                <c:pt idx="101">
                  <c:v>183.9</c:v>
                </c:pt>
                <c:pt idx="102">
                  <c:v>276.60000000000002</c:v>
                </c:pt>
                <c:pt idx="103">
                  <c:v>405.6</c:v>
                </c:pt>
                <c:pt idx="104">
                  <c:v>353.1</c:v>
                </c:pt>
                <c:pt idx="105">
                  <c:v>139.6</c:v>
                </c:pt>
                <c:pt idx="106">
                  <c:v>114.4</c:v>
                </c:pt>
                <c:pt idx="107">
                  <c:v>157.4</c:v>
                </c:pt>
                <c:pt idx="108">
                  <c:v>270.7</c:v>
                </c:pt>
                <c:pt idx="109">
                  <c:v>213</c:v>
                </c:pt>
                <c:pt idx="110">
                  <c:v>147.4</c:v>
                </c:pt>
                <c:pt idx="111">
                  <c:v>307.60000000000002</c:v>
                </c:pt>
                <c:pt idx="112">
                  <c:v>5.609</c:v>
                </c:pt>
                <c:pt idx="113">
                  <c:v>82.89</c:v>
                </c:pt>
              </c:numCache>
            </c:numRef>
          </c:yVal>
          <c:smooth val="0"/>
          <c:extLst xmlns:c16r2="http://schemas.microsoft.com/office/drawing/2015/06/chart">
            <c:ext xmlns:c16="http://schemas.microsoft.com/office/drawing/2014/chart" uri="{C3380CC4-5D6E-409C-BE32-E72D297353CC}">
              <c16:uniqueId val="{00000001-BF9C-48F3-B7E9-32B7E9155911}"/>
            </c:ext>
          </c:extLst>
        </c:ser>
        <c:dLbls>
          <c:showLegendKey val="0"/>
          <c:showVal val="0"/>
          <c:showCatName val="0"/>
          <c:showSerName val="0"/>
          <c:showPercent val="0"/>
          <c:showBubbleSize val="0"/>
        </c:dLbls>
        <c:axId val="-1517550672"/>
        <c:axId val="-1517550128"/>
      </c:scatterChart>
      <c:valAx>
        <c:axId val="-1517550672"/>
        <c:scaling>
          <c:orientation val="minMax"/>
          <c:max val="40"/>
          <c:min val="15"/>
        </c:scaling>
        <c:delete val="0"/>
        <c:axPos val="b"/>
        <c:title>
          <c:tx>
            <c:rich>
              <a:bodyPr rot="0" spcFirstLastPara="1" vertOverflow="ellipsis" vert="horz" wrap="square" anchor="ctr" anchorCtr="1"/>
              <a:lstStyle/>
              <a:p>
                <a:pPr>
                  <a:defRPr sz="800" b="0" i="0" u="none" strike="noStrike" kern="1200" baseline="0">
                    <a:solidFill>
                      <a:schemeClr val="tx1">
                        <a:lumMod val="65000"/>
                        <a:lumOff val="35000"/>
                      </a:schemeClr>
                    </a:solidFill>
                    <a:latin typeface="+mn-lt"/>
                    <a:ea typeface="+mn-ea"/>
                    <a:cs typeface="+mn-cs"/>
                  </a:defRPr>
                </a:pPr>
                <a:r>
                  <a:rPr lang="en-US"/>
                  <a:t>BMI</a:t>
                </a:r>
                <a:endParaRPr lang="ko-KR"/>
              </a:p>
            </c:rich>
          </c:tx>
          <c:overlay val="0"/>
          <c:spPr>
            <a:noFill/>
            <a:ln>
              <a:noFill/>
            </a:ln>
            <a:effectLst/>
          </c:spPr>
          <c:txPr>
            <a:bodyPr rot="0" spcFirstLastPara="1" vertOverflow="ellipsis" vert="horz" wrap="square" anchor="ctr" anchorCtr="1"/>
            <a:lstStyle/>
            <a:p>
              <a:pPr>
                <a:defRPr sz="8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mn-lt"/>
                <a:ea typeface="+mn-ea"/>
                <a:cs typeface="+mn-cs"/>
              </a:defRPr>
            </a:pPr>
            <a:endParaRPr lang="en-US"/>
          </a:p>
        </c:txPr>
        <c:crossAx val="-1517550128"/>
        <c:crosses val="autoZero"/>
        <c:crossBetween val="midCat"/>
      </c:valAx>
      <c:valAx>
        <c:axId val="-1517550128"/>
        <c:scaling>
          <c:orientation val="minMax"/>
        </c:scaling>
        <c:delete val="0"/>
        <c:axPos val="l"/>
        <c:title>
          <c:tx>
            <c:rich>
              <a:bodyPr rot="-5400000" spcFirstLastPara="1" vertOverflow="ellipsis" vert="horz" wrap="square" anchor="ctr" anchorCtr="1"/>
              <a:lstStyle/>
              <a:p>
                <a:pPr>
                  <a:defRPr sz="800" b="0" i="0" u="none" strike="noStrike" kern="1200" baseline="0">
                    <a:solidFill>
                      <a:schemeClr val="tx1">
                        <a:lumMod val="65000"/>
                        <a:lumOff val="35000"/>
                      </a:schemeClr>
                    </a:solidFill>
                    <a:latin typeface="+mn-lt"/>
                    <a:ea typeface="+mn-ea"/>
                    <a:cs typeface="+mn-cs"/>
                  </a:defRPr>
                </a:pPr>
                <a:r>
                  <a:rPr lang="en-US" dirty="0"/>
                  <a:t>GYG2 mRNA </a:t>
                </a:r>
                <a:r>
                  <a:rPr lang="en-US" dirty="0" smtClean="0"/>
                  <a:t>(</a:t>
                </a:r>
                <a:r>
                  <a:rPr lang="en-US" altLang="ko-KR" dirty="0" smtClean="0"/>
                  <a:t>TPM</a:t>
                </a:r>
                <a:r>
                  <a:rPr lang="en-US" dirty="0" smtClean="0"/>
                  <a:t>)</a:t>
                </a:r>
                <a:endParaRPr lang="ko-KR" dirty="0"/>
              </a:p>
            </c:rich>
          </c:tx>
          <c:overlay val="0"/>
          <c:spPr>
            <a:noFill/>
            <a:ln>
              <a:noFill/>
            </a:ln>
            <a:effectLst/>
          </c:spPr>
          <c:txPr>
            <a:bodyPr rot="-5400000" spcFirstLastPara="1" vertOverflow="ellipsis" vert="horz" wrap="square" anchor="ctr" anchorCtr="1"/>
            <a:lstStyle/>
            <a:p>
              <a:pPr>
                <a:defRPr sz="8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mn-lt"/>
                <a:ea typeface="+mn-ea"/>
                <a:cs typeface="+mn-cs"/>
              </a:defRPr>
            </a:pPr>
            <a:endParaRPr lang="en-US"/>
          </a:p>
        </c:txPr>
        <c:crossAx val="-1517550672"/>
        <c:crosses val="autoZero"/>
        <c:crossBetween val="midCat"/>
      </c:valAx>
      <c:spPr>
        <a:noFill/>
        <a:ln>
          <a:noFill/>
        </a:ln>
        <a:effectLst/>
      </c:spPr>
    </c:plotArea>
    <c:plotVisOnly val="1"/>
    <c:dispBlanksAs val="gap"/>
    <c:showDLblsOverMax val="0"/>
  </c:chart>
  <c:spPr>
    <a:noFill/>
    <a:ln>
      <a:noFill/>
    </a:ln>
    <a:effectLst/>
  </c:spPr>
  <c:txPr>
    <a:bodyPr/>
    <a:lstStyle/>
    <a:p>
      <a:pPr>
        <a:defRPr sz="800">
          <a:latin typeface="+mn-lt"/>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31027500000000002"/>
          <c:y val="3.9400694444444447E-2"/>
          <c:w val="0.58459722222222232"/>
          <c:h val="0.72898611111111111"/>
        </c:manualLayout>
      </c:layout>
      <c:scatterChart>
        <c:scatterStyle val="lineMarker"/>
        <c:varyColors val="0"/>
        <c:ser>
          <c:idx val="0"/>
          <c:order val="0"/>
          <c:spPr>
            <a:ln w="19050" cap="rnd">
              <a:noFill/>
              <a:round/>
            </a:ln>
            <a:effectLst/>
          </c:spPr>
          <c:marker>
            <c:symbol val="circle"/>
            <c:size val="2"/>
            <c:spPr>
              <a:solidFill>
                <a:schemeClr val="tx1"/>
              </a:solidFill>
              <a:ln w="9525">
                <a:noFill/>
              </a:ln>
              <a:effectLst/>
            </c:spPr>
          </c:marker>
          <c:trendline>
            <c:spPr>
              <a:ln w="19050" cap="rnd">
                <a:solidFill>
                  <a:schemeClr val="accent1"/>
                </a:solidFill>
                <a:prstDash val="sysDot"/>
              </a:ln>
              <a:effectLst/>
            </c:spPr>
            <c:trendlineType val="linear"/>
            <c:dispRSqr val="0"/>
            <c:dispEq val="0"/>
          </c:trendline>
          <c:trendline>
            <c:spPr>
              <a:ln w="19050" cap="rnd">
                <a:solidFill>
                  <a:schemeClr val="tx1"/>
                </a:solidFill>
                <a:prstDash val="solid"/>
              </a:ln>
              <a:effectLst/>
            </c:spPr>
            <c:trendlineType val="linear"/>
            <c:dispRSqr val="0"/>
            <c:dispEq val="0"/>
          </c:trendline>
          <c:xVal>
            <c:numRef>
              <c:f>sub!$L$8:$L$449</c:f>
              <c:numCache>
                <c:formatCode>General</c:formatCode>
                <c:ptCount val="442"/>
                <c:pt idx="0">
                  <c:v>375.1</c:v>
                </c:pt>
                <c:pt idx="1">
                  <c:v>261.60000000000002</c:v>
                </c:pt>
                <c:pt idx="2">
                  <c:v>450.3</c:v>
                </c:pt>
                <c:pt idx="3">
                  <c:v>74.84</c:v>
                </c:pt>
                <c:pt idx="4">
                  <c:v>138.9</c:v>
                </c:pt>
                <c:pt idx="5">
                  <c:v>232.8</c:v>
                </c:pt>
                <c:pt idx="6">
                  <c:v>190.5</c:v>
                </c:pt>
                <c:pt idx="7">
                  <c:v>443.6</c:v>
                </c:pt>
                <c:pt idx="8">
                  <c:v>335.7</c:v>
                </c:pt>
                <c:pt idx="9">
                  <c:v>240.4</c:v>
                </c:pt>
                <c:pt idx="10">
                  <c:v>198.2</c:v>
                </c:pt>
                <c:pt idx="11">
                  <c:v>449.6</c:v>
                </c:pt>
                <c:pt idx="12">
                  <c:v>252.4</c:v>
                </c:pt>
                <c:pt idx="13">
                  <c:v>133.69999999999999</c:v>
                </c:pt>
                <c:pt idx="14">
                  <c:v>164.8</c:v>
                </c:pt>
                <c:pt idx="15">
                  <c:v>352.2</c:v>
                </c:pt>
                <c:pt idx="16">
                  <c:v>387.5</c:v>
                </c:pt>
                <c:pt idx="17">
                  <c:v>282.60000000000002</c:v>
                </c:pt>
                <c:pt idx="18">
                  <c:v>271.8</c:v>
                </c:pt>
                <c:pt idx="19">
                  <c:v>24.36</c:v>
                </c:pt>
                <c:pt idx="20">
                  <c:v>310.7</c:v>
                </c:pt>
                <c:pt idx="21">
                  <c:v>258.5</c:v>
                </c:pt>
                <c:pt idx="22">
                  <c:v>69.680000000000007</c:v>
                </c:pt>
                <c:pt idx="23">
                  <c:v>461.9</c:v>
                </c:pt>
                <c:pt idx="24">
                  <c:v>419.8</c:v>
                </c:pt>
                <c:pt idx="25">
                  <c:v>406.9</c:v>
                </c:pt>
                <c:pt idx="26">
                  <c:v>179.6</c:v>
                </c:pt>
                <c:pt idx="27">
                  <c:v>182.3</c:v>
                </c:pt>
                <c:pt idx="28">
                  <c:v>268.8</c:v>
                </c:pt>
                <c:pt idx="29">
                  <c:v>140.69999999999999</c:v>
                </c:pt>
                <c:pt idx="30">
                  <c:v>224</c:v>
                </c:pt>
                <c:pt idx="31">
                  <c:v>484.7</c:v>
                </c:pt>
                <c:pt idx="32">
                  <c:v>27.98</c:v>
                </c:pt>
                <c:pt idx="33">
                  <c:v>2.2650000000000001</c:v>
                </c:pt>
                <c:pt idx="34">
                  <c:v>123.4</c:v>
                </c:pt>
                <c:pt idx="35">
                  <c:v>346</c:v>
                </c:pt>
                <c:pt idx="36">
                  <c:v>311.8</c:v>
                </c:pt>
                <c:pt idx="37">
                  <c:v>218</c:v>
                </c:pt>
                <c:pt idx="38">
                  <c:v>289.89999999999998</c:v>
                </c:pt>
                <c:pt idx="39">
                  <c:v>101.4</c:v>
                </c:pt>
                <c:pt idx="40">
                  <c:v>281.2</c:v>
                </c:pt>
                <c:pt idx="41">
                  <c:v>157.6</c:v>
                </c:pt>
                <c:pt idx="42">
                  <c:v>121.8</c:v>
                </c:pt>
                <c:pt idx="43">
                  <c:v>92.38</c:v>
                </c:pt>
                <c:pt idx="44">
                  <c:v>315.89999999999998</c:v>
                </c:pt>
                <c:pt idx="45">
                  <c:v>259.10000000000002</c:v>
                </c:pt>
                <c:pt idx="46">
                  <c:v>354.9</c:v>
                </c:pt>
                <c:pt idx="47">
                  <c:v>399.9</c:v>
                </c:pt>
                <c:pt idx="48">
                  <c:v>90.75</c:v>
                </c:pt>
                <c:pt idx="49">
                  <c:v>293.2</c:v>
                </c:pt>
                <c:pt idx="50">
                  <c:v>94.35</c:v>
                </c:pt>
                <c:pt idx="51">
                  <c:v>40.29</c:v>
                </c:pt>
                <c:pt idx="52">
                  <c:v>284.39999999999998</c:v>
                </c:pt>
                <c:pt idx="53">
                  <c:v>66.95</c:v>
                </c:pt>
                <c:pt idx="54">
                  <c:v>216.3</c:v>
                </c:pt>
                <c:pt idx="55">
                  <c:v>147.30000000000001</c:v>
                </c:pt>
                <c:pt idx="56">
                  <c:v>166.6</c:v>
                </c:pt>
                <c:pt idx="57">
                  <c:v>62.4</c:v>
                </c:pt>
                <c:pt idx="58">
                  <c:v>138</c:v>
                </c:pt>
                <c:pt idx="59">
                  <c:v>331.2</c:v>
                </c:pt>
                <c:pt idx="60">
                  <c:v>283.8</c:v>
                </c:pt>
                <c:pt idx="61">
                  <c:v>25.63</c:v>
                </c:pt>
                <c:pt idx="62">
                  <c:v>28.19</c:v>
                </c:pt>
                <c:pt idx="63">
                  <c:v>68.87</c:v>
                </c:pt>
                <c:pt idx="64">
                  <c:v>212.6</c:v>
                </c:pt>
                <c:pt idx="65">
                  <c:v>132</c:v>
                </c:pt>
                <c:pt idx="66">
                  <c:v>116.5</c:v>
                </c:pt>
                <c:pt idx="67">
                  <c:v>28.19</c:v>
                </c:pt>
                <c:pt idx="68">
                  <c:v>122.8</c:v>
                </c:pt>
                <c:pt idx="69">
                  <c:v>99.61</c:v>
                </c:pt>
                <c:pt idx="70">
                  <c:v>116.1</c:v>
                </c:pt>
                <c:pt idx="71">
                  <c:v>101.6</c:v>
                </c:pt>
                <c:pt idx="72">
                  <c:v>143.5</c:v>
                </c:pt>
                <c:pt idx="73">
                  <c:v>746.4</c:v>
                </c:pt>
                <c:pt idx="74">
                  <c:v>40.700000000000003</c:v>
                </c:pt>
                <c:pt idx="75">
                  <c:v>220.5</c:v>
                </c:pt>
                <c:pt idx="76">
                  <c:v>54.15</c:v>
                </c:pt>
                <c:pt idx="77">
                  <c:v>119.1</c:v>
                </c:pt>
                <c:pt idx="78">
                  <c:v>344.6</c:v>
                </c:pt>
                <c:pt idx="79">
                  <c:v>24.05</c:v>
                </c:pt>
                <c:pt idx="80">
                  <c:v>359.2</c:v>
                </c:pt>
                <c:pt idx="81">
                  <c:v>141.5</c:v>
                </c:pt>
                <c:pt idx="82">
                  <c:v>73.650000000000006</c:v>
                </c:pt>
                <c:pt idx="83">
                  <c:v>131.6</c:v>
                </c:pt>
                <c:pt idx="84">
                  <c:v>95.2</c:v>
                </c:pt>
                <c:pt idx="85">
                  <c:v>82.22</c:v>
                </c:pt>
                <c:pt idx="86">
                  <c:v>265.60000000000002</c:v>
                </c:pt>
                <c:pt idx="87">
                  <c:v>80.5</c:v>
                </c:pt>
                <c:pt idx="88">
                  <c:v>293.8</c:v>
                </c:pt>
                <c:pt idx="89">
                  <c:v>131.6</c:v>
                </c:pt>
                <c:pt idx="90">
                  <c:v>57.79</c:v>
                </c:pt>
                <c:pt idx="91">
                  <c:v>92.21</c:v>
                </c:pt>
                <c:pt idx="92">
                  <c:v>192.8</c:v>
                </c:pt>
                <c:pt idx="93">
                  <c:v>17.37</c:v>
                </c:pt>
                <c:pt idx="94">
                  <c:v>83.37</c:v>
                </c:pt>
                <c:pt idx="95">
                  <c:v>285</c:v>
                </c:pt>
                <c:pt idx="96">
                  <c:v>172.8</c:v>
                </c:pt>
                <c:pt idx="97">
                  <c:v>92.63</c:v>
                </c:pt>
                <c:pt idx="98">
                  <c:v>306.5</c:v>
                </c:pt>
                <c:pt idx="99">
                  <c:v>62.61</c:v>
                </c:pt>
                <c:pt idx="100">
                  <c:v>91.85</c:v>
                </c:pt>
                <c:pt idx="101">
                  <c:v>201</c:v>
                </c:pt>
                <c:pt idx="102">
                  <c:v>220.9</c:v>
                </c:pt>
                <c:pt idx="103">
                  <c:v>314.3</c:v>
                </c:pt>
                <c:pt idx="104">
                  <c:v>52.24</c:v>
                </c:pt>
                <c:pt idx="105">
                  <c:v>10.47</c:v>
                </c:pt>
                <c:pt idx="106">
                  <c:v>275.2</c:v>
                </c:pt>
                <c:pt idx="107">
                  <c:v>84.65</c:v>
                </c:pt>
                <c:pt idx="108">
                  <c:v>27.13</c:v>
                </c:pt>
                <c:pt idx="109">
                  <c:v>33.04</c:v>
                </c:pt>
                <c:pt idx="110">
                  <c:v>69.44</c:v>
                </c:pt>
                <c:pt idx="111">
                  <c:v>243</c:v>
                </c:pt>
                <c:pt idx="112">
                  <c:v>161.4</c:v>
                </c:pt>
                <c:pt idx="113">
                  <c:v>248.5</c:v>
                </c:pt>
                <c:pt idx="114">
                  <c:v>109</c:v>
                </c:pt>
                <c:pt idx="115">
                  <c:v>163.19999999999999</c:v>
                </c:pt>
                <c:pt idx="116">
                  <c:v>12.97</c:v>
                </c:pt>
                <c:pt idx="117">
                  <c:v>152.9</c:v>
                </c:pt>
                <c:pt idx="118">
                  <c:v>323.8</c:v>
                </c:pt>
                <c:pt idx="119">
                  <c:v>87.46</c:v>
                </c:pt>
                <c:pt idx="120">
                  <c:v>73.239999999999995</c:v>
                </c:pt>
                <c:pt idx="121">
                  <c:v>313.60000000000002</c:v>
                </c:pt>
                <c:pt idx="122">
                  <c:v>105.4</c:v>
                </c:pt>
                <c:pt idx="123">
                  <c:v>212.4</c:v>
                </c:pt>
                <c:pt idx="124">
                  <c:v>193.6</c:v>
                </c:pt>
                <c:pt idx="125">
                  <c:v>316.7</c:v>
                </c:pt>
                <c:pt idx="126">
                  <c:v>47.14</c:v>
                </c:pt>
                <c:pt idx="127">
                  <c:v>489</c:v>
                </c:pt>
                <c:pt idx="128">
                  <c:v>38.26</c:v>
                </c:pt>
                <c:pt idx="129">
                  <c:v>351.5</c:v>
                </c:pt>
                <c:pt idx="130">
                  <c:v>331.3</c:v>
                </c:pt>
                <c:pt idx="131">
                  <c:v>157.30000000000001</c:v>
                </c:pt>
                <c:pt idx="132">
                  <c:v>24.42</c:v>
                </c:pt>
                <c:pt idx="133">
                  <c:v>71.3</c:v>
                </c:pt>
                <c:pt idx="134">
                  <c:v>78.45</c:v>
                </c:pt>
                <c:pt idx="135">
                  <c:v>24.01</c:v>
                </c:pt>
                <c:pt idx="136">
                  <c:v>226.8</c:v>
                </c:pt>
                <c:pt idx="137">
                  <c:v>174.8</c:v>
                </c:pt>
                <c:pt idx="138">
                  <c:v>158.1</c:v>
                </c:pt>
                <c:pt idx="139">
                  <c:v>86.66</c:v>
                </c:pt>
                <c:pt idx="140">
                  <c:v>93.83</c:v>
                </c:pt>
                <c:pt idx="141">
                  <c:v>389.5</c:v>
                </c:pt>
                <c:pt idx="142">
                  <c:v>155.4</c:v>
                </c:pt>
                <c:pt idx="143">
                  <c:v>180.5</c:v>
                </c:pt>
                <c:pt idx="144">
                  <c:v>165.1</c:v>
                </c:pt>
                <c:pt idx="145">
                  <c:v>17.399999999999999</c:v>
                </c:pt>
                <c:pt idx="146">
                  <c:v>200.1</c:v>
                </c:pt>
                <c:pt idx="147">
                  <c:v>20.46</c:v>
                </c:pt>
                <c:pt idx="148">
                  <c:v>77.349999999999994</c:v>
                </c:pt>
                <c:pt idx="149">
                  <c:v>231.9</c:v>
                </c:pt>
                <c:pt idx="150">
                  <c:v>113.8</c:v>
                </c:pt>
                <c:pt idx="151">
                  <c:v>118.4</c:v>
                </c:pt>
                <c:pt idx="152">
                  <c:v>46.97</c:v>
                </c:pt>
                <c:pt idx="153">
                  <c:v>19.3</c:v>
                </c:pt>
                <c:pt idx="154">
                  <c:v>5.6639999999999997</c:v>
                </c:pt>
                <c:pt idx="155">
                  <c:v>179.7</c:v>
                </c:pt>
                <c:pt idx="156">
                  <c:v>82.98</c:v>
                </c:pt>
                <c:pt idx="157">
                  <c:v>169.6</c:v>
                </c:pt>
                <c:pt idx="158">
                  <c:v>207</c:v>
                </c:pt>
                <c:pt idx="159">
                  <c:v>162.5</c:v>
                </c:pt>
                <c:pt idx="160">
                  <c:v>191.9</c:v>
                </c:pt>
                <c:pt idx="161">
                  <c:v>14.71</c:v>
                </c:pt>
                <c:pt idx="162">
                  <c:v>159.1</c:v>
                </c:pt>
                <c:pt idx="163">
                  <c:v>100.4</c:v>
                </c:pt>
                <c:pt idx="164">
                  <c:v>145.19999999999999</c:v>
                </c:pt>
                <c:pt idx="165">
                  <c:v>95.45</c:v>
                </c:pt>
                <c:pt idx="166">
                  <c:v>61.36</c:v>
                </c:pt>
                <c:pt idx="167">
                  <c:v>125.6</c:v>
                </c:pt>
                <c:pt idx="168">
                  <c:v>29.29</c:v>
                </c:pt>
                <c:pt idx="169">
                  <c:v>132.80000000000001</c:v>
                </c:pt>
                <c:pt idx="170">
                  <c:v>140.80000000000001</c:v>
                </c:pt>
                <c:pt idx="171">
                  <c:v>59.53</c:v>
                </c:pt>
                <c:pt idx="172">
                  <c:v>24.76</c:v>
                </c:pt>
                <c:pt idx="173">
                  <c:v>40.299999999999997</c:v>
                </c:pt>
                <c:pt idx="174">
                  <c:v>84.54</c:v>
                </c:pt>
                <c:pt idx="175">
                  <c:v>185.2</c:v>
                </c:pt>
                <c:pt idx="176">
                  <c:v>124.2</c:v>
                </c:pt>
                <c:pt idx="177">
                  <c:v>59.14</c:v>
                </c:pt>
                <c:pt idx="178">
                  <c:v>78.819999999999993</c:v>
                </c:pt>
                <c:pt idx="179">
                  <c:v>40</c:v>
                </c:pt>
                <c:pt idx="180">
                  <c:v>89.49</c:v>
                </c:pt>
                <c:pt idx="181">
                  <c:v>123.2</c:v>
                </c:pt>
                <c:pt idx="182">
                  <c:v>121.5</c:v>
                </c:pt>
                <c:pt idx="183">
                  <c:v>129.69999999999999</c:v>
                </c:pt>
                <c:pt idx="184">
                  <c:v>110.5</c:v>
                </c:pt>
                <c:pt idx="185">
                  <c:v>115</c:v>
                </c:pt>
                <c:pt idx="186">
                  <c:v>168.6</c:v>
                </c:pt>
                <c:pt idx="187">
                  <c:v>82.08</c:v>
                </c:pt>
                <c:pt idx="188">
                  <c:v>5.5439999999999996</c:v>
                </c:pt>
                <c:pt idx="189">
                  <c:v>138.9</c:v>
                </c:pt>
                <c:pt idx="190">
                  <c:v>154.1</c:v>
                </c:pt>
                <c:pt idx="191">
                  <c:v>88.47</c:v>
                </c:pt>
                <c:pt idx="192">
                  <c:v>126</c:v>
                </c:pt>
                <c:pt idx="193">
                  <c:v>32.15</c:v>
                </c:pt>
                <c:pt idx="194">
                  <c:v>49.91</c:v>
                </c:pt>
                <c:pt idx="195">
                  <c:v>84.29</c:v>
                </c:pt>
                <c:pt idx="196">
                  <c:v>60.57</c:v>
                </c:pt>
                <c:pt idx="197">
                  <c:v>46.08</c:v>
                </c:pt>
                <c:pt idx="198">
                  <c:v>134.69999999999999</c:v>
                </c:pt>
                <c:pt idx="199">
                  <c:v>217.6</c:v>
                </c:pt>
                <c:pt idx="200">
                  <c:v>88.16</c:v>
                </c:pt>
                <c:pt idx="201">
                  <c:v>59.94</c:v>
                </c:pt>
                <c:pt idx="202">
                  <c:v>113.3</c:v>
                </c:pt>
                <c:pt idx="203">
                  <c:v>179.9</c:v>
                </c:pt>
                <c:pt idx="204">
                  <c:v>53.3</c:v>
                </c:pt>
                <c:pt idx="205">
                  <c:v>75.010000000000005</c:v>
                </c:pt>
                <c:pt idx="206">
                  <c:v>71.87</c:v>
                </c:pt>
                <c:pt idx="207">
                  <c:v>33.71</c:v>
                </c:pt>
                <c:pt idx="208">
                  <c:v>41.84</c:v>
                </c:pt>
                <c:pt idx="209">
                  <c:v>96.47</c:v>
                </c:pt>
                <c:pt idx="210">
                  <c:v>36.57</c:v>
                </c:pt>
                <c:pt idx="211">
                  <c:v>47.95</c:v>
                </c:pt>
                <c:pt idx="212">
                  <c:v>125.8</c:v>
                </c:pt>
                <c:pt idx="213">
                  <c:v>64.239999999999995</c:v>
                </c:pt>
                <c:pt idx="214">
                  <c:v>229.2</c:v>
                </c:pt>
                <c:pt idx="215">
                  <c:v>83.71</c:v>
                </c:pt>
                <c:pt idx="216">
                  <c:v>100.5</c:v>
                </c:pt>
                <c:pt idx="217">
                  <c:v>50.39</c:v>
                </c:pt>
                <c:pt idx="218">
                  <c:v>97.55</c:v>
                </c:pt>
                <c:pt idx="219">
                  <c:v>164.9</c:v>
                </c:pt>
                <c:pt idx="220">
                  <c:v>57.66</c:v>
                </c:pt>
                <c:pt idx="221">
                  <c:v>110.3</c:v>
                </c:pt>
                <c:pt idx="222">
                  <c:v>11.53</c:v>
                </c:pt>
                <c:pt idx="223">
                  <c:v>38.840000000000003</c:v>
                </c:pt>
                <c:pt idx="224">
                  <c:v>83.95</c:v>
                </c:pt>
                <c:pt idx="225">
                  <c:v>73.13</c:v>
                </c:pt>
                <c:pt idx="226">
                  <c:v>48.1</c:v>
                </c:pt>
                <c:pt idx="227">
                  <c:v>125</c:v>
                </c:pt>
                <c:pt idx="228">
                  <c:v>102.3</c:v>
                </c:pt>
                <c:pt idx="229">
                  <c:v>186.7</c:v>
                </c:pt>
                <c:pt idx="230">
                  <c:v>102.1</c:v>
                </c:pt>
                <c:pt idx="231">
                  <c:v>39.090000000000003</c:v>
                </c:pt>
                <c:pt idx="232">
                  <c:v>129.30000000000001</c:v>
                </c:pt>
                <c:pt idx="233">
                  <c:v>18.100000000000001</c:v>
                </c:pt>
                <c:pt idx="234">
                  <c:v>42.16</c:v>
                </c:pt>
                <c:pt idx="235">
                  <c:v>26.07</c:v>
                </c:pt>
                <c:pt idx="236">
                  <c:v>16.64</c:v>
                </c:pt>
                <c:pt idx="237">
                  <c:v>76.48</c:v>
                </c:pt>
                <c:pt idx="238">
                  <c:v>145.69999999999999</c:v>
                </c:pt>
                <c:pt idx="239">
                  <c:v>108.7</c:v>
                </c:pt>
                <c:pt idx="240">
                  <c:v>56.56</c:v>
                </c:pt>
                <c:pt idx="241">
                  <c:v>151.5</c:v>
                </c:pt>
                <c:pt idx="242">
                  <c:v>148.6</c:v>
                </c:pt>
                <c:pt idx="243">
                  <c:v>71.790000000000006</c:v>
                </c:pt>
                <c:pt idx="244">
                  <c:v>277.8</c:v>
                </c:pt>
                <c:pt idx="245">
                  <c:v>38.61</c:v>
                </c:pt>
                <c:pt idx="246">
                  <c:v>71.75</c:v>
                </c:pt>
                <c:pt idx="247">
                  <c:v>169.9</c:v>
                </c:pt>
                <c:pt idx="248">
                  <c:v>140.30000000000001</c:v>
                </c:pt>
                <c:pt idx="249">
                  <c:v>8.218</c:v>
                </c:pt>
                <c:pt idx="250">
                  <c:v>13.75</c:v>
                </c:pt>
                <c:pt idx="251">
                  <c:v>124.9</c:v>
                </c:pt>
                <c:pt idx="252">
                  <c:v>221.7</c:v>
                </c:pt>
                <c:pt idx="253">
                  <c:v>88.01</c:v>
                </c:pt>
                <c:pt idx="254">
                  <c:v>67.52</c:v>
                </c:pt>
                <c:pt idx="255">
                  <c:v>91.08</c:v>
                </c:pt>
                <c:pt idx="256">
                  <c:v>40.9</c:v>
                </c:pt>
                <c:pt idx="257">
                  <c:v>138</c:v>
                </c:pt>
                <c:pt idx="258">
                  <c:v>151.80000000000001</c:v>
                </c:pt>
                <c:pt idx="259">
                  <c:v>13.65</c:v>
                </c:pt>
                <c:pt idx="260">
                  <c:v>9.3780000000000001</c:v>
                </c:pt>
                <c:pt idx="261">
                  <c:v>13.97</c:v>
                </c:pt>
                <c:pt idx="262">
                  <c:v>60.96</c:v>
                </c:pt>
                <c:pt idx="263">
                  <c:v>58.08</c:v>
                </c:pt>
                <c:pt idx="264">
                  <c:v>175.3</c:v>
                </c:pt>
                <c:pt idx="265">
                  <c:v>269.60000000000002</c:v>
                </c:pt>
                <c:pt idx="266">
                  <c:v>20.04</c:v>
                </c:pt>
                <c:pt idx="267">
                  <c:v>109.4</c:v>
                </c:pt>
                <c:pt idx="268">
                  <c:v>73.11</c:v>
                </c:pt>
                <c:pt idx="269">
                  <c:v>29.61</c:v>
                </c:pt>
                <c:pt idx="270">
                  <c:v>45.84</c:v>
                </c:pt>
                <c:pt idx="271">
                  <c:v>71.03</c:v>
                </c:pt>
                <c:pt idx="272">
                  <c:v>70.98</c:v>
                </c:pt>
                <c:pt idx="273">
                  <c:v>80.64</c:v>
                </c:pt>
                <c:pt idx="274">
                  <c:v>68.849999999999994</c:v>
                </c:pt>
                <c:pt idx="275">
                  <c:v>37.61</c:v>
                </c:pt>
                <c:pt idx="276">
                  <c:v>101.8</c:v>
                </c:pt>
                <c:pt idx="277">
                  <c:v>14.72</c:v>
                </c:pt>
                <c:pt idx="278">
                  <c:v>256</c:v>
                </c:pt>
                <c:pt idx="279">
                  <c:v>41.65</c:v>
                </c:pt>
                <c:pt idx="280">
                  <c:v>73.28</c:v>
                </c:pt>
                <c:pt idx="281">
                  <c:v>112.4</c:v>
                </c:pt>
                <c:pt idx="282">
                  <c:v>92.12</c:v>
                </c:pt>
                <c:pt idx="283">
                  <c:v>25.82</c:v>
                </c:pt>
                <c:pt idx="284">
                  <c:v>6.819</c:v>
                </c:pt>
                <c:pt idx="285">
                  <c:v>89.64</c:v>
                </c:pt>
                <c:pt idx="286">
                  <c:v>9.9260000000000002</c:v>
                </c:pt>
                <c:pt idx="287">
                  <c:v>38.65</c:v>
                </c:pt>
                <c:pt idx="288">
                  <c:v>115.3</c:v>
                </c:pt>
                <c:pt idx="289">
                  <c:v>138.19999999999999</c:v>
                </c:pt>
                <c:pt idx="290">
                  <c:v>4.9400000000000004</c:v>
                </c:pt>
                <c:pt idx="291">
                  <c:v>78.5</c:v>
                </c:pt>
                <c:pt idx="292">
                  <c:v>61.59</c:v>
                </c:pt>
                <c:pt idx="293">
                  <c:v>156</c:v>
                </c:pt>
                <c:pt idx="294">
                  <c:v>17.68</c:v>
                </c:pt>
                <c:pt idx="295">
                  <c:v>43.98</c:v>
                </c:pt>
                <c:pt idx="296">
                  <c:v>33.89</c:v>
                </c:pt>
                <c:pt idx="297">
                  <c:v>86.87</c:v>
                </c:pt>
                <c:pt idx="298">
                  <c:v>36</c:v>
                </c:pt>
                <c:pt idx="299">
                  <c:v>16.739999999999998</c:v>
                </c:pt>
                <c:pt idx="300">
                  <c:v>56.62</c:v>
                </c:pt>
                <c:pt idx="301">
                  <c:v>102.8</c:v>
                </c:pt>
                <c:pt idx="302">
                  <c:v>84.64</c:v>
                </c:pt>
                <c:pt idx="303">
                  <c:v>88.07</c:v>
                </c:pt>
                <c:pt idx="304">
                  <c:v>56.65</c:v>
                </c:pt>
                <c:pt idx="305">
                  <c:v>150</c:v>
                </c:pt>
                <c:pt idx="306">
                  <c:v>76.98</c:v>
                </c:pt>
                <c:pt idx="307">
                  <c:v>6.5990000000000002</c:v>
                </c:pt>
                <c:pt idx="308">
                  <c:v>56.59</c:v>
                </c:pt>
                <c:pt idx="309">
                  <c:v>125.8</c:v>
                </c:pt>
                <c:pt idx="310">
                  <c:v>40.22</c:v>
                </c:pt>
                <c:pt idx="311">
                  <c:v>102.1</c:v>
                </c:pt>
                <c:pt idx="312">
                  <c:v>18.059999999999999</c:v>
                </c:pt>
                <c:pt idx="313">
                  <c:v>118.1</c:v>
                </c:pt>
                <c:pt idx="314">
                  <c:v>53.5</c:v>
                </c:pt>
                <c:pt idx="315">
                  <c:v>39.65</c:v>
                </c:pt>
                <c:pt idx="316">
                  <c:v>64.39</c:v>
                </c:pt>
                <c:pt idx="317">
                  <c:v>48.17</c:v>
                </c:pt>
                <c:pt idx="318">
                  <c:v>22.64</c:v>
                </c:pt>
                <c:pt idx="319">
                  <c:v>161.4</c:v>
                </c:pt>
                <c:pt idx="320">
                  <c:v>119.1</c:v>
                </c:pt>
                <c:pt idx="321">
                  <c:v>119.5</c:v>
                </c:pt>
                <c:pt idx="322">
                  <c:v>136</c:v>
                </c:pt>
                <c:pt idx="323">
                  <c:v>37.85</c:v>
                </c:pt>
                <c:pt idx="324">
                  <c:v>52.28</c:v>
                </c:pt>
                <c:pt idx="325">
                  <c:v>69.48</c:v>
                </c:pt>
                <c:pt idx="326">
                  <c:v>56.36</c:v>
                </c:pt>
                <c:pt idx="327">
                  <c:v>82.52</c:v>
                </c:pt>
                <c:pt idx="328">
                  <c:v>27.77</c:v>
                </c:pt>
                <c:pt idx="329">
                  <c:v>104.3</c:v>
                </c:pt>
                <c:pt idx="330">
                  <c:v>90.99</c:v>
                </c:pt>
                <c:pt idx="331">
                  <c:v>27.23</c:v>
                </c:pt>
                <c:pt idx="332">
                  <c:v>110.5</c:v>
                </c:pt>
                <c:pt idx="333">
                  <c:v>40.33</c:v>
                </c:pt>
                <c:pt idx="334">
                  <c:v>14.17</c:v>
                </c:pt>
                <c:pt idx="335">
                  <c:v>52.57</c:v>
                </c:pt>
                <c:pt idx="336">
                  <c:v>53.06</c:v>
                </c:pt>
                <c:pt idx="337">
                  <c:v>75.709999999999994</c:v>
                </c:pt>
                <c:pt idx="338">
                  <c:v>39.22</c:v>
                </c:pt>
                <c:pt idx="339">
                  <c:v>36.369999999999997</c:v>
                </c:pt>
                <c:pt idx="340">
                  <c:v>148.4</c:v>
                </c:pt>
                <c:pt idx="341">
                  <c:v>6.1070000000000002</c:v>
                </c:pt>
                <c:pt idx="342">
                  <c:v>60.05</c:v>
                </c:pt>
                <c:pt idx="343">
                  <c:v>87.23</c:v>
                </c:pt>
                <c:pt idx="344">
                  <c:v>26.92</c:v>
                </c:pt>
                <c:pt idx="345">
                  <c:v>203.6</c:v>
                </c:pt>
                <c:pt idx="346">
                  <c:v>42.8</c:v>
                </c:pt>
                <c:pt idx="347">
                  <c:v>11.87</c:v>
                </c:pt>
                <c:pt idx="348">
                  <c:v>32.89</c:v>
                </c:pt>
                <c:pt idx="349">
                  <c:v>55.97</c:v>
                </c:pt>
                <c:pt idx="350">
                  <c:v>54.56</c:v>
                </c:pt>
                <c:pt idx="351">
                  <c:v>90.18</c:v>
                </c:pt>
                <c:pt idx="352">
                  <c:v>77.7</c:v>
                </c:pt>
                <c:pt idx="353">
                  <c:v>36.619999999999997</c:v>
                </c:pt>
                <c:pt idx="354">
                  <c:v>64.12</c:v>
                </c:pt>
                <c:pt idx="355">
                  <c:v>8.91</c:v>
                </c:pt>
                <c:pt idx="356">
                  <c:v>33.33</c:v>
                </c:pt>
                <c:pt idx="357">
                  <c:v>75.28</c:v>
                </c:pt>
                <c:pt idx="358">
                  <c:v>185.8</c:v>
                </c:pt>
                <c:pt idx="359">
                  <c:v>22.75</c:v>
                </c:pt>
                <c:pt idx="360">
                  <c:v>55.7</c:v>
                </c:pt>
                <c:pt idx="361">
                  <c:v>36.24</c:v>
                </c:pt>
                <c:pt idx="362">
                  <c:v>22.48</c:v>
                </c:pt>
                <c:pt idx="363">
                  <c:v>55.07</c:v>
                </c:pt>
                <c:pt idx="364">
                  <c:v>24.26</c:v>
                </c:pt>
                <c:pt idx="365">
                  <c:v>172.1</c:v>
                </c:pt>
                <c:pt idx="366">
                  <c:v>24.97</c:v>
                </c:pt>
                <c:pt idx="367">
                  <c:v>82.94</c:v>
                </c:pt>
                <c:pt idx="368">
                  <c:v>42.63</c:v>
                </c:pt>
                <c:pt idx="369">
                  <c:v>23.52</c:v>
                </c:pt>
                <c:pt idx="370">
                  <c:v>48.93</c:v>
                </c:pt>
                <c:pt idx="371">
                  <c:v>85.42</c:v>
                </c:pt>
                <c:pt idx="372">
                  <c:v>39.020000000000003</c:v>
                </c:pt>
                <c:pt idx="373">
                  <c:v>112.7</c:v>
                </c:pt>
                <c:pt idx="374">
                  <c:v>53</c:v>
                </c:pt>
                <c:pt idx="375">
                  <c:v>270.60000000000002</c:v>
                </c:pt>
                <c:pt idx="376">
                  <c:v>28.74</c:v>
                </c:pt>
                <c:pt idx="377">
                  <c:v>33.6</c:v>
                </c:pt>
                <c:pt idx="378">
                  <c:v>22.43</c:v>
                </c:pt>
                <c:pt idx="379">
                  <c:v>10.24</c:v>
                </c:pt>
                <c:pt idx="380">
                  <c:v>140.30000000000001</c:v>
                </c:pt>
                <c:pt idx="381">
                  <c:v>36.520000000000003</c:v>
                </c:pt>
                <c:pt idx="382">
                  <c:v>374.1</c:v>
                </c:pt>
                <c:pt idx="383">
                  <c:v>124.8</c:v>
                </c:pt>
                <c:pt idx="384">
                  <c:v>110.5</c:v>
                </c:pt>
                <c:pt idx="385">
                  <c:v>140.4</c:v>
                </c:pt>
                <c:pt idx="386">
                  <c:v>42.23</c:v>
                </c:pt>
                <c:pt idx="387">
                  <c:v>13.49</c:v>
                </c:pt>
                <c:pt idx="388">
                  <c:v>113.9</c:v>
                </c:pt>
                <c:pt idx="389">
                  <c:v>19.62</c:v>
                </c:pt>
                <c:pt idx="390">
                  <c:v>36.35</c:v>
                </c:pt>
                <c:pt idx="391">
                  <c:v>5.7649999999999997</c:v>
                </c:pt>
                <c:pt idx="392">
                  <c:v>144.6</c:v>
                </c:pt>
                <c:pt idx="393">
                  <c:v>123</c:v>
                </c:pt>
                <c:pt idx="394">
                  <c:v>74.09</c:v>
                </c:pt>
                <c:pt idx="395">
                  <c:v>32</c:v>
                </c:pt>
                <c:pt idx="396">
                  <c:v>147.19999999999999</c:v>
                </c:pt>
                <c:pt idx="397">
                  <c:v>32.43</c:v>
                </c:pt>
                <c:pt idx="398">
                  <c:v>39.869999999999997</c:v>
                </c:pt>
                <c:pt idx="399">
                  <c:v>10.86</c:v>
                </c:pt>
                <c:pt idx="400">
                  <c:v>8.0820000000000007</c:v>
                </c:pt>
                <c:pt idx="401">
                  <c:v>23.69</c:v>
                </c:pt>
                <c:pt idx="402">
                  <c:v>53.02</c:v>
                </c:pt>
                <c:pt idx="403">
                  <c:v>93.96</c:v>
                </c:pt>
                <c:pt idx="404">
                  <c:v>74.459999999999994</c:v>
                </c:pt>
                <c:pt idx="405">
                  <c:v>174.5</c:v>
                </c:pt>
                <c:pt idx="406">
                  <c:v>43.43</c:v>
                </c:pt>
                <c:pt idx="407">
                  <c:v>24.14</c:v>
                </c:pt>
                <c:pt idx="408">
                  <c:v>46.64</c:v>
                </c:pt>
                <c:pt idx="409">
                  <c:v>33.07</c:v>
                </c:pt>
                <c:pt idx="410">
                  <c:v>42.18</c:v>
                </c:pt>
                <c:pt idx="411">
                  <c:v>59.06</c:v>
                </c:pt>
                <c:pt idx="412">
                  <c:v>16.510000000000002</c:v>
                </c:pt>
                <c:pt idx="413">
                  <c:v>53.52</c:v>
                </c:pt>
                <c:pt idx="414">
                  <c:v>26.95</c:v>
                </c:pt>
                <c:pt idx="415">
                  <c:v>92.85</c:v>
                </c:pt>
                <c:pt idx="416">
                  <c:v>21.39</c:v>
                </c:pt>
                <c:pt idx="417">
                  <c:v>14.06</c:v>
                </c:pt>
                <c:pt idx="418">
                  <c:v>64.78</c:v>
                </c:pt>
                <c:pt idx="419">
                  <c:v>121.6</c:v>
                </c:pt>
                <c:pt idx="420">
                  <c:v>125.9</c:v>
                </c:pt>
                <c:pt idx="421">
                  <c:v>85.52</c:v>
                </c:pt>
                <c:pt idx="422">
                  <c:v>1.694</c:v>
                </c:pt>
                <c:pt idx="423">
                  <c:v>36.92</c:v>
                </c:pt>
                <c:pt idx="424">
                  <c:v>80.39</c:v>
                </c:pt>
                <c:pt idx="425">
                  <c:v>22.95</c:v>
                </c:pt>
                <c:pt idx="426">
                  <c:v>17.100000000000001</c:v>
                </c:pt>
                <c:pt idx="427">
                  <c:v>41.93</c:v>
                </c:pt>
                <c:pt idx="428">
                  <c:v>28.32</c:v>
                </c:pt>
                <c:pt idx="429">
                  <c:v>68.260000000000005</c:v>
                </c:pt>
                <c:pt idx="430">
                  <c:v>29.62</c:v>
                </c:pt>
                <c:pt idx="431">
                  <c:v>64.98</c:v>
                </c:pt>
                <c:pt idx="432">
                  <c:v>85.19</c:v>
                </c:pt>
                <c:pt idx="433">
                  <c:v>6.8970000000000002</c:v>
                </c:pt>
                <c:pt idx="434">
                  <c:v>6.5910000000000002</c:v>
                </c:pt>
                <c:pt idx="435">
                  <c:v>100.7</c:v>
                </c:pt>
                <c:pt idx="436">
                  <c:v>72.88</c:v>
                </c:pt>
                <c:pt idx="437">
                  <c:v>126</c:v>
                </c:pt>
                <c:pt idx="438">
                  <c:v>49.26</c:v>
                </c:pt>
                <c:pt idx="439">
                  <c:v>30.71</c:v>
                </c:pt>
                <c:pt idx="440">
                  <c:v>134.80000000000001</c:v>
                </c:pt>
                <c:pt idx="441">
                  <c:v>45.42</c:v>
                </c:pt>
              </c:numCache>
            </c:numRef>
          </c:xVal>
          <c:yVal>
            <c:numRef>
              <c:f>sub!$M$8:$M$449</c:f>
              <c:numCache>
                <c:formatCode>General</c:formatCode>
                <c:ptCount val="442"/>
                <c:pt idx="0">
                  <c:v>2808</c:v>
                </c:pt>
                <c:pt idx="1">
                  <c:v>1294</c:v>
                </c:pt>
                <c:pt idx="2">
                  <c:v>2926</c:v>
                </c:pt>
                <c:pt idx="3">
                  <c:v>407.2</c:v>
                </c:pt>
                <c:pt idx="4">
                  <c:v>930.4</c:v>
                </c:pt>
                <c:pt idx="5">
                  <c:v>1595</c:v>
                </c:pt>
                <c:pt idx="6">
                  <c:v>1037</c:v>
                </c:pt>
                <c:pt idx="7">
                  <c:v>2767</c:v>
                </c:pt>
                <c:pt idx="8">
                  <c:v>1184</c:v>
                </c:pt>
                <c:pt idx="9">
                  <c:v>2051</c:v>
                </c:pt>
                <c:pt idx="10">
                  <c:v>1058</c:v>
                </c:pt>
                <c:pt idx="11">
                  <c:v>766.3</c:v>
                </c:pt>
                <c:pt idx="12">
                  <c:v>974.4</c:v>
                </c:pt>
                <c:pt idx="13">
                  <c:v>644.5</c:v>
                </c:pt>
                <c:pt idx="14">
                  <c:v>601.4</c:v>
                </c:pt>
                <c:pt idx="15">
                  <c:v>1286</c:v>
                </c:pt>
                <c:pt idx="16">
                  <c:v>1519</c:v>
                </c:pt>
                <c:pt idx="17">
                  <c:v>1493</c:v>
                </c:pt>
                <c:pt idx="18">
                  <c:v>1152</c:v>
                </c:pt>
                <c:pt idx="19">
                  <c:v>34.33</c:v>
                </c:pt>
                <c:pt idx="20">
                  <c:v>1695</c:v>
                </c:pt>
                <c:pt idx="21">
                  <c:v>1831</c:v>
                </c:pt>
                <c:pt idx="22">
                  <c:v>587.29999999999995</c:v>
                </c:pt>
                <c:pt idx="23">
                  <c:v>1365</c:v>
                </c:pt>
                <c:pt idx="24">
                  <c:v>2569</c:v>
                </c:pt>
                <c:pt idx="25">
                  <c:v>2832</c:v>
                </c:pt>
                <c:pt idx="26">
                  <c:v>1052</c:v>
                </c:pt>
                <c:pt idx="27">
                  <c:v>820.6</c:v>
                </c:pt>
                <c:pt idx="28">
                  <c:v>915.6</c:v>
                </c:pt>
                <c:pt idx="29">
                  <c:v>763.3</c:v>
                </c:pt>
                <c:pt idx="30">
                  <c:v>1156</c:v>
                </c:pt>
                <c:pt idx="31">
                  <c:v>2993</c:v>
                </c:pt>
                <c:pt idx="32">
                  <c:v>89.45</c:v>
                </c:pt>
                <c:pt idx="33">
                  <c:v>11.5</c:v>
                </c:pt>
                <c:pt idx="34">
                  <c:v>634.1</c:v>
                </c:pt>
                <c:pt idx="35">
                  <c:v>3742</c:v>
                </c:pt>
                <c:pt idx="36">
                  <c:v>1316</c:v>
                </c:pt>
                <c:pt idx="37">
                  <c:v>1257</c:v>
                </c:pt>
                <c:pt idx="38">
                  <c:v>2179</c:v>
                </c:pt>
                <c:pt idx="39">
                  <c:v>341.8</c:v>
                </c:pt>
                <c:pt idx="40">
                  <c:v>1653</c:v>
                </c:pt>
                <c:pt idx="41">
                  <c:v>426.3</c:v>
                </c:pt>
                <c:pt idx="42">
                  <c:v>896.2</c:v>
                </c:pt>
                <c:pt idx="43">
                  <c:v>236.1</c:v>
                </c:pt>
                <c:pt idx="44">
                  <c:v>779.6</c:v>
                </c:pt>
                <c:pt idx="45">
                  <c:v>1629</c:v>
                </c:pt>
                <c:pt idx="46">
                  <c:v>1275</c:v>
                </c:pt>
                <c:pt idx="47">
                  <c:v>3017</c:v>
                </c:pt>
                <c:pt idx="48">
                  <c:v>442.9</c:v>
                </c:pt>
                <c:pt idx="49">
                  <c:v>2312</c:v>
                </c:pt>
                <c:pt idx="50">
                  <c:v>615.1</c:v>
                </c:pt>
                <c:pt idx="51">
                  <c:v>176.7</c:v>
                </c:pt>
                <c:pt idx="52">
                  <c:v>2012</c:v>
                </c:pt>
                <c:pt idx="53">
                  <c:v>150.4</c:v>
                </c:pt>
                <c:pt idx="54">
                  <c:v>919.7</c:v>
                </c:pt>
                <c:pt idx="55">
                  <c:v>788.5</c:v>
                </c:pt>
                <c:pt idx="56">
                  <c:v>743</c:v>
                </c:pt>
                <c:pt idx="57">
                  <c:v>186.5</c:v>
                </c:pt>
                <c:pt idx="58">
                  <c:v>1020</c:v>
                </c:pt>
                <c:pt idx="59">
                  <c:v>790.6</c:v>
                </c:pt>
                <c:pt idx="60">
                  <c:v>1118</c:v>
                </c:pt>
                <c:pt idx="61">
                  <c:v>159.30000000000001</c:v>
                </c:pt>
                <c:pt idx="62">
                  <c:v>165.2</c:v>
                </c:pt>
                <c:pt idx="63">
                  <c:v>633.20000000000005</c:v>
                </c:pt>
                <c:pt idx="64">
                  <c:v>1432</c:v>
                </c:pt>
                <c:pt idx="65">
                  <c:v>950.3</c:v>
                </c:pt>
                <c:pt idx="66">
                  <c:v>616</c:v>
                </c:pt>
                <c:pt idx="67">
                  <c:v>166.2</c:v>
                </c:pt>
                <c:pt idx="68">
                  <c:v>513.29999999999995</c:v>
                </c:pt>
                <c:pt idx="69">
                  <c:v>715.5</c:v>
                </c:pt>
                <c:pt idx="70">
                  <c:v>917.8</c:v>
                </c:pt>
                <c:pt idx="71">
                  <c:v>381.8</c:v>
                </c:pt>
                <c:pt idx="72">
                  <c:v>750.2</c:v>
                </c:pt>
                <c:pt idx="73">
                  <c:v>2104</c:v>
                </c:pt>
                <c:pt idx="74">
                  <c:v>310.7</c:v>
                </c:pt>
                <c:pt idx="75">
                  <c:v>969.4</c:v>
                </c:pt>
                <c:pt idx="76">
                  <c:v>211.6</c:v>
                </c:pt>
                <c:pt idx="77">
                  <c:v>719.6</c:v>
                </c:pt>
                <c:pt idx="78">
                  <c:v>1488</c:v>
                </c:pt>
                <c:pt idx="79">
                  <c:v>127.3</c:v>
                </c:pt>
                <c:pt idx="80">
                  <c:v>1056</c:v>
                </c:pt>
                <c:pt idx="81">
                  <c:v>649</c:v>
                </c:pt>
                <c:pt idx="82">
                  <c:v>358.9</c:v>
                </c:pt>
                <c:pt idx="83">
                  <c:v>553.79999999999995</c:v>
                </c:pt>
                <c:pt idx="84">
                  <c:v>430.3</c:v>
                </c:pt>
                <c:pt idx="85">
                  <c:v>369.7</c:v>
                </c:pt>
                <c:pt idx="86">
                  <c:v>748.2</c:v>
                </c:pt>
                <c:pt idx="87">
                  <c:v>322.10000000000002</c:v>
                </c:pt>
                <c:pt idx="88">
                  <c:v>1429</c:v>
                </c:pt>
                <c:pt idx="89">
                  <c:v>468.5</c:v>
                </c:pt>
                <c:pt idx="90">
                  <c:v>147.19999999999999</c:v>
                </c:pt>
                <c:pt idx="91">
                  <c:v>557.6</c:v>
                </c:pt>
                <c:pt idx="92">
                  <c:v>725</c:v>
                </c:pt>
                <c:pt idx="93">
                  <c:v>47.64</c:v>
                </c:pt>
                <c:pt idx="94">
                  <c:v>157</c:v>
                </c:pt>
                <c:pt idx="95">
                  <c:v>1146</c:v>
                </c:pt>
                <c:pt idx="96">
                  <c:v>1189</c:v>
                </c:pt>
                <c:pt idx="97">
                  <c:v>514.1</c:v>
                </c:pt>
                <c:pt idx="98">
                  <c:v>1542</c:v>
                </c:pt>
                <c:pt idx="99">
                  <c:v>137.9</c:v>
                </c:pt>
                <c:pt idx="100">
                  <c:v>750.6</c:v>
                </c:pt>
                <c:pt idx="101">
                  <c:v>1195</c:v>
                </c:pt>
                <c:pt idx="102">
                  <c:v>622.4</c:v>
                </c:pt>
                <c:pt idx="103">
                  <c:v>1327</c:v>
                </c:pt>
                <c:pt idx="104">
                  <c:v>131.80000000000001</c:v>
                </c:pt>
                <c:pt idx="105">
                  <c:v>62.07</c:v>
                </c:pt>
                <c:pt idx="106">
                  <c:v>1849</c:v>
                </c:pt>
                <c:pt idx="107">
                  <c:v>261.2</c:v>
                </c:pt>
                <c:pt idx="108">
                  <c:v>107.8</c:v>
                </c:pt>
                <c:pt idx="109">
                  <c:v>175.2</c:v>
                </c:pt>
                <c:pt idx="110">
                  <c:v>298.2</c:v>
                </c:pt>
                <c:pt idx="111">
                  <c:v>951.8</c:v>
                </c:pt>
                <c:pt idx="112">
                  <c:v>475.3</c:v>
                </c:pt>
                <c:pt idx="113">
                  <c:v>1904</c:v>
                </c:pt>
                <c:pt idx="114">
                  <c:v>1040</c:v>
                </c:pt>
                <c:pt idx="115">
                  <c:v>1295</c:v>
                </c:pt>
                <c:pt idx="116">
                  <c:v>59.31</c:v>
                </c:pt>
                <c:pt idx="117">
                  <c:v>506.5</c:v>
                </c:pt>
                <c:pt idx="118">
                  <c:v>976.4</c:v>
                </c:pt>
                <c:pt idx="119">
                  <c:v>273.60000000000002</c:v>
                </c:pt>
                <c:pt idx="120">
                  <c:v>369.9</c:v>
                </c:pt>
                <c:pt idx="121">
                  <c:v>1518</c:v>
                </c:pt>
                <c:pt idx="122">
                  <c:v>403.2</c:v>
                </c:pt>
                <c:pt idx="123">
                  <c:v>627.70000000000005</c:v>
                </c:pt>
                <c:pt idx="124">
                  <c:v>1174</c:v>
                </c:pt>
                <c:pt idx="125">
                  <c:v>1089</c:v>
                </c:pt>
                <c:pt idx="126">
                  <c:v>278.8</c:v>
                </c:pt>
                <c:pt idx="127">
                  <c:v>2010</c:v>
                </c:pt>
                <c:pt idx="128">
                  <c:v>188.9</c:v>
                </c:pt>
                <c:pt idx="129">
                  <c:v>1828</c:v>
                </c:pt>
                <c:pt idx="130">
                  <c:v>1458</c:v>
                </c:pt>
                <c:pt idx="131">
                  <c:v>1444</c:v>
                </c:pt>
                <c:pt idx="132">
                  <c:v>89.36</c:v>
                </c:pt>
                <c:pt idx="133">
                  <c:v>501.5</c:v>
                </c:pt>
                <c:pt idx="134">
                  <c:v>430</c:v>
                </c:pt>
                <c:pt idx="135">
                  <c:v>107.6</c:v>
                </c:pt>
                <c:pt idx="136">
                  <c:v>1104</c:v>
                </c:pt>
                <c:pt idx="137">
                  <c:v>481.5</c:v>
                </c:pt>
                <c:pt idx="138">
                  <c:v>1814</c:v>
                </c:pt>
                <c:pt idx="139">
                  <c:v>491.5</c:v>
                </c:pt>
                <c:pt idx="140">
                  <c:v>308.5</c:v>
                </c:pt>
                <c:pt idx="141">
                  <c:v>1897</c:v>
                </c:pt>
                <c:pt idx="142">
                  <c:v>970.2</c:v>
                </c:pt>
                <c:pt idx="143">
                  <c:v>846.6</c:v>
                </c:pt>
                <c:pt idx="144">
                  <c:v>759.2</c:v>
                </c:pt>
                <c:pt idx="145">
                  <c:v>82.83</c:v>
                </c:pt>
                <c:pt idx="146">
                  <c:v>599.4</c:v>
                </c:pt>
                <c:pt idx="147">
                  <c:v>56.62</c:v>
                </c:pt>
                <c:pt idx="148">
                  <c:v>321.89999999999998</c:v>
                </c:pt>
                <c:pt idx="149">
                  <c:v>1195</c:v>
                </c:pt>
                <c:pt idx="150">
                  <c:v>359.3</c:v>
                </c:pt>
                <c:pt idx="151">
                  <c:v>676.1</c:v>
                </c:pt>
                <c:pt idx="152">
                  <c:v>159.19999999999999</c:v>
                </c:pt>
                <c:pt idx="153">
                  <c:v>34</c:v>
                </c:pt>
                <c:pt idx="154">
                  <c:v>15.2</c:v>
                </c:pt>
                <c:pt idx="155">
                  <c:v>622.6</c:v>
                </c:pt>
                <c:pt idx="156">
                  <c:v>549.70000000000005</c:v>
                </c:pt>
                <c:pt idx="157">
                  <c:v>2064</c:v>
                </c:pt>
                <c:pt idx="158">
                  <c:v>1377</c:v>
                </c:pt>
                <c:pt idx="159">
                  <c:v>1982</c:v>
                </c:pt>
                <c:pt idx="160">
                  <c:v>2024</c:v>
                </c:pt>
                <c:pt idx="161">
                  <c:v>173.3</c:v>
                </c:pt>
                <c:pt idx="162">
                  <c:v>757.6</c:v>
                </c:pt>
                <c:pt idx="163">
                  <c:v>624.9</c:v>
                </c:pt>
                <c:pt idx="164">
                  <c:v>930.8</c:v>
                </c:pt>
                <c:pt idx="165">
                  <c:v>943.1</c:v>
                </c:pt>
                <c:pt idx="166">
                  <c:v>1205</c:v>
                </c:pt>
                <c:pt idx="167">
                  <c:v>1176</c:v>
                </c:pt>
                <c:pt idx="168">
                  <c:v>655.7</c:v>
                </c:pt>
                <c:pt idx="169">
                  <c:v>1545</c:v>
                </c:pt>
                <c:pt idx="170">
                  <c:v>450.9</c:v>
                </c:pt>
                <c:pt idx="171">
                  <c:v>476.1</c:v>
                </c:pt>
                <c:pt idx="172">
                  <c:v>344.4</c:v>
                </c:pt>
                <c:pt idx="173">
                  <c:v>408.2</c:v>
                </c:pt>
                <c:pt idx="174">
                  <c:v>1112</c:v>
                </c:pt>
                <c:pt idx="175">
                  <c:v>2203</c:v>
                </c:pt>
                <c:pt idx="176">
                  <c:v>1241</c:v>
                </c:pt>
                <c:pt idx="177">
                  <c:v>542.1</c:v>
                </c:pt>
                <c:pt idx="178">
                  <c:v>307</c:v>
                </c:pt>
                <c:pt idx="179">
                  <c:v>234</c:v>
                </c:pt>
                <c:pt idx="180">
                  <c:v>922.7</c:v>
                </c:pt>
                <c:pt idx="181">
                  <c:v>1183</c:v>
                </c:pt>
                <c:pt idx="182">
                  <c:v>2039</c:v>
                </c:pt>
                <c:pt idx="183">
                  <c:v>1114</c:v>
                </c:pt>
                <c:pt idx="184">
                  <c:v>667.9</c:v>
                </c:pt>
                <c:pt idx="185">
                  <c:v>1615</c:v>
                </c:pt>
                <c:pt idx="186">
                  <c:v>1061</c:v>
                </c:pt>
                <c:pt idx="187">
                  <c:v>327.9</c:v>
                </c:pt>
                <c:pt idx="188">
                  <c:v>28.72</c:v>
                </c:pt>
                <c:pt idx="189">
                  <c:v>1806</c:v>
                </c:pt>
                <c:pt idx="190">
                  <c:v>3251</c:v>
                </c:pt>
                <c:pt idx="191">
                  <c:v>728.1</c:v>
                </c:pt>
                <c:pt idx="192">
                  <c:v>885.1</c:v>
                </c:pt>
                <c:pt idx="193">
                  <c:v>286.10000000000002</c:v>
                </c:pt>
                <c:pt idx="194">
                  <c:v>247.1</c:v>
                </c:pt>
                <c:pt idx="195">
                  <c:v>1155</c:v>
                </c:pt>
                <c:pt idx="196">
                  <c:v>573.29999999999995</c:v>
                </c:pt>
                <c:pt idx="197">
                  <c:v>413</c:v>
                </c:pt>
                <c:pt idx="198">
                  <c:v>693.5</c:v>
                </c:pt>
                <c:pt idx="199">
                  <c:v>1082</c:v>
                </c:pt>
                <c:pt idx="200">
                  <c:v>679</c:v>
                </c:pt>
                <c:pt idx="201">
                  <c:v>413.7</c:v>
                </c:pt>
                <c:pt idx="202">
                  <c:v>710.5</c:v>
                </c:pt>
                <c:pt idx="203">
                  <c:v>530.4</c:v>
                </c:pt>
                <c:pt idx="204">
                  <c:v>361</c:v>
                </c:pt>
                <c:pt idx="205">
                  <c:v>768.2</c:v>
                </c:pt>
                <c:pt idx="206">
                  <c:v>1188</c:v>
                </c:pt>
                <c:pt idx="207">
                  <c:v>220.3</c:v>
                </c:pt>
                <c:pt idx="208">
                  <c:v>508.6</c:v>
                </c:pt>
                <c:pt idx="209">
                  <c:v>910.4</c:v>
                </c:pt>
                <c:pt idx="210">
                  <c:v>279.60000000000002</c:v>
                </c:pt>
                <c:pt idx="211">
                  <c:v>719.1</c:v>
                </c:pt>
                <c:pt idx="212">
                  <c:v>1736</c:v>
                </c:pt>
                <c:pt idx="213">
                  <c:v>535.79999999999995</c:v>
                </c:pt>
                <c:pt idx="214">
                  <c:v>1354</c:v>
                </c:pt>
                <c:pt idx="215">
                  <c:v>465.1</c:v>
                </c:pt>
                <c:pt idx="216">
                  <c:v>1356</c:v>
                </c:pt>
                <c:pt idx="217">
                  <c:v>892.3</c:v>
                </c:pt>
                <c:pt idx="218">
                  <c:v>765.6</c:v>
                </c:pt>
                <c:pt idx="219">
                  <c:v>1328</c:v>
                </c:pt>
                <c:pt idx="220">
                  <c:v>719.4</c:v>
                </c:pt>
                <c:pt idx="221">
                  <c:v>1412</c:v>
                </c:pt>
                <c:pt idx="222">
                  <c:v>45.4</c:v>
                </c:pt>
                <c:pt idx="223">
                  <c:v>281.89999999999998</c:v>
                </c:pt>
                <c:pt idx="224">
                  <c:v>617.4</c:v>
                </c:pt>
                <c:pt idx="225">
                  <c:v>523</c:v>
                </c:pt>
                <c:pt idx="226">
                  <c:v>334.4</c:v>
                </c:pt>
                <c:pt idx="227">
                  <c:v>2026</c:v>
                </c:pt>
                <c:pt idx="228">
                  <c:v>1670</c:v>
                </c:pt>
                <c:pt idx="229">
                  <c:v>1668</c:v>
                </c:pt>
                <c:pt idx="230">
                  <c:v>736.8</c:v>
                </c:pt>
                <c:pt idx="231">
                  <c:v>513.29999999999995</c:v>
                </c:pt>
                <c:pt idx="232">
                  <c:v>1733</c:v>
                </c:pt>
                <c:pt idx="233">
                  <c:v>71.86</c:v>
                </c:pt>
                <c:pt idx="234">
                  <c:v>593.6</c:v>
                </c:pt>
                <c:pt idx="235">
                  <c:v>113.5</c:v>
                </c:pt>
                <c:pt idx="236">
                  <c:v>96.68</c:v>
                </c:pt>
                <c:pt idx="237">
                  <c:v>743.8</c:v>
                </c:pt>
                <c:pt idx="238">
                  <c:v>1597</c:v>
                </c:pt>
                <c:pt idx="239">
                  <c:v>479</c:v>
                </c:pt>
                <c:pt idx="240">
                  <c:v>700.8</c:v>
                </c:pt>
                <c:pt idx="241">
                  <c:v>1034</c:v>
                </c:pt>
                <c:pt idx="242">
                  <c:v>1690</c:v>
                </c:pt>
                <c:pt idx="243">
                  <c:v>582.6</c:v>
                </c:pt>
                <c:pt idx="244">
                  <c:v>2954</c:v>
                </c:pt>
                <c:pt idx="245">
                  <c:v>423.2</c:v>
                </c:pt>
                <c:pt idx="246">
                  <c:v>1477</c:v>
                </c:pt>
                <c:pt idx="247">
                  <c:v>1132</c:v>
                </c:pt>
                <c:pt idx="248">
                  <c:v>1039</c:v>
                </c:pt>
                <c:pt idx="249">
                  <c:v>74.790000000000006</c:v>
                </c:pt>
                <c:pt idx="250">
                  <c:v>54.46</c:v>
                </c:pt>
                <c:pt idx="251">
                  <c:v>1251</c:v>
                </c:pt>
                <c:pt idx="252">
                  <c:v>706.2</c:v>
                </c:pt>
                <c:pt idx="253">
                  <c:v>1193</c:v>
                </c:pt>
                <c:pt idx="254">
                  <c:v>653.9</c:v>
                </c:pt>
                <c:pt idx="255">
                  <c:v>521.79999999999995</c:v>
                </c:pt>
                <c:pt idx="256">
                  <c:v>131.5</c:v>
                </c:pt>
                <c:pt idx="257">
                  <c:v>680.8</c:v>
                </c:pt>
                <c:pt idx="258">
                  <c:v>539.9</c:v>
                </c:pt>
                <c:pt idx="259">
                  <c:v>104.2</c:v>
                </c:pt>
                <c:pt idx="260">
                  <c:v>41.78</c:v>
                </c:pt>
                <c:pt idx="261">
                  <c:v>67.95</c:v>
                </c:pt>
                <c:pt idx="262">
                  <c:v>876.5</c:v>
                </c:pt>
                <c:pt idx="263">
                  <c:v>491.4</c:v>
                </c:pt>
                <c:pt idx="264">
                  <c:v>1990</c:v>
                </c:pt>
                <c:pt idx="265">
                  <c:v>3553</c:v>
                </c:pt>
                <c:pt idx="266">
                  <c:v>80.39</c:v>
                </c:pt>
                <c:pt idx="267">
                  <c:v>1155</c:v>
                </c:pt>
                <c:pt idx="268">
                  <c:v>1291</c:v>
                </c:pt>
                <c:pt idx="269">
                  <c:v>234.5</c:v>
                </c:pt>
                <c:pt idx="270">
                  <c:v>1515</c:v>
                </c:pt>
                <c:pt idx="271">
                  <c:v>584.70000000000005</c:v>
                </c:pt>
                <c:pt idx="272">
                  <c:v>799.2</c:v>
                </c:pt>
                <c:pt idx="273">
                  <c:v>405</c:v>
                </c:pt>
                <c:pt idx="274">
                  <c:v>358.9</c:v>
                </c:pt>
                <c:pt idx="275">
                  <c:v>301.5</c:v>
                </c:pt>
                <c:pt idx="276">
                  <c:v>794.8</c:v>
                </c:pt>
                <c:pt idx="277">
                  <c:v>106.1</c:v>
                </c:pt>
                <c:pt idx="278">
                  <c:v>1334</c:v>
                </c:pt>
                <c:pt idx="279">
                  <c:v>326.39999999999998</c:v>
                </c:pt>
                <c:pt idx="280">
                  <c:v>590.9</c:v>
                </c:pt>
                <c:pt idx="281">
                  <c:v>1386</c:v>
                </c:pt>
                <c:pt idx="282">
                  <c:v>1007</c:v>
                </c:pt>
                <c:pt idx="283">
                  <c:v>203.7</c:v>
                </c:pt>
                <c:pt idx="284">
                  <c:v>27.59</c:v>
                </c:pt>
                <c:pt idx="285">
                  <c:v>1472</c:v>
                </c:pt>
                <c:pt idx="286">
                  <c:v>77.47</c:v>
                </c:pt>
                <c:pt idx="287">
                  <c:v>318.8</c:v>
                </c:pt>
                <c:pt idx="288">
                  <c:v>669.8</c:v>
                </c:pt>
                <c:pt idx="289">
                  <c:v>3125</c:v>
                </c:pt>
                <c:pt idx="290">
                  <c:v>16.22</c:v>
                </c:pt>
                <c:pt idx="291">
                  <c:v>489.8</c:v>
                </c:pt>
                <c:pt idx="292">
                  <c:v>467.7</c:v>
                </c:pt>
                <c:pt idx="293">
                  <c:v>912.6</c:v>
                </c:pt>
                <c:pt idx="294">
                  <c:v>74.290000000000006</c:v>
                </c:pt>
                <c:pt idx="295">
                  <c:v>166.2</c:v>
                </c:pt>
                <c:pt idx="296">
                  <c:v>377.6</c:v>
                </c:pt>
                <c:pt idx="297">
                  <c:v>774.8</c:v>
                </c:pt>
                <c:pt idx="298">
                  <c:v>324.39999999999998</c:v>
                </c:pt>
                <c:pt idx="299">
                  <c:v>120.4</c:v>
                </c:pt>
                <c:pt idx="300">
                  <c:v>277.89999999999998</c:v>
                </c:pt>
                <c:pt idx="301">
                  <c:v>795.6</c:v>
                </c:pt>
                <c:pt idx="302">
                  <c:v>468.8</c:v>
                </c:pt>
                <c:pt idx="303">
                  <c:v>673.8</c:v>
                </c:pt>
                <c:pt idx="304">
                  <c:v>271.10000000000002</c:v>
                </c:pt>
                <c:pt idx="305">
                  <c:v>997.2</c:v>
                </c:pt>
                <c:pt idx="306">
                  <c:v>776.4</c:v>
                </c:pt>
                <c:pt idx="307">
                  <c:v>16.8</c:v>
                </c:pt>
                <c:pt idx="308">
                  <c:v>889.7</c:v>
                </c:pt>
                <c:pt idx="309">
                  <c:v>717.2</c:v>
                </c:pt>
                <c:pt idx="310">
                  <c:v>374</c:v>
                </c:pt>
                <c:pt idx="311">
                  <c:v>619.4</c:v>
                </c:pt>
                <c:pt idx="312">
                  <c:v>76.7</c:v>
                </c:pt>
                <c:pt idx="313">
                  <c:v>906</c:v>
                </c:pt>
                <c:pt idx="314">
                  <c:v>312.2</c:v>
                </c:pt>
                <c:pt idx="315">
                  <c:v>333.5</c:v>
                </c:pt>
                <c:pt idx="316">
                  <c:v>531.1</c:v>
                </c:pt>
                <c:pt idx="317">
                  <c:v>275</c:v>
                </c:pt>
                <c:pt idx="318">
                  <c:v>232.8</c:v>
                </c:pt>
                <c:pt idx="319">
                  <c:v>1166</c:v>
                </c:pt>
                <c:pt idx="320">
                  <c:v>833.7</c:v>
                </c:pt>
                <c:pt idx="321">
                  <c:v>1163</c:v>
                </c:pt>
                <c:pt idx="322">
                  <c:v>846.1</c:v>
                </c:pt>
                <c:pt idx="323">
                  <c:v>343.6</c:v>
                </c:pt>
                <c:pt idx="324">
                  <c:v>669.3</c:v>
                </c:pt>
                <c:pt idx="325">
                  <c:v>687.4</c:v>
                </c:pt>
                <c:pt idx="326">
                  <c:v>407</c:v>
                </c:pt>
                <c:pt idx="327">
                  <c:v>411.5</c:v>
                </c:pt>
                <c:pt idx="328">
                  <c:v>304.3</c:v>
                </c:pt>
                <c:pt idx="329">
                  <c:v>960.4</c:v>
                </c:pt>
                <c:pt idx="330">
                  <c:v>880.6</c:v>
                </c:pt>
                <c:pt idx="331">
                  <c:v>174.3</c:v>
                </c:pt>
                <c:pt idx="332">
                  <c:v>940</c:v>
                </c:pt>
                <c:pt idx="333">
                  <c:v>234.7</c:v>
                </c:pt>
                <c:pt idx="334">
                  <c:v>100.9</c:v>
                </c:pt>
                <c:pt idx="335">
                  <c:v>523.70000000000005</c:v>
                </c:pt>
                <c:pt idx="336">
                  <c:v>634.9</c:v>
                </c:pt>
                <c:pt idx="337">
                  <c:v>702.3</c:v>
                </c:pt>
                <c:pt idx="338">
                  <c:v>234.3</c:v>
                </c:pt>
                <c:pt idx="339">
                  <c:v>402.9</c:v>
                </c:pt>
                <c:pt idx="340">
                  <c:v>573.6</c:v>
                </c:pt>
                <c:pt idx="341">
                  <c:v>27.66</c:v>
                </c:pt>
                <c:pt idx="342">
                  <c:v>521.9</c:v>
                </c:pt>
                <c:pt idx="343">
                  <c:v>1580</c:v>
                </c:pt>
                <c:pt idx="344">
                  <c:v>396.1</c:v>
                </c:pt>
                <c:pt idx="345">
                  <c:v>1195</c:v>
                </c:pt>
                <c:pt idx="346">
                  <c:v>363.1</c:v>
                </c:pt>
                <c:pt idx="347">
                  <c:v>62.11</c:v>
                </c:pt>
                <c:pt idx="348">
                  <c:v>241.2</c:v>
                </c:pt>
                <c:pt idx="349">
                  <c:v>121.1</c:v>
                </c:pt>
                <c:pt idx="350">
                  <c:v>679.1</c:v>
                </c:pt>
                <c:pt idx="351">
                  <c:v>1699</c:v>
                </c:pt>
                <c:pt idx="352">
                  <c:v>1024</c:v>
                </c:pt>
                <c:pt idx="353">
                  <c:v>397.1</c:v>
                </c:pt>
                <c:pt idx="354">
                  <c:v>465.1</c:v>
                </c:pt>
                <c:pt idx="355">
                  <c:v>63.41</c:v>
                </c:pt>
                <c:pt idx="356">
                  <c:v>235.1</c:v>
                </c:pt>
                <c:pt idx="357">
                  <c:v>997.4</c:v>
                </c:pt>
                <c:pt idx="358">
                  <c:v>668.1</c:v>
                </c:pt>
                <c:pt idx="359">
                  <c:v>355.4</c:v>
                </c:pt>
                <c:pt idx="360">
                  <c:v>240.5</c:v>
                </c:pt>
                <c:pt idx="361">
                  <c:v>250.6</c:v>
                </c:pt>
                <c:pt idx="362">
                  <c:v>189.5</c:v>
                </c:pt>
                <c:pt idx="363">
                  <c:v>429.5</c:v>
                </c:pt>
                <c:pt idx="364">
                  <c:v>163.80000000000001</c:v>
                </c:pt>
                <c:pt idx="365">
                  <c:v>1448</c:v>
                </c:pt>
                <c:pt idx="366">
                  <c:v>246.7</c:v>
                </c:pt>
                <c:pt idx="367">
                  <c:v>727.9</c:v>
                </c:pt>
                <c:pt idx="368">
                  <c:v>237.1</c:v>
                </c:pt>
                <c:pt idx="369">
                  <c:v>70.510000000000005</c:v>
                </c:pt>
                <c:pt idx="370">
                  <c:v>216.8</c:v>
                </c:pt>
                <c:pt idx="371">
                  <c:v>568.4</c:v>
                </c:pt>
                <c:pt idx="372">
                  <c:v>351.5</c:v>
                </c:pt>
                <c:pt idx="373">
                  <c:v>2026</c:v>
                </c:pt>
                <c:pt idx="374">
                  <c:v>529.79999999999995</c:v>
                </c:pt>
                <c:pt idx="375">
                  <c:v>3226</c:v>
                </c:pt>
                <c:pt idx="376">
                  <c:v>289</c:v>
                </c:pt>
                <c:pt idx="377">
                  <c:v>215.7</c:v>
                </c:pt>
                <c:pt idx="378">
                  <c:v>162.6</c:v>
                </c:pt>
                <c:pt idx="379">
                  <c:v>157.30000000000001</c:v>
                </c:pt>
                <c:pt idx="380">
                  <c:v>1216</c:v>
                </c:pt>
                <c:pt idx="381">
                  <c:v>179.6</c:v>
                </c:pt>
                <c:pt idx="382">
                  <c:v>1490</c:v>
                </c:pt>
                <c:pt idx="383">
                  <c:v>1067</c:v>
                </c:pt>
                <c:pt idx="384">
                  <c:v>1196</c:v>
                </c:pt>
                <c:pt idx="385">
                  <c:v>1392</c:v>
                </c:pt>
                <c:pt idx="386">
                  <c:v>113</c:v>
                </c:pt>
                <c:pt idx="387">
                  <c:v>132</c:v>
                </c:pt>
                <c:pt idx="388">
                  <c:v>728.1</c:v>
                </c:pt>
                <c:pt idx="389">
                  <c:v>75.97</c:v>
                </c:pt>
                <c:pt idx="390">
                  <c:v>585.20000000000005</c:v>
                </c:pt>
                <c:pt idx="391">
                  <c:v>55.86</c:v>
                </c:pt>
                <c:pt idx="392">
                  <c:v>868.4</c:v>
                </c:pt>
                <c:pt idx="393">
                  <c:v>1286</c:v>
                </c:pt>
                <c:pt idx="394">
                  <c:v>760.9</c:v>
                </c:pt>
                <c:pt idx="395">
                  <c:v>402.3</c:v>
                </c:pt>
                <c:pt idx="396">
                  <c:v>1353</c:v>
                </c:pt>
                <c:pt idx="397">
                  <c:v>187</c:v>
                </c:pt>
                <c:pt idx="398">
                  <c:v>416.7</c:v>
                </c:pt>
                <c:pt idx="399">
                  <c:v>31.68</c:v>
                </c:pt>
                <c:pt idx="400">
                  <c:v>44.31</c:v>
                </c:pt>
                <c:pt idx="401">
                  <c:v>236.7</c:v>
                </c:pt>
                <c:pt idx="402">
                  <c:v>373.1</c:v>
                </c:pt>
                <c:pt idx="403">
                  <c:v>709.5</c:v>
                </c:pt>
                <c:pt idx="404">
                  <c:v>437.7</c:v>
                </c:pt>
                <c:pt idx="405">
                  <c:v>1413</c:v>
                </c:pt>
                <c:pt idx="406">
                  <c:v>209.4</c:v>
                </c:pt>
                <c:pt idx="407">
                  <c:v>192.2</c:v>
                </c:pt>
                <c:pt idx="408">
                  <c:v>619.9</c:v>
                </c:pt>
                <c:pt idx="409">
                  <c:v>502.7</c:v>
                </c:pt>
                <c:pt idx="410">
                  <c:v>288.8</c:v>
                </c:pt>
                <c:pt idx="411">
                  <c:v>503.8</c:v>
                </c:pt>
                <c:pt idx="412">
                  <c:v>73.55</c:v>
                </c:pt>
                <c:pt idx="413">
                  <c:v>660.9</c:v>
                </c:pt>
                <c:pt idx="414">
                  <c:v>123.6</c:v>
                </c:pt>
                <c:pt idx="415">
                  <c:v>1185</c:v>
                </c:pt>
                <c:pt idx="416">
                  <c:v>256.5</c:v>
                </c:pt>
                <c:pt idx="417">
                  <c:v>45.63</c:v>
                </c:pt>
                <c:pt idx="418">
                  <c:v>999.1</c:v>
                </c:pt>
                <c:pt idx="419">
                  <c:v>1212</c:v>
                </c:pt>
                <c:pt idx="420">
                  <c:v>1200</c:v>
                </c:pt>
                <c:pt idx="421">
                  <c:v>1205</c:v>
                </c:pt>
                <c:pt idx="422">
                  <c:v>13.98</c:v>
                </c:pt>
                <c:pt idx="423">
                  <c:v>195.2</c:v>
                </c:pt>
                <c:pt idx="424">
                  <c:v>654</c:v>
                </c:pt>
                <c:pt idx="425">
                  <c:v>112.8</c:v>
                </c:pt>
                <c:pt idx="426">
                  <c:v>102.6</c:v>
                </c:pt>
                <c:pt idx="427">
                  <c:v>330.3</c:v>
                </c:pt>
                <c:pt idx="428">
                  <c:v>139.1</c:v>
                </c:pt>
                <c:pt idx="429">
                  <c:v>633.20000000000005</c:v>
                </c:pt>
                <c:pt idx="430">
                  <c:v>385.2</c:v>
                </c:pt>
                <c:pt idx="431">
                  <c:v>400.8</c:v>
                </c:pt>
                <c:pt idx="432">
                  <c:v>482.8</c:v>
                </c:pt>
                <c:pt idx="433">
                  <c:v>54.17</c:v>
                </c:pt>
                <c:pt idx="434">
                  <c:v>22.5</c:v>
                </c:pt>
                <c:pt idx="435">
                  <c:v>460</c:v>
                </c:pt>
                <c:pt idx="436">
                  <c:v>905</c:v>
                </c:pt>
                <c:pt idx="437">
                  <c:v>1151</c:v>
                </c:pt>
                <c:pt idx="438">
                  <c:v>436.6</c:v>
                </c:pt>
                <c:pt idx="439">
                  <c:v>283.89999999999998</c:v>
                </c:pt>
                <c:pt idx="440">
                  <c:v>586.79999999999995</c:v>
                </c:pt>
                <c:pt idx="441">
                  <c:v>303.10000000000002</c:v>
                </c:pt>
              </c:numCache>
            </c:numRef>
          </c:yVal>
          <c:smooth val="0"/>
          <c:extLst xmlns:c16r2="http://schemas.microsoft.com/office/drawing/2015/06/chart">
            <c:ext xmlns:c16="http://schemas.microsoft.com/office/drawing/2014/chart" uri="{C3380CC4-5D6E-409C-BE32-E72D297353CC}">
              <c16:uniqueId val="{00000000-D178-4D43-84FF-2D3C0444FDF7}"/>
            </c:ext>
          </c:extLst>
        </c:ser>
        <c:dLbls>
          <c:showLegendKey val="0"/>
          <c:showVal val="0"/>
          <c:showCatName val="0"/>
          <c:showSerName val="0"/>
          <c:showPercent val="0"/>
          <c:showBubbleSize val="0"/>
        </c:dLbls>
        <c:axId val="-1517547408"/>
        <c:axId val="-1517549040"/>
      </c:scatterChart>
      <c:valAx>
        <c:axId val="-1517547408"/>
        <c:scaling>
          <c:orientation val="minMax"/>
        </c:scaling>
        <c:delete val="0"/>
        <c:axPos val="b"/>
        <c:title>
          <c:tx>
            <c:rich>
              <a:bodyPr rot="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a:t>SAT ADIPOQ (tpm)</a:t>
                </a:r>
                <a:endParaRPr lang="ko-KR"/>
              </a:p>
            </c:rich>
          </c:tx>
          <c:overlay val="0"/>
          <c:spPr>
            <a:noFill/>
            <a:ln>
              <a:noFill/>
            </a:ln>
            <a:effectLst/>
          </c:spPr>
          <c:txPr>
            <a:bodyPr rot="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1517549040"/>
        <c:crosses val="autoZero"/>
        <c:crossBetween val="midCat"/>
      </c:valAx>
      <c:valAx>
        <c:axId val="-1517549040"/>
        <c:scaling>
          <c:orientation val="minMax"/>
        </c:scaling>
        <c:delete val="0"/>
        <c:axPos val="l"/>
        <c:title>
          <c:tx>
            <c:rich>
              <a:bodyPr rot="-54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dirty="0"/>
                  <a:t>SAT GYG2 </a:t>
                </a:r>
                <a:r>
                  <a:rPr lang="en-US" dirty="0" smtClean="0"/>
                  <a:t>(</a:t>
                </a:r>
                <a:r>
                  <a:rPr lang="en-US" altLang="ko-KR" dirty="0" smtClean="0"/>
                  <a:t>TPM</a:t>
                </a:r>
                <a:r>
                  <a:rPr lang="en-US" dirty="0" smtClean="0"/>
                  <a:t>)</a:t>
                </a:r>
                <a:endParaRPr lang="ko-KR" dirty="0"/>
              </a:p>
            </c:rich>
          </c:tx>
          <c:layout>
            <c:manualLayout>
              <c:xMode val="edge"/>
              <c:yMode val="edge"/>
              <c:x val="1.5082777777777778E-2"/>
              <c:y val="0.14544375000000001"/>
            </c:manualLayout>
          </c:layout>
          <c:overlay val="0"/>
          <c:spPr>
            <a:noFill/>
            <a:ln>
              <a:noFill/>
            </a:ln>
            <a:effectLst/>
          </c:spPr>
          <c:txPr>
            <a:bodyPr rot="-54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1517547408"/>
        <c:crosses val="autoZero"/>
        <c:crossBetween val="midCat"/>
      </c:valAx>
      <c:spPr>
        <a:noFill/>
        <a:ln>
          <a:noFill/>
        </a:ln>
        <a:effectLst/>
      </c:spPr>
    </c:plotArea>
    <c:plotVisOnly val="1"/>
    <c:dispBlanksAs val="gap"/>
    <c:showDLblsOverMax val="0"/>
  </c:chart>
  <c:spPr>
    <a:noFill/>
    <a:ln>
      <a:noFill/>
    </a:ln>
    <a:effectLst/>
  </c:spPr>
  <c:txPr>
    <a:bodyPr/>
    <a:lstStyle/>
    <a:p>
      <a:pPr>
        <a:defRPr sz="800">
          <a:latin typeface="Arial" panose="020B0604020202020204" pitchFamily="34" charset="0"/>
          <a:cs typeface="Arial" panose="020B0604020202020204" pitchFamily="34" charset="0"/>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9602111111111112"/>
          <c:y val="5.0925925925925923E-2"/>
          <c:w val="0.59885111111111122"/>
          <c:h val="0.72938263888888888"/>
        </c:manualLayout>
      </c:layout>
      <c:scatterChart>
        <c:scatterStyle val="lineMarker"/>
        <c:varyColors val="0"/>
        <c:ser>
          <c:idx val="0"/>
          <c:order val="0"/>
          <c:spPr>
            <a:ln w="25400" cap="rnd">
              <a:noFill/>
              <a:round/>
            </a:ln>
            <a:effectLst/>
          </c:spPr>
          <c:marker>
            <c:symbol val="circle"/>
            <c:size val="2"/>
            <c:spPr>
              <a:solidFill>
                <a:schemeClr val="tx1"/>
              </a:solidFill>
              <a:ln w="9525">
                <a:noFill/>
              </a:ln>
              <a:effectLst/>
            </c:spPr>
          </c:marker>
          <c:trendline>
            <c:spPr>
              <a:ln w="19050" cap="rnd">
                <a:solidFill>
                  <a:schemeClr val="accent1"/>
                </a:solidFill>
                <a:prstDash val="sysDot"/>
              </a:ln>
              <a:effectLst/>
            </c:spPr>
            <c:trendlineType val="linear"/>
            <c:dispRSqr val="0"/>
            <c:dispEq val="0"/>
          </c:trendline>
          <c:trendline>
            <c:spPr>
              <a:ln w="19050" cap="rnd">
                <a:solidFill>
                  <a:schemeClr val="tx1"/>
                </a:solidFill>
                <a:prstDash val="solid"/>
              </a:ln>
              <a:effectLst/>
            </c:spPr>
            <c:trendlineType val="linear"/>
            <c:dispRSqr val="0"/>
            <c:dispEq val="0"/>
          </c:trendline>
          <c:xVal>
            <c:numRef>
              <c:f>sub!$L$8:$L$449</c:f>
              <c:numCache>
                <c:formatCode>General</c:formatCode>
                <c:ptCount val="442"/>
                <c:pt idx="0">
                  <c:v>375.1</c:v>
                </c:pt>
                <c:pt idx="1">
                  <c:v>261.60000000000002</c:v>
                </c:pt>
                <c:pt idx="2">
                  <c:v>450.3</c:v>
                </c:pt>
                <c:pt idx="3">
                  <c:v>74.84</c:v>
                </c:pt>
                <c:pt idx="4">
                  <c:v>138.9</c:v>
                </c:pt>
                <c:pt idx="5">
                  <c:v>232.8</c:v>
                </c:pt>
                <c:pt idx="6">
                  <c:v>190.5</c:v>
                </c:pt>
                <c:pt idx="7">
                  <c:v>443.6</c:v>
                </c:pt>
                <c:pt idx="8">
                  <c:v>335.7</c:v>
                </c:pt>
                <c:pt idx="9">
                  <c:v>240.4</c:v>
                </c:pt>
                <c:pt idx="10">
                  <c:v>198.2</c:v>
                </c:pt>
                <c:pt idx="11">
                  <c:v>449.6</c:v>
                </c:pt>
                <c:pt idx="12">
                  <c:v>252.4</c:v>
                </c:pt>
                <c:pt idx="13">
                  <c:v>133.69999999999999</c:v>
                </c:pt>
                <c:pt idx="14">
                  <c:v>164.8</c:v>
                </c:pt>
                <c:pt idx="15">
                  <c:v>352.2</c:v>
                </c:pt>
                <c:pt idx="16">
                  <c:v>387.5</c:v>
                </c:pt>
                <c:pt idx="17">
                  <c:v>282.60000000000002</c:v>
                </c:pt>
                <c:pt idx="18">
                  <c:v>271.8</c:v>
                </c:pt>
                <c:pt idx="19">
                  <c:v>24.36</c:v>
                </c:pt>
                <c:pt idx="20">
                  <c:v>310.7</c:v>
                </c:pt>
                <c:pt idx="21">
                  <c:v>258.5</c:v>
                </c:pt>
                <c:pt idx="22">
                  <c:v>69.680000000000007</c:v>
                </c:pt>
                <c:pt idx="23">
                  <c:v>461.9</c:v>
                </c:pt>
                <c:pt idx="24">
                  <c:v>419.8</c:v>
                </c:pt>
                <c:pt idx="25">
                  <c:v>406.9</c:v>
                </c:pt>
                <c:pt idx="26">
                  <c:v>179.6</c:v>
                </c:pt>
                <c:pt idx="27">
                  <c:v>182.3</c:v>
                </c:pt>
                <c:pt idx="28">
                  <c:v>268.8</c:v>
                </c:pt>
                <c:pt idx="29">
                  <c:v>140.69999999999999</c:v>
                </c:pt>
                <c:pt idx="30">
                  <c:v>224</c:v>
                </c:pt>
                <c:pt idx="31">
                  <c:v>484.7</c:v>
                </c:pt>
                <c:pt idx="32">
                  <c:v>27.98</c:v>
                </c:pt>
                <c:pt idx="33">
                  <c:v>2.2650000000000001</c:v>
                </c:pt>
                <c:pt idx="34">
                  <c:v>123.4</c:v>
                </c:pt>
                <c:pt idx="35">
                  <c:v>346</c:v>
                </c:pt>
                <c:pt idx="36">
                  <c:v>311.8</c:v>
                </c:pt>
                <c:pt idx="37">
                  <c:v>218</c:v>
                </c:pt>
                <c:pt idx="38">
                  <c:v>289.89999999999998</c:v>
                </c:pt>
                <c:pt idx="39">
                  <c:v>101.4</c:v>
                </c:pt>
                <c:pt idx="40">
                  <c:v>281.2</c:v>
                </c:pt>
                <c:pt idx="41">
                  <c:v>157.6</c:v>
                </c:pt>
                <c:pt idx="42">
                  <c:v>121.8</c:v>
                </c:pt>
                <c:pt idx="43">
                  <c:v>92.38</c:v>
                </c:pt>
                <c:pt idx="44">
                  <c:v>315.89999999999998</c:v>
                </c:pt>
                <c:pt idx="45">
                  <c:v>259.10000000000002</c:v>
                </c:pt>
                <c:pt idx="46">
                  <c:v>354.9</c:v>
                </c:pt>
                <c:pt idx="47">
                  <c:v>399.9</c:v>
                </c:pt>
                <c:pt idx="48">
                  <c:v>90.75</c:v>
                </c:pt>
                <c:pt idx="49">
                  <c:v>293.2</c:v>
                </c:pt>
                <c:pt idx="50">
                  <c:v>94.35</c:v>
                </c:pt>
                <c:pt idx="51">
                  <c:v>40.29</c:v>
                </c:pt>
                <c:pt idx="52">
                  <c:v>284.39999999999998</c:v>
                </c:pt>
                <c:pt idx="53">
                  <c:v>66.95</c:v>
                </c:pt>
                <c:pt idx="54">
                  <c:v>216.3</c:v>
                </c:pt>
                <c:pt idx="55">
                  <c:v>147.30000000000001</c:v>
                </c:pt>
                <c:pt idx="56">
                  <c:v>166.6</c:v>
                </c:pt>
                <c:pt idx="57">
                  <c:v>62.4</c:v>
                </c:pt>
                <c:pt idx="58">
                  <c:v>138</c:v>
                </c:pt>
                <c:pt idx="59">
                  <c:v>331.2</c:v>
                </c:pt>
                <c:pt idx="60">
                  <c:v>283.8</c:v>
                </c:pt>
                <c:pt idx="61">
                  <c:v>25.63</c:v>
                </c:pt>
                <c:pt idx="62">
                  <c:v>28.19</c:v>
                </c:pt>
                <c:pt idx="63">
                  <c:v>68.87</c:v>
                </c:pt>
                <c:pt idx="64">
                  <c:v>212.6</c:v>
                </c:pt>
                <c:pt idx="65">
                  <c:v>132</c:v>
                </c:pt>
                <c:pt idx="66">
                  <c:v>116.5</c:v>
                </c:pt>
                <c:pt idx="67">
                  <c:v>28.19</c:v>
                </c:pt>
                <c:pt idx="68">
                  <c:v>122.8</c:v>
                </c:pt>
                <c:pt idx="69">
                  <c:v>99.61</c:v>
                </c:pt>
                <c:pt idx="70">
                  <c:v>116.1</c:v>
                </c:pt>
                <c:pt idx="71">
                  <c:v>101.6</c:v>
                </c:pt>
                <c:pt idx="72">
                  <c:v>143.5</c:v>
                </c:pt>
                <c:pt idx="73">
                  <c:v>746.4</c:v>
                </c:pt>
                <c:pt idx="74">
                  <c:v>40.700000000000003</c:v>
                </c:pt>
                <c:pt idx="75">
                  <c:v>220.5</c:v>
                </c:pt>
                <c:pt idx="76">
                  <c:v>54.15</c:v>
                </c:pt>
                <c:pt idx="77">
                  <c:v>119.1</c:v>
                </c:pt>
                <c:pt idx="78">
                  <c:v>344.6</c:v>
                </c:pt>
                <c:pt idx="79">
                  <c:v>24.05</c:v>
                </c:pt>
                <c:pt idx="80">
                  <c:v>359.2</c:v>
                </c:pt>
                <c:pt idx="81">
                  <c:v>141.5</c:v>
                </c:pt>
                <c:pt idx="82">
                  <c:v>73.650000000000006</c:v>
                </c:pt>
                <c:pt idx="83">
                  <c:v>131.6</c:v>
                </c:pt>
                <c:pt idx="84">
                  <c:v>95.2</c:v>
                </c:pt>
                <c:pt idx="85">
                  <c:v>82.22</c:v>
                </c:pt>
                <c:pt idx="86">
                  <c:v>265.60000000000002</c:v>
                </c:pt>
                <c:pt idx="87">
                  <c:v>80.5</c:v>
                </c:pt>
                <c:pt idx="88">
                  <c:v>293.8</c:v>
                </c:pt>
                <c:pt idx="89">
                  <c:v>131.6</c:v>
                </c:pt>
                <c:pt idx="90">
                  <c:v>57.79</c:v>
                </c:pt>
                <c:pt idx="91">
                  <c:v>92.21</c:v>
                </c:pt>
                <c:pt idx="92">
                  <c:v>192.8</c:v>
                </c:pt>
                <c:pt idx="93">
                  <c:v>17.37</c:v>
                </c:pt>
                <c:pt idx="94">
                  <c:v>83.37</c:v>
                </c:pt>
                <c:pt idx="95">
                  <c:v>285</c:v>
                </c:pt>
                <c:pt idx="96">
                  <c:v>172.8</c:v>
                </c:pt>
                <c:pt idx="97">
                  <c:v>92.63</c:v>
                </c:pt>
                <c:pt idx="98">
                  <c:v>306.5</c:v>
                </c:pt>
                <c:pt idx="99">
                  <c:v>62.61</c:v>
                </c:pt>
                <c:pt idx="100">
                  <c:v>91.85</c:v>
                </c:pt>
                <c:pt idx="101">
                  <c:v>201</c:v>
                </c:pt>
                <c:pt idx="102">
                  <c:v>220.9</c:v>
                </c:pt>
                <c:pt idx="103">
                  <c:v>314.3</c:v>
                </c:pt>
                <c:pt idx="104">
                  <c:v>52.24</c:v>
                </c:pt>
                <c:pt idx="105">
                  <c:v>10.47</c:v>
                </c:pt>
                <c:pt idx="106">
                  <c:v>275.2</c:v>
                </c:pt>
                <c:pt idx="107">
                  <c:v>84.65</c:v>
                </c:pt>
                <c:pt idx="108">
                  <c:v>27.13</c:v>
                </c:pt>
                <c:pt idx="109">
                  <c:v>33.04</c:v>
                </c:pt>
                <c:pt idx="110">
                  <c:v>69.44</c:v>
                </c:pt>
                <c:pt idx="111">
                  <c:v>243</c:v>
                </c:pt>
                <c:pt idx="112">
                  <c:v>161.4</c:v>
                </c:pt>
                <c:pt idx="113">
                  <c:v>248.5</c:v>
                </c:pt>
                <c:pt idx="114">
                  <c:v>109</c:v>
                </c:pt>
                <c:pt idx="115">
                  <c:v>163.19999999999999</c:v>
                </c:pt>
                <c:pt idx="116">
                  <c:v>12.97</c:v>
                </c:pt>
                <c:pt idx="117">
                  <c:v>152.9</c:v>
                </c:pt>
                <c:pt idx="118">
                  <c:v>323.8</c:v>
                </c:pt>
                <c:pt idx="119">
                  <c:v>87.46</c:v>
                </c:pt>
                <c:pt idx="120">
                  <c:v>73.239999999999995</c:v>
                </c:pt>
                <c:pt idx="121">
                  <c:v>313.60000000000002</c:v>
                </c:pt>
                <c:pt idx="122">
                  <c:v>105.4</c:v>
                </c:pt>
                <c:pt idx="123">
                  <c:v>212.4</c:v>
                </c:pt>
                <c:pt idx="124">
                  <c:v>193.6</c:v>
                </c:pt>
                <c:pt idx="125">
                  <c:v>316.7</c:v>
                </c:pt>
                <c:pt idx="126">
                  <c:v>47.14</c:v>
                </c:pt>
                <c:pt idx="127">
                  <c:v>489</c:v>
                </c:pt>
                <c:pt idx="128">
                  <c:v>38.26</c:v>
                </c:pt>
                <c:pt idx="129">
                  <c:v>351.5</c:v>
                </c:pt>
                <c:pt idx="130">
                  <c:v>331.3</c:v>
                </c:pt>
                <c:pt idx="131">
                  <c:v>157.30000000000001</c:v>
                </c:pt>
                <c:pt idx="132">
                  <c:v>24.42</c:v>
                </c:pt>
                <c:pt idx="133">
                  <c:v>71.3</c:v>
                </c:pt>
                <c:pt idx="134">
                  <c:v>78.45</c:v>
                </c:pt>
                <c:pt idx="135">
                  <c:v>24.01</c:v>
                </c:pt>
                <c:pt idx="136">
                  <c:v>226.8</c:v>
                </c:pt>
                <c:pt idx="137">
                  <c:v>174.8</c:v>
                </c:pt>
                <c:pt idx="138">
                  <c:v>158.1</c:v>
                </c:pt>
                <c:pt idx="139">
                  <c:v>86.66</c:v>
                </c:pt>
                <c:pt idx="140">
                  <c:v>93.83</c:v>
                </c:pt>
                <c:pt idx="141">
                  <c:v>389.5</c:v>
                </c:pt>
                <c:pt idx="142">
                  <c:v>155.4</c:v>
                </c:pt>
                <c:pt idx="143">
                  <c:v>180.5</c:v>
                </c:pt>
                <c:pt idx="144">
                  <c:v>165.1</c:v>
                </c:pt>
                <c:pt idx="145">
                  <c:v>17.399999999999999</c:v>
                </c:pt>
                <c:pt idx="146">
                  <c:v>200.1</c:v>
                </c:pt>
                <c:pt idx="147">
                  <c:v>20.46</c:v>
                </c:pt>
                <c:pt idx="148">
                  <c:v>77.349999999999994</c:v>
                </c:pt>
                <c:pt idx="149">
                  <c:v>231.9</c:v>
                </c:pt>
                <c:pt idx="150">
                  <c:v>113.8</c:v>
                </c:pt>
                <c:pt idx="151">
                  <c:v>118.4</c:v>
                </c:pt>
                <c:pt idx="152">
                  <c:v>46.97</c:v>
                </c:pt>
                <c:pt idx="153">
                  <c:v>19.3</c:v>
                </c:pt>
                <c:pt idx="154">
                  <c:v>5.6639999999999997</c:v>
                </c:pt>
                <c:pt idx="155">
                  <c:v>179.7</c:v>
                </c:pt>
                <c:pt idx="156">
                  <c:v>82.98</c:v>
                </c:pt>
                <c:pt idx="157">
                  <c:v>169.6</c:v>
                </c:pt>
                <c:pt idx="158">
                  <c:v>207</c:v>
                </c:pt>
                <c:pt idx="159">
                  <c:v>162.5</c:v>
                </c:pt>
                <c:pt idx="160">
                  <c:v>191.9</c:v>
                </c:pt>
                <c:pt idx="161">
                  <c:v>14.71</c:v>
                </c:pt>
                <c:pt idx="162">
                  <c:v>159.1</c:v>
                </c:pt>
                <c:pt idx="163">
                  <c:v>100.4</c:v>
                </c:pt>
                <c:pt idx="164">
                  <c:v>145.19999999999999</c:v>
                </c:pt>
                <c:pt idx="165">
                  <c:v>95.45</c:v>
                </c:pt>
                <c:pt idx="166">
                  <c:v>61.36</c:v>
                </c:pt>
                <c:pt idx="167">
                  <c:v>125.6</c:v>
                </c:pt>
                <c:pt idx="168">
                  <c:v>29.29</c:v>
                </c:pt>
                <c:pt idx="169">
                  <c:v>132.80000000000001</c:v>
                </c:pt>
                <c:pt idx="170">
                  <c:v>140.80000000000001</c:v>
                </c:pt>
                <c:pt idx="171">
                  <c:v>59.53</c:v>
                </c:pt>
                <c:pt idx="172">
                  <c:v>24.76</c:v>
                </c:pt>
                <c:pt idx="173">
                  <c:v>40.299999999999997</c:v>
                </c:pt>
                <c:pt idx="174">
                  <c:v>84.54</c:v>
                </c:pt>
                <c:pt idx="175">
                  <c:v>185.2</c:v>
                </c:pt>
                <c:pt idx="176">
                  <c:v>124.2</c:v>
                </c:pt>
                <c:pt idx="177">
                  <c:v>59.14</c:v>
                </c:pt>
                <c:pt idx="178">
                  <c:v>78.819999999999993</c:v>
                </c:pt>
                <c:pt idx="179">
                  <c:v>40</c:v>
                </c:pt>
                <c:pt idx="180">
                  <c:v>89.49</c:v>
                </c:pt>
                <c:pt idx="181">
                  <c:v>123.2</c:v>
                </c:pt>
                <c:pt idx="182">
                  <c:v>121.5</c:v>
                </c:pt>
                <c:pt idx="183">
                  <c:v>129.69999999999999</c:v>
                </c:pt>
                <c:pt idx="184">
                  <c:v>110.5</c:v>
                </c:pt>
                <c:pt idx="185">
                  <c:v>115</c:v>
                </c:pt>
                <c:pt idx="186">
                  <c:v>168.6</c:v>
                </c:pt>
                <c:pt idx="187">
                  <c:v>82.08</c:v>
                </c:pt>
                <c:pt idx="188">
                  <c:v>5.5439999999999996</c:v>
                </c:pt>
                <c:pt idx="189">
                  <c:v>138.9</c:v>
                </c:pt>
                <c:pt idx="190">
                  <c:v>154.1</c:v>
                </c:pt>
                <c:pt idx="191">
                  <c:v>88.47</c:v>
                </c:pt>
                <c:pt idx="192">
                  <c:v>126</c:v>
                </c:pt>
                <c:pt idx="193">
                  <c:v>32.15</c:v>
                </c:pt>
                <c:pt idx="194">
                  <c:v>49.91</c:v>
                </c:pt>
                <c:pt idx="195">
                  <c:v>84.29</c:v>
                </c:pt>
                <c:pt idx="196">
                  <c:v>60.57</c:v>
                </c:pt>
                <c:pt idx="197">
                  <c:v>46.08</c:v>
                </c:pt>
                <c:pt idx="198">
                  <c:v>134.69999999999999</c:v>
                </c:pt>
                <c:pt idx="199">
                  <c:v>217.6</c:v>
                </c:pt>
                <c:pt idx="200">
                  <c:v>88.16</c:v>
                </c:pt>
                <c:pt idx="201">
                  <c:v>59.94</c:v>
                </c:pt>
                <c:pt idx="202">
                  <c:v>113.3</c:v>
                </c:pt>
                <c:pt idx="203">
                  <c:v>179.9</c:v>
                </c:pt>
                <c:pt idx="204">
                  <c:v>53.3</c:v>
                </c:pt>
                <c:pt idx="205">
                  <c:v>75.010000000000005</c:v>
                </c:pt>
                <c:pt idx="206">
                  <c:v>71.87</c:v>
                </c:pt>
                <c:pt idx="207">
                  <c:v>33.71</c:v>
                </c:pt>
                <c:pt idx="208">
                  <c:v>41.84</c:v>
                </c:pt>
                <c:pt idx="209">
                  <c:v>96.47</c:v>
                </c:pt>
                <c:pt idx="210">
                  <c:v>36.57</c:v>
                </c:pt>
                <c:pt idx="211">
                  <c:v>47.95</c:v>
                </c:pt>
                <c:pt idx="212">
                  <c:v>125.8</c:v>
                </c:pt>
                <c:pt idx="213">
                  <c:v>64.239999999999995</c:v>
                </c:pt>
                <c:pt idx="214">
                  <c:v>229.2</c:v>
                </c:pt>
                <c:pt idx="215">
                  <c:v>83.71</c:v>
                </c:pt>
                <c:pt idx="216">
                  <c:v>100.5</c:v>
                </c:pt>
                <c:pt idx="217">
                  <c:v>50.39</c:v>
                </c:pt>
                <c:pt idx="218">
                  <c:v>97.55</c:v>
                </c:pt>
                <c:pt idx="219">
                  <c:v>164.9</c:v>
                </c:pt>
                <c:pt idx="220">
                  <c:v>57.66</c:v>
                </c:pt>
                <c:pt idx="221">
                  <c:v>110.3</c:v>
                </c:pt>
                <c:pt idx="222">
                  <c:v>11.53</c:v>
                </c:pt>
                <c:pt idx="223">
                  <c:v>38.840000000000003</c:v>
                </c:pt>
                <c:pt idx="224">
                  <c:v>83.95</c:v>
                </c:pt>
                <c:pt idx="225">
                  <c:v>73.13</c:v>
                </c:pt>
                <c:pt idx="226">
                  <c:v>48.1</c:v>
                </c:pt>
                <c:pt idx="227">
                  <c:v>125</c:v>
                </c:pt>
                <c:pt idx="228">
                  <c:v>102.3</c:v>
                </c:pt>
                <c:pt idx="229">
                  <c:v>186.7</c:v>
                </c:pt>
                <c:pt idx="230">
                  <c:v>102.1</c:v>
                </c:pt>
                <c:pt idx="231">
                  <c:v>39.090000000000003</c:v>
                </c:pt>
                <c:pt idx="232">
                  <c:v>129.30000000000001</c:v>
                </c:pt>
                <c:pt idx="233">
                  <c:v>18.100000000000001</c:v>
                </c:pt>
                <c:pt idx="234">
                  <c:v>42.16</c:v>
                </c:pt>
                <c:pt idx="235">
                  <c:v>26.07</c:v>
                </c:pt>
                <c:pt idx="236">
                  <c:v>16.64</c:v>
                </c:pt>
                <c:pt idx="237">
                  <c:v>76.48</c:v>
                </c:pt>
                <c:pt idx="238">
                  <c:v>145.69999999999999</c:v>
                </c:pt>
                <c:pt idx="239">
                  <c:v>108.7</c:v>
                </c:pt>
                <c:pt idx="240">
                  <c:v>56.56</c:v>
                </c:pt>
                <c:pt idx="241">
                  <c:v>151.5</c:v>
                </c:pt>
                <c:pt idx="242">
                  <c:v>148.6</c:v>
                </c:pt>
                <c:pt idx="243">
                  <c:v>71.790000000000006</c:v>
                </c:pt>
                <c:pt idx="244">
                  <c:v>277.8</c:v>
                </c:pt>
                <c:pt idx="245">
                  <c:v>38.61</c:v>
                </c:pt>
                <c:pt idx="246">
                  <c:v>71.75</c:v>
                </c:pt>
                <c:pt idx="247">
                  <c:v>169.9</c:v>
                </c:pt>
                <c:pt idx="248">
                  <c:v>140.30000000000001</c:v>
                </c:pt>
                <c:pt idx="249">
                  <c:v>8.218</c:v>
                </c:pt>
                <c:pt idx="250">
                  <c:v>13.75</c:v>
                </c:pt>
                <c:pt idx="251">
                  <c:v>124.9</c:v>
                </c:pt>
                <c:pt idx="252">
                  <c:v>221.7</c:v>
                </c:pt>
                <c:pt idx="253">
                  <c:v>88.01</c:v>
                </c:pt>
                <c:pt idx="254">
                  <c:v>67.52</c:v>
                </c:pt>
                <c:pt idx="255">
                  <c:v>91.08</c:v>
                </c:pt>
                <c:pt idx="256">
                  <c:v>40.9</c:v>
                </c:pt>
                <c:pt idx="257">
                  <c:v>138</c:v>
                </c:pt>
                <c:pt idx="258">
                  <c:v>151.80000000000001</c:v>
                </c:pt>
                <c:pt idx="259">
                  <c:v>13.65</c:v>
                </c:pt>
                <c:pt idx="260">
                  <c:v>9.3780000000000001</c:v>
                </c:pt>
                <c:pt idx="261">
                  <c:v>13.97</c:v>
                </c:pt>
                <c:pt idx="262">
                  <c:v>60.96</c:v>
                </c:pt>
                <c:pt idx="263">
                  <c:v>58.08</c:v>
                </c:pt>
                <c:pt idx="264">
                  <c:v>175.3</c:v>
                </c:pt>
                <c:pt idx="265">
                  <c:v>269.60000000000002</c:v>
                </c:pt>
                <c:pt idx="266">
                  <c:v>20.04</c:v>
                </c:pt>
                <c:pt idx="267">
                  <c:v>109.4</c:v>
                </c:pt>
                <c:pt idx="268">
                  <c:v>73.11</c:v>
                </c:pt>
                <c:pt idx="269">
                  <c:v>29.61</c:v>
                </c:pt>
                <c:pt idx="270">
                  <c:v>45.84</c:v>
                </c:pt>
                <c:pt idx="271">
                  <c:v>71.03</c:v>
                </c:pt>
                <c:pt idx="272">
                  <c:v>70.98</c:v>
                </c:pt>
                <c:pt idx="273">
                  <c:v>80.64</c:v>
                </c:pt>
                <c:pt idx="274">
                  <c:v>68.849999999999994</c:v>
                </c:pt>
                <c:pt idx="275">
                  <c:v>37.61</c:v>
                </c:pt>
                <c:pt idx="276">
                  <c:v>101.8</c:v>
                </c:pt>
                <c:pt idx="277">
                  <c:v>14.72</c:v>
                </c:pt>
                <c:pt idx="278">
                  <c:v>256</c:v>
                </c:pt>
                <c:pt idx="279">
                  <c:v>41.65</c:v>
                </c:pt>
                <c:pt idx="280">
                  <c:v>73.28</c:v>
                </c:pt>
                <c:pt idx="281">
                  <c:v>112.4</c:v>
                </c:pt>
                <c:pt idx="282">
                  <c:v>92.12</c:v>
                </c:pt>
                <c:pt idx="283">
                  <c:v>25.82</c:v>
                </c:pt>
                <c:pt idx="284">
                  <c:v>6.819</c:v>
                </c:pt>
                <c:pt idx="285">
                  <c:v>89.64</c:v>
                </c:pt>
                <c:pt idx="286">
                  <c:v>9.9260000000000002</c:v>
                </c:pt>
                <c:pt idx="287">
                  <c:v>38.65</c:v>
                </c:pt>
                <c:pt idx="288">
                  <c:v>115.3</c:v>
                </c:pt>
                <c:pt idx="289">
                  <c:v>138.19999999999999</c:v>
                </c:pt>
                <c:pt idx="290">
                  <c:v>4.9400000000000004</c:v>
                </c:pt>
                <c:pt idx="291">
                  <c:v>78.5</c:v>
                </c:pt>
                <c:pt idx="292">
                  <c:v>61.59</c:v>
                </c:pt>
                <c:pt idx="293">
                  <c:v>156</c:v>
                </c:pt>
                <c:pt idx="294">
                  <c:v>17.68</c:v>
                </c:pt>
                <c:pt idx="295">
                  <c:v>43.98</c:v>
                </c:pt>
                <c:pt idx="296">
                  <c:v>33.89</c:v>
                </c:pt>
                <c:pt idx="297">
                  <c:v>86.87</c:v>
                </c:pt>
                <c:pt idx="298">
                  <c:v>36</c:v>
                </c:pt>
                <c:pt idx="299">
                  <c:v>16.739999999999998</c:v>
                </c:pt>
                <c:pt idx="300">
                  <c:v>56.62</c:v>
                </c:pt>
                <c:pt idx="301">
                  <c:v>102.8</c:v>
                </c:pt>
                <c:pt idx="302">
                  <c:v>84.64</c:v>
                </c:pt>
                <c:pt idx="303">
                  <c:v>88.07</c:v>
                </c:pt>
                <c:pt idx="304">
                  <c:v>56.65</c:v>
                </c:pt>
                <c:pt idx="305">
                  <c:v>150</c:v>
                </c:pt>
                <c:pt idx="306">
                  <c:v>76.98</c:v>
                </c:pt>
                <c:pt idx="307">
                  <c:v>6.5990000000000002</c:v>
                </c:pt>
                <c:pt idx="308">
                  <c:v>56.59</c:v>
                </c:pt>
                <c:pt idx="309">
                  <c:v>125.8</c:v>
                </c:pt>
                <c:pt idx="310">
                  <c:v>40.22</c:v>
                </c:pt>
                <c:pt idx="311">
                  <c:v>102.1</c:v>
                </c:pt>
                <c:pt idx="312">
                  <c:v>18.059999999999999</c:v>
                </c:pt>
                <c:pt idx="313">
                  <c:v>118.1</c:v>
                </c:pt>
                <c:pt idx="314">
                  <c:v>53.5</c:v>
                </c:pt>
                <c:pt idx="315">
                  <c:v>39.65</c:v>
                </c:pt>
                <c:pt idx="316">
                  <c:v>64.39</c:v>
                </c:pt>
                <c:pt idx="317">
                  <c:v>48.17</c:v>
                </c:pt>
                <c:pt idx="318">
                  <c:v>22.64</c:v>
                </c:pt>
                <c:pt idx="319">
                  <c:v>161.4</c:v>
                </c:pt>
                <c:pt idx="320">
                  <c:v>119.1</c:v>
                </c:pt>
                <c:pt idx="321">
                  <c:v>119.5</c:v>
                </c:pt>
                <c:pt idx="322">
                  <c:v>136</c:v>
                </c:pt>
                <c:pt idx="323">
                  <c:v>37.85</c:v>
                </c:pt>
                <c:pt idx="324">
                  <c:v>52.28</c:v>
                </c:pt>
                <c:pt idx="325">
                  <c:v>69.48</c:v>
                </c:pt>
                <c:pt idx="326">
                  <c:v>56.36</c:v>
                </c:pt>
                <c:pt idx="327">
                  <c:v>82.52</c:v>
                </c:pt>
                <c:pt idx="328">
                  <c:v>27.77</c:v>
                </c:pt>
                <c:pt idx="329">
                  <c:v>104.3</c:v>
                </c:pt>
                <c:pt idx="330">
                  <c:v>90.99</c:v>
                </c:pt>
                <c:pt idx="331">
                  <c:v>27.23</c:v>
                </c:pt>
                <c:pt idx="332">
                  <c:v>110.5</c:v>
                </c:pt>
                <c:pt idx="333">
                  <c:v>40.33</c:v>
                </c:pt>
                <c:pt idx="334">
                  <c:v>14.17</c:v>
                </c:pt>
                <c:pt idx="335">
                  <c:v>52.57</c:v>
                </c:pt>
                <c:pt idx="336">
                  <c:v>53.06</c:v>
                </c:pt>
                <c:pt idx="337">
                  <c:v>75.709999999999994</c:v>
                </c:pt>
                <c:pt idx="338">
                  <c:v>39.22</c:v>
                </c:pt>
                <c:pt idx="339">
                  <c:v>36.369999999999997</c:v>
                </c:pt>
                <c:pt idx="340">
                  <c:v>148.4</c:v>
                </c:pt>
                <c:pt idx="341">
                  <c:v>6.1070000000000002</c:v>
                </c:pt>
                <c:pt idx="342">
                  <c:v>60.05</c:v>
                </c:pt>
                <c:pt idx="343">
                  <c:v>87.23</c:v>
                </c:pt>
                <c:pt idx="344">
                  <c:v>26.92</c:v>
                </c:pt>
                <c:pt idx="345">
                  <c:v>203.6</c:v>
                </c:pt>
                <c:pt idx="346">
                  <c:v>42.8</c:v>
                </c:pt>
                <c:pt idx="347">
                  <c:v>11.87</c:v>
                </c:pt>
                <c:pt idx="348">
                  <c:v>32.89</c:v>
                </c:pt>
                <c:pt idx="349">
                  <c:v>55.97</c:v>
                </c:pt>
                <c:pt idx="350">
                  <c:v>54.56</c:v>
                </c:pt>
                <c:pt idx="351">
                  <c:v>90.18</c:v>
                </c:pt>
                <c:pt idx="352">
                  <c:v>77.7</c:v>
                </c:pt>
                <c:pt idx="353">
                  <c:v>36.619999999999997</c:v>
                </c:pt>
                <c:pt idx="354">
                  <c:v>64.12</c:v>
                </c:pt>
                <c:pt idx="355">
                  <c:v>8.91</c:v>
                </c:pt>
                <c:pt idx="356">
                  <c:v>33.33</c:v>
                </c:pt>
                <c:pt idx="357">
                  <c:v>75.28</c:v>
                </c:pt>
                <c:pt idx="358">
                  <c:v>185.8</c:v>
                </c:pt>
                <c:pt idx="359">
                  <c:v>22.75</c:v>
                </c:pt>
                <c:pt idx="360">
                  <c:v>55.7</c:v>
                </c:pt>
                <c:pt idx="361">
                  <c:v>36.24</c:v>
                </c:pt>
                <c:pt idx="362">
                  <c:v>22.48</c:v>
                </c:pt>
                <c:pt idx="363">
                  <c:v>55.07</c:v>
                </c:pt>
                <c:pt idx="364">
                  <c:v>24.26</c:v>
                </c:pt>
                <c:pt idx="365">
                  <c:v>172.1</c:v>
                </c:pt>
                <c:pt idx="366">
                  <c:v>24.97</c:v>
                </c:pt>
                <c:pt idx="367">
                  <c:v>82.94</c:v>
                </c:pt>
                <c:pt idx="368">
                  <c:v>42.63</c:v>
                </c:pt>
                <c:pt idx="369">
                  <c:v>23.52</c:v>
                </c:pt>
                <c:pt idx="370">
                  <c:v>48.93</c:v>
                </c:pt>
                <c:pt idx="371">
                  <c:v>85.42</c:v>
                </c:pt>
                <c:pt idx="372">
                  <c:v>39.020000000000003</c:v>
                </c:pt>
                <c:pt idx="373">
                  <c:v>112.7</c:v>
                </c:pt>
                <c:pt idx="374">
                  <c:v>53</c:v>
                </c:pt>
                <c:pt idx="375">
                  <c:v>270.60000000000002</c:v>
                </c:pt>
                <c:pt idx="376">
                  <c:v>28.74</c:v>
                </c:pt>
                <c:pt idx="377">
                  <c:v>33.6</c:v>
                </c:pt>
                <c:pt idx="378">
                  <c:v>22.43</c:v>
                </c:pt>
                <c:pt idx="379">
                  <c:v>10.24</c:v>
                </c:pt>
                <c:pt idx="380">
                  <c:v>140.30000000000001</c:v>
                </c:pt>
                <c:pt idx="381">
                  <c:v>36.520000000000003</c:v>
                </c:pt>
                <c:pt idx="382">
                  <c:v>374.1</c:v>
                </c:pt>
                <c:pt idx="383">
                  <c:v>124.8</c:v>
                </c:pt>
                <c:pt idx="384">
                  <c:v>110.5</c:v>
                </c:pt>
                <c:pt idx="385">
                  <c:v>140.4</c:v>
                </c:pt>
                <c:pt idx="386">
                  <c:v>42.23</c:v>
                </c:pt>
                <c:pt idx="387">
                  <c:v>13.49</c:v>
                </c:pt>
                <c:pt idx="388">
                  <c:v>113.9</c:v>
                </c:pt>
                <c:pt idx="389">
                  <c:v>19.62</c:v>
                </c:pt>
                <c:pt idx="390">
                  <c:v>36.35</c:v>
                </c:pt>
                <c:pt idx="391">
                  <c:v>5.7649999999999997</c:v>
                </c:pt>
                <c:pt idx="392">
                  <c:v>144.6</c:v>
                </c:pt>
                <c:pt idx="393">
                  <c:v>123</c:v>
                </c:pt>
                <c:pt idx="394">
                  <c:v>74.09</c:v>
                </c:pt>
                <c:pt idx="395">
                  <c:v>32</c:v>
                </c:pt>
                <c:pt idx="396">
                  <c:v>147.19999999999999</c:v>
                </c:pt>
                <c:pt idx="397">
                  <c:v>32.43</c:v>
                </c:pt>
                <c:pt idx="398">
                  <c:v>39.869999999999997</c:v>
                </c:pt>
                <c:pt idx="399">
                  <c:v>10.86</c:v>
                </c:pt>
                <c:pt idx="400">
                  <c:v>8.0820000000000007</c:v>
                </c:pt>
                <c:pt idx="401">
                  <c:v>23.69</c:v>
                </c:pt>
                <c:pt idx="402">
                  <c:v>53.02</c:v>
                </c:pt>
                <c:pt idx="403">
                  <c:v>93.96</c:v>
                </c:pt>
                <c:pt idx="404">
                  <c:v>74.459999999999994</c:v>
                </c:pt>
                <c:pt idx="405">
                  <c:v>174.5</c:v>
                </c:pt>
                <c:pt idx="406">
                  <c:v>43.43</c:v>
                </c:pt>
                <c:pt idx="407">
                  <c:v>24.14</c:v>
                </c:pt>
                <c:pt idx="408">
                  <c:v>46.64</c:v>
                </c:pt>
                <c:pt idx="409">
                  <c:v>33.07</c:v>
                </c:pt>
                <c:pt idx="410">
                  <c:v>42.18</c:v>
                </c:pt>
                <c:pt idx="411">
                  <c:v>59.06</c:v>
                </c:pt>
                <c:pt idx="412">
                  <c:v>16.510000000000002</c:v>
                </c:pt>
                <c:pt idx="413">
                  <c:v>53.52</c:v>
                </c:pt>
                <c:pt idx="414">
                  <c:v>26.95</c:v>
                </c:pt>
                <c:pt idx="415">
                  <c:v>92.85</c:v>
                </c:pt>
                <c:pt idx="416">
                  <c:v>21.39</c:v>
                </c:pt>
                <c:pt idx="417">
                  <c:v>14.06</c:v>
                </c:pt>
                <c:pt idx="418">
                  <c:v>64.78</c:v>
                </c:pt>
                <c:pt idx="419">
                  <c:v>121.6</c:v>
                </c:pt>
                <c:pt idx="420">
                  <c:v>125.9</c:v>
                </c:pt>
                <c:pt idx="421">
                  <c:v>85.52</c:v>
                </c:pt>
                <c:pt idx="422">
                  <c:v>1.694</c:v>
                </c:pt>
                <c:pt idx="423">
                  <c:v>36.92</c:v>
                </c:pt>
                <c:pt idx="424">
                  <c:v>80.39</c:v>
                </c:pt>
                <c:pt idx="425">
                  <c:v>22.95</c:v>
                </c:pt>
                <c:pt idx="426">
                  <c:v>17.100000000000001</c:v>
                </c:pt>
                <c:pt idx="427">
                  <c:v>41.93</c:v>
                </c:pt>
                <c:pt idx="428">
                  <c:v>28.32</c:v>
                </c:pt>
                <c:pt idx="429">
                  <c:v>68.260000000000005</c:v>
                </c:pt>
                <c:pt idx="430">
                  <c:v>29.62</c:v>
                </c:pt>
                <c:pt idx="431">
                  <c:v>64.98</c:v>
                </c:pt>
                <c:pt idx="432">
                  <c:v>85.19</c:v>
                </c:pt>
                <c:pt idx="433">
                  <c:v>6.8970000000000002</c:v>
                </c:pt>
                <c:pt idx="434">
                  <c:v>6.5910000000000002</c:v>
                </c:pt>
                <c:pt idx="435">
                  <c:v>100.7</c:v>
                </c:pt>
                <c:pt idx="436">
                  <c:v>72.88</c:v>
                </c:pt>
                <c:pt idx="437">
                  <c:v>126</c:v>
                </c:pt>
                <c:pt idx="438">
                  <c:v>49.26</c:v>
                </c:pt>
                <c:pt idx="439">
                  <c:v>30.71</c:v>
                </c:pt>
                <c:pt idx="440">
                  <c:v>134.80000000000001</c:v>
                </c:pt>
                <c:pt idx="441">
                  <c:v>45.42</c:v>
                </c:pt>
              </c:numCache>
            </c:numRef>
          </c:xVal>
          <c:yVal>
            <c:numRef>
              <c:f>sub!$N$8:$N$449</c:f>
              <c:numCache>
                <c:formatCode>General</c:formatCode>
                <c:ptCount val="442"/>
                <c:pt idx="0">
                  <c:v>581.5</c:v>
                </c:pt>
                <c:pt idx="1">
                  <c:v>156.4</c:v>
                </c:pt>
                <c:pt idx="2">
                  <c:v>1409</c:v>
                </c:pt>
                <c:pt idx="3">
                  <c:v>61.12</c:v>
                </c:pt>
                <c:pt idx="4">
                  <c:v>478.4</c:v>
                </c:pt>
                <c:pt idx="5">
                  <c:v>439.2</c:v>
                </c:pt>
                <c:pt idx="6">
                  <c:v>321.8</c:v>
                </c:pt>
                <c:pt idx="7">
                  <c:v>1139</c:v>
                </c:pt>
                <c:pt idx="8">
                  <c:v>895.1</c:v>
                </c:pt>
                <c:pt idx="9">
                  <c:v>2078</c:v>
                </c:pt>
                <c:pt idx="10">
                  <c:v>207</c:v>
                </c:pt>
                <c:pt idx="11">
                  <c:v>752.3</c:v>
                </c:pt>
                <c:pt idx="12">
                  <c:v>143.5</c:v>
                </c:pt>
                <c:pt idx="13">
                  <c:v>6.9240000000000004</c:v>
                </c:pt>
                <c:pt idx="14">
                  <c:v>167.3</c:v>
                </c:pt>
                <c:pt idx="15">
                  <c:v>2336</c:v>
                </c:pt>
                <c:pt idx="16">
                  <c:v>1292</c:v>
                </c:pt>
                <c:pt idx="17">
                  <c:v>425.2</c:v>
                </c:pt>
                <c:pt idx="18">
                  <c:v>163.19999999999999</c:v>
                </c:pt>
                <c:pt idx="19">
                  <c:v>10.15</c:v>
                </c:pt>
                <c:pt idx="20">
                  <c:v>980.3</c:v>
                </c:pt>
                <c:pt idx="21">
                  <c:v>751.2</c:v>
                </c:pt>
                <c:pt idx="22">
                  <c:v>148.5</c:v>
                </c:pt>
                <c:pt idx="23">
                  <c:v>408.4</c:v>
                </c:pt>
                <c:pt idx="24">
                  <c:v>865.7</c:v>
                </c:pt>
                <c:pt idx="25">
                  <c:v>1105</c:v>
                </c:pt>
                <c:pt idx="26">
                  <c:v>422.2</c:v>
                </c:pt>
                <c:pt idx="27">
                  <c:v>729</c:v>
                </c:pt>
                <c:pt idx="28">
                  <c:v>314.5</c:v>
                </c:pt>
                <c:pt idx="29">
                  <c:v>119.1</c:v>
                </c:pt>
                <c:pt idx="30">
                  <c:v>1376</c:v>
                </c:pt>
                <c:pt idx="31">
                  <c:v>1523</c:v>
                </c:pt>
                <c:pt idx="32">
                  <c:v>7.4560000000000004</c:v>
                </c:pt>
                <c:pt idx="33">
                  <c:v>10.45</c:v>
                </c:pt>
                <c:pt idx="34">
                  <c:v>77.23</c:v>
                </c:pt>
                <c:pt idx="35">
                  <c:v>3647</c:v>
                </c:pt>
                <c:pt idx="36">
                  <c:v>555.70000000000005</c:v>
                </c:pt>
                <c:pt idx="37">
                  <c:v>1540</c:v>
                </c:pt>
                <c:pt idx="38">
                  <c:v>1357</c:v>
                </c:pt>
                <c:pt idx="39">
                  <c:v>54.61</c:v>
                </c:pt>
                <c:pt idx="40">
                  <c:v>2774</c:v>
                </c:pt>
                <c:pt idx="41">
                  <c:v>137.1</c:v>
                </c:pt>
                <c:pt idx="42">
                  <c:v>135.4</c:v>
                </c:pt>
                <c:pt idx="43">
                  <c:v>309.39999999999998</c:v>
                </c:pt>
                <c:pt idx="44">
                  <c:v>134.5</c:v>
                </c:pt>
                <c:pt idx="45">
                  <c:v>1481</c:v>
                </c:pt>
                <c:pt idx="46">
                  <c:v>480.4</c:v>
                </c:pt>
                <c:pt idx="47">
                  <c:v>3364</c:v>
                </c:pt>
                <c:pt idx="48">
                  <c:v>18.73</c:v>
                </c:pt>
                <c:pt idx="49">
                  <c:v>1025</c:v>
                </c:pt>
                <c:pt idx="50">
                  <c:v>149.19999999999999</c:v>
                </c:pt>
                <c:pt idx="51">
                  <c:v>34.020000000000003</c:v>
                </c:pt>
                <c:pt idx="52">
                  <c:v>1123</c:v>
                </c:pt>
                <c:pt idx="53">
                  <c:v>211.4</c:v>
                </c:pt>
                <c:pt idx="54">
                  <c:v>183.6</c:v>
                </c:pt>
                <c:pt idx="55">
                  <c:v>187.2</c:v>
                </c:pt>
                <c:pt idx="56">
                  <c:v>516.29999999999995</c:v>
                </c:pt>
                <c:pt idx="57">
                  <c:v>273.7</c:v>
                </c:pt>
                <c:pt idx="58">
                  <c:v>434</c:v>
                </c:pt>
                <c:pt idx="59">
                  <c:v>680.8</c:v>
                </c:pt>
                <c:pt idx="60">
                  <c:v>1235</c:v>
                </c:pt>
                <c:pt idx="61">
                  <c:v>134.69999999999999</c:v>
                </c:pt>
                <c:pt idx="62">
                  <c:v>49.47</c:v>
                </c:pt>
                <c:pt idx="63">
                  <c:v>621.79999999999995</c:v>
                </c:pt>
                <c:pt idx="64">
                  <c:v>1361</c:v>
                </c:pt>
                <c:pt idx="65">
                  <c:v>1384</c:v>
                </c:pt>
                <c:pt idx="66">
                  <c:v>109.5</c:v>
                </c:pt>
                <c:pt idx="67">
                  <c:v>59.62</c:v>
                </c:pt>
                <c:pt idx="68">
                  <c:v>127.7</c:v>
                </c:pt>
                <c:pt idx="69">
                  <c:v>214.7</c:v>
                </c:pt>
                <c:pt idx="70">
                  <c:v>1383</c:v>
                </c:pt>
                <c:pt idx="71">
                  <c:v>282.3</c:v>
                </c:pt>
                <c:pt idx="72">
                  <c:v>261.89999999999998</c:v>
                </c:pt>
                <c:pt idx="73">
                  <c:v>949.5</c:v>
                </c:pt>
                <c:pt idx="74">
                  <c:v>266.10000000000002</c:v>
                </c:pt>
                <c:pt idx="75">
                  <c:v>936.5</c:v>
                </c:pt>
                <c:pt idx="76">
                  <c:v>24.34</c:v>
                </c:pt>
                <c:pt idx="77">
                  <c:v>704.4</c:v>
                </c:pt>
                <c:pt idx="78">
                  <c:v>753.2</c:v>
                </c:pt>
                <c:pt idx="79">
                  <c:v>37.97</c:v>
                </c:pt>
                <c:pt idx="80">
                  <c:v>1564</c:v>
                </c:pt>
                <c:pt idx="81">
                  <c:v>505.2</c:v>
                </c:pt>
                <c:pt idx="82">
                  <c:v>105.8</c:v>
                </c:pt>
                <c:pt idx="83">
                  <c:v>690.6</c:v>
                </c:pt>
                <c:pt idx="84">
                  <c:v>270.10000000000002</c:v>
                </c:pt>
                <c:pt idx="85">
                  <c:v>206.9</c:v>
                </c:pt>
                <c:pt idx="86">
                  <c:v>385.5</c:v>
                </c:pt>
                <c:pt idx="87">
                  <c:v>9.1910000000000007</c:v>
                </c:pt>
                <c:pt idx="88">
                  <c:v>1724</c:v>
                </c:pt>
                <c:pt idx="89">
                  <c:v>342.8</c:v>
                </c:pt>
                <c:pt idx="90">
                  <c:v>38.56</c:v>
                </c:pt>
                <c:pt idx="91">
                  <c:v>1299</c:v>
                </c:pt>
                <c:pt idx="92">
                  <c:v>154.30000000000001</c:v>
                </c:pt>
                <c:pt idx="93">
                  <c:v>8.4019999999999992</c:v>
                </c:pt>
                <c:pt idx="94">
                  <c:v>102.3</c:v>
                </c:pt>
                <c:pt idx="95">
                  <c:v>960</c:v>
                </c:pt>
                <c:pt idx="96">
                  <c:v>1372</c:v>
                </c:pt>
                <c:pt idx="97">
                  <c:v>144.9</c:v>
                </c:pt>
                <c:pt idx="98">
                  <c:v>464.3</c:v>
                </c:pt>
                <c:pt idx="99">
                  <c:v>52.11</c:v>
                </c:pt>
                <c:pt idx="100">
                  <c:v>203.5</c:v>
                </c:pt>
                <c:pt idx="101">
                  <c:v>2362</c:v>
                </c:pt>
                <c:pt idx="102">
                  <c:v>394.9</c:v>
                </c:pt>
                <c:pt idx="103">
                  <c:v>1108</c:v>
                </c:pt>
                <c:pt idx="104">
                  <c:v>56.33</c:v>
                </c:pt>
                <c:pt idx="105">
                  <c:v>10.14</c:v>
                </c:pt>
                <c:pt idx="106">
                  <c:v>543.20000000000005</c:v>
                </c:pt>
                <c:pt idx="107">
                  <c:v>158.4</c:v>
                </c:pt>
                <c:pt idx="108">
                  <c:v>7.1890000000000001</c:v>
                </c:pt>
                <c:pt idx="109">
                  <c:v>37</c:v>
                </c:pt>
                <c:pt idx="110">
                  <c:v>108.1</c:v>
                </c:pt>
                <c:pt idx="111">
                  <c:v>622.70000000000005</c:v>
                </c:pt>
                <c:pt idx="112">
                  <c:v>228.6</c:v>
                </c:pt>
                <c:pt idx="113">
                  <c:v>1516</c:v>
                </c:pt>
                <c:pt idx="114">
                  <c:v>212.3</c:v>
                </c:pt>
                <c:pt idx="115">
                  <c:v>445.4</c:v>
                </c:pt>
                <c:pt idx="116">
                  <c:v>81.17</c:v>
                </c:pt>
                <c:pt idx="117">
                  <c:v>448.9</c:v>
                </c:pt>
                <c:pt idx="118">
                  <c:v>1876</c:v>
                </c:pt>
                <c:pt idx="119">
                  <c:v>97.92</c:v>
                </c:pt>
                <c:pt idx="120">
                  <c:v>32.46</c:v>
                </c:pt>
                <c:pt idx="121">
                  <c:v>2678</c:v>
                </c:pt>
                <c:pt idx="122">
                  <c:v>150.6</c:v>
                </c:pt>
                <c:pt idx="123">
                  <c:v>561.20000000000005</c:v>
                </c:pt>
                <c:pt idx="124">
                  <c:v>779.4</c:v>
                </c:pt>
                <c:pt idx="125">
                  <c:v>831.7</c:v>
                </c:pt>
                <c:pt idx="126">
                  <c:v>441.3</c:v>
                </c:pt>
                <c:pt idx="127">
                  <c:v>693.2</c:v>
                </c:pt>
                <c:pt idx="128">
                  <c:v>33.68</c:v>
                </c:pt>
                <c:pt idx="129">
                  <c:v>1039</c:v>
                </c:pt>
                <c:pt idx="130">
                  <c:v>2727</c:v>
                </c:pt>
                <c:pt idx="131">
                  <c:v>4.7610000000000001</c:v>
                </c:pt>
                <c:pt idx="132">
                  <c:v>19.03</c:v>
                </c:pt>
                <c:pt idx="133">
                  <c:v>332.5</c:v>
                </c:pt>
                <c:pt idx="134">
                  <c:v>30.12</c:v>
                </c:pt>
                <c:pt idx="135">
                  <c:v>35.26</c:v>
                </c:pt>
                <c:pt idx="136">
                  <c:v>1837</c:v>
                </c:pt>
                <c:pt idx="137">
                  <c:v>297.2</c:v>
                </c:pt>
                <c:pt idx="138">
                  <c:v>1049</c:v>
                </c:pt>
                <c:pt idx="139">
                  <c:v>89.57</c:v>
                </c:pt>
                <c:pt idx="140">
                  <c:v>206.7</c:v>
                </c:pt>
                <c:pt idx="141">
                  <c:v>604.70000000000005</c:v>
                </c:pt>
                <c:pt idx="142">
                  <c:v>261</c:v>
                </c:pt>
                <c:pt idx="143">
                  <c:v>68.930000000000007</c:v>
                </c:pt>
                <c:pt idx="144">
                  <c:v>1306</c:v>
                </c:pt>
                <c:pt idx="145">
                  <c:v>129.30000000000001</c:v>
                </c:pt>
                <c:pt idx="146">
                  <c:v>1025</c:v>
                </c:pt>
                <c:pt idx="147">
                  <c:v>3.4340000000000002</c:v>
                </c:pt>
                <c:pt idx="148">
                  <c:v>293.89999999999998</c:v>
                </c:pt>
                <c:pt idx="149">
                  <c:v>1216</c:v>
                </c:pt>
                <c:pt idx="150">
                  <c:v>308.10000000000002</c:v>
                </c:pt>
                <c:pt idx="151">
                  <c:v>422.7</c:v>
                </c:pt>
                <c:pt idx="152">
                  <c:v>49.86</c:v>
                </c:pt>
                <c:pt idx="153">
                  <c:v>20.23</c:v>
                </c:pt>
                <c:pt idx="154">
                  <c:v>7.2839999999999998</c:v>
                </c:pt>
                <c:pt idx="155">
                  <c:v>586.79999999999995</c:v>
                </c:pt>
                <c:pt idx="156">
                  <c:v>136.69999999999999</c:v>
                </c:pt>
                <c:pt idx="157">
                  <c:v>136.80000000000001</c:v>
                </c:pt>
                <c:pt idx="158">
                  <c:v>325.7</c:v>
                </c:pt>
                <c:pt idx="159">
                  <c:v>1187</c:v>
                </c:pt>
                <c:pt idx="160">
                  <c:v>851.6</c:v>
                </c:pt>
                <c:pt idx="161">
                  <c:v>822.7</c:v>
                </c:pt>
                <c:pt idx="162">
                  <c:v>228.6</c:v>
                </c:pt>
                <c:pt idx="163">
                  <c:v>211.3</c:v>
                </c:pt>
                <c:pt idx="164">
                  <c:v>147.6</c:v>
                </c:pt>
                <c:pt idx="165">
                  <c:v>452.6</c:v>
                </c:pt>
                <c:pt idx="166">
                  <c:v>67.180000000000007</c:v>
                </c:pt>
                <c:pt idx="167">
                  <c:v>301.39999999999998</c:v>
                </c:pt>
                <c:pt idx="168">
                  <c:v>556.79999999999995</c:v>
                </c:pt>
                <c:pt idx="169">
                  <c:v>532.9</c:v>
                </c:pt>
                <c:pt idx="170">
                  <c:v>197.3</c:v>
                </c:pt>
                <c:pt idx="171">
                  <c:v>68.77</c:v>
                </c:pt>
                <c:pt idx="172">
                  <c:v>441.3</c:v>
                </c:pt>
                <c:pt idx="173">
                  <c:v>83.69</c:v>
                </c:pt>
                <c:pt idx="174">
                  <c:v>150.1</c:v>
                </c:pt>
                <c:pt idx="175">
                  <c:v>386.5</c:v>
                </c:pt>
                <c:pt idx="176">
                  <c:v>329.1</c:v>
                </c:pt>
                <c:pt idx="177">
                  <c:v>289.39999999999998</c:v>
                </c:pt>
                <c:pt idx="178">
                  <c:v>92.38</c:v>
                </c:pt>
                <c:pt idx="179">
                  <c:v>611.79999999999995</c:v>
                </c:pt>
                <c:pt idx="180">
                  <c:v>1362</c:v>
                </c:pt>
                <c:pt idx="181">
                  <c:v>837.5</c:v>
                </c:pt>
                <c:pt idx="182">
                  <c:v>521.9</c:v>
                </c:pt>
                <c:pt idx="183">
                  <c:v>253.4</c:v>
                </c:pt>
                <c:pt idx="184">
                  <c:v>205.2</c:v>
                </c:pt>
                <c:pt idx="185">
                  <c:v>764</c:v>
                </c:pt>
                <c:pt idx="186">
                  <c:v>1224</c:v>
                </c:pt>
                <c:pt idx="187">
                  <c:v>167.2</c:v>
                </c:pt>
                <c:pt idx="188">
                  <c:v>2.2599999999999998</c:v>
                </c:pt>
                <c:pt idx="189">
                  <c:v>157.1</c:v>
                </c:pt>
                <c:pt idx="190">
                  <c:v>2130</c:v>
                </c:pt>
                <c:pt idx="191">
                  <c:v>199.5</c:v>
                </c:pt>
                <c:pt idx="192">
                  <c:v>16.670000000000002</c:v>
                </c:pt>
                <c:pt idx="193">
                  <c:v>70.53</c:v>
                </c:pt>
                <c:pt idx="194">
                  <c:v>62.32</c:v>
                </c:pt>
                <c:pt idx="195">
                  <c:v>430.8</c:v>
                </c:pt>
                <c:pt idx="196">
                  <c:v>554.29999999999995</c:v>
                </c:pt>
                <c:pt idx="197">
                  <c:v>117.4</c:v>
                </c:pt>
                <c:pt idx="198">
                  <c:v>196.8</c:v>
                </c:pt>
                <c:pt idx="199">
                  <c:v>3068</c:v>
                </c:pt>
                <c:pt idx="200">
                  <c:v>694.7</c:v>
                </c:pt>
                <c:pt idx="201">
                  <c:v>89.58</c:v>
                </c:pt>
                <c:pt idx="202">
                  <c:v>306.7</c:v>
                </c:pt>
                <c:pt idx="203">
                  <c:v>335.2</c:v>
                </c:pt>
                <c:pt idx="204">
                  <c:v>25.09</c:v>
                </c:pt>
                <c:pt idx="205">
                  <c:v>856.7</c:v>
                </c:pt>
                <c:pt idx="206">
                  <c:v>922.9</c:v>
                </c:pt>
                <c:pt idx="207">
                  <c:v>229.2</c:v>
                </c:pt>
                <c:pt idx="208">
                  <c:v>34.450000000000003</c:v>
                </c:pt>
                <c:pt idx="209">
                  <c:v>288.10000000000002</c:v>
                </c:pt>
                <c:pt idx="210">
                  <c:v>22.2</c:v>
                </c:pt>
                <c:pt idx="211">
                  <c:v>11.09</c:v>
                </c:pt>
                <c:pt idx="212">
                  <c:v>65.61</c:v>
                </c:pt>
                <c:pt idx="213">
                  <c:v>429</c:v>
                </c:pt>
                <c:pt idx="214">
                  <c:v>28.59</c:v>
                </c:pt>
                <c:pt idx="215">
                  <c:v>364</c:v>
                </c:pt>
                <c:pt idx="216">
                  <c:v>356.6</c:v>
                </c:pt>
                <c:pt idx="217">
                  <c:v>226.5</c:v>
                </c:pt>
                <c:pt idx="218">
                  <c:v>655.5</c:v>
                </c:pt>
                <c:pt idx="219">
                  <c:v>229.5</c:v>
                </c:pt>
                <c:pt idx="220">
                  <c:v>1513</c:v>
                </c:pt>
                <c:pt idx="221">
                  <c:v>315</c:v>
                </c:pt>
                <c:pt idx="222">
                  <c:v>6.3150000000000004</c:v>
                </c:pt>
                <c:pt idx="223">
                  <c:v>31.69</c:v>
                </c:pt>
                <c:pt idx="224">
                  <c:v>160</c:v>
                </c:pt>
                <c:pt idx="225">
                  <c:v>191.9</c:v>
                </c:pt>
                <c:pt idx="226">
                  <c:v>366</c:v>
                </c:pt>
                <c:pt idx="227">
                  <c:v>473.6</c:v>
                </c:pt>
                <c:pt idx="228">
                  <c:v>1301</c:v>
                </c:pt>
                <c:pt idx="229">
                  <c:v>416.8</c:v>
                </c:pt>
                <c:pt idx="230">
                  <c:v>825</c:v>
                </c:pt>
                <c:pt idx="231">
                  <c:v>456.8</c:v>
                </c:pt>
                <c:pt idx="232">
                  <c:v>1032</c:v>
                </c:pt>
                <c:pt idx="233">
                  <c:v>34.979999999999997</c:v>
                </c:pt>
                <c:pt idx="234">
                  <c:v>41.63</c:v>
                </c:pt>
                <c:pt idx="235">
                  <c:v>16.14</c:v>
                </c:pt>
                <c:pt idx="236">
                  <c:v>4.5270000000000001</c:v>
                </c:pt>
                <c:pt idx="237">
                  <c:v>333</c:v>
                </c:pt>
                <c:pt idx="238">
                  <c:v>741.9</c:v>
                </c:pt>
                <c:pt idx="239">
                  <c:v>361.2</c:v>
                </c:pt>
                <c:pt idx="240">
                  <c:v>754.6</c:v>
                </c:pt>
                <c:pt idx="241">
                  <c:v>1582</c:v>
                </c:pt>
                <c:pt idx="242">
                  <c:v>314.60000000000002</c:v>
                </c:pt>
                <c:pt idx="243">
                  <c:v>333.6</c:v>
                </c:pt>
                <c:pt idx="244">
                  <c:v>237.3</c:v>
                </c:pt>
                <c:pt idx="245">
                  <c:v>374.6</c:v>
                </c:pt>
                <c:pt idx="246">
                  <c:v>11.59</c:v>
                </c:pt>
                <c:pt idx="247">
                  <c:v>308.8</c:v>
                </c:pt>
                <c:pt idx="248">
                  <c:v>512.4</c:v>
                </c:pt>
                <c:pt idx="249">
                  <c:v>20.27</c:v>
                </c:pt>
                <c:pt idx="250">
                  <c:v>3.7240000000000002</c:v>
                </c:pt>
                <c:pt idx="251">
                  <c:v>1391</c:v>
                </c:pt>
                <c:pt idx="252">
                  <c:v>819.1</c:v>
                </c:pt>
                <c:pt idx="253">
                  <c:v>511.4</c:v>
                </c:pt>
                <c:pt idx="254">
                  <c:v>404.7</c:v>
                </c:pt>
                <c:pt idx="255">
                  <c:v>364.2</c:v>
                </c:pt>
                <c:pt idx="256">
                  <c:v>173.6</c:v>
                </c:pt>
                <c:pt idx="257">
                  <c:v>346.4</c:v>
                </c:pt>
                <c:pt idx="258">
                  <c:v>349</c:v>
                </c:pt>
                <c:pt idx="259">
                  <c:v>11.97</c:v>
                </c:pt>
                <c:pt idx="260">
                  <c:v>104.6</c:v>
                </c:pt>
                <c:pt idx="261">
                  <c:v>31.04</c:v>
                </c:pt>
                <c:pt idx="262">
                  <c:v>256.7</c:v>
                </c:pt>
                <c:pt idx="263">
                  <c:v>257</c:v>
                </c:pt>
                <c:pt idx="264">
                  <c:v>220.6</c:v>
                </c:pt>
                <c:pt idx="265">
                  <c:v>283.39999999999998</c:v>
                </c:pt>
                <c:pt idx="266">
                  <c:v>11.45</c:v>
                </c:pt>
                <c:pt idx="267">
                  <c:v>537</c:v>
                </c:pt>
                <c:pt idx="268">
                  <c:v>480.2</c:v>
                </c:pt>
                <c:pt idx="269">
                  <c:v>44.75</c:v>
                </c:pt>
                <c:pt idx="270">
                  <c:v>1691</c:v>
                </c:pt>
                <c:pt idx="271">
                  <c:v>112.9</c:v>
                </c:pt>
                <c:pt idx="272">
                  <c:v>772.1</c:v>
                </c:pt>
                <c:pt idx="273">
                  <c:v>6.7279999999999998</c:v>
                </c:pt>
                <c:pt idx="274">
                  <c:v>267.3</c:v>
                </c:pt>
                <c:pt idx="275">
                  <c:v>223.3</c:v>
                </c:pt>
                <c:pt idx="276">
                  <c:v>106.3</c:v>
                </c:pt>
                <c:pt idx="277">
                  <c:v>40.44</c:v>
                </c:pt>
                <c:pt idx="278">
                  <c:v>833.9</c:v>
                </c:pt>
                <c:pt idx="279">
                  <c:v>52.14</c:v>
                </c:pt>
                <c:pt idx="280">
                  <c:v>169.5</c:v>
                </c:pt>
                <c:pt idx="281">
                  <c:v>1905</c:v>
                </c:pt>
                <c:pt idx="282">
                  <c:v>1016</c:v>
                </c:pt>
                <c:pt idx="283">
                  <c:v>67.69</c:v>
                </c:pt>
                <c:pt idx="284">
                  <c:v>12.48</c:v>
                </c:pt>
                <c:pt idx="285">
                  <c:v>170.3</c:v>
                </c:pt>
                <c:pt idx="286">
                  <c:v>67.430000000000007</c:v>
                </c:pt>
                <c:pt idx="287">
                  <c:v>302.7</c:v>
                </c:pt>
                <c:pt idx="288">
                  <c:v>300.8</c:v>
                </c:pt>
                <c:pt idx="289">
                  <c:v>681.6</c:v>
                </c:pt>
                <c:pt idx="290">
                  <c:v>2.0550000000000002</c:v>
                </c:pt>
                <c:pt idx="291">
                  <c:v>198.6</c:v>
                </c:pt>
                <c:pt idx="292">
                  <c:v>375.1</c:v>
                </c:pt>
                <c:pt idx="293">
                  <c:v>45.88</c:v>
                </c:pt>
                <c:pt idx="294">
                  <c:v>103.2</c:v>
                </c:pt>
                <c:pt idx="295">
                  <c:v>7.8949999999999996</c:v>
                </c:pt>
                <c:pt idx="296">
                  <c:v>38.799999999999997</c:v>
                </c:pt>
                <c:pt idx="297">
                  <c:v>822.5</c:v>
                </c:pt>
                <c:pt idx="298">
                  <c:v>46.65</c:v>
                </c:pt>
                <c:pt idx="299">
                  <c:v>25.32</c:v>
                </c:pt>
                <c:pt idx="300">
                  <c:v>256.8</c:v>
                </c:pt>
                <c:pt idx="301">
                  <c:v>364.9</c:v>
                </c:pt>
                <c:pt idx="302">
                  <c:v>337.6</c:v>
                </c:pt>
                <c:pt idx="303">
                  <c:v>206</c:v>
                </c:pt>
                <c:pt idx="304">
                  <c:v>45.98</c:v>
                </c:pt>
                <c:pt idx="305">
                  <c:v>1730</c:v>
                </c:pt>
                <c:pt idx="306">
                  <c:v>60.15</c:v>
                </c:pt>
                <c:pt idx="307">
                  <c:v>8.0820000000000007</c:v>
                </c:pt>
                <c:pt idx="308">
                  <c:v>1256</c:v>
                </c:pt>
                <c:pt idx="309">
                  <c:v>649.79999999999995</c:v>
                </c:pt>
                <c:pt idx="310">
                  <c:v>96.74</c:v>
                </c:pt>
                <c:pt idx="311">
                  <c:v>96.15</c:v>
                </c:pt>
                <c:pt idx="312">
                  <c:v>6.33</c:v>
                </c:pt>
                <c:pt idx="313">
                  <c:v>160.5</c:v>
                </c:pt>
                <c:pt idx="314">
                  <c:v>134.69999999999999</c:v>
                </c:pt>
                <c:pt idx="315">
                  <c:v>109.3</c:v>
                </c:pt>
                <c:pt idx="316">
                  <c:v>153.80000000000001</c:v>
                </c:pt>
                <c:pt idx="317">
                  <c:v>19.41</c:v>
                </c:pt>
                <c:pt idx="318">
                  <c:v>69.319999999999993</c:v>
                </c:pt>
                <c:pt idx="319">
                  <c:v>309.3</c:v>
                </c:pt>
                <c:pt idx="320">
                  <c:v>436.9</c:v>
                </c:pt>
                <c:pt idx="321">
                  <c:v>38.79</c:v>
                </c:pt>
                <c:pt idx="322">
                  <c:v>192.8</c:v>
                </c:pt>
                <c:pt idx="323">
                  <c:v>427.9</c:v>
                </c:pt>
                <c:pt idx="324">
                  <c:v>453.9</c:v>
                </c:pt>
                <c:pt idx="325">
                  <c:v>137.4</c:v>
                </c:pt>
                <c:pt idx="326">
                  <c:v>166</c:v>
                </c:pt>
                <c:pt idx="327">
                  <c:v>321</c:v>
                </c:pt>
                <c:pt idx="328">
                  <c:v>36.54</c:v>
                </c:pt>
                <c:pt idx="329">
                  <c:v>1435</c:v>
                </c:pt>
                <c:pt idx="330">
                  <c:v>567.6</c:v>
                </c:pt>
                <c:pt idx="331">
                  <c:v>10.46</c:v>
                </c:pt>
                <c:pt idx="332">
                  <c:v>471.7</c:v>
                </c:pt>
                <c:pt idx="333">
                  <c:v>28.45</c:v>
                </c:pt>
                <c:pt idx="334">
                  <c:v>20.21</c:v>
                </c:pt>
                <c:pt idx="335">
                  <c:v>161.19999999999999</c:v>
                </c:pt>
                <c:pt idx="336">
                  <c:v>493.1</c:v>
                </c:pt>
                <c:pt idx="337">
                  <c:v>330.2</c:v>
                </c:pt>
                <c:pt idx="338">
                  <c:v>32.06</c:v>
                </c:pt>
                <c:pt idx="339">
                  <c:v>112.5</c:v>
                </c:pt>
                <c:pt idx="340">
                  <c:v>262.39999999999998</c:v>
                </c:pt>
                <c:pt idx="341">
                  <c:v>5.4029999999999996</c:v>
                </c:pt>
                <c:pt idx="342">
                  <c:v>462.7</c:v>
                </c:pt>
                <c:pt idx="343">
                  <c:v>540.4</c:v>
                </c:pt>
                <c:pt idx="344">
                  <c:v>183</c:v>
                </c:pt>
                <c:pt idx="345">
                  <c:v>145.6</c:v>
                </c:pt>
                <c:pt idx="346">
                  <c:v>237.4</c:v>
                </c:pt>
                <c:pt idx="347">
                  <c:v>20.84</c:v>
                </c:pt>
                <c:pt idx="348">
                  <c:v>38.76</c:v>
                </c:pt>
                <c:pt idx="349">
                  <c:v>4.2839999999999998</c:v>
                </c:pt>
                <c:pt idx="350">
                  <c:v>608.4</c:v>
                </c:pt>
                <c:pt idx="351">
                  <c:v>2432</c:v>
                </c:pt>
                <c:pt idx="352">
                  <c:v>1351</c:v>
                </c:pt>
                <c:pt idx="353">
                  <c:v>4.6710000000000003</c:v>
                </c:pt>
                <c:pt idx="354">
                  <c:v>79.69</c:v>
                </c:pt>
                <c:pt idx="355">
                  <c:v>7.6619999999999999</c:v>
                </c:pt>
                <c:pt idx="356">
                  <c:v>234.3</c:v>
                </c:pt>
                <c:pt idx="357">
                  <c:v>58.04</c:v>
                </c:pt>
                <c:pt idx="358">
                  <c:v>201.3</c:v>
                </c:pt>
                <c:pt idx="359">
                  <c:v>18.87</c:v>
                </c:pt>
                <c:pt idx="360">
                  <c:v>74.37</c:v>
                </c:pt>
                <c:pt idx="361">
                  <c:v>71.73</c:v>
                </c:pt>
                <c:pt idx="362">
                  <c:v>28.98</c:v>
                </c:pt>
                <c:pt idx="363">
                  <c:v>258.10000000000002</c:v>
                </c:pt>
                <c:pt idx="364">
                  <c:v>145.6</c:v>
                </c:pt>
                <c:pt idx="365">
                  <c:v>301.7</c:v>
                </c:pt>
                <c:pt idx="366">
                  <c:v>7.19</c:v>
                </c:pt>
                <c:pt idx="367">
                  <c:v>863.7</c:v>
                </c:pt>
                <c:pt idx="368">
                  <c:v>176.5</c:v>
                </c:pt>
                <c:pt idx="369">
                  <c:v>27.79</c:v>
                </c:pt>
                <c:pt idx="370">
                  <c:v>71.290000000000006</c:v>
                </c:pt>
                <c:pt idx="371">
                  <c:v>318.8</c:v>
                </c:pt>
                <c:pt idx="372">
                  <c:v>303.89999999999998</c:v>
                </c:pt>
                <c:pt idx="373">
                  <c:v>649</c:v>
                </c:pt>
                <c:pt idx="374">
                  <c:v>572.9</c:v>
                </c:pt>
                <c:pt idx="375">
                  <c:v>2528</c:v>
                </c:pt>
                <c:pt idx="376">
                  <c:v>112</c:v>
                </c:pt>
                <c:pt idx="377">
                  <c:v>102.8</c:v>
                </c:pt>
                <c:pt idx="378">
                  <c:v>94.62</c:v>
                </c:pt>
                <c:pt idx="379">
                  <c:v>10.09</c:v>
                </c:pt>
                <c:pt idx="380">
                  <c:v>899</c:v>
                </c:pt>
                <c:pt idx="381">
                  <c:v>67.180000000000007</c:v>
                </c:pt>
                <c:pt idx="382">
                  <c:v>409.8</c:v>
                </c:pt>
                <c:pt idx="383">
                  <c:v>442.6</c:v>
                </c:pt>
                <c:pt idx="384">
                  <c:v>763.4</c:v>
                </c:pt>
                <c:pt idx="385">
                  <c:v>108</c:v>
                </c:pt>
                <c:pt idx="386">
                  <c:v>100.9</c:v>
                </c:pt>
                <c:pt idx="387">
                  <c:v>38.950000000000003</c:v>
                </c:pt>
                <c:pt idx="388">
                  <c:v>336.8</c:v>
                </c:pt>
                <c:pt idx="389">
                  <c:v>104.3</c:v>
                </c:pt>
                <c:pt idx="390">
                  <c:v>174.7</c:v>
                </c:pt>
                <c:pt idx="391">
                  <c:v>4.82</c:v>
                </c:pt>
                <c:pt idx="392">
                  <c:v>280.89999999999998</c:v>
                </c:pt>
                <c:pt idx="393">
                  <c:v>308.7</c:v>
                </c:pt>
                <c:pt idx="394">
                  <c:v>82.92</c:v>
                </c:pt>
                <c:pt idx="395">
                  <c:v>182.4</c:v>
                </c:pt>
                <c:pt idx="396">
                  <c:v>740.6</c:v>
                </c:pt>
                <c:pt idx="397">
                  <c:v>49.74</c:v>
                </c:pt>
                <c:pt idx="398">
                  <c:v>28.03</c:v>
                </c:pt>
                <c:pt idx="399">
                  <c:v>10.02</c:v>
                </c:pt>
                <c:pt idx="400">
                  <c:v>19.79</c:v>
                </c:pt>
                <c:pt idx="401">
                  <c:v>190.2</c:v>
                </c:pt>
                <c:pt idx="402">
                  <c:v>465.3</c:v>
                </c:pt>
                <c:pt idx="403">
                  <c:v>525.29999999999995</c:v>
                </c:pt>
                <c:pt idx="404">
                  <c:v>238.9</c:v>
                </c:pt>
                <c:pt idx="405">
                  <c:v>2158</c:v>
                </c:pt>
                <c:pt idx="406">
                  <c:v>118.6</c:v>
                </c:pt>
                <c:pt idx="407">
                  <c:v>40.159999999999997</c:v>
                </c:pt>
                <c:pt idx="408">
                  <c:v>65.56</c:v>
                </c:pt>
                <c:pt idx="409">
                  <c:v>563.1</c:v>
                </c:pt>
                <c:pt idx="410">
                  <c:v>59.21</c:v>
                </c:pt>
                <c:pt idx="411">
                  <c:v>80.02</c:v>
                </c:pt>
                <c:pt idx="412">
                  <c:v>125.4</c:v>
                </c:pt>
                <c:pt idx="413">
                  <c:v>19.079999999999998</c:v>
                </c:pt>
                <c:pt idx="414">
                  <c:v>17.079999999999998</c:v>
                </c:pt>
                <c:pt idx="415">
                  <c:v>784.7</c:v>
                </c:pt>
                <c:pt idx="416">
                  <c:v>79.959999999999994</c:v>
                </c:pt>
                <c:pt idx="417">
                  <c:v>10.23</c:v>
                </c:pt>
                <c:pt idx="418">
                  <c:v>553.9</c:v>
                </c:pt>
                <c:pt idx="419">
                  <c:v>22.6</c:v>
                </c:pt>
                <c:pt idx="420">
                  <c:v>1179</c:v>
                </c:pt>
                <c:pt idx="421">
                  <c:v>261.39999999999998</c:v>
                </c:pt>
                <c:pt idx="422">
                  <c:v>16.28</c:v>
                </c:pt>
                <c:pt idx="423">
                  <c:v>68.02</c:v>
                </c:pt>
                <c:pt idx="424">
                  <c:v>1010</c:v>
                </c:pt>
                <c:pt idx="425">
                  <c:v>6.8819999999999997</c:v>
                </c:pt>
                <c:pt idx="426">
                  <c:v>27.4</c:v>
                </c:pt>
                <c:pt idx="427">
                  <c:v>153.80000000000001</c:v>
                </c:pt>
                <c:pt idx="428">
                  <c:v>44.43</c:v>
                </c:pt>
                <c:pt idx="429">
                  <c:v>125.5</c:v>
                </c:pt>
                <c:pt idx="430">
                  <c:v>189.4</c:v>
                </c:pt>
                <c:pt idx="431">
                  <c:v>64.31</c:v>
                </c:pt>
                <c:pt idx="432">
                  <c:v>321.89999999999998</c:v>
                </c:pt>
                <c:pt idx="433">
                  <c:v>8.657</c:v>
                </c:pt>
                <c:pt idx="434">
                  <c:v>3.7490000000000001</c:v>
                </c:pt>
                <c:pt idx="435">
                  <c:v>349.3</c:v>
                </c:pt>
                <c:pt idx="436">
                  <c:v>308.3</c:v>
                </c:pt>
                <c:pt idx="437">
                  <c:v>643.79999999999995</c:v>
                </c:pt>
                <c:pt idx="438">
                  <c:v>98.77</c:v>
                </c:pt>
                <c:pt idx="439">
                  <c:v>70.91</c:v>
                </c:pt>
                <c:pt idx="440">
                  <c:v>203.3</c:v>
                </c:pt>
                <c:pt idx="441">
                  <c:v>49.4</c:v>
                </c:pt>
              </c:numCache>
            </c:numRef>
          </c:yVal>
          <c:smooth val="0"/>
          <c:extLst xmlns:c16r2="http://schemas.microsoft.com/office/drawing/2015/06/chart">
            <c:ext xmlns:c16="http://schemas.microsoft.com/office/drawing/2014/chart" uri="{C3380CC4-5D6E-409C-BE32-E72D297353CC}">
              <c16:uniqueId val="{00000000-C22A-485D-A552-D6AB2CDB6CC2}"/>
            </c:ext>
          </c:extLst>
        </c:ser>
        <c:dLbls>
          <c:showLegendKey val="0"/>
          <c:showVal val="0"/>
          <c:showCatName val="0"/>
          <c:showSerName val="0"/>
          <c:showPercent val="0"/>
          <c:showBubbleSize val="0"/>
        </c:dLbls>
        <c:axId val="-1419048512"/>
        <c:axId val="-1419060480"/>
      </c:scatterChart>
      <c:valAx>
        <c:axId val="-1419048512"/>
        <c:scaling>
          <c:orientation val="minMax"/>
        </c:scaling>
        <c:delete val="0"/>
        <c:axPos val="b"/>
        <c:title>
          <c:tx>
            <c:rich>
              <a:bodyPr rot="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a:t>SAT LEP (tpm)</a:t>
                </a:r>
                <a:endParaRPr lang="ko-KR"/>
              </a:p>
            </c:rich>
          </c:tx>
          <c:layout>
            <c:manualLayout>
              <c:xMode val="edge"/>
              <c:yMode val="edge"/>
              <c:x val="0.43389222222222223"/>
              <c:y val="0.89244652777777778"/>
            </c:manualLayout>
          </c:layout>
          <c:overlay val="0"/>
          <c:spPr>
            <a:noFill/>
            <a:ln>
              <a:noFill/>
            </a:ln>
            <a:effectLst/>
          </c:spPr>
          <c:txPr>
            <a:bodyPr rot="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1419060480"/>
        <c:crosses val="autoZero"/>
        <c:crossBetween val="midCat"/>
      </c:valAx>
      <c:valAx>
        <c:axId val="-1419060480"/>
        <c:scaling>
          <c:orientation val="minMax"/>
        </c:scaling>
        <c:delete val="0"/>
        <c:axPos val="l"/>
        <c:title>
          <c:tx>
            <c:rich>
              <a:bodyPr rot="-54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dirty="0"/>
                  <a:t>SAT GYG2 </a:t>
                </a:r>
                <a:r>
                  <a:rPr lang="en-US" dirty="0" smtClean="0"/>
                  <a:t>(</a:t>
                </a:r>
                <a:r>
                  <a:rPr lang="en-US" altLang="ko-KR" dirty="0" smtClean="0"/>
                  <a:t>TPM</a:t>
                </a:r>
                <a:r>
                  <a:rPr lang="en-US" dirty="0" smtClean="0"/>
                  <a:t>)</a:t>
                </a:r>
                <a:endParaRPr lang="ko-KR" dirty="0"/>
              </a:p>
            </c:rich>
          </c:tx>
          <c:layout>
            <c:manualLayout>
              <c:xMode val="edge"/>
              <c:yMode val="edge"/>
              <c:x val="8.0272222222222238E-3"/>
              <c:y val="0.13662430555555555"/>
            </c:manualLayout>
          </c:layout>
          <c:overlay val="0"/>
          <c:spPr>
            <a:noFill/>
            <a:ln>
              <a:noFill/>
            </a:ln>
            <a:effectLst/>
          </c:spPr>
          <c:txPr>
            <a:bodyPr rot="-54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1419048512"/>
        <c:crosses val="autoZero"/>
        <c:crossBetween val="midCat"/>
      </c:valAx>
      <c:spPr>
        <a:noFill/>
        <a:ln>
          <a:noFill/>
        </a:ln>
        <a:effectLst/>
      </c:spPr>
    </c:plotArea>
    <c:plotVisOnly val="1"/>
    <c:dispBlanksAs val="gap"/>
    <c:showDLblsOverMax val="0"/>
  </c:chart>
  <c:spPr>
    <a:noFill/>
    <a:ln>
      <a:noFill/>
    </a:ln>
    <a:effectLst/>
  </c:spPr>
  <c:txPr>
    <a:bodyPr/>
    <a:lstStyle/>
    <a:p>
      <a:pPr>
        <a:defRPr sz="800">
          <a:latin typeface="Arial" panose="020B0604020202020204" pitchFamily="34" charset="0"/>
          <a:cs typeface="Arial" panose="020B0604020202020204" pitchFamily="34" charset="0"/>
        </a:defRPr>
      </a:pPr>
      <a:endParaRPr lang="en-U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5756833333333334"/>
          <c:y val="4.7823611111111122E-2"/>
          <c:w val="0.63730388888888889"/>
          <c:h val="0.7205631944444445"/>
        </c:manualLayout>
      </c:layout>
      <c:scatterChart>
        <c:scatterStyle val="lineMarker"/>
        <c:varyColors val="0"/>
        <c:ser>
          <c:idx val="0"/>
          <c:order val="0"/>
          <c:spPr>
            <a:ln w="25400" cap="rnd">
              <a:noFill/>
              <a:round/>
            </a:ln>
            <a:effectLst/>
          </c:spPr>
          <c:marker>
            <c:symbol val="circle"/>
            <c:size val="2"/>
            <c:spPr>
              <a:solidFill>
                <a:schemeClr val="tx1"/>
              </a:solidFill>
              <a:ln w="9525">
                <a:noFill/>
              </a:ln>
              <a:effectLst/>
            </c:spPr>
          </c:marker>
          <c:trendline>
            <c:spPr>
              <a:ln w="19050" cap="rnd">
                <a:solidFill>
                  <a:schemeClr val="accent1"/>
                </a:solidFill>
                <a:prstDash val="sysDot"/>
              </a:ln>
              <a:effectLst/>
            </c:spPr>
            <c:trendlineType val="linear"/>
            <c:dispRSqr val="0"/>
            <c:dispEq val="0"/>
          </c:trendline>
          <c:trendline>
            <c:spPr>
              <a:ln w="19050" cap="rnd">
                <a:solidFill>
                  <a:schemeClr val="tx1"/>
                </a:solidFill>
                <a:prstDash val="solid"/>
              </a:ln>
              <a:effectLst/>
            </c:spPr>
            <c:trendlineType val="linear"/>
            <c:dispRSqr val="0"/>
            <c:dispEq val="0"/>
          </c:trendline>
          <c:xVal>
            <c:numRef>
              <c:f>sub!$L$8:$L$449</c:f>
              <c:numCache>
                <c:formatCode>General</c:formatCode>
                <c:ptCount val="442"/>
                <c:pt idx="0">
                  <c:v>375.1</c:v>
                </c:pt>
                <c:pt idx="1">
                  <c:v>261.60000000000002</c:v>
                </c:pt>
                <c:pt idx="2">
                  <c:v>450.3</c:v>
                </c:pt>
                <c:pt idx="3">
                  <c:v>74.84</c:v>
                </c:pt>
                <c:pt idx="4">
                  <c:v>138.9</c:v>
                </c:pt>
                <c:pt idx="5">
                  <c:v>232.8</c:v>
                </c:pt>
                <c:pt idx="6">
                  <c:v>190.5</c:v>
                </c:pt>
                <c:pt idx="7">
                  <c:v>443.6</c:v>
                </c:pt>
                <c:pt idx="8">
                  <c:v>335.7</c:v>
                </c:pt>
                <c:pt idx="9">
                  <c:v>240.4</c:v>
                </c:pt>
                <c:pt idx="10">
                  <c:v>198.2</c:v>
                </c:pt>
                <c:pt idx="11">
                  <c:v>449.6</c:v>
                </c:pt>
                <c:pt idx="12">
                  <c:v>252.4</c:v>
                </c:pt>
                <c:pt idx="13">
                  <c:v>133.69999999999999</c:v>
                </c:pt>
                <c:pt idx="14">
                  <c:v>164.8</c:v>
                </c:pt>
                <c:pt idx="15">
                  <c:v>352.2</c:v>
                </c:pt>
                <c:pt idx="16">
                  <c:v>387.5</c:v>
                </c:pt>
                <c:pt idx="17">
                  <c:v>282.60000000000002</c:v>
                </c:pt>
                <c:pt idx="18">
                  <c:v>271.8</c:v>
                </c:pt>
                <c:pt idx="19">
                  <c:v>24.36</c:v>
                </c:pt>
                <c:pt idx="20">
                  <c:v>310.7</c:v>
                </c:pt>
                <c:pt idx="21">
                  <c:v>258.5</c:v>
                </c:pt>
                <c:pt idx="22">
                  <c:v>69.680000000000007</c:v>
                </c:pt>
                <c:pt idx="23">
                  <c:v>461.9</c:v>
                </c:pt>
                <c:pt idx="24">
                  <c:v>419.8</c:v>
                </c:pt>
                <c:pt idx="25">
                  <c:v>406.9</c:v>
                </c:pt>
                <c:pt idx="26">
                  <c:v>179.6</c:v>
                </c:pt>
                <c:pt idx="27">
                  <c:v>182.3</c:v>
                </c:pt>
                <c:pt idx="28">
                  <c:v>268.8</c:v>
                </c:pt>
                <c:pt idx="29">
                  <c:v>140.69999999999999</c:v>
                </c:pt>
                <c:pt idx="30">
                  <c:v>224</c:v>
                </c:pt>
                <c:pt idx="31">
                  <c:v>484.7</c:v>
                </c:pt>
                <c:pt idx="32">
                  <c:v>27.98</c:v>
                </c:pt>
                <c:pt idx="33">
                  <c:v>2.2650000000000001</c:v>
                </c:pt>
                <c:pt idx="34">
                  <c:v>123.4</c:v>
                </c:pt>
                <c:pt idx="35">
                  <c:v>346</c:v>
                </c:pt>
                <c:pt idx="36">
                  <c:v>311.8</c:v>
                </c:pt>
                <c:pt idx="37">
                  <c:v>218</c:v>
                </c:pt>
                <c:pt idx="38">
                  <c:v>289.89999999999998</c:v>
                </c:pt>
                <c:pt idx="39">
                  <c:v>101.4</c:v>
                </c:pt>
                <c:pt idx="40">
                  <c:v>281.2</c:v>
                </c:pt>
                <c:pt idx="41">
                  <c:v>157.6</c:v>
                </c:pt>
                <c:pt idx="42">
                  <c:v>121.8</c:v>
                </c:pt>
                <c:pt idx="43">
                  <c:v>92.38</c:v>
                </c:pt>
                <c:pt idx="44">
                  <c:v>315.89999999999998</c:v>
                </c:pt>
                <c:pt idx="45">
                  <c:v>259.10000000000002</c:v>
                </c:pt>
                <c:pt idx="46">
                  <c:v>354.9</c:v>
                </c:pt>
                <c:pt idx="47">
                  <c:v>399.9</c:v>
                </c:pt>
                <c:pt idx="48">
                  <c:v>90.75</c:v>
                </c:pt>
                <c:pt idx="49">
                  <c:v>293.2</c:v>
                </c:pt>
                <c:pt idx="50">
                  <c:v>94.35</c:v>
                </c:pt>
                <c:pt idx="51">
                  <c:v>40.29</c:v>
                </c:pt>
                <c:pt idx="52">
                  <c:v>284.39999999999998</c:v>
                </c:pt>
                <c:pt idx="53">
                  <c:v>66.95</c:v>
                </c:pt>
                <c:pt idx="54">
                  <c:v>216.3</c:v>
                </c:pt>
                <c:pt idx="55">
                  <c:v>147.30000000000001</c:v>
                </c:pt>
                <c:pt idx="56">
                  <c:v>166.6</c:v>
                </c:pt>
                <c:pt idx="57">
                  <c:v>62.4</c:v>
                </c:pt>
                <c:pt idx="58">
                  <c:v>138</c:v>
                </c:pt>
                <c:pt idx="59">
                  <c:v>331.2</c:v>
                </c:pt>
                <c:pt idx="60">
                  <c:v>283.8</c:v>
                </c:pt>
                <c:pt idx="61">
                  <c:v>25.63</c:v>
                </c:pt>
                <c:pt idx="62">
                  <c:v>28.19</c:v>
                </c:pt>
                <c:pt idx="63">
                  <c:v>68.87</c:v>
                </c:pt>
                <c:pt idx="64">
                  <c:v>212.6</c:v>
                </c:pt>
                <c:pt idx="65">
                  <c:v>132</c:v>
                </c:pt>
                <c:pt idx="66">
                  <c:v>116.5</c:v>
                </c:pt>
                <c:pt idx="67">
                  <c:v>28.19</c:v>
                </c:pt>
                <c:pt idx="68">
                  <c:v>122.8</c:v>
                </c:pt>
                <c:pt idx="69">
                  <c:v>99.61</c:v>
                </c:pt>
                <c:pt idx="70">
                  <c:v>116.1</c:v>
                </c:pt>
                <c:pt idx="71">
                  <c:v>101.6</c:v>
                </c:pt>
                <c:pt idx="72">
                  <c:v>143.5</c:v>
                </c:pt>
                <c:pt idx="73">
                  <c:v>746.4</c:v>
                </c:pt>
                <c:pt idx="74">
                  <c:v>40.700000000000003</c:v>
                </c:pt>
                <c:pt idx="75">
                  <c:v>220.5</c:v>
                </c:pt>
                <c:pt idx="76">
                  <c:v>54.15</c:v>
                </c:pt>
                <c:pt idx="77">
                  <c:v>119.1</c:v>
                </c:pt>
                <c:pt idx="78">
                  <c:v>344.6</c:v>
                </c:pt>
                <c:pt idx="79">
                  <c:v>24.05</c:v>
                </c:pt>
                <c:pt idx="80">
                  <c:v>359.2</c:v>
                </c:pt>
                <c:pt idx="81">
                  <c:v>141.5</c:v>
                </c:pt>
                <c:pt idx="82">
                  <c:v>73.650000000000006</c:v>
                </c:pt>
                <c:pt idx="83">
                  <c:v>131.6</c:v>
                </c:pt>
                <c:pt idx="84">
                  <c:v>95.2</c:v>
                </c:pt>
                <c:pt idx="85">
                  <c:v>82.22</c:v>
                </c:pt>
                <c:pt idx="86">
                  <c:v>265.60000000000002</c:v>
                </c:pt>
                <c:pt idx="87">
                  <c:v>80.5</c:v>
                </c:pt>
                <c:pt idx="88">
                  <c:v>293.8</c:v>
                </c:pt>
                <c:pt idx="89">
                  <c:v>131.6</c:v>
                </c:pt>
                <c:pt idx="90">
                  <c:v>57.79</c:v>
                </c:pt>
                <c:pt idx="91">
                  <c:v>92.21</c:v>
                </c:pt>
                <c:pt idx="92">
                  <c:v>192.8</c:v>
                </c:pt>
                <c:pt idx="93">
                  <c:v>17.37</c:v>
                </c:pt>
                <c:pt idx="94">
                  <c:v>83.37</c:v>
                </c:pt>
                <c:pt idx="95">
                  <c:v>285</c:v>
                </c:pt>
                <c:pt idx="96">
                  <c:v>172.8</c:v>
                </c:pt>
                <c:pt idx="97">
                  <c:v>92.63</c:v>
                </c:pt>
                <c:pt idx="98">
                  <c:v>306.5</c:v>
                </c:pt>
                <c:pt idx="99">
                  <c:v>62.61</c:v>
                </c:pt>
                <c:pt idx="100">
                  <c:v>91.85</c:v>
                </c:pt>
                <c:pt idx="101">
                  <c:v>201</c:v>
                </c:pt>
                <c:pt idx="102">
                  <c:v>220.9</c:v>
                </c:pt>
                <c:pt idx="103">
                  <c:v>314.3</c:v>
                </c:pt>
                <c:pt idx="104">
                  <c:v>52.24</c:v>
                </c:pt>
                <c:pt idx="105">
                  <c:v>10.47</c:v>
                </c:pt>
                <c:pt idx="106">
                  <c:v>275.2</c:v>
                </c:pt>
                <c:pt idx="107">
                  <c:v>84.65</c:v>
                </c:pt>
                <c:pt idx="108">
                  <c:v>27.13</c:v>
                </c:pt>
                <c:pt idx="109">
                  <c:v>33.04</c:v>
                </c:pt>
                <c:pt idx="110">
                  <c:v>69.44</c:v>
                </c:pt>
                <c:pt idx="111">
                  <c:v>243</c:v>
                </c:pt>
                <c:pt idx="112">
                  <c:v>161.4</c:v>
                </c:pt>
                <c:pt idx="113">
                  <c:v>248.5</c:v>
                </c:pt>
                <c:pt idx="114">
                  <c:v>109</c:v>
                </c:pt>
                <c:pt idx="115">
                  <c:v>163.19999999999999</c:v>
                </c:pt>
                <c:pt idx="116">
                  <c:v>12.97</c:v>
                </c:pt>
                <c:pt idx="117">
                  <c:v>152.9</c:v>
                </c:pt>
                <c:pt idx="118">
                  <c:v>323.8</c:v>
                </c:pt>
                <c:pt idx="119">
                  <c:v>87.46</c:v>
                </c:pt>
                <c:pt idx="120">
                  <c:v>73.239999999999995</c:v>
                </c:pt>
                <c:pt idx="121">
                  <c:v>313.60000000000002</c:v>
                </c:pt>
                <c:pt idx="122">
                  <c:v>105.4</c:v>
                </c:pt>
                <c:pt idx="123">
                  <c:v>212.4</c:v>
                </c:pt>
                <c:pt idx="124">
                  <c:v>193.6</c:v>
                </c:pt>
                <c:pt idx="125">
                  <c:v>316.7</c:v>
                </c:pt>
                <c:pt idx="126">
                  <c:v>47.14</c:v>
                </c:pt>
                <c:pt idx="127">
                  <c:v>489</c:v>
                </c:pt>
                <c:pt idx="128">
                  <c:v>38.26</c:v>
                </c:pt>
                <c:pt idx="129">
                  <c:v>351.5</c:v>
                </c:pt>
                <c:pt idx="130">
                  <c:v>331.3</c:v>
                </c:pt>
                <c:pt idx="131">
                  <c:v>157.30000000000001</c:v>
                </c:pt>
                <c:pt idx="132">
                  <c:v>24.42</c:v>
                </c:pt>
                <c:pt idx="133">
                  <c:v>71.3</c:v>
                </c:pt>
                <c:pt idx="134">
                  <c:v>78.45</c:v>
                </c:pt>
                <c:pt idx="135">
                  <c:v>24.01</c:v>
                </c:pt>
                <c:pt idx="136">
                  <c:v>226.8</c:v>
                </c:pt>
                <c:pt idx="137">
                  <c:v>174.8</c:v>
                </c:pt>
                <c:pt idx="138">
                  <c:v>158.1</c:v>
                </c:pt>
                <c:pt idx="139">
                  <c:v>86.66</c:v>
                </c:pt>
                <c:pt idx="140">
                  <c:v>93.83</c:v>
                </c:pt>
                <c:pt idx="141">
                  <c:v>389.5</c:v>
                </c:pt>
                <c:pt idx="142">
                  <c:v>155.4</c:v>
                </c:pt>
                <c:pt idx="143">
                  <c:v>180.5</c:v>
                </c:pt>
                <c:pt idx="144">
                  <c:v>165.1</c:v>
                </c:pt>
                <c:pt idx="145">
                  <c:v>17.399999999999999</c:v>
                </c:pt>
                <c:pt idx="146">
                  <c:v>200.1</c:v>
                </c:pt>
                <c:pt idx="147">
                  <c:v>20.46</c:v>
                </c:pt>
                <c:pt idx="148">
                  <c:v>77.349999999999994</c:v>
                </c:pt>
                <c:pt idx="149">
                  <c:v>231.9</c:v>
                </c:pt>
                <c:pt idx="150">
                  <c:v>113.8</c:v>
                </c:pt>
                <c:pt idx="151">
                  <c:v>118.4</c:v>
                </c:pt>
                <c:pt idx="152">
                  <c:v>46.97</c:v>
                </c:pt>
                <c:pt idx="153">
                  <c:v>19.3</c:v>
                </c:pt>
                <c:pt idx="154">
                  <c:v>5.6639999999999997</c:v>
                </c:pt>
                <c:pt idx="155">
                  <c:v>179.7</c:v>
                </c:pt>
                <c:pt idx="156">
                  <c:v>82.98</c:v>
                </c:pt>
                <c:pt idx="157">
                  <c:v>169.6</c:v>
                </c:pt>
                <c:pt idx="158">
                  <c:v>207</c:v>
                </c:pt>
                <c:pt idx="159">
                  <c:v>162.5</c:v>
                </c:pt>
                <c:pt idx="160">
                  <c:v>191.9</c:v>
                </c:pt>
                <c:pt idx="161">
                  <c:v>14.71</c:v>
                </c:pt>
                <c:pt idx="162">
                  <c:v>159.1</c:v>
                </c:pt>
                <c:pt idx="163">
                  <c:v>100.4</c:v>
                </c:pt>
                <c:pt idx="164">
                  <c:v>145.19999999999999</c:v>
                </c:pt>
                <c:pt idx="165">
                  <c:v>95.45</c:v>
                </c:pt>
                <c:pt idx="166">
                  <c:v>61.36</c:v>
                </c:pt>
                <c:pt idx="167">
                  <c:v>125.6</c:v>
                </c:pt>
                <c:pt idx="168">
                  <c:v>29.29</c:v>
                </c:pt>
                <c:pt idx="169">
                  <c:v>132.80000000000001</c:v>
                </c:pt>
                <c:pt idx="170">
                  <c:v>140.80000000000001</c:v>
                </c:pt>
                <c:pt idx="171">
                  <c:v>59.53</c:v>
                </c:pt>
                <c:pt idx="172">
                  <c:v>24.76</c:v>
                </c:pt>
                <c:pt idx="173">
                  <c:v>40.299999999999997</c:v>
                </c:pt>
                <c:pt idx="174">
                  <c:v>84.54</c:v>
                </c:pt>
                <c:pt idx="175">
                  <c:v>185.2</c:v>
                </c:pt>
                <c:pt idx="176">
                  <c:v>124.2</c:v>
                </c:pt>
                <c:pt idx="177">
                  <c:v>59.14</c:v>
                </c:pt>
                <c:pt idx="178">
                  <c:v>78.819999999999993</c:v>
                </c:pt>
                <c:pt idx="179">
                  <c:v>40</c:v>
                </c:pt>
                <c:pt idx="180">
                  <c:v>89.49</c:v>
                </c:pt>
                <c:pt idx="181">
                  <c:v>123.2</c:v>
                </c:pt>
                <c:pt idx="182">
                  <c:v>121.5</c:v>
                </c:pt>
                <c:pt idx="183">
                  <c:v>129.69999999999999</c:v>
                </c:pt>
                <c:pt idx="184">
                  <c:v>110.5</c:v>
                </c:pt>
                <c:pt idx="185">
                  <c:v>115</c:v>
                </c:pt>
                <c:pt idx="186">
                  <c:v>168.6</c:v>
                </c:pt>
                <c:pt idx="187">
                  <c:v>82.08</c:v>
                </c:pt>
                <c:pt idx="188">
                  <c:v>5.5439999999999996</c:v>
                </c:pt>
                <c:pt idx="189">
                  <c:v>138.9</c:v>
                </c:pt>
                <c:pt idx="190">
                  <c:v>154.1</c:v>
                </c:pt>
                <c:pt idx="191">
                  <c:v>88.47</c:v>
                </c:pt>
                <c:pt idx="192">
                  <c:v>126</c:v>
                </c:pt>
                <c:pt idx="193">
                  <c:v>32.15</c:v>
                </c:pt>
                <c:pt idx="194">
                  <c:v>49.91</c:v>
                </c:pt>
                <c:pt idx="195">
                  <c:v>84.29</c:v>
                </c:pt>
                <c:pt idx="196">
                  <c:v>60.57</c:v>
                </c:pt>
                <c:pt idx="197">
                  <c:v>46.08</c:v>
                </c:pt>
                <c:pt idx="198">
                  <c:v>134.69999999999999</c:v>
                </c:pt>
                <c:pt idx="199">
                  <c:v>217.6</c:v>
                </c:pt>
                <c:pt idx="200">
                  <c:v>88.16</c:v>
                </c:pt>
                <c:pt idx="201">
                  <c:v>59.94</c:v>
                </c:pt>
                <c:pt idx="202">
                  <c:v>113.3</c:v>
                </c:pt>
                <c:pt idx="203">
                  <c:v>179.9</c:v>
                </c:pt>
                <c:pt idx="204">
                  <c:v>53.3</c:v>
                </c:pt>
                <c:pt idx="205">
                  <c:v>75.010000000000005</c:v>
                </c:pt>
                <c:pt idx="206">
                  <c:v>71.87</c:v>
                </c:pt>
                <c:pt idx="207">
                  <c:v>33.71</c:v>
                </c:pt>
                <c:pt idx="208">
                  <c:v>41.84</c:v>
                </c:pt>
                <c:pt idx="209">
                  <c:v>96.47</c:v>
                </c:pt>
                <c:pt idx="210">
                  <c:v>36.57</c:v>
                </c:pt>
                <c:pt idx="211">
                  <c:v>47.95</c:v>
                </c:pt>
                <c:pt idx="212">
                  <c:v>125.8</c:v>
                </c:pt>
                <c:pt idx="213">
                  <c:v>64.239999999999995</c:v>
                </c:pt>
                <c:pt idx="214">
                  <c:v>229.2</c:v>
                </c:pt>
                <c:pt idx="215">
                  <c:v>83.71</c:v>
                </c:pt>
                <c:pt idx="216">
                  <c:v>100.5</c:v>
                </c:pt>
                <c:pt idx="217">
                  <c:v>50.39</c:v>
                </c:pt>
                <c:pt idx="218">
                  <c:v>97.55</c:v>
                </c:pt>
                <c:pt idx="219">
                  <c:v>164.9</c:v>
                </c:pt>
                <c:pt idx="220">
                  <c:v>57.66</c:v>
                </c:pt>
                <c:pt idx="221">
                  <c:v>110.3</c:v>
                </c:pt>
                <c:pt idx="222">
                  <c:v>11.53</c:v>
                </c:pt>
                <c:pt idx="223">
                  <c:v>38.840000000000003</c:v>
                </c:pt>
                <c:pt idx="224">
                  <c:v>83.95</c:v>
                </c:pt>
                <c:pt idx="225">
                  <c:v>73.13</c:v>
                </c:pt>
                <c:pt idx="226">
                  <c:v>48.1</c:v>
                </c:pt>
                <c:pt idx="227">
                  <c:v>125</c:v>
                </c:pt>
                <c:pt idx="228">
                  <c:v>102.3</c:v>
                </c:pt>
                <c:pt idx="229">
                  <c:v>186.7</c:v>
                </c:pt>
                <c:pt idx="230">
                  <c:v>102.1</c:v>
                </c:pt>
                <c:pt idx="231">
                  <c:v>39.090000000000003</c:v>
                </c:pt>
                <c:pt idx="232">
                  <c:v>129.30000000000001</c:v>
                </c:pt>
                <c:pt idx="233">
                  <c:v>18.100000000000001</c:v>
                </c:pt>
                <c:pt idx="234">
                  <c:v>42.16</c:v>
                </c:pt>
                <c:pt idx="235">
                  <c:v>26.07</c:v>
                </c:pt>
                <c:pt idx="236">
                  <c:v>16.64</c:v>
                </c:pt>
                <c:pt idx="237">
                  <c:v>76.48</c:v>
                </c:pt>
                <c:pt idx="238">
                  <c:v>145.69999999999999</c:v>
                </c:pt>
                <c:pt idx="239">
                  <c:v>108.7</c:v>
                </c:pt>
                <c:pt idx="240">
                  <c:v>56.56</c:v>
                </c:pt>
                <c:pt idx="241">
                  <c:v>151.5</c:v>
                </c:pt>
                <c:pt idx="242">
                  <c:v>148.6</c:v>
                </c:pt>
                <c:pt idx="243">
                  <c:v>71.790000000000006</c:v>
                </c:pt>
                <c:pt idx="244">
                  <c:v>277.8</c:v>
                </c:pt>
                <c:pt idx="245">
                  <c:v>38.61</c:v>
                </c:pt>
                <c:pt idx="246">
                  <c:v>71.75</c:v>
                </c:pt>
                <c:pt idx="247">
                  <c:v>169.9</c:v>
                </c:pt>
                <c:pt idx="248">
                  <c:v>140.30000000000001</c:v>
                </c:pt>
                <c:pt idx="249">
                  <c:v>8.218</c:v>
                </c:pt>
                <c:pt idx="250">
                  <c:v>13.75</c:v>
                </c:pt>
                <c:pt idx="251">
                  <c:v>124.9</c:v>
                </c:pt>
                <c:pt idx="252">
                  <c:v>221.7</c:v>
                </c:pt>
                <c:pt idx="253">
                  <c:v>88.01</c:v>
                </c:pt>
                <c:pt idx="254">
                  <c:v>67.52</c:v>
                </c:pt>
                <c:pt idx="255">
                  <c:v>91.08</c:v>
                </c:pt>
                <c:pt idx="256">
                  <c:v>40.9</c:v>
                </c:pt>
                <c:pt idx="257">
                  <c:v>138</c:v>
                </c:pt>
                <c:pt idx="258">
                  <c:v>151.80000000000001</c:v>
                </c:pt>
                <c:pt idx="259">
                  <c:v>13.65</c:v>
                </c:pt>
                <c:pt idx="260">
                  <c:v>9.3780000000000001</c:v>
                </c:pt>
                <c:pt idx="261">
                  <c:v>13.97</c:v>
                </c:pt>
                <c:pt idx="262">
                  <c:v>60.96</c:v>
                </c:pt>
                <c:pt idx="263">
                  <c:v>58.08</c:v>
                </c:pt>
                <c:pt idx="264">
                  <c:v>175.3</c:v>
                </c:pt>
                <c:pt idx="265">
                  <c:v>269.60000000000002</c:v>
                </c:pt>
                <c:pt idx="266">
                  <c:v>20.04</c:v>
                </c:pt>
                <c:pt idx="267">
                  <c:v>109.4</c:v>
                </c:pt>
                <c:pt idx="268">
                  <c:v>73.11</c:v>
                </c:pt>
                <c:pt idx="269">
                  <c:v>29.61</c:v>
                </c:pt>
                <c:pt idx="270">
                  <c:v>45.84</c:v>
                </c:pt>
                <c:pt idx="271">
                  <c:v>71.03</c:v>
                </c:pt>
                <c:pt idx="272">
                  <c:v>70.98</c:v>
                </c:pt>
                <c:pt idx="273">
                  <c:v>80.64</c:v>
                </c:pt>
                <c:pt idx="274">
                  <c:v>68.849999999999994</c:v>
                </c:pt>
                <c:pt idx="275">
                  <c:v>37.61</c:v>
                </c:pt>
                <c:pt idx="276">
                  <c:v>101.8</c:v>
                </c:pt>
                <c:pt idx="277">
                  <c:v>14.72</c:v>
                </c:pt>
                <c:pt idx="278">
                  <c:v>256</c:v>
                </c:pt>
                <c:pt idx="279">
                  <c:v>41.65</c:v>
                </c:pt>
                <c:pt idx="280">
                  <c:v>73.28</c:v>
                </c:pt>
                <c:pt idx="281">
                  <c:v>112.4</c:v>
                </c:pt>
                <c:pt idx="282">
                  <c:v>92.12</c:v>
                </c:pt>
                <c:pt idx="283">
                  <c:v>25.82</c:v>
                </c:pt>
                <c:pt idx="284">
                  <c:v>6.819</c:v>
                </c:pt>
                <c:pt idx="285">
                  <c:v>89.64</c:v>
                </c:pt>
                <c:pt idx="286">
                  <c:v>9.9260000000000002</c:v>
                </c:pt>
                <c:pt idx="287">
                  <c:v>38.65</c:v>
                </c:pt>
                <c:pt idx="288">
                  <c:v>115.3</c:v>
                </c:pt>
                <c:pt idx="289">
                  <c:v>138.19999999999999</c:v>
                </c:pt>
                <c:pt idx="290">
                  <c:v>4.9400000000000004</c:v>
                </c:pt>
                <c:pt idx="291">
                  <c:v>78.5</c:v>
                </c:pt>
                <c:pt idx="292">
                  <c:v>61.59</c:v>
                </c:pt>
                <c:pt idx="293">
                  <c:v>156</c:v>
                </c:pt>
                <c:pt idx="294">
                  <c:v>17.68</c:v>
                </c:pt>
                <c:pt idx="295">
                  <c:v>43.98</c:v>
                </c:pt>
                <c:pt idx="296">
                  <c:v>33.89</c:v>
                </c:pt>
                <c:pt idx="297">
                  <c:v>86.87</c:v>
                </c:pt>
                <c:pt idx="298">
                  <c:v>36</c:v>
                </c:pt>
                <c:pt idx="299">
                  <c:v>16.739999999999998</c:v>
                </c:pt>
                <c:pt idx="300">
                  <c:v>56.62</c:v>
                </c:pt>
                <c:pt idx="301">
                  <c:v>102.8</c:v>
                </c:pt>
                <c:pt idx="302">
                  <c:v>84.64</c:v>
                </c:pt>
                <c:pt idx="303">
                  <c:v>88.07</c:v>
                </c:pt>
                <c:pt idx="304">
                  <c:v>56.65</c:v>
                </c:pt>
                <c:pt idx="305">
                  <c:v>150</c:v>
                </c:pt>
                <c:pt idx="306">
                  <c:v>76.98</c:v>
                </c:pt>
                <c:pt idx="307">
                  <c:v>6.5990000000000002</c:v>
                </c:pt>
                <c:pt idx="308">
                  <c:v>56.59</c:v>
                </c:pt>
                <c:pt idx="309">
                  <c:v>125.8</c:v>
                </c:pt>
                <c:pt idx="310">
                  <c:v>40.22</c:v>
                </c:pt>
                <c:pt idx="311">
                  <c:v>102.1</c:v>
                </c:pt>
                <c:pt idx="312">
                  <c:v>18.059999999999999</c:v>
                </c:pt>
                <c:pt idx="313">
                  <c:v>118.1</c:v>
                </c:pt>
                <c:pt idx="314">
                  <c:v>53.5</c:v>
                </c:pt>
                <c:pt idx="315">
                  <c:v>39.65</c:v>
                </c:pt>
                <c:pt idx="316">
                  <c:v>64.39</c:v>
                </c:pt>
                <c:pt idx="317">
                  <c:v>48.17</c:v>
                </c:pt>
                <c:pt idx="318">
                  <c:v>22.64</c:v>
                </c:pt>
                <c:pt idx="319">
                  <c:v>161.4</c:v>
                </c:pt>
                <c:pt idx="320">
                  <c:v>119.1</c:v>
                </c:pt>
                <c:pt idx="321">
                  <c:v>119.5</c:v>
                </c:pt>
                <c:pt idx="322">
                  <c:v>136</c:v>
                </c:pt>
                <c:pt idx="323">
                  <c:v>37.85</c:v>
                </c:pt>
                <c:pt idx="324">
                  <c:v>52.28</c:v>
                </c:pt>
                <c:pt idx="325">
                  <c:v>69.48</c:v>
                </c:pt>
                <c:pt idx="326">
                  <c:v>56.36</c:v>
                </c:pt>
                <c:pt idx="327">
                  <c:v>82.52</c:v>
                </c:pt>
                <c:pt idx="328">
                  <c:v>27.77</c:v>
                </c:pt>
                <c:pt idx="329">
                  <c:v>104.3</c:v>
                </c:pt>
                <c:pt idx="330">
                  <c:v>90.99</c:v>
                </c:pt>
                <c:pt idx="331">
                  <c:v>27.23</c:v>
                </c:pt>
                <c:pt idx="332">
                  <c:v>110.5</c:v>
                </c:pt>
                <c:pt idx="333">
                  <c:v>40.33</c:v>
                </c:pt>
                <c:pt idx="334">
                  <c:v>14.17</c:v>
                </c:pt>
                <c:pt idx="335">
                  <c:v>52.57</c:v>
                </c:pt>
                <c:pt idx="336">
                  <c:v>53.06</c:v>
                </c:pt>
                <c:pt idx="337">
                  <c:v>75.709999999999994</c:v>
                </c:pt>
                <c:pt idx="338">
                  <c:v>39.22</c:v>
                </c:pt>
                <c:pt idx="339">
                  <c:v>36.369999999999997</c:v>
                </c:pt>
                <c:pt idx="340">
                  <c:v>148.4</c:v>
                </c:pt>
                <c:pt idx="341">
                  <c:v>6.1070000000000002</c:v>
                </c:pt>
                <c:pt idx="342">
                  <c:v>60.05</c:v>
                </c:pt>
                <c:pt idx="343">
                  <c:v>87.23</c:v>
                </c:pt>
                <c:pt idx="344">
                  <c:v>26.92</c:v>
                </c:pt>
                <c:pt idx="345">
                  <c:v>203.6</c:v>
                </c:pt>
                <c:pt idx="346">
                  <c:v>42.8</c:v>
                </c:pt>
                <c:pt idx="347">
                  <c:v>11.87</c:v>
                </c:pt>
                <c:pt idx="348">
                  <c:v>32.89</c:v>
                </c:pt>
                <c:pt idx="349">
                  <c:v>55.97</c:v>
                </c:pt>
                <c:pt idx="350">
                  <c:v>54.56</c:v>
                </c:pt>
                <c:pt idx="351">
                  <c:v>90.18</c:v>
                </c:pt>
                <c:pt idx="352">
                  <c:v>77.7</c:v>
                </c:pt>
                <c:pt idx="353">
                  <c:v>36.619999999999997</c:v>
                </c:pt>
                <c:pt idx="354">
                  <c:v>64.12</c:v>
                </c:pt>
                <c:pt idx="355">
                  <c:v>8.91</c:v>
                </c:pt>
                <c:pt idx="356">
                  <c:v>33.33</c:v>
                </c:pt>
                <c:pt idx="357">
                  <c:v>75.28</c:v>
                </c:pt>
                <c:pt idx="358">
                  <c:v>185.8</c:v>
                </c:pt>
                <c:pt idx="359">
                  <c:v>22.75</c:v>
                </c:pt>
                <c:pt idx="360">
                  <c:v>55.7</c:v>
                </c:pt>
                <c:pt idx="361">
                  <c:v>36.24</c:v>
                </c:pt>
                <c:pt idx="362">
                  <c:v>22.48</c:v>
                </c:pt>
                <c:pt idx="363">
                  <c:v>55.07</c:v>
                </c:pt>
                <c:pt idx="364">
                  <c:v>24.26</c:v>
                </c:pt>
                <c:pt idx="365">
                  <c:v>172.1</c:v>
                </c:pt>
                <c:pt idx="366">
                  <c:v>24.97</c:v>
                </c:pt>
                <c:pt idx="367">
                  <c:v>82.94</c:v>
                </c:pt>
                <c:pt idx="368">
                  <c:v>42.63</c:v>
                </c:pt>
                <c:pt idx="369">
                  <c:v>23.52</c:v>
                </c:pt>
                <c:pt idx="370">
                  <c:v>48.93</c:v>
                </c:pt>
                <c:pt idx="371">
                  <c:v>85.42</c:v>
                </c:pt>
                <c:pt idx="372">
                  <c:v>39.020000000000003</c:v>
                </c:pt>
                <c:pt idx="373">
                  <c:v>112.7</c:v>
                </c:pt>
                <c:pt idx="374">
                  <c:v>53</c:v>
                </c:pt>
                <c:pt idx="375">
                  <c:v>270.60000000000002</c:v>
                </c:pt>
                <c:pt idx="376">
                  <c:v>28.74</c:v>
                </c:pt>
                <c:pt idx="377">
                  <c:v>33.6</c:v>
                </c:pt>
                <c:pt idx="378">
                  <c:v>22.43</c:v>
                </c:pt>
                <c:pt idx="379">
                  <c:v>10.24</c:v>
                </c:pt>
                <c:pt idx="380">
                  <c:v>140.30000000000001</c:v>
                </c:pt>
                <c:pt idx="381">
                  <c:v>36.520000000000003</c:v>
                </c:pt>
                <c:pt idx="382">
                  <c:v>374.1</c:v>
                </c:pt>
                <c:pt idx="383">
                  <c:v>124.8</c:v>
                </c:pt>
                <c:pt idx="384">
                  <c:v>110.5</c:v>
                </c:pt>
                <c:pt idx="385">
                  <c:v>140.4</c:v>
                </c:pt>
                <c:pt idx="386">
                  <c:v>42.23</c:v>
                </c:pt>
                <c:pt idx="387">
                  <c:v>13.49</c:v>
                </c:pt>
                <c:pt idx="388">
                  <c:v>113.9</c:v>
                </c:pt>
                <c:pt idx="389">
                  <c:v>19.62</c:v>
                </c:pt>
                <c:pt idx="390">
                  <c:v>36.35</c:v>
                </c:pt>
                <c:pt idx="391">
                  <c:v>5.7649999999999997</c:v>
                </c:pt>
                <c:pt idx="392">
                  <c:v>144.6</c:v>
                </c:pt>
                <c:pt idx="393">
                  <c:v>123</c:v>
                </c:pt>
                <c:pt idx="394">
                  <c:v>74.09</c:v>
                </c:pt>
                <c:pt idx="395">
                  <c:v>32</c:v>
                </c:pt>
                <c:pt idx="396">
                  <c:v>147.19999999999999</c:v>
                </c:pt>
                <c:pt idx="397">
                  <c:v>32.43</c:v>
                </c:pt>
                <c:pt idx="398">
                  <c:v>39.869999999999997</c:v>
                </c:pt>
                <c:pt idx="399">
                  <c:v>10.86</c:v>
                </c:pt>
                <c:pt idx="400">
                  <c:v>8.0820000000000007</c:v>
                </c:pt>
                <c:pt idx="401">
                  <c:v>23.69</c:v>
                </c:pt>
                <c:pt idx="402">
                  <c:v>53.02</c:v>
                </c:pt>
                <c:pt idx="403">
                  <c:v>93.96</c:v>
                </c:pt>
                <c:pt idx="404">
                  <c:v>74.459999999999994</c:v>
                </c:pt>
                <c:pt idx="405">
                  <c:v>174.5</c:v>
                </c:pt>
                <c:pt idx="406">
                  <c:v>43.43</c:v>
                </c:pt>
                <c:pt idx="407">
                  <c:v>24.14</c:v>
                </c:pt>
                <c:pt idx="408">
                  <c:v>46.64</c:v>
                </c:pt>
                <c:pt idx="409">
                  <c:v>33.07</c:v>
                </c:pt>
                <c:pt idx="410">
                  <c:v>42.18</c:v>
                </c:pt>
                <c:pt idx="411">
                  <c:v>59.06</c:v>
                </c:pt>
                <c:pt idx="412">
                  <c:v>16.510000000000002</c:v>
                </c:pt>
                <c:pt idx="413">
                  <c:v>53.52</c:v>
                </c:pt>
                <c:pt idx="414">
                  <c:v>26.95</c:v>
                </c:pt>
                <c:pt idx="415">
                  <c:v>92.85</c:v>
                </c:pt>
                <c:pt idx="416">
                  <c:v>21.39</c:v>
                </c:pt>
                <c:pt idx="417">
                  <c:v>14.06</c:v>
                </c:pt>
                <c:pt idx="418">
                  <c:v>64.78</c:v>
                </c:pt>
                <c:pt idx="419">
                  <c:v>121.6</c:v>
                </c:pt>
                <c:pt idx="420">
                  <c:v>125.9</c:v>
                </c:pt>
                <c:pt idx="421">
                  <c:v>85.52</c:v>
                </c:pt>
                <c:pt idx="422">
                  <c:v>1.694</c:v>
                </c:pt>
                <c:pt idx="423">
                  <c:v>36.92</c:v>
                </c:pt>
                <c:pt idx="424">
                  <c:v>80.39</c:v>
                </c:pt>
                <c:pt idx="425">
                  <c:v>22.95</c:v>
                </c:pt>
                <c:pt idx="426">
                  <c:v>17.100000000000001</c:v>
                </c:pt>
                <c:pt idx="427">
                  <c:v>41.93</c:v>
                </c:pt>
                <c:pt idx="428">
                  <c:v>28.32</c:v>
                </c:pt>
                <c:pt idx="429">
                  <c:v>68.260000000000005</c:v>
                </c:pt>
                <c:pt idx="430">
                  <c:v>29.62</c:v>
                </c:pt>
                <c:pt idx="431">
                  <c:v>64.98</c:v>
                </c:pt>
                <c:pt idx="432">
                  <c:v>85.19</c:v>
                </c:pt>
                <c:pt idx="433">
                  <c:v>6.8970000000000002</c:v>
                </c:pt>
                <c:pt idx="434">
                  <c:v>6.5910000000000002</c:v>
                </c:pt>
                <c:pt idx="435">
                  <c:v>100.7</c:v>
                </c:pt>
                <c:pt idx="436">
                  <c:v>72.88</c:v>
                </c:pt>
                <c:pt idx="437">
                  <c:v>126</c:v>
                </c:pt>
                <c:pt idx="438">
                  <c:v>49.26</c:v>
                </c:pt>
                <c:pt idx="439">
                  <c:v>30.71</c:v>
                </c:pt>
                <c:pt idx="440">
                  <c:v>134.80000000000001</c:v>
                </c:pt>
                <c:pt idx="441">
                  <c:v>45.42</c:v>
                </c:pt>
              </c:numCache>
            </c:numRef>
          </c:xVal>
          <c:yVal>
            <c:numRef>
              <c:f>sub!$T$8:$T$449</c:f>
              <c:numCache>
                <c:formatCode>General</c:formatCode>
                <c:ptCount val="442"/>
                <c:pt idx="0">
                  <c:v>53.97</c:v>
                </c:pt>
                <c:pt idx="1">
                  <c:v>56.49</c:v>
                </c:pt>
                <c:pt idx="2">
                  <c:v>54.9</c:v>
                </c:pt>
                <c:pt idx="3">
                  <c:v>89.46</c:v>
                </c:pt>
                <c:pt idx="4">
                  <c:v>72.459999999999994</c:v>
                </c:pt>
                <c:pt idx="5">
                  <c:v>82.23</c:v>
                </c:pt>
                <c:pt idx="6">
                  <c:v>75.349999999999994</c:v>
                </c:pt>
                <c:pt idx="7">
                  <c:v>57.26</c:v>
                </c:pt>
                <c:pt idx="8">
                  <c:v>107.7</c:v>
                </c:pt>
                <c:pt idx="9">
                  <c:v>50.52</c:v>
                </c:pt>
                <c:pt idx="10">
                  <c:v>76.42</c:v>
                </c:pt>
                <c:pt idx="11">
                  <c:v>63.36</c:v>
                </c:pt>
                <c:pt idx="12">
                  <c:v>91.42</c:v>
                </c:pt>
                <c:pt idx="13">
                  <c:v>57.4</c:v>
                </c:pt>
                <c:pt idx="14">
                  <c:v>121.2</c:v>
                </c:pt>
                <c:pt idx="15">
                  <c:v>89.08</c:v>
                </c:pt>
                <c:pt idx="16">
                  <c:v>68.42</c:v>
                </c:pt>
                <c:pt idx="17">
                  <c:v>63.24</c:v>
                </c:pt>
                <c:pt idx="18">
                  <c:v>84.59</c:v>
                </c:pt>
                <c:pt idx="19">
                  <c:v>115.6</c:v>
                </c:pt>
                <c:pt idx="20">
                  <c:v>72.430000000000007</c:v>
                </c:pt>
                <c:pt idx="21">
                  <c:v>75.81</c:v>
                </c:pt>
                <c:pt idx="22">
                  <c:v>86.75</c:v>
                </c:pt>
                <c:pt idx="23">
                  <c:v>73.680000000000007</c:v>
                </c:pt>
                <c:pt idx="24">
                  <c:v>60.37</c:v>
                </c:pt>
                <c:pt idx="25">
                  <c:v>49.67</c:v>
                </c:pt>
                <c:pt idx="26">
                  <c:v>121.9</c:v>
                </c:pt>
                <c:pt idx="27">
                  <c:v>73.459999999999994</c:v>
                </c:pt>
                <c:pt idx="28">
                  <c:v>91.95</c:v>
                </c:pt>
                <c:pt idx="29">
                  <c:v>74.959999999999994</c:v>
                </c:pt>
                <c:pt idx="30">
                  <c:v>105.1</c:v>
                </c:pt>
                <c:pt idx="31">
                  <c:v>65.63</c:v>
                </c:pt>
                <c:pt idx="32">
                  <c:v>97.04</c:v>
                </c:pt>
                <c:pt idx="33">
                  <c:v>128.19999999999999</c:v>
                </c:pt>
                <c:pt idx="34">
                  <c:v>74.06</c:v>
                </c:pt>
                <c:pt idx="35">
                  <c:v>58.04</c:v>
                </c:pt>
                <c:pt idx="36">
                  <c:v>60.77</c:v>
                </c:pt>
                <c:pt idx="37">
                  <c:v>86.29</c:v>
                </c:pt>
                <c:pt idx="38">
                  <c:v>77.16</c:v>
                </c:pt>
                <c:pt idx="39">
                  <c:v>130.1</c:v>
                </c:pt>
                <c:pt idx="40">
                  <c:v>92.08</c:v>
                </c:pt>
                <c:pt idx="41">
                  <c:v>119.5</c:v>
                </c:pt>
                <c:pt idx="42">
                  <c:v>99.32</c:v>
                </c:pt>
                <c:pt idx="43">
                  <c:v>59.86</c:v>
                </c:pt>
                <c:pt idx="44">
                  <c:v>110.3</c:v>
                </c:pt>
                <c:pt idx="45">
                  <c:v>72.540000000000006</c:v>
                </c:pt>
                <c:pt idx="46">
                  <c:v>103.9</c:v>
                </c:pt>
                <c:pt idx="47">
                  <c:v>71.61</c:v>
                </c:pt>
                <c:pt idx="48">
                  <c:v>113</c:v>
                </c:pt>
                <c:pt idx="49">
                  <c:v>90</c:v>
                </c:pt>
                <c:pt idx="50">
                  <c:v>134.69999999999999</c:v>
                </c:pt>
                <c:pt idx="51">
                  <c:v>106.7</c:v>
                </c:pt>
                <c:pt idx="52">
                  <c:v>114.1</c:v>
                </c:pt>
                <c:pt idx="53">
                  <c:v>86.42</c:v>
                </c:pt>
                <c:pt idx="54">
                  <c:v>96.41</c:v>
                </c:pt>
                <c:pt idx="55">
                  <c:v>77.02</c:v>
                </c:pt>
                <c:pt idx="56">
                  <c:v>125.7</c:v>
                </c:pt>
                <c:pt idx="57">
                  <c:v>127</c:v>
                </c:pt>
                <c:pt idx="58">
                  <c:v>74.11</c:v>
                </c:pt>
                <c:pt idx="59">
                  <c:v>76</c:v>
                </c:pt>
                <c:pt idx="60">
                  <c:v>97.62</c:v>
                </c:pt>
                <c:pt idx="61">
                  <c:v>108.4</c:v>
                </c:pt>
                <c:pt idx="62">
                  <c:v>117.2</c:v>
                </c:pt>
                <c:pt idx="63">
                  <c:v>106.6</c:v>
                </c:pt>
                <c:pt idx="64">
                  <c:v>87.86</c:v>
                </c:pt>
                <c:pt idx="65">
                  <c:v>103.3</c:v>
                </c:pt>
                <c:pt idx="66">
                  <c:v>98.44</c:v>
                </c:pt>
                <c:pt idx="67">
                  <c:v>113.4</c:v>
                </c:pt>
                <c:pt idx="68">
                  <c:v>118.4</c:v>
                </c:pt>
                <c:pt idx="69">
                  <c:v>37.31</c:v>
                </c:pt>
                <c:pt idx="70">
                  <c:v>54.88</c:v>
                </c:pt>
                <c:pt idx="71">
                  <c:v>110.6</c:v>
                </c:pt>
                <c:pt idx="72">
                  <c:v>88.86</c:v>
                </c:pt>
                <c:pt idx="73">
                  <c:v>71.180000000000007</c:v>
                </c:pt>
                <c:pt idx="74">
                  <c:v>57.89</c:v>
                </c:pt>
                <c:pt idx="75">
                  <c:v>63.85</c:v>
                </c:pt>
                <c:pt idx="76">
                  <c:v>79.8</c:v>
                </c:pt>
                <c:pt idx="77">
                  <c:v>73.69</c:v>
                </c:pt>
                <c:pt idx="78">
                  <c:v>49.46</c:v>
                </c:pt>
                <c:pt idx="79">
                  <c:v>109.8</c:v>
                </c:pt>
                <c:pt idx="80">
                  <c:v>108.6</c:v>
                </c:pt>
                <c:pt idx="81">
                  <c:v>78.95</c:v>
                </c:pt>
                <c:pt idx="82">
                  <c:v>93.67</c:v>
                </c:pt>
                <c:pt idx="83">
                  <c:v>45.12</c:v>
                </c:pt>
                <c:pt idx="84">
                  <c:v>119.6</c:v>
                </c:pt>
                <c:pt idx="85">
                  <c:v>86.51</c:v>
                </c:pt>
                <c:pt idx="86">
                  <c:v>100.1</c:v>
                </c:pt>
                <c:pt idx="87">
                  <c:v>95.59</c:v>
                </c:pt>
                <c:pt idx="88">
                  <c:v>97.04</c:v>
                </c:pt>
                <c:pt idx="89">
                  <c:v>82.57</c:v>
                </c:pt>
                <c:pt idx="90">
                  <c:v>115.2</c:v>
                </c:pt>
                <c:pt idx="91">
                  <c:v>79.11</c:v>
                </c:pt>
                <c:pt idx="92">
                  <c:v>74.13</c:v>
                </c:pt>
                <c:pt idx="93">
                  <c:v>121</c:v>
                </c:pt>
                <c:pt idx="94">
                  <c:v>82.53</c:v>
                </c:pt>
                <c:pt idx="95">
                  <c:v>84.16</c:v>
                </c:pt>
                <c:pt idx="96">
                  <c:v>58.15</c:v>
                </c:pt>
                <c:pt idx="97">
                  <c:v>55.01</c:v>
                </c:pt>
                <c:pt idx="98">
                  <c:v>119.6</c:v>
                </c:pt>
                <c:pt idx="99">
                  <c:v>150</c:v>
                </c:pt>
                <c:pt idx="100">
                  <c:v>100.8</c:v>
                </c:pt>
                <c:pt idx="101">
                  <c:v>87.21</c:v>
                </c:pt>
                <c:pt idx="102">
                  <c:v>94.97</c:v>
                </c:pt>
                <c:pt idx="103">
                  <c:v>67.180000000000007</c:v>
                </c:pt>
                <c:pt idx="104">
                  <c:v>91.36</c:v>
                </c:pt>
                <c:pt idx="105">
                  <c:v>85.18</c:v>
                </c:pt>
                <c:pt idx="106">
                  <c:v>73.209999999999994</c:v>
                </c:pt>
                <c:pt idx="107">
                  <c:v>74.040000000000006</c:v>
                </c:pt>
                <c:pt idx="108">
                  <c:v>111.8</c:v>
                </c:pt>
                <c:pt idx="109">
                  <c:v>75.3</c:v>
                </c:pt>
                <c:pt idx="110">
                  <c:v>61.59</c:v>
                </c:pt>
                <c:pt idx="111">
                  <c:v>54.42</c:v>
                </c:pt>
                <c:pt idx="112">
                  <c:v>137</c:v>
                </c:pt>
                <c:pt idx="113">
                  <c:v>64.19</c:v>
                </c:pt>
                <c:pt idx="114">
                  <c:v>118.8</c:v>
                </c:pt>
                <c:pt idx="115">
                  <c:v>62.06</c:v>
                </c:pt>
                <c:pt idx="116">
                  <c:v>83.12</c:v>
                </c:pt>
                <c:pt idx="117">
                  <c:v>69.319999999999993</c:v>
                </c:pt>
                <c:pt idx="118">
                  <c:v>72.48</c:v>
                </c:pt>
                <c:pt idx="119">
                  <c:v>83.06</c:v>
                </c:pt>
                <c:pt idx="120">
                  <c:v>75.010000000000005</c:v>
                </c:pt>
                <c:pt idx="121">
                  <c:v>66.52</c:v>
                </c:pt>
                <c:pt idx="122">
                  <c:v>131.69999999999999</c:v>
                </c:pt>
                <c:pt idx="123">
                  <c:v>81.89</c:v>
                </c:pt>
                <c:pt idx="124">
                  <c:v>64.7</c:v>
                </c:pt>
                <c:pt idx="125">
                  <c:v>77.05</c:v>
                </c:pt>
                <c:pt idx="126">
                  <c:v>122.3</c:v>
                </c:pt>
                <c:pt idx="127">
                  <c:v>57.36</c:v>
                </c:pt>
                <c:pt idx="128">
                  <c:v>96.13</c:v>
                </c:pt>
                <c:pt idx="129">
                  <c:v>66.97</c:v>
                </c:pt>
                <c:pt idx="130">
                  <c:v>92.85</c:v>
                </c:pt>
                <c:pt idx="131">
                  <c:v>80.97</c:v>
                </c:pt>
                <c:pt idx="132">
                  <c:v>126.1</c:v>
                </c:pt>
                <c:pt idx="133">
                  <c:v>92.74</c:v>
                </c:pt>
                <c:pt idx="134">
                  <c:v>79.98</c:v>
                </c:pt>
                <c:pt idx="135">
                  <c:v>131.6</c:v>
                </c:pt>
                <c:pt idx="136">
                  <c:v>91.44</c:v>
                </c:pt>
                <c:pt idx="137">
                  <c:v>101.5</c:v>
                </c:pt>
                <c:pt idx="138">
                  <c:v>67.73</c:v>
                </c:pt>
                <c:pt idx="139">
                  <c:v>128.5</c:v>
                </c:pt>
                <c:pt idx="140">
                  <c:v>88.09</c:v>
                </c:pt>
                <c:pt idx="141">
                  <c:v>73.77</c:v>
                </c:pt>
                <c:pt idx="142">
                  <c:v>96.86</c:v>
                </c:pt>
                <c:pt idx="143">
                  <c:v>64.75</c:v>
                </c:pt>
                <c:pt idx="144">
                  <c:v>89.7</c:v>
                </c:pt>
                <c:pt idx="145">
                  <c:v>71.56</c:v>
                </c:pt>
                <c:pt idx="146">
                  <c:v>93.66</c:v>
                </c:pt>
                <c:pt idx="147">
                  <c:v>105.9</c:v>
                </c:pt>
                <c:pt idx="148">
                  <c:v>117.7</c:v>
                </c:pt>
                <c:pt idx="149">
                  <c:v>69.849999999999994</c:v>
                </c:pt>
                <c:pt idx="150">
                  <c:v>83.29</c:v>
                </c:pt>
                <c:pt idx="151">
                  <c:v>90.3</c:v>
                </c:pt>
                <c:pt idx="152">
                  <c:v>102.7</c:v>
                </c:pt>
                <c:pt idx="153">
                  <c:v>96.82</c:v>
                </c:pt>
                <c:pt idx="154">
                  <c:v>61.66</c:v>
                </c:pt>
                <c:pt idx="155">
                  <c:v>116.5</c:v>
                </c:pt>
                <c:pt idx="156">
                  <c:v>139.5</c:v>
                </c:pt>
                <c:pt idx="157">
                  <c:v>62.34</c:v>
                </c:pt>
                <c:pt idx="158">
                  <c:v>84.38</c:v>
                </c:pt>
                <c:pt idx="159">
                  <c:v>69.13</c:v>
                </c:pt>
                <c:pt idx="160">
                  <c:v>51.2</c:v>
                </c:pt>
                <c:pt idx="161">
                  <c:v>29.56</c:v>
                </c:pt>
                <c:pt idx="162">
                  <c:v>69.67</c:v>
                </c:pt>
                <c:pt idx="163">
                  <c:v>92.39</c:v>
                </c:pt>
                <c:pt idx="164">
                  <c:v>134.4</c:v>
                </c:pt>
                <c:pt idx="165">
                  <c:v>166.4</c:v>
                </c:pt>
                <c:pt idx="166">
                  <c:v>82.18</c:v>
                </c:pt>
                <c:pt idx="167">
                  <c:v>88.93</c:v>
                </c:pt>
                <c:pt idx="168">
                  <c:v>70.06</c:v>
                </c:pt>
                <c:pt idx="169">
                  <c:v>78.75</c:v>
                </c:pt>
                <c:pt idx="170">
                  <c:v>80.38</c:v>
                </c:pt>
                <c:pt idx="171">
                  <c:v>151.9</c:v>
                </c:pt>
                <c:pt idx="172">
                  <c:v>49.1</c:v>
                </c:pt>
                <c:pt idx="173">
                  <c:v>77.72</c:v>
                </c:pt>
                <c:pt idx="174">
                  <c:v>42.02</c:v>
                </c:pt>
                <c:pt idx="175">
                  <c:v>64.59</c:v>
                </c:pt>
                <c:pt idx="176">
                  <c:v>98.35</c:v>
                </c:pt>
                <c:pt idx="177">
                  <c:v>112.8</c:v>
                </c:pt>
                <c:pt idx="178">
                  <c:v>151.4</c:v>
                </c:pt>
                <c:pt idx="179">
                  <c:v>64.739999999999995</c:v>
                </c:pt>
                <c:pt idx="180">
                  <c:v>91.28</c:v>
                </c:pt>
                <c:pt idx="181">
                  <c:v>66.23</c:v>
                </c:pt>
                <c:pt idx="182">
                  <c:v>61.8</c:v>
                </c:pt>
                <c:pt idx="183">
                  <c:v>81.459999999999994</c:v>
                </c:pt>
                <c:pt idx="184">
                  <c:v>120.6</c:v>
                </c:pt>
                <c:pt idx="185">
                  <c:v>66.98</c:v>
                </c:pt>
                <c:pt idx="186">
                  <c:v>111.5</c:v>
                </c:pt>
                <c:pt idx="187">
                  <c:v>118</c:v>
                </c:pt>
                <c:pt idx="188">
                  <c:v>54.75</c:v>
                </c:pt>
                <c:pt idx="189">
                  <c:v>87.2</c:v>
                </c:pt>
                <c:pt idx="190">
                  <c:v>72.44</c:v>
                </c:pt>
                <c:pt idx="191">
                  <c:v>100.1</c:v>
                </c:pt>
                <c:pt idx="192">
                  <c:v>111.2</c:v>
                </c:pt>
                <c:pt idx="193">
                  <c:v>135.19999999999999</c:v>
                </c:pt>
                <c:pt idx="194">
                  <c:v>86.64</c:v>
                </c:pt>
                <c:pt idx="195">
                  <c:v>54.86</c:v>
                </c:pt>
                <c:pt idx="196">
                  <c:v>65.099999999999994</c:v>
                </c:pt>
                <c:pt idx="197">
                  <c:v>97.76</c:v>
                </c:pt>
                <c:pt idx="198">
                  <c:v>146</c:v>
                </c:pt>
                <c:pt idx="199">
                  <c:v>84.92</c:v>
                </c:pt>
                <c:pt idx="200">
                  <c:v>66.34</c:v>
                </c:pt>
                <c:pt idx="201">
                  <c:v>118.3</c:v>
                </c:pt>
                <c:pt idx="202">
                  <c:v>113.7</c:v>
                </c:pt>
                <c:pt idx="203">
                  <c:v>109.2</c:v>
                </c:pt>
                <c:pt idx="204">
                  <c:v>89.35</c:v>
                </c:pt>
                <c:pt idx="205">
                  <c:v>64.64</c:v>
                </c:pt>
                <c:pt idx="206">
                  <c:v>82.44</c:v>
                </c:pt>
                <c:pt idx="207">
                  <c:v>90.69</c:v>
                </c:pt>
                <c:pt idx="208">
                  <c:v>66.58</c:v>
                </c:pt>
                <c:pt idx="209">
                  <c:v>100.7</c:v>
                </c:pt>
                <c:pt idx="210">
                  <c:v>121.1</c:v>
                </c:pt>
                <c:pt idx="211">
                  <c:v>57.45</c:v>
                </c:pt>
                <c:pt idx="212">
                  <c:v>39.68</c:v>
                </c:pt>
                <c:pt idx="213">
                  <c:v>112.9</c:v>
                </c:pt>
                <c:pt idx="214">
                  <c:v>77.22</c:v>
                </c:pt>
                <c:pt idx="215">
                  <c:v>81.599999999999994</c:v>
                </c:pt>
                <c:pt idx="216">
                  <c:v>61.82</c:v>
                </c:pt>
                <c:pt idx="217">
                  <c:v>114.1</c:v>
                </c:pt>
                <c:pt idx="218">
                  <c:v>74.62</c:v>
                </c:pt>
                <c:pt idx="219">
                  <c:v>102.6</c:v>
                </c:pt>
                <c:pt idx="220">
                  <c:v>101.3</c:v>
                </c:pt>
                <c:pt idx="221">
                  <c:v>79.39</c:v>
                </c:pt>
                <c:pt idx="222">
                  <c:v>71.040000000000006</c:v>
                </c:pt>
                <c:pt idx="223">
                  <c:v>121.1</c:v>
                </c:pt>
                <c:pt idx="224">
                  <c:v>112.9</c:v>
                </c:pt>
                <c:pt idx="225">
                  <c:v>92.52</c:v>
                </c:pt>
                <c:pt idx="226">
                  <c:v>96.58</c:v>
                </c:pt>
                <c:pt idx="227">
                  <c:v>62.72</c:v>
                </c:pt>
                <c:pt idx="228">
                  <c:v>97.48</c:v>
                </c:pt>
                <c:pt idx="229">
                  <c:v>77.41</c:v>
                </c:pt>
                <c:pt idx="230">
                  <c:v>83.01</c:v>
                </c:pt>
                <c:pt idx="231">
                  <c:v>109.8</c:v>
                </c:pt>
                <c:pt idx="232">
                  <c:v>84.13</c:v>
                </c:pt>
                <c:pt idx="233">
                  <c:v>50.51</c:v>
                </c:pt>
                <c:pt idx="234">
                  <c:v>55.19</c:v>
                </c:pt>
                <c:pt idx="235">
                  <c:v>114</c:v>
                </c:pt>
                <c:pt idx="236">
                  <c:v>92.84</c:v>
                </c:pt>
                <c:pt idx="237">
                  <c:v>76.7</c:v>
                </c:pt>
                <c:pt idx="238">
                  <c:v>77.64</c:v>
                </c:pt>
                <c:pt idx="239">
                  <c:v>113</c:v>
                </c:pt>
                <c:pt idx="240">
                  <c:v>91.79</c:v>
                </c:pt>
                <c:pt idx="241">
                  <c:v>88.63</c:v>
                </c:pt>
                <c:pt idx="242">
                  <c:v>83.81</c:v>
                </c:pt>
                <c:pt idx="243">
                  <c:v>107.8</c:v>
                </c:pt>
                <c:pt idx="244">
                  <c:v>53.24</c:v>
                </c:pt>
                <c:pt idx="245">
                  <c:v>121.8</c:v>
                </c:pt>
                <c:pt idx="246">
                  <c:v>88.49</c:v>
                </c:pt>
                <c:pt idx="247">
                  <c:v>112.4</c:v>
                </c:pt>
                <c:pt idx="248">
                  <c:v>79.86</c:v>
                </c:pt>
                <c:pt idx="249">
                  <c:v>156</c:v>
                </c:pt>
                <c:pt idx="250">
                  <c:v>159.9</c:v>
                </c:pt>
                <c:pt idx="251">
                  <c:v>97.53</c:v>
                </c:pt>
                <c:pt idx="252">
                  <c:v>118.1</c:v>
                </c:pt>
                <c:pt idx="253">
                  <c:v>92.46</c:v>
                </c:pt>
                <c:pt idx="254">
                  <c:v>72.86</c:v>
                </c:pt>
                <c:pt idx="255">
                  <c:v>102</c:v>
                </c:pt>
                <c:pt idx="256">
                  <c:v>92.2</c:v>
                </c:pt>
                <c:pt idx="257">
                  <c:v>114.6</c:v>
                </c:pt>
                <c:pt idx="258">
                  <c:v>107.6</c:v>
                </c:pt>
                <c:pt idx="259">
                  <c:v>129.5</c:v>
                </c:pt>
                <c:pt idx="260">
                  <c:v>56.99</c:v>
                </c:pt>
                <c:pt idx="261">
                  <c:v>130.80000000000001</c:v>
                </c:pt>
                <c:pt idx="262">
                  <c:v>67.400000000000006</c:v>
                </c:pt>
                <c:pt idx="263">
                  <c:v>117.4</c:v>
                </c:pt>
                <c:pt idx="264">
                  <c:v>106.6</c:v>
                </c:pt>
                <c:pt idx="265">
                  <c:v>91.49</c:v>
                </c:pt>
                <c:pt idx="266">
                  <c:v>138.6</c:v>
                </c:pt>
                <c:pt idx="267">
                  <c:v>74.5</c:v>
                </c:pt>
                <c:pt idx="268">
                  <c:v>70.52</c:v>
                </c:pt>
                <c:pt idx="269">
                  <c:v>105.9</c:v>
                </c:pt>
                <c:pt idx="270">
                  <c:v>94.81</c:v>
                </c:pt>
                <c:pt idx="271">
                  <c:v>130</c:v>
                </c:pt>
                <c:pt idx="272">
                  <c:v>101.7</c:v>
                </c:pt>
                <c:pt idx="273">
                  <c:v>113.1</c:v>
                </c:pt>
                <c:pt idx="274">
                  <c:v>130.6</c:v>
                </c:pt>
                <c:pt idx="275">
                  <c:v>115.4</c:v>
                </c:pt>
                <c:pt idx="276">
                  <c:v>135.5</c:v>
                </c:pt>
                <c:pt idx="277">
                  <c:v>94.06</c:v>
                </c:pt>
                <c:pt idx="278">
                  <c:v>85.57</c:v>
                </c:pt>
                <c:pt idx="279">
                  <c:v>136.5</c:v>
                </c:pt>
                <c:pt idx="280">
                  <c:v>77.7</c:v>
                </c:pt>
                <c:pt idx="281">
                  <c:v>88.44</c:v>
                </c:pt>
                <c:pt idx="282">
                  <c:v>86.64</c:v>
                </c:pt>
                <c:pt idx="283">
                  <c:v>86.63</c:v>
                </c:pt>
                <c:pt idx="284">
                  <c:v>149.80000000000001</c:v>
                </c:pt>
                <c:pt idx="285">
                  <c:v>109.9</c:v>
                </c:pt>
                <c:pt idx="286">
                  <c:v>124.7</c:v>
                </c:pt>
                <c:pt idx="287">
                  <c:v>122.5</c:v>
                </c:pt>
                <c:pt idx="288">
                  <c:v>121.8</c:v>
                </c:pt>
                <c:pt idx="289">
                  <c:v>54.08</c:v>
                </c:pt>
                <c:pt idx="290">
                  <c:v>70.69</c:v>
                </c:pt>
                <c:pt idx="291">
                  <c:v>135.1</c:v>
                </c:pt>
                <c:pt idx="292">
                  <c:v>125.5</c:v>
                </c:pt>
                <c:pt idx="293">
                  <c:v>82.98</c:v>
                </c:pt>
                <c:pt idx="294">
                  <c:v>117</c:v>
                </c:pt>
                <c:pt idx="295">
                  <c:v>145.1</c:v>
                </c:pt>
                <c:pt idx="296">
                  <c:v>107.5</c:v>
                </c:pt>
                <c:pt idx="297">
                  <c:v>81.819999999999993</c:v>
                </c:pt>
                <c:pt idx="298">
                  <c:v>115.8</c:v>
                </c:pt>
                <c:pt idx="299">
                  <c:v>97.19</c:v>
                </c:pt>
                <c:pt idx="300">
                  <c:v>128.80000000000001</c:v>
                </c:pt>
                <c:pt idx="301">
                  <c:v>163.5</c:v>
                </c:pt>
                <c:pt idx="302">
                  <c:v>110.3</c:v>
                </c:pt>
                <c:pt idx="303">
                  <c:v>58.46</c:v>
                </c:pt>
                <c:pt idx="304">
                  <c:v>137.9</c:v>
                </c:pt>
                <c:pt idx="305">
                  <c:v>94.49</c:v>
                </c:pt>
                <c:pt idx="306">
                  <c:v>49.02</c:v>
                </c:pt>
                <c:pt idx="307">
                  <c:v>81.72</c:v>
                </c:pt>
                <c:pt idx="308">
                  <c:v>129.1</c:v>
                </c:pt>
                <c:pt idx="309">
                  <c:v>98.95</c:v>
                </c:pt>
                <c:pt idx="310">
                  <c:v>133.5</c:v>
                </c:pt>
                <c:pt idx="311">
                  <c:v>110.9</c:v>
                </c:pt>
                <c:pt idx="312">
                  <c:v>109.6</c:v>
                </c:pt>
                <c:pt idx="313">
                  <c:v>95.37</c:v>
                </c:pt>
                <c:pt idx="314">
                  <c:v>124.8</c:v>
                </c:pt>
                <c:pt idx="315">
                  <c:v>124.7</c:v>
                </c:pt>
                <c:pt idx="316">
                  <c:v>114.5</c:v>
                </c:pt>
                <c:pt idx="317">
                  <c:v>97.91</c:v>
                </c:pt>
                <c:pt idx="318">
                  <c:v>100.4</c:v>
                </c:pt>
                <c:pt idx="319">
                  <c:v>73.69</c:v>
                </c:pt>
                <c:pt idx="320">
                  <c:v>92.05</c:v>
                </c:pt>
                <c:pt idx="321">
                  <c:v>94.23</c:v>
                </c:pt>
                <c:pt idx="322">
                  <c:v>95.19</c:v>
                </c:pt>
                <c:pt idx="323">
                  <c:v>89.53</c:v>
                </c:pt>
                <c:pt idx="324">
                  <c:v>85.41</c:v>
                </c:pt>
                <c:pt idx="325">
                  <c:v>107.4</c:v>
                </c:pt>
                <c:pt idx="326">
                  <c:v>93.02</c:v>
                </c:pt>
                <c:pt idx="327">
                  <c:v>90.57</c:v>
                </c:pt>
                <c:pt idx="328">
                  <c:v>103.8</c:v>
                </c:pt>
                <c:pt idx="329">
                  <c:v>102.3</c:v>
                </c:pt>
                <c:pt idx="330">
                  <c:v>77.05</c:v>
                </c:pt>
                <c:pt idx="331">
                  <c:v>184</c:v>
                </c:pt>
                <c:pt idx="332">
                  <c:v>106</c:v>
                </c:pt>
                <c:pt idx="333">
                  <c:v>148.9</c:v>
                </c:pt>
                <c:pt idx="334">
                  <c:v>127.3</c:v>
                </c:pt>
                <c:pt idx="335">
                  <c:v>92.67</c:v>
                </c:pt>
                <c:pt idx="336">
                  <c:v>91.81</c:v>
                </c:pt>
                <c:pt idx="337">
                  <c:v>107.4</c:v>
                </c:pt>
                <c:pt idx="338">
                  <c:v>174.5</c:v>
                </c:pt>
                <c:pt idx="339">
                  <c:v>80.87</c:v>
                </c:pt>
                <c:pt idx="340">
                  <c:v>89.11</c:v>
                </c:pt>
                <c:pt idx="341">
                  <c:v>147</c:v>
                </c:pt>
                <c:pt idx="342">
                  <c:v>110.6</c:v>
                </c:pt>
                <c:pt idx="343">
                  <c:v>63.25</c:v>
                </c:pt>
                <c:pt idx="344">
                  <c:v>118.4</c:v>
                </c:pt>
                <c:pt idx="345">
                  <c:v>93.94</c:v>
                </c:pt>
                <c:pt idx="346">
                  <c:v>89.33</c:v>
                </c:pt>
                <c:pt idx="347">
                  <c:v>117.6</c:v>
                </c:pt>
                <c:pt idx="348">
                  <c:v>106.4</c:v>
                </c:pt>
                <c:pt idx="349">
                  <c:v>97.53</c:v>
                </c:pt>
                <c:pt idx="350">
                  <c:v>68.44</c:v>
                </c:pt>
                <c:pt idx="351">
                  <c:v>88.51</c:v>
                </c:pt>
                <c:pt idx="352">
                  <c:v>97.7</c:v>
                </c:pt>
                <c:pt idx="353">
                  <c:v>94.63</c:v>
                </c:pt>
                <c:pt idx="354">
                  <c:v>84.61</c:v>
                </c:pt>
                <c:pt idx="355">
                  <c:v>149.9</c:v>
                </c:pt>
                <c:pt idx="356">
                  <c:v>105.3</c:v>
                </c:pt>
                <c:pt idx="357">
                  <c:v>104.6</c:v>
                </c:pt>
                <c:pt idx="358">
                  <c:v>123.9</c:v>
                </c:pt>
                <c:pt idx="359">
                  <c:v>73.67</c:v>
                </c:pt>
                <c:pt idx="360">
                  <c:v>125.3</c:v>
                </c:pt>
                <c:pt idx="361">
                  <c:v>120.5</c:v>
                </c:pt>
                <c:pt idx="362">
                  <c:v>139.69999999999999</c:v>
                </c:pt>
                <c:pt idx="363">
                  <c:v>124.2</c:v>
                </c:pt>
                <c:pt idx="364">
                  <c:v>140.1</c:v>
                </c:pt>
                <c:pt idx="365">
                  <c:v>104.8</c:v>
                </c:pt>
                <c:pt idx="366">
                  <c:v>80.84</c:v>
                </c:pt>
                <c:pt idx="367">
                  <c:v>69.19</c:v>
                </c:pt>
                <c:pt idx="368">
                  <c:v>128.5</c:v>
                </c:pt>
                <c:pt idx="369">
                  <c:v>132.5</c:v>
                </c:pt>
                <c:pt idx="370">
                  <c:v>121.3</c:v>
                </c:pt>
                <c:pt idx="371">
                  <c:v>106.7</c:v>
                </c:pt>
                <c:pt idx="372">
                  <c:v>60.33</c:v>
                </c:pt>
                <c:pt idx="373">
                  <c:v>53.29</c:v>
                </c:pt>
                <c:pt idx="374">
                  <c:v>86.42</c:v>
                </c:pt>
                <c:pt idx="375">
                  <c:v>74.430000000000007</c:v>
                </c:pt>
                <c:pt idx="376">
                  <c:v>106.5</c:v>
                </c:pt>
                <c:pt idx="377">
                  <c:v>139.1</c:v>
                </c:pt>
                <c:pt idx="378">
                  <c:v>93.96</c:v>
                </c:pt>
                <c:pt idx="379">
                  <c:v>86.81</c:v>
                </c:pt>
                <c:pt idx="380">
                  <c:v>79.349999999999994</c:v>
                </c:pt>
                <c:pt idx="381">
                  <c:v>118.1</c:v>
                </c:pt>
                <c:pt idx="382">
                  <c:v>82.81</c:v>
                </c:pt>
                <c:pt idx="383">
                  <c:v>93.6</c:v>
                </c:pt>
                <c:pt idx="384">
                  <c:v>88.26</c:v>
                </c:pt>
                <c:pt idx="385">
                  <c:v>109.6</c:v>
                </c:pt>
                <c:pt idx="386">
                  <c:v>85.73</c:v>
                </c:pt>
                <c:pt idx="387">
                  <c:v>52.83</c:v>
                </c:pt>
                <c:pt idx="388">
                  <c:v>119.6</c:v>
                </c:pt>
                <c:pt idx="389">
                  <c:v>108.9</c:v>
                </c:pt>
                <c:pt idx="390">
                  <c:v>132.9</c:v>
                </c:pt>
                <c:pt idx="391">
                  <c:v>74.05</c:v>
                </c:pt>
                <c:pt idx="392">
                  <c:v>93.03</c:v>
                </c:pt>
                <c:pt idx="393">
                  <c:v>101</c:v>
                </c:pt>
                <c:pt idx="394">
                  <c:v>74.34</c:v>
                </c:pt>
                <c:pt idx="395">
                  <c:v>73.92</c:v>
                </c:pt>
                <c:pt idx="396">
                  <c:v>99.35</c:v>
                </c:pt>
                <c:pt idx="397">
                  <c:v>102.4</c:v>
                </c:pt>
                <c:pt idx="398">
                  <c:v>132.1</c:v>
                </c:pt>
                <c:pt idx="399">
                  <c:v>147.6</c:v>
                </c:pt>
                <c:pt idx="400">
                  <c:v>131.1</c:v>
                </c:pt>
                <c:pt idx="401">
                  <c:v>113.8</c:v>
                </c:pt>
                <c:pt idx="402">
                  <c:v>88.96</c:v>
                </c:pt>
                <c:pt idx="403">
                  <c:v>118.6</c:v>
                </c:pt>
                <c:pt idx="404">
                  <c:v>147.19999999999999</c:v>
                </c:pt>
                <c:pt idx="405">
                  <c:v>70.36</c:v>
                </c:pt>
                <c:pt idx="406">
                  <c:v>121.6</c:v>
                </c:pt>
                <c:pt idx="407">
                  <c:v>141</c:v>
                </c:pt>
                <c:pt idx="408">
                  <c:v>75.37</c:v>
                </c:pt>
                <c:pt idx="409">
                  <c:v>113.6</c:v>
                </c:pt>
                <c:pt idx="410">
                  <c:v>147.69999999999999</c:v>
                </c:pt>
                <c:pt idx="411">
                  <c:v>149</c:v>
                </c:pt>
                <c:pt idx="412">
                  <c:v>129.5</c:v>
                </c:pt>
                <c:pt idx="413">
                  <c:v>94.72</c:v>
                </c:pt>
                <c:pt idx="414">
                  <c:v>104.9</c:v>
                </c:pt>
                <c:pt idx="415">
                  <c:v>90.15</c:v>
                </c:pt>
                <c:pt idx="416">
                  <c:v>125.9</c:v>
                </c:pt>
                <c:pt idx="417">
                  <c:v>109.6</c:v>
                </c:pt>
                <c:pt idx="418">
                  <c:v>76.42</c:v>
                </c:pt>
                <c:pt idx="419">
                  <c:v>52.32</c:v>
                </c:pt>
                <c:pt idx="420">
                  <c:v>63.8</c:v>
                </c:pt>
                <c:pt idx="421">
                  <c:v>73.239999999999995</c:v>
                </c:pt>
                <c:pt idx="422">
                  <c:v>81.19</c:v>
                </c:pt>
                <c:pt idx="423">
                  <c:v>62.1</c:v>
                </c:pt>
                <c:pt idx="424">
                  <c:v>93.62</c:v>
                </c:pt>
                <c:pt idx="425">
                  <c:v>148.4</c:v>
                </c:pt>
                <c:pt idx="426">
                  <c:v>119.9</c:v>
                </c:pt>
                <c:pt idx="427">
                  <c:v>136.19999999999999</c:v>
                </c:pt>
                <c:pt idx="428">
                  <c:v>185.8</c:v>
                </c:pt>
                <c:pt idx="429">
                  <c:v>110.3</c:v>
                </c:pt>
                <c:pt idx="430">
                  <c:v>57.66</c:v>
                </c:pt>
                <c:pt idx="431">
                  <c:v>119.9</c:v>
                </c:pt>
                <c:pt idx="432">
                  <c:v>95.55</c:v>
                </c:pt>
                <c:pt idx="433">
                  <c:v>106.5</c:v>
                </c:pt>
                <c:pt idx="434">
                  <c:v>78.900000000000006</c:v>
                </c:pt>
                <c:pt idx="435">
                  <c:v>95.98</c:v>
                </c:pt>
                <c:pt idx="436">
                  <c:v>115.1</c:v>
                </c:pt>
                <c:pt idx="437">
                  <c:v>118</c:v>
                </c:pt>
                <c:pt idx="438">
                  <c:v>93.8</c:v>
                </c:pt>
                <c:pt idx="439">
                  <c:v>55.16</c:v>
                </c:pt>
                <c:pt idx="440">
                  <c:v>95.68</c:v>
                </c:pt>
                <c:pt idx="441">
                  <c:v>131.30000000000001</c:v>
                </c:pt>
              </c:numCache>
            </c:numRef>
          </c:yVal>
          <c:smooth val="0"/>
          <c:extLst xmlns:c16r2="http://schemas.microsoft.com/office/drawing/2015/06/chart">
            <c:ext xmlns:c16="http://schemas.microsoft.com/office/drawing/2014/chart" uri="{C3380CC4-5D6E-409C-BE32-E72D297353CC}">
              <c16:uniqueId val="{00000000-4F2F-4A45-9D4F-129FC680499B}"/>
            </c:ext>
          </c:extLst>
        </c:ser>
        <c:dLbls>
          <c:showLegendKey val="0"/>
          <c:showVal val="0"/>
          <c:showCatName val="0"/>
          <c:showSerName val="0"/>
          <c:showPercent val="0"/>
          <c:showBubbleSize val="0"/>
        </c:dLbls>
        <c:axId val="-1419062656"/>
        <c:axId val="-1419047968"/>
      </c:scatterChart>
      <c:valAx>
        <c:axId val="-1419062656"/>
        <c:scaling>
          <c:orientation val="minMax"/>
        </c:scaling>
        <c:delete val="0"/>
        <c:axPos val="b"/>
        <c:title>
          <c:tx>
            <c:rich>
              <a:bodyPr rot="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dirty="0"/>
                  <a:t>SAT TNFSF12 (</a:t>
                </a:r>
                <a:r>
                  <a:rPr lang="en-US" dirty="0" err="1"/>
                  <a:t>tpm</a:t>
                </a:r>
                <a:r>
                  <a:rPr lang="en-US" dirty="0"/>
                  <a:t>)</a:t>
                </a:r>
                <a:endParaRPr lang="ko-KR" dirty="0"/>
              </a:p>
            </c:rich>
          </c:tx>
          <c:overlay val="0"/>
          <c:spPr>
            <a:noFill/>
            <a:ln>
              <a:noFill/>
            </a:ln>
            <a:effectLst/>
          </c:spPr>
          <c:txPr>
            <a:bodyPr rot="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1419047968"/>
        <c:crosses val="autoZero"/>
        <c:crossBetween val="midCat"/>
      </c:valAx>
      <c:valAx>
        <c:axId val="-1419047968"/>
        <c:scaling>
          <c:orientation val="minMax"/>
        </c:scaling>
        <c:delete val="0"/>
        <c:axPos val="l"/>
        <c:title>
          <c:tx>
            <c:rich>
              <a:bodyPr rot="-54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dirty="0"/>
                  <a:t>SAT GYG2 </a:t>
                </a:r>
                <a:r>
                  <a:rPr lang="en-US" dirty="0" smtClean="0"/>
                  <a:t>(</a:t>
                </a:r>
                <a:r>
                  <a:rPr lang="en-US" altLang="ko-KR" dirty="0" smtClean="0"/>
                  <a:t>TPM</a:t>
                </a:r>
                <a:r>
                  <a:rPr lang="en-US" dirty="0" smtClean="0"/>
                  <a:t>)</a:t>
                </a:r>
                <a:endParaRPr lang="ko-KR" dirty="0"/>
              </a:p>
            </c:rich>
          </c:tx>
          <c:layout>
            <c:manualLayout>
              <c:xMode val="edge"/>
              <c:yMode val="edge"/>
              <c:x val="1.5082777777777778E-2"/>
              <c:y val="0.20717986111111106"/>
            </c:manualLayout>
          </c:layout>
          <c:overlay val="0"/>
          <c:spPr>
            <a:noFill/>
            <a:ln>
              <a:noFill/>
            </a:ln>
            <a:effectLst/>
          </c:spPr>
          <c:txPr>
            <a:bodyPr rot="-54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1419062656"/>
        <c:crosses val="autoZero"/>
        <c:crossBetween val="midCat"/>
      </c:valAx>
      <c:spPr>
        <a:noFill/>
        <a:ln>
          <a:noFill/>
        </a:ln>
        <a:effectLst/>
      </c:spPr>
    </c:plotArea>
    <c:plotVisOnly val="1"/>
    <c:dispBlanksAs val="gap"/>
    <c:showDLblsOverMax val="0"/>
  </c:chart>
  <c:spPr>
    <a:noFill/>
    <a:ln>
      <a:noFill/>
    </a:ln>
    <a:effectLst/>
  </c:spPr>
  <c:txPr>
    <a:bodyPr/>
    <a:lstStyle/>
    <a:p>
      <a:pPr>
        <a:defRPr sz="800">
          <a:latin typeface="Arial" panose="020B0604020202020204" pitchFamily="34" charset="0"/>
          <a:cs typeface="Arial" panose="020B0604020202020204" pitchFamily="34" charset="0"/>
        </a:defRPr>
      </a:pPr>
      <a:endParaRPr lang="en-US"/>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31835763888888885"/>
          <c:y val="6.4501874187448016E-2"/>
          <c:w val="0.62392222222222216"/>
          <c:h val="0.7899565144596512"/>
        </c:manualLayout>
      </c:layout>
      <c:barChart>
        <c:barDir val="col"/>
        <c:grouping val="clustered"/>
        <c:varyColors val="0"/>
        <c:ser>
          <c:idx val="0"/>
          <c:order val="0"/>
          <c:spPr>
            <a:solidFill>
              <a:schemeClr val="accent1"/>
            </a:solidFill>
            <a:ln w="12700">
              <a:solidFill>
                <a:schemeClr val="tx1"/>
              </a:solidFill>
            </a:ln>
            <a:effectLst/>
          </c:spPr>
          <c:invertIfNegative val="0"/>
          <c:dPt>
            <c:idx val="0"/>
            <c:invertIfNegative val="0"/>
            <c:bubble3D val="0"/>
            <c:spPr>
              <a:solidFill>
                <a:schemeClr val="bg1"/>
              </a:solidFill>
              <a:ln w="12700">
                <a:solidFill>
                  <a:schemeClr val="tx1"/>
                </a:solidFill>
              </a:ln>
              <a:effectLst/>
            </c:spPr>
            <c:extLst xmlns:c16r2="http://schemas.microsoft.com/office/drawing/2015/06/chart">
              <c:ext xmlns:c16="http://schemas.microsoft.com/office/drawing/2014/chart" uri="{C3380CC4-5D6E-409C-BE32-E72D297353CC}">
                <c16:uniqueId val="{00000001-533B-42A3-9613-9DC616947AF6}"/>
              </c:ext>
            </c:extLst>
          </c:dPt>
          <c:dPt>
            <c:idx val="1"/>
            <c:invertIfNegative val="0"/>
            <c:bubble3D val="0"/>
            <c:spPr>
              <a:solidFill>
                <a:schemeClr val="bg1">
                  <a:lumMod val="65000"/>
                </a:schemeClr>
              </a:solidFill>
              <a:ln w="12700">
                <a:solidFill>
                  <a:schemeClr val="tx1"/>
                </a:solidFill>
              </a:ln>
              <a:effectLst/>
            </c:spPr>
            <c:extLst xmlns:c16r2="http://schemas.microsoft.com/office/drawing/2015/06/chart">
              <c:ext xmlns:c16="http://schemas.microsoft.com/office/drawing/2014/chart" uri="{C3380CC4-5D6E-409C-BE32-E72D297353CC}">
                <c16:uniqueId val="{00000003-533B-42A3-9613-9DC616947AF6}"/>
              </c:ext>
            </c:extLst>
          </c:dPt>
          <c:dPt>
            <c:idx val="2"/>
            <c:invertIfNegative val="0"/>
            <c:bubble3D val="0"/>
            <c:spPr>
              <a:solidFill>
                <a:schemeClr val="tx1"/>
              </a:solidFill>
              <a:ln w="12700">
                <a:solidFill>
                  <a:schemeClr val="tx1"/>
                </a:solidFill>
              </a:ln>
              <a:effectLst/>
            </c:spPr>
            <c:extLst xmlns:c16r2="http://schemas.microsoft.com/office/drawing/2015/06/chart">
              <c:ext xmlns:c16="http://schemas.microsoft.com/office/drawing/2014/chart" uri="{C3380CC4-5D6E-409C-BE32-E72D297353CC}">
                <c16:uniqueId val="{00000005-533B-42A3-9613-9DC616947AF6}"/>
              </c:ext>
            </c:extLst>
          </c:dPt>
          <c:errBars>
            <c:errBarType val="both"/>
            <c:errValType val="cust"/>
            <c:noEndCap val="0"/>
            <c:plus>
              <c:numRef>
                <c:f>(ORO_DAPI!$P$6,ORO_DAPI!$P$11,ORO_DAPI!$P$16)</c:f>
                <c:numCache>
                  <c:formatCode>General</c:formatCode>
                  <c:ptCount val="3"/>
                  <c:pt idx="0">
                    <c:v>0.14494744129642498</c:v>
                  </c:pt>
                  <c:pt idx="1">
                    <c:v>0.11621082755346439</c:v>
                  </c:pt>
                  <c:pt idx="2">
                    <c:v>0.10116131465277246</c:v>
                  </c:pt>
                </c:numCache>
              </c:numRef>
            </c:plus>
            <c:minus>
              <c:numRef>
                <c:f>(ORO_DAPI!$P$6,ORO_DAPI!$P$11,ORO_DAPI!$P$16)</c:f>
                <c:numCache>
                  <c:formatCode>General</c:formatCode>
                  <c:ptCount val="3"/>
                  <c:pt idx="0">
                    <c:v>0.14494744129642498</c:v>
                  </c:pt>
                  <c:pt idx="1">
                    <c:v>0.11621082755346439</c:v>
                  </c:pt>
                  <c:pt idx="2">
                    <c:v>0.10116131465277246</c:v>
                  </c:pt>
                </c:numCache>
              </c:numRef>
            </c:minus>
            <c:spPr>
              <a:noFill/>
              <a:ln w="12700" cap="flat" cmpd="sng" algn="ctr">
                <a:solidFill>
                  <a:schemeClr val="tx1">
                    <a:lumMod val="65000"/>
                    <a:lumOff val="35000"/>
                  </a:schemeClr>
                </a:solidFill>
                <a:round/>
              </a:ln>
              <a:effectLst/>
            </c:spPr>
          </c:errBars>
          <c:cat>
            <c:strRef>
              <c:f>(ORO_DAPI!$A$6,ORO_DAPI!$A$10,ORO_DAPI!$A$15)</c:f>
              <c:strCache>
                <c:ptCount val="3"/>
                <c:pt idx="0">
                  <c:v>0W</c:v>
                </c:pt>
                <c:pt idx="1">
                  <c:v>2W</c:v>
                </c:pt>
                <c:pt idx="2">
                  <c:v>4W</c:v>
                </c:pt>
              </c:strCache>
            </c:strRef>
          </c:cat>
          <c:val>
            <c:numRef>
              <c:f>(ORO_DAPI!$O$6,ORO_DAPI!$O$11,ORO_DAPI!$O$16)</c:f>
              <c:numCache>
                <c:formatCode>0.00</c:formatCode>
                <c:ptCount val="3"/>
                <c:pt idx="0">
                  <c:v>1</c:v>
                </c:pt>
                <c:pt idx="1">
                  <c:v>0.99201500903745388</c:v>
                </c:pt>
                <c:pt idx="2">
                  <c:v>0.88535186752863559</c:v>
                </c:pt>
              </c:numCache>
            </c:numRef>
          </c:val>
          <c:extLst xmlns:c16r2="http://schemas.microsoft.com/office/drawing/2015/06/chart">
            <c:ext xmlns:c16="http://schemas.microsoft.com/office/drawing/2014/chart" uri="{C3380CC4-5D6E-409C-BE32-E72D297353CC}">
              <c16:uniqueId val="{00000006-533B-42A3-9613-9DC616947AF6}"/>
            </c:ext>
          </c:extLst>
        </c:ser>
        <c:dLbls>
          <c:showLegendKey val="0"/>
          <c:showVal val="0"/>
          <c:showCatName val="0"/>
          <c:showSerName val="0"/>
          <c:showPercent val="0"/>
          <c:showBubbleSize val="0"/>
        </c:dLbls>
        <c:gapWidth val="219"/>
        <c:overlap val="-27"/>
        <c:axId val="-1419058304"/>
        <c:axId val="-1419056128"/>
      </c:barChart>
      <c:catAx>
        <c:axId val="-1419058304"/>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1419056128"/>
        <c:crosses val="autoZero"/>
        <c:auto val="1"/>
        <c:lblAlgn val="ctr"/>
        <c:lblOffset val="100"/>
        <c:noMultiLvlLbl val="0"/>
      </c:catAx>
      <c:valAx>
        <c:axId val="-1419056128"/>
        <c:scaling>
          <c:orientation val="minMax"/>
        </c:scaling>
        <c:delete val="0"/>
        <c:axPos val="l"/>
        <c:title>
          <c:tx>
            <c:rich>
              <a:bodyPr rot="-54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a:t>ORO area (a.u.)</a:t>
                </a:r>
                <a:endParaRPr lang="ko-KR"/>
              </a:p>
            </c:rich>
          </c:tx>
          <c:layout>
            <c:manualLayout>
              <c:xMode val="edge"/>
              <c:yMode val="edge"/>
              <c:x val="1.8531944444444445E-2"/>
              <c:y val="0.20139444444444449"/>
            </c:manualLayout>
          </c:layout>
          <c:overlay val="0"/>
          <c:spPr>
            <a:noFill/>
            <a:ln>
              <a:noFill/>
            </a:ln>
            <a:effectLst/>
          </c:spPr>
          <c:txPr>
            <a:bodyPr rot="-54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numFmt formatCode="#,##0.0_);[Red]\(#,##0.0\)" sourceLinked="0"/>
        <c:majorTickMark val="none"/>
        <c:minorTickMark val="none"/>
        <c:tickLblPos val="nextTo"/>
        <c:spPr>
          <a:noFill/>
          <a:ln>
            <a:solidFill>
              <a:schemeClr val="bg1">
                <a:lumMod val="85000"/>
              </a:schemeClr>
            </a:solidFill>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1419058304"/>
        <c:crosses val="autoZero"/>
        <c:crossBetween val="between"/>
        <c:majorUnit val="0.5"/>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sz="800">
          <a:latin typeface="Arial" panose="020B0604020202020204" pitchFamily="34" charset="0"/>
          <a:cs typeface="Arial" panose="020B0604020202020204" pitchFamily="34" charset="0"/>
        </a:defRPr>
      </a:pPr>
      <a:endParaRPr lang="en-US"/>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dPt>
            <c:idx val="0"/>
            <c:bubble3D val="0"/>
            <c:spPr>
              <a:solidFill>
                <a:schemeClr val="accent1"/>
              </a:solidFill>
              <a:ln>
                <a:noFill/>
              </a:ln>
              <a:effectLst>
                <a:outerShdw blurRad="63500" sx="102000" sy="102000" algn="ctr" rotWithShape="0">
                  <a:prstClr val="black">
                    <a:alpha val="20000"/>
                  </a:prstClr>
                </a:outerShdw>
              </a:effectLst>
            </c:spPr>
            <c:extLst xmlns:c16r2="http://schemas.microsoft.com/office/drawing/2015/06/chart">
              <c:ext xmlns:c16="http://schemas.microsoft.com/office/drawing/2014/chart" uri="{C3380CC4-5D6E-409C-BE32-E72D297353CC}">
                <c16:uniqueId val="{00000001-252F-48C5-8CD2-AFE93335A9DB}"/>
              </c:ext>
            </c:extLst>
          </c:dPt>
          <c:dPt>
            <c:idx val="1"/>
            <c:bubble3D val="0"/>
            <c:spPr>
              <a:solidFill>
                <a:schemeClr val="accent2"/>
              </a:solidFill>
              <a:ln>
                <a:noFill/>
              </a:ln>
              <a:effectLst>
                <a:outerShdw blurRad="63500" sx="102000" sy="102000" algn="ctr" rotWithShape="0">
                  <a:prstClr val="black">
                    <a:alpha val="20000"/>
                  </a:prstClr>
                </a:outerShdw>
              </a:effectLst>
            </c:spPr>
            <c:extLst xmlns:c16r2="http://schemas.microsoft.com/office/drawing/2015/06/chart">
              <c:ext xmlns:c16="http://schemas.microsoft.com/office/drawing/2014/chart" uri="{C3380CC4-5D6E-409C-BE32-E72D297353CC}">
                <c16:uniqueId val="{00000003-252F-48C5-8CD2-AFE93335A9DB}"/>
              </c:ext>
            </c:extLst>
          </c:dPt>
          <c:dPt>
            <c:idx val="2"/>
            <c:bubble3D val="0"/>
            <c:spPr>
              <a:solidFill>
                <a:schemeClr val="accent3"/>
              </a:solidFill>
              <a:ln>
                <a:noFill/>
              </a:ln>
              <a:effectLst>
                <a:outerShdw blurRad="63500" sx="102000" sy="102000" algn="ctr" rotWithShape="0">
                  <a:prstClr val="black">
                    <a:alpha val="20000"/>
                  </a:prstClr>
                </a:outerShdw>
              </a:effectLst>
            </c:spPr>
            <c:extLst xmlns:c16r2="http://schemas.microsoft.com/office/drawing/2015/06/chart">
              <c:ext xmlns:c16="http://schemas.microsoft.com/office/drawing/2014/chart" uri="{C3380CC4-5D6E-409C-BE32-E72D297353CC}">
                <c16:uniqueId val="{00000005-252F-48C5-8CD2-AFE93335A9DB}"/>
              </c:ext>
            </c:extLst>
          </c:dPt>
          <c:dLbls>
            <c:dLbl>
              <c:idx val="0"/>
              <c:spPr>
                <a:noFill/>
                <a:ln>
                  <a:noFill/>
                </a:ln>
                <a:effectLst/>
              </c:spPr>
              <c:txPr>
                <a:bodyPr rot="0" spcFirstLastPara="1" vertOverflow="ellipsis" vert="horz" wrap="square" lIns="38100" tIns="19050" rIns="38100" bIns="19050" anchor="ctr" anchorCtr="1">
                  <a:spAutoFit/>
                </a:bodyPr>
                <a:lstStyle/>
                <a:p>
                  <a:pPr>
                    <a:defRPr sz="1000" b="1" i="0" u="none" strike="noStrike" kern="1200" spc="0" baseline="0">
                      <a:solidFill>
                        <a:schemeClr val="accent1"/>
                      </a:solidFill>
                      <a:latin typeface="+mn-lt"/>
                      <a:ea typeface="+mn-ea"/>
                      <a:cs typeface="+mn-cs"/>
                    </a:defRPr>
                  </a:pPr>
                  <a:endParaRPr lang="en-US"/>
                </a:p>
              </c:txPr>
              <c:dLblPos val="outEnd"/>
              <c:showLegendKey val="0"/>
              <c:showVal val="0"/>
              <c:showCatName val="1"/>
              <c:showSerName val="0"/>
              <c:showPercent val="0"/>
              <c:showBubbleSize val="0"/>
            </c:dLbl>
            <c:dLbl>
              <c:idx val="1"/>
              <c:spPr>
                <a:noFill/>
                <a:ln>
                  <a:noFill/>
                </a:ln>
                <a:effectLst/>
              </c:spPr>
              <c:txPr>
                <a:bodyPr rot="0" spcFirstLastPara="1" vertOverflow="ellipsis" vert="horz" wrap="square" lIns="38100" tIns="19050" rIns="38100" bIns="19050" anchor="ctr" anchorCtr="1">
                  <a:spAutoFit/>
                </a:bodyPr>
                <a:lstStyle/>
                <a:p>
                  <a:pPr>
                    <a:defRPr sz="1000" b="1" i="0" u="none" strike="noStrike" kern="1200" spc="0" baseline="0">
                      <a:solidFill>
                        <a:schemeClr val="accent2"/>
                      </a:solidFill>
                      <a:latin typeface="+mn-lt"/>
                      <a:ea typeface="+mn-ea"/>
                      <a:cs typeface="+mn-cs"/>
                    </a:defRPr>
                  </a:pPr>
                  <a:endParaRPr lang="en-US"/>
                </a:p>
              </c:txPr>
              <c:dLblPos val="outEnd"/>
              <c:showLegendKey val="0"/>
              <c:showVal val="0"/>
              <c:showCatName val="1"/>
              <c:showSerName val="0"/>
              <c:showPercent val="0"/>
              <c:showBubbleSize val="0"/>
            </c:dLbl>
            <c:dLbl>
              <c:idx val="2"/>
              <c:spPr>
                <a:noFill/>
                <a:ln>
                  <a:noFill/>
                </a:ln>
                <a:effectLst/>
              </c:spPr>
              <c:txPr>
                <a:bodyPr rot="0" spcFirstLastPara="1" vertOverflow="ellipsis" vert="horz" wrap="square" lIns="38100" tIns="19050" rIns="38100" bIns="19050" anchor="ctr" anchorCtr="1">
                  <a:spAutoFit/>
                </a:bodyPr>
                <a:lstStyle/>
                <a:p>
                  <a:pPr>
                    <a:defRPr sz="1000" b="1" i="0" u="none" strike="noStrike" kern="1200" spc="0" baseline="0">
                      <a:solidFill>
                        <a:schemeClr val="accent3"/>
                      </a:solidFill>
                      <a:latin typeface="+mn-lt"/>
                      <a:ea typeface="+mn-ea"/>
                      <a:cs typeface="+mn-cs"/>
                    </a:defRPr>
                  </a:pPr>
                  <a:endParaRPr lang="en-US"/>
                </a:p>
              </c:txPr>
              <c:dLblPos val="outEnd"/>
              <c:showLegendKey val="0"/>
              <c:showVal val="0"/>
              <c:showCatName val="1"/>
              <c:showSerName val="0"/>
              <c:showPercent val="0"/>
              <c:showBubbleSize val="0"/>
            </c:dLbl>
            <c:spPr>
              <a:noFill/>
              <a:ln>
                <a:noFill/>
              </a:ln>
              <a:effectLst/>
            </c:spPr>
            <c:dLblPos val="outEnd"/>
            <c:showLegendKey val="0"/>
            <c:showVal val="0"/>
            <c:showCatName val="1"/>
            <c:showSerName val="0"/>
            <c:showPercent val="0"/>
            <c:showBubbleSize val="0"/>
            <c:showLeaderLines val="1"/>
            <c:leaderLines>
              <c:spPr>
                <a:ln w="9525" cap="flat" cmpd="sng" algn="ctr">
                  <a:solidFill>
                    <a:schemeClr val="tx1">
                      <a:lumMod val="35000"/>
                      <a:lumOff val="65000"/>
                    </a:schemeClr>
                  </a:solidFill>
                  <a:round/>
                </a:ln>
                <a:effectLst/>
              </c:spPr>
            </c:leaderLines>
            <c:extLst xmlns:c16r2="http://schemas.microsoft.com/office/drawing/2015/06/chart">
              <c:ext xmlns:c15="http://schemas.microsoft.com/office/drawing/2012/chart" uri="{CE6537A1-D6FC-4f65-9D91-7224C49458BB}"/>
            </c:extLst>
          </c:dLbls>
          <c:cat>
            <c:strRef>
              <c:f>'SenMayo_genelist_adipose tissue'!$P$7:$P$9</c:f>
              <c:strCache>
                <c:ptCount val="3"/>
                <c:pt idx="0">
                  <c:v>&lt;1</c:v>
                </c:pt>
                <c:pt idx="1">
                  <c:v>≥1 &amp; &lt;10</c:v>
                </c:pt>
                <c:pt idx="2">
                  <c:v>&gt;10</c:v>
                </c:pt>
              </c:strCache>
            </c:strRef>
          </c:cat>
          <c:val>
            <c:numRef>
              <c:f>'SenMayo_genelist_adipose tissue'!$Q$7:$Q$9</c:f>
              <c:numCache>
                <c:formatCode>General</c:formatCode>
                <c:ptCount val="3"/>
                <c:pt idx="0">
                  <c:v>35</c:v>
                </c:pt>
                <c:pt idx="1">
                  <c:v>27</c:v>
                </c:pt>
                <c:pt idx="2">
                  <c:v>65</c:v>
                </c:pt>
              </c:numCache>
            </c:numRef>
          </c:val>
          <c:extLst xmlns:c16r2="http://schemas.microsoft.com/office/drawing/2015/06/chart">
            <c:ext xmlns:c16="http://schemas.microsoft.com/office/drawing/2014/chart" uri="{C3380CC4-5D6E-409C-BE32-E72D297353CC}">
              <c16:uniqueId val="{00000006-252F-48C5-8CD2-AFE93335A9DB}"/>
            </c:ext>
          </c:extLst>
        </c:ser>
        <c:dLbls>
          <c:dLblPos val="outEnd"/>
          <c:showLegendKey val="0"/>
          <c:showVal val="0"/>
          <c:showCatName val="1"/>
          <c:showSerName val="0"/>
          <c:showPercent val="0"/>
          <c:showBubbleSize val="0"/>
          <c:showLeaderLines val="1"/>
        </c:dLbls>
        <c:firstSliceAng val="0"/>
      </c:pieChart>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dPt>
            <c:idx val="0"/>
            <c:bubble3D val="0"/>
            <c:spPr>
              <a:solidFill>
                <a:schemeClr val="accent1"/>
              </a:solidFill>
              <a:ln>
                <a:noFill/>
              </a:ln>
              <a:effectLst>
                <a:outerShdw blurRad="63500" sx="102000" sy="102000" algn="ctr" rotWithShape="0">
                  <a:prstClr val="black">
                    <a:alpha val="20000"/>
                  </a:prstClr>
                </a:outerShdw>
              </a:effectLst>
            </c:spPr>
            <c:extLst xmlns:c16r2="http://schemas.microsoft.com/office/drawing/2015/06/chart">
              <c:ext xmlns:c16="http://schemas.microsoft.com/office/drawing/2014/chart" uri="{C3380CC4-5D6E-409C-BE32-E72D297353CC}">
                <c16:uniqueId val="{00000001-A47D-4EE3-9D77-C39E850B9D56}"/>
              </c:ext>
            </c:extLst>
          </c:dPt>
          <c:dPt>
            <c:idx val="1"/>
            <c:bubble3D val="0"/>
            <c:spPr>
              <a:solidFill>
                <a:schemeClr val="accent2"/>
              </a:solidFill>
              <a:ln>
                <a:noFill/>
              </a:ln>
              <a:effectLst>
                <a:outerShdw blurRad="63500" sx="102000" sy="102000" algn="ctr" rotWithShape="0">
                  <a:prstClr val="black">
                    <a:alpha val="20000"/>
                  </a:prstClr>
                </a:outerShdw>
              </a:effectLst>
            </c:spPr>
            <c:extLst xmlns:c16r2="http://schemas.microsoft.com/office/drawing/2015/06/chart">
              <c:ext xmlns:c16="http://schemas.microsoft.com/office/drawing/2014/chart" uri="{C3380CC4-5D6E-409C-BE32-E72D297353CC}">
                <c16:uniqueId val="{00000003-A47D-4EE3-9D77-C39E850B9D56}"/>
              </c:ext>
            </c:extLst>
          </c:dPt>
          <c:dPt>
            <c:idx val="2"/>
            <c:bubble3D val="0"/>
            <c:spPr>
              <a:solidFill>
                <a:schemeClr val="accent3"/>
              </a:solidFill>
              <a:ln>
                <a:noFill/>
              </a:ln>
              <a:effectLst>
                <a:outerShdw blurRad="63500" sx="102000" sy="102000" algn="ctr" rotWithShape="0">
                  <a:prstClr val="black">
                    <a:alpha val="20000"/>
                  </a:prstClr>
                </a:outerShdw>
              </a:effectLst>
            </c:spPr>
            <c:extLst xmlns:c16r2="http://schemas.microsoft.com/office/drawing/2015/06/chart">
              <c:ext xmlns:c16="http://schemas.microsoft.com/office/drawing/2014/chart" uri="{C3380CC4-5D6E-409C-BE32-E72D297353CC}">
                <c16:uniqueId val="{00000005-A47D-4EE3-9D77-C39E850B9D56}"/>
              </c:ext>
            </c:extLst>
          </c:dPt>
          <c:dLbls>
            <c:dLbl>
              <c:idx val="0"/>
              <c:spPr>
                <a:noFill/>
                <a:ln>
                  <a:noFill/>
                </a:ln>
                <a:effectLst/>
              </c:spPr>
              <c:txPr>
                <a:bodyPr rot="0" spcFirstLastPara="1" vertOverflow="ellipsis" vert="horz" wrap="square" lIns="38100" tIns="19050" rIns="38100" bIns="19050" anchor="ctr" anchorCtr="1">
                  <a:spAutoFit/>
                </a:bodyPr>
                <a:lstStyle/>
                <a:p>
                  <a:pPr>
                    <a:defRPr sz="1000" b="1" i="0" u="none" strike="noStrike" kern="1200" spc="0" baseline="0">
                      <a:solidFill>
                        <a:schemeClr val="accent1"/>
                      </a:solidFill>
                      <a:latin typeface="+mn-lt"/>
                      <a:ea typeface="+mn-ea"/>
                      <a:cs typeface="+mn-cs"/>
                    </a:defRPr>
                  </a:pPr>
                  <a:endParaRPr lang="en-US"/>
                </a:p>
              </c:txPr>
              <c:dLblPos val="outEnd"/>
              <c:showLegendKey val="0"/>
              <c:showVal val="0"/>
              <c:showCatName val="1"/>
              <c:showSerName val="0"/>
              <c:showPercent val="0"/>
              <c:showBubbleSize val="0"/>
            </c:dLbl>
            <c:dLbl>
              <c:idx val="1"/>
              <c:spPr>
                <a:noFill/>
                <a:ln>
                  <a:noFill/>
                </a:ln>
                <a:effectLst/>
              </c:spPr>
              <c:txPr>
                <a:bodyPr rot="0" spcFirstLastPara="1" vertOverflow="ellipsis" vert="horz" wrap="square" lIns="38100" tIns="19050" rIns="38100" bIns="19050" anchor="ctr" anchorCtr="1">
                  <a:spAutoFit/>
                </a:bodyPr>
                <a:lstStyle/>
                <a:p>
                  <a:pPr>
                    <a:defRPr sz="1000" b="1" i="0" u="none" strike="noStrike" kern="1200" spc="0" baseline="0">
                      <a:solidFill>
                        <a:schemeClr val="accent2"/>
                      </a:solidFill>
                      <a:latin typeface="+mn-lt"/>
                      <a:ea typeface="+mn-ea"/>
                      <a:cs typeface="+mn-cs"/>
                    </a:defRPr>
                  </a:pPr>
                  <a:endParaRPr lang="en-US"/>
                </a:p>
              </c:txPr>
              <c:dLblPos val="outEnd"/>
              <c:showLegendKey val="0"/>
              <c:showVal val="0"/>
              <c:showCatName val="1"/>
              <c:showSerName val="0"/>
              <c:showPercent val="0"/>
              <c:showBubbleSize val="0"/>
            </c:dLbl>
            <c:dLbl>
              <c:idx val="2"/>
              <c:spPr>
                <a:noFill/>
                <a:ln>
                  <a:noFill/>
                </a:ln>
                <a:effectLst/>
              </c:spPr>
              <c:txPr>
                <a:bodyPr rot="0" spcFirstLastPara="1" vertOverflow="ellipsis" vert="horz" wrap="square" lIns="38100" tIns="19050" rIns="38100" bIns="19050" anchor="ctr" anchorCtr="1">
                  <a:spAutoFit/>
                </a:bodyPr>
                <a:lstStyle/>
                <a:p>
                  <a:pPr>
                    <a:defRPr sz="1000" b="1" i="0" u="none" strike="noStrike" kern="1200" spc="0" baseline="0">
                      <a:solidFill>
                        <a:schemeClr val="accent3"/>
                      </a:solidFill>
                      <a:latin typeface="+mn-lt"/>
                      <a:ea typeface="+mn-ea"/>
                      <a:cs typeface="+mn-cs"/>
                    </a:defRPr>
                  </a:pPr>
                  <a:endParaRPr lang="en-US"/>
                </a:p>
              </c:txPr>
              <c:dLblPos val="outEnd"/>
              <c:showLegendKey val="0"/>
              <c:showVal val="0"/>
              <c:showCatName val="1"/>
              <c:showSerName val="0"/>
              <c:showPercent val="0"/>
              <c:showBubbleSize val="0"/>
            </c:dLbl>
            <c:spPr>
              <a:noFill/>
              <a:ln>
                <a:noFill/>
              </a:ln>
              <a:effectLst/>
            </c:spPr>
            <c:dLblPos val="outEnd"/>
            <c:showLegendKey val="0"/>
            <c:showVal val="0"/>
            <c:showCatName val="1"/>
            <c:showSerName val="0"/>
            <c:showPercent val="0"/>
            <c:showBubbleSize val="0"/>
            <c:showLeaderLines val="1"/>
            <c:leaderLines>
              <c:spPr>
                <a:ln w="9525" cap="flat" cmpd="sng" algn="ctr">
                  <a:solidFill>
                    <a:schemeClr val="tx1">
                      <a:lumMod val="35000"/>
                      <a:lumOff val="65000"/>
                    </a:schemeClr>
                  </a:solidFill>
                  <a:round/>
                </a:ln>
                <a:effectLst/>
              </c:spPr>
            </c:leaderLines>
            <c:extLst xmlns:c16r2="http://schemas.microsoft.com/office/drawing/2015/06/chart">
              <c:ext xmlns:c15="http://schemas.microsoft.com/office/drawing/2012/chart" uri="{CE6537A1-D6FC-4f65-9D91-7224C49458BB}"/>
            </c:extLst>
          </c:dLbls>
          <c:cat>
            <c:strRef>
              <c:f>'Genage_gelelist_adipose tissue'!$Q$3:$Q$5</c:f>
              <c:strCache>
                <c:ptCount val="3"/>
                <c:pt idx="0">
                  <c:v>&lt;1</c:v>
                </c:pt>
                <c:pt idx="1">
                  <c:v>≥1 &amp; &lt;10</c:v>
                </c:pt>
                <c:pt idx="2">
                  <c:v>&gt;10</c:v>
                </c:pt>
              </c:strCache>
            </c:strRef>
          </c:cat>
          <c:val>
            <c:numRef>
              <c:f>'Genage_gelelist_adipose tissue'!$R$3:$R$5</c:f>
              <c:numCache>
                <c:formatCode>General</c:formatCode>
                <c:ptCount val="3"/>
                <c:pt idx="0">
                  <c:v>37</c:v>
                </c:pt>
                <c:pt idx="1">
                  <c:v>52</c:v>
                </c:pt>
                <c:pt idx="2">
                  <c:v>218</c:v>
                </c:pt>
              </c:numCache>
            </c:numRef>
          </c:val>
          <c:extLst xmlns:c16r2="http://schemas.microsoft.com/office/drawing/2015/06/chart">
            <c:ext xmlns:c16="http://schemas.microsoft.com/office/drawing/2014/chart" uri="{C3380CC4-5D6E-409C-BE32-E72D297353CC}">
              <c16:uniqueId val="{00000006-A47D-4EE3-9D77-C39E850B9D56}"/>
            </c:ext>
          </c:extLst>
        </c:ser>
        <c:dLbls>
          <c:dLblPos val="outEnd"/>
          <c:showLegendKey val="0"/>
          <c:showVal val="0"/>
          <c:showCatName val="1"/>
          <c:showSerName val="0"/>
          <c:showPercent val="0"/>
          <c:showBubbleSize val="0"/>
          <c:showLeaderLines val="1"/>
        </c:dLbls>
        <c:firstSliceAng val="0"/>
      </c:pieChart>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10.xml><?xml version="1.0" encoding="utf-8"?>
<cs:chartStyle xmlns:cs="http://schemas.microsoft.com/office/drawing/2012/chartStyle" xmlns:a="http://schemas.openxmlformats.org/drawingml/2006/main" id="259">
  <cs:axisTitle>
    <cs:lnRef idx="0"/>
    <cs:fillRef idx="0"/>
    <cs:effectRef idx="0"/>
    <cs:fontRef idx="minor">
      <a:schemeClr val="tx1">
        <a:lumMod val="65000"/>
        <a:lumOff val="35000"/>
      </a:schemeClr>
    </cs:fontRef>
    <cs:defRPr sz="900" kern="1200" cap="all"/>
  </cs:axisTitle>
  <cs:categoryAxis>
    <cs:lnRef idx="0"/>
    <cs:fillRef idx="0"/>
    <cs:effectRef idx="0"/>
    <cs:fontRef idx="minor">
      <a:schemeClr val="tx1">
        <a:lumMod val="65000"/>
        <a:lumOff val="35000"/>
      </a:schemeClr>
    </cs:fontRef>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cs:styleClr val="auto"/>
    </cs:fontRef>
    <cs:defRPr sz="1000" b="1" i="0" u="none" strike="noStrike" kern="1200" spc="0" baseline="0"/>
  </cs:dataLabel>
  <cs:dataLabelCallout>
    <cs:lnRef idx="0">
      <cs:styleClr val="auto"/>
    </cs:lnRef>
    <cs:fillRef idx="0"/>
    <cs:effectRef idx="0"/>
    <cs:fontRef idx="minor">
      <cs:styleClr val="auto"/>
    </cs:fontRef>
    <cs:spPr>
      <a:solidFill>
        <a:schemeClr val="lt1"/>
      </a:solidFill>
      <a:ln>
        <a:solidFill>
          <a:schemeClr val="phClr"/>
        </a:solidFill>
      </a:ln>
    </cs:spPr>
    <cs:defRPr sz="1000" b="1"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dk1"/>
    </cs:fontRef>
    <cs:spPr>
      <a:solidFill>
        <a:schemeClr val="phClr"/>
      </a:solidFill>
      <a:effectLst>
        <a:outerShdw blurRad="63500" sx="102000" sy="102000" algn="ctr" rotWithShape="0">
          <a:prstClr val="black">
            <a:alpha val="20000"/>
          </a:prstClr>
        </a:outerShdw>
      </a:effectLst>
    </cs:spPr>
  </cs:dataPoint>
  <cs:dataPoint3D>
    <cs:lnRef idx="0"/>
    <cs:fillRef idx="0">
      <cs:styleClr val="auto"/>
    </cs:fillRef>
    <cs:effectRef idx="0"/>
    <cs:fontRef idx="minor">
      <a:schemeClr val="dk1"/>
    </cs:fontRef>
    <cs:spPr>
      <a:solidFill>
        <a:schemeClr val="phClr"/>
      </a:solidFill>
      <a:effectLst>
        <a:outerShdw blurRad="88900" sx="102000" sy="102000" algn="ctr" rotWithShape="0">
          <a:prstClr val="black">
            <a:alpha val="10000"/>
          </a:prstClr>
        </a:outerShdw>
      </a:effectLst>
      <a:scene3d>
        <a:camera prst="orthographicFront"/>
        <a:lightRig rig="threePt" dir="t"/>
      </a:scene3d>
      <a:sp3d>
        <a:bevelT w="127000" h="127000"/>
        <a:bevelB w="127000" h="127000"/>
      </a:sp3d>
    </cs:spPr>
  </cs:dataPoint3D>
  <cs:dataPointLine>
    <cs:lnRef idx="0">
      <cs:styleClr val="auto"/>
    </cs:lnRef>
    <cs:fillRef idx="0"/>
    <cs:effectRef idx="0"/>
    <cs:fontRef idx="minor">
      <a:schemeClr val="dk1"/>
    </cs:fontRef>
    <cs:spPr>
      <a:ln w="28575" cap="rnd">
        <a:solidFill>
          <a:schemeClr val="phClr"/>
        </a:solidFill>
        <a:round/>
      </a:ln>
    </cs:spPr>
  </cs:dataPointLine>
  <cs:dataPointMarker>
    <cs:lnRef idx="0"/>
    <cs:fillRef idx="0">
      <cs:styleClr val="auto"/>
    </cs:fillRef>
    <cs:effectRef idx="0"/>
    <cs:fontRef idx="minor">
      <a:schemeClr val="dk1"/>
    </cs:fontRef>
    <cs:spPr>
      <a:solidFill>
        <a:schemeClr val="phClr"/>
      </a:solidFill>
      <a:ln w="9525">
        <a:solidFill>
          <a:schemeClr val="lt1"/>
        </a:solidFill>
      </a:ln>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600" b="1" kern="1200" cap="all" baseline="0"/>
  </cs:title>
  <cs:trendline>
    <cs:lnRef idx="0">
      <cs:styleClr val="auto"/>
    </cs:lnRef>
    <cs:fillRef idx="0"/>
    <cs:effectRef idx="0"/>
    <cs:fontRef idx="minor">
      <a:schemeClr val="tx1"/>
    </cs:fontRef>
    <cs:spPr>
      <a:ln w="19050" cap="rnd">
        <a:solidFill>
          <a:schemeClr val="phClr"/>
        </a:solidFill>
        <a:prstDash val="sysDash"/>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59">
  <cs:axisTitle>
    <cs:lnRef idx="0"/>
    <cs:fillRef idx="0"/>
    <cs:effectRef idx="0"/>
    <cs:fontRef idx="minor">
      <a:schemeClr val="tx1">
        <a:lumMod val="65000"/>
        <a:lumOff val="35000"/>
      </a:schemeClr>
    </cs:fontRef>
    <cs:defRPr sz="900" kern="1200" cap="all"/>
  </cs:axisTitle>
  <cs:categoryAxis>
    <cs:lnRef idx="0"/>
    <cs:fillRef idx="0"/>
    <cs:effectRef idx="0"/>
    <cs:fontRef idx="minor">
      <a:schemeClr val="tx1">
        <a:lumMod val="65000"/>
        <a:lumOff val="35000"/>
      </a:schemeClr>
    </cs:fontRef>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cs:styleClr val="auto"/>
    </cs:fontRef>
    <cs:defRPr sz="1000" b="1" i="0" u="none" strike="noStrike" kern="1200" spc="0" baseline="0"/>
  </cs:dataLabel>
  <cs:dataLabelCallout>
    <cs:lnRef idx="0">
      <cs:styleClr val="auto"/>
    </cs:lnRef>
    <cs:fillRef idx="0"/>
    <cs:effectRef idx="0"/>
    <cs:fontRef idx="minor">
      <cs:styleClr val="auto"/>
    </cs:fontRef>
    <cs:spPr>
      <a:solidFill>
        <a:schemeClr val="lt1"/>
      </a:solidFill>
      <a:ln>
        <a:solidFill>
          <a:schemeClr val="phClr"/>
        </a:solidFill>
      </a:ln>
    </cs:spPr>
    <cs:defRPr sz="1000" b="1"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dk1"/>
    </cs:fontRef>
    <cs:spPr>
      <a:solidFill>
        <a:schemeClr val="phClr"/>
      </a:solidFill>
      <a:effectLst>
        <a:outerShdw blurRad="63500" sx="102000" sy="102000" algn="ctr" rotWithShape="0">
          <a:prstClr val="black">
            <a:alpha val="20000"/>
          </a:prstClr>
        </a:outerShdw>
      </a:effectLst>
    </cs:spPr>
  </cs:dataPoint>
  <cs:dataPoint3D>
    <cs:lnRef idx="0"/>
    <cs:fillRef idx="0">
      <cs:styleClr val="auto"/>
    </cs:fillRef>
    <cs:effectRef idx="0"/>
    <cs:fontRef idx="minor">
      <a:schemeClr val="dk1"/>
    </cs:fontRef>
    <cs:spPr>
      <a:solidFill>
        <a:schemeClr val="phClr"/>
      </a:solidFill>
      <a:effectLst>
        <a:outerShdw blurRad="88900" sx="102000" sy="102000" algn="ctr" rotWithShape="0">
          <a:prstClr val="black">
            <a:alpha val="10000"/>
          </a:prstClr>
        </a:outerShdw>
      </a:effectLst>
      <a:scene3d>
        <a:camera prst="orthographicFront"/>
        <a:lightRig rig="threePt" dir="t"/>
      </a:scene3d>
      <a:sp3d>
        <a:bevelT w="127000" h="127000"/>
        <a:bevelB w="127000" h="127000"/>
      </a:sp3d>
    </cs:spPr>
  </cs:dataPoint3D>
  <cs:dataPointLine>
    <cs:lnRef idx="0">
      <cs:styleClr val="auto"/>
    </cs:lnRef>
    <cs:fillRef idx="0"/>
    <cs:effectRef idx="0"/>
    <cs:fontRef idx="minor">
      <a:schemeClr val="dk1"/>
    </cs:fontRef>
    <cs:spPr>
      <a:ln w="28575" cap="rnd">
        <a:solidFill>
          <a:schemeClr val="phClr"/>
        </a:solidFill>
        <a:round/>
      </a:ln>
    </cs:spPr>
  </cs:dataPointLine>
  <cs:dataPointMarker>
    <cs:lnRef idx="0"/>
    <cs:fillRef idx="0">
      <cs:styleClr val="auto"/>
    </cs:fillRef>
    <cs:effectRef idx="0"/>
    <cs:fontRef idx="minor">
      <a:schemeClr val="dk1"/>
    </cs:fontRef>
    <cs:spPr>
      <a:solidFill>
        <a:schemeClr val="phClr"/>
      </a:solidFill>
      <a:ln w="9525">
        <a:solidFill>
          <a:schemeClr val="lt1"/>
        </a:solidFill>
      </a:ln>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600" b="1" kern="1200" cap="all" baseline="0"/>
  </cs:title>
  <cs:trendline>
    <cs:lnRef idx="0">
      <cs:styleClr val="auto"/>
    </cs:lnRef>
    <cs:fillRef idx="0"/>
    <cs:effectRef idx="0"/>
    <cs:fontRef idx="minor">
      <a:schemeClr val="tx1"/>
    </cs:fontRef>
    <cs:spPr>
      <a:ln w="19050" cap="rnd">
        <a:solidFill>
          <a:schemeClr val="phClr"/>
        </a:solidFill>
        <a:prstDash val="sysDash"/>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59">
  <cs:axisTitle>
    <cs:lnRef idx="0"/>
    <cs:fillRef idx="0"/>
    <cs:effectRef idx="0"/>
    <cs:fontRef idx="minor">
      <a:schemeClr val="tx1">
        <a:lumMod val="65000"/>
        <a:lumOff val="35000"/>
      </a:schemeClr>
    </cs:fontRef>
    <cs:defRPr sz="900" kern="1200" cap="all"/>
  </cs:axisTitle>
  <cs:categoryAxis>
    <cs:lnRef idx="0"/>
    <cs:fillRef idx="0"/>
    <cs:effectRef idx="0"/>
    <cs:fontRef idx="minor">
      <a:schemeClr val="tx1">
        <a:lumMod val="65000"/>
        <a:lumOff val="35000"/>
      </a:schemeClr>
    </cs:fontRef>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cs:styleClr val="auto"/>
    </cs:fontRef>
    <cs:defRPr sz="1000" b="1" i="0" u="none" strike="noStrike" kern="1200" spc="0" baseline="0"/>
  </cs:dataLabel>
  <cs:dataLabelCallout>
    <cs:lnRef idx="0">
      <cs:styleClr val="auto"/>
    </cs:lnRef>
    <cs:fillRef idx="0"/>
    <cs:effectRef idx="0"/>
    <cs:fontRef idx="minor">
      <cs:styleClr val="auto"/>
    </cs:fontRef>
    <cs:spPr>
      <a:solidFill>
        <a:schemeClr val="lt1"/>
      </a:solidFill>
      <a:ln>
        <a:solidFill>
          <a:schemeClr val="phClr"/>
        </a:solidFill>
      </a:ln>
    </cs:spPr>
    <cs:defRPr sz="1000" b="1"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dk1"/>
    </cs:fontRef>
    <cs:spPr>
      <a:solidFill>
        <a:schemeClr val="phClr"/>
      </a:solidFill>
      <a:effectLst>
        <a:outerShdw blurRad="63500" sx="102000" sy="102000" algn="ctr" rotWithShape="0">
          <a:prstClr val="black">
            <a:alpha val="20000"/>
          </a:prstClr>
        </a:outerShdw>
      </a:effectLst>
    </cs:spPr>
  </cs:dataPoint>
  <cs:dataPoint3D>
    <cs:lnRef idx="0"/>
    <cs:fillRef idx="0">
      <cs:styleClr val="auto"/>
    </cs:fillRef>
    <cs:effectRef idx="0"/>
    <cs:fontRef idx="minor">
      <a:schemeClr val="dk1"/>
    </cs:fontRef>
    <cs:spPr>
      <a:solidFill>
        <a:schemeClr val="phClr"/>
      </a:solidFill>
      <a:effectLst>
        <a:outerShdw blurRad="88900" sx="102000" sy="102000" algn="ctr" rotWithShape="0">
          <a:prstClr val="black">
            <a:alpha val="10000"/>
          </a:prstClr>
        </a:outerShdw>
      </a:effectLst>
      <a:scene3d>
        <a:camera prst="orthographicFront"/>
        <a:lightRig rig="threePt" dir="t"/>
      </a:scene3d>
      <a:sp3d>
        <a:bevelT w="127000" h="127000"/>
        <a:bevelB w="127000" h="127000"/>
      </a:sp3d>
    </cs:spPr>
  </cs:dataPoint3D>
  <cs:dataPointLine>
    <cs:lnRef idx="0">
      <cs:styleClr val="auto"/>
    </cs:lnRef>
    <cs:fillRef idx="0"/>
    <cs:effectRef idx="0"/>
    <cs:fontRef idx="minor">
      <a:schemeClr val="dk1"/>
    </cs:fontRef>
    <cs:spPr>
      <a:ln w="28575" cap="rnd">
        <a:solidFill>
          <a:schemeClr val="phClr"/>
        </a:solidFill>
        <a:round/>
      </a:ln>
    </cs:spPr>
  </cs:dataPointLine>
  <cs:dataPointMarker>
    <cs:lnRef idx="0"/>
    <cs:fillRef idx="0">
      <cs:styleClr val="auto"/>
    </cs:fillRef>
    <cs:effectRef idx="0"/>
    <cs:fontRef idx="minor">
      <a:schemeClr val="dk1"/>
    </cs:fontRef>
    <cs:spPr>
      <a:solidFill>
        <a:schemeClr val="phClr"/>
      </a:solidFill>
      <a:ln w="9525">
        <a:solidFill>
          <a:schemeClr val="lt1"/>
        </a:solidFill>
      </a:ln>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600" b="1" kern="1200" cap="all" baseline="0"/>
  </cs:title>
  <cs:trendline>
    <cs:lnRef idx="0">
      <cs:styleClr val="auto"/>
    </cs:lnRef>
    <cs:fillRef idx="0"/>
    <cs:effectRef idx="0"/>
    <cs:fontRef idx="minor">
      <a:schemeClr val="tx1"/>
    </cs:fontRef>
    <cs:spPr>
      <a:ln w="19050" cap="rnd">
        <a:solidFill>
          <a:schemeClr val="phClr"/>
        </a:solidFill>
        <a:prstDash val="sysDash"/>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49099" cy="498693"/>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54939" y="0"/>
            <a:ext cx="2949099" cy="498693"/>
          </a:xfrm>
          <a:prstGeom prst="rect">
            <a:avLst/>
          </a:prstGeom>
        </p:spPr>
        <p:txBody>
          <a:bodyPr vert="horz" lIns="91440" tIns="45720" rIns="91440" bIns="45720" rtlCol="0"/>
          <a:lstStyle>
            <a:lvl1pPr algn="r">
              <a:defRPr sz="1200"/>
            </a:lvl1pPr>
          </a:lstStyle>
          <a:p>
            <a:fld id="{57698F45-270E-44F1-A7CD-5E5F22B1535A}" type="datetimeFigureOut">
              <a:rPr lang="ko-KR" altLang="en-US" smtClean="0"/>
              <a:t>2023-11-16</a:t>
            </a:fld>
            <a:endParaRPr lang="ko-KR" altLang="en-US"/>
          </a:p>
        </p:txBody>
      </p:sp>
      <p:sp>
        <p:nvSpPr>
          <p:cNvPr id="4" name="슬라이드 이미지 개체 틀 3"/>
          <p:cNvSpPr>
            <a:spLocks noGrp="1" noRot="1" noChangeAspect="1"/>
          </p:cNvSpPr>
          <p:nvPr>
            <p:ph type="sldImg" idx="2"/>
          </p:nvPr>
        </p:nvSpPr>
        <p:spPr>
          <a:xfrm>
            <a:off x="2146300" y="1243013"/>
            <a:ext cx="2513013" cy="3354387"/>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80562" y="4783307"/>
            <a:ext cx="5444490" cy="3913614"/>
          </a:xfrm>
          <a:prstGeom prst="rect">
            <a:avLst/>
          </a:prstGeom>
        </p:spPr>
        <p:txBody>
          <a:bodyPr vert="horz" lIns="91440" tIns="45720" rIns="91440" bIns="45720" rtlCol="0"/>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6" name="바닥글 개체 틀 5"/>
          <p:cNvSpPr>
            <a:spLocks noGrp="1"/>
          </p:cNvSpPr>
          <p:nvPr>
            <p:ph type="ftr" sz="quarter" idx="4"/>
          </p:nvPr>
        </p:nvSpPr>
        <p:spPr>
          <a:xfrm>
            <a:off x="0" y="9440647"/>
            <a:ext cx="2949099" cy="498692"/>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54939" y="9440647"/>
            <a:ext cx="2949099" cy="498692"/>
          </a:xfrm>
          <a:prstGeom prst="rect">
            <a:avLst/>
          </a:prstGeom>
        </p:spPr>
        <p:txBody>
          <a:bodyPr vert="horz" lIns="91440" tIns="45720" rIns="91440" bIns="45720" rtlCol="0" anchor="b"/>
          <a:lstStyle>
            <a:lvl1pPr algn="r">
              <a:defRPr sz="1200"/>
            </a:lvl1pPr>
          </a:lstStyle>
          <a:p>
            <a:fld id="{4C98E984-C175-4C64-A692-9F7356E6928E}" type="slidenum">
              <a:rPr lang="ko-KR" altLang="en-US" smtClean="0"/>
              <a:t>‹#›</a:t>
            </a:fld>
            <a:endParaRPr lang="ko-KR" altLang="en-US"/>
          </a:p>
        </p:txBody>
      </p:sp>
    </p:spTree>
    <p:extLst>
      <p:ext uri="{BB962C8B-B14F-4D97-AF65-F5344CB8AC3E}">
        <p14:creationId xmlns:p14="http://schemas.microsoft.com/office/powerpoint/2010/main" val="2550692128"/>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pPr marL="0" indent="0">
              <a:buNone/>
            </a:pPr>
            <a:endParaRPr lang="ko-KR" altLang="en-US" dirty="0"/>
          </a:p>
        </p:txBody>
      </p:sp>
      <p:sp>
        <p:nvSpPr>
          <p:cNvPr id="4" name="슬라이드 번호 개체 틀 3"/>
          <p:cNvSpPr>
            <a:spLocks noGrp="1"/>
          </p:cNvSpPr>
          <p:nvPr>
            <p:ph type="sldNum" sz="quarter" idx="10"/>
          </p:nvPr>
        </p:nvSpPr>
        <p:spPr/>
        <p:txBody>
          <a:bodyPr/>
          <a:lstStyle/>
          <a:p>
            <a:fld id="{4C98E984-C175-4C64-A692-9F7356E6928E}" type="slidenum">
              <a:rPr lang="ko-KR" altLang="en-US" smtClean="0"/>
              <a:t>1</a:t>
            </a:fld>
            <a:endParaRPr lang="ko-KR" altLang="en-US"/>
          </a:p>
        </p:txBody>
      </p:sp>
    </p:spTree>
    <p:extLst>
      <p:ext uri="{BB962C8B-B14F-4D97-AF65-F5344CB8AC3E}">
        <p14:creationId xmlns:p14="http://schemas.microsoft.com/office/powerpoint/2010/main" val="35593034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dirty="0"/>
          </a:p>
        </p:txBody>
      </p:sp>
      <p:sp>
        <p:nvSpPr>
          <p:cNvPr id="4" name="슬라이드 번호 개체 틀 3"/>
          <p:cNvSpPr>
            <a:spLocks noGrp="1"/>
          </p:cNvSpPr>
          <p:nvPr>
            <p:ph type="sldNum" sz="quarter" idx="10"/>
          </p:nvPr>
        </p:nvSpPr>
        <p:spPr/>
        <p:txBody>
          <a:bodyPr/>
          <a:lstStyle/>
          <a:p>
            <a:fld id="{4C98E984-C175-4C64-A692-9F7356E6928E}" type="slidenum">
              <a:rPr lang="ko-KR" altLang="en-US" smtClean="0"/>
              <a:t>3</a:t>
            </a:fld>
            <a:endParaRPr lang="ko-KR" altLang="en-US"/>
          </a:p>
        </p:txBody>
      </p:sp>
    </p:spTree>
    <p:extLst>
      <p:ext uri="{BB962C8B-B14F-4D97-AF65-F5344CB8AC3E}">
        <p14:creationId xmlns:p14="http://schemas.microsoft.com/office/powerpoint/2010/main" val="234808337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r>
              <a:rPr lang="en-US" altLang="ko-KR" sz="1200" dirty="0"/>
              <a:t>Method</a:t>
            </a:r>
          </a:p>
          <a:p>
            <a:r>
              <a:rPr lang="en-US" altLang="ko-KR" sz="1200" dirty="0"/>
              <a:t>Determination of Lipid Accumulation</a:t>
            </a:r>
          </a:p>
          <a:p>
            <a:r>
              <a:rPr lang="en-US" altLang="ko-KR" sz="1200" dirty="0"/>
              <a:t>To examine lipid accumulation, the cells were fixed with paraformaldehyde and stained with Oil Red O. Four images of each group were used for the analysis of the relative mean area of lipid droplets using </a:t>
            </a:r>
            <a:r>
              <a:rPr lang="en-US" altLang="ko-KR" sz="1200" dirty="0" err="1"/>
              <a:t>ImageJ</a:t>
            </a:r>
            <a:r>
              <a:rPr lang="en-US" altLang="ko-KR" sz="1200" dirty="0"/>
              <a:t>. The lipid droplets were outlined and their area was measured, and then the mean ± SD was calculated. </a:t>
            </a:r>
          </a:p>
          <a:p>
            <a:endParaRPr lang="en-US" altLang="ko-KR" sz="1200" dirty="0"/>
          </a:p>
          <a:p>
            <a:r>
              <a:rPr lang="en-US" altLang="ko-KR" sz="1200" dirty="0"/>
              <a:t>ref) https://www.ncbi.nlm.nih.gov/pmc/articles/PMC8439418/</a:t>
            </a:r>
            <a:endParaRPr lang="ko-KR" altLang="en-US" sz="1200" dirty="0"/>
          </a:p>
          <a:p>
            <a:endParaRPr lang="ko-KR" altLang="en-US" dirty="0"/>
          </a:p>
        </p:txBody>
      </p:sp>
      <p:sp>
        <p:nvSpPr>
          <p:cNvPr id="4" name="슬라이드 번호 개체 틀 3"/>
          <p:cNvSpPr>
            <a:spLocks noGrp="1"/>
          </p:cNvSpPr>
          <p:nvPr>
            <p:ph type="sldNum" sz="quarter" idx="10"/>
          </p:nvPr>
        </p:nvSpPr>
        <p:spPr/>
        <p:txBody>
          <a:bodyPr/>
          <a:lstStyle/>
          <a:p>
            <a:fld id="{4C98E984-C175-4C64-A692-9F7356E6928E}" type="slidenum">
              <a:rPr lang="ko-KR" altLang="en-US" smtClean="0"/>
              <a:t>4</a:t>
            </a:fld>
            <a:endParaRPr lang="ko-KR" altLang="en-US"/>
          </a:p>
        </p:txBody>
      </p:sp>
    </p:spTree>
    <p:extLst>
      <p:ext uri="{BB962C8B-B14F-4D97-AF65-F5344CB8AC3E}">
        <p14:creationId xmlns:p14="http://schemas.microsoft.com/office/powerpoint/2010/main" val="185621339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dirty="0"/>
          </a:p>
        </p:txBody>
      </p:sp>
      <p:sp>
        <p:nvSpPr>
          <p:cNvPr id="4" name="슬라이드 번호 개체 틀 3"/>
          <p:cNvSpPr>
            <a:spLocks noGrp="1"/>
          </p:cNvSpPr>
          <p:nvPr>
            <p:ph type="sldNum" sz="quarter" idx="10"/>
          </p:nvPr>
        </p:nvSpPr>
        <p:spPr/>
        <p:txBody>
          <a:bodyPr/>
          <a:lstStyle/>
          <a:p>
            <a:fld id="{4C98E984-C175-4C64-A692-9F7356E6928E}" type="slidenum">
              <a:rPr lang="ko-KR" altLang="en-US" smtClean="0"/>
              <a:t>5</a:t>
            </a:fld>
            <a:endParaRPr lang="ko-KR" altLang="en-US"/>
          </a:p>
        </p:txBody>
      </p:sp>
    </p:spTree>
    <p:extLst>
      <p:ext uri="{BB962C8B-B14F-4D97-AF65-F5344CB8AC3E}">
        <p14:creationId xmlns:p14="http://schemas.microsoft.com/office/powerpoint/2010/main" val="51281605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dirty="0"/>
          </a:p>
        </p:txBody>
      </p:sp>
      <p:sp>
        <p:nvSpPr>
          <p:cNvPr id="4" name="슬라이드 번호 개체 틀 3"/>
          <p:cNvSpPr>
            <a:spLocks noGrp="1"/>
          </p:cNvSpPr>
          <p:nvPr>
            <p:ph type="sldNum" sz="quarter" idx="10"/>
          </p:nvPr>
        </p:nvSpPr>
        <p:spPr/>
        <p:txBody>
          <a:bodyPr/>
          <a:lstStyle/>
          <a:p>
            <a:fld id="{4C98E984-C175-4C64-A692-9F7356E6928E}" type="slidenum">
              <a:rPr lang="ko-KR" altLang="en-US" smtClean="0"/>
              <a:t>6</a:t>
            </a:fld>
            <a:endParaRPr lang="ko-KR" altLang="en-US"/>
          </a:p>
        </p:txBody>
      </p:sp>
    </p:spTree>
    <p:extLst>
      <p:ext uri="{BB962C8B-B14F-4D97-AF65-F5344CB8AC3E}">
        <p14:creationId xmlns:p14="http://schemas.microsoft.com/office/powerpoint/2010/main" val="309004603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ko-KR" altLang="en-US"/>
              <a:t>마스터 제목 스타일 편집</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ko-KR" altLang="en-US"/>
              <a:t>클릭하여 마스터 부제목 스타일 편집</a:t>
            </a:r>
            <a:endParaRPr lang="en-US" dirty="0"/>
          </a:p>
        </p:txBody>
      </p:sp>
      <p:sp>
        <p:nvSpPr>
          <p:cNvPr id="4" name="Date Placeholder 3"/>
          <p:cNvSpPr>
            <a:spLocks noGrp="1"/>
          </p:cNvSpPr>
          <p:nvPr>
            <p:ph type="dt" sz="half" idx="10"/>
          </p:nvPr>
        </p:nvSpPr>
        <p:spPr/>
        <p:txBody>
          <a:bodyPr/>
          <a:lstStyle/>
          <a:p>
            <a:fld id="{FBEAF422-363D-4410-B12C-C901038EA544}" type="datetimeFigureOut">
              <a:rPr lang="ko-KR" altLang="en-US" smtClean="0"/>
              <a:t>2023-11-1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65A8FA1B-9D15-479C-BBC2-E9FA55289E52}" type="slidenum">
              <a:rPr lang="ko-KR" altLang="en-US" smtClean="0"/>
              <a:t>‹#›</a:t>
            </a:fld>
            <a:endParaRPr lang="ko-KR" altLang="en-US"/>
          </a:p>
        </p:txBody>
      </p:sp>
    </p:spTree>
    <p:extLst>
      <p:ext uri="{BB962C8B-B14F-4D97-AF65-F5344CB8AC3E}">
        <p14:creationId xmlns:p14="http://schemas.microsoft.com/office/powerpoint/2010/main" val="14958939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FBEAF422-363D-4410-B12C-C901038EA544}" type="datetimeFigureOut">
              <a:rPr lang="ko-KR" altLang="en-US" smtClean="0"/>
              <a:t>2023-11-1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65A8FA1B-9D15-479C-BBC2-E9FA55289E52}" type="slidenum">
              <a:rPr lang="ko-KR" altLang="en-US" smtClean="0"/>
              <a:t>‹#›</a:t>
            </a:fld>
            <a:endParaRPr lang="ko-KR" altLang="en-US"/>
          </a:p>
        </p:txBody>
      </p:sp>
    </p:spTree>
    <p:extLst>
      <p:ext uri="{BB962C8B-B14F-4D97-AF65-F5344CB8AC3E}">
        <p14:creationId xmlns:p14="http://schemas.microsoft.com/office/powerpoint/2010/main" val="325537014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FBEAF422-363D-4410-B12C-C901038EA544}" type="datetimeFigureOut">
              <a:rPr lang="ko-KR" altLang="en-US" smtClean="0"/>
              <a:t>2023-11-1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65A8FA1B-9D15-479C-BBC2-E9FA55289E52}" type="slidenum">
              <a:rPr lang="ko-KR" altLang="en-US" smtClean="0"/>
              <a:t>‹#›</a:t>
            </a:fld>
            <a:endParaRPr lang="ko-KR" altLang="en-US"/>
          </a:p>
        </p:txBody>
      </p:sp>
    </p:spTree>
    <p:extLst>
      <p:ext uri="{BB962C8B-B14F-4D97-AF65-F5344CB8AC3E}">
        <p14:creationId xmlns:p14="http://schemas.microsoft.com/office/powerpoint/2010/main" val="167783825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FBEAF422-363D-4410-B12C-C901038EA544}" type="datetimeFigureOut">
              <a:rPr lang="ko-KR" altLang="en-US" smtClean="0"/>
              <a:t>2023-11-1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65A8FA1B-9D15-479C-BBC2-E9FA55289E52}" type="slidenum">
              <a:rPr lang="ko-KR" altLang="en-US" smtClean="0"/>
              <a:t>‹#›</a:t>
            </a:fld>
            <a:endParaRPr lang="ko-KR" altLang="en-US"/>
          </a:p>
        </p:txBody>
      </p:sp>
    </p:spTree>
    <p:extLst>
      <p:ext uri="{BB962C8B-B14F-4D97-AF65-F5344CB8AC3E}">
        <p14:creationId xmlns:p14="http://schemas.microsoft.com/office/powerpoint/2010/main" val="304897865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ko-KR" altLang="en-US"/>
              <a:t>마스터 제목 스타일 편집</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ko-KR" altLang="en-US"/>
              <a:t>마스터 텍스트 스타일 편집</a:t>
            </a:r>
          </a:p>
        </p:txBody>
      </p:sp>
      <p:sp>
        <p:nvSpPr>
          <p:cNvPr id="4" name="Date Placeholder 3"/>
          <p:cNvSpPr>
            <a:spLocks noGrp="1"/>
          </p:cNvSpPr>
          <p:nvPr>
            <p:ph type="dt" sz="half" idx="10"/>
          </p:nvPr>
        </p:nvSpPr>
        <p:spPr/>
        <p:txBody>
          <a:bodyPr/>
          <a:lstStyle/>
          <a:p>
            <a:fld id="{FBEAF422-363D-4410-B12C-C901038EA544}" type="datetimeFigureOut">
              <a:rPr lang="ko-KR" altLang="en-US" smtClean="0"/>
              <a:t>2023-11-1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65A8FA1B-9D15-479C-BBC2-E9FA55289E52}" type="slidenum">
              <a:rPr lang="ko-KR" altLang="en-US" smtClean="0"/>
              <a:t>‹#›</a:t>
            </a:fld>
            <a:endParaRPr lang="ko-KR" altLang="en-US"/>
          </a:p>
        </p:txBody>
      </p:sp>
    </p:spTree>
    <p:extLst>
      <p:ext uri="{BB962C8B-B14F-4D97-AF65-F5344CB8AC3E}">
        <p14:creationId xmlns:p14="http://schemas.microsoft.com/office/powerpoint/2010/main" val="405477331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Date Placeholder 4"/>
          <p:cNvSpPr>
            <a:spLocks noGrp="1"/>
          </p:cNvSpPr>
          <p:nvPr>
            <p:ph type="dt" sz="half" idx="10"/>
          </p:nvPr>
        </p:nvSpPr>
        <p:spPr/>
        <p:txBody>
          <a:bodyPr/>
          <a:lstStyle/>
          <a:p>
            <a:fld id="{FBEAF422-363D-4410-B12C-C901038EA544}" type="datetimeFigureOut">
              <a:rPr lang="ko-KR" altLang="en-US" smtClean="0"/>
              <a:t>2023-11-16</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65A8FA1B-9D15-479C-BBC2-E9FA55289E52}" type="slidenum">
              <a:rPr lang="ko-KR" altLang="en-US" smtClean="0"/>
              <a:t>‹#›</a:t>
            </a:fld>
            <a:endParaRPr lang="ko-KR" altLang="en-US"/>
          </a:p>
        </p:txBody>
      </p:sp>
    </p:spTree>
    <p:extLst>
      <p:ext uri="{BB962C8B-B14F-4D97-AF65-F5344CB8AC3E}">
        <p14:creationId xmlns:p14="http://schemas.microsoft.com/office/powerpoint/2010/main" val="22839160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 편집</a:t>
            </a:r>
          </a:p>
        </p:txBody>
      </p:sp>
      <p:sp>
        <p:nvSpPr>
          <p:cNvPr id="4" name="Content Placeholder 3"/>
          <p:cNvSpPr>
            <a:spLocks noGrp="1"/>
          </p:cNvSpPr>
          <p:nvPr>
            <p:ph sz="half" idx="2"/>
          </p:nvPr>
        </p:nvSpPr>
        <p:spPr>
          <a:xfrm>
            <a:off x="472381" y="3340100"/>
            <a:ext cx="2901255" cy="4912784"/>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 편집</a:t>
            </a:r>
          </a:p>
        </p:txBody>
      </p:sp>
      <p:sp>
        <p:nvSpPr>
          <p:cNvPr id="6" name="Content Placeholder 5"/>
          <p:cNvSpPr>
            <a:spLocks noGrp="1"/>
          </p:cNvSpPr>
          <p:nvPr>
            <p:ph sz="quarter" idx="4"/>
          </p:nvPr>
        </p:nvSpPr>
        <p:spPr>
          <a:xfrm>
            <a:off x="3471863" y="3340100"/>
            <a:ext cx="2915543" cy="4912784"/>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7" name="Date Placeholder 6"/>
          <p:cNvSpPr>
            <a:spLocks noGrp="1"/>
          </p:cNvSpPr>
          <p:nvPr>
            <p:ph type="dt" sz="half" idx="10"/>
          </p:nvPr>
        </p:nvSpPr>
        <p:spPr/>
        <p:txBody>
          <a:bodyPr/>
          <a:lstStyle/>
          <a:p>
            <a:fld id="{FBEAF422-363D-4410-B12C-C901038EA544}" type="datetimeFigureOut">
              <a:rPr lang="ko-KR" altLang="en-US" smtClean="0"/>
              <a:t>2023-11-16</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65A8FA1B-9D15-479C-BBC2-E9FA55289E52}" type="slidenum">
              <a:rPr lang="ko-KR" altLang="en-US" smtClean="0"/>
              <a:t>‹#›</a:t>
            </a:fld>
            <a:endParaRPr lang="ko-KR" altLang="en-US"/>
          </a:p>
        </p:txBody>
      </p:sp>
    </p:spTree>
    <p:extLst>
      <p:ext uri="{BB962C8B-B14F-4D97-AF65-F5344CB8AC3E}">
        <p14:creationId xmlns:p14="http://schemas.microsoft.com/office/powerpoint/2010/main" val="54011863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FBEAF422-363D-4410-B12C-C901038EA544}" type="datetimeFigureOut">
              <a:rPr lang="ko-KR" altLang="en-US" smtClean="0"/>
              <a:t>2023-11-16</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65A8FA1B-9D15-479C-BBC2-E9FA55289E52}" type="slidenum">
              <a:rPr lang="ko-KR" altLang="en-US" smtClean="0"/>
              <a:t>‹#›</a:t>
            </a:fld>
            <a:endParaRPr lang="ko-KR" altLang="en-US"/>
          </a:p>
        </p:txBody>
      </p:sp>
    </p:spTree>
    <p:extLst>
      <p:ext uri="{BB962C8B-B14F-4D97-AF65-F5344CB8AC3E}">
        <p14:creationId xmlns:p14="http://schemas.microsoft.com/office/powerpoint/2010/main" val="398282644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BEAF422-363D-4410-B12C-C901038EA544}" type="datetimeFigureOut">
              <a:rPr lang="ko-KR" altLang="en-US" smtClean="0"/>
              <a:t>2023-11-16</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65A8FA1B-9D15-479C-BBC2-E9FA55289E52}" type="slidenum">
              <a:rPr lang="ko-KR" altLang="en-US" smtClean="0"/>
              <a:t>‹#›</a:t>
            </a:fld>
            <a:endParaRPr lang="ko-KR" altLang="en-US"/>
          </a:p>
        </p:txBody>
      </p:sp>
    </p:spTree>
    <p:extLst>
      <p:ext uri="{BB962C8B-B14F-4D97-AF65-F5344CB8AC3E}">
        <p14:creationId xmlns:p14="http://schemas.microsoft.com/office/powerpoint/2010/main" val="20048541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ko-KR" altLang="en-US"/>
              <a:t>마스터 제목 스타일 편집</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 편집</a:t>
            </a:r>
          </a:p>
        </p:txBody>
      </p:sp>
      <p:sp>
        <p:nvSpPr>
          <p:cNvPr id="5" name="Date Placeholder 4"/>
          <p:cNvSpPr>
            <a:spLocks noGrp="1"/>
          </p:cNvSpPr>
          <p:nvPr>
            <p:ph type="dt" sz="half" idx="10"/>
          </p:nvPr>
        </p:nvSpPr>
        <p:spPr/>
        <p:txBody>
          <a:bodyPr/>
          <a:lstStyle/>
          <a:p>
            <a:fld id="{FBEAF422-363D-4410-B12C-C901038EA544}" type="datetimeFigureOut">
              <a:rPr lang="ko-KR" altLang="en-US" smtClean="0"/>
              <a:t>2023-11-16</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65A8FA1B-9D15-479C-BBC2-E9FA55289E52}" type="slidenum">
              <a:rPr lang="ko-KR" altLang="en-US" smtClean="0"/>
              <a:t>‹#›</a:t>
            </a:fld>
            <a:endParaRPr lang="ko-KR" altLang="en-US"/>
          </a:p>
        </p:txBody>
      </p:sp>
    </p:spTree>
    <p:extLst>
      <p:ext uri="{BB962C8B-B14F-4D97-AF65-F5344CB8AC3E}">
        <p14:creationId xmlns:p14="http://schemas.microsoft.com/office/powerpoint/2010/main" val="224413180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 편집</a:t>
            </a:r>
          </a:p>
        </p:txBody>
      </p:sp>
      <p:sp>
        <p:nvSpPr>
          <p:cNvPr id="5" name="Date Placeholder 4"/>
          <p:cNvSpPr>
            <a:spLocks noGrp="1"/>
          </p:cNvSpPr>
          <p:nvPr>
            <p:ph type="dt" sz="half" idx="10"/>
          </p:nvPr>
        </p:nvSpPr>
        <p:spPr/>
        <p:txBody>
          <a:bodyPr/>
          <a:lstStyle/>
          <a:p>
            <a:fld id="{FBEAF422-363D-4410-B12C-C901038EA544}" type="datetimeFigureOut">
              <a:rPr lang="ko-KR" altLang="en-US" smtClean="0"/>
              <a:t>2023-11-16</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65A8FA1B-9D15-479C-BBC2-E9FA55289E52}" type="slidenum">
              <a:rPr lang="ko-KR" altLang="en-US" smtClean="0"/>
              <a:t>‹#›</a:t>
            </a:fld>
            <a:endParaRPr lang="ko-KR" altLang="en-US"/>
          </a:p>
        </p:txBody>
      </p:sp>
    </p:spTree>
    <p:extLst>
      <p:ext uri="{BB962C8B-B14F-4D97-AF65-F5344CB8AC3E}">
        <p14:creationId xmlns:p14="http://schemas.microsoft.com/office/powerpoint/2010/main" val="15904684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FBEAF422-363D-4410-B12C-C901038EA544}" type="datetimeFigureOut">
              <a:rPr lang="ko-KR" altLang="en-US" smtClean="0"/>
              <a:t>2023-11-16</a:t>
            </a:fld>
            <a:endParaRPr lang="ko-KR" alt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65A8FA1B-9D15-479C-BBC2-E9FA55289E52}" type="slidenum">
              <a:rPr lang="ko-KR" altLang="en-US" smtClean="0"/>
              <a:t>‹#›</a:t>
            </a:fld>
            <a:endParaRPr lang="ko-KR" altLang="en-US"/>
          </a:p>
        </p:txBody>
      </p:sp>
    </p:spTree>
    <p:extLst>
      <p:ext uri="{BB962C8B-B14F-4D97-AF65-F5344CB8AC3E}">
        <p14:creationId xmlns:p14="http://schemas.microsoft.com/office/powerpoint/2010/main" val="3034948238"/>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800" rtl="0" eaLnBrk="1" latinLnBrk="1"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1"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1"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1"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1" hangingPunct="1">
        <a:defRPr sz="1350" kern="1200">
          <a:solidFill>
            <a:schemeClr val="tx1"/>
          </a:solidFill>
          <a:latin typeface="+mn-lt"/>
          <a:ea typeface="+mn-ea"/>
          <a:cs typeface="+mn-cs"/>
        </a:defRPr>
      </a:lvl1pPr>
      <a:lvl2pPr marL="342900" algn="l" defTabSz="685800" rtl="0" eaLnBrk="1" latinLnBrk="1" hangingPunct="1">
        <a:defRPr sz="1350" kern="1200">
          <a:solidFill>
            <a:schemeClr val="tx1"/>
          </a:solidFill>
          <a:latin typeface="+mn-lt"/>
          <a:ea typeface="+mn-ea"/>
          <a:cs typeface="+mn-cs"/>
        </a:defRPr>
      </a:lvl2pPr>
      <a:lvl3pPr marL="685800" algn="l" defTabSz="685800" rtl="0" eaLnBrk="1" latinLnBrk="1" hangingPunct="1">
        <a:defRPr sz="1350" kern="1200">
          <a:solidFill>
            <a:schemeClr val="tx1"/>
          </a:solidFill>
          <a:latin typeface="+mn-lt"/>
          <a:ea typeface="+mn-ea"/>
          <a:cs typeface="+mn-cs"/>
        </a:defRPr>
      </a:lvl3pPr>
      <a:lvl4pPr marL="1028700" algn="l" defTabSz="685800" rtl="0" eaLnBrk="1" latinLnBrk="1" hangingPunct="1">
        <a:defRPr sz="1350" kern="1200">
          <a:solidFill>
            <a:schemeClr val="tx1"/>
          </a:solidFill>
          <a:latin typeface="+mn-lt"/>
          <a:ea typeface="+mn-ea"/>
          <a:cs typeface="+mn-cs"/>
        </a:defRPr>
      </a:lvl4pPr>
      <a:lvl5pPr marL="1371600" algn="l" defTabSz="685800" rtl="0" eaLnBrk="1" latinLnBrk="1" hangingPunct="1">
        <a:defRPr sz="1350" kern="1200">
          <a:solidFill>
            <a:schemeClr val="tx1"/>
          </a:solidFill>
          <a:latin typeface="+mn-lt"/>
          <a:ea typeface="+mn-ea"/>
          <a:cs typeface="+mn-cs"/>
        </a:defRPr>
      </a:lvl5pPr>
      <a:lvl6pPr marL="1714500" algn="l" defTabSz="685800" rtl="0" eaLnBrk="1" latinLnBrk="1" hangingPunct="1">
        <a:defRPr sz="1350" kern="1200">
          <a:solidFill>
            <a:schemeClr val="tx1"/>
          </a:solidFill>
          <a:latin typeface="+mn-lt"/>
          <a:ea typeface="+mn-ea"/>
          <a:cs typeface="+mn-cs"/>
        </a:defRPr>
      </a:lvl6pPr>
      <a:lvl7pPr marL="2057400" algn="l" defTabSz="685800" rtl="0" eaLnBrk="1" latinLnBrk="1" hangingPunct="1">
        <a:defRPr sz="1350" kern="1200">
          <a:solidFill>
            <a:schemeClr val="tx1"/>
          </a:solidFill>
          <a:latin typeface="+mn-lt"/>
          <a:ea typeface="+mn-ea"/>
          <a:cs typeface="+mn-cs"/>
        </a:defRPr>
      </a:lvl7pPr>
      <a:lvl8pPr marL="2400300" algn="l" defTabSz="685800" rtl="0" eaLnBrk="1" latinLnBrk="1" hangingPunct="1">
        <a:defRPr sz="1350" kern="1200">
          <a:solidFill>
            <a:schemeClr val="tx1"/>
          </a:solidFill>
          <a:latin typeface="+mn-lt"/>
          <a:ea typeface="+mn-ea"/>
          <a:cs typeface="+mn-cs"/>
        </a:defRPr>
      </a:lvl8pPr>
      <a:lvl9pPr marL="2743200" algn="l" defTabSz="685800" rtl="0" eaLnBrk="1" latinLnBrk="1"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4.png"/><Relationship Id="rId3" Type="http://schemas.openxmlformats.org/officeDocument/2006/relationships/notesSlide" Target="../notesSlides/notesSlide1.xml"/><Relationship Id="rId7" Type="http://schemas.openxmlformats.org/officeDocument/2006/relationships/image" Target="../media/image3.png"/><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1.emf"/><Relationship Id="rId5" Type="http://schemas.openxmlformats.org/officeDocument/2006/relationships/oleObject" Target="../embeddings/oleObject1.bin"/><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8" Type="http://schemas.openxmlformats.org/officeDocument/2006/relationships/image" Target="../media/image11.jpeg"/><Relationship Id="rId13" Type="http://schemas.openxmlformats.org/officeDocument/2006/relationships/image" Target="../media/image16.jpeg"/><Relationship Id="rId3" Type="http://schemas.openxmlformats.org/officeDocument/2006/relationships/image" Target="../media/image6.jpeg"/><Relationship Id="rId7" Type="http://schemas.openxmlformats.org/officeDocument/2006/relationships/image" Target="../media/image10.jpeg"/><Relationship Id="rId12" Type="http://schemas.openxmlformats.org/officeDocument/2006/relationships/image" Target="../media/image15.jpeg"/><Relationship Id="rId17" Type="http://schemas.openxmlformats.org/officeDocument/2006/relationships/image" Target="../media/image20.jpeg"/><Relationship Id="rId2" Type="http://schemas.openxmlformats.org/officeDocument/2006/relationships/image" Target="../media/image5.jpeg"/><Relationship Id="rId16" Type="http://schemas.openxmlformats.org/officeDocument/2006/relationships/image" Target="../media/image19.jpeg"/><Relationship Id="rId1" Type="http://schemas.openxmlformats.org/officeDocument/2006/relationships/slideLayout" Target="../slideLayouts/slideLayout7.xml"/><Relationship Id="rId6" Type="http://schemas.openxmlformats.org/officeDocument/2006/relationships/image" Target="../media/image9.jpeg"/><Relationship Id="rId11" Type="http://schemas.openxmlformats.org/officeDocument/2006/relationships/image" Target="../media/image14.jpeg"/><Relationship Id="rId5" Type="http://schemas.openxmlformats.org/officeDocument/2006/relationships/image" Target="../media/image8.jpeg"/><Relationship Id="rId15" Type="http://schemas.openxmlformats.org/officeDocument/2006/relationships/image" Target="../media/image18.jpeg"/><Relationship Id="rId10" Type="http://schemas.openxmlformats.org/officeDocument/2006/relationships/image" Target="../media/image13.jpeg"/><Relationship Id="rId4" Type="http://schemas.openxmlformats.org/officeDocument/2006/relationships/image" Target="../media/image7.jpeg"/><Relationship Id="rId9" Type="http://schemas.openxmlformats.org/officeDocument/2006/relationships/image" Target="../media/image12.jpeg"/><Relationship Id="rId14" Type="http://schemas.openxmlformats.org/officeDocument/2006/relationships/image" Target="../media/image17.jpeg"/></Relationships>
</file>

<file path=ppt/slides/_rels/slide3.xml.rels><?xml version="1.0" encoding="UTF-8" standalone="yes"?>
<Relationships xmlns="http://schemas.openxmlformats.org/package/2006/relationships"><Relationship Id="rId8" Type="http://schemas.openxmlformats.org/officeDocument/2006/relationships/chart" Target="../charts/chart6.xml"/><Relationship Id="rId3" Type="http://schemas.openxmlformats.org/officeDocument/2006/relationships/chart" Target="../charts/chart1.xml"/><Relationship Id="rId7" Type="http://schemas.openxmlformats.org/officeDocument/2006/relationships/chart" Target="../charts/chart5.xml"/><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chart" Target="../charts/chart4.xml"/><Relationship Id="rId5" Type="http://schemas.openxmlformats.org/officeDocument/2006/relationships/chart" Target="../charts/chart3.xml"/><Relationship Id="rId4" Type="http://schemas.openxmlformats.org/officeDocument/2006/relationships/chart" Target="../charts/chart2.xml"/></Relationships>
</file>

<file path=ppt/slides/_rels/slide4.xml.rels><?xml version="1.0" encoding="UTF-8" standalone="yes"?>
<Relationships xmlns="http://schemas.openxmlformats.org/package/2006/relationships"><Relationship Id="rId3" Type="http://schemas.openxmlformats.org/officeDocument/2006/relationships/chart" Target="../charts/chart7.xml"/><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23.tiff"/><Relationship Id="rId5" Type="http://schemas.openxmlformats.org/officeDocument/2006/relationships/image" Target="../media/image22.tiff"/><Relationship Id="rId4" Type="http://schemas.openxmlformats.org/officeDocument/2006/relationships/image" Target="../media/image21.tiff"/></Relationships>
</file>

<file path=ppt/slides/_rels/slide5.xml.rels><?xml version="1.0" encoding="UTF-8" standalone="yes"?>
<Relationships xmlns="http://schemas.openxmlformats.org/package/2006/relationships"><Relationship Id="rId3" Type="http://schemas.openxmlformats.org/officeDocument/2006/relationships/chart" Target="../charts/chart8.xml"/><Relationship Id="rId2" Type="http://schemas.openxmlformats.org/officeDocument/2006/relationships/notesSlide" Target="../notesSlides/notesSlide4.xml"/><Relationship Id="rId1" Type="http://schemas.openxmlformats.org/officeDocument/2006/relationships/slideLayout" Target="../slideLayouts/slideLayout7.xml"/><Relationship Id="rId5" Type="http://schemas.openxmlformats.org/officeDocument/2006/relationships/chart" Target="../charts/chart10.xml"/><Relationship Id="rId4" Type="http://schemas.openxmlformats.org/officeDocument/2006/relationships/chart" Target="../charts/chart9.xml"/></Relationships>
</file>

<file path=ppt/slides/_rels/slide6.xml.rels><?xml version="1.0" encoding="UTF-8" standalone="yes"?>
<Relationships xmlns="http://schemas.openxmlformats.org/package/2006/relationships"><Relationship Id="rId8" Type="http://schemas.openxmlformats.org/officeDocument/2006/relationships/image" Target="../media/image29.jpeg"/><Relationship Id="rId3" Type="http://schemas.openxmlformats.org/officeDocument/2006/relationships/image" Target="../media/image24.emf"/><Relationship Id="rId7" Type="http://schemas.openxmlformats.org/officeDocument/2006/relationships/image" Target="../media/image28.jpeg"/><Relationship Id="rId2" Type="http://schemas.openxmlformats.org/officeDocument/2006/relationships/notesSlide" Target="../notesSlides/notesSlide5.xml"/><Relationship Id="rId1" Type="http://schemas.openxmlformats.org/officeDocument/2006/relationships/slideLayout" Target="../slideLayouts/slideLayout7.xml"/><Relationship Id="rId6" Type="http://schemas.openxmlformats.org/officeDocument/2006/relationships/image" Target="../media/image27.emf"/><Relationship Id="rId5" Type="http://schemas.openxmlformats.org/officeDocument/2006/relationships/image" Target="../media/image26.emf"/><Relationship Id="rId10" Type="http://schemas.openxmlformats.org/officeDocument/2006/relationships/image" Target="../media/image31.emf"/><Relationship Id="rId4" Type="http://schemas.openxmlformats.org/officeDocument/2006/relationships/image" Target="../media/image25.emf"/><Relationship Id="rId9" Type="http://schemas.openxmlformats.org/officeDocument/2006/relationships/image" Target="../media/image30.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0" y="117643"/>
            <a:ext cx="4452730" cy="369332"/>
          </a:xfrm>
          <a:prstGeom prst="rect">
            <a:avLst/>
          </a:prstGeom>
          <a:noFill/>
        </p:spPr>
        <p:txBody>
          <a:bodyPr wrap="square" rtlCol="0">
            <a:spAutoFit/>
          </a:bodyPr>
          <a:lstStyle/>
          <a:p>
            <a:r>
              <a:rPr lang="en-US" altLang="ko-KR" dirty="0"/>
              <a:t>Supplementary Figure 1</a:t>
            </a:r>
            <a:endParaRPr lang="ko-KR" altLang="en-US" dirty="0"/>
          </a:p>
        </p:txBody>
      </p:sp>
      <p:pic>
        <p:nvPicPr>
          <p:cNvPr id="3" name="그림 2"/>
          <p:cNvPicPr>
            <a:picLocks noChangeAspect="1"/>
          </p:cNvPicPr>
          <p:nvPr/>
        </p:nvPicPr>
        <p:blipFill>
          <a:blip r:embed="rId4"/>
          <a:stretch>
            <a:fillRect/>
          </a:stretch>
        </p:blipFill>
        <p:spPr>
          <a:xfrm>
            <a:off x="3429000" y="3200699"/>
            <a:ext cx="2737333" cy="2801385"/>
          </a:xfrm>
          <a:prstGeom prst="rect">
            <a:avLst/>
          </a:prstGeom>
        </p:spPr>
      </p:pic>
      <p:sp>
        <p:nvSpPr>
          <p:cNvPr id="4" name="TextBox 3"/>
          <p:cNvSpPr txBox="1"/>
          <p:nvPr/>
        </p:nvSpPr>
        <p:spPr>
          <a:xfrm>
            <a:off x="629008" y="2875532"/>
            <a:ext cx="205868" cy="246221"/>
          </a:xfrm>
          <a:prstGeom prst="rect">
            <a:avLst/>
          </a:prstGeom>
          <a:noFill/>
        </p:spPr>
        <p:txBody>
          <a:bodyPr wrap="square" rtlCol="0">
            <a:spAutoFit/>
          </a:bodyPr>
          <a:lstStyle/>
          <a:p>
            <a:r>
              <a:rPr lang="en-US" altLang="ko-KR" sz="1000" b="1" dirty="0">
                <a:latin typeface="Arial" panose="020B0604020202020204" pitchFamily="34" charset="0"/>
                <a:cs typeface="Arial" panose="020B0604020202020204" pitchFamily="34" charset="0"/>
              </a:rPr>
              <a:t>C</a:t>
            </a:r>
            <a:endParaRPr lang="ko-KR" altLang="en-US" sz="1000" b="1" dirty="0">
              <a:latin typeface="Arial" panose="020B0604020202020204" pitchFamily="34" charset="0"/>
              <a:cs typeface="Arial" panose="020B0604020202020204" pitchFamily="34" charset="0"/>
            </a:endParaRPr>
          </a:p>
        </p:txBody>
      </p:sp>
      <p:graphicFrame>
        <p:nvGraphicFramePr>
          <p:cNvPr id="5" name="개체 4"/>
          <p:cNvGraphicFramePr>
            <a:graphicFrameLocks noChangeAspect="1"/>
          </p:cNvGraphicFramePr>
          <p:nvPr>
            <p:extLst>
              <p:ext uri="{D42A27DB-BD31-4B8C-83A1-F6EECF244321}">
                <p14:modId xmlns:p14="http://schemas.microsoft.com/office/powerpoint/2010/main" val="4134082347"/>
              </p:ext>
            </p:extLst>
          </p:nvPr>
        </p:nvGraphicFramePr>
        <p:xfrm>
          <a:off x="578374" y="3200699"/>
          <a:ext cx="2729454" cy="1910459"/>
        </p:xfrm>
        <a:graphic>
          <a:graphicData uri="http://schemas.openxmlformats.org/presentationml/2006/ole">
            <mc:AlternateContent xmlns:mc="http://schemas.openxmlformats.org/markup-compatibility/2006">
              <mc:Choice xmlns:v="urn:schemas-microsoft-com:vml" Requires="v">
                <p:oleObj spid="_x0000_s1037" name="Acrobat Document" r:id="rId5" imgW="5486400" imgH="3840480" progId="AcroExch.Document.DC">
                  <p:embed/>
                </p:oleObj>
              </mc:Choice>
              <mc:Fallback>
                <p:oleObj name="Acrobat Document" r:id="rId5" imgW="5486400" imgH="3840480" progId="AcroExch.Document.DC">
                  <p:embed/>
                  <p:pic>
                    <p:nvPicPr>
                      <p:cNvPr id="5" name="개체 4"/>
                      <p:cNvPicPr/>
                      <p:nvPr/>
                    </p:nvPicPr>
                    <p:blipFill>
                      <a:blip r:embed="rId6"/>
                      <a:stretch>
                        <a:fillRect/>
                      </a:stretch>
                    </p:blipFill>
                    <p:spPr>
                      <a:xfrm>
                        <a:off x="578374" y="3200699"/>
                        <a:ext cx="2729454" cy="1910459"/>
                      </a:xfrm>
                      <a:prstGeom prst="rect">
                        <a:avLst/>
                      </a:prstGeom>
                    </p:spPr>
                  </p:pic>
                </p:oleObj>
              </mc:Fallback>
            </mc:AlternateContent>
          </a:graphicData>
        </a:graphic>
      </p:graphicFrame>
      <p:sp>
        <p:nvSpPr>
          <p:cNvPr id="6" name="TextBox 5"/>
          <p:cNvSpPr txBox="1"/>
          <p:nvPr/>
        </p:nvSpPr>
        <p:spPr>
          <a:xfrm>
            <a:off x="3429000" y="2875532"/>
            <a:ext cx="205868" cy="246221"/>
          </a:xfrm>
          <a:prstGeom prst="rect">
            <a:avLst/>
          </a:prstGeom>
          <a:noFill/>
        </p:spPr>
        <p:txBody>
          <a:bodyPr wrap="square" rtlCol="0">
            <a:spAutoFit/>
          </a:bodyPr>
          <a:lstStyle/>
          <a:p>
            <a:r>
              <a:rPr lang="en-US" altLang="ko-KR" sz="1000" b="1" dirty="0">
                <a:latin typeface="Arial" panose="020B0604020202020204" pitchFamily="34" charset="0"/>
                <a:cs typeface="Arial" panose="020B0604020202020204" pitchFamily="34" charset="0"/>
              </a:rPr>
              <a:t>D</a:t>
            </a:r>
            <a:endParaRPr lang="ko-KR" altLang="en-US" sz="1000" b="1" dirty="0">
              <a:latin typeface="Arial" panose="020B0604020202020204" pitchFamily="34" charset="0"/>
              <a:cs typeface="Arial" panose="020B0604020202020204" pitchFamily="34" charset="0"/>
            </a:endParaRPr>
          </a:p>
        </p:txBody>
      </p:sp>
      <p:sp>
        <p:nvSpPr>
          <p:cNvPr id="8" name="TextBox 7"/>
          <p:cNvSpPr txBox="1"/>
          <p:nvPr/>
        </p:nvSpPr>
        <p:spPr>
          <a:xfrm>
            <a:off x="556494" y="711647"/>
            <a:ext cx="340341" cy="246221"/>
          </a:xfrm>
          <a:prstGeom prst="rect">
            <a:avLst/>
          </a:prstGeom>
          <a:noFill/>
        </p:spPr>
        <p:txBody>
          <a:bodyPr wrap="square" rtlCol="0">
            <a:spAutoFit/>
          </a:bodyPr>
          <a:lstStyle/>
          <a:p>
            <a:r>
              <a:rPr lang="en-US" altLang="ko-KR" sz="1000" b="1" dirty="0">
                <a:latin typeface="Arial" panose="020B0604020202020204" pitchFamily="34" charset="0"/>
                <a:cs typeface="Arial" panose="020B0604020202020204" pitchFamily="34" charset="0"/>
              </a:rPr>
              <a:t>A</a:t>
            </a:r>
            <a:endParaRPr lang="ko-KR" altLang="en-US" sz="1000" b="1" dirty="0">
              <a:latin typeface="Arial" panose="020B0604020202020204" pitchFamily="34" charset="0"/>
              <a:cs typeface="Arial" panose="020B0604020202020204" pitchFamily="34" charset="0"/>
            </a:endParaRPr>
          </a:p>
        </p:txBody>
      </p:sp>
      <p:sp>
        <p:nvSpPr>
          <p:cNvPr id="9" name="TextBox 8"/>
          <p:cNvSpPr txBox="1"/>
          <p:nvPr/>
        </p:nvSpPr>
        <p:spPr>
          <a:xfrm>
            <a:off x="3214095" y="711647"/>
            <a:ext cx="478608" cy="246221"/>
          </a:xfrm>
          <a:prstGeom prst="rect">
            <a:avLst/>
          </a:prstGeom>
          <a:noFill/>
        </p:spPr>
        <p:txBody>
          <a:bodyPr wrap="square" rtlCol="0">
            <a:spAutoFit/>
          </a:bodyPr>
          <a:lstStyle/>
          <a:p>
            <a:r>
              <a:rPr lang="en-US" altLang="ko-KR" sz="1000" b="1" dirty="0">
                <a:latin typeface="Arial" panose="020B0604020202020204" pitchFamily="34" charset="0"/>
                <a:cs typeface="Arial" panose="020B0604020202020204" pitchFamily="34" charset="0"/>
              </a:rPr>
              <a:t>B</a:t>
            </a:r>
            <a:endParaRPr lang="ko-KR" altLang="en-US" sz="1000" b="1" dirty="0">
              <a:latin typeface="Arial" panose="020B0604020202020204" pitchFamily="34" charset="0"/>
              <a:cs typeface="Arial" panose="020B0604020202020204" pitchFamily="34" charset="0"/>
            </a:endParaRPr>
          </a:p>
        </p:txBody>
      </p:sp>
      <p:sp>
        <p:nvSpPr>
          <p:cNvPr id="10" name="AutoShape 181" descr="http://127.0.0.1:59567/chunk_output/s/7B756BC6/cp64s7yjn7xmn/00001e.png?resize=8"/>
          <p:cNvSpPr>
            <a:spLocks noChangeAspect="1" noChangeArrowheads="1"/>
          </p:cNvSpPr>
          <p:nvPr/>
        </p:nvSpPr>
        <p:spPr bwMode="auto">
          <a:xfrm>
            <a:off x="63499" y="-136526"/>
            <a:ext cx="5038725" cy="5038725"/>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a:p>
        </p:txBody>
      </p:sp>
      <p:pic>
        <p:nvPicPr>
          <p:cNvPr id="12" name="그림 11"/>
          <p:cNvPicPr>
            <a:picLocks noChangeAspect="1"/>
          </p:cNvPicPr>
          <p:nvPr/>
        </p:nvPicPr>
        <p:blipFill>
          <a:blip r:embed="rId7"/>
          <a:stretch>
            <a:fillRect/>
          </a:stretch>
        </p:blipFill>
        <p:spPr>
          <a:xfrm>
            <a:off x="578374" y="963359"/>
            <a:ext cx="2617588" cy="1616291"/>
          </a:xfrm>
          <a:prstGeom prst="rect">
            <a:avLst/>
          </a:prstGeom>
        </p:spPr>
      </p:pic>
      <p:pic>
        <p:nvPicPr>
          <p:cNvPr id="11" name="그림 10"/>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3247849" y="963359"/>
            <a:ext cx="3018437" cy="1776193"/>
          </a:xfrm>
          <a:prstGeom prst="rect">
            <a:avLst/>
          </a:prstGeom>
        </p:spPr>
      </p:pic>
    </p:spTree>
    <p:extLst>
      <p:ext uri="{BB962C8B-B14F-4D97-AF65-F5344CB8AC3E}">
        <p14:creationId xmlns:p14="http://schemas.microsoft.com/office/powerpoint/2010/main" val="228770901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1" name="표 20"/>
          <p:cNvGraphicFramePr>
            <a:graphicFrameLocks noGrp="1"/>
          </p:cNvGraphicFramePr>
          <p:nvPr>
            <p:extLst>
              <p:ext uri="{D42A27DB-BD31-4B8C-83A1-F6EECF244321}">
                <p14:modId xmlns:p14="http://schemas.microsoft.com/office/powerpoint/2010/main" val="3131212727"/>
              </p:ext>
            </p:extLst>
          </p:nvPr>
        </p:nvGraphicFramePr>
        <p:xfrm>
          <a:off x="489378" y="636577"/>
          <a:ext cx="5653973" cy="8005001"/>
        </p:xfrm>
        <a:graphic>
          <a:graphicData uri="http://schemas.openxmlformats.org/drawingml/2006/table">
            <a:tbl>
              <a:tblPr firstRow="1" bandRow="1">
                <a:tableStyleId>{7E9639D4-E3E2-4D34-9284-5A2195B3D0D7}</a:tableStyleId>
              </a:tblPr>
              <a:tblGrid>
                <a:gridCol w="699903">
                  <a:extLst>
                    <a:ext uri="{9D8B030D-6E8A-4147-A177-3AD203B41FA5}">
                      <a16:colId xmlns:a16="http://schemas.microsoft.com/office/drawing/2014/main" xmlns="" val="2289282194"/>
                    </a:ext>
                  </a:extLst>
                </a:gridCol>
                <a:gridCol w="1851239">
                  <a:extLst>
                    <a:ext uri="{9D8B030D-6E8A-4147-A177-3AD203B41FA5}">
                      <a16:colId xmlns:a16="http://schemas.microsoft.com/office/drawing/2014/main" xmlns="" val="3047427620"/>
                    </a:ext>
                  </a:extLst>
                </a:gridCol>
                <a:gridCol w="1034277">
                  <a:extLst>
                    <a:ext uri="{9D8B030D-6E8A-4147-A177-3AD203B41FA5}">
                      <a16:colId xmlns:a16="http://schemas.microsoft.com/office/drawing/2014/main" xmlns="" val="4104370846"/>
                    </a:ext>
                  </a:extLst>
                </a:gridCol>
                <a:gridCol w="1034277">
                  <a:extLst>
                    <a:ext uri="{9D8B030D-6E8A-4147-A177-3AD203B41FA5}">
                      <a16:colId xmlns:a16="http://schemas.microsoft.com/office/drawing/2014/main" xmlns="" val="2437305"/>
                    </a:ext>
                  </a:extLst>
                </a:gridCol>
                <a:gridCol w="1034277">
                  <a:extLst>
                    <a:ext uri="{9D8B030D-6E8A-4147-A177-3AD203B41FA5}">
                      <a16:colId xmlns:a16="http://schemas.microsoft.com/office/drawing/2014/main" xmlns="" val="3344688276"/>
                    </a:ext>
                  </a:extLst>
                </a:gridCol>
              </a:tblGrid>
              <a:tr h="913541">
                <a:tc>
                  <a:txBody>
                    <a:bodyPr/>
                    <a:lstStyle/>
                    <a:p>
                      <a:pPr algn="l" fontAlgn="ctr"/>
                      <a:endParaRPr lang="ko-KR" altLang="en-US" sz="1000" b="0" i="0" u="none" strike="noStrike" dirty="0">
                        <a:solidFill>
                          <a:srgbClr val="000000"/>
                        </a:solidFill>
                        <a:effectLst/>
                        <a:latin typeface="+mn-lt"/>
                        <a:ea typeface="맑은 고딕" panose="020B0503020000020004" pitchFamily="50" charset="-127"/>
                      </a:endParaRPr>
                    </a:p>
                  </a:txBody>
                  <a:tcPr marL="7620" marR="7620" marT="7620" marB="0" anchor="ctr"/>
                </a:tc>
                <a:tc>
                  <a:txBody>
                    <a:bodyPr/>
                    <a:lstStyle/>
                    <a:p>
                      <a:pPr algn="ctr" fontAlgn="ctr"/>
                      <a:r>
                        <a:rPr lang="en-US" sz="1000" u="none" strike="noStrike" dirty="0">
                          <a:effectLst/>
                        </a:rPr>
                        <a:t>Antibody Staining</a:t>
                      </a:r>
                      <a:endParaRPr lang="en-US" sz="1000" b="0" i="0" u="none" strike="noStrike" dirty="0">
                        <a:solidFill>
                          <a:srgbClr val="000000"/>
                        </a:solidFill>
                        <a:effectLst/>
                        <a:latin typeface="+mn-lt"/>
                        <a:ea typeface="맑은 고딕" panose="020B0503020000020004" pitchFamily="50" charset="-127"/>
                      </a:endParaRPr>
                    </a:p>
                  </a:txBody>
                  <a:tcPr marL="7620" marR="7620" marT="7620" marB="0" anchor="ctr"/>
                </a:tc>
                <a:tc>
                  <a:txBody>
                    <a:bodyPr/>
                    <a:lstStyle/>
                    <a:p>
                      <a:pPr algn="ctr" fontAlgn="ctr"/>
                      <a:r>
                        <a:rPr lang="en-US" sz="1000" u="none" strike="noStrike" dirty="0">
                          <a:effectLst/>
                        </a:rPr>
                        <a:t>Antibody</a:t>
                      </a:r>
                      <a:endParaRPr lang="en-US" sz="1000" b="0" i="0" u="none" strike="noStrike" dirty="0">
                        <a:solidFill>
                          <a:srgbClr val="000000"/>
                        </a:solidFill>
                        <a:effectLst/>
                        <a:latin typeface="+mn-lt"/>
                        <a:ea typeface="맑은 고딕" panose="020B0503020000020004" pitchFamily="50" charset="-127"/>
                      </a:endParaRPr>
                    </a:p>
                  </a:txBody>
                  <a:tcPr marL="7620" marR="7620" marT="7620" marB="0" anchor="ctr"/>
                </a:tc>
                <a:tc>
                  <a:txBody>
                    <a:bodyPr/>
                    <a:lstStyle/>
                    <a:p>
                      <a:pPr algn="l" fontAlgn="ctr"/>
                      <a:r>
                        <a:rPr lang="en-US" sz="1000" u="none" strike="noStrike" dirty="0">
                          <a:effectLst/>
                        </a:rPr>
                        <a:t>Protein expression </a:t>
                      </a:r>
                    </a:p>
                    <a:p>
                      <a:pPr algn="l" fontAlgn="ctr"/>
                      <a:r>
                        <a:rPr lang="en-US" sz="1000" u="none" strike="noStrike" dirty="0">
                          <a:effectLst/>
                        </a:rPr>
                        <a:t>(low(L), </a:t>
                      </a:r>
                    </a:p>
                    <a:p>
                      <a:pPr algn="l" fontAlgn="ctr"/>
                      <a:r>
                        <a:rPr lang="en-US" sz="1000" u="none" strike="noStrike" dirty="0">
                          <a:effectLst/>
                        </a:rPr>
                        <a:t>medium (M), </a:t>
                      </a:r>
                    </a:p>
                    <a:p>
                      <a:pPr algn="l" fontAlgn="ctr"/>
                      <a:r>
                        <a:rPr lang="en-US" sz="1000" u="none" strike="noStrike" dirty="0">
                          <a:effectLst/>
                        </a:rPr>
                        <a:t>and high(H))</a:t>
                      </a:r>
                      <a:endParaRPr lang="en-US" sz="1000" b="0" i="0" u="none" strike="noStrike" dirty="0">
                        <a:solidFill>
                          <a:srgbClr val="000000"/>
                        </a:solidFill>
                        <a:effectLst/>
                        <a:latin typeface="+mn-lt"/>
                        <a:ea typeface="맑은 고딕" panose="020B0503020000020004" pitchFamily="50" charset="-127"/>
                      </a:endParaRPr>
                    </a:p>
                  </a:txBody>
                  <a:tcPr marL="7620" marR="7620" marT="7620" marB="0" anchor="ctr"/>
                </a:tc>
                <a:tc>
                  <a:txBody>
                    <a:bodyPr/>
                    <a:lstStyle/>
                    <a:p>
                      <a:pPr algn="l" fontAlgn="ctr"/>
                      <a:r>
                        <a:rPr lang="en-US" sz="1000" u="none" strike="noStrike" dirty="0">
                          <a:effectLst/>
                        </a:rPr>
                        <a:t>Protein evidence </a:t>
                      </a:r>
                    </a:p>
                    <a:p>
                      <a:pPr algn="l" fontAlgn="ctr"/>
                      <a:r>
                        <a:rPr lang="en-US" sz="1000" u="none" strike="noStrike" dirty="0">
                          <a:effectLst/>
                        </a:rPr>
                        <a:t>(protein level, </a:t>
                      </a:r>
                    </a:p>
                    <a:p>
                      <a:pPr algn="l" fontAlgn="ctr"/>
                      <a:r>
                        <a:rPr lang="en-US" sz="1000" u="none" strike="noStrike" dirty="0">
                          <a:effectLst/>
                        </a:rPr>
                        <a:t>transcript level, </a:t>
                      </a:r>
                    </a:p>
                    <a:p>
                      <a:pPr algn="l" fontAlgn="ctr"/>
                      <a:r>
                        <a:rPr lang="en-US" sz="1000" u="none" strike="noStrike" dirty="0">
                          <a:effectLst/>
                        </a:rPr>
                        <a:t>no evidence, </a:t>
                      </a:r>
                    </a:p>
                    <a:p>
                      <a:pPr algn="l" fontAlgn="ctr"/>
                      <a:r>
                        <a:rPr lang="en-US" sz="1000" u="none" strike="noStrike" dirty="0">
                          <a:effectLst/>
                        </a:rPr>
                        <a:t>or not available)</a:t>
                      </a:r>
                      <a:endParaRPr lang="en-US" sz="1000" b="0" i="0" u="none" strike="noStrike" dirty="0">
                        <a:solidFill>
                          <a:srgbClr val="000000"/>
                        </a:solidFill>
                        <a:effectLst/>
                        <a:latin typeface="+mn-lt"/>
                        <a:ea typeface="맑은 고딕" panose="020B0503020000020004" pitchFamily="50" charset="-127"/>
                      </a:endParaRPr>
                    </a:p>
                  </a:txBody>
                  <a:tcPr marL="7620" marR="7620" marT="7620" marB="0" anchor="ctr"/>
                </a:tc>
                <a:extLst>
                  <a:ext uri="{0D108BD9-81ED-4DB2-BD59-A6C34878D82A}">
                    <a16:rowId xmlns:a16="http://schemas.microsoft.com/office/drawing/2014/main" xmlns="" val="1783803675"/>
                  </a:ext>
                </a:extLst>
              </a:tr>
              <a:tr h="787940">
                <a:tc>
                  <a:txBody>
                    <a:bodyPr/>
                    <a:lstStyle/>
                    <a:p>
                      <a:pPr algn="ctr" fontAlgn="ctr"/>
                      <a:r>
                        <a:rPr lang="en-US" sz="1000" u="none" strike="noStrike" dirty="0">
                          <a:effectLst/>
                        </a:rPr>
                        <a:t>ADIPOQ</a:t>
                      </a:r>
                      <a:endParaRPr lang="en-US" sz="1000" b="0" i="0" u="none" strike="noStrike" dirty="0">
                        <a:solidFill>
                          <a:srgbClr val="000000"/>
                        </a:solidFill>
                        <a:effectLst/>
                        <a:latin typeface="+mn-lt"/>
                        <a:ea typeface="맑은 고딕" panose="020B0503020000020004" pitchFamily="50" charset="-127"/>
                      </a:endParaRPr>
                    </a:p>
                  </a:txBody>
                  <a:tcPr marL="7620" marR="7620" marT="7620" marB="0" anchor="ctr"/>
                </a:tc>
                <a:tc>
                  <a:txBody>
                    <a:bodyPr/>
                    <a:lstStyle/>
                    <a:p>
                      <a:pPr algn="l" fontAlgn="ctr"/>
                      <a:endParaRPr lang="ko-KR" altLang="en-US" sz="1000" b="0" i="0" u="none" strike="noStrike" dirty="0">
                        <a:solidFill>
                          <a:srgbClr val="000000"/>
                        </a:solidFill>
                        <a:effectLst/>
                        <a:latin typeface="+mn-lt"/>
                        <a:ea typeface="맑은 고딕" panose="020B0503020000020004" pitchFamily="50" charset="-127"/>
                      </a:endParaRPr>
                    </a:p>
                  </a:txBody>
                  <a:tcPr marL="7620" marR="7620" marT="7620" marB="0" anchor="ctr"/>
                </a:tc>
                <a:tc>
                  <a:txBody>
                    <a:bodyPr/>
                    <a:lstStyle/>
                    <a:p>
                      <a:pPr algn="ctr" fontAlgn="ctr"/>
                      <a:r>
                        <a:rPr lang="en-US" sz="1000" u="none" strike="noStrike" dirty="0">
                          <a:effectLst/>
                        </a:rPr>
                        <a:t>CAB046467</a:t>
                      </a:r>
                      <a:endParaRPr lang="en-US" sz="1000" b="0" i="0" u="none" strike="noStrike" dirty="0">
                        <a:solidFill>
                          <a:srgbClr val="000000"/>
                        </a:solidFill>
                        <a:effectLst/>
                        <a:latin typeface="+mn-lt"/>
                        <a:ea typeface="맑은 고딕" panose="020B0503020000020004" pitchFamily="50" charset="-127"/>
                      </a:endParaRPr>
                    </a:p>
                  </a:txBody>
                  <a:tcPr marL="7620" marR="7620" marT="7620" marB="0" anchor="ctr"/>
                </a:tc>
                <a:tc>
                  <a:txBody>
                    <a:bodyPr/>
                    <a:lstStyle/>
                    <a:p>
                      <a:pPr algn="ctr" fontAlgn="ctr"/>
                      <a:r>
                        <a:rPr lang="en-US" sz="1000" u="none" strike="noStrike" dirty="0">
                          <a:effectLst/>
                        </a:rPr>
                        <a:t>No data</a:t>
                      </a:r>
                      <a:endParaRPr lang="en-US" sz="1000" b="0" i="0" u="none" strike="noStrike" dirty="0">
                        <a:solidFill>
                          <a:srgbClr val="000000"/>
                        </a:solidFill>
                        <a:effectLst/>
                        <a:latin typeface="+mn-lt"/>
                        <a:ea typeface="맑은 고딕" panose="020B0503020000020004" pitchFamily="50" charset="-127"/>
                      </a:endParaRPr>
                    </a:p>
                  </a:txBody>
                  <a:tcPr marL="7620" marR="7620" marT="7620" marB="0" anchor="ctr"/>
                </a:tc>
                <a:tc>
                  <a:txBody>
                    <a:bodyPr/>
                    <a:lstStyle/>
                    <a:p>
                      <a:pPr algn="ctr" fontAlgn="ctr"/>
                      <a:r>
                        <a:rPr lang="en-US" sz="1000" u="none" strike="noStrike" dirty="0">
                          <a:effectLst/>
                        </a:rPr>
                        <a:t>protein level</a:t>
                      </a:r>
                      <a:endParaRPr lang="en-US" sz="1000" b="0" i="0" u="none" strike="noStrike" dirty="0">
                        <a:solidFill>
                          <a:srgbClr val="000000"/>
                        </a:solidFill>
                        <a:effectLst/>
                        <a:latin typeface="+mn-lt"/>
                        <a:ea typeface="맑은 고딕" panose="020B0503020000020004" pitchFamily="50" charset="-127"/>
                      </a:endParaRPr>
                    </a:p>
                  </a:txBody>
                  <a:tcPr marL="7620" marR="7620" marT="7620" marB="0" anchor="ctr"/>
                </a:tc>
                <a:extLst>
                  <a:ext uri="{0D108BD9-81ED-4DB2-BD59-A6C34878D82A}">
                    <a16:rowId xmlns:a16="http://schemas.microsoft.com/office/drawing/2014/main" xmlns="" val="3624477914"/>
                  </a:ext>
                </a:extLst>
              </a:tr>
              <a:tr h="787940">
                <a:tc>
                  <a:txBody>
                    <a:bodyPr/>
                    <a:lstStyle/>
                    <a:p>
                      <a:pPr algn="ctr" fontAlgn="ctr"/>
                      <a:r>
                        <a:rPr lang="en-US" sz="1000" u="none" strike="noStrike" dirty="0">
                          <a:effectLst/>
                        </a:rPr>
                        <a:t>CIDEC</a:t>
                      </a:r>
                      <a:endParaRPr lang="en-US" sz="1000" b="0" i="0" u="none" strike="noStrike" dirty="0">
                        <a:solidFill>
                          <a:srgbClr val="000000"/>
                        </a:solidFill>
                        <a:effectLst/>
                        <a:latin typeface="+mn-lt"/>
                        <a:ea typeface="맑은 고딕" panose="020B0503020000020004" pitchFamily="50" charset="-127"/>
                      </a:endParaRPr>
                    </a:p>
                  </a:txBody>
                  <a:tcPr marL="7620" marR="7620" marT="7620" marB="0" anchor="ctr"/>
                </a:tc>
                <a:tc>
                  <a:txBody>
                    <a:bodyPr/>
                    <a:lstStyle/>
                    <a:p>
                      <a:pPr algn="l" fontAlgn="ctr"/>
                      <a:endParaRPr lang="ko-KR" altLang="en-US" sz="1000" b="0" i="0" u="none" strike="noStrike" dirty="0">
                        <a:solidFill>
                          <a:srgbClr val="000000"/>
                        </a:solidFill>
                        <a:effectLst/>
                        <a:latin typeface="+mn-lt"/>
                        <a:ea typeface="맑은 고딕" panose="020B0503020000020004" pitchFamily="50" charset="-127"/>
                      </a:endParaRPr>
                    </a:p>
                  </a:txBody>
                  <a:tcPr marL="7620" marR="7620" marT="7620" marB="0" anchor="ctr"/>
                </a:tc>
                <a:tc>
                  <a:txBody>
                    <a:bodyPr/>
                    <a:lstStyle/>
                    <a:p>
                      <a:pPr algn="ctr" fontAlgn="ctr"/>
                      <a:r>
                        <a:rPr lang="en-US" sz="1000" u="none" strike="noStrike" dirty="0">
                          <a:effectLst/>
                        </a:rPr>
                        <a:t> HPA018837</a:t>
                      </a:r>
                      <a:endParaRPr lang="en-US" sz="1000" b="0" i="0" u="none" strike="noStrike" dirty="0">
                        <a:solidFill>
                          <a:srgbClr val="000000"/>
                        </a:solidFill>
                        <a:effectLst/>
                        <a:latin typeface="+mn-lt"/>
                        <a:ea typeface="맑은 고딕" panose="020B0503020000020004" pitchFamily="50" charset="-127"/>
                      </a:endParaRPr>
                    </a:p>
                  </a:txBody>
                  <a:tcPr marL="7620" marR="7620" marT="7620" marB="0" anchor="ctr"/>
                </a:tc>
                <a:tc>
                  <a:txBody>
                    <a:bodyPr/>
                    <a:lstStyle/>
                    <a:p>
                      <a:pPr algn="ctr" fontAlgn="ctr"/>
                      <a:r>
                        <a:rPr lang="en-US" sz="1000" u="none" strike="noStrike" dirty="0">
                          <a:effectLst/>
                        </a:rPr>
                        <a:t>M</a:t>
                      </a:r>
                      <a:endParaRPr lang="en-US" sz="1000" b="0" i="0" u="none" strike="noStrike" dirty="0">
                        <a:solidFill>
                          <a:srgbClr val="000000"/>
                        </a:solidFill>
                        <a:effectLst/>
                        <a:latin typeface="+mn-lt"/>
                        <a:ea typeface="맑은 고딕" panose="020B0503020000020004" pitchFamily="50" charset="-127"/>
                      </a:endParaRPr>
                    </a:p>
                  </a:txBody>
                  <a:tcPr marL="7620" marR="7620" marT="7620" marB="0" anchor="ctr"/>
                </a:tc>
                <a:tc>
                  <a:txBody>
                    <a:bodyPr/>
                    <a:lstStyle/>
                    <a:p>
                      <a:pPr algn="ctr" fontAlgn="ctr"/>
                      <a:r>
                        <a:rPr lang="en-US" sz="1000" u="none" strike="noStrike" dirty="0">
                          <a:effectLst/>
                        </a:rPr>
                        <a:t>protein level</a:t>
                      </a:r>
                      <a:endParaRPr lang="en-US" sz="1000" b="0" i="0" u="none" strike="noStrike" dirty="0">
                        <a:solidFill>
                          <a:srgbClr val="000000"/>
                        </a:solidFill>
                        <a:effectLst/>
                        <a:latin typeface="+mn-lt"/>
                        <a:ea typeface="맑은 고딕" panose="020B0503020000020004" pitchFamily="50" charset="-127"/>
                      </a:endParaRPr>
                    </a:p>
                  </a:txBody>
                  <a:tcPr marL="7620" marR="7620" marT="7620" marB="0" anchor="ctr"/>
                </a:tc>
                <a:extLst>
                  <a:ext uri="{0D108BD9-81ED-4DB2-BD59-A6C34878D82A}">
                    <a16:rowId xmlns:a16="http://schemas.microsoft.com/office/drawing/2014/main" xmlns="" val="2314919058"/>
                  </a:ext>
                </a:extLst>
              </a:tr>
              <a:tr h="787940">
                <a:tc>
                  <a:txBody>
                    <a:bodyPr/>
                    <a:lstStyle/>
                    <a:p>
                      <a:pPr algn="ctr" fontAlgn="ctr"/>
                      <a:r>
                        <a:rPr lang="en-US" sz="1000" u="none" strike="noStrike" dirty="0">
                          <a:effectLst/>
                        </a:rPr>
                        <a:t>GPD1</a:t>
                      </a:r>
                      <a:endParaRPr lang="en-US" sz="1000" b="0" i="0" u="none" strike="noStrike" dirty="0">
                        <a:solidFill>
                          <a:srgbClr val="000000"/>
                        </a:solidFill>
                        <a:effectLst/>
                        <a:latin typeface="+mn-lt"/>
                        <a:ea typeface="맑은 고딕" panose="020B0503020000020004" pitchFamily="50" charset="-127"/>
                      </a:endParaRPr>
                    </a:p>
                  </a:txBody>
                  <a:tcPr marL="7620" marR="7620" marT="7620" marB="0" anchor="ctr"/>
                </a:tc>
                <a:tc>
                  <a:txBody>
                    <a:bodyPr/>
                    <a:lstStyle/>
                    <a:p>
                      <a:pPr algn="l" fontAlgn="ctr"/>
                      <a:endParaRPr lang="ko-KR" altLang="en-US" sz="1000" b="0" i="0" u="none" strike="noStrike">
                        <a:solidFill>
                          <a:srgbClr val="000000"/>
                        </a:solidFill>
                        <a:effectLst/>
                        <a:latin typeface="+mn-lt"/>
                        <a:ea typeface="맑은 고딕" panose="020B0503020000020004" pitchFamily="50" charset="-127"/>
                      </a:endParaRPr>
                    </a:p>
                  </a:txBody>
                  <a:tcPr marL="7620" marR="7620" marT="7620" marB="0" anchor="ctr"/>
                </a:tc>
                <a:tc>
                  <a:txBody>
                    <a:bodyPr/>
                    <a:lstStyle/>
                    <a:p>
                      <a:pPr algn="ctr" fontAlgn="ctr"/>
                      <a:r>
                        <a:rPr lang="en-US" sz="1000" u="none" strike="noStrike" dirty="0">
                          <a:effectLst/>
                        </a:rPr>
                        <a:t> HPA044620</a:t>
                      </a:r>
                      <a:endParaRPr lang="en-US" sz="1000" b="0" i="0" u="none" strike="noStrike" dirty="0">
                        <a:solidFill>
                          <a:srgbClr val="000000"/>
                        </a:solidFill>
                        <a:effectLst/>
                        <a:latin typeface="+mn-lt"/>
                        <a:ea typeface="맑은 고딕" panose="020B0503020000020004" pitchFamily="50" charset="-127"/>
                      </a:endParaRPr>
                    </a:p>
                  </a:txBody>
                  <a:tcPr marL="7620" marR="7620" marT="7620" marB="0" anchor="ctr"/>
                </a:tc>
                <a:tc>
                  <a:txBody>
                    <a:bodyPr/>
                    <a:lstStyle/>
                    <a:p>
                      <a:pPr algn="ctr" fontAlgn="ctr"/>
                      <a:r>
                        <a:rPr lang="en-US" sz="1000" u="none" strike="noStrike" dirty="0">
                          <a:effectLst/>
                        </a:rPr>
                        <a:t>H</a:t>
                      </a:r>
                      <a:endParaRPr lang="en-US" sz="1000" b="0" i="0" u="none" strike="noStrike" dirty="0">
                        <a:solidFill>
                          <a:srgbClr val="000000"/>
                        </a:solidFill>
                        <a:effectLst/>
                        <a:latin typeface="+mn-lt"/>
                        <a:ea typeface="맑은 고딕" panose="020B0503020000020004" pitchFamily="50" charset="-127"/>
                      </a:endParaRPr>
                    </a:p>
                  </a:txBody>
                  <a:tcPr marL="7620" marR="7620" marT="7620" marB="0" anchor="ctr"/>
                </a:tc>
                <a:tc>
                  <a:txBody>
                    <a:bodyPr/>
                    <a:lstStyle/>
                    <a:p>
                      <a:pPr algn="ctr" fontAlgn="ctr"/>
                      <a:r>
                        <a:rPr lang="en-US" sz="1000" u="none" strike="noStrike" dirty="0">
                          <a:effectLst/>
                        </a:rPr>
                        <a:t>protein level</a:t>
                      </a:r>
                      <a:endParaRPr lang="en-US" sz="1000" b="0" i="0" u="none" strike="noStrike" dirty="0">
                        <a:solidFill>
                          <a:srgbClr val="000000"/>
                        </a:solidFill>
                        <a:effectLst/>
                        <a:latin typeface="+mn-lt"/>
                        <a:ea typeface="맑은 고딕" panose="020B0503020000020004" pitchFamily="50" charset="-127"/>
                      </a:endParaRPr>
                    </a:p>
                  </a:txBody>
                  <a:tcPr marL="7620" marR="7620" marT="7620" marB="0" anchor="ctr"/>
                </a:tc>
                <a:extLst>
                  <a:ext uri="{0D108BD9-81ED-4DB2-BD59-A6C34878D82A}">
                    <a16:rowId xmlns:a16="http://schemas.microsoft.com/office/drawing/2014/main" xmlns="" val="2496189986"/>
                  </a:ext>
                </a:extLst>
              </a:tr>
              <a:tr h="787940">
                <a:tc>
                  <a:txBody>
                    <a:bodyPr/>
                    <a:lstStyle/>
                    <a:p>
                      <a:pPr algn="ctr" fontAlgn="ctr"/>
                      <a:r>
                        <a:rPr lang="en-US" sz="1000" u="none" strike="noStrike" dirty="0">
                          <a:effectLst/>
                        </a:rPr>
                        <a:t>GYG2</a:t>
                      </a:r>
                      <a:endParaRPr lang="en-US" sz="1000" b="0" i="0" u="none" strike="noStrike" dirty="0">
                        <a:solidFill>
                          <a:srgbClr val="000000"/>
                        </a:solidFill>
                        <a:effectLst/>
                        <a:latin typeface="+mn-lt"/>
                        <a:ea typeface="맑은 고딕" panose="020B0503020000020004" pitchFamily="50" charset="-127"/>
                      </a:endParaRPr>
                    </a:p>
                  </a:txBody>
                  <a:tcPr marL="7620" marR="7620" marT="7620" marB="0" anchor="ctr"/>
                </a:tc>
                <a:tc>
                  <a:txBody>
                    <a:bodyPr/>
                    <a:lstStyle/>
                    <a:p>
                      <a:pPr algn="l" fontAlgn="ctr"/>
                      <a:endParaRPr lang="ko-KR" altLang="en-US" sz="1000" b="0" i="0" u="none" strike="noStrike">
                        <a:solidFill>
                          <a:srgbClr val="000000"/>
                        </a:solidFill>
                        <a:effectLst/>
                        <a:latin typeface="+mn-lt"/>
                        <a:ea typeface="맑은 고딕" panose="020B0503020000020004" pitchFamily="50" charset="-127"/>
                      </a:endParaRPr>
                    </a:p>
                  </a:txBody>
                  <a:tcPr marL="7620" marR="7620" marT="7620" marB="0" anchor="ctr"/>
                </a:tc>
                <a:tc>
                  <a:txBody>
                    <a:bodyPr/>
                    <a:lstStyle/>
                    <a:p>
                      <a:pPr algn="ctr" fontAlgn="ctr"/>
                      <a:r>
                        <a:rPr lang="en-US" sz="1000" u="none" strike="noStrike">
                          <a:effectLst/>
                        </a:rPr>
                        <a:t>HPA064686</a:t>
                      </a:r>
                      <a:endParaRPr lang="en-US" sz="1000" b="0" i="0" u="none" strike="noStrike">
                        <a:solidFill>
                          <a:srgbClr val="000000"/>
                        </a:solidFill>
                        <a:effectLst/>
                        <a:latin typeface="+mn-lt"/>
                        <a:ea typeface="맑은 고딕" panose="020B0503020000020004" pitchFamily="50" charset="-127"/>
                      </a:endParaRPr>
                    </a:p>
                  </a:txBody>
                  <a:tcPr marL="7620" marR="7620" marT="7620" marB="0" anchor="ctr"/>
                </a:tc>
                <a:tc>
                  <a:txBody>
                    <a:bodyPr/>
                    <a:lstStyle/>
                    <a:p>
                      <a:pPr algn="ctr" fontAlgn="ctr"/>
                      <a:r>
                        <a:rPr lang="en-US" sz="1000" u="none" strike="noStrike" dirty="0">
                          <a:effectLst/>
                        </a:rPr>
                        <a:t>M</a:t>
                      </a:r>
                      <a:endParaRPr lang="en-US" sz="1000" b="0" i="0" u="none" strike="noStrike" dirty="0">
                        <a:solidFill>
                          <a:srgbClr val="000000"/>
                        </a:solidFill>
                        <a:effectLst/>
                        <a:latin typeface="+mn-lt"/>
                        <a:ea typeface="맑은 고딕" panose="020B0503020000020004" pitchFamily="50" charset="-127"/>
                      </a:endParaRPr>
                    </a:p>
                  </a:txBody>
                  <a:tcPr marL="7620" marR="7620" marT="7620" marB="0" anchor="ctr"/>
                </a:tc>
                <a:tc>
                  <a:txBody>
                    <a:bodyPr/>
                    <a:lstStyle/>
                    <a:p>
                      <a:pPr algn="ctr" fontAlgn="ctr"/>
                      <a:r>
                        <a:rPr lang="en-US" sz="1000" u="none" strike="noStrike" dirty="0">
                          <a:effectLst/>
                        </a:rPr>
                        <a:t>protein level</a:t>
                      </a:r>
                      <a:endParaRPr lang="en-US" sz="1000" b="0" i="0" u="none" strike="noStrike" dirty="0">
                        <a:solidFill>
                          <a:srgbClr val="000000"/>
                        </a:solidFill>
                        <a:effectLst/>
                        <a:latin typeface="+mn-lt"/>
                        <a:ea typeface="맑은 고딕" panose="020B0503020000020004" pitchFamily="50" charset="-127"/>
                      </a:endParaRPr>
                    </a:p>
                  </a:txBody>
                  <a:tcPr marL="7620" marR="7620" marT="7620" marB="0" anchor="ctr"/>
                </a:tc>
                <a:extLst>
                  <a:ext uri="{0D108BD9-81ED-4DB2-BD59-A6C34878D82A}">
                    <a16:rowId xmlns:a16="http://schemas.microsoft.com/office/drawing/2014/main" xmlns="" val="217022563"/>
                  </a:ext>
                </a:extLst>
              </a:tr>
              <a:tr h="787940">
                <a:tc>
                  <a:txBody>
                    <a:bodyPr/>
                    <a:lstStyle/>
                    <a:p>
                      <a:pPr algn="ctr" fontAlgn="ctr"/>
                      <a:r>
                        <a:rPr lang="en-US" sz="1000" u="none" strike="noStrike" dirty="0">
                          <a:effectLst/>
                        </a:rPr>
                        <a:t>LIPE</a:t>
                      </a:r>
                      <a:endParaRPr lang="en-US" sz="1000" b="0" i="0" u="none" strike="noStrike" dirty="0">
                        <a:solidFill>
                          <a:srgbClr val="000000"/>
                        </a:solidFill>
                        <a:effectLst/>
                        <a:latin typeface="+mn-lt"/>
                        <a:ea typeface="맑은 고딕" panose="020B0503020000020004" pitchFamily="50" charset="-127"/>
                      </a:endParaRPr>
                    </a:p>
                  </a:txBody>
                  <a:tcPr marL="7620" marR="7620" marT="7620" marB="0" anchor="ctr"/>
                </a:tc>
                <a:tc>
                  <a:txBody>
                    <a:bodyPr/>
                    <a:lstStyle/>
                    <a:p>
                      <a:pPr algn="l" fontAlgn="ctr"/>
                      <a:endParaRPr lang="ko-KR" altLang="en-US" sz="1000" b="0" i="0" u="none" strike="noStrike">
                        <a:solidFill>
                          <a:srgbClr val="000000"/>
                        </a:solidFill>
                        <a:effectLst/>
                        <a:latin typeface="+mn-lt"/>
                        <a:ea typeface="맑은 고딕" panose="020B0503020000020004" pitchFamily="50" charset="-127"/>
                      </a:endParaRPr>
                    </a:p>
                  </a:txBody>
                  <a:tcPr marL="7620" marR="7620" marT="7620" marB="0" anchor="ctr"/>
                </a:tc>
                <a:tc>
                  <a:txBody>
                    <a:bodyPr/>
                    <a:lstStyle/>
                    <a:p>
                      <a:pPr algn="ctr" fontAlgn="ctr"/>
                      <a:r>
                        <a:rPr lang="en-US" sz="1000" u="none" strike="noStrike">
                          <a:effectLst/>
                        </a:rPr>
                        <a:t>CAB017700</a:t>
                      </a:r>
                      <a:endParaRPr lang="en-US" sz="1000" b="0" i="0" u="none" strike="noStrike">
                        <a:solidFill>
                          <a:srgbClr val="000000"/>
                        </a:solidFill>
                        <a:effectLst/>
                        <a:latin typeface="+mn-lt"/>
                        <a:ea typeface="맑은 고딕" panose="020B0503020000020004" pitchFamily="50" charset="-127"/>
                      </a:endParaRPr>
                    </a:p>
                  </a:txBody>
                  <a:tcPr marL="7620" marR="7620" marT="7620" marB="0" anchor="ctr"/>
                </a:tc>
                <a:tc>
                  <a:txBody>
                    <a:bodyPr/>
                    <a:lstStyle/>
                    <a:p>
                      <a:pPr algn="ctr" fontAlgn="ctr"/>
                      <a:r>
                        <a:rPr lang="en-US" sz="1000" u="none" strike="noStrike">
                          <a:effectLst/>
                        </a:rPr>
                        <a:t>H</a:t>
                      </a:r>
                      <a:endParaRPr lang="en-US" sz="1000" b="0" i="0" u="none" strike="noStrike">
                        <a:solidFill>
                          <a:srgbClr val="000000"/>
                        </a:solidFill>
                        <a:effectLst/>
                        <a:latin typeface="+mn-lt"/>
                        <a:ea typeface="맑은 고딕" panose="020B0503020000020004" pitchFamily="50" charset="-127"/>
                      </a:endParaRPr>
                    </a:p>
                  </a:txBody>
                  <a:tcPr marL="7620" marR="7620" marT="7620" marB="0" anchor="ctr"/>
                </a:tc>
                <a:tc>
                  <a:txBody>
                    <a:bodyPr/>
                    <a:lstStyle/>
                    <a:p>
                      <a:pPr algn="ctr" fontAlgn="ctr"/>
                      <a:r>
                        <a:rPr lang="en-US" sz="1000" u="none" strike="noStrike" dirty="0">
                          <a:effectLst/>
                        </a:rPr>
                        <a:t>protein level</a:t>
                      </a:r>
                      <a:endParaRPr lang="en-US" sz="1000" b="0" i="0" u="none" strike="noStrike" dirty="0">
                        <a:solidFill>
                          <a:srgbClr val="000000"/>
                        </a:solidFill>
                        <a:effectLst/>
                        <a:latin typeface="+mn-lt"/>
                        <a:ea typeface="맑은 고딕" panose="020B0503020000020004" pitchFamily="50" charset="-127"/>
                      </a:endParaRPr>
                    </a:p>
                  </a:txBody>
                  <a:tcPr marL="7620" marR="7620" marT="7620" marB="0" anchor="ctr"/>
                </a:tc>
                <a:extLst>
                  <a:ext uri="{0D108BD9-81ED-4DB2-BD59-A6C34878D82A}">
                    <a16:rowId xmlns:a16="http://schemas.microsoft.com/office/drawing/2014/main" xmlns="" val="2877939892"/>
                  </a:ext>
                </a:extLst>
              </a:tr>
              <a:tr h="787940">
                <a:tc>
                  <a:txBody>
                    <a:bodyPr/>
                    <a:lstStyle/>
                    <a:p>
                      <a:pPr algn="ctr" fontAlgn="ctr"/>
                      <a:r>
                        <a:rPr lang="en-US" sz="1000" u="none" strike="noStrike" dirty="0">
                          <a:effectLst/>
                        </a:rPr>
                        <a:t>PLIN1</a:t>
                      </a:r>
                      <a:endParaRPr lang="en-US" sz="1000" b="0" i="0" u="none" strike="noStrike" dirty="0">
                        <a:solidFill>
                          <a:srgbClr val="000000"/>
                        </a:solidFill>
                        <a:effectLst/>
                        <a:latin typeface="+mn-lt"/>
                        <a:ea typeface="맑은 고딕" panose="020B0503020000020004" pitchFamily="50" charset="-127"/>
                      </a:endParaRPr>
                    </a:p>
                  </a:txBody>
                  <a:tcPr marL="7620" marR="7620" marT="7620" marB="0" anchor="ctr"/>
                </a:tc>
                <a:tc>
                  <a:txBody>
                    <a:bodyPr/>
                    <a:lstStyle/>
                    <a:p>
                      <a:pPr algn="l" fontAlgn="ctr"/>
                      <a:endParaRPr lang="ko-KR" altLang="en-US" sz="1000" b="0" i="0" u="none" strike="noStrike">
                        <a:solidFill>
                          <a:srgbClr val="000000"/>
                        </a:solidFill>
                        <a:effectLst/>
                        <a:latin typeface="+mn-lt"/>
                        <a:ea typeface="맑은 고딕" panose="020B0503020000020004" pitchFamily="50" charset="-127"/>
                      </a:endParaRPr>
                    </a:p>
                  </a:txBody>
                  <a:tcPr marL="7620" marR="7620" marT="7620" marB="0" anchor="ctr"/>
                </a:tc>
                <a:tc>
                  <a:txBody>
                    <a:bodyPr/>
                    <a:lstStyle/>
                    <a:p>
                      <a:pPr algn="ctr" fontAlgn="ctr"/>
                      <a:r>
                        <a:rPr lang="en-US" sz="1000" u="none" strike="noStrike">
                          <a:effectLst/>
                        </a:rPr>
                        <a:t>CAB033821</a:t>
                      </a:r>
                      <a:endParaRPr lang="en-US" sz="1000" b="0" i="0" u="none" strike="noStrike">
                        <a:solidFill>
                          <a:srgbClr val="000000"/>
                        </a:solidFill>
                        <a:effectLst/>
                        <a:latin typeface="+mn-lt"/>
                        <a:ea typeface="맑은 고딕" panose="020B0503020000020004" pitchFamily="50" charset="-127"/>
                      </a:endParaRPr>
                    </a:p>
                  </a:txBody>
                  <a:tcPr marL="7620" marR="7620" marT="7620" marB="0" anchor="ctr"/>
                </a:tc>
                <a:tc>
                  <a:txBody>
                    <a:bodyPr/>
                    <a:lstStyle/>
                    <a:p>
                      <a:pPr algn="ctr" fontAlgn="ctr"/>
                      <a:r>
                        <a:rPr lang="en-US" sz="1000" u="none" strike="noStrike">
                          <a:effectLst/>
                        </a:rPr>
                        <a:t>H</a:t>
                      </a:r>
                      <a:endParaRPr lang="en-US" sz="1000" b="0" i="0" u="none" strike="noStrike">
                        <a:solidFill>
                          <a:srgbClr val="000000"/>
                        </a:solidFill>
                        <a:effectLst/>
                        <a:latin typeface="+mn-lt"/>
                        <a:ea typeface="맑은 고딕" panose="020B0503020000020004" pitchFamily="50" charset="-127"/>
                      </a:endParaRPr>
                    </a:p>
                  </a:txBody>
                  <a:tcPr marL="7620" marR="7620" marT="7620" marB="0" anchor="ctr"/>
                </a:tc>
                <a:tc>
                  <a:txBody>
                    <a:bodyPr/>
                    <a:lstStyle/>
                    <a:p>
                      <a:pPr algn="ctr" fontAlgn="ctr"/>
                      <a:r>
                        <a:rPr lang="en-US" sz="1000" u="none" strike="noStrike" dirty="0">
                          <a:effectLst/>
                        </a:rPr>
                        <a:t>protein level</a:t>
                      </a:r>
                      <a:endParaRPr lang="en-US" sz="1000" b="0" i="0" u="none" strike="noStrike" dirty="0">
                        <a:solidFill>
                          <a:srgbClr val="000000"/>
                        </a:solidFill>
                        <a:effectLst/>
                        <a:latin typeface="+mn-lt"/>
                        <a:ea typeface="맑은 고딕" panose="020B0503020000020004" pitchFamily="50" charset="-127"/>
                      </a:endParaRPr>
                    </a:p>
                  </a:txBody>
                  <a:tcPr marL="7620" marR="7620" marT="7620" marB="0" anchor="ctr"/>
                </a:tc>
                <a:extLst>
                  <a:ext uri="{0D108BD9-81ED-4DB2-BD59-A6C34878D82A}">
                    <a16:rowId xmlns:a16="http://schemas.microsoft.com/office/drawing/2014/main" xmlns="" val="1763217365"/>
                  </a:ext>
                </a:extLst>
              </a:tr>
              <a:tr h="787940">
                <a:tc>
                  <a:txBody>
                    <a:bodyPr/>
                    <a:lstStyle/>
                    <a:p>
                      <a:pPr algn="ctr" fontAlgn="ctr"/>
                      <a:r>
                        <a:rPr lang="en-US" sz="1000" u="none" strike="noStrike" dirty="0">
                          <a:effectLst/>
                        </a:rPr>
                        <a:t>TRARG1</a:t>
                      </a:r>
                      <a:endParaRPr lang="en-US" sz="1000" b="0" i="0" u="none" strike="noStrike" dirty="0">
                        <a:solidFill>
                          <a:srgbClr val="000000"/>
                        </a:solidFill>
                        <a:effectLst/>
                        <a:latin typeface="+mn-lt"/>
                        <a:ea typeface="맑은 고딕" panose="020B0503020000020004" pitchFamily="50" charset="-127"/>
                      </a:endParaRPr>
                    </a:p>
                  </a:txBody>
                  <a:tcPr marL="7620" marR="7620" marT="7620" marB="0" anchor="ctr"/>
                </a:tc>
                <a:tc>
                  <a:txBody>
                    <a:bodyPr/>
                    <a:lstStyle/>
                    <a:p>
                      <a:pPr algn="l" fontAlgn="ctr"/>
                      <a:endParaRPr lang="ko-KR" altLang="en-US" sz="1000" b="0" i="0" u="none" strike="noStrike">
                        <a:solidFill>
                          <a:srgbClr val="000000"/>
                        </a:solidFill>
                        <a:effectLst/>
                        <a:latin typeface="+mn-lt"/>
                        <a:ea typeface="맑은 고딕" panose="020B0503020000020004" pitchFamily="50" charset="-127"/>
                      </a:endParaRPr>
                    </a:p>
                  </a:txBody>
                  <a:tcPr marL="7620" marR="7620" marT="7620" marB="0" anchor="ctr"/>
                </a:tc>
                <a:tc>
                  <a:txBody>
                    <a:bodyPr/>
                    <a:lstStyle/>
                    <a:p>
                      <a:pPr algn="ctr" fontAlgn="ctr"/>
                      <a:r>
                        <a:rPr lang="en-US" sz="1000" u="none" strike="noStrike">
                          <a:effectLst/>
                        </a:rPr>
                        <a:t>HPA050825</a:t>
                      </a:r>
                      <a:endParaRPr lang="en-US" sz="1000" b="0" i="0" u="none" strike="noStrike">
                        <a:solidFill>
                          <a:srgbClr val="000000"/>
                        </a:solidFill>
                        <a:effectLst/>
                        <a:latin typeface="+mn-lt"/>
                        <a:ea typeface="맑은 고딕" panose="020B0503020000020004" pitchFamily="50" charset="-127"/>
                      </a:endParaRPr>
                    </a:p>
                  </a:txBody>
                  <a:tcPr marL="7620" marR="7620" marT="7620" marB="0" anchor="ctr"/>
                </a:tc>
                <a:tc>
                  <a:txBody>
                    <a:bodyPr/>
                    <a:lstStyle/>
                    <a:p>
                      <a:pPr algn="ctr" fontAlgn="ctr"/>
                      <a:r>
                        <a:rPr lang="en-US" sz="1000" u="none" strike="noStrike">
                          <a:effectLst/>
                        </a:rPr>
                        <a:t>H</a:t>
                      </a:r>
                      <a:endParaRPr lang="en-US" sz="1000" b="0" i="0" u="none" strike="noStrike">
                        <a:solidFill>
                          <a:srgbClr val="000000"/>
                        </a:solidFill>
                        <a:effectLst/>
                        <a:latin typeface="+mn-lt"/>
                        <a:ea typeface="맑은 고딕" panose="020B0503020000020004" pitchFamily="50" charset="-127"/>
                      </a:endParaRPr>
                    </a:p>
                  </a:txBody>
                  <a:tcPr marL="7620" marR="7620" marT="7620" marB="0" anchor="ctr"/>
                </a:tc>
                <a:tc>
                  <a:txBody>
                    <a:bodyPr/>
                    <a:lstStyle/>
                    <a:p>
                      <a:pPr algn="ctr" fontAlgn="ctr"/>
                      <a:r>
                        <a:rPr lang="en-US" sz="1000" u="none" strike="noStrike" dirty="0">
                          <a:effectLst/>
                        </a:rPr>
                        <a:t>protein level</a:t>
                      </a:r>
                      <a:endParaRPr lang="en-US" sz="1000" b="0" i="0" u="none" strike="noStrike" dirty="0">
                        <a:solidFill>
                          <a:srgbClr val="000000"/>
                        </a:solidFill>
                        <a:effectLst/>
                        <a:latin typeface="+mn-lt"/>
                        <a:ea typeface="맑은 고딕" panose="020B0503020000020004" pitchFamily="50" charset="-127"/>
                      </a:endParaRPr>
                    </a:p>
                  </a:txBody>
                  <a:tcPr marL="7620" marR="7620" marT="7620" marB="0" anchor="ctr"/>
                </a:tc>
                <a:extLst>
                  <a:ext uri="{0D108BD9-81ED-4DB2-BD59-A6C34878D82A}">
                    <a16:rowId xmlns:a16="http://schemas.microsoft.com/office/drawing/2014/main" xmlns="" val="4219283767"/>
                  </a:ext>
                </a:extLst>
              </a:tr>
              <a:tr h="787940">
                <a:tc>
                  <a:txBody>
                    <a:bodyPr/>
                    <a:lstStyle/>
                    <a:p>
                      <a:pPr algn="ctr" fontAlgn="ctr"/>
                      <a:r>
                        <a:rPr lang="en-US" sz="1000" u="none" strike="noStrike" dirty="0">
                          <a:effectLst/>
                        </a:rPr>
                        <a:t>LPL</a:t>
                      </a:r>
                      <a:endParaRPr lang="en-US" sz="1000" b="0" i="0" u="none" strike="noStrike" dirty="0">
                        <a:solidFill>
                          <a:srgbClr val="000000"/>
                        </a:solidFill>
                        <a:effectLst/>
                        <a:latin typeface="+mn-lt"/>
                        <a:ea typeface="맑은 고딕" panose="020B0503020000020004" pitchFamily="50" charset="-127"/>
                      </a:endParaRPr>
                    </a:p>
                  </a:txBody>
                  <a:tcPr marL="7620" marR="7620" marT="7620" marB="0" anchor="ctr"/>
                </a:tc>
                <a:tc>
                  <a:txBody>
                    <a:bodyPr/>
                    <a:lstStyle/>
                    <a:p>
                      <a:pPr algn="l" fontAlgn="ctr"/>
                      <a:endParaRPr lang="ko-KR" altLang="en-US" sz="1000" b="0" i="0" u="none" strike="noStrike">
                        <a:solidFill>
                          <a:srgbClr val="000000"/>
                        </a:solidFill>
                        <a:effectLst/>
                        <a:latin typeface="+mn-lt"/>
                        <a:ea typeface="맑은 고딕" panose="020B0503020000020004" pitchFamily="50" charset="-127"/>
                      </a:endParaRPr>
                    </a:p>
                  </a:txBody>
                  <a:tcPr marL="7620" marR="7620" marT="7620" marB="0" anchor="ctr"/>
                </a:tc>
                <a:tc>
                  <a:txBody>
                    <a:bodyPr/>
                    <a:lstStyle/>
                    <a:p>
                      <a:pPr algn="ctr" fontAlgn="ctr"/>
                      <a:r>
                        <a:rPr lang="en-US" sz="1000" u="none" strike="noStrike">
                          <a:effectLst/>
                        </a:rPr>
                        <a:t>No data</a:t>
                      </a:r>
                      <a:endParaRPr lang="en-US" sz="1000" b="0" i="0" u="none" strike="noStrike">
                        <a:solidFill>
                          <a:srgbClr val="000000"/>
                        </a:solidFill>
                        <a:effectLst/>
                        <a:latin typeface="+mn-lt"/>
                        <a:ea typeface="맑은 고딕" panose="020B0503020000020004" pitchFamily="50" charset="-127"/>
                      </a:endParaRPr>
                    </a:p>
                  </a:txBody>
                  <a:tcPr marL="7620" marR="7620" marT="7620" marB="0" anchor="ctr"/>
                </a:tc>
                <a:tc>
                  <a:txBody>
                    <a:bodyPr/>
                    <a:lstStyle/>
                    <a:p>
                      <a:pPr algn="ctr" fontAlgn="ctr"/>
                      <a:r>
                        <a:rPr lang="en-US" sz="1000" u="none" strike="noStrike">
                          <a:effectLst/>
                        </a:rPr>
                        <a:t>No data</a:t>
                      </a:r>
                      <a:endParaRPr lang="en-US" sz="1000" b="0" i="0" u="none" strike="noStrike">
                        <a:solidFill>
                          <a:srgbClr val="000000"/>
                        </a:solidFill>
                        <a:effectLst/>
                        <a:latin typeface="+mn-lt"/>
                        <a:ea typeface="맑은 고딕" panose="020B0503020000020004" pitchFamily="50" charset="-127"/>
                      </a:endParaRPr>
                    </a:p>
                  </a:txBody>
                  <a:tcPr marL="7620" marR="7620" marT="7620" marB="0" anchor="ctr"/>
                </a:tc>
                <a:tc>
                  <a:txBody>
                    <a:bodyPr/>
                    <a:lstStyle/>
                    <a:p>
                      <a:pPr algn="ctr" fontAlgn="ctr"/>
                      <a:r>
                        <a:rPr lang="en-US" sz="1000" u="none" strike="noStrike" dirty="0">
                          <a:effectLst/>
                        </a:rPr>
                        <a:t>protein level</a:t>
                      </a:r>
                      <a:endParaRPr lang="en-US" sz="1000" b="0" i="0" u="none" strike="noStrike" dirty="0">
                        <a:solidFill>
                          <a:srgbClr val="000000"/>
                        </a:solidFill>
                        <a:effectLst/>
                        <a:latin typeface="+mn-lt"/>
                        <a:ea typeface="맑은 고딕" panose="020B0503020000020004" pitchFamily="50" charset="-127"/>
                      </a:endParaRPr>
                    </a:p>
                  </a:txBody>
                  <a:tcPr marL="7620" marR="7620" marT="7620" marB="0" anchor="ctr"/>
                </a:tc>
                <a:extLst>
                  <a:ext uri="{0D108BD9-81ED-4DB2-BD59-A6C34878D82A}">
                    <a16:rowId xmlns:a16="http://schemas.microsoft.com/office/drawing/2014/main" xmlns="" val="4244026279"/>
                  </a:ext>
                </a:extLst>
              </a:tr>
              <a:tr h="787940">
                <a:tc>
                  <a:txBody>
                    <a:bodyPr/>
                    <a:lstStyle/>
                    <a:p>
                      <a:pPr algn="ctr" fontAlgn="ctr"/>
                      <a:r>
                        <a:rPr lang="en-US" sz="1000" u="none" strike="noStrike" dirty="0">
                          <a:effectLst/>
                        </a:rPr>
                        <a:t>PPARG</a:t>
                      </a:r>
                      <a:endParaRPr lang="en-US" sz="1000" b="0" i="0" u="none" strike="noStrike" dirty="0">
                        <a:solidFill>
                          <a:srgbClr val="000000"/>
                        </a:solidFill>
                        <a:effectLst/>
                        <a:latin typeface="+mn-lt"/>
                        <a:ea typeface="맑은 고딕" panose="020B0503020000020004" pitchFamily="50" charset="-127"/>
                      </a:endParaRPr>
                    </a:p>
                  </a:txBody>
                  <a:tcPr marL="7620" marR="7620" marT="7620" marB="0" anchor="ctr"/>
                </a:tc>
                <a:tc>
                  <a:txBody>
                    <a:bodyPr/>
                    <a:lstStyle/>
                    <a:p>
                      <a:pPr algn="l" fontAlgn="ctr"/>
                      <a:endParaRPr lang="ko-KR" altLang="en-US" sz="1000" b="0" i="0" u="none" strike="noStrike">
                        <a:solidFill>
                          <a:srgbClr val="000000"/>
                        </a:solidFill>
                        <a:effectLst/>
                        <a:latin typeface="+mn-lt"/>
                        <a:ea typeface="맑은 고딕" panose="020B0503020000020004" pitchFamily="50" charset="-127"/>
                      </a:endParaRPr>
                    </a:p>
                  </a:txBody>
                  <a:tcPr marL="7620" marR="7620" marT="7620" marB="0" anchor="ctr"/>
                </a:tc>
                <a:tc>
                  <a:txBody>
                    <a:bodyPr/>
                    <a:lstStyle/>
                    <a:p>
                      <a:pPr algn="ctr" fontAlgn="ctr"/>
                      <a:r>
                        <a:rPr lang="en-US" sz="1000" u="none" strike="noStrike" dirty="0">
                          <a:effectLst/>
                        </a:rPr>
                        <a:t>CAB004282</a:t>
                      </a:r>
                      <a:endParaRPr lang="en-US" sz="1000" b="0" i="0" u="none" strike="noStrike" dirty="0">
                        <a:solidFill>
                          <a:srgbClr val="000000"/>
                        </a:solidFill>
                        <a:effectLst/>
                        <a:latin typeface="+mn-lt"/>
                        <a:ea typeface="맑은 고딕" panose="020B0503020000020004" pitchFamily="50" charset="-127"/>
                      </a:endParaRPr>
                    </a:p>
                  </a:txBody>
                  <a:tcPr marL="7620" marR="7620" marT="7620" marB="0" anchor="ctr"/>
                </a:tc>
                <a:tc>
                  <a:txBody>
                    <a:bodyPr/>
                    <a:lstStyle/>
                    <a:p>
                      <a:pPr algn="ctr" fontAlgn="ctr"/>
                      <a:r>
                        <a:rPr lang="en-US" sz="1000" u="none" strike="noStrike" dirty="0">
                          <a:effectLst/>
                        </a:rPr>
                        <a:t>L</a:t>
                      </a:r>
                      <a:endParaRPr lang="en-US" sz="1000" b="0" i="0" u="none" strike="noStrike" dirty="0">
                        <a:solidFill>
                          <a:srgbClr val="000000"/>
                        </a:solidFill>
                        <a:effectLst/>
                        <a:latin typeface="+mn-lt"/>
                        <a:ea typeface="맑은 고딕" panose="020B0503020000020004" pitchFamily="50" charset="-127"/>
                      </a:endParaRPr>
                    </a:p>
                  </a:txBody>
                  <a:tcPr marL="7620" marR="7620" marT="7620" marB="0" anchor="ctr"/>
                </a:tc>
                <a:tc>
                  <a:txBody>
                    <a:bodyPr/>
                    <a:lstStyle/>
                    <a:p>
                      <a:pPr algn="ctr" fontAlgn="ctr"/>
                      <a:r>
                        <a:rPr lang="en-US" sz="1000" u="none" strike="noStrike" dirty="0">
                          <a:effectLst/>
                        </a:rPr>
                        <a:t>protein level</a:t>
                      </a:r>
                      <a:endParaRPr lang="en-US" sz="1000" b="0" i="0" u="none" strike="noStrike" dirty="0">
                        <a:solidFill>
                          <a:srgbClr val="000000"/>
                        </a:solidFill>
                        <a:effectLst/>
                        <a:latin typeface="+mn-lt"/>
                        <a:ea typeface="맑은 고딕" panose="020B0503020000020004" pitchFamily="50" charset="-127"/>
                      </a:endParaRPr>
                    </a:p>
                  </a:txBody>
                  <a:tcPr marL="7620" marR="7620" marT="7620" marB="0" anchor="ctr"/>
                </a:tc>
                <a:extLst>
                  <a:ext uri="{0D108BD9-81ED-4DB2-BD59-A6C34878D82A}">
                    <a16:rowId xmlns:a16="http://schemas.microsoft.com/office/drawing/2014/main" xmlns="" val="2003262318"/>
                  </a:ext>
                </a:extLst>
              </a:tr>
            </a:tbl>
          </a:graphicData>
        </a:graphic>
      </p:graphicFrame>
      <p:sp>
        <p:nvSpPr>
          <p:cNvPr id="2" name="TextBox 1"/>
          <p:cNvSpPr txBox="1"/>
          <p:nvPr/>
        </p:nvSpPr>
        <p:spPr>
          <a:xfrm>
            <a:off x="0" y="117643"/>
            <a:ext cx="4452730" cy="369332"/>
          </a:xfrm>
          <a:prstGeom prst="rect">
            <a:avLst/>
          </a:prstGeom>
          <a:noFill/>
        </p:spPr>
        <p:txBody>
          <a:bodyPr wrap="square" rtlCol="0">
            <a:spAutoFit/>
          </a:bodyPr>
          <a:lstStyle/>
          <a:p>
            <a:r>
              <a:rPr lang="en-US" altLang="ko-KR" dirty="0"/>
              <a:t>Supplementary Figure 2</a:t>
            </a:r>
            <a:endParaRPr lang="ko-KR" altLang="en-US" dirty="0"/>
          </a:p>
        </p:txBody>
      </p:sp>
      <p:pic>
        <p:nvPicPr>
          <p:cNvPr id="5" name="그림 4"/>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368562" y="3953133"/>
            <a:ext cx="720000" cy="720000"/>
          </a:xfrm>
          <a:prstGeom prst="rect">
            <a:avLst/>
          </a:prstGeom>
        </p:spPr>
      </p:pic>
      <p:pic>
        <p:nvPicPr>
          <p:cNvPr id="6" name="그림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203135" y="3953133"/>
            <a:ext cx="720000" cy="720000"/>
          </a:xfrm>
          <a:prstGeom prst="rect">
            <a:avLst/>
          </a:prstGeom>
        </p:spPr>
      </p:pic>
      <p:pic>
        <p:nvPicPr>
          <p:cNvPr id="7" name="그림 6"/>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368562" y="1589166"/>
            <a:ext cx="720000" cy="720000"/>
          </a:xfrm>
          <a:prstGeom prst="rect">
            <a:avLst/>
          </a:prstGeom>
        </p:spPr>
      </p:pic>
      <p:pic>
        <p:nvPicPr>
          <p:cNvPr id="8" name="그림 7"/>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203135" y="1589166"/>
            <a:ext cx="720000" cy="720000"/>
          </a:xfrm>
          <a:prstGeom prst="rect">
            <a:avLst/>
          </a:prstGeom>
        </p:spPr>
      </p:pic>
      <p:pic>
        <p:nvPicPr>
          <p:cNvPr id="9" name="그림 8"/>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1368562" y="2377155"/>
            <a:ext cx="720000" cy="720000"/>
          </a:xfrm>
          <a:prstGeom prst="rect">
            <a:avLst/>
          </a:prstGeom>
        </p:spPr>
      </p:pic>
      <p:pic>
        <p:nvPicPr>
          <p:cNvPr id="10" name="그림 9"/>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2203135" y="2377155"/>
            <a:ext cx="720000" cy="720000"/>
          </a:xfrm>
          <a:prstGeom prst="rect">
            <a:avLst/>
          </a:prstGeom>
        </p:spPr>
      </p:pic>
      <p:pic>
        <p:nvPicPr>
          <p:cNvPr id="11" name="그림 10"/>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1368562" y="3165144"/>
            <a:ext cx="720000" cy="720000"/>
          </a:xfrm>
          <a:prstGeom prst="rect">
            <a:avLst/>
          </a:prstGeom>
        </p:spPr>
      </p:pic>
      <p:pic>
        <p:nvPicPr>
          <p:cNvPr id="12" name="그림 11"/>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2203135" y="3165144"/>
            <a:ext cx="720000" cy="720000"/>
          </a:xfrm>
          <a:prstGeom prst="rect">
            <a:avLst/>
          </a:prstGeom>
        </p:spPr>
      </p:pic>
      <p:pic>
        <p:nvPicPr>
          <p:cNvPr id="13" name="그림 12"/>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1368562" y="4741122"/>
            <a:ext cx="720000" cy="720000"/>
          </a:xfrm>
          <a:prstGeom prst="rect">
            <a:avLst/>
          </a:prstGeom>
        </p:spPr>
      </p:pic>
      <p:pic>
        <p:nvPicPr>
          <p:cNvPr id="14" name="그림 13"/>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2203135" y="4741122"/>
            <a:ext cx="720000" cy="720000"/>
          </a:xfrm>
          <a:prstGeom prst="rect">
            <a:avLst/>
          </a:prstGeom>
        </p:spPr>
      </p:pic>
      <p:pic>
        <p:nvPicPr>
          <p:cNvPr id="15" name="그림 14"/>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1368562" y="5529111"/>
            <a:ext cx="720000" cy="720000"/>
          </a:xfrm>
          <a:prstGeom prst="rect">
            <a:avLst/>
          </a:prstGeom>
        </p:spPr>
      </p:pic>
      <p:pic>
        <p:nvPicPr>
          <p:cNvPr id="16" name="그림 15"/>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2203135" y="5529111"/>
            <a:ext cx="720000" cy="720000"/>
          </a:xfrm>
          <a:prstGeom prst="rect">
            <a:avLst/>
          </a:prstGeom>
        </p:spPr>
      </p:pic>
      <p:pic>
        <p:nvPicPr>
          <p:cNvPr id="17" name="그림 16"/>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a:off x="1368562" y="6317101"/>
            <a:ext cx="720000" cy="720000"/>
          </a:xfrm>
          <a:prstGeom prst="rect">
            <a:avLst/>
          </a:prstGeom>
        </p:spPr>
      </p:pic>
      <p:pic>
        <p:nvPicPr>
          <p:cNvPr id="18" name="그림 17"/>
          <p:cNvPicPr>
            <a:picLocks noChangeAspect="1"/>
          </p:cNvPicPr>
          <p:nvPr/>
        </p:nvPicPr>
        <p:blipFill>
          <a:blip r:embed="rId15" cstate="print">
            <a:extLst>
              <a:ext uri="{28A0092B-C50C-407E-A947-70E740481C1C}">
                <a14:useLocalDpi xmlns:a14="http://schemas.microsoft.com/office/drawing/2010/main" val="0"/>
              </a:ext>
            </a:extLst>
          </a:blip>
          <a:stretch>
            <a:fillRect/>
          </a:stretch>
        </p:blipFill>
        <p:spPr>
          <a:xfrm>
            <a:off x="2203135" y="6317101"/>
            <a:ext cx="720000" cy="720000"/>
          </a:xfrm>
          <a:prstGeom prst="rect">
            <a:avLst/>
          </a:prstGeom>
        </p:spPr>
      </p:pic>
      <p:pic>
        <p:nvPicPr>
          <p:cNvPr id="19" name="그림 18"/>
          <p:cNvPicPr>
            <a:picLocks noChangeAspect="1"/>
          </p:cNvPicPr>
          <p:nvPr/>
        </p:nvPicPr>
        <p:blipFill>
          <a:blip r:embed="rId16" cstate="print">
            <a:extLst>
              <a:ext uri="{28A0092B-C50C-407E-A947-70E740481C1C}">
                <a14:useLocalDpi xmlns:a14="http://schemas.microsoft.com/office/drawing/2010/main" val="0"/>
              </a:ext>
            </a:extLst>
          </a:blip>
          <a:stretch>
            <a:fillRect/>
          </a:stretch>
        </p:blipFill>
        <p:spPr>
          <a:xfrm>
            <a:off x="1368562" y="7891339"/>
            <a:ext cx="720000" cy="720000"/>
          </a:xfrm>
          <a:prstGeom prst="rect">
            <a:avLst/>
          </a:prstGeom>
        </p:spPr>
      </p:pic>
      <p:pic>
        <p:nvPicPr>
          <p:cNvPr id="20" name="그림 19"/>
          <p:cNvPicPr>
            <a:picLocks noChangeAspect="1"/>
          </p:cNvPicPr>
          <p:nvPr/>
        </p:nvPicPr>
        <p:blipFill>
          <a:blip r:embed="rId17" cstate="print">
            <a:extLst>
              <a:ext uri="{28A0092B-C50C-407E-A947-70E740481C1C}">
                <a14:useLocalDpi xmlns:a14="http://schemas.microsoft.com/office/drawing/2010/main" val="0"/>
              </a:ext>
            </a:extLst>
          </a:blip>
          <a:stretch>
            <a:fillRect/>
          </a:stretch>
        </p:blipFill>
        <p:spPr>
          <a:xfrm>
            <a:off x="2203135" y="7889102"/>
            <a:ext cx="720000" cy="720000"/>
          </a:xfrm>
          <a:prstGeom prst="rect">
            <a:avLst/>
          </a:prstGeom>
        </p:spPr>
      </p:pic>
    </p:spTree>
    <p:extLst>
      <p:ext uri="{BB962C8B-B14F-4D97-AF65-F5344CB8AC3E}">
        <p14:creationId xmlns:p14="http://schemas.microsoft.com/office/powerpoint/2010/main" val="406268510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9" name="차트 18"/>
          <p:cNvGraphicFramePr>
            <a:graphicFrameLocks/>
          </p:cNvGraphicFramePr>
          <p:nvPr>
            <p:extLst>
              <p:ext uri="{D42A27DB-BD31-4B8C-83A1-F6EECF244321}">
                <p14:modId xmlns:p14="http://schemas.microsoft.com/office/powerpoint/2010/main" val="1800635002"/>
              </p:ext>
            </p:extLst>
          </p:nvPr>
        </p:nvGraphicFramePr>
        <p:xfrm>
          <a:off x="874295" y="2250464"/>
          <a:ext cx="2160000" cy="14400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5" name="차트 4"/>
          <p:cNvGraphicFramePr>
            <a:graphicFrameLocks/>
          </p:cNvGraphicFramePr>
          <p:nvPr>
            <p:extLst>
              <p:ext uri="{D42A27DB-BD31-4B8C-83A1-F6EECF244321}">
                <p14:modId xmlns:p14="http://schemas.microsoft.com/office/powerpoint/2010/main" val="4078265044"/>
              </p:ext>
            </p:extLst>
          </p:nvPr>
        </p:nvGraphicFramePr>
        <p:xfrm>
          <a:off x="754202" y="653013"/>
          <a:ext cx="2160000" cy="1440000"/>
        </p:xfrm>
        <a:graphic>
          <a:graphicData uri="http://schemas.openxmlformats.org/drawingml/2006/chart">
            <c:chart xmlns:c="http://schemas.openxmlformats.org/drawingml/2006/chart" xmlns:r="http://schemas.openxmlformats.org/officeDocument/2006/relationships" r:id="rId4"/>
          </a:graphicData>
        </a:graphic>
      </p:graphicFrame>
      <p:sp>
        <p:nvSpPr>
          <p:cNvPr id="2" name="TextBox 1"/>
          <p:cNvSpPr txBox="1"/>
          <p:nvPr/>
        </p:nvSpPr>
        <p:spPr>
          <a:xfrm>
            <a:off x="127321" y="196770"/>
            <a:ext cx="6694293" cy="369332"/>
          </a:xfrm>
          <a:prstGeom prst="rect">
            <a:avLst/>
          </a:prstGeom>
          <a:noFill/>
        </p:spPr>
        <p:txBody>
          <a:bodyPr wrap="square" rtlCol="0">
            <a:spAutoFit/>
          </a:bodyPr>
          <a:lstStyle/>
          <a:p>
            <a:r>
              <a:rPr lang="en-US" altLang="ko-KR" dirty="0"/>
              <a:t>Supplementary Figure 3</a:t>
            </a:r>
            <a:endParaRPr lang="ko-KR" altLang="en-US" dirty="0"/>
          </a:p>
        </p:txBody>
      </p:sp>
      <p:sp>
        <p:nvSpPr>
          <p:cNvPr id="4" name="TextBox 3"/>
          <p:cNvSpPr txBox="1"/>
          <p:nvPr/>
        </p:nvSpPr>
        <p:spPr>
          <a:xfrm>
            <a:off x="1353647" y="587307"/>
            <a:ext cx="658070" cy="215444"/>
          </a:xfrm>
          <a:prstGeom prst="rect">
            <a:avLst/>
          </a:prstGeom>
          <a:noFill/>
        </p:spPr>
        <p:txBody>
          <a:bodyPr wrap="square" rtlCol="0">
            <a:spAutoFit/>
          </a:bodyPr>
          <a:lstStyle/>
          <a:p>
            <a:pPr algn="ctr"/>
            <a:r>
              <a:rPr lang="en-US" altLang="ko-KR" sz="800" b="1" dirty="0"/>
              <a:t>VAT</a:t>
            </a:r>
            <a:endParaRPr lang="ko-KR" altLang="en-US" sz="800" b="1" dirty="0"/>
          </a:p>
        </p:txBody>
      </p:sp>
      <p:sp>
        <p:nvSpPr>
          <p:cNvPr id="6" name="TextBox 5"/>
          <p:cNvSpPr txBox="1"/>
          <p:nvPr/>
        </p:nvSpPr>
        <p:spPr>
          <a:xfrm>
            <a:off x="2251819" y="674218"/>
            <a:ext cx="1047666" cy="584775"/>
          </a:xfrm>
          <a:prstGeom prst="rect">
            <a:avLst/>
          </a:prstGeom>
          <a:noFill/>
        </p:spPr>
        <p:txBody>
          <a:bodyPr wrap="square" rtlCol="0">
            <a:spAutoFit/>
          </a:bodyPr>
          <a:lstStyle/>
          <a:p>
            <a:r>
              <a:rPr lang="en-US" altLang="ko-KR" sz="800" b="1" dirty="0">
                <a:solidFill>
                  <a:schemeClr val="accent2"/>
                </a:solidFill>
              </a:rPr>
              <a:t>Female</a:t>
            </a:r>
            <a:r>
              <a:rPr lang="en-US" altLang="ko-KR" sz="800" dirty="0"/>
              <a:t> </a:t>
            </a:r>
          </a:p>
          <a:p>
            <a:r>
              <a:rPr lang="en-US" altLang="ko-KR" sz="800" dirty="0" err="1"/>
              <a:t>r</a:t>
            </a:r>
            <a:r>
              <a:rPr lang="en-US" altLang="ko-KR" sz="800" baseline="-25000" dirty="0" err="1"/>
              <a:t>s</a:t>
            </a:r>
            <a:r>
              <a:rPr lang="en-US" altLang="ko-KR" sz="800" dirty="0"/>
              <a:t> = -0.06, </a:t>
            </a:r>
            <a:r>
              <a:rPr lang="en-US" altLang="ko-KR" sz="800" i="1" dirty="0"/>
              <a:t>P</a:t>
            </a:r>
            <a:r>
              <a:rPr lang="en-US" altLang="ko-KR" sz="800" dirty="0"/>
              <a:t> = 0.53</a:t>
            </a:r>
          </a:p>
          <a:p>
            <a:r>
              <a:rPr lang="en-US" altLang="ko-KR" sz="800" b="1" dirty="0">
                <a:solidFill>
                  <a:schemeClr val="accent1"/>
                </a:solidFill>
              </a:rPr>
              <a:t>Male </a:t>
            </a:r>
          </a:p>
          <a:p>
            <a:r>
              <a:rPr lang="en-US" altLang="ko-KR" sz="800" dirty="0" err="1"/>
              <a:t>r</a:t>
            </a:r>
            <a:r>
              <a:rPr lang="en-US" altLang="ko-KR" sz="800" baseline="-25000" dirty="0" err="1"/>
              <a:t>s</a:t>
            </a:r>
            <a:r>
              <a:rPr lang="en-US" altLang="ko-KR" sz="800" dirty="0"/>
              <a:t> = -0.14, </a:t>
            </a:r>
            <a:r>
              <a:rPr lang="en-US" altLang="ko-KR" sz="800" i="1" dirty="0"/>
              <a:t>P</a:t>
            </a:r>
            <a:r>
              <a:rPr lang="en-US" altLang="ko-KR" sz="800" dirty="0"/>
              <a:t> = 0.03</a:t>
            </a:r>
            <a:endParaRPr lang="ko-KR" altLang="en-US" sz="800" dirty="0"/>
          </a:p>
        </p:txBody>
      </p:sp>
      <p:sp>
        <p:nvSpPr>
          <p:cNvPr id="7" name="TextBox 6"/>
          <p:cNvSpPr txBox="1"/>
          <p:nvPr/>
        </p:nvSpPr>
        <p:spPr>
          <a:xfrm>
            <a:off x="517062" y="653013"/>
            <a:ext cx="365048" cy="246221"/>
          </a:xfrm>
          <a:prstGeom prst="rect">
            <a:avLst/>
          </a:prstGeom>
          <a:noFill/>
        </p:spPr>
        <p:txBody>
          <a:bodyPr wrap="square" rtlCol="0">
            <a:spAutoFit/>
          </a:bodyPr>
          <a:lstStyle/>
          <a:p>
            <a:r>
              <a:rPr lang="en-US" altLang="ko-KR" sz="1000" b="1" dirty="0">
                <a:latin typeface="+mn-ea"/>
              </a:rPr>
              <a:t>A </a:t>
            </a:r>
            <a:endParaRPr lang="ko-KR" altLang="en-US" sz="1000" b="1" dirty="0">
              <a:solidFill>
                <a:srgbClr val="FF0000"/>
              </a:solidFill>
              <a:latin typeface="+mn-ea"/>
            </a:endParaRPr>
          </a:p>
        </p:txBody>
      </p:sp>
      <p:sp>
        <p:nvSpPr>
          <p:cNvPr id="10" name="TextBox 9"/>
          <p:cNvSpPr txBox="1"/>
          <p:nvPr/>
        </p:nvSpPr>
        <p:spPr>
          <a:xfrm>
            <a:off x="3122585" y="2189951"/>
            <a:ext cx="477042" cy="246221"/>
          </a:xfrm>
          <a:prstGeom prst="rect">
            <a:avLst/>
          </a:prstGeom>
          <a:noFill/>
        </p:spPr>
        <p:txBody>
          <a:bodyPr wrap="square" rtlCol="0">
            <a:spAutoFit/>
          </a:bodyPr>
          <a:lstStyle/>
          <a:p>
            <a:r>
              <a:rPr lang="en-US" altLang="ko-KR" sz="1000" b="1" dirty="0">
                <a:latin typeface="+mn-ea"/>
              </a:rPr>
              <a:t>C</a:t>
            </a:r>
            <a:endParaRPr lang="ko-KR" altLang="en-US" sz="1000" b="1" dirty="0">
              <a:latin typeface="+mn-ea"/>
            </a:endParaRPr>
          </a:p>
        </p:txBody>
      </p:sp>
      <p:sp>
        <p:nvSpPr>
          <p:cNvPr id="11" name="TextBox 10"/>
          <p:cNvSpPr txBox="1"/>
          <p:nvPr/>
        </p:nvSpPr>
        <p:spPr>
          <a:xfrm>
            <a:off x="517062" y="2189951"/>
            <a:ext cx="484250" cy="246221"/>
          </a:xfrm>
          <a:prstGeom prst="rect">
            <a:avLst/>
          </a:prstGeom>
          <a:noFill/>
        </p:spPr>
        <p:txBody>
          <a:bodyPr wrap="square" rtlCol="0">
            <a:spAutoFit/>
          </a:bodyPr>
          <a:lstStyle/>
          <a:p>
            <a:r>
              <a:rPr lang="en-US" altLang="ko-KR" sz="1000" b="1" dirty="0">
                <a:latin typeface="+mn-ea"/>
              </a:rPr>
              <a:t>B </a:t>
            </a:r>
            <a:endParaRPr lang="ko-KR" altLang="en-US" sz="1000" b="1" dirty="0">
              <a:solidFill>
                <a:srgbClr val="FF0000"/>
              </a:solidFill>
              <a:latin typeface="+mn-ea"/>
            </a:endParaRPr>
          </a:p>
        </p:txBody>
      </p:sp>
      <p:sp>
        <p:nvSpPr>
          <p:cNvPr id="18" name="TextBox 17"/>
          <p:cNvSpPr txBox="1"/>
          <p:nvPr/>
        </p:nvSpPr>
        <p:spPr>
          <a:xfrm>
            <a:off x="2244004" y="2340796"/>
            <a:ext cx="1177181" cy="584775"/>
          </a:xfrm>
          <a:prstGeom prst="rect">
            <a:avLst/>
          </a:prstGeom>
          <a:noFill/>
        </p:spPr>
        <p:txBody>
          <a:bodyPr wrap="square" rtlCol="0">
            <a:spAutoFit/>
          </a:bodyPr>
          <a:lstStyle/>
          <a:p>
            <a:r>
              <a:rPr lang="en-US" altLang="ko-KR" sz="800" b="1" dirty="0">
                <a:solidFill>
                  <a:schemeClr val="accent2"/>
                </a:solidFill>
              </a:rPr>
              <a:t>Female</a:t>
            </a:r>
            <a:r>
              <a:rPr lang="en-US" altLang="ko-KR" sz="800" dirty="0"/>
              <a:t> </a:t>
            </a:r>
          </a:p>
          <a:p>
            <a:r>
              <a:rPr lang="en-US" altLang="ko-KR" sz="800" dirty="0" err="1"/>
              <a:t>r</a:t>
            </a:r>
            <a:r>
              <a:rPr lang="en-US" altLang="ko-KR" sz="800" baseline="-25000" dirty="0" err="1"/>
              <a:t>s</a:t>
            </a:r>
            <a:r>
              <a:rPr lang="en-US" altLang="ko-KR" sz="800" dirty="0"/>
              <a:t> = 0.01, </a:t>
            </a:r>
            <a:r>
              <a:rPr lang="en-US" altLang="ko-KR" sz="800" i="1" dirty="0"/>
              <a:t>P</a:t>
            </a:r>
            <a:r>
              <a:rPr lang="en-US" altLang="ko-KR" sz="800" dirty="0"/>
              <a:t> = 0.87</a:t>
            </a:r>
            <a:endParaRPr lang="ko-KR" altLang="en-US" sz="800" dirty="0"/>
          </a:p>
          <a:p>
            <a:r>
              <a:rPr lang="en-US" altLang="ko-KR" sz="800" b="1" dirty="0">
                <a:solidFill>
                  <a:schemeClr val="accent1"/>
                </a:solidFill>
              </a:rPr>
              <a:t>Male </a:t>
            </a:r>
          </a:p>
          <a:p>
            <a:r>
              <a:rPr lang="en-US" altLang="ko-KR" sz="800" dirty="0" err="1"/>
              <a:t>r</a:t>
            </a:r>
            <a:r>
              <a:rPr lang="en-US" altLang="ko-KR" sz="800" baseline="-25000" dirty="0" err="1"/>
              <a:t>s</a:t>
            </a:r>
            <a:r>
              <a:rPr lang="en-US" altLang="ko-KR" sz="800" dirty="0"/>
              <a:t> = -0.07, </a:t>
            </a:r>
            <a:r>
              <a:rPr lang="en-US" altLang="ko-KR" sz="800" i="1" dirty="0"/>
              <a:t>P</a:t>
            </a:r>
            <a:r>
              <a:rPr lang="en-US" altLang="ko-KR" sz="800" dirty="0"/>
              <a:t> = 0.19</a:t>
            </a:r>
            <a:endParaRPr lang="ko-KR" altLang="en-US" sz="800" dirty="0"/>
          </a:p>
        </p:txBody>
      </p:sp>
      <p:graphicFrame>
        <p:nvGraphicFramePr>
          <p:cNvPr id="20" name="차트 19"/>
          <p:cNvGraphicFramePr>
            <a:graphicFrameLocks/>
          </p:cNvGraphicFramePr>
          <p:nvPr>
            <p:extLst>
              <p:ext uri="{D42A27DB-BD31-4B8C-83A1-F6EECF244321}">
                <p14:modId xmlns:p14="http://schemas.microsoft.com/office/powerpoint/2010/main" val="2620458224"/>
              </p:ext>
            </p:extLst>
          </p:nvPr>
        </p:nvGraphicFramePr>
        <p:xfrm>
          <a:off x="3358080" y="2258213"/>
          <a:ext cx="2160000" cy="1440000"/>
        </p:xfrm>
        <a:graphic>
          <a:graphicData uri="http://schemas.openxmlformats.org/drawingml/2006/chart">
            <c:chart xmlns:c="http://schemas.openxmlformats.org/drawingml/2006/chart" xmlns:r="http://schemas.openxmlformats.org/officeDocument/2006/relationships" r:id="rId5"/>
          </a:graphicData>
        </a:graphic>
      </p:graphicFrame>
      <p:sp>
        <p:nvSpPr>
          <p:cNvPr id="21" name="TextBox 20"/>
          <p:cNvSpPr txBox="1"/>
          <p:nvPr/>
        </p:nvSpPr>
        <p:spPr>
          <a:xfrm>
            <a:off x="4822425" y="2258213"/>
            <a:ext cx="1404155" cy="584775"/>
          </a:xfrm>
          <a:prstGeom prst="rect">
            <a:avLst/>
          </a:prstGeom>
          <a:noFill/>
        </p:spPr>
        <p:txBody>
          <a:bodyPr wrap="square" rtlCol="0">
            <a:spAutoFit/>
          </a:bodyPr>
          <a:lstStyle/>
          <a:p>
            <a:r>
              <a:rPr lang="en-US" altLang="ko-KR" sz="800" b="1" dirty="0">
                <a:solidFill>
                  <a:schemeClr val="accent2"/>
                </a:solidFill>
              </a:rPr>
              <a:t>Female</a:t>
            </a:r>
            <a:r>
              <a:rPr lang="en-US" altLang="ko-KR" sz="800" dirty="0"/>
              <a:t> </a:t>
            </a:r>
          </a:p>
          <a:p>
            <a:r>
              <a:rPr lang="en-US" altLang="ko-KR" sz="800" dirty="0" err="1"/>
              <a:t>r</a:t>
            </a:r>
            <a:r>
              <a:rPr lang="en-US" altLang="ko-KR" sz="800" baseline="-25000" dirty="0" err="1"/>
              <a:t>s</a:t>
            </a:r>
            <a:r>
              <a:rPr lang="en-US" altLang="ko-KR" sz="800" dirty="0"/>
              <a:t> = 0.01, </a:t>
            </a:r>
            <a:r>
              <a:rPr lang="en-US" altLang="ko-KR" sz="800" i="1" dirty="0"/>
              <a:t>P</a:t>
            </a:r>
            <a:r>
              <a:rPr lang="en-US" altLang="ko-KR" sz="800" dirty="0"/>
              <a:t> = 0.86</a:t>
            </a:r>
            <a:endParaRPr lang="ko-KR" altLang="en-US" sz="800" dirty="0"/>
          </a:p>
          <a:p>
            <a:r>
              <a:rPr lang="en-US" altLang="ko-KR" sz="800" b="1" dirty="0">
                <a:solidFill>
                  <a:schemeClr val="accent1"/>
                </a:solidFill>
              </a:rPr>
              <a:t>Male </a:t>
            </a:r>
          </a:p>
          <a:p>
            <a:r>
              <a:rPr lang="en-US" altLang="ko-KR" sz="800" dirty="0" err="1"/>
              <a:t>r</a:t>
            </a:r>
            <a:r>
              <a:rPr lang="en-US" altLang="ko-KR" sz="800" baseline="-25000" dirty="0" err="1"/>
              <a:t>s</a:t>
            </a:r>
            <a:r>
              <a:rPr lang="en-US" altLang="ko-KR" sz="800" dirty="0"/>
              <a:t> = 0.02, </a:t>
            </a:r>
            <a:r>
              <a:rPr lang="en-US" altLang="ko-KR" sz="800" i="1" dirty="0"/>
              <a:t>P</a:t>
            </a:r>
            <a:r>
              <a:rPr lang="en-US" altLang="ko-KR" sz="800" dirty="0"/>
              <a:t> = 0.71</a:t>
            </a:r>
            <a:endParaRPr lang="ko-KR" altLang="en-US" sz="800" dirty="0"/>
          </a:p>
        </p:txBody>
      </p:sp>
      <p:sp>
        <p:nvSpPr>
          <p:cNvPr id="22" name="TextBox 21"/>
          <p:cNvSpPr txBox="1"/>
          <p:nvPr/>
        </p:nvSpPr>
        <p:spPr>
          <a:xfrm>
            <a:off x="3642853" y="2258213"/>
            <a:ext cx="658070" cy="215444"/>
          </a:xfrm>
          <a:prstGeom prst="rect">
            <a:avLst/>
          </a:prstGeom>
          <a:noFill/>
        </p:spPr>
        <p:txBody>
          <a:bodyPr wrap="square" rtlCol="0">
            <a:spAutoFit/>
          </a:bodyPr>
          <a:lstStyle/>
          <a:p>
            <a:pPr algn="ctr"/>
            <a:r>
              <a:rPr lang="en-US" altLang="ko-KR" sz="800" b="1" dirty="0"/>
              <a:t>VAT</a:t>
            </a:r>
            <a:endParaRPr lang="ko-KR" altLang="en-US" sz="800" b="1" dirty="0"/>
          </a:p>
        </p:txBody>
      </p:sp>
      <p:sp>
        <p:nvSpPr>
          <p:cNvPr id="23" name="TextBox 22"/>
          <p:cNvSpPr txBox="1"/>
          <p:nvPr/>
        </p:nvSpPr>
        <p:spPr>
          <a:xfrm>
            <a:off x="1396741" y="2227097"/>
            <a:ext cx="658070" cy="215444"/>
          </a:xfrm>
          <a:prstGeom prst="rect">
            <a:avLst/>
          </a:prstGeom>
          <a:noFill/>
        </p:spPr>
        <p:txBody>
          <a:bodyPr wrap="square" rtlCol="0">
            <a:spAutoFit/>
          </a:bodyPr>
          <a:lstStyle/>
          <a:p>
            <a:pPr algn="ctr"/>
            <a:r>
              <a:rPr lang="en-US" altLang="ko-KR" sz="800" b="1" dirty="0"/>
              <a:t>SAT</a:t>
            </a:r>
            <a:endParaRPr lang="ko-KR" altLang="en-US" sz="800" b="1" dirty="0"/>
          </a:p>
        </p:txBody>
      </p:sp>
      <p:graphicFrame>
        <p:nvGraphicFramePr>
          <p:cNvPr id="16" name="표 15"/>
          <p:cNvGraphicFramePr>
            <a:graphicFrameLocks noGrp="1"/>
          </p:cNvGraphicFramePr>
          <p:nvPr>
            <p:extLst>
              <p:ext uri="{D42A27DB-BD31-4B8C-83A1-F6EECF244321}">
                <p14:modId xmlns:p14="http://schemas.microsoft.com/office/powerpoint/2010/main" val="659986223"/>
              </p:ext>
            </p:extLst>
          </p:nvPr>
        </p:nvGraphicFramePr>
        <p:xfrm>
          <a:off x="833354" y="4060021"/>
          <a:ext cx="2466131" cy="2732229"/>
        </p:xfrm>
        <a:graphic>
          <a:graphicData uri="http://schemas.openxmlformats.org/drawingml/2006/table">
            <a:tbl>
              <a:tblPr/>
              <a:tblGrid>
                <a:gridCol w="591427">
                  <a:extLst>
                    <a:ext uri="{9D8B030D-6E8A-4147-A177-3AD203B41FA5}">
                      <a16:colId xmlns:a16="http://schemas.microsoft.com/office/drawing/2014/main" xmlns="" val="3750152784"/>
                    </a:ext>
                  </a:extLst>
                </a:gridCol>
                <a:gridCol w="468676">
                  <a:extLst>
                    <a:ext uri="{9D8B030D-6E8A-4147-A177-3AD203B41FA5}">
                      <a16:colId xmlns:a16="http://schemas.microsoft.com/office/drawing/2014/main" xmlns="" val="3228394047"/>
                    </a:ext>
                  </a:extLst>
                </a:gridCol>
                <a:gridCol w="468676">
                  <a:extLst>
                    <a:ext uri="{9D8B030D-6E8A-4147-A177-3AD203B41FA5}">
                      <a16:colId xmlns:a16="http://schemas.microsoft.com/office/drawing/2014/main" xmlns="" val="3306219529"/>
                    </a:ext>
                  </a:extLst>
                </a:gridCol>
                <a:gridCol w="468676">
                  <a:extLst>
                    <a:ext uri="{9D8B030D-6E8A-4147-A177-3AD203B41FA5}">
                      <a16:colId xmlns:a16="http://schemas.microsoft.com/office/drawing/2014/main" xmlns="" val="1855483575"/>
                    </a:ext>
                  </a:extLst>
                </a:gridCol>
                <a:gridCol w="468676">
                  <a:extLst>
                    <a:ext uri="{9D8B030D-6E8A-4147-A177-3AD203B41FA5}">
                      <a16:colId xmlns:a16="http://schemas.microsoft.com/office/drawing/2014/main" xmlns="" val="2571063602"/>
                    </a:ext>
                  </a:extLst>
                </a:gridCol>
              </a:tblGrid>
              <a:tr h="181315">
                <a:tc rowSpan="2">
                  <a:txBody>
                    <a:bodyPr/>
                    <a:lstStyle/>
                    <a:p>
                      <a:pPr algn="ctr" fontAlgn="ctr"/>
                      <a:r>
                        <a:rPr lang="ko-KR" altLang="en-US"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　</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gridSpan="2">
                  <a:txBody>
                    <a:bodyPr/>
                    <a:lstStyle/>
                    <a:p>
                      <a:pPr algn="ctr" fontAlgn="ctr"/>
                      <a:r>
                        <a:rPr lang="en-US"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Expression (tpm)</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latinLnBrk="1"/>
                      <a:endParaRPr lang="ko-KR" altLang="en-US"/>
                    </a:p>
                  </a:txBody>
                  <a:tcPr/>
                </a:tc>
                <a:tc gridSpan="2">
                  <a:txBody>
                    <a:bodyPr/>
                    <a:lstStyle/>
                    <a:p>
                      <a:pPr algn="ctr" fontAlgn="ctr"/>
                      <a:r>
                        <a:rPr lang="en-US"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GYG2-cor</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latinLnBrk="1"/>
                      <a:endParaRPr lang="ko-KR" altLang="en-US"/>
                    </a:p>
                  </a:txBody>
                  <a:tcPr/>
                </a:tc>
                <a:extLst>
                  <a:ext uri="{0D108BD9-81ED-4DB2-BD59-A6C34878D82A}">
                    <a16:rowId xmlns:a16="http://schemas.microsoft.com/office/drawing/2014/main" xmlns="" val="18574618"/>
                  </a:ext>
                </a:extLst>
              </a:tr>
              <a:tr h="187567">
                <a:tc vMerge="1">
                  <a:txBody>
                    <a:bodyPr/>
                    <a:lstStyle/>
                    <a:p>
                      <a:pPr latinLnBrk="1"/>
                      <a:endParaRPr lang="ko-KR" altLang="en-US"/>
                    </a:p>
                  </a:txBody>
                  <a:tcPr/>
                </a:tc>
                <a:tc>
                  <a:txBody>
                    <a:bodyPr/>
                    <a:lstStyle/>
                    <a:p>
                      <a:pPr algn="ctr" fontAlgn="ctr"/>
                      <a:r>
                        <a:rPr lang="en-US"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SAT</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VAT</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SAT</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VAT</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xmlns="" val="1715962749"/>
                  </a:ext>
                </a:extLst>
              </a:tr>
              <a:tr h="181315">
                <a:tc>
                  <a:txBody>
                    <a:bodyPr/>
                    <a:lstStyle/>
                    <a:p>
                      <a:pPr algn="ctr" fontAlgn="ctr"/>
                      <a:r>
                        <a:rPr lang="en-US"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GYG2</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dirty="0">
                          <a:solidFill>
                            <a:srgbClr val="000000"/>
                          </a:solidFill>
                          <a:effectLst/>
                          <a:latin typeface="Arial" panose="020B0604020202020204" pitchFamily="34" charset="0"/>
                          <a:ea typeface="맑은 고딕" panose="020B0503020000020004" pitchFamily="50" charset="-127"/>
                          <a:cs typeface="Arial" panose="020B0604020202020204" pitchFamily="34" charset="0"/>
                        </a:rPr>
                        <a:t>84.9</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69.1</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ko-KR" altLang="en-US"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　</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ko-KR" altLang="en-US"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　</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xmlns="" val="4018705785"/>
                  </a:ext>
                </a:extLst>
              </a:tr>
              <a:tr h="181315">
                <a:tc>
                  <a:txBody>
                    <a:bodyPr/>
                    <a:lstStyle/>
                    <a:p>
                      <a:pPr algn="ctr" fontAlgn="ctr"/>
                      <a:r>
                        <a:rPr lang="en-US"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ADIPOQ</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dirty="0">
                          <a:solidFill>
                            <a:srgbClr val="000000"/>
                          </a:solidFill>
                          <a:effectLst/>
                          <a:latin typeface="Arial" panose="020B0604020202020204" pitchFamily="34" charset="0"/>
                          <a:ea typeface="맑은 고딕" panose="020B0503020000020004" pitchFamily="50" charset="-127"/>
                          <a:cs typeface="Arial" panose="020B0604020202020204" pitchFamily="34" charset="0"/>
                        </a:rPr>
                        <a:t>621.2</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498.7</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0.74</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63BE7B"/>
                    </a:solidFill>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0.72</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67C07E"/>
                    </a:solidFill>
                  </a:tcPr>
                </a:tc>
                <a:extLst>
                  <a:ext uri="{0D108BD9-81ED-4DB2-BD59-A6C34878D82A}">
                    <a16:rowId xmlns:a16="http://schemas.microsoft.com/office/drawing/2014/main" xmlns="" val="2415728670"/>
                  </a:ext>
                </a:extLst>
              </a:tr>
              <a:tr h="181315">
                <a:tc>
                  <a:txBody>
                    <a:bodyPr/>
                    <a:lstStyle/>
                    <a:p>
                      <a:pPr algn="ctr" fontAlgn="ctr"/>
                      <a:r>
                        <a:rPr lang="en-US"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LEP</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dirty="0">
                          <a:solidFill>
                            <a:srgbClr val="000000"/>
                          </a:solidFill>
                          <a:effectLst/>
                          <a:latin typeface="Arial" panose="020B0604020202020204" pitchFamily="34" charset="0"/>
                          <a:ea typeface="맑은 고딕" panose="020B0503020000020004" pitchFamily="50" charset="-127"/>
                          <a:cs typeface="Arial" panose="020B0604020202020204" pitchFamily="34" charset="0"/>
                        </a:rPr>
                        <a:t>229.4</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61.7</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0.55</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8BCF9D"/>
                    </a:solidFill>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0.50</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95D3A5"/>
                    </a:solidFill>
                  </a:tcPr>
                </a:tc>
                <a:extLst>
                  <a:ext uri="{0D108BD9-81ED-4DB2-BD59-A6C34878D82A}">
                    <a16:rowId xmlns:a16="http://schemas.microsoft.com/office/drawing/2014/main" xmlns="" val="3800128371"/>
                  </a:ext>
                </a:extLst>
              </a:tr>
              <a:tr h="181315">
                <a:tc>
                  <a:txBody>
                    <a:bodyPr/>
                    <a:lstStyle/>
                    <a:p>
                      <a:pPr algn="ctr" fontAlgn="ctr"/>
                      <a:r>
                        <a:rPr lang="en-US"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AGT</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7.9</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dirty="0">
                          <a:solidFill>
                            <a:srgbClr val="000000"/>
                          </a:solidFill>
                          <a:effectLst/>
                          <a:latin typeface="Arial" panose="020B0604020202020204" pitchFamily="34" charset="0"/>
                          <a:ea typeface="맑은 고딕" panose="020B0503020000020004" pitchFamily="50" charset="-127"/>
                          <a:cs typeface="Arial" panose="020B0604020202020204" pitchFamily="34" charset="0"/>
                        </a:rPr>
                        <a:t>13.3</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0.19</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BACAD"/>
                    </a:solidFill>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0.03</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9FDFA"/>
                    </a:solidFill>
                  </a:tcPr>
                </a:tc>
                <a:extLst>
                  <a:ext uri="{0D108BD9-81ED-4DB2-BD59-A6C34878D82A}">
                    <a16:rowId xmlns:a16="http://schemas.microsoft.com/office/drawing/2014/main" xmlns="" val="2482145559"/>
                  </a:ext>
                </a:extLst>
              </a:tr>
              <a:tr h="181315">
                <a:tc>
                  <a:txBody>
                    <a:bodyPr/>
                    <a:lstStyle/>
                    <a:p>
                      <a:pPr algn="ctr" fontAlgn="ctr"/>
                      <a:r>
                        <a:rPr lang="en-US"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SPP1</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47.0</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dirty="0">
                          <a:solidFill>
                            <a:srgbClr val="000000"/>
                          </a:solidFill>
                          <a:effectLst/>
                          <a:latin typeface="Arial" panose="020B0604020202020204" pitchFamily="34" charset="0"/>
                          <a:ea typeface="맑은 고딕" panose="020B0503020000020004" pitchFamily="50" charset="-127"/>
                          <a:cs typeface="Arial" panose="020B0604020202020204" pitchFamily="34" charset="0"/>
                        </a:rPr>
                        <a:t>29.0</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0.08</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DDCDC"/>
                    </a:solidFill>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0.09</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DD8D8"/>
                    </a:solidFill>
                  </a:tcPr>
                </a:tc>
                <a:extLst>
                  <a:ext uri="{0D108BD9-81ED-4DB2-BD59-A6C34878D82A}">
                    <a16:rowId xmlns:a16="http://schemas.microsoft.com/office/drawing/2014/main" xmlns="" val="2017768327"/>
                  </a:ext>
                </a:extLst>
              </a:tr>
              <a:tr h="181315">
                <a:tc>
                  <a:txBody>
                    <a:bodyPr/>
                    <a:lstStyle/>
                    <a:p>
                      <a:pPr algn="ctr" fontAlgn="ctr"/>
                      <a:r>
                        <a:rPr lang="en-US"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RETN</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2.0</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1.9</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0.02</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EF4F4"/>
                    </a:solidFill>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0.00</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EFEFE"/>
                    </a:solidFill>
                  </a:tcPr>
                </a:tc>
                <a:extLst>
                  <a:ext uri="{0D108BD9-81ED-4DB2-BD59-A6C34878D82A}">
                    <a16:rowId xmlns:a16="http://schemas.microsoft.com/office/drawing/2014/main" xmlns="" val="3480751592"/>
                  </a:ext>
                </a:extLst>
              </a:tr>
              <a:tr h="181315">
                <a:tc>
                  <a:txBody>
                    <a:bodyPr/>
                    <a:lstStyle/>
                    <a:p>
                      <a:pPr algn="ctr" fontAlgn="ctr"/>
                      <a:r>
                        <a:rPr lang="en-US"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NAMPT</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76.9</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dirty="0">
                          <a:solidFill>
                            <a:srgbClr val="000000"/>
                          </a:solidFill>
                          <a:effectLst/>
                          <a:latin typeface="Arial" panose="020B0604020202020204" pitchFamily="34" charset="0"/>
                          <a:ea typeface="맑은 고딕" panose="020B0503020000020004" pitchFamily="50" charset="-127"/>
                          <a:cs typeface="Arial" panose="020B0604020202020204" pitchFamily="34" charset="0"/>
                        </a:rPr>
                        <a:t>185.2</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0.14</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CC1C2"/>
                    </a:solidFill>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0.01</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EFAFA"/>
                    </a:solidFill>
                  </a:tcPr>
                </a:tc>
                <a:extLst>
                  <a:ext uri="{0D108BD9-81ED-4DB2-BD59-A6C34878D82A}">
                    <a16:rowId xmlns:a16="http://schemas.microsoft.com/office/drawing/2014/main" xmlns="" val="1946002614"/>
                  </a:ext>
                </a:extLst>
              </a:tr>
              <a:tr h="181315">
                <a:tc>
                  <a:txBody>
                    <a:bodyPr/>
                    <a:lstStyle/>
                    <a:p>
                      <a:pPr algn="ctr" fontAlgn="ctr"/>
                      <a:r>
                        <a:rPr lang="en-US"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TNFSF10</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73.0</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dirty="0">
                          <a:solidFill>
                            <a:srgbClr val="000000"/>
                          </a:solidFill>
                          <a:effectLst/>
                          <a:latin typeface="Arial" panose="020B0604020202020204" pitchFamily="34" charset="0"/>
                          <a:ea typeface="맑은 고딕" panose="020B0503020000020004" pitchFamily="50" charset="-127"/>
                          <a:cs typeface="Arial" panose="020B0604020202020204" pitchFamily="34" charset="0"/>
                        </a:rPr>
                        <a:t>75.2</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0.17</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BB5B6"/>
                    </a:solidFill>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0.18</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BB3B4"/>
                    </a:solidFill>
                  </a:tcPr>
                </a:tc>
                <a:extLst>
                  <a:ext uri="{0D108BD9-81ED-4DB2-BD59-A6C34878D82A}">
                    <a16:rowId xmlns:a16="http://schemas.microsoft.com/office/drawing/2014/main" xmlns="" val="3501849100"/>
                  </a:ext>
                </a:extLst>
              </a:tr>
              <a:tr h="181315">
                <a:tc>
                  <a:txBody>
                    <a:bodyPr/>
                    <a:lstStyle/>
                    <a:p>
                      <a:pPr algn="ctr" fontAlgn="ctr"/>
                      <a:r>
                        <a:rPr lang="en-US"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TNFSF12</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92.9</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73.3</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dirty="0">
                          <a:solidFill>
                            <a:srgbClr val="000000"/>
                          </a:solidFill>
                          <a:effectLst/>
                          <a:latin typeface="Arial" panose="020B0604020202020204" pitchFamily="34" charset="0"/>
                          <a:ea typeface="맑은 고딕" panose="020B0503020000020004" pitchFamily="50" charset="-127"/>
                          <a:cs typeface="Arial" panose="020B0604020202020204" pitchFamily="34" charset="0"/>
                        </a:rPr>
                        <a:t>-0.35</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8696B"/>
                    </a:solidFill>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0.17</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BB6B7"/>
                    </a:solidFill>
                  </a:tcPr>
                </a:tc>
                <a:extLst>
                  <a:ext uri="{0D108BD9-81ED-4DB2-BD59-A6C34878D82A}">
                    <a16:rowId xmlns:a16="http://schemas.microsoft.com/office/drawing/2014/main" xmlns="" val="3944463533"/>
                  </a:ext>
                </a:extLst>
              </a:tr>
              <a:tr h="181315">
                <a:tc>
                  <a:txBody>
                    <a:bodyPr/>
                    <a:lstStyle/>
                    <a:p>
                      <a:pPr algn="ctr" fontAlgn="ctr"/>
                      <a:r>
                        <a:rPr lang="en-US"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TNFSF13</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30.1</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42.0</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dirty="0">
                          <a:solidFill>
                            <a:srgbClr val="000000"/>
                          </a:solidFill>
                          <a:effectLst/>
                          <a:latin typeface="Arial" panose="020B0604020202020204" pitchFamily="34" charset="0"/>
                          <a:ea typeface="맑은 고딕" panose="020B0503020000020004" pitchFamily="50" charset="-127"/>
                          <a:cs typeface="Arial" panose="020B0604020202020204" pitchFamily="34" charset="0"/>
                        </a:rPr>
                        <a:t>0.07</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0F9F3"/>
                    </a:solidFill>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0.07</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DE0E0"/>
                    </a:solidFill>
                  </a:tcPr>
                </a:tc>
                <a:extLst>
                  <a:ext uri="{0D108BD9-81ED-4DB2-BD59-A6C34878D82A}">
                    <a16:rowId xmlns:a16="http://schemas.microsoft.com/office/drawing/2014/main" xmlns="" val="1822711908"/>
                  </a:ext>
                </a:extLst>
              </a:tr>
              <a:tr h="181315">
                <a:tc>
                  <a:txBody>
                    <a:bodyPr/>
                    <a:lstStyle/>
                    <a:p>
                      <a:pPr algn="ctr" fontAlgn="ctr"/>
                      <a:r>
                        <a:rPr lang="en-US"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IL6</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6.5</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36.1</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dirty="0">
                          <a:solidFill>
                            <a:srgbClr val="000000"/>
                          </a:solidFill>
                          <a:effectLst/>
                          <a:latin typeface="Arial" panose="020B0604020202020204" pitchFamily="34" charset="0"/>
                          <a:ea typeface="맑은 고딕" panose="020B0503020000020004" pitchFamily="50" charset="-127"/>
                          <a:cs typeface="Arial" panose="020B0604020202020204" pitchFamily="34" charset="0"/>
                        </a:rPr>
                        <a:t>-0.16</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BBBBC"/>
                    </a:solidFill>
                  </a:tcPr>
                </a:tc>
                <a:tc>
                  <a:txBody>
                    <a:bodyPr/>
                    <a:lstStyle/>
                    <a:p>
                      <a:pPr algn="ctr" fontAlgn="ctr"/>
                      <a:r>
                        <a:rPr lang="en-US" altLang="ko-KR" sz="800" b="0" i="0" u="none" strike="noStrike" dirty="0">
                          <a:solidFill>
                            <a:srgbClr val="000000"/>
                          </a:solidFill>
                          <a:effectLst/>
                          <a:latin typeface="Arial" panose="020B0604020202020204" pitchFamily="34" charset="0"/>
                          <a:ea typeface="맑은 고딕" panose="020B0503020000020004" pitchFamily="50" charset="-127"/>
                          <a:cs typeface="Arial" panose="020B0604020202020204" pitchFamily="34" charset="0"/>
                        </a:rPr>
                        <a:t>0.03</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9FDFA"/>
                    </a:solidFill>
                  </a:tcPr>
                </a:tc>
                <a:extLst>
                  <a:ext uri="{0D108BD9-81ED-4DB2-BD59-A6C34878D82A}">
                    <a16:rowId xmlns:a16="http://schemas.microsoft.com/office/drawing/2014/main" xmlns="" val="324118285"/>
                  </a:ext>
                </a:extLst>
              </a:tr>
              <a:tr h="181315">
                <a:tc>
                  <a:txBody>
                    <a:bodyPr/>
                    <a:lstStyle/>
                    <a:p>
                      <a:pPr algn="ctr" fontAlgn="ctr"/>
                      <a:r>
                        <a:rPr lang="en-US"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CCL2</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33.4</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143.0</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0.18</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BB0B2"/>
                    </a:solidFill>
                  </a:tcPr>
                </a:tc>
                <a:tc>
                  <a:txBody>
                    <a:bodyPr/>
                    <a:lstStyle/>
                    <a:p>
                      <a:pPr algn="ctr" fontAlgn="ctr"/>
                      <a:r>
                        <a:rPr lang="en-US" altLang="ko-KR" sz="800" b="0" i="0" u="none" strike="noStrike" dirty="0">
                          <a:solidFill>
                            <a:srgbClr val="000000"/>
                          </a:solidFill>
                          <a:effectLst/>
                          <a:latin typeface="Arial" panose="020B0604020202020204" pitchFamily="34" charset="0"/>
                          <a:ea typeface="맑은 고딕" panose="020B0503020000020004" pitchFamily="50" charset="-127"/>
                          <a:cs typeface="Arial" panose="020B0604020202020204" pitchFamily="34" charset="0"/>
                        </a:rPr>
                        <a:t>0.07</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0F9F3"/>
                    </a:solidFill>
                  </a:tcPr>
                </a:tc>
                <a:extLst>
                  <a:ext uri="{0D108BD9-81ED-4DB2-BD59-A6C34878D82A}">
                    <a16:rowId xmlns:a16="http://schemas.microsoft.com/office/drawing/2014/main" xmlns="" val="2539386356"/>
                  </a:ext>
                </a:extLst>
              </a:tr>
              <a:tr h="187567">
                <a:tc>
                  <a:txBody>
                    <a:bodyPr/>
                    <a:lstStyle/>
                    <a:p>
                      <a:pPr algn="ctr" fontAlgn="ctr"/>
                      <a:r>
                        <a:rPr lang="en-US" sz="800" b="0" i="0" u="none" strike="noStrike" dirty="0">
                          <a:solidFill>
                            <a:srgbClr val="000000"/>
                          </a:solidFill>
                          <a:effectLst/>
                          <a:latin typeface="Arial" panose="020B0604020202020204" pitchFamily="34" charset="0"/>
                          <a:ea typeface="맑은 고딕" panose="020B0503020000020004" pitchFamily="50" charset="-127"/>
                          <a:cs typeface="Arial" panose="020B0604020202020204" pitchFamily="34" charset="0"/>
                        </a:rPr>
                        <a:t>CXCL8</a:t>
                      </a:r>
                    </a:p>
                  </a:txBody>
                  <a:tcPr marL="7620" marR="7620" marT="762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2.3</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15.7</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altLang="ko-KR" sz="800" b="0" i="0" u="none" strike="noStrike">
                          <a:solidFill>
                            <a:srgbClr val="000000"/>
                          </a:solidFill>
                          <a:effectLst/>
                          <a:latin typeface="Arial" panose="020B0604020202020204" pitchFamily="34" charset="0"/>
                          <a:ea typeface="맑은 고딕" panose="020B0503020000020004" pitchFamily="50" charset="-127"/>
                          <a:cs typeface="Arial" panose="020B0604020202020204" pitchFamily="34" charset="0"/>
                        </a:rPr>
                        <a:t>-0.19</a:t>
                      </a:r>
                    </a:p>
                  </a:txBody>
                  <a:tcPr marL="7620" marR="7620" marT="762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BAFB0"/>
                    </a:solidFill>
                  </a:tcPr>
                </a:tc>
                <a:tc>
                  <a:txBody>
                    <a:bodyPr/>
                    <a:lstStyle/>
                    <a:p>
                      <a:pPr algn="ctr" fontAlgn="ctr"/>
                      <a:r>
                        <a:rPr lang="en-US" altLang="ko-KR" sz="800" b="0" i="0" u="none" strike="noStrike" dirty="0">
                          <a:solidFill>
                            <a:srgbClr val="000000"/>
                          </a:solidFill>
                          <a:effectLst/>
                          <a:latin typeface="Arial" panose="020B0604020202020204" pitchFamily="34" charset="0"/>
                          <a:ea typeface="맑은 고딕" panose="020B0503020000020004" pitchFamily="50" charset="-127"/>
                          <a:cs typeface="Arial" panose="020B0604020202020204" pitchFamily="34" charset="0"/>
                        </a:rPr>
                        <a:t>-0.07</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DE2E3"/>
                    </a:solidFill>
                  </a:tcPr>
                </a:tc>
                <a:extLst>
                  <a:ext uri="{0D108BD9-81ED-4DB2-BD59-A6C34878D82A}">
                    <a16:rowId xmlns:a16="http://schemas.microsoft.com/office/drawing/2014/main" xmlns="" val="1802049776"/>
                  </a:ext>
                </a:extLst>
              </a:tr>
            </a:tbl>
          </a:graphicData>
        </a:graphic>
      </p:graphicFrame>
      <p:sp>
        <p:nvSpPr>
          <p:cNvPr id="17" name="TextBox 16"/>
          <p:cNvSpPr txBox="1"/>
          <p:nvPr/>
        </p:nvSpPr>
        <p:spPr>
          <a:xfrm>
            <a:off x="3307815" y="3882062"/>
            <a:ext cx="477042" cy="246221"/>
          </a:xfrm>
          <a:prstGeom prst="rect">
            <a:avLst/>
          </a:prstGeom>
          <a:noFill/>
        </p:spPr>
        <p:txBody>
          <a:bodyPr wrap="square" rtlCol="0">
            <a:spAutoFit/>
          </a:bodyPr>
          <a:lstStyle/>
          <a:p>
            <a:r>
              <a:rPr lang="en-US" altLang="ko-KR" sz="1000" b="1" dirty="0">
                <a:latin typeface="+mn-ea"/>
              </a:rPr>
              <a:t>E</a:t>
            </a:r>
            <a:endParaRPr lang="ko-KR" altLang="en-US" sz="1000" b="1" dirty="0">
              <a:latin typeface="+mn-ea"/>
            </a:endParaRPr>
          </a:p>
        </p:txBody>
      </p:sp>
      <p:sp>
        <p:nvSpPr>
          <p:cNvPr id="24" name="TextBox 23"/>
          <p:cNvSpPr txBox="1"/>
          <p:nvPr/>
        </p:nvSpPr>
        <p:spPr>
          <a:xfrm>
            <a:off x="566442" y="3882062"/>
            <a:ext cx="484250" cy="246221"/>
          </a:xfrm>
          <a:prstGeom prst="rect">
            <a:avLst/>
          </a:prstGeom>
          <a:noFill/>
        </p:spPr>
        <p:txBody>
          <a:bodyPr wrap="square" rtlCol="0">
            <a:spAutoFit/>
          </a:bodyPr>
          <a:lstStyle/>
          <a:p>
            <a:r>
              <a:rPr lang="en-US" altLang="ko-KR" sz="1000" b="1" dirty="0">
                <a:latin typeface="+mn-ea"/>
              </a:rPr>
              <a:t>D </a:t>
            </a:r>
            <a:endParaRPr lang="ko-KR" altLang="en-US" sz="1000" b="1" dirty="0">
              <a:solidFill>
                <a:srgbClr val="FF0000"/>
              </a:solidFill>
              <a:latin typeface="+mn-ea"/>
            </a:endParaRPr>
          </a:p>
        </p:txBody>
      </p:sp>
      <p:graphicFrame>
        <p:nvGraphicFramePr>
          <p:cNvPr id="26" name="차트 25"/>
          <p:cNvGraphicFramePr>
            <a:graphicFrameLocks/>
          </p:cNvGraphicFramePr>
          <p:nvPr>
            <p:extLst>
              <p:ext uri="{D42A27DB-BD31-4B8C-83A1-F6EECF244321}">
                <p14:modId xmlns:p14="http://schemas.microsoft.com/office/powerpoint/2010/main" val="3163057189"/>
              </p:ext>
            </p:extLst>
          </p:nvPr>
        </p:nvGraphicFramePr>
        <p:xfrm>
          <a:off x="3793187" y="4066769"/>
          <a:ext cx="1800000" cy="1440000"/>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27" name="차트 26"/>
          <p:cNvGraphicFramePr>
            <a:graphicFrameLocks/>
          </p:cNvGraphicFramePr>
          <p:nvPr>
            <p:extLst>
              <p:ext uri="{D42A27DB-BD31-4B8C-83A1-F6EECF244321}">
                <p14:modId xmlns:p14="http://schemas.microsoft.com/office/powerpoint/2010/main" val="160802386"/>
              </p:ext>
            </p:extLst>
          </p:nvPr>
        </p:nvGraphicFramePr>
        <p:xfrm>
          <a:off x="3793187" y="5501070"/>
          <a:ext cx="1800000" cy="1440000"/>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28" name="차트 27"/>
          <p:cNvGraphicFramePr>
            <a:graphicFrameLocks/>
          </p:cNvGraphicFramePr>
          <p:nvPr>
            <p:extLst>
              <p:ext uri="{D42A27DB-BD31-4B8C-83A1-F6EECF244321}">
                <p14:modId xmlns:p14="http://schemas.microsoft.com/office/powerpoint/2010/main" val="2950838410"/>
              </p:ext>
            </p:extLst>
          </p:nvPr>
        </p:nvGraphicFramePr>
        <p:xfrm>
          <a:off x="3793187" y="6935371"/>
          <a:ext cx="1800000" cy="1440000"/>
        </p:xfrm>
        <a:graphic>
          <a:graphicData uri="http://schemas.openxmlformats.org/drawingml/2006/chart">
            <c:chart xmlns:c="http://schemas.openxmlformats.org/drawingml/2006/chart" xmlns:r="http://schemas.openxmlformats.org/officeDocument/2006/relationships" r:id="rId8"/>
          </a:graphicData>
        </a:graphic>
      </p:graphicFrame>
    </p:spTree>
    <p:extLst>
      <p:ext uri="{BB962C8B-B14F-4D97-AF65-F5344CB8AC3E}">
        <p14:creationId xmlns:p14="http://schemas.microsoft.com/office/powerpoint/2010/main" val="181512076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27321" y="196770"/>
            <a:ext cx="6694293" cy="369332"/>
          </a:xfrm>
          <a:prstGeom prst="rect">
            <a:avLst/>
          </a:prstGeom>
          <a:noFill/>
        </p:spPr>
        <p:txBody>
          <a:bodyPr wrap="square" rtlCol="0">
            <a:spAutoFit/>
          </a:bodyPr>
          <a:lstStyle/>
          <a:p>
            <a:r>
              <a:rPr lang="en-US" altLang="ko-KR" dirty="0"/>
              <a:t>Supplementary Figure 4</a:t>
            </a:r>
            <a:endParaRPr lang="ko-KR" altLang="en-US" dirty="0"/>
          </a:p>
        </p:txBody>
      </p:sp>
      <p:graphicFrame>
        <p:nvGraphicFramePr>
          <p:cNvPr id="3" name="차트 2"/>
          <p:cNvGraphicFramePr>
            <a:graphicFrameLocks/>
          </p:cNvGraphicFramePr>
          <p:nvPr>
            <p:extLst>
              <p:ext uri="{D42A27DB-BD31-4B8C-83A1-F6EECF244321}">
                <p14:modId xmlns:p14="http://schemas.microsoft.com/office/powerpoint/2010/main" val="1283221406"/>
              </p:ext>
            </p:extLst>
          </p:nvPr>
        </p:nvGraphicFramePr>
        <p:xfrm>
          <a:off x="845363" y="2112066"/>
          <a:ext cx="1440000" cy="1440000"/>
        </p:xfrm>
        <a:graphic>
          <a:graphicData uri="http://schemas.openxmlformats.org/drawingml/2006/chart">
            <c:chart xmlns:c="http://schemas.openxmlformats.org/drawingml/2006/chart" xmlns:r="http://schemas.openxmlformats.org/officeDocument/2006/relationships" r:id="rId3"/>
          </a:graphicData>
        </a:graphic>
      </p:graphicFrame>
      <p:pic>
        <p:nvPicPr>
          <p:cNvPr id="4" name="그림 3"/>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576990" y="1020838"/>
            <a:ext cx="900000" cy="675000"/>
          </a:xfrm>
          <a:prstGeom prst="rect">
            <a:avLst/>
          </a:prstGeom>
        </p:spPr>
      </p:pic>
      <p:pic>
        <p:nvPicPr>
          <p:cNvPr id="5" name="그림 4"/>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1506864" y="1020838"/>
            <a:ext cx="900000" cy="675000"/>
          </a:xfrm>
          <a:prstGeom prst="rect">
            <a:avLst/>
          </a:prstGeom>
        </p:spPr>
      </p:pic>
      <p:pic>
        <p:nvPicPr>
          <p:cNvPr id="6" name="그림 5"/>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2436739" y="1020838"/>
            <a:ext cx="900000" cy="675000"/>
          </a:xfrm>
          <a:prstGeom prst="rect">
            <a:avLst/>
          </a:prstGeom>
        </p:spPr>
      </p:pic>
      <p:sp>
        <p:nvSpPr>
          <p:cNvPr id="7" name="TextBox 6"/>
          <p:cNvSpPr txBox="1"/>
          <p:nvPr/>
        </p:nvSpPr>
        <p:spPr>
          <a:xfrm>
            <a:off x="1415237" y="1702330"/>
            <a:ext cx="1083253" cy="215444"/>
          </a:xfrm>
          <a:prstGeom prst="rect">
            <a:avLst/>
          </a:prstGeom>
          <a:noFill/>
        </p:spPr>
        <p:txBody>
          <a:bodyPr wrap="square" rtlCol="0">
            <a:spAutoFit/>
          </a:bodyPr>
          <a:lstStyle/>
          <a:p>
            <a:pPr algn="ctr"/>
            <a:r>
              <a:rPr lang="en-US" altLang="ko-KR" sz="800" b="1" dirty="0"/>
              <a:t>2 W</a:t>
            </a:r>
            <a:endParaRPr lang="ko-KR" altLang="en-US" sz="800" b="1" dirty="0"/>
          </a:p>
        </p:txBody>
      </p:sp>
      <p:sp>
        <p:nvSpPr>
          <p:cNvPr id="8" name="TextBox 7"/>
          <p:cNvSpPr txBox="1"/>
          <p:nvPr/>
        </p:nvSpPr>
        <p:spPr>
          <a:xfrm>
            <a:off x="2345111" y="1702330"/>
            <a:ext cx="1083253" cy="215444"/>
          </a:xfrm>
          <a:prstGeom prst="rect">
            <a:avLst/>
          </a:prstGeom>
          <a:noFill/>
        </p:spPr>
        <p:txBody>
          <a:bodyPr wrap="square" rtlCol="0">
            <a:spAutoFit/>
          </a:bodyPr>
          <a:lstStyle/>
          <a:p>
            <a:pPr algn="ctr"/>
            <a:r>
              <a:rPr lang="en-US" altLang="ko-KR" sz="800" b="1" dirty="0"/>
              <a:t>4 W</a:t>
            </a:r>
            <a:endParaRPr lang="ko-KR" altLang="en-US" sz="800" b="1" dirty="0"/>
          </a:p>
        </p:txBody>
      </p:sp>
      <p:sp>
        <p:nvSpPr>
          <p:cNvPr id="9" name="TextBox 8"/>
          <p:cNvSpPr txBox="1"/>
          <p:nvPr/>
        </p:nvSpPr>
        <p:spPr>
          <a:xfrm>
            <a:off x="485363" y="1702330"/>
            <a:ext cx="1083253" cy="215444"/>
          </a:xfrm>
          <a:prstGeom prst="rect">
            <a:avLst/>
          </a:prstGeom>
          <a:noFill/>
        </p:spPr>
        <p:txBody>
          <a:bodyPr wrap="square" rtlCol="0">
            <a:spAutoFit/>
          </a:bodyPr>
          <a:lstStyle/>
          <a:p>
            <a:pPr algn="ctr"/>
            <a:r>
              <a:rPr lang="en-US" altLang="ko-KR" sz="800" b="1" dirty="0"/>
              <a:t>0 W</a:t>
            </a:r>
            <a:endParaRPr lang="ko-KR" altLang="en-US" sz="800" b="1" dirty="0"/>
          </a:p>
        </p:txBody>
      </p:sp>
      <p:sp>
        <p:nvSpPr>
          <p:cNvPr id="10" name="TextBox 9"/>
          <p:cNvSpPr txBox="1"/>
          <p:nvPr/>
        </p:nvSpPr>
        <p:spPr>
          <a:xfrm>
            <a:off x="485363" y="732899"/>
            <a:ext cx="360000" cy="246221"/>
          </a:xfrm>
          <a:prstGeom prst="rect">
            <a:avLst/>
          </a:prstGeom>
          <a:noFill/>
        </p:spPr>
        <p:txBody>
          <a:bodyPr wrap="square" rtlCol="0">
            <a:spAutoFit/>
          </a:bodyPr>
          <a:lstStyle/>
          <a:p>
            <a:r>
              <a:rPr lang="en-US" altLang="ko-KR" sz="1000" b="1" dirty="0">
                <a:latin typeface="+mn-ea"/>
              </a:rPr>
              <a:t>A</a:t>
            </a:r>
          </a:p>
        </p:txBody>
      </p:sp>
      <p:sp>
        <p:nvSpPr>
          <p:cNvPr id="11" name="TextBox 10"/>
          <p:cNvSpPr txBox="1"/>
          <p:nvPr/>
        </p:nvSpPr>
        <p:spPr>
          <a:xfrm>
            <a:off x="538655" y="2159802"/>
            <a:ext cx="360000" cy="246221"/>
          </a:xfrm>
          <a:prstGeom prst="rect">
            <a:avLst/>
          </a:prstGeom>
          <a:noFill/>
        </p:spPr>
        <p:txBody>
          <a:bodyPr wrap="square" rtlCol="0">
            <a:spAutoFit/>
          </a:bodyPr>
          <a:lstStyle/>
          <a:p>
            <a:r>
              <a:rPr lang="en-US" altLang="ko-KR" sz="1000" b="1" dirty="0">
                <a:latin typeface="+mn-ea"/>
              </a:rPr>
              <a:t>B</a:t>
            </a:r>
            <a:endParaRPr lang="ko-KR" altLang="en-US" sz="1000" b="1" dirty="0">
              <a:latin typeface="+mn-ea"/>
            </a:endParaRPr>
          </a:p>
        </p:txBody>
      </p:sp>
      <p:sp>
        <p:nvSpPr>
          <p:cNvPr id="12" name="TextBox 11"/>
          <p:cNvSpPr txBox="1"/>
          <p:nvPr/>
        </p:nvSpPr>
        <p:spPr>
          <a:xfrm>
            <a:off x="1574997" y="2190579"/>
            <a:ext cx="369502" cy="215444"/>
          </a:xfrm>
          <a:prstGeom prst="rect">
            <a:avLst/>
          </a:prstGeom>
          <a:noFill/>
        </p:spPr>
        <p:txBody>
          <a:bodyPr wrap="square" rtlCol="0">
            <a:spAutoFit/>
          </a:bodyPr>
          <a:lstStyle/>
          <a:p>
            <a:pPr algn="ctr"/>
            <a:r>
              <a:rPr lang="en-US" altLang="ko-KR" sz="800" b="1" dirty="0"/>
              <a:t>NS</a:t>
            </a:r>
            <a:endParaRPr lang="ko-KR" altLang="en-US" sz="800" b="1" dirty="0"/>
          </a:p>
        </p:txBody>
      </p:sp>
      <p:cxnSp>
        <p:nvCxnSpPr>
          <p:cNvPr id="13" name="직선 연결선 12"/>
          <p:cNvCxnSpPr/>
          <p:nvPr/>
        </p:nvCxnSpPr>
        <p:spPr>
          <a:xfrm>
            <a:off x="1453748" y="2388997"/>
            <a:ext cx="612000" cy="336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41792607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27321" y="196770"/>
            <a:ext cx="6694293" cy="369332"/>
          </a:xfrm>
          <a:prstGeom prst="rect">
            <a:avLst/>
          </a:prstGeom>
          <a:noFill/>
        </p:spPr>
        <p:txBody>
          <a:bodyPr wrap="square" rtlCol="0">
            <a:spAutoFit/>
          </a:bodyPr>
          <a:lstStyle/>
          <a:p>
            <a:r>
              <a:rPr lang="en-US" altLang="ko-KR" dirty="0"/>
              <a:t>Supplementary Figure 5</a:t>
            </a:r>
            <a:endParaRPr lang="ko-KR" altLang="en-US" dirty="0"/>
          </a:p>
        </p:txBody>
      </p:sp>
      <p:graphicFrame>
        <p:nvGraphicFramePr>
          <p:cNvPr id="3" name="차트 2"/>
          <p:cNvGraphicFramePr>
            <a:graphicFrameLocks/>
          </p:cNvGraphicFramePr>
          <p:nvPr>
            <p:extLst>
              <p:ext uri="{D42A27DB-BD31-4B8C-83A1-F6EECF244321}">
                <p14:modId xmlns:p14="http://schemas.microsoft.com/office/powerpoint/2010/main" val="4235618445"/>
              </p:ext>
            </p:extLst>
          </p:nvPr>
        </p:nvGraphicFramePr>
        <p:xfrm>
          <a:off x="716156" y="885460"/>
          <a:ext cx="1800000" cy="1800000"/>
        </p:xfrm>
        <a:graphic>
          <a:graphicData uri="http://schemas.openxmlformats.org/drawingml/2006/chart">
            <c:chart xmlns:c="http://schemas.openxmlformats.org/drawingml/2006/chart" xmlns:r="http://schemas.openxmlformats.org/officeDocument/2006/relationships" r:id="rId3"/>
          </a:graphicData>
        </a:graphic>
      </p:graphicFrame>
      <p:sp>
        <p:nvSpPr>
          <p:cNvPr id="4" name="TextBox 3"/>
          <p:cNvSpPr txBox="1"/>
          <p:nvPr/>
        </p:nvSpPr>
        <p:spPr>
          <a:xfrm>
            <a:off x="1188936" y="762349"/>
            <a:ext cx="854440" cy="246221"/>
          </a:xfrm>
          <a:prstGeom prst="rect">
            <a:avLst/>
          </a:prstGeom>
          <a:noFill/>
        </p:spPr>
        <p:txBody>
          <a:bodyPr wrap="square" rtlCol="0">
            <a:spAutoFit/>
          </a:bodyPr>
          <a:lstStyle/>
          <a:p>
            <a:pPr algn="ctr"/>
            <a:r>
              <a:rPr lang="en-US" altLang="ko-KR" sz="1000" b="1" dirty="0"/>
              <a:t>SenMayo</a:t>
            </a:r>
            <a:endParaRPr lang="ko-KR" altLang="en-US" sz="1000" b="1" dirty="0"/>
          </a:p>
        </p:txBody>
      </p:sp>
      <p:sp>
        <p:nvSpPr>
          <p:cNvPr id="5" name="TextBox 4"/>
          <p:cNvSpPr txBox="1"/>
          <p:nvPr/>
        </p:nvSpPr>
        <p:spPr>
          <a:xfrm>
            <a:off x="2616936" y="762349"/>
            <a:ext cx="1976204" cy="246221"/>
          </a:xfrm>
          <a:prstGeom prst="rect">
            <a:avLst/>
          </a:prstGeom>
          <a:noFill/>
        </p:spPr>
        <p:txBody>
          <a:bodyPr wrap="square" rtlCol="0">
            <a:spAutoFit/>
          </a:bodyPr>
          <a:lstStyle/>
          <a:p>
            <a:pPr algn="ctr"/>
            <a:r>
              <a:rPr lang="en-US" altLang="ko-KR" sz="1000" b="1" dirty="0"/>
              <a:t>Molecular signatures of aging</a:t>
            </a:r>
            <a:endParaRPr lang="ko-KR" altLang="en-US" sz="1000" b="1" dirty="0"/>
          </a:p>
        </p:txBody>
      </p:sp>
      <p:sp>
        <p:nvSpPr>
          <p:cNvPr id="6" name="TextBox 5"/>
          <p:cNvSpPr txBox="1"/>
          <p:nvPr/>
        </p:nvSpPr>
        <p:spPr>
          <a:xfrm>
            <a:off x="4921770" y="762349"/>
            <a:ext cx="1354111" cy="246221"/>
          </a:xfrm>
          <a:prstGeom prst="rect">
            <a:avLst/>
          </a:prstGeom>
          <a:noFill/>
        </p:spPr>
        <p:txBody>
          <a:bodyPr wrap="square" rtlCol="0">
            <a:spAutoFit/>
          </a:bodyPr>
          <a:lstStyle/>
          <a:p>
            <a:pPr algn="ctr"/>
            <a:r>
              <a:rPr lang="en-US" altLang="ko-KR" sz="1000" b="1" dirty="0"/>
              <a:t>CellAge</a:t>
            </a:r>
            <a:endParaRPr lang="ko-KR" altLang="en-US" sz="1000" b="1" dirty="0"/>
          </a:p>
        </p:txBody>
      </p:sp>
      <p:graphicFrame>
        <p:nvGraphicFramePr>
          <p:cNvPr id="7" name="차트 6"/>
          <p:cNvGraphicFramePr>
            <a:graphicFrameLocks/>
          </p:cNvGraphicFramePr>
          <p:nvPr>
            <p:extLst>
              <p:ext uri="{D42A27DB-BD31-4B8C-83A1-F6EECF244321}">
                <p14:modId xmlns:p14="http://schemas.microsoft.com/office/powerpoint/2010/main" val="3632178228"/>
              </p:ext>
            </p:extLst>
          </p:nvPr>
        </p:nvGraphicFramePr>
        <p:xfrm>
          <a:off x="2699251" y="885460"/>
          <a:ext cx="1800000" cy="18000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8" name="차트 7"/>
          <p:cNvGraphicFramePr>
            <a:graphicFrameLocks/>
          </p:cNvGraphicFramePr>
          <p:nvPr>
            <p:extLst>
              <p:ext uri="{D42A27DB-BD31-4B8C-83A1-F6EECF244321}">
                <p14:modId xmlns:p14="http://schemas.microsoft.com/office/powerpoint/2010/main" val="2920983003"/>
              </p:ext>
            </p:extLst>
          </p:nvPr>
        </p:nvGraphicFramePr>
        <p:xfrm>
          <a:off x="4698825" y="885460"/>
          <a:ext cx="1800000" cy="1800000"/>
        </p:xfrm>
        <a:graphic>
          <a:graphicData uri="http://schemas.openxmlformats.org/drawingml/2006/chart">
            <c:chart xmlns:c="http://schemas.openxmlformats.org/drawingml/2006/chart" xmlns:r="http://schemas.openxmlformats.org/officeDocument/2006/relationships" r:id="rId5"/>
          </a:graphicData>
        </a:graphic>
      </p:graphicFrame>
      <p:sp>
        <p:nvSpPr>
          <p:cNvPr id="9" name="TextBox 8"/>
          <p:cNvSpPr txBox="1"/>
          <p:nvPr/>
        </p:nvSpPr>
        <p:spPr>
          <a:xfrm>
            <a:off x="660533" y="762349"/>
            <a:ext cx="365048" cy="246221"/>
          </a:xfrm>
          <a:prstGeom prst="rect">
            <a:avLst/>
          </a:prstGeom>
          <a:noFill/>
        </p:spPr>
        <p:txBody>
          <a:bodyPr wrap="square" rtlCol="0">
            <a:spAutoFit/>
          </a:bodyPr>
          <a:lstStyle/>
          <a:p>
            <a:r>
              <a:rPr lang="en-US" altLang="ko-KR" sz="1000" b="1" dirty="0">
                <a:latin typeface="+mn-ea"/>
              </a:rPr>
              <a:t>A </a:t>
            </a:r>
            <a:endParaRPr lang="ko-KR" altLang="en-US" sz="1000" b="1" dirty="0">
              <a:solidFill>
                <a:srgbClr val="FF0000"/>
              </a:solidFill>
              <a:latin typeface="+mn-ea"/>
            </a:endParaRPr>
          </a:p>
        </p:txBody>
      </p:sp>
      <p:sp>
        <p:nvSpPr>
          <p:cNvPr id="10" name="TextBox 9"/>
          <p:cNvSpPr txBox="1"/>
          <p:nvPr/>
        </p:nvSpPr>
        <p:spPr>
          <a:xfrm>
            <a:off x="4885906" y="762349"/>
            <a:ext cx="477042" cy="246221"/>
          </a:xfrm>
          <a:prstGeom prst="rect">
            <a:avLst/>
          </a:prstGeom>
          <a:noFill/>
        </p:spPr>
        <p:txBody>
          <a:bodyPr wrap="square" rtlCol="0">
            <a:spAutoFit/>
          </a:bodyPr>
          <a:lstStyle/>
          <a:p>
            <a:r>
              <a:rPr lang="en-US" altLang="ko-KR" sz="1000" b="1" dirty="0">
                <a:latin typeface="+mn-ea"/>
              </a:rPr>
              <a:t>C</a:t>
            </a:r>
            <a:endParaRPr lang="ko-KR" altLang="en-US" sz="1000" b="1" dirty="0">
              <a:latin typeface="+mn-ea"/>
            </a:endParaRPr>
          </a:p>
        </p:txBody>
      </p:sp>
      <p:sp>
        <p:nvSpPr>
          <p:cNvPr id="11" name="TextBox 10"/>
          <p:cNvSpPr txBox="1"/>
          <p:nvPr/>
        </p:nvSpPr>
        <p:spPr>
          <a:xfrm>
            <a:off x="2510421" y="762349"/>
            <a:ext cx="484250" cy="246221"/>
          </a:xfrm>
          <a:prstGeom prst="rect">
            <a:avLst/>
          </a:prstGeom>
          <a:noFill/>
        </p:spPr>
        <p:txBody>
          <a:bodyPr wrap="square" rtlCol="0">
            <a:spAutoFit/>
          </a:bodyPr>
          <a:lstStyle/>
          <a:p>
            <a:r>
              <a:rPr lang="en-US" altLang="ko-KR" sz="1000" b="1" dirty="0">
                <a:latin typeface="+mn-ea"/>
              </a:rPr>
              <a:t>B </a:t>
            </a:r>
            <a:endParaRPr lang="ko-KR" altLang="en-US" sz="1000" b="1" dirty="0">
              <a:solidFill>
                <a:srgbClr val="FF0000"/>
              </a:solidFill>
              <a:latin typeface="+mn-ea"/>
            </a:endParaRPr>
          </a:p>
        </p:txBody>
      </p:sp>
    </p:spTree>
    <p:extLst>
      <p:ext uri="{BB962C8B-B14F-4D97-AF65-F5344CB8AC3E}">
        <p14:creationId xmlns:p14="http://schemas.microsoft.com/office/powerpoint/2010/main" val="251090415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0" y="117643"/>
            <a:ext cx="4452730" cy="369332"/>
          </a:xfrm>
          <a:prstGeom prst="rect">
            <a:avLst/>
          </a:prstGeom>
          <a:noFill/>
        </p:spPr>
        <p:txBody>
          <a:bodyPr wrap="square" rtlCol="0">
            <a:spAutoFit/>
          </a:bodyPr>
          <a:lstStyle/>
          <a:p>
            <a:r>
              <a:rPr lang="en-US" altLang="ko-KR" dirty="0"/>
              <a:t>Supplementary Figure 6</a:t>
            </a:r>
            <a:endParaRPr lang="ko-KR" altLang="en-US" dirty="0"/>
          </a:p>
        </p:txBody>
      </p:sp>
      <p:pic>
        <p:nvPicPr>
          <p:cNvPr id="3" name="그림 2"/>
          <p:cNvPicPr>
            <a:picLocks noChangeAspect="1"/>
          </p:cNvPicPr>
          <p:nvPr/>
        </p:nvPicPr>
        <p:blipFill rotWithShape="1">
          <a:blip r:embed="rId3"/>
          <a:srcRect r="83549"/>
          <a:stretch/>
        </p:blipFill>
        <p:spPr>
          <a:xfrm>
            <a:off x="3388870" y="513451"/>
            <a:ext cx="894054" cy="3600000"/>
          </a:xfrm>
          <a:prstGeom prst="rect">
            <a:avLst/>
          </a:prstGeom>
        </p:spPr>
      </p:pic>
      <p:pic>
        <p:nvPicPr>
          <p:cNvPr id="4" name="그림 3"/>
          <p:cNvPicPr>
            <a:picLocks noChangeAspect="1"/>
          </p:cNvPicPr>
          <p:nvPr/>
        </p:nvPicPr>
        <p:blipFill rotWithShape="1">
          <a:blip r:embed="rId4"/>
          <a:srcRect r="83364"/>
          <a:stretch/>
        </p:blipFill>
        <p:spPr>
          <a:xfrm>
            <a:off x="5027674" y="553950"/>
            <a:ext cx="882318" cy="3600000"/>
          </a:xfrm>
          <a:prstGeom prst="rect">
            <a:avLst/>
          </a:prstGeom>
        </p:spPr>
      </p:pic>
      <p:sp>
        <p:nvSpPr>
          <p:cNvPr id="5" name="TextBox 4"/>
          <p:cNvSpPr txBox="1"/>
          <p:nvPr/>
        </p:nvSpPr>
        <p:spPr>
          <a:xfrm>
            <a:off x="3789309" y="532583"/>
            <a:ext cx="842472" cy="261610"/>
          </a:xfrm>
          <a:prstGeom prst="rect">
            <a:avLst/>
          </a:prstGeom>
          <a:noFill/>
        </p:spPr>
        <p:txBody>
          <a:bodyPr wrap="square" rtlCol="0">
            <a:spAutoFit/>
          </a:bodyPr>
          <a:lstStyle/>
          <a:p>
            <a:pPr algn="ctr"/>
            <a:r>
              <a:rPr lang="en-US" altLang="ko-KR" sz="1100" b="1" dirty="0">
                <a:solidFill>
                  <a:schemeClr val="accent2"/>
                </a:solidFill>
              </a:rPr>
              <a:t>Female</a:t>
            </a:r>
            <a:endParaRPr lang="ko-KR" altLang="en-US" sz="1100" b="1" dirty="0">
              <a:solidFill>
                <a:schemeClr val="accent2"/>
              </a:solidFill>
            </a:endParaRPr>
          </a:p>
        </p:txBody>
      </p:sp>
      <p:sp>
        <p:nvSpPr>
          <p:cNvPr id="6" name="TextBox 5"/>
          <p:cNvSpPr txBox="1"/>
          <p:nvPr/>
        </p:nvSpPr>
        <p:spPr>
          <a:xfrm>
            <a:off x="5419636" y="532583"/>
            <a:ext cx="842472" cy="261610"/>
          </a:xfrm>
          <a:prstGeom prst="rect">
            <a:avLst/>
          </a:prstGeom>
          <a:noFill/>
        </p:spPr>
        <p:txBody>
          <a:bodyPr wrap="square" rtlCol="0">
            <a:spAutoFit/>
          </a:bodyPr>
          <a:lstStyle/>
          <a:p>
            <a:pPr algn="ctr"/>
            <a:r>
              <a:rPr lang="en-US" altLang="ko-KR" sz="1100" b="1" dirty="0">
                <a:solidFill>
                  <a:schemeClr val="accent5"/>
                </a:solidFill>
              </a:rPr>
              <a:t>Male</a:t>
            </a:r>
            <a:endParaRPr lang="ko-KR" altLang="en-US" sz="1100" b="1" dirty="0">
              <a:solidFill>
                <a:schemeClr val="accent5"/>
              </a:solidFill>
            </a:endParaRPr>
          </a:p>
        </p:txBody>
      </p:sp>
      <p:sp>
        <p:nvSpPr>
          <p:cNvPr id="7" name="직사각형 6"/>
          <p:cNvSpPr/>
          <p:nvPr/>
        </p:nvSpPr>
        <p:spPr>
          <a:xfrm>
            <a:off x="4312080" y="3666870"/>
            <a:ext cx="540000" cy="91244"/>
          </a:xfrm>
          <a:prstGeom prst="rect">
            <a:avLst/>
          </a:prstGeom>
          <a:gradFill flip="none" rotWithShape="1">
            <a:gsLst>
              <a:gs pos="50000">
                <a:srgbClr val="E3EEF8"/>
              </a:gs>
              <a:gs pos="0">
                <a:srgbClr val="FF0000"/>
              </a:gs>
              <a:gs pos="100000">
                <a:schemeClr val="accent5"/>
              </a:gs>
            </a:gsLst>
            <a:lin ang="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8" name="TextBox 7"/>
          <p:cNvSpPr txBox="1"/>
          <p:nvPr/>
        </p:nvSpPr>
        <p:spPr>
          <a:xfrm>
            <a:off x="4218614" y="3716388"/>
            <a:ext cx="175606" cy="200055"/>
          </a:xfrm>
          <a:prstGeom prst="rect">
            <a:avLst/>
          </a:prstGeom>
          <a:noFill/>
        </p:spPr>
        <p:txBody>
          <a:bodyPr wrap="square" rtlCol="0">
            <a:spAutoFit/>
          </a:bodyPr>
          <a:lstStyle/>
          <a:p>
            <a:pPr algn="ctr"/>
            <a:r>
              <a:rPr lang="en-US" altLang="ko-KR" sz="700" b="1" dirty="0"/>
              <a:t>1</a:t>
            </a:r>
            <a:endParaRPr lang="ko-KR" altLang="en-US" sz="700" b="1" dirty="0"/>
          </a:p>
        </p:txBody>
      </p:sp>
      <p:sp>
        <p:nvSpPr>
          <p:cNvPr id="9" name="TextBox 8"/>
          <p:cNvSpPr txBox="1"/>
          <p:nvPr/>
        </p:nvSpPr>
        <p:spPr>
          <a:xfrm>
            <a:off x="4484950" y="3716388"/>
            <a:ext cx="175606" cy="200055"/>
          </a:xfrm>
          <a:prstGeom prst="rect">
            <a:avLst/>
          </a:prstGeom>
          <a:noFill/>
        </p:spPr>
        <p:txBody>
          <a:bodyPr wrap="square" rtlCol="0">
            <a:spAutoFit/>
          </a:bodyPr>
          <a:lstStyle/>
          <a:p>
            <a:pPr algn="ctr"/>
            <a:r>
              <a:rPr lang="en-US" altLang="ko-KR" sz="700" b="1" dirty="0"/>
              <a:t>0</a:t>
            </a:r>
            <a:endParaRPr lang="ko-KR" altLang="en-US" sz="700" b="1" dirty="0"/>
          </a:p>
        </p:txBody>
      </p:sp>
      <p:sp>
        <p:nvSpPr>
          <p:cNvPr id="10" name="TextBox 9"/>
          <p:cNvSpPr txBox="1"/>
          <p:nvPr/>
        </p:nvSpPr>
        <p:spPr>
          <a:xfrm>
            <a:off x="4707480" y="3716388"/>
            <a:ext cx="259786" cy="200055"/>
          </a:xfrm>
          <a:prstGeom prst="rect">
            <a:avLst/>
          </a:prstGeom>
          <a:noFill/>
        </p:spPr>
        <p:txBody>
          <a:bodyPr wrap="square" rtlCol="0">
            <a:spAutoFit/>
          </a:bodyPr>
          <a:lstStyle/>
          <a:p>
            <a:pPr algn="ctr"/>
            <a:r>
              <a:rPr lang="en-US" altLang="ko-KR" sz="700" b="1" dirty="0"/>
              <a:t>-1</a:t>
            </a:r>
            <a:endParaRPr lang="ko-KR" altLang="en-US" sz="700" b="1" dirty="0"/>
          </a:p>
        </p:txBody>
      </p:sp>
      <p:sp>
        <p:nvSpPr>
          <p:cNvPr id="11" name="직사각형 10"/>
          <p:cNvSpPr/>
          <p:nvPr/>
        </p:nvSpPr>
        <p:spPr>
          <a:xfrm>
            <a:off x="5715801" y="3666870"/>
            <a:ext cx="540000" cy="91244"/>
          </a:xfrm>
          <a:prstGeom prst="rect">
            <a:avLst/>
          </a:prstGeom>
          <a:gradFill flip="none" rotWithShape="1">
            <a:gsLst>
              <a:gs pos="50000">
                <a:srgbClr val="E3EEF8"/>
              </a:gs>
              <a:gs pos="0">
                <a:srgbClr val="FF0000"/>
              </a:gs>
              <a:gs pos="100000">
                <a:schemeClr val="accent5"/>
              </a:gs>
            </a:gsLst>
            <a:lin ang="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2" name="TextBox 11"/>
          <p:cNvSpPr txBox="1"/>
          <p:nvPr/>
        </p:nvSpPr>
        <p:spPr>
          <a:xfrm>
            <a:off x="5622335" y="3729899"/>
            <a:ext cx="175606" cy="200055"/>
          </a:xfrm>
          <a:prstGeom prst="rect">
            <a:avLst/>
          </a:prstGeom>
          <a:noFill/>
        </p:spPr>
        <p:txBody>
          <a:bodyPr wrap="square" rtlCol="0">
            <a:spAutoFit/>
          </a:bodyPr>
          <a:lstStyle/>
          <a:p>
            <a:pPr algn="ctr"/>
            <a:r>
              <a:rPr lang="en-US" altLang="ko-KR" sz="700" b="1" dirty="0"/>
              <a:t>1</a:t>
            </a:r>
            <a:endParaRPr lang="ko-KR" altLang="en-US" sz="700" b="1" dirty="0"/>
          </a:p>
        </p:txBody>
      </p:sp>
      <p:sp>
        <p:nvSpPr>
          <p:cNvPr id="13" name="TextBox 12"/>
          <p:cNvSpPr txBox="1"/>
          <p:nvPr/>
        </p:nvSpPr>
        <p:spPr>
          <a:xfrm>
            <a:off x="5888671" y="3729899"/>
            <a:ext cx="175606" cy="200055"/>
          </a:xfrm>
          <a:prstGeom prst="rect">
            <a:avLst/>
          </a:prstGeom>
          <a:noFill/>
        </p:spPr>
        <p:txBody>
          <a:bodyPr wrap="square" rtlCol="0">
            <a:spAutoFit/>
          </a:bodyPr>
          <a:lstStyle/>
          <a:p>
            <a:pPr algn="ctr"/>
            <a:r>
              <a:rPr lang="en-US" altLang="ko-KR" sz="700" b="1" dirty="0"/>
              <a:t>0</a:t>
            </a:r>
            <a:endParaRPr lang="ko-KR" altLang="en-US" sz="700" b="1" dirty="0"/>
          </a:p>
        </p:txBody>
      </p:sp>
      <p:sp>
        <p:nvSpPr>
          <p:cNvPr id="14" name="TextBox 13"/>
          <p:cNvSpPr txBox="1"/>
          <p:nvPr/>
        </p:nvSpPr>
        <p:spPr>
          <a:xfrm>
            <a:off x="6124081" y="3729899"/>
            <a:ext cx="259786" cy="200055"/>
          </a:xfrm>
          <a:prstGeom prst="rect">
            <a:avLst/>
          </a:prstGeom>
          <a:noFill/>
        </p:spPr>
        <p:txBody>
          <a:bodyPr wrap="square" rtlCol="0">
            <a:spAutoFit/>
          </a:bodyPr>
          <a:lstStyle/>
          <a:p>
            <a:pPr algn="ctr"/>
            <a:r>
              <a:rPr lang="en-US" altLang="ko-KR" sz="700" b="1" dirty="0"/>
              <a:t>-1</a:t>
            </a:r>
            <a:endParaRPr lang="ko-KR" altLang="en-US" sz="700" b="1" dirty="0"/>
          </a:p>
        </p:txBody>
      </p:sp>
      <p:graphicFrame>
        <p:nvGraphicFramePr>
          <p:cNvPr id="15" name="표 14"/>
          <p:cNvGraphicFramePr>
            <a:graphicFrameLocks noGrp="1"/>
          </p:cNvGraphicFramePr>
          <p:nvPr>
            <p:extLst>
              <p:ext uri="{D42A27DB-BD31-4B8C-83A1-F6EECF244321}">
                <p14:modId xmlns:p14="http://schemas.microsoft.com/office/powerpoint/2010/main" val="2273514953"/>
              </p:ext>
            </p:extLst>
          </p:nvPr>
        </p:nvGraphicFramePr>
        <p:xfrm>
          <a:off x="4303896" y="758778"/>
          <a:ext cx="650138" cy="2900718"/>
        </p:xfrm>
        <a:graphic>
          <a:graphicData uri="http://schemas.openxmlformats.org/drawingml/2006/table">
            <a:tbl>
              <a:tblPr/>
              <a:tblGrid>
                <a:gridCol w="325069">
                  <a:extLst>
                    <a:ext uri="{9D8B030D-6E8A-4147-A177-3AD203B41FA5}">
                      <a16:colId xmlns:a16="http://schemas.microsoft.com/office/drawing/2014/main" xmlns="" val="3638985850"/>
                    </a:ext>
                  </a:extLst>
                </a:gridCol>
                <a:gridCol w="325069">
                  <a:extLst>
                    <a:ext uri="{9D8B030D-6E8A-4147-A177-3AD203B41FA5}">
                      <a16:colId xmlns:a16="http://schemas.microsoft.com/office/drawing/2014/main" xmlns="" val="1816579872"/>
                    </a:ext>
                  </a:extLst>
                </a:gridCol>
              </a:tblGrid>
              <a:tr h="161151">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00</a:t>
                      </a:r>
                    </a:p>
                  </a:txBody>
                  <a:tcPr marL="7620" marR="7620" marT="7620" marB="0" anchor="ctr">
                    <a:lnL>
                      <a:noFill/>
                    </a:lnL>
                    <a:lnR>
                      <a:noFill/>
                    </a:lnR>
                    <a:lnT>
                      <a:noFill/>
                    </a:lnT>
                    <a:lnB>
                      <a:noFill/>
                    </a:lnB>
                    <a:solidFill>
                      <a:srgbClr val="FFFFFF"/>
                    </a:solidFill>
                  </a:tcPr>
                </a:tc>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1.00</a:t>
                      </a:r>
                    </a:p>
                  </a:txBody>
                  <a:tcPr marL="7620" marR="7620" marT="7620" marB="0" anchor="ctr">
                    <a:lnL>
                      <a:noFill/>
                    </a:lnL>
                    <a:lnR>
                      <a:noFill/>
                    </a:lnR>
                    <a:lnT>
                      <a:noFill/>
                    </a:lnT>
                    <a:lnB>
                      <a:noFill/>
                    </a:lnB>
                  </a:tcPr>
                </a:tc>
                <a:extLst>
                  <a:ext uri="{0D108BD9-81ED-4DB2-BD59-A6C34878D82A}">
                    <a16:rowId xmlns:a16="http://schemas.microsoft.com/office/drawing/2014/main" xmlns="" val="2122048406"/>
                  </a:ext>
                </a:extLst>
              </a:tr>
              <a:tr h="161151">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08</a:t>
                      </a:r>
                    </a:p>
                  </a:txBody>
                  <a:tcPr marL="7620" marR="7620" marT="7620" marB="0" anchor="ctr">
                    <a:lnL>
                      <a:noFill/>
                    </a:lnL>
                    <a:lnR>
                      <a:noFill/>
                    </a:lnR>
                    <a:lnT>
                      <a:noFill/>
                    </a:lnT>
                    <a:lnB>
                      <a:noFill/>
                    </a:lnB>
                    <a:solidFill>
                      <a:srgbClr val="F2F7FB"/>
                    </a:solidFill>
                  </a:tcPr>
                </a:tc>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30</a:t>
                      </a:r>
                    </a:p>
                  </a:txBody>
                  <a:tcPr marL="7620" marR="7620" marT="7620" marB="0" anchor="ctr">
                    <a:lnL>
                      <a:noFill/>
                    </a:lnL>
                    <a:lnR>
                      <a:noFill/>
                    </a:lnR>
                    <a:lnT>
                      <a:noFill/>
                    </a:lnT>
                    <a:lnB>
                      <a:noFill/>
                    </a:lnB>
                  </a:tcPr>
                </a:tc>
                <a:extLst>
                  <a:ext uri="{0D108BD9-81ED-4DB2-BD59-A6C34878D82A}">
                    <a16:rowId xmlns:a16="http://schemas.microsoft.com/office/drawing/2014/main" xmlns="" val="824851498"/>
                  </a:ext>
                </a:extLst>
              </a:tr>
              <a:tr h="161151">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32</a:t>
                      </a:r>
                    </a:p>
                  </a:txBody>
                  <a:tcPr marL="7620" marR="7620" marT="7620" marB="0" anchor="ctr">
                    <a:lnL>
                      <a:noFill/>
                    </a:lnL>
                    <a:lnR>
                      <a:noFill/>
                    </a:lnR>
                    <a:lnT>
                      <a:noFill/>
                    </a:lnT>
                    <a:lnB>
                      <a:noFill/>
                    </a:lnB>
                    <a:solidFill>
                      <a:srgbClr val="CADFF1"/>
                    </a:solidFill>
                  </a:tcPr>
                </a:tc>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00</a:t>
                      </a:r>
                    </a:p>
                  </a:txBody>
                  <a:tcPr marL="7620" marR="7620" marT="7620" marB="0" anchor="ctr">
                    <a:lnL>
                      <a:noFill/>
                    </a:lnL>
                    <a:lnR>
                      <a:noFill/>
                    </a:lnR>
                    <a:lnT>
                      <a:noFill/>
                    </a:lnT>
                    <a:lnB>
                      <a:noFill/>
                    </a:lnB>
                  </a:tcPr>
                </a:tc>
                <a:extLst>
                  <a:ext uri="{0D108BD9-81ED-4DB2-BD59-A6C34878D82A}">
                    <a16:rowId xmlns:a16="http://schemas.microsoft.com/office/drawing/2014/main" xmlns="" val="1965399502"/>
                  </a:ext>
                </a:extLst>
              </a:tr>
              <a:tr h="161151">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17</a:t>
                      </a:r>
                    </a:p>
                  </a:txBody>
                  <a:tcPr marL="7620" marR="7620" marT="7620" marB="0" anchor="ctr">
                    <a:lnL>
                      <a:noFill/>
                    </a:lnL>
                    <a:lnR>
                      <a:noFill/>
                    </a:lnR>
                    <a:lnT>
                      <a:noFill/>
                    </a:lnT>
                    <a:lnB>
                      <a:noFill/>
                    </a:lnB>
                    <a:solidFill>
                      <a:srgbClr val="E3EEF7"/>
                    </a:solidFill>
                  </a:tcPr>
                </a:tc>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04</a:t>
                      </a:r>
                    </a:p>
                  </a:txBody>
                  <a:tcPr marL="7620" marR="7620" marT="7620" marB="0" anchor="ctr">
                    <a:lnL>
                      <a:noFill/>
                    </a:lnL>
                    <a:lnR>
                      <a:noFill/>
                    </a:lnR>
                    <a:lnT>
                      <a:noFill/>
                    </a:lnT>
                    <a:lnB>
                      <a:noFill/>
                    </a:lnB>
                  </a:tcPr>
                </a:tc>
                <a:extLst>
                  <a:ext uri="{0D108BD9-81ED-4DB2-BD59-A6C34878D82A}">
                    <a16:rowId xmlns:a16="http://schemas.microsoft.com/office/drawing/2014/main" xmlns="" val="354086755"/>
                  </a:ext>
                </a:extLst>
              </a:tr>
              <a:tr h="161151">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02</a:t>
                      </a:r>
                    </a:p>
                  </a:txBody>
                  <a:tcPr marL="7620" marR="7620" marT="7620" marB="0" anchor="ctr">
                    <a:lnL>
                      <a:noFill/>
                    </a:lnL>
                    <a:lnR>
                      <a:noFill/>
                    </a:lnR>
                    <a:lnT>
                      <a:noFill/>
                    </a:lnT>
                    <a:lnB>
                      <a:noFill/>
                    </a:lnB>
                    <a:solidFill>
                      <a:srgbClr val="FCFDFE"/>
                    </a:solidFill>
                  </a:tcPr>
                </a:tc>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80</a:t>
                      </a:r>
                    </a:p>
                  </a:txBody>
                  <a:tcPr marL="7620" marR="7620" marT="7620" marB="0" anchor="ctr">
                    <a:lnL>
                      <a:noFill/>
                    </a:lnL>
                    <a:lnR>
                      <a:noFill/>
                    </a:lnR>
                    <a:lnT>
                      <a:noFill/>
                    </a:lnT>
                    <a:lnB>
                      <a:noFill/>
                    </a:lnB>
                  </a:tcPr>
                </a:tc>
                <a:extLst>
                  <a:ext uri="{0D108BD9-81ED-4DB2-BD59-A6C34878D82A}">
                    <a16:rowId xmlns:a16="http://schemas.microsoft.com/office/drawing/2014/main" xmlns="" val="3376826587"/>
                  </a:ext>
                </a:extLst>
              </a:tr>
              <a:tr h="161151">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00</a:t>
                      </a:r>
                    </a:p>
                  </a:txBody>
                  <a:tcPr marL="7620" marR="7620" marT="7620" marB="0" anchor="ctr">
                    <a:lnL>
                      <a:noFill/>
                    </a:lnL>
                    <a:lnR>
                      <a:noFill/>
                    </a:lnR>
                    <a:lnT>
                      <a:noFill/>
                    </a:lnT>
                    <a:lnB>
                      <a:noFill/>
                    </a:lnB>
                    <a:solidFill>
                      <a:srgbClr val="FFFFFF"/>
                    </a:solidFill>
                  </a:tcPr>
                </a:tc>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1.00</a:t>
                      </a:r>
                    </a:p>
                  </a:txBody>
                  <a:tcPr marL="7620" marR="7620" marT="7620" marB="0" anchor="ctr">
                    <a:lnL>
                      <a:noFill/>
                    </a:lnL>
                    <a:lnR>
                      <a:noFill/>
                    </a:lnR>
                    <a:lnT>
                      <a:noFill/>
                    </a:lnT>
                    <a:lnB>
                      <a:noFill/>
                    </a:lnB>
                  </a:tcPr>
                </a:tc>
                <a:extLst>
                  <a:ext uri="{0D108BD9-81ED-4DB2-BD59-A6C34878D82A}">
                    <a16:rowId xmlns:a16="http://schemas.microsoft.com/office/drawing/2014/main" xmlns="" val="2286203580"/>
                  </a:ext>
                </a:extLst>
              </a:tr>
              <a:tr h="161151">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09</a:t>
                      </a:r>
                    </a:p>
                  </a:txBody>
                  <a:tcPr marL="7620" marR="7620" marT="7620" marB="0" anchor="ctr">
                    <a:lnL>
                      <a:noFill/>
                    </a:lnL>
                    <a:lnR>
                      <a:noFill/>
                    </a:lnR>
                    <a:lnT>
                      <a:noFill/>
                    </a:lnT>
                    <a:lnB>
                      <a:noFill/>
                    </a:lnB>
                    <a:solidFill>
                      <a:srgbClr val="EFF5FB"/>
                    </a:solidFill>
                  </a:tcPr>
                </a:tc>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30</a:t>
                      </a:r>
                    </a:p>
                  </a:txBody>
                  <a:tcPr marL="7620" marR="7620" marT="7620" marB="0" anchor="ctr">
                    <a:lnL>
                      <a:noFill/>
                    </a:lnL>
                    <a:lnR>
                      <a:noFill/>
                    </a:lnR>
                    <a:lnT>
                      <a:noFill/>
                    </a:lnT>
                    <a:lnB>
                      <a:noFill/>
                    </a:lnB>
                  </a:tcPr>
                </a:tc>
                <a:extLst>
                  <a:ext uri="{0D108BD9-81ED-4DB2-BD59-A6C34878D82A}">
                    <a16:rowId xmlns:a16="http://schemas.microsoft.com/office/drawing/2014/main" xmlns="" val="1377347023"/>
                  </a:ext>
                </a:extLst>
              </a:tr>
              <a:tr h="161151">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16</a:t>
                      </a:r>
                    </a:p>
                  </a:txBody>
                  <a:tcPr marL="7620" marR="7620" marT="7620" marB="0" anchor="ctr">
                    <a:lnL>
                      <a:noFill/>
                    </a:lnL>
                    <a:lnR>
                      <a:noFill/>
                    </a:lnR>
                    <a:lnT>
                      <a:noFill/>
                    </a:lnT>
                    <a:lnB>
                      <a:noFill/>
                    </a:lnB>
                    <a:solidFill>
                      <a:srgbClr val="FFD7D7"/>
                    </a:solidFill>
                  </a:tcPr>
                </a:tc>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06</a:t>
                      </a:r>
                    </a:p>
                  </a:txBody>
                  <a:tcPr marL="7620" marR="7620" marT="7620" marB="0" anchor="ctr">
                    <a:lnL>
                      <a:noFill/>
                    </a:lnL>
                    <a:lnR>
                      <a:noFill/>
                    </a:lnR>
                    <a:lnT>
                      <a:noFill/>
                    </a:lnT>
                    <a:lnB>
                      <a:noFill/>
                    </a:lnB>
                  </a:tcPr>
                </a:tc>
                <a:extLst>
                  <a:ext uri="{0D108BD9-81ED-4DB2-BD59-A6C34878D82A}">
                    <a16:rowId xmlns:a16="http://schemas.microsoft.com/office/drawing/2014/main" xmlns="" val="2034831051"/>
                  </a:ext>
                </a:extLst>
              </a:tr>
              <a:tr h="161151">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19</a:t>
                      </a:r>
                    </a:p>
                  </a:txBody>
                  <a:tcPr marL="7620" marR="7620" marT="7620" marB="0" anchor="ctr">
                    <a:lnL>
                      <a:noFill/>
                    </a:lnL>
                    <a:lnR>
                      <a:noFill/>
                    </a:lnR>
                    <a:lnT>
                      <a:noFill/>
                    </a:lnT>
                    <a:lnB>
                      <a:noFill/>
                    </a:lnB>
                    <a:solidFill>
                      <a:srgbClr val="FFCFCF"/>
                    </a:solidFill>
                  </a:tcPr>
                </a:tc>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02</a:t>
                      </a:r>
                    </a:p>
                  </a:txBody>
                  <a:tcPr marL="7620" marR="7620" marT="7620" marB="0" anchor="ctr">
                    <a:lnL>
                      <a:noFill/>
                    </a:lnL>
                    <a:lnR>
                      <a:noFill/>
                    </a:lnR>
                    <a:lnT>
                      <a:noFill/>
                    </a:lnT>
                    <a:lnB>
                      <a:noFill/>
                    </a:lnB>
                  </a:tcPr>
                </a:tc>
                <a:extLst>
                  <a:ext uri="{0D108BD9-81ED-4DB2-BD59-A6C34878D82A}">
                    <a16:rowId xmlns:a16="http://schemas.microsoft.com/office/drawing/2014/main" xmlns="" val="1540816033"/>
                  </a:ext>
                </a:extLst>
              </a:tr>
              <a:tr h="161151">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12</a:t>
                      </a:r>
                    </a:p>
                  </a:txBody>
                  <a:tcPr marL="7620" marR="7620" marT="7620" marB="0" anchor="ctr">
                    <a:lnL>
                      <a:noFill/>
                    </a:lnL>
                    <a:lnR>
                      <a:noFill/>
                    </a:lnR>
                    <a:lnT>
                      <a:noFill/>
                    </a:lnT>
                    <a:lnB>
                      <a:noFill/>
                    </a:lnB>
                    <a:solidFill>
                      <a:srgbClr val="FFE1E1"/>
                    </a:solidFill>
                  </a:tcPr>
                </a:tc>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20</a:t>
                      </a:r>
                    </a:p>
                  </a:txBody>
                  <a:tcPr marL="7620" marR="7620" marT="7620" marB="0" anchor="ctr">
                    <a:lnL>
                      <a:noFill/>
                    </a:lnL>
                    <a:lnR>
                      <a:noFill/>
                    </a:lnR>
                    <a:lnT>
                      <a:noFill/>
                    </a:lnT>
                    <a:lnB>
                      <a:noFill/>
                    </a:lnB>
                  </a:tcPr>
                </a:tc>
                <a:extLst>
                  <a:ext uri="{0D108BD9-81ED-4DB2-BD59-A6C34878D82A}">
                    <a16:rowId xmlns:a16="http://schemas.microsoft.com/office/drawing/2014/main" xmlns="" val="438890698"/>
                  </a:ext>
                </a:extLst>
              </a:tr>
              <a:tr h="161151">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16</a:t>
                      </a:r>
                    </a:p>
                  </a:txBody>
                  <a:tcPr marL="7620" marR="7620" marT="7620" marB="0" anchor="ctr">
                    <a:lnL>
                      <a:noFill/>
                    </a:lnL>
                    <a:lnR>
                      <a:noFill/>
                    </a:lnR>
                    <a:lnT>
                      <a:noFill/>
                    </a:lnT>
                    <a:lnB>
                      <a:noFill/>
                    </a:lnB>
                    <a:solidFill>
                      <a:srgbClr val="FFD7D7"/>
                    </a:solidFill>
                  </a:tcPr>
                </a:tc>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05</a:t>
                      </a:r>
                    </a:p>
                  </a:txBody>
                  <a:tcPr marL="7620" marR="7620" marT="7620" marB="0" anchor="ctr">
                    <a:lnL>
                      <a:noFill/>
                    </a:lnL>
                    <a:lnR>
                      <a:noFill/>
                    </a:lnR>
                    <a:lnT>
                      <a:noFill/>
                    </a:lnT>
                    <a:lnB>
                      <a:noFill/>
                    </a:lnB>
                  </a:tcPr>
                </a:tc>
                <a:extLst>
                  <a:ext uri="{0D108BD9-81ED-4DB2-BD59-A6C34878D82A}">
                    <a16:rowId xmlns:a16="http://schemas.microsoft.com/office/drawing/2014/main" xmlns="" val="2703146907"/>
                  </a:ext>
                </a:extLst>
              </a:tr>
              <a:tr h="161151">
                <a:tc>
                  <a:txBody>
                    <a:bodyPr/>
                    <a:lstStyle/>
                    <a:p>
                      <a:pPr algn="ctr" fontAlgn="ctr"/>
                      <a:r>
                        <a:rPr lang="en-US" altLang="ko-KR" sz="500" b="1" i="0" u="none" strike="noStrike" dirty="0">
                          <a:solidFill>
                            <a:srgbClr val="000000"/>
                          </a:solidFill>
                          <a:effectLst/>
                          <a:latin typeface="맑은 고딕" panose="020B0503020000020004" pitchFamily="50" charset="-127"/>
                          <a:ea typeface="맑은 고딕" panose="020B0503020000020004" pitchFamily="50" charset="-127"/>
                        </a:rPr>
                        <a:t>0.25</a:t>
                      </a:r>
                    </a:p>
                  </a:txBody>
                  <a:tcPr marL="7620" marR="7620" marT="7620" marB="0" anchor="ctr">
                    <a:lnL>
                      <a:noFill/>
                    </a:lnL>
                    <a:lnR>
                      <a:noFill/>
                    </a:lnR>
                    <a:lnT>
                      <a:noFill/>
                    </a:lnT>
                    <a:lnB>
                      <a:noFill/>
                    </a:lnB>
                    <a:solidFill>
                      <a:srgbClr val="FFC0C0"/>
                    </a:solidFill>
                  </a:tcPr>
                </a:tc>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00</a:t>
                      </a:r>
                    </a:p>
                  </a:txBody>
                  <a:tcPr marL="7620" marR="7620" marT="7620" marB="0" anchor="ctr">
                    <a:lnL>
                      <a:noFill/>
                    </a:lnL>
                    <a:lnR>
                      <a:noFill/>
                    </a:lnR>
                    <a:lnT>
                      <a:noFill/>
                    </a:lnT>
                    <a:lnB>
                      <a:noFill/>
                    </a:lnB>
                  </a:tcPr>
                </a:tc>
                <a:extLst>
                  <a:ext uri="{0D108BD9-81ED-4DB2-BD59-A6C34878D82A}">
                    <a16:rowId xmlns:a16="http://schemas.microsoft.com/office/drawing/2014/main" xmlns="" val="2738480357"/>
                  </a:ext>
                </a:extLst>
              </a:tr>
              <a:tr h="161151">
                <a:tc>
                  <a:txBody>
                    <a:bodyPr/>
                    <a:lstStyle/>
                    <a:p>
                      <a:pPr algn="ctr" fontAlgn="ctr"/>
                      <a:r>
                        <a:rPr lang="en-US" altLang="ko-KR" sz="500" b="1" i="0" u="none" strike="noStrike" dirty="0">
                          <a:solidFill>
                            <a:srgbClr val="000000"/>
                          </a:solidFill>
                          <a:effectLst/>
                          <a:latin typeface="맑은 고딕" panose="020B0503020000020004" pitchFamily="50" charset="-127"/>
                          <a:ea typeface="맑은 고딕" panose="020B0503020000020004" pitchFamily="50" charset="-127"/>
                        </a:rPr>
                        <a:t>0.12</a:t>
                      </a:r>
                    </a:p>
                  </a:txBody>
                  <a:tcPr marL="7620" marR="7620" marT="7620" marB="0" anchor="ctr">
                    <a:lnL>
                      <a:noFill/>
                    </a:lnL>
                    <a:lnR>
                      <a:noFill/>
                    </a:lnR>
                    <a:lnT>
                      <a:noFill/>
                    </a:lnT>
                    <a:lnB>
                      <a:noFill/>
                    </a:lnB>
                    <a:solidFill>
                      <a:srgbClr val="FFE1E1"/>
                    </a:solidFill>
                  </a:tcPr>
                </a:tc>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10</a:t>
                      </a:r>
                    </a:p>
                  </a:txBody>
                  <a:tcPr marL="7620" marR="7620" marT="7620" marB="0" anchor="ctr">
                    <a:lnL>
                      <a:noFill/>
                    </a:lnL>
                    <a:lnR>
                      <a:noFill/>
                    </a:lnR>
                    <a:lnT>
                      <a:noFill/>
                    </a:lnT>
                    <a:lnB>
                      <a:noFill/>
                    </a:lnB>
                  </a:tcPr>
                </a:tc>
                <a:extLst>
                  <a:ext uri="{0D108BD9-81ED-4DB2-BD59-A6C34878D82A}">
                    <a16:rowId xmlns:a16="http://schemas.microsoft.com/office/drawing/2014/main" xmlns="" val="1339646129"/>
                  </a:ext>
                </a:extLst>
              </a:tr>
              <a:tr h="161151">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01</a:t>
                      </a:r>
                    </a:p>
                  </a:txBody>
                  <a:tcPr marL="7620" marR="7620" marT="7620" marB="0" anchor="ctr">
                    <a:lnL>
                      <a:noFill/>
                    </a:lnL>
                    <a:lnR>
                      <a:noFill/>
                    </a:lnR>
                    <a:lnT>
                      <a:noFill/>
                    </a:lnT>
                    <a:lnB>
                      <a:noFill/>
                    </a:lnB>
                    <a:solidFill>
                      <a:srgbClr val="FFFEFE"/>
                    </a:solidFill>
                  </a:tcPr>
                </a:tc>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90</a:t>
                      </a:r>
                    </a:p>
                  </a:txBody>
                  <a:tcPr marL="7620" marR="7620" marT="7620" marB="0" anchor="ctr">
                    <a:lnL>
                      <a:noFill/>
                    </a:lnL>
                    <a:lnR>
                      <a:noFill/>
                    </a:lnR>
                    <a:lnT>
                      <a:noFill/>
                    </a:lnT>
                    <a:lnB>
                      <a:noFill/>
                    </a:lnB>
                  </a:tcPr>
                </a:tc>
                <a:extLst>
                  <a:ext uri="{0D108BD9-81ED-4DB2-BD59-A6C34878D82A}">
                    <a16:rowId xmlns:a16="http://schemas.microsoft.com/office/drawing/2014/main" xmlns="" val="1265735173"/>
                  </a:ext>
                </a:extLst>
              </a:tr>
              <a:tr h="161151">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02</a:t>
                      </a:r>
                    </a:p>
                  </a:txBody>
                  <a:tcPr marL="7620" marR="7620" marT="7620" marB="0" anchor="ctr">
                    <a:lnL>
                      <a:noFill/>
                    </a:lnL>
                    <a:lnR>
                      <a:noFill/>
                    </a:lnR>
                    <a:lnT>
                      <a:noFill/>
                    </a:lnT>
                    <a:lnB>
                      <a:noFill/>
                    </a:lnB>
                    <a:solidFill>
                      <a:srgbClr val="FFFAFA"/>
                    </a:solidFill>
                  </a:tcPr>
                </a:tc>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80</a:t>
                      </a:r>
                    </a:p>
                  </a:txBody>
                  <a:tcPr marL="7620" marR="7620" marT="7620" marB="0" anchor="ctr">
                    <a:lnL>
                      <a:noFill/>
                    </a:lnL>
                    <a:lnR>
                      <a:noFill/>
                    </a:lnR>
                    <a:lnT>
                      <a:noFill/>
                    </a:lnT>
                    <a:lnB>
                      <a:noFill/>
                    </a:lnB>
                  </a:tcPr>
                </a:tc>
                <a:extLst>
                  <a:ext uri="{0D108BD9-81ED-4DB2-BD59-A6C34878D82A}">
                    <a16:rowId xmlns:a16="http://schemas.microsoft.com/office/drawing/2014/main" xmlns="" val="511714141"/>
                  </a:ext>
                </a:extLst>
              </a:tr>
              <a:tr h="161151">
                <a:tc>
                  <a:txBody>
                    <a:bodyPr/>
                    <a:lstStyle/>
                    <a:p>
                      <a:pPr algn="ctr" fontAlgn="ctr"/>
                      <a:r>
                        <a:rPr lang="en-US" altLang="ko-KR" sz="500" b="1" i="0" u="none" strike="noStrike" dirty="0">
                          <a:solidFill>
                            <a:srgbClr val="000000"/>
                          </a:solidFill>
                          <a:effectLst/>
                          <a:latin typeface="맑은 고딕" panose="020B0503020000020004" pitchFamily="50" charset="-127"/>
                          <a:ea typeface="맑은 고딕" panose="020B0503020000020004" pitchFamily="50" charset="-127"/>
                        </a:rPr>
                        <a:t>0.13</a:t>
                      </a:r>
                    </a:p>
                  </a:txBody>
                  <a:tcPr marL="7620" marR="7620" marT="7620" marB="0" anchor="ctr">
                    <a:lnL>
                      <a:noFill/>
                    </a:lnL>
                    <a:lnR>
                      <a:noFill/>
                    </a:lnR>
                    <a:lnT>
                      <a:noFill/>
                    </a:lnT>
                    <a:lnB>
                      <a:noFill/>
                    </a:lnB>
                    <a:solidFill>
                      <a:srgbClr val="FFDEDE"/>
                    </a:solidFill>
                  </a:tcPr>
                </a:tc>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10</a:t>
                      </a:r>
                    </a:p>
                  </a:txBody>
                  <a:tcPr marL="7620" marR="7620" marT="7620" marB="0" anchor="ctr">
                    <a:lnL>
                      <a:noFill/>
                    </a:lnL>
                    <a:lnR>
                      <a:noFill/>
                    </a:lnR>
                    <a:lnT>
                      <a:noFill/>
                    </a:lnT>
                    <a:lnB>
                      <a:noFill/>
                    </a:lnB>
                  </a:tcPr>
                </a:tc>
                <a:extLst>
                  <a:ext uri="{0D108BD9-81ED-4DB2-BD59-A6C34878D82A}">
                    <a16:rowId xmlns:a16="http://schemas.microsoft.com/office/drawing/2014/main" xmlns="" val="3795373707"/>
                  </a:ext>
                </a:extLst>
              </a:tr>
              <a:tr h="161151">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11</a:t>
                      </a:r>
                    </a:p>
                  </a:txBody>
                  <a:tcPr marL="7620" marR="7620" marT="7620" marB="0" anchor="ctr">
                    <a:lnL>
                      <a:noFill/>
                    </a:lnL>
                    <a:lnR>
                      <a:noFill/>
                    </a:lnR>
                    <a:lnT>
                      <a:noFill/>
                    </a:lnT>
                    <a:lnB>
                      <a:noFill/>
                    </a:lnB>
                    <a:solidFill>
                      <a:srgbClr val="FFE3E3"/>
                    </a:solidFill>
                  </a:tcPr>
                </a:tc>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20</a:t>
                      </a:r>
                    </a:p>
                  </a:txBody>
                  <a:tcPr marL="7620" marR="7620" marT="7620" marB="0" anchor="ctr">
                    <a:lnL>
                      <a:noFill/>
                    </a:lnL>
                    <a:lnR>
                      <a:noFill/>
                    </a:lnR>
                    <a:lnT>
                      <a:noFill/>
                    </a:lnT>
                    <a:lnB>
                      <a:noFill/>
                    </a:lnB>
                  </a:tcPr>
                </a:tc>
                <a:extLst>
                  <a:ext uri="{0D108BD9-81ED-4DB2-BD59-A6C34878D82A}">
                    <a16:rowId xmlns:a16="http://schemas.microsoft.com/office/drawing/2014/main" xmlns="" val="3623036620"/>
                  </a:ext>
                </a:extLst>
              </a:tr>
              <a:tr h="161151">
                <a:tc>
                  <a:txBody>
                    <a:bodyPr/>
                    <a:lstStyle/>
                    <a:p>
                      <a:pPr algn="ctr" fontAlgn="ctr"/>
                      <a:r>
                        <a:rPr lang="en-US" altLang="ko-KR" sz="500" b="1" i="0" u="none" strike="noStrike" dirty="0">
                          <a:solidFill>
                            <a:srgbClr val="000000"/>
                          </a:solidFill>
                          <a:effectLst/>
                          <a:latin typeface="맑은 고딕" panose="020B0503020000020004" pitchFamily="50" charset="-127"/>
                          <a:ea typeface="맑은 고딕" panose="020B0503020000020004" pitchFamily="50" charset="-127"/>
                        </a:rPr>
                        <a:t>0.19</a:t>
                      </a:r>
                    </a:p>
                  </a:txBody>
                  <a:tcPr marL="7620" marR="7620" marT="7620" marB="0" anchor="ctr">
                    <a:lnL>
                      <a:noFill/>
                    </a:lnL>
                    <a:lnR>
                      <a:noFill/>
                    </a:lnR>
                    <a:lnT>
                      <a:noFill/>
                    </a:lnT>
                    <a:lnB>
                      <a:noFill/>
                    </a:lnB>
                    <a:solidFill>
                      <a:srgbClr val="FFCFCF"/>
                    </a:solidFill>
                  </a:tcPr>
                </a:tc>
                <a:tc>
                  <a:txBody>
                    <a:bodyPr/>
                    <a:lstStyle/>
                    <a:p>
                      <a:pPr algn="ctr" fontAlgn="ctr"/>
                      <a:r>
                        <a:rPr lang="en-US" altLang="ko-KR" sz="500" b="1" i="0" u="none" strike="noStrike" dirty="0">
                          <a:solidFill>
                            <a:srgbClr val="000000"/>
                          </a:solidFill>
                          <a:effectLst/>
                          <a:latin typeface="맑은 고딕" panose="020B0503020000020004" pitchFamily="50" charset="-127"/>
                          <a:ea typeface="맑은 고딕" panose="020B0503020000020004" pitchFamily="50" charset="-127"/>
                        </a:rPr>
                        <a:t>0.02</a:t>
                      </a:r>
                    </a:p>
                  </a:txBody>
                  <a:tcPr marL="7620" marR="7620" marT="7620" marB="0" anchor="ctr">
                    <a:lnL>
                      <a:noFill/>
                    </a:lnL>
                    <a:lnR>
                      <a:noFill/>
                    </a:lnR>
                    <a:lnT>
                      <a:noFill/>
                    </a:lnT>
                    <a:lnB>
                      <a:noFill/>
                    </a:lnB>
                  </a:tcPr>
                </a:tc>
                <a:extLst>
                  <a:ext uri="{0D108BD9-81ED-4DB2-BD59-A6C34878D82A}">
                    <a16:rowId xmlns:a16="http://schemas.microsoft.com/office/drawing/2014/main" xmlns="" val="4124218053"/>
                  </a:ext>
                </a:extLst>
              </a:tr>
            </a:tbl>
          </a:graphicData>
        </a:graphic>
      </p:graphicFrame>
      <p:graphicFrame>
        <p:nvGraphicFramePr>
          <p:cNvPr id="16" name="표 15"/>
          <p:cNvGraphicFramePr>
            <a:graphicFrameLocks noGrp="1"/>
          </p:cNvGraphicFramePr>
          <p:nvPr>
            <p:extLst>
              <p:ext uri="{D42A27DB-BD31-4B8C-83A1-F6EECF244321}">
                <p14:modId xmlns:p14="http://schemas.microsoft.com/office/powerpoint/2010/main" val="2715488762"/>
              </p:ext>
            </p:extLst>
          </p:nvPr>
        </p:nvGraphicFramePr>
        <p:xfrm>
          <a:off x="5940809" y="758778"/>
          <a:ext cx="574740" cy="2880800"/>
        </p:xfrm>
        <a:graphic>
          <a:graphicData uri="http://schemas.openxmlformats.org/drawingml/2006/table">
            <a:tbl>
              <a:tblPr/>
              <a:tblGrid>
                <a:gridCol w="287370">
                  <a:extLst>
                    <a:ext uri="{9D8B030D-6E8A-4147-A177-3AD203B41FA5}">
                      <a16:colId xmlns:a16="http://schemas.microsoft.com/office/drawing/2014/main" xmlns="" val="2220652947"/>
                    </a:ext>
                  </a:extLst>
                </a:gridCol>
                <a:gridCol w="287370">
                  <a:extLst>
                    <a:ext uri="{9D8B030D-6E8A-4147-A177-3AD203B41FA5}">
                      <a16:colId xmlns:a16="http://schemas.microsoft.com/office/drawing/2014/main" xmlns="" val="3643814149"/>
                    </a:ext>
                  </a:extLst>
                </a:gridCol>
              </a:tblGrid>
              <a:tr h="180050">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07</a:t>
                      </a:r>
                    </a:p>
                  </a:txBody>
                  <a:tcPr marL="7620" marR="7620" marT="7620" marB="0" anchor="ctr">
                    <a:lnL>
                      <a:noFill/>
                    </a:lnL>
                    <a:lnR>
                      <a:noFill/>
                    </a:lnR>
                    <a:lnT>
                      <a:noFill/>
                    </a:lnT>
                    <a:lnB>
                      <a:noFill/>
                    </a:lnB>
                    <a:solidFill>
                      <a:srgbClr val="F4F8FC"/>
                    </a:solidFill>
                  </a:tcPr>
                </a:tc>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30</a:t>
                      </a:r>
                    </a:p>
                  </a:txBody>
                  <a:tcPr marL="7620" marR="7620" marT="7620" marB="0" anchor="ctr">
                    <a:lnL>
                      <a:noFill/>
                    </a:lnL>
                    <a:lnR>
                      <a:noFill/>
                    </a:lnR>
                    <a:lnT>
                      <a:noFill/>
                    </a:lnT>
                    <a:lnB>
                      <a:noFill/>
                    </a:lnB>
                  </a:tcPr>
                </a:tc>
                <a:extLst>
                  <a:ext uri="{0D108BD9-81ED-4DB2-BD59-A6C34878D82A}">
                    <a16:rowId xmlns:a16="http://schemas.microsoft.com/office/drawing/2014/main" xmlns="" val="30700786"/>
                  </a:ext>
                </a:extLst>
              </a:tr>
              <a:tr h="180050">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16</a:t>
                      </a:r>
                    </a:p>
                  </a:txBody>
                  <a:tcPr marL="7620" marR="7620" marT="7620" marB="0" anchor="ctr">
                    <a:lnL>
                      <a:noFill/>
                    </a:lnL>
                    <a:lnR>
                      <a:noFill/>
                    </a:lnR>
                    <a:lnT>
                      <a:noFill/>
                    </a:lnT>
                    <a:lnB>
                      <a:noFill/>
                    </a:lnB>
                    <a:solidFill>
                      <a:srgbClr val="E4EFF8"/>
                    </a:solidFill>
                  </a:tcPr>
                </a:tc>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01</a:t>
                      </a:r>
                    </a:p>
                  </a:txBody>
                  <a:tcPr marL="7620" marR="7620" marT="7620" marB="0" anchor="ctr">
                    <a:lnL>
                      <a:noFill/>
                    </a:lnL>
                    <a:lnR>
                      <a:noFill/>
                    </a:lnR>
                    <a:lnT>
                      <a:noFill/>
                    </a:lnT>
                    <a:lnB>
                      <a:noFill/>
                    </a:lnB>
                  </a:tcPr>
                </a:tc>
                <a:extLst>
                  <a:ext uri="{0D108BD9-81ED-4DB2-BD59-A6C34878D82A}">
                    <a16:rowId xmlns:a16="http://schemas.microsoft.com/office/drawing/2014/main" xmlns="" val="1412356831"/>
                  </a:ext>
                </a:extLst>
              </a:tr>
              <a:tr h="180050">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34</a:t>
                      </a:r>
                    </a:p>
                  </a:txBody>
                  <a:tcPr marL="7620" marR="7620" marT="7620" marB="0" anchor="ctr">
                    <a:lnL>
                      <a:noFill/>
                    </a:lnL>
                    <a:lnR>
                      <a:noFill/>
                    </a:lnR>
                    <a:lnT>
                      <a:noFill/>
                    </a:lnT>
                    <a:lnB>
                      <a:noFill/>
                    </a:lnB>
                    <a:solidFill>
                      <a:srgbClr val="C7DCF0"/>
                    </a:solidFill>
                  </a:tcPr>
                </a:tc>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00</a:t>
                      </a:r>
                    </a:p>
                  </a:txBody>
                  <a:tcPr marL="7620" marR="7620" marT="7620" marB="0" anchor="ctr">
                    <a:lnL>
                      <a:noFill/>
                    </a:lnL>
                    <a:lnR>
                      <a:noFill/>
                    </a:lnR>
                    <a:lnT>
                      <a:noFill/>
                    </a:lnT>
                    <a:lnB>
                      <a:noFill/>
                    </a:lnB>
                  </a:tcPr>
                </a:tc>
                <a:extLst>
                  <a:ext uri="{0D108BD9-81ED-4DB2-BD59-A6C34878D82A}">
                    <a16:rowId xmlns:a16="http://schemas.microsoft.com/office/drawing/2014/main" xmlns="" val="2132093180"/>
                  </a:ext>
                </a:extLst>
              </a:tr>
              <a:tr h="180050">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15</a:t>
                      </a:r>
                    </a:p>
                  </a:txBody>
                  <a:tcPr marL="7620" marR="7620" marT="7620" marB="0" anchor="ctr">
                    <a:lnL>
                      <a:noFill/>
                    </a:lnL>
                    <a:lnR>
                      <a:noFill/>
                    </a:lnR>
                    <a:lnT>
                      <a:noFill/>
                    </a:lnT>
                    <a:lnB>
                      <a:noFill/>
                    </a:lnB>
                    <a:solidFill>
                      <a:srgbClr val="FFD9D9"/>
                    </a:solidFill>
                  </a:tcPr>
                </a:tc>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01</a:t>
                      </a:r>
                    </a:p>
                  </a:txBody>
                  <a:tcPr marL="7620" marR="7620" marT="7620" marB="0" anchor="ctr">
                    <a:lnL>
                      <a:noFill/>
                    </a:lnL>
                    <a:lnR>
                      <a:noFill/>
                    </a:lnR>
                    <a:lnT>
                      <a:noFill/>
                    </a:lnT>
                    <a:lnB>
                      <a:noFill/>
                    </a:lnB>
                  </a:tcPr>
                </a:tc>
                <a:extLst>
                  <a:ext uri="{0D108BD9-81ED-4DB2-BD59-A6C34878D82A}">
                    <a16:rowId xmlns:a16="http://schemas.microsoft.com/office/drawing/2014/main" xmlns="" val="4154228591"/>
                  </a:ext>
                </a:extLst>
              </a:tr>
              <a:tr h="180050">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04</a:t>
                      </a:r>
                    </a:p>
                  </a:txBody>
                  <a:tcPr marL="7620" marR="7620" marT="7620" marB="0" anchor="ctr">
                    <a:lnL>
                      <a:noFill/>
                    </a:lnL>
                    <a:lnR>
                      <a:noFill/>
                    </a:lnR>
                    <a:lnT>
                      <a:noFill/>
                    </a:lnT>
                    <a:lnB>
                      <a:noFill/>
                    </a:lnB>
                    <a:solidFill>
                      <a:srgbClr val="F7FAFD"/>
                    </a:solidFill>
                  </a:tcPr>
                </a:tc>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50</a:t>
                      </a:r>
                    </a:p>
                  </a:txBody>
                  <a:tcPr marL="7620" marR="7620" marT="7620" marB="0" anchor="ctr">
                    <a:lnL>
                      <a:noFill/>
                    </a:lnL>
                    <a:lnR>
                      <a:noFill/>
                    </a:lnR>
                    <a:lnT>
                      <a:noFill/>
                    </a:lnT>
                    <a:lnB>
                      <a:noFill/>
                    </a:lnB>
                  </a:tcPr>
                </a:tc>
                <a:extLst>
                  <a:ext uri="{0D108BD9-81ED-4DB2-BD59-A6C34878D82A}">
                    <a16:rowId xmlns:a16="http://schemas.microsoft.com/office/drawing/2014/main" xmlns="" val="1242944043"/>
                  </a:ext>
                </a:extLst>
              </a:tr>
              <a:tr h="180050">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01</a:t>
                      </a:r>
                    </a:p>
                  </a:txBody>
                  <a:tcPr marL="7620" marR="7620" marT="7620" marB="0" anchor="ctr">
                    <a:lnL>
                      <a:noFill/>
                    </a:lnL>
                    <a:lnR>
                      <a:noFill/>
                    </a:lnR>
                    <a:lnT>
                      <a:noFill/>
                    </a:lnT>
                    <a:lnB>
                      <a:noFill/>
                    </a:lnB>
                    <a:solidFill>
                      <a:srgbClr val="FDFDFE"/>
                    </a:solidFill>
                  </a:tcPr>
                </a:tc>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80</a:t>
                      </a:r>
                    </a:p>
                  </a:txBody>
                  <a:tcPr marL="7620" marR="7620" marT="7620" marB="0" anchor="ctr">
                    <a:lnL>
                      <a:noFill/>
                    </a:lnL>
                    <a:lnR>
                      <a:noFill/>
                    </a:lnR>
                    <a:lnT>
                      <a:noFill/>
                    </a:lnT>
                    <a:lnB>
                      <a:noFill/>
                    </a:lnB>
                  </a:tcPr>
                </a:tc>
                <a:extLst>
                  <a:ext uri="{0D108BD9-81ED-4DB2-BD59-A6C34878D82A}">
                    <a16:rowId xmlns:a16="http://schemas.microsoft.com/office/drawing/2014/main" xmlns="" val="795001509"/>
                  </a:ext>
                </a:extLst>
              </a:tr>
              <a:tr h="180050">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11</a:t>
                      </a:r>
                    </a:p>
                  </a:txBody>
                  <a:tcPr marL="7620" marR="7620" marT="7620" marB="0" anchor="ctr">
                    <a:lnL>
                      <a:noFill/>
                    </a:lnL>
                    <a:lnR>
                      <a:noFill/>
                    </a:lnR>
                    <a:lnT>
                      <a:noFill/>
                    </a:lnT>
                    <a:lnB>
                      <a:noFill/>
                    </a:lnB>
                    <a:solidFill>
                      <a:srgbClr val="FFE3E3"/>
                    </a:solidFill>
                  </a:tcPr>
                </a:tc>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07</a:t>
                      </a:r>
                    </a:p>
                  </a:txBody>
                  <a:tcPr marL="7620" marR="7620" marT="7620" marB="0" anchor="ctr">
                    <a:lnL>
                      <a:noFill/>
                    </a:lnL>
                    <a:lnR>
                      <a:noFill/>
                    </a:lnR>
                    <a:lnT>
                      <a:noFill/>
                    </a:lnT>
                    <a:lnB>
                      <a:noFill/>
                    </a:lnB>
                  </a:tcPr>
                </a:tc>
                <a:extLst>
                  <a:ext uri="{0D108BD9-81ED-4DB2-BD59-A6C34878D82A}">
                    <a16:rowId xmlns:a16="http://schemas.microsoft.com/office/drawing/2014/main" xmlns="" val="3167544073"/>
                  </a:ext>
                </a:extLst>
              </a:tr>
              <a:tr h="180050">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17</a:t>
                      </a:r>
                    </a:p>
                  </a:txBody>
                  <a:tcPr marL="7620" marR="7620" marT="7620" marB="0" anchor="ctr">
                    <a:lnL>
                      <a:noFill/>
                    </a:lnL>
                    <a:lnR>
                      <a:noFill/>
                    </a:lnR>
                    <a:lnT>
                      <a:noFill/>
                    </a:lnT>
                    <a:lnB>
                      <a:noFill/>
                    </a:lnB>
                    <a:solidFill>
                      <a:srgbClr val="FFD4D4"/>
                    </a:solidFill>
                  </a:tcPr>
                </a:tc>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01</a:t>
                      </a:r>
                    </a:p>
                  </a:txBody>
                  <a:tcPr marL="7620" marR="7620" marT="7620" marB="0" anchor="ctr">
                    <a:lnL>
                      <a:noFill/>
                    </a:lnL>
                    <a:lnR>
                      <a:noFill/>
                    </a:lnR>
                    <a:lnT>
                      <a:noFill/>
                    </a:lnT>
                    <a:lnB>
                      <a:noFill/>
                    </a:lnB>
                  </a:tcPr>
                </a:tc>
                <a:extLst>
                  <a:ext uri="{0D108BD9-81ED-4DB2-BD59-A6C34878D82A}">
                    <a16:rowId xmlns:a16="http://schemas.microsoft.com/office/drawing/2014/main" xmlns="" val="2708671580"/>
                  </a:ext>
                </a:extLst>
              </a:tr>
              <a:tr h="180050">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17</a:t>
                      </a:r>
                    </a:p>
                  </a:txBody>
                  <a:tcPr marL="7620" marR="7620" marT="7620" marB="0" anchor="ctr">
                    <a:lnL>
                      <a:noFill/>
                    </a:lnL>
                    <a:lnR>
                      <a:noFill/>
                    </a:lnR>
                    <a:lnT>
                      <a:noFill/>
                    </a:lnT>
                    <a:lnB>
                      <a:noFill/>
                    </a:lnB>
                    <a:solidFill>
                      <a:srgbClr val="FFD4D4"/>
                    </a:solidFill>
                  </a:tcPr>
                </a:tc>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01</a:t>
                      </a:r>
                    </a:p>
                  </a:txBody>
                  <a:tcPr marL="7620" marR="7620" marT="7620" marB="0" anchor="ctr">
                    <a:lnL>
                      <a:noFill/>
                    </a:lnL>
                    <a:lnR>
                      <a:noFill/>
                    </a:lnR>
                    <a:lnT>
                      <a:noFill/>
                    </a:lnT>
                    <a:lnB>
                      <a:noFill/>
                    </a:lnB>
                  </a:tcPr>
                </a:tc>
                <a:extLst>
                  <a:ext uri="{0D108BD9-81ED-4DB2-BD59-A6C34878D82A}">
                    <a16:rowId xmlns:a16="http://schemas.microsoft.com/office/drawing/2014/main" xmlns="" val="1919810611"/>
                  </a:ext>
                </a:extLst>
              </a:tr>
              <a:tr h="180050">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27</a:t>
                      </a:r>
                    </a:p>
                  </a:txBody>
                  <a:tcPr marL="7620" marR="7620" marT="7620" marB="0" anchor="ctr">
                    <a:lnL>
                      <a:noFill/>
                    </a:lnL>
                    <a:lnR>
                      <a:noFill/>
                    </a:lnR>
                    <a:lnT>
                      <a:noFill/>
                    </a:lnT>
                    <a:lnB>
                      <a:noFill/>
                    </a:lnB>
                    <a:solidFill>
                      <a:srgbClr val="FFBBBB"/>
                    </a:solidFill>
                  </a:tcPr>
                </a:tc>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00</a:t>
                      </a:r>
                    </a:p>
                  </a:txBody>
                  <a:tcPr marL="7620" marR="7620" marT="7620" marB="0" anchor="ctr">
                    <a:lnL>
                      <a:noFill/>
                    </a:lnL>
                    <a:lnR>
                      <a:noFill/>
                    </a:lnR>
                    <a:lnT>
                      <a:noFill/>
                    </a:lnT>
                    <a:lnB>
                      <a:noFill/>
                    </a:lnB>
                  </a:tcPr>
                </a:tc>
                <a:extLst>
                  <a:ext uri="{0D108BD9-81ED-4DB2-BD59-A6C34878D82A}">
                    <a16:rowId xmlns:a16="http://schemas.microsoft.com/office/drawing/2014/main" xmlns="" val="2903658422"/>
                  </a:ext>
                </a:extLst>
              </a:tr>
              <a:tr h="180050">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16</a:t>
                      </a:r>
                    </a:p>
                  </a:txBody>
                  <a:tcPr marL="7620" marR="7620" marT="7620" marB="0" anchor="ctr">
                    <a:lnL>
                      <a:noFill/>
                    </a:lnL>
                    <a:lnR>
                      <a:noFill/>
                    </a:lnR>
                    <a:lnT>
                      <a:noFill/>
                    </a:lnT>
                    <a:lnB>
                      <a:noFill/>
                    </a:lnB>
                    <a:solidFill>
                      <a:srgbClr val="FFD7D7"/>
                    </a:solidFill>
                  </a:tcPr>
                </a:tc>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01</a:t>
                      </a:r>
                    </a:p>
                  </a:txBody>
                  <a:tcPr marL="7620" marR="7620" marT="7620" marB="0" anchor="ctr">
                    <a:lnL>
                      <a:noFill/>
                    </a:lnL>
                    <a:lnR>
                      <a:noFill/>
                    </a:lnR>
                    <a:lnT>
                      <a:noFill/>
                    </a:lnT>
                    <a:lnB>
                      <a:noFill/>
                    </a:lnB>
                  </a:tcPr>
                </a:tc>
                <a:extLst>
                  <a:ext uri="{0D108BD9-81ED-4DB2-BD59-A6C34878D82A}">
                    <a16:rowId xmlns:a16="http://schemas.microsoft.com/office/drawing/2014/main" xmlns="" val="37331293"/>
                  </a:ext>
                </a:extLst>
              </a:tr>
              <a:tr h="180050">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23</a:t>
                      </a:r>
                    </a:p>
                  </a:txBody>
                  <a:tcPr marL="7620" marR="7620" marT="7620" marB="0" anchor="ctr">
                    <a:lnL>
                      <a:noFill/>
                    </a:lnL>
                    <a:lnR>
                      <a:noFill/>
                    </a:lnR>
                    <a:lnT>
                      <a:noFill/>
                    </a:lnT>
                    <a:lnB>
                      <a:noFill/>
                    </a:lnB>
                    <a:solidFill>
                      <a:srgbClr val="FFC5C5"/>
                    </a:solidFill>
                  </a:tcPr>
                </a:tc>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00</a:t>
                      </a:r>
                    </a:p>
                  </a:txBody>
                  <a:tcPr marL="7620" marR="7620" marT="7620" marB="0" anchor="ctr">
                    <a:lnL>
                      <a:noFill/>
                    </a:lnL>
                    <a:lnR>
                      <a:noFill/>
                    </a:lnR>
                    <a:lnT>
                      <a:noFill/>
                    </a:lnT>
                    <a:lnB>
                      <a:noFill/>
                    </a:lnB>
                  </a:tcPr>
                </a:tc>
                <a:extLst>
                  <a:ext uri="{0D108BD9-81ED-4DB2-BD59-A6C34878D82A}">
                    <a16:rowId xmlns:a16="http://schemas.microsoft.com/office/drawing/2014/main" xmlns="" val="26173902"/>
                  </a:ext>
                </a:extLst>
              </a:tr>
              <a:tr h="180050">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06</a:t>
                      </a:r>
                    </a:p>
                  </a:txBody>
                  <a:tcPr marL="7620" marR="7620" marT="7620" marB="0" anchor="ctr">
                    <a:lnL>
                      <a:noFill/>
                    </a:lnL>
                    <a:lnR>
                      <a:noFill/>
                    </a:lnR>
                    <a:lnT>
                      <a:noFill/>
                    </a:lnT>
                    <a:lnB>
                      <a:noFill/>
                    </a:lnB>
                    <a:solidFill>
                      <a:srgbClr val="FFEFEF"/>
                    </a:solidFill>
                  </a:tcPr>
                </a:tc>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30</a:t>
                      </a:r>
                    </a:p>
                  </a:txBody>
                  <a:tcPr marL="7620" marR="7620" marT="7620" marB="0" anchor="ctr">
                    <a:lnL>
                      <a:noFill/>
                    </a:lnL>
                    <a:lnR>
                      <a:noFill/>
                    </a:lnR>
                    <a:lnT>
                      <a:noFill/>
                    </a:lnT>
                    <a:lnB>
                      <a:noFill/>
                    </a:lnB>
                  </a:tcPr>
                </a:tc>
                <a:extLst>
                  <a:ext uri="{0D108BD9-81ED-4DB2-BD59-A6C34878D82A}">
                    <a16:rowId xmlns:a16="http://schemas.microsoft.com/office/drawing/2014/main" xmlns="" val="2843978657"/>
                  </a:ext>
                </a:extLst>
              </a:tr>
              <a:tr h="180050">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04</a:t>
                      </a:r>
                    </a:p>
                  </a:txBody>
                  <a:tcPr marL="7620" marR="7620" marT="7620" marB="0" anchor="ctr">
                    <a:lnL>
                      <a:noFill/>
                    </a:lnL>
                    <a:lnR>
                      <a:noFill/>
                    </a:lnR>
                    <a:lnT>
                      <a:noFill/>
                    </a:lnT>
                    <a:lnB>
                      <a:noFill/>
                    </a:lnB>
                    <a:solidFill>
                      <a:srgbClr val="FFF5F5"/>
                    </a:solidFill>
                  </a:tcPr>
                </a:tc>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50</a:t>
                      </a:r>
                    </a:p>
                  </a:txBody>
                  <a:tcPr marL="7620" marR="7620" marT="7620" marB="0" anchor="ctr">
                    <a:lnL>
                      <a:noFill/>
                    </a:lnL>
                    <a:lnR>
                      <a:noFill/>
                    </a:lnR>
                    <a:lnT>
                      <a:noFill/>
                    </a:lnT>
                    <a:lnB>
                      <a:noFill/>
                    </a:lnB>
                  </a:tcPr>
                </a:tc>
                <a:extLst>
                  <a:ext uri="{0D108BD9-81ED-4DB2-BD59-A6C34878D82A}">
                    <a16:rowId xmlns:a16="http://schemas.microsoft.com/office/drawing/2014/main" xmlns="" val="3945589838"/>
                  </a:ext>
                </a:extLst>
              </a:tr>
              <a:tr h="180050">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20</a:t>
                      </a:r>
                    </a:p>
                  </a:txBody>
                  <a:tcPr marL="7620" marR="7620" marT="7620" marB="0" anchor="ctr">
                    <a:lnL>
                      <a:noFill/>
                    </a:lnL>
                    <a:lnR>
                      <a:noFill/>
                    </a:lnR>
                    <a:lnT>
                      <a:noFill/>
                    </a:lnT>
                    <a:lnB>
                      <a:noFill/>
                    </a:lnB>
                    <a:solidFill>
                      <a:srgbClr val="FFCDCD"/>
                    </a:solidFill>
                  </a:tcPr>
                </a:tc>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00</a:t>
                      </a:r>
                    </a:p>
                  </a:txBody>
                  <a:tcPr marL="7620" marR="7620" marT="7620" marB="0" anchor="ctr">
                    <a:lnL>
                      <a:noFill/>
                    </a:lnL>
                    <a:lnR>
                      <a:noFill/>
                    </a:lnR>
                    <a:lnT>
                      <a:noFill/>
                    </a:lnT>
                    <a:lnB>
                      <a:noFill/>
                    </a:lnB>
                  </a:tcPr>
                </a:tc>
                <a:extLst>
                  <a:ext uri="{0D108BD9-81ED-4DB2-BD59-A6C34878D82A}">
                    <a16:rowId xmlns:a16="http://schemas.microsoft.com/office/drawing/2014/main" xmlns="" val="1009562477"/>
                  </a:ext>
                </a:extLst>
              </a:tr>
              <a:tr h="180050">
                <a:tc>
                  <a:txBody>
                    <a:bodyPr/>
                    <a:lstStyle/>
                    <a:p>
                      <a:pPr algn="ctr" fontAlgn="ctr"/>
                      <a:r>
                        <a:rPr lang="en-US" altLang="ko-KR" sz="500" b="1" i="0" u="none" strike="noStrike">
                          <a:solidFill>
                            <a:srgbClr val="000000"/>
                          </a:solidFill>
                          <a:effectLst/>
                          <a:latin typeface="맑은 고딕" panose="020B0503020000020004" pitchFamily="50" charset="-127"/>
                          <a:ea typeface="맑은 고딕" panose="020B0503020000020004" pitchFamily="50" charset="-127"/>
                        </a:rPr>
                        <a:t>0.28</a:t>
                      </a:r>
                    </a:p>
                  </a:txBody>
                  <a:tcPr marL="7620" marR="7620" marT="7620" marB="0" anchor="ctr">
                    <a:lnL>
                      <a:noFill/>
                    </a:lnL>
                    <a:lnR>
                      <a:noFill/>
                    </a:lnR>
                    <a:lnT>
                      <a:noFill/>
                    </a:lnT>
                    <a:lnB>
                      <a:noFill/>
                    </a:lnB>
                    <a:solidFill>
                      <a:srgbClr val="FFB8B8"/>
                    </a:solidFill>
                  </a:tcPr>
                </a:tc>
                <a:tc>
                  <a:txBody>
                    <a:bodyPr/>
                    <a:lstStyle/>
                    <a:p>
                      <a:pPr algn="ctr" fontAlgn="ctr"/>
                      <a:r>
                        <a:rPr lang="en-US" altLang="ko-KR" sz="500" b="1" i="0" u="none" strike="noStrike" dirty="0">
                          <a:solidFill>
                            <a:srgbClr val="000000"/>
                          </a:solidFill>
                          <a:effectLst/>
                          <a:latin typeface="맑은 고딕" panose="020B0503020000020004" pitchFamily="50" charset="-127"/>
                          <a:ea typeface="맑은 고딕" panose="020B0503020000020004" pitchFamily="50" charset="-127"/>
                        </a:rPr>
                        <a:t>0.00</a:t>
                      </a:r>
                    </a:p>
                  </a:txBody>
                  <a:tcPr marL="7620" marR="7620" marT="7620" marB="0" anchor="ctr">
                    <a:lnL>
                      <a:noFill/>
                    </a:lnL>
                    <a:lnR>
                      <a:noFill/>
                    </a:lnR>
                    <a:lnT>
                      <a:noFill/>
                    </a:lnT>
                    <a:lnB>
                      <a:noFill/>
                    </a:lnB>
                  </a:tcPr>
                </a:tc>
                <a:extLst>
                  <a:ext uri="{0D108BD9-81ED-4DB2-BD59-A6C34878D82A}">
                    <a16:rowId xmlns:a16="http://schemas.microsoft.com/office/drawing/2014/main" xmlns="" val="1920416399"/>
                  </a:ext>
                </a:extLst>
              </a:tr>
            </a:tbl>
          </a:graphicData>
        </a:graphic>
      </p:graphicFrame>
      <p:sp>
        <p:nvSpPr>
          <p:cNvPr id="17" name="TextBox 16"/>
          <p:cNvSpPr txBox="1"/>
          <p:nvPr/>
        </p:nvSpPr>
        <p:spPr>
          <a:xfrm>
            <a:off x="4800071" y="1086139"/>
            <a:ext cx="219205" cy="215444"/>
          </a:xfrm>
          <a:prstGeom prst="rect">
            <a:avLst/>
          </a:prstGeom>
          <a:noFill/>
        </p:spPr>
        <p:txBody>
          <a:bodyPr wrap="square" rtlCol="0">
            <a:spAutoFit/>
          </a:bodyPr>
          <a:lstStyle/>
          <a:p>
            <a:r>
              <a:rPr lang="en-US" altLang="ko-KR" sz="800" b="1"/>
              <a:t>*</a:t>
            </a:r>
            <a:endParaRPr lang="ko-KR" altLang="en-US" sz="800" b="1" dirty="0"/>
          </a:p>
        </p:txBody>
      </p:sp>
      <p:sp>
        <p:nvSpPr>
          <p:cNvPr id="18" name="TextBox 17"/>
          <p:cNvSpPr txBox="1"/>
          <p:nvPr/>
        </p:nvSpPr>
        <p:spPr>
          <a:xfrm>
            <a:off x="4800071" y="1237363"/>
            <a:ext cx="219205" cy="215444"/>
          </a:xfrm>
          <a:prstGeom prst="rect">
            <a:avLst/>
          </a:prstGeom>
          <a:noFill/>
        </p:spPr>
        <p:txBody>
          <a:bodyPr wrap="square" rtlCol="0">
            <a:spAutoFit/>
          </a:bodyPr>
          <a:lstStyle/>
          <a:p>
            <a:r>
              <a:rPr lang="en-US" altLang="ko-KR" sz="800" b="1" dirty="0"/>
              <a:t>*</a:t>
            </a:r>
            <a:endParaRPr lang="ko-KR" altLang="en-US" sz="800" b="1" dirty="0"/>
          </a:p>
        </p:txBody>
      </p:sp>
      <p:sp>
        <p:nvSpPr>
          <p:cNvPr id="19" name="TextBox 18"/>
          <p:cNvSpPr txBox="1"/>
          <p:nvPr/>
        </p:nvSpPr>
        <p:spPr>
          <a:xfrm>
            <a:off x="4800071" y="2030118"/>
            <a:ext cx="219205" cy="215444"/>
          </a:xfrm>
          <a:prstGeom prst="rect">
            <a:avLst/>
          </a:prstGeom>
          <a:noFill/>
        </p:spPr>
        <p:txBody>
          <a:bodyPr wrap="square" rtlCol="0">
            <a:spAutoFit/>
          </a:bodyPr>
          <a:lstStyle/>
          <a:p>
            <a:r>
              <a:rPr lang="en-US" altLang="ko-KR" sz="800" b="1" dirty="0"/>
              <a:t>*</a:t>
            </a:r>
            <a:endParaRPr lang="ko-KR" altLang="en-US" sz="800" b="1" dirty="0"/>
          </a:p>
        </p:txBody>
      </p:sp>
      <p:sp>
        <p:nvSpPr>
          <p:cNvPr id="20" name="TextBox 19"/>
          <p:cNvSpPr txBox="1"/>
          <p:nvPr/>
        </p:nvSpPr>
        <p:spPr>
          <a:xfrm>
            <a:off x="4800071" y="2515579"/>
            <a:ext cx="219205" cy="215444"/>
          </a:xfrm>
          <a:prstGeom prst="rect">
            <a:avLst/>
          </a:prstGeom>
          <a:noFill/>
        </p:spPr>
        <p:txBody>
          <a:bodyPr wrap="square" rtlCol="0">
            <a:spAutoFit/>
          </a:bodyPr>
          <a:lstStyle/>
          <a:p>
            <a:r>
              <a:rPr lang="en-US" altLang="ko-KR" sz="800" b="1" dirty="0"/>
              <a:t>*</a:t>
            </a:r>
            <a:endParaRPr lang="ko-KR" altLang="en-US" sz="800" b="1" dirty="0"/>
          </a:p>
        </p:txBody>
      </p:sp>
      <p:sp>
        <p:nvSpPr>
          <p:cNvPr id="21" name="TextBox 20"/>
          <p:cNvSpPr txBox="1"/>
          <p:nvPr/>
        </p:nvSpPr>
        <p:spPr>
          <a:xfrm>
            <a:off x="4800071" y="3490261"/>
            <a:ext cx="219205" cy="215444"/>
          </a:xfrm>
          <a:prstGeom prst="rect">
            <a:avLst/>
          </a:prstGeom>
          <a:noFill/>
        </p:spPr>
        <p:txBody>
          <a:bodyPr wrap="square" rtlCol="0">
            <a:spAutoFit/>
          </a:bodyPr>
          <a:lstStyle/>
          <a:p>
            <a:r>
              <a:rPr lang="en-US" altLang="ko-KR" sz="800" b="1" dirty="0"/>
              <a:t>*</a:t>
            </a:r>
            <a:endParaRPr lang="ko-KR" altLang="en-US" sz="800" b="1" dirty="0"/>
          </a:p>
        </p:txBody>
      </p:sp>
      <p:sp>
        <p:nvSpPr>
          <p:cNvPr id="22" name="TextBox 21"/>
          <p:cNvSpPr txBox="1"/>
          <p:nvPr/>
        </p:nvSpPr>
        <p:spPr>
          <a:xfrm>
            <a:off x="6405487" y="950441"/>
            <a:ext cx="219205" cy="215444"/>
          </a:xfrm>
          <a:prstGeom prst="rect">
            <a:avLst/>
          </a:prstGeom>
          <a:noFill/>
        </p:spPr>
        <p:txBody>
          <a:bodyPr wrap="square" rtlCol="0">
            <a:spAutoFit/>
          </a:bodyPr>
          <a:lstStyle/>
          <a:p>
            <a:r>
              <a:rPr lang="en-US" altLang="ko-KR" sz="800" b="1"/>
              <a:t>*</a:t>
            </a:r>
            <a:endParaRPr lang="ko-KR" altLang="en-US" sz="800" b="1" dirty="0"/>
          </a:p>
        </p:txBody>
      </p:sp>
      <p:sp>
        <p:nvSpPr>
          <p:cNvPr id="23" name="TextBox 22"/>
          <p:cNvSpPr txBox="1"/>
          <p:nvPr/>
        </p:nvSpPr>
        <p:spPr>
          <a:xfrm>
            <a:off x="6405487" y="1132980"/>
            <a:ext cx="219205" cy="215444"/>
          </a:xfrm>
          <a:prstGeom prst="rect">
            <a:avLst/>
          </a:prstGeom>
          <a:noFill/>
        </p:spPr>
        <p:txBody>
          <a:bodyPr wrap="square" rtlCol="0">
            <a:spAutoFit/>
          </a:bodyPr>
          <a:lstStyle/>
          <a:p>
            <a:r>
              <a:rPr lang="en-US" altLang="ko-KR" sz="800" b="1" dirty="0"/>
              <a:t>*</a:t>
            </a:r>
            <a:endParaRPr lang="ko-KR" altLang="en-US" sz="800" b="1" dirty="0"/>
          </a:p>
        </p:txBody>
      </p:sp>
      <p:sp>
        <p:nvSpPr>
          <p:cNvPr id="24" name="TextBox 23"/>
          <p:cNvSpPr txBox="1"/>
          <p:nvPr/>
        </p:nvSpPr>
        <p:spPr>
          <a:xfrm>
            <a:off x="6405487" y="2019680"/>
            <a:ext cx="219205" cy="215444"/>
          </a:xfrm>
          <a:prstGeom prst="rect">
            <a:avLst/>
          </a:prstGeom>
          <a:noFill/>
        </p:spPr>
        <p:txBody>
          <a:bodyPr wrap="square" rtlCol="0">
            <a:spAutoFit/>
          </a:bodyPr>
          <a:lstStyle/>
          <a:p>
            <a:r>
              <a:rPr lang="en-US" altLang="ko-KR" sz="800" b="1" dirty="0"/>
              <a:t>*</a:t>
            </a:r>
            <a:endParaRPr lang="ko-KR" altLang="en-US" sz="800" b="1" dirty="0"/>
          </a:p>
        </p:txBody>
      </p:sp>
      <p:sp>
        <p:nvSpPr>
          <p:cNvPr id="25" name="TextBox 24"/>
          <p:cNvSpPr txBox="1"/>
          <p:nvPr/>
        </p:nvSpPr>
        <p:spPr>
          <a:xfrm>
            <a:off x="6405487" y="2379881"/>
            <a:ext cx="219205" cy="215444"/>
          </a:xfrm>
          <a:prstGeom prst="rect">
            <a:avLst/>
          </a:prstGeom>
          <a:noFill/>
        </p:spPr>
        <p:txBody>
          <a:bodyPr wrap="square" rtlCol="0">
            <a:spAutoFit/>
          </a:bodyPr>
          <a:lstStyle/>
          <a:p>
            <a:r>
              <a:rPr lang="en-US" altLang="ko-KR" sz="800" b="1" dirty="0"/>
              <a:t>*</a:t>
            </a:r>
            <a:endParaRPr lang="ko-KR" altLang="en-US" sz="800" b="1" dirty="0"/>
          </a:p>
        </p:txBody>
      </p:sp>
      <p:sp>
        <p:nvSpPr>
          <p:cNvPr id="26" name="TextBox 25"/>
          <p:cNvSpPr txBox="1"/>
          <p:nvPr/>
        </p:nvSpPr>
        <p:spPr>
          <a:xfrm>
            <a:off x="6405487" y="3298196"/>
            <a:ext cx="219205" cy="215444"/>
          </a:xfrm>
          <a:prstGeom prst="rect">
            <a:avLst/>
          </a:prstGeom>
          <a:noFill/>
        </p:spPr>
        <p:txBody>
          <a:bodyPr wrap="square" rtlCol="0">
            <a:spAutoFit/>
          </a:bodyPr>
          <a:lstStyle/>
          <a:p>
            <a:r>
              <a:rPr lang="en-US" altLang="ko-KR" sz="800" b="1" dirty="0"/>
              <a:t>*</a:t>
            </a:r>
            <a:endParaRPr lang="ko-KR" altLang="en-US" sz="800" b="1" dirty="0"/>
          </a:p>
        </p:txBody>
      </p:sp>
      <p:sp>
        <p:nvSpPr>
          <p:cNvPr id="27" name="TextBox 26"/>
          <p:cNvSpPr txBox="1"/>
          <p:nvPr/>
        </p:nvSpPr>
        <p:spPr>
          <a:xfrm>
            <a:off x="6405487" y="1291643"/>
            <a:ext cx="219205" cy="215444"/>
          </a:xfrm>
          <a:prstGeom prst="rect">
            <a:avLst/>
          </a:prstGeom>
          <a:noFill/>
        </p:spPr>
        <p:txBody>
          <a:bodyPr wrap="square" rtlCol="0">
            <a:spAutoFit/>
          </a:bodyPr>
          <a:lstStyle/>
          <a:p>
            <a:r>
              <a:rPr lang="en-US" altLang="ko-KR" sz="800" b="1" dirty="0"/>
              <a:t>*</a:t>
            </a:r>
            <a:endParaRPr lang="ko-KR" altLang="en-US" sz="800" b="1" dirty="0"/>
          </a:p>
        </p:txBody>
      </p:sp>
      <p:sp>
        <p:nvSpPr>
          <p:cNvPr id="28" name="TextBox 27"/>
          <p:cNvSpPr txBox="1"/>
          <p:nvPr/>
        </p:nvSpPr>
        <p:spPr>
          <a:xfrm>
            <a:off x="6405487" y="2209658"/>
            <a:ext cx="219205" cy="215444"/>
          </a:xfrm>
          <a:prstGeom prst="rect">
            <a:avLst/>
          </a:prstGeom>
          <a:noFill/>
        </p:spPr>
        <p:txBody>
          <a:bodyPr wrap="square" rtlCol="0">
            <a:spAutoFit/>
          </a:bodyPr>
          <a:lstStyle/>
          <a:p>
            <a:r>
              <a:rPr lang="en-US" altLang="ko-KR" sz="800" b="1" dirty="0"/>
              <a:t>*</a:t>
            </a:r>
            <a:endParaRPr lang="ko-KR" altLang="en-US" sz="800" b="1" dirty="0"/>
          </a:p>
        </p:txBody>
      </p:sp>
      <p:sp>
        <p:nvSpPr>
          <p:cNvPr id="29" name="TextBox 28"/>
          <p:cNvSpPr txBox="1"/>
          <p:nvPr/>
        </p:nvSpPr>
        <p:spPr>
          <a:xfrm>
            <a:off x="6405487" y="2745223"/>
            <a:ext cx="219205" cy="215444"/>
          </a:xfrm>
          <a:prstGeom prst="rect">
            <a:avLst/>
          </a:prstGeom>
          <a:noFill/>
        </p:spPr>
        <p:txBody>
          <a:bodyPr wrap="square" rtlCol="0">
            <a:spAutoFit/>
          </a:bodyPr>
          <a:lstStyle/>
          <a:p>
            <a:r>
              <a:rPr lang="en-US" altLang="ko-KR" sz="800" b="1" dirty="0"/>
              <a:t>*</a:t>
            </a:r>
            <a:endParaRPr lang="ko-KR" altLang="en-US" sz="800" b="1" dirty="0"/>
          </a:p>
        </p:txBody>
      </p:sp>
      <p:sp>
        <p:nvSpPr>
          <p:cNvPr id="30" name="TextBox 29"/>
          <p:cNvSpPr txBox="1"/>
          <p:nvPr/>
        </p:nvSpPr>
        <p:spPr>
          <a:xfrm>
            <a:off x="6405487" y="2556211"/>
            <a:ext cx="219205" cy="215444"/>
          </a:xfrm>
          <a:prstGeom prst="rect">
            <a:avLst/>
          </a:prstGeom>
          <a:noFill/>
        </p:spPr>
        <p:txBody>
          <a:bodyPr wrap="square" rtlCol="0">
            <a:spAutoFit/>
          </a:bodyPr>
          <a:lstStyle/>
          <a:p>
            <a:r>
              <a:rPr lang="en-US" altLang="ko-KR" sz="800" b="1" dirty="0"/>
              <a:t>*</a:t>
            </a:r>
            <a:endParaRPr lang="ko-KR" altLang="en-US" sz="800" b="1" dirty="0"/>
          </a:p>
        </p:txBody>
      </p:sp>
      <p:sp>
        <p:nvSpPr>
          <p:cNvPr id="31" name="TextBox 30"/>
          <p:cNvSpPr txBox="1"/>
          <p:nvPr/>
        </p:nvSpPr>
        <p:spPr>
          <a:xfrm>
            <a:off x="6405487" y="3475648"/>
            <a:ext cx="219205" cy="215444"/>
          </a:xfrm>
          <a:prstGeom prst="rect">
            <a:avLst/>
          </a:prstGeom>
          <a:noFill/>
        </p:spPr>
        <p:txBody>
          <a:bodyPr wrap="square" rtlCol="0">
            <a:spAutoFit/>
          </a:bodyPr>
          <a:lstStyle/>
          <a:p>
            <a:r>
              <a:rPr lang="en-US" altLang="ko-KR" sz="800" b="1" dirty="0"/>
              <a:t>*</a:t>
            </a:r>
            <a:endParaRPr lang="ko-KR" altLang="en-US" sz="800" b="1" dirty="0"/>
          </a:p>
        </p:txBody>
      </p:sp>
      <p:pic>
        <p:nvPicPr>
          <p:cNvPr id="32" name="그림 31"/>
          <p:cNvPicPr>
            <a:picLocks noChangeAspect="1"/>
          </p:cNvPicPr>
          <p:nvPr/>
        </p:nvPicPr>
        <p:blipFill rotWithShape="1">
          <a:blip r:embed="rId5"/>
          <a:srcRect r="49832"/>
          <a:stretch/>
        </p:blipFill>
        <p:spPr>
          <a:xfrm>
            <a:off x="2227615" y="721856"/>
            <a:ext cx="791711" cy="1169819"/>
          </a:xfrm>
          <a:prstGeom prst="rect">
            <a:avLst/>
          </a:prstGeom>
        </p:spPr>
      </p:pic>
      <p:pic>
        <p:nvPicPr>
          <p:cNvPr id="33" name="그림 32"/>
          <p:cNvPicPr>
            <a:picLocks noChangeAspect="1"/>
          </p:cNvPicPr>
          <p:nvPr/>
        </p:nvPicPr>
        <p:blipFill>
          <a:blip r:embed="rId6"/>
          <a:stretch>
            <a:fillRect/>
          </a:stretch>
        </p:blipFill>
        <p:spPr>
          <a:xfrm>
            <a:off x="576644" y="721856"/>
            <a:ext cx="1521577" cy="1515467"/>
          </a:xfrm>
          <a:prstGeom prst="rect">
            <a:avLst/>
          </a:prstGeom>
        </p:spPr>
      </p:pic>
      <p:sp>
        <p:nvSpPr>
          <p:cNvPr id="34" name="TextBox 33"/>
          <p:cNvSpPr txBox="1"/>
          <p:nvPr/>
        </p:nvSpPr>
        <p:spPr>
          <a:xfrm>
            <a:off x="2081738" y="499880"/>
            <a:ext cx="288351" cy="246221"/>
          </a:xfrm>
          <a:prstGeom prst="rect">
            <a:avLst/>
          </a:prstGeom>
          <a:noFill/>
        </p:spPr>
        <p:txBody>
          <a:bodyPr wrap="square" rtlCol="0">
            <a:spAutoFit/>
          </a:bodyPr>
          <a:lstStyle/>
          <a:p>
            <a:r>
              <a:rPr lang="en-US" altLang="ko-KR" sz="1000" b="1" dirty="0"/>
              <a:t>B </a:t>
            </a:r>
            <a:endParaRPr lang="ko-KR" altLang="en-US" sz="1000" b="1" dirty="0"/>
          </a:p>
        </p:txBody>
      </p:sp>
      <p:sp>
        <p:nvSpPr>
          <p:cNvPr id="35" name="TextBox 34"/>
          <p:cNvSpPr txBox="1"/>
          <p:nvPr/>
        </p:nvSpPr>
        <p:spPr>
          <a:xfrm>
            <a:off x="527638" y="479794"/>
            <a:ext cx="264968" cy="246221"/>
          </a:xfrm>
          <a:prstGeom prst="rect">
            <a:avLst/>
          </a:prstGeom>
          <a:noFill/>
        </p:spPr>
        <p:txBody>
          <a:bodyPr wrap="square" rtlCol="0">
            <a:spAutoFit/>
          </a:bodyPr>
          <a:lstStyle/>
          <a:p>
            <a:r>
              <a:rPr lang="en-US" altLang="ko-KR" sz="1000" b="1" dirty="0"/>
              <a:t>A</a:t>
            </a:r>
            <a:endParaRPr lang="ko-KR" altLang="en-US" sz="1000" b="1" dirty="0"/>
          </a:p>
        </p:txBody>
      </p:sp>
      <p:sp>
        <p:nvSpPr>
          <p:cNvPr id="36" name="TextBox 35"/>
          <p:cNvSpPr txBox="1"/>
          <p:nvPr/>
        </p:nvSpPr>
        <p:spPr>
          <a:xfrm>
            <a:off x="3519308" y="3890124"/>
            <a:ext cx="293896" cy="243931"/>
          </a:xfrm>
          <a:prstGeom prst="rect">
            <a:avLst/>
          </a:prstGeom>
          <a:noFill/>
        </p:spPr>
        <p:txBody>
          <a:bodyPr wrap="square" rtlCol="0">
            <a:spAutoFit/>
          </a:bodyPr>
          <a:lstStyle/>
          <a:p>
            <a:r>
              <a:rPr lang="en-US" altLang="ko-KR" sz="1000" b="1" dirty="0"/>
              <a:t>E</a:t>
            </a:r>
            <a:endParaRPr lang="ko-KR" altLang="en-US" sz="1000" b="1" dirty="0"/>
          </a:p>
        </p:txBody>
      </p:sp>
      <p:pic>
        <p:nvPicPr>
          <p:cNvPr id="37" name="그림 36"/>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3813203" y="4413664"/>
            <a:ext cx="2520000" cy="1680000"/>
          </a:xfrm>
          <a:prstGeom prst="rect">
            <a:avLst/>
          </a:prstGeom>
        </p:spPr>
      </p:pic>
      <p:pic>
        <p:nvPicPr>
          <p:cNvPr id="38" name="그림 37"/>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3580121" y="6213027"/>
            <a:ext cx="2880000" cy="1645714"/>
          </a:xfrm>
          <a:prstGeom prst="rect">
            <a:avLst/>
          </a:prstGeom>
        </p:spPr>
      </p:pic>
      <p:sp>
        <p:nvSpPr>
          <p:cNvPr id="39" name="TextBox 38"/>
          <p:cNvSpPr txBox="1"/>
          <p:nvPr/>
        </p:nvSpPr>
        <p:spPr>
          <a:xfrm>
            <a:off x="3538115" y="6112556"/>
            <a:ext cx="2390685" cy="246221"/>
          </a:xfrm>
          <a:prstGeom prst="rect">
            <a:avLst/>
          </a:prstGeom>
          <a:noFill/>
        </p:spPr>
        <p:txBody>
          <a:bodyPr wrap="square" rtlCol="0">
            <a:spAutoFit/>
          </a:bodyPr>
          <a:lstStyle/>
          <a:p>
            <a:r>
              <a:rPr lang="en-US" altLang="ko-KR" sz="1000" b="1" dirty="0" err="1"/>
              <a:t>Male_magenta</a:t>
            </a:r>
            <a:endParaRPr lang="ko-KR" altLang="en-US" sz="1000" b="1" dirty="0"/>
          </a:p>
        </p:txBody>
      </p:sp>
      <p:pic>
        <p:nvPicPr>
          <p:cNvPr id="40" name="그림 39"/>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639363" y="6430009"/>
            <a:ext cx="2139742" cy="2139742"/>
          </a:xfrm>
          <a:prstGeom prst="rect">
            <a:avLst/>
          </a:prstGeom>
        </p:spPr>
      </p:pic>
      <p:sp>
        <p:nvSpPr>
          <p:cNvPr id="41" name="TextBox 40"/>
          <p:cNvSpPr txBox="1"/>
          <p:nvPr/>
        </p:nvSpPr>
        <p:spPr>
          <a:xfrm>
            <a:off x="531135" y="2335279"/>
            <a:ext cx="261471" cy="246221"/>
          </a:xfrm>
          <a:prstGeom prst="rect">
            <a:avLst/>
          </a:prstGeom>
          <a:noFill/>
        </p:spPr>
        <p:txBody>
          <a:bodyPr wrap="square" rtlCol="0">
            <a:spAutoFit/>
          </a:bodyPr>
          <a:lstStyle/>
          <a:p>
            <a:r>
              <a:rPr lang="en-US" altLang="ko-KR" sz="1000" b="1" dirty="0"/>
              <a:t>C</a:t>
            </a:r>
            <a:endParaRPr lang="ko-KR" altLang="en-US" sz="1000" b="1" dirty="0"/>
          </a:p>
        </p:txBody>
      </p:sp>
      <p:sp>
        <p:nvSpPr>
          <p:cNvPr id="42" name="TextBox 41"/>
          <p:cNvSpPr txBox="1"/>
          <p:nvPr/>
        </p:nvSpPr>
        <p:spPr>
          <a:xfrm>
            <a:off x="3522454" y="4108279"/>
            <a:ext cx="2390685" cy="246221"/>
          </a:xfrm>
          <a:prstGeom prst="rect">
            <a:avLst/>
          </a:prstGeom>
          <a:noFill/>
        </p:spPr>
        <p:txBody>
          <a:bodyPr wrap="square" rtlCol="0">
            <a:spAutoFit/>
          </a:bodyPr>
          <a:lstStyle/>
          <a:p>
            <a:r>
              <a:rPr lang="en-US" altLang="ko-KR" sz="1000" b="1" dirty="0" err="1"/>
              <a:t>Female_yellow</a:t>
            </a:r>
            <a:endParaRPr lang="ko-KR" altLang="en-US" sz="1000" b="1" dirty="0"/>
          </a:p>
        </p:txBody>
      </p:sp>
      <p:sp>
        <p:nvSpPr>
          <p:cNvPr id="43" name="TextBox 42"/>
          <p:cNvSpPr txBox="1"/>
          <p:nvPr/>
        </p:nvSpPr>
        <p:spPr>
          <a:xfrm>
            <a:off x="527638" y="6417128"/>
            <a:ext cx="1573497" cy="246221"/>
          </a:xfrm>
          <a:prstGeom prst="rect">
            <a:avLst/>
          </a:prstGeom>
          <a:noFill/>
        </p:spPr>
        <p:txBody>
          <a:bodyPr wrap="square" rtlCol="0">
            <a:spAutoFit/>
          </a:bodyPr>
          <a:lstStyle/>
          <a:p>
            <a:r>
              <a:rPr lang="en-US" altLang="ko-KR" sz="1000" b="1" dirty="0"/>
              <a:t>F</a:t>
            </a:r>
            <a:endParaRPr lang="ko-KR" altLang="en-US" sz="1000" b="1" dirty="0"/>
          </a:p>
        </p:txBody>
      </p:sp>
      <p:sp>
        <p:nvSpPr>
          <p:cNvPr id="44" name="TextBox 43"/>
          <p:cNvSpPr txBox="1"/>
          <p:nvPr/>
        </p:nvSpPr>
        <p:spPr>
          <a:xfrm>
            <a:off x="1183956" y="8336411"/>
            <a:ext cx="1565216" cy="246221"/>
          </a:xfrm>
          <a:prstGeom prst="rect">
            <a:avLst/>
          </a:prstGeom>
          <a:noFill/>
        </p:spPr>
        <p:txBody>
          <a:bodyPr wrap="square" rtlCol="0">
            <a:spAutoFit/>
          </a:bodyPr>
          <a:lstStyle/>
          <a:p>
            <a:pPr algn="ctr"/>
            <a:r>
              <a:rPr lang="en-US" altLang="ko-KR" sz="1000" b="1" dirty="0" err="1">
                <a:solidFill>
                  <a:schemeClr val="accent2"/>
                </a:solidFill>
              </a:rPr>
              <a:t>Female_yellow</a:t>
            </a:r>
            <a:endParaRPr lang="ko-KR" altLang="en-US" sz="1000" b="1" dirty="0">
              <a:solidFill>
                <a:schemeClr val="accent2"/>
              </a:solidFill>
            </a:endParaRPr>
          </a:p>
        </p:txBody>
      </p:sp>
      <p:sp>
        <p:nvSpPr>
          <p:cNvPr id="45" name="TextBox 44"/>
          <p:cNvSpPr txBox="1"/>
          <p:nvPr/>
        </p:nvSpPr>
        <p:spPr>
          <a:xfrm>
            <a:off x="2008300" y="7977779"/>
            <a:ext cx="1540436" cy="246221"/>
          </a:xfrm>
          <a:prstGeom prst="rect">
            <a:avLst/>
          </a:prstGeom>
          <a:noFill/>
        </p:spPr>
        <p:txBody>
          <a:bodyPr wrap="square" rtlCol="0">
            <a:spAutoFit/>
          </a:bodyPr>
          <a:lstStyle/>
          <a:p>
            <a:pPr algn="ctr"/>
            <a:r>
              <a:rPr lang="en-US" altLang="ko-KR" sz="1000" b="1" dirty="0" err="1">
                <a:solidFill>
                  <a:schemeClr val="accent5"/>
                </a:solidFill>
              </a:rPr>
              <a:t>Male_magenta</a:t>
            </a:r>
            <a:endParaRPr lang="ko-KR" altLang="en-US" sz="1000" b="1" dirty="0">
              <a:solidFill>
                <a:schemeClr val="accent5"/>
              </a:solidFill>
            </a:endParaRPr>
          </a:p>
        </p:txBody>
      </p:sp>
      <p:sp>
        <p:nvSpPr>
          <p:cNvPr id="46" name="TextBox 45"/>
          <p:cNvSpPr txBox="1"/>
          <p:nvPr/>
        </p:nvSpPr>
        <p:spPr>
          <a:xfrm>
            <a:off x="530562" y="6583014"/>
            <a:ext cx="848045" cy="246221"/>
          </a:xfrm>
          <a:prstGeom prst="rect">
            <a:avLst/>
          </a:prstGeom>
          <a:noFill/>
        </p:spPr>
        <p:txBody>
          <a:bodyPr wrap="square" rtlCol="0">
            <a:spAutoFit/>
          </a:bodyPr>
          <a:lstStyle/>
          <a:p>
            <a:pPr algn="ctr"/>
            <a:r>
              <a:rPr lang="en-US" altLang="ko-KR" sz="1000" b="1" dirty="0" err="1">
                <a:solidFill>
                  <a:schemeClr val="accent6"/>
                </a:solidFill>
              </a:rPr>
              <a:t>Total_black</a:t>
            </a:r>
            <a:endParaRPr lang="ko-KR" altLang="en-US" sz="1000" b="1" dirty="0">
              <a:solidFill>
                <a:schemeClr val="accent6"/>
              </a:solidFill>
            </a:endParaRPr>
          </a:p>
        </p:txBody>
      </p:sp>
      <p:sp>
        <p:nvSpPr>
          <p:cNvPr id="47" name="TextBox 46"/>
          <p:cNvSpPr txBox="1"/>
          <p:nvPr/>
        </p:nvSpPr>
        <p:spPr>
          <a:xfrm>
            <a:off x="1044126" y="7142342"/>
            <a:ext cx="848045" cy="246221"/>
          </a:xfrm>
          <a:prstGeom prst="rect">
            <a:avLst/>
          </a:prstGeom>
          <a:noFill/>
        </p:spPr>
        <p:txBody>
          <a:bodyPr wrap="square" rtlCol="0">
            <a:spAutoFit/>
          </a:bodyPr>
          <a:lstStyle/>
          <a:p>
            <a:pPr algn="ctr"/>
            <a:r>
              <a:rPr lang="en-US" altLang="ko-KR" sz="1000" b="1" dirty="0"/>
              <a:t>548</a:t>
            </a:r>
            <a:endParaRPr lang="ko-KR" altLang="en-US" sz="1000" b="1" dirty="0"/>
          </a:p>
        </p:txBody>
      </p:sp>
      <p:sp>
        <p:nvSpPr>
          <p:cNvPr id="48" name="TextBox 47"/>
          <p:cNvSpPr txBox="1"/>
          <p:nvPr/>
        </p:nvSpPr>
        <p:spPr>
          <a:xfrm>
            <a:off x="1966564" y="8195268"/>
            <a:ext cx="322069" cy="246221"/>
          </a:xfrm>
          <a:prstGeom prst="rect">
            <a:avLst/>
          </a:prstGeom>
          <a:noFill/>
        </p:spPr>
        <p:txBody>
          <a:bodyPr wrap="square" rtlCol="0">
            <a:spAutoFit/>
          </a:bodyPr>
          <a:lstStyle/>
          <a:p>
            <a:pPr algn="ctr"/>
            <a:r>
              <a:rPr lang="en-US" altLang="ko-KR" sz="1000" b="1" dirty="0"/>
              <a:t>5</a:t>
            </a:r>
            <a:endParaRPr lang="ko-KR" altLang="en-US" sz="1000" b="1" dirty="0"/>
          </a:p>
        </p:txBody>
      </p:sp>
      <p:sp>
        <p:nvSpPr>
          <p:cNvPr id="49" name="TextBox 48"/>
          <p:cNvSpPr txBox="1"/>
          <p:nvPr/>
        </p:nvSpPr>
        <p:spPr>
          <a:xfrm>
            <a:off x="2008300" y="7798463"/>
            <a:ext cx="322069" cy="246221"/>
          </a:xfrm>
          <a:prstGeom prst="rect">
            <a:avLst/>
          </a:prstGeom>
          <a:noFill/>
        </p:spPr>
        <p:txBody>
          <a:bodyPr wrap="square" rtlCol="0">
            <a:spAutoFit/>
          </a:bodyPr>
          <a:lstStyle/>
          <a:p>
            <a:pPr algn="ctr"/>
            <a:r>
              <a:rPr lang="en-US" altLang="ko-KR" sz="1000" b="1" dirty="0"/>
              <a:t>44</a:t>
            </a:r>
            <a:endParaRPr lang="ko-KR" altLang="en-US" sz="1000" b="1" dirty="0"/>
          </a:p>
        </p:txBody>
      </p:sp>
      <p:sp>
        <p:nvSpPr>
          <p:cNvPr id="50" name="TextBox 49"/>
          <p:cNvSpPr txBox="1"/>
          <p:nvPr/>
        </p:nvSpPr>
        <p:spPr>
          <a:xfrm>
            <a:off x="2231284" y="7798877"/>
            <a:ext cx="322069" cy="246221"/>
          </a:xfrm>
          <a:prstGeom prst="rect">
            <a:avLst/>
          </a:prstGeom>
          <a:noFill/>
        </p:spPr>
        <p:txBody>
          <a:bodyPr wrap="square" rtlCol="0">
            <a:spAutoFit/>
          </a:bodyPr>
          <a:lstStyle/>
          <a:p>
            <a:pPr algn="ctr"/>
            <a:r>
              <a:rPr lang="en-US" altLang="ko-KR" sz="1000" b="1" dirty="0"/>
              <a:t>6</a:t>
            </a:r>
            <a:endParaRPr lang="ko-KR" altLang="en-US" sz="1000" b="1" dirty="0"/>
          </a:p>
        </p:txBody>
      </p:sp>
      <p:sp>
        <p:nvSpPr>
          <p:cNvPr id="51" name="TextBox 50"/>
          <p:cNvSpPr txBox="1"/>
          <p:nvPr/>
        </p:nvSpPr>
        <p:spPr>
          <a:xfrm>
            <a:off x="1517828" y="7818878"/>
            <a:ext cx="397881" cy="246221"/>
          </a:xfrm>
          <a:prstGeom prst="rect">
            <a:avLst/>
          </a:prstGeom>
          <a:noFill/>
        </p:spPr>
        <p:txBody>
          <a:bodyPr wrap="square" rtlCol="0">
            <a:spAutoFit/>
          </a:bodyPr>
          <a:lstStyle/>
          <a:p>
            <a:pPr algn="ctr"/>
            <a:r>
              <a:rPr lang="en-US" altLang="ko-KR" sz="1000" b="1" dirty="0"/>
              <a:t>129</a:t>
            </a:r>
            <a:endParaRPr lang="ko-KR" altLang="en-US" sz="1000" b="1" dirty="0"/>
          </a:p>
        </p:txBody>
      </p:sp>
      <p:pic>
        <p:nvPicPr>
          <p:cNvPr id="52" name="그림 51"/>
          <p:cNvPicPr>
            <a:picLocks noChangeAspect="1"/>
          </p:cNvPicPr>
          <p:nvPr/>
        </p:nvPicPr>
        <p:blipFill>
          <a:blip r:embed="rId10"/>
          <a:stretch>
            <a:fillRect/>
          </a:stretch>
        </p:blipFill>
        <p:spPr>
          <a:xfrm>
            <a:off x="566866" y="2637471"/>
            <a:ext cx="2885189" cy="3598195"/>
          </a:xfrm>
          <a:prstGeom prst="rect">
            <a:avLst/>
          </a:prstGeom>
        </p:spPr>
      </p:pic>
      <p:sp>
        <p:nvSpPr>
          <p:cNvPr id="53" name="TextBox 52"/>
          <p:cNvSpPr txBox="1"/>
          <p:nvPr/>
        </p:nvSpPr>
        <p:spPr>
          <a:xfrm>
            <a:off x="3437193" y="499880"/>
            <a:ext cx="293896" cy="243931"/>
          </a:xfrm>
          <a:prstGeom prst="rect">
            <a:avLst/>
          </a:prstGeom>
          <a:noFill/>
        </p:spPr>
        <p:txBody>
          <a:bodyPr wrap="square" rtlCol="0">
            <a:spAutoFit/>
          </a:bodyPr>
          <a:lstStyle/>
          <a:p>
            <a:r>
              <a:rPr lang="en-US" altLang="ko-KR" sz="1000" b="1" dirty="0"/>
              <a:t>D</a:t>
            </a:r>
            <a:endParaRPr lang="ko-KR" altLang="en-US" sz="1000" b="1" dirty="0"/>
          </a:p>
        </p:txBody>
      </p:sp>
      <p:sp>
        <p:nvSpPr>
          <p:cNvPr id="54" name="TextBox 53"/>
          <p:cNvSpPr txBox="1"/>
          <p:nvPr/>
        </p:nvSpPr>
        <p:spPr>
          <a:xfrm>
            <a:off x="512014" y="2539101"/>
            <a:ext cx="261471" cy="246221"/>
          </a:xfrm>
          <a:prstGeom prst="rect">
            <a:avLst/>
          </a:prstGeom>
          <a:noFill/>
        </p:spPr>
        <p:txBody>
          <a:bodyPr wrap="square" rtlCol="0">
            <a:spAutoFit/>
          </a:bodyPr>
          <a:lstStyle/>
          <a:p>
            <a:r>
              <a:rPr lang="en-US" altLang="ko-KR" sz="1000" b="1" dirty="0"/>
              <a:t>a</a:t>
            </a:r>
            <a:endParaRPr lang="ko-KR" altLang="en-US" sz="1000" b="1" dirty="0"/>
          </a:p>
        </p:txBody>
      </p:sp>
      <p:sp>
        <p:nvSpPr>
          <p:cNvPr id="55" name="TextBox 54"/>
          <p:cNvSpPr txBox="1"/>
          <p:nvPr/>
        </p:nvSpPr>
        <p:spPr>
          <a:xfrm>
            <a:off x="1928239" y="2539101"/>
            <a:ext cx="261471" cy="246221"/>
          </a:xfrm>
          <a:prstGeom prst="rect">
            <a:avLst/>
          </a:prstGeom>
          <a:noFill/>
        </p:spPr>
        <p:txBody>
          <a:bodyPr wrap="square" rtlCol="0">
            <a:spAutoFit/>
          </a:bodyPr>
          <a:lstStyle/>
          <a:p>
            <a:r>
              <a:rPr lang="en-US" altLang="ko-KR" sz="1000" b="1" dirty="0"/>
              <a:t>b</a:t>
            </a:r>
            <a:endParaRPr lang="ko-KR" altLang="en-US" sz="1000" b="1" dirty="0"/>
          </a:p>
        </p:txBody>
      </p:sp>
      <p:sp>
        <p:nvSpPr>
          <p:cNvPr id="56" name="TextBox 55"/>
          <p:cNvSpPr txBox="1"/>
          <p:nvPr/>
        </p:nvSpPr>
        <p:spPr>
          <a:xfrm>
            <a:off x="512014" y="3712492"/>
            <a:ext cx="261471" cy="246221"/>
          </a:xfrm>
          <a:prstGeom prst="rect">
            <a:avLst/>
          </a:prstGeom>
          <a:noFill/>
        </p:spPr>
        <p:txBody>
          <a:bodyPr wrap="square" rtlCol="0">
            <a:spAutoFit/>
          </a:bodyPr>
          <a:lstStyle/>
          <a:p>
            <a:r>
              <a:rPr lang="en-US" altLang="ko-KR" sz="1000" b="1" dirty="0"/>
              <a:t>c</a:t>
            </a:r>
            <a:endParaRPr lang="ko-KR" altLang="en-US" sz="1000" b="1" dirty="0"/>
          </a:p>
        </p:txBody>
      </p:sp>
      <p:sp>
        <p:nvSpPr>
          <p:cNvPr id="57" name="TextBox 56"/>
          <p:cNvSpPr txBox="1"/>
          <p:nvPr/>
        </p:nvSpPr>
        <p:spPr>
          <a:xfrm>
            <a:off x="1928239" y="3712492"/>
            <a:ext cx="261471" cy="246221"/>
          </a:xfrm>
          <a:prstGeom prst="rect">
            <a:avLst/>
          </a:prstGeom>
          <a:noFill/>
        </p:spPr>
        <p:txBody>
          <a:bodyPr wrap="square" rtlCol="0">
            <a:spAutoFit/>
          </a:bodyPr>
          <a:lstStyle/>
          <a:p>
            <a:r>
              <a:rPr lang="en-US" altLang="ko-KR" sz="1000" b="1" dirty="0"/>
              <a:t>d</a:t>
            </a:r>
            <a:endParaRPr lang="ko-KR" altLang="en-US" sz="1000" b="1" dirty="0"/>
          </a:p>
        </p:txBody>
      </p:sp>
      <p:sp>
        <p:nvSpPr>
          <p:cNvPr id="58" name="TextBox 57"/>
          <p:cNvSpPr txBox="1"/>
          <p:nvPr/>
        </p:nvSpPr>
        <p:spPr>
          <a:xfrm>
            <a:off x="512014" y="4935818"/>
            <a:ext cx="261471" cy="246221"/>
          </a:xfrm>
          <a:prstGeom prst="rect">
            <a:avLst/>
          </a:prstGeom>
          <a:noFill/>
        </p:spPr>
        <p:txBody>
          <a:bodyPr wrap="square" rtlCol="0">
            <a:spAutoFit/>
          </a:bodyPr>
          <a:lstStyle/>
          <a:p>
            <a:r>
              <a:rPr lang="en-US" altLang="ko-KR" sz="1000" b="1" dirty="0"/>
              <a:t>e</a:t>
            </a:r>
            <a:endParaRPr lang="ko-KR" altLang="en-US" sz="1000" b="1" dirty="0"/>
          </a:p>
        </p:txBody>
      </p:sp>
      <p:sp>
        <p:nvSpPr>
          <p:cNvPr id="59" name="TextBox 58"/>
          <p:cNvSpPr txBox="1"/>
          <p:nvPr/>
        </p:nvSpPr>
        <p:spPr>
          <a:xfrm>
            <a:off x="1928239" y="4935818"/>
            <a:ext cx="261471" cy="246221"/>
          </a:xfrm>
          <a:prstGeom prst="rect">
            <a:avLst/>
          </a:prstGeom>
          <a:noFill/>
        </p:spPr>
        <p:txBody>
          <a:bodyPr wrap="square" rtlCol="0">
            <a:spAutoFit/>
          </a:bodyPr>
          <a:lstStyle/>
          <a:p>
            <a:r>
              <a:rPr lang="en-US" altLang="ko-KR" sz="1000" b="1" dirty="0"/>
              <a:t>f</a:t>
            </a:r>
            <a:endParaRPr lang="ko-KR" altLang="en-US" sz="1000" b="1" dirty="0"/>
          </a:p>
        </p:txBody>
      </p:sp>
    </p:spTree>
    <p:extLst>
      <p:ext uri="{BB962C8B-B14F-4D97-AF65-F5344CB8AC3E}">
        <p14:creationId xmlns:p14="http://schemas.microsoft.com/office/powerpoint/2010/main" val="3744189200"/>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8945</TotalTime>
  <Words>520</Words>
  <Application>Microsoft Office PowerPoint</Application>
  <PresentationFormat>Letter Paper (8.5x11 in)</PresentationFormat>
  <Paragraphs>297</Paragraphs>
  <Slides>6</Slides>
  <Notes>5</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6</vt:i4>
      </vt:variant>
    </vt:vector>
  </HeadingPairs>
  <TitlesOfParts>
    <vt:vector size="12" baseType="lpstr">
      <vt:lpstr>맑은 고딕</vt:lpstr>
      <vt:lpstr>Arial</vt:lpstr>
      <vt:lpstr>Calibri</vt:lpstr>
      <vt:lpstr>Calibri Light</vt:lpstr>
      <vt:lpstr>Office 테마</vt:lpstr>
      <vt:lpstr>Acrobat Document</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amore</dc:creator>
  <cp:lastModifiedBy>Pachaiyappan M.</cp:lastModifiedBy>
  <cp:revision>446</cp:revision>
  <cp:lastPrinted>2023-10-20T10:06:58Z</cp:lastPrinted>
  <dcterms:created xsi:type="dcterms:W3CDTF">2022-08-24T01:15:55Z</dcterms:created>
  <dcterms:modified xsi:type="dcterms:W3CDTF">2023-11-16T13:12:30Z</dcterms:modified>
</cp:coreProperties>
</file>